
<file path=[Content_Types].xml><?xml version="1.0" encoding="utf-8"?>
<Types xmlns="http://schemas.openxmlformats.org/package/2006/content-types">
  <Default Extension="jp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notesSlides/notesSlide4.xml" ContentType="application/vnd.openxmlformats-officedocument.presentationml.notesSlid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1.xml" ContentType="application/vnd.openxmlformats-officedocument.themeOverride+xml"/>
  <Override PartName="/ppt/notesSlides/notesSlide5.xml" ContentType="application/vnd.openxmlformats-officedocument.presentationml.notesSl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theme/themeOverride2.xml" ContentType="application/vnd.openxmlformats-officedocument.themeOverride+xml"/>
  <Override PartName="/ppt/charts/chart4.xml" ContentType="application/vnd.openxmlformats-officedocument.drawingml.chart+xml"/>
  <Override PartName="/ppt/charts/style4.xml" ContentType="application/vnd.ms-office.chartstyle+xml"/>
  <Override PartName="/ppt/charts/colors4.xml" ContentType="application/vnd.ms-office.chartcolorstyle+xml"/>
  <Override PartName="/ppt/theme/themeOverride3.xml" ContentType="application/vnd.openxmlformats-officedocument.themeOverride+xml"/>
  <Override PartName="/ppt/charts/chart5.xml" ContentType="application/vnd.openxmlformats-officedocument.drawingml.chart+xml"/>
  <Override PartName="/ppt/charts/style5.xml" ContentType="application/vnd.ms-office.chartstyle+xml"/>
  <Override PartName="/ppt/charts/colors5.xml" ContentType="application/vnd.ms-office.chartcolorstyle+xml"/>
  <Override PartName="/ppt/theme/themeOverride4.xml" ContentType="application/vnd.openxmlformats-officedocument.themeOverride+xml"/>
  <Override PartName="/ppt/notesSlides/notesSlide6.xml" ContentType="application/vnd.openxmlformats-officedocument.presentationml.notesSlide+xml"/>
  <Override PartName="/ppt/charts/chart6.xml" ContentType="application/vnd.openxmlformats-officedocument.drawingml.chart+xml"/>
  <Override PartName="/ppt/charts/style6.xml" ContentType="application/vnd.ms-office.chartstyle+xml"/>
  <Override PartName="/ppt/charts/colors6.xml" ContentType="application/vnd.ms-office.chartcolorstyl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charts/chart7.xml" ContentType="application/vnd.openxmlformats-officedocument.drawingml.chart+xml"/>
  <Override PartName="/ppt/charts/style7.xml" ContentType="application/vnd.ms-office.chartstyle+xml"/>
  <Override PartName="/ppt/charts/colors7.xml" ContentType="application/vnd.ms-office.chartcolorstyl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metadata" ContentType="application/binary"/>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 Id="rId4" Type="http://schemas.openxmlformats.org/officeDocument/2006/relationships/custom-properties" Target="docProps/custom.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saveSubsetFonts="1" autoCompressPictures="0">
  <p:sldMasterIdLst>
    <p:sldMasterId id="2147483648" r:id="rId1"/>
  </p:sldMasterIdLst>
  <p:notesMasterIdLst>
    <p:notesMasterId r:id="rId14"/>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Lst>
  <p:sldSz cx="7772400" cy="10058400"/>
  <p:notesSz cx="6858000" cy="9296400"/>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ext>
    <p:ext uri="GoogleSlidesCustomDataVersion2">
      <go:slidesCustomData xmlns:go="http://customooxmlschemas.google.com/" xmlns:ahyp="http://schemas.microsoft.com/office/drawing/2018/hyperlinkcolor" xmlns:p15="http://schemas.microsoft.com/office/powerpoint/2012/main" xmlns:p14="http://schemas.microsoft.com/office/powerpoint/2010/main" xmlns:com="http://schemas.openxmlformats.org/drawingml/2006/compatibility" xmlns:pvml="urn:schemas-microsoft-com:office:powerpoint" xmlns:v="urn:schemas-microsoft-com:vml" xmlns:o="urn:schemas-microsoft-com:office:office" xmlns:dgm="http://schemas.openxmlformats.org/drawingml/2006/diagram" xmlns:c="http://schemas.openxmlformats.org/drawingml/2006/chart" xmlns:mv="urn:schemas-microsoft-com:mac:vml" xmlns:mc="http://schemas.openxmlformats.org/markup-compatibility/2006" xmlns="" r:id="rId18" roundtripDataSignature="AMtx7mjTU6xpRG7Gp5N/eKAM/Jg/6X1L0g=="/>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3F9B46F7-8DFB-436F-B93C-1C2E9E377E49}">
  <a:tblStyle styleId="{3F9B46F7-8DFB-436F-B93C-1C2E9E377E49}" styleName="Table_0">
    <a:wholeTbl>
      <a:tcTxStyle b="off" i="off">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 styleId="{EF749503-7E41-47C8-9E7A-A9317FD33F2B}" styleName="Table_1">
    <a:wholeTbl>
      <a:tcTxStyle b="off" i="off">
        <a:font>
          <a:latin typeface="Arial"/>
          <a:ea typeface="Arial"/>
          <a:cs typeface="Arial"/>
        </a:font>
        <a:srgbClr val="000000"/>
      </a:tcTxStyle>
      <a:tcStyle>
        <a:tcBdr/>
      </a:tcStyle>
    </a:wholeTbl>
    <a:band1H>
      <a:tcTxStyle b="off" i="off"/>
      <a:tcStyle>
        <a:tcBdr/>
      </a:tcStyle>
    </a:band1H>
    <a:band2H>
      <a:tcTxStyle b="off" i="off"/>
      <a:tcStyle>
        <a:tcBdr/>
      </a:tcStyle>
    </a:band2H>
    <a:band1V>
      <a:tcTxStyle b="off" i="off"/>
      <a:tcStyle>
        <a:tcBdr/>
      </a:tcStyle>
    </a:band1V>
    <a:band2V>
      <a:tcTxStyle b="off" i="off"/>
      <a:tcStyle>
        <a:tcBdr/>
      </a:tcStyle>
    </a:band2V>
    <a:lastCol>
      <a:tcTxStyle b="off" i="off"/>
      <a:tcStyle>
        <a:tcBdr/>
      </a:tcStyle>
    </a:lastCol>
    <a:firstCol>
      <a:tcTxStyle b="off" i="off"/>
      <a:tcStyle>
        <a:tcBdr/>
      </a:tcStyle>
    </a:firstCol>
    <a:lastRow>
      <a:tcTxStyle b="off" i="off"/>
      <a:tcStyle>
        <a:tcBdr/>
      </a:tcStyle>
    </a:lastRow>
    <a:seCell>
      <a:tcTxStyle b="off" i="off"/>
      <a:tcStyle>
        <a:tcBdr/>
      </a:tcStyle>
    </a:seCell>
    <a:swCell>
      <a:tcTxStyle b="off" i="off"/>
      <a:tcStyle>
        <a:tcBdr/>
      </a:tcStyle>
    </a:swCell>
    <a:firstRow>
      <a:tcTxStyle b="off" i="off"/>
      <a:tcStyle>
        <a:tcBdr/>
      </a:tcStyle>
    </a:firstRow>
    <a:neCell>
      <a:tcTxStyle b="off" i="off"/>
      <a:tcStyle>
        <a:tcBdr/>
      </a:tcStyle>
    </a:neCell>
    <a:nwCell>
      <a:tcTxStyle b="off" i="off"/>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100" d="100"/>
          <a:sy n="100" d="100"/>
        </p:scale>
        <p:origin x="660" y="-340"/>
      </p:cViewPr>
      <p:guideLst/>
    </p:cSldViewPr>
  </p:slideViewPr>
  <p:notesTextViewPr>
    <p:cViewPr>
      <p:scale>
        <a:sx n="1" d="1"/>
        <a:sy n="1" d="1"/>
      </p:scale>
      <p:origin x="0" y="0"/>
    </p:cViewPr>
  </p:notesTextViewPr>
  <p:sorterViewPr>
    <p:cViewPr varScale="1">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customschemas.google.com/relationships/presentationmetadata" Target="metadata"/><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2" Type="http://schemas.openxmlformats.org/officeDocument/2006/relationships/slide" Target="slides/slide1.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notesMaster" Target="notesMasters/notesMaster1.xml"/><Relationship Id="rId22"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oleObject" Target="file:///\\Users\rickkim\Google%20Drive\School\1.%20Current%20Research\0.%20RMT2%20Methylation\Growth%20Phenotypes\Growth%20graph.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Volumes\GoogleDrive\My%20Drive\School_Carnegie\1.%20Grossman%20Lab\0.%20Project%20Transfer\RMT2%20Project%202022\2.%20Data%20folder\2.%20Supplemental%20Figures\Figure%20S3.%20Proteins%20by%20photosynthetic%20complex\RK_20200820_Merged_Batch_ABCD_LtoH_Quantitation.xlsx" TargetMode="External"/></Relationships>
</file>

<file path=ppt/charts/_rels/chart3.xml.rels><?xml version="1.0" encoding="UTF-8" standalone="yes"?>
<Relationships xmlns="http://schemas.openxmlformats.org/package/2006/relationships"><Relationship Id="rId3" Type="http://schemas.openxmlformats.org/officeDocument/2006/relationships/themeOverride" Target="../theme/themeOverride2.xml"/><Relationship Id="rId2" Type="http://schemas.microsoft.com/office/2011/relationships/chartColorStyle" Target="colors3.xml"/><Relationship Id="rId1" Type="http://schemas.microsoft.com/office/2011/relationships/chartStyle" Target="style3.xml"/><Relationship Id="rId4" Type="http://schemas.openxmlformats.org/officeDocument/2006/relationships/oleObject" Target="file:///\\Users\rickkim\Google%20Drive\School\1.%20Current%20Research\0.%20RMT2%20Methylation\0.%20RT-qPCR\Combined_RMT2_CCM_Genes.xlsx" TargetMode="External"/></Relationships>
</file>

<file path=ppt/charts/_rels/chart4.xml.rels><?xml version="1.0" encoding="UTF-8" standalone="yes"?>
<Relationships xmlns="http://schemas.openxmlformats.org/package/2006/relationships"><Relationship Id="rId3" Type="http://schemas.openxmlformats.org/officeDocument/2006/relationships/themeOverride" Target="../theme/themeOverride3.xml"/><Relationship Id="rId2" Type="http://schemas.microsoft.com/office/2011/relationships/chartColorStyle" Target="colors4.xml"/><Relationship Id="rId1" Type="http://schemas.microsoft.com/office/2011/relationships/chartStyle" Target="style4.xml"/><Relationship Id="rId4" Type="http://schemas.openxmlformats.org/officeDocument/2006/relationships/oleObject" Target="file:///\\Users\rickkim\Google%20Drive\School\1.%20Current%20Research\0.%20RMT2%20Methylation\0.%20RT-qPCR\Combined_RMT2_CCM_Genes.xlsx" TargetMode="External"/></Relationships>
</file>

<file path=ppt/charts/_rels/chart5.xml.rels><?xml version="1.0" encoding="UTF-8" standalone="yes"?>
<Relationships xmlns="http://schemas.openxmlformats.org/package/2006/relationships"><Relationship Id="rId3" Type="http://schemas.openxmlformats.org/officeDocument/2006/relationships/themeOverride" Target="../theme/themeOverride4.xml"/><Relationship Id="rId2" Type="http://schemas.microsoft.com/office/2011/relationships/chartColorStyle" Target="colors5.xml"/><Relationship Id="rId1" Type="http://schemas.microsoft.com/office/2011/relationships/chartStyle" Target="style5.xml"/><Relationship Id="rId4" Type="http://schemas.openxmlformats.org/officeDocument/2006/relationships/oleObject" Target="file:///\\Users\rickkim\Google%20Drive\School\1.%20Current%20Research\0.%20RMT2%20Methylation\0.%20RT-qPCR\Combined_RMT2_CCM_Genes.xlsx" TargetMode="External"/></Relationships>
</file>

<file path=ppt/charts/_rels/chart6.xml.rels><?xml version="1.0" encoding="UTF-8" standalone="yes"?>
<Relationships xmlns="http://schemas.openxmlformats.org/package/2006/relationships"><Relationship Id="rId3" Type="http://schemas.openxmlformats.org/officeDocument/2006/relationships/oleObject" Target="file:///\\Users\rick_kim\Google%20Drive\School\1.%20RMT2\0.%20qPCR%20done%20by%20Justin\Normalized\Result%20qPCR%20psaC_PSAD_PSAE_cblp.xlsx" TargetMode="External"/><Relationship Id="rId2" Type="http://schemas.microsoft.com/office/2011/relationships/chartColorStyle" Target="colors6.xml"/><Relationship Id="rId1" Type="http://schemas.microsoft.com/office/2011/relationships/chartStyle" Target="style6.xml"/></Relationships>
</file>

<file path=ppt/charts/_rels/chart7.xml.rels><?xml version="1.0" encoding="UTF-8" standalone="yes"?>
<Relationships xmlns="http://schemas.openxmlformats.org/package/2006/relationships"><Relationship Id="rId3" Type="http://schemas.openxmlformats.org/officeDocument/2006/relationships/oleObject" Target="file:///\\Users\rick_kim\Google%20Drive\School\1.%20RMT2\0.%20RMT2-P700\2020.3.16.%20Dark%20PSI%20in%20rmt2\200423_RMT2_combined.xlsx" TargetMode="External"/><Relationship Id="rId2" Type="http://schemas.microsoft.com/office/2011/relationships/chartColorStyle" Target="colors7.xml"/><Relationship Id="rId1" Type="http://schemas.microsoft.com/office/2011/relationships/chartStyle" Target="style7.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600" b="1" i="0" u="none" strike="noStrike" kern="1200" spc="0" baseline="0">
                <a:solidFill>
                  <a:schemeClr val="tx1"/>
                </a:solidFill>
                <a:latin typeface="Times New Roman" panose="02020603050405020304" pitchFamily="18" charset="0"/>
                <a:ea typeface="Times New Roman" charset="0"/>
                <a:cs typeface="Times New Roman" panose="02020603050405020304" pitchFamily="18" charset="0"/>
              </a:defRPr>
            </a:pPr>
            <a:r>
              <a:rPr lang="en-US" sz="1600" b="1" dirty="0" err="1"/>
              <a:t>Chl</a:t>
            </a:r>
            <a:r>
              <a:rPr lang="en-US" sz="1600" b="1" dirty="0"/>
              <a:t> Growth</a:t>
            </a:r>
          </a:p>
        </c:rich>
      </c:tx>
      <c:overlay val="0"/>
      <c:spPr>
        <a:noFill/>
        <a:ln>
          <a:noFill/>
        </a:ln>
        <a:effectLst/>
      </c:spPr>
      <c:txPr>
        <a:bodyPr rot="0" spcFirstLastPara="1" vertOverflow="ellipsis" vert="horz" wrap="square" anchor="ctr" anchorCtr="1"/>
        <a:lstStyle/>
        <a:p>
          <a:pPr>
            <a:defRPr sz="1600" b="1" i="0" u="none" strike="noStrike" kern="1200" spc="0" baseline="0">
              <a:solidFill>
                <a:schemeClr val="tx1"/>
              </a:solidFill>
              <a:latin typeface="Times New Roman" panose="02020603050405020304" pitchFamily="18" charset="0"/>
              <a:ea typeface="Times New Roman" charset="0"/>
              <a:cs typeface="Times New Roman" panose="02020603050405020304" pitchFamily="18" charset="0"/>
            </a:defRPr>
          </a:pPr>
          <a:endParaRPr lang="en-US"/>
        </a:p>
      </c:txPr>
    </c:title>
    <c:autoTitleDeleted val="0"/>
    <c:plotArea>
      <c:layout>
        <c:manualLayout>
          <c:layoutTarget val="inner"/>
          <c:xMode val="edge"/>
          <c:yMode val="edge"/>
          <c:x val="0.15351310346053484"/>
          <c:y val="0.14273111359300897"/>
          <c:w val="0.84256398808201238"/>
          <c:h val="0.70501772855107891"/>
        </c:manualLayout>
      </c:layout>
      <c:barChart>
        <c:barDir val="col"/>
        <c:grouping val="clustered"/>
        <c:varyColors val="0"/>
        <c:ser>
          <c:idx val="0"/>
          <c:order val="0"/>
          <c:tx>
            <c:strRef>
              <c:f>Sheet1!$B$13</c:f>
              <c:strCache>
                <c:ptCount val="1"/>
                <c:pt idx="0">
                  <c:v>WT</c:v>
                </c:pt>
              </c:strCache>
            </c:strRef>
          </c:tx>
          <c:spPr>
            <a:solidFill>
              <a:schemeClr val="tx1">
                <a:lumMod val="75000"/>
                <a:lumOff val="25000"/>
              </a:schemeClr>
            </a:solidFill>
            <a:ln>
              <a:noFill/>
            </a:ln>
            <a:effectLst/>
          </c:spPr>
          <c:invertIfNegative val="0"/>
          <c:errBars>
            <c:errBarType val="both"/>
            <c:errValType val="cust"/>
            <c:noEndCap val="0"/>
            <c:plus>
              <c:numRef>
                <c:f>Sheet1!$C$18:$G$18</c:f>
                <c:numCache>
                  <c:formatCode>General</c:formatCode>
                  <c:ptCount val="5"/>
                  <c:pt idx="0">
                    <c:v>9.8994949366117052E-2</c:v>
                  </c:pt>
                  <c:pt idx="1">
                    <c:v>0.93338095116624298</c:v>
                  </c:pt>
                  <c:pt idx="2">
                    <c:v>0.31112698372207931</c:v>
                  </c:pt>
                  <c:pt idx="3">
                    <c:v>0.31112698372207931</c:v>
                  </c:pt>
                  <c:pt idx="4">
                    <c:v>0.39597979746446316</c:v>
                  </c:pt>
                </c:numCache>
              </c:numRef>
            </c:plus>
            <c:minus>
              <c:numRef>
                <c:f>Sheet1!$C$18:$G$18</c:f>
                <c:numCache>
                  <c:formatCode>General</c:formatCode>
                  <c:ptCount val="5"/>
                  <c:pt idx="0">
                    <c:v>9.8994949366117052E-2</c:v>
                  </c:pt>
                  <c:pt idx="1">
                    <c:v>0.93338095116624298</c:v>
                  </c:pt>
                  <c:pt idx="2">
                    <c:v>0.31112698372207931</c:v>
                  </c:pt>
                  <c:pt idx="3">
                    <c:v>0.31112698372207931</c:v>
                  </c:pt>
                  <c:pt idx="4">
                    <c:v>0.39597979746446316</c:v>
                  </c:pt>
                </c:numCache>
              </c:numRef>
            </c:minus>
            <c:spPr>
              <a:noFill/>
              <a:ln w="9525" cap="flat" cmpd="sng" algn="ctr">
                <a:solidFill>
                  <a:schemeClr val="tx1">
                    <a:lumMod val="65000"/>
                    <a:lumOff val="35000"/>
                  </a:schemeClr>
                </a:solidFill>
                <a:round/>
              </a:ln>
              <a:effectLst/>
            </c:spPr>
          </c:errBars>
          <c:cat>
            <c:numRef>
              <c:f>Sheet1!$C$12:$G$12</c:f>
              <c:numCache>
                <c:formatCode>General</c:formatCode>
                <c:ptCount val="5"/>
                <c:pt idx="0">
                  <c:v>20</c:v>
                </c:pt>
                <c:pt idx="1">
                  <c:v>50</c:v>
                </c:pt>
                <c:pt idx="2">
                  <c:v>100</c:v>
                </c:pt>
                <c:pt idx="3">
                  <c:v>200</c:v>
                </c:pt>
                <c:pt idx="4">
                  <c:v>500</c:v>
                </c:pt>
              </c:numCache>
            </c:numRef>
          </c:cat>
          <c:val>
            <c:numRef>
              <c:f>Sheet1!$C$13:$G$13</c:f>
              <c:numCache>
                <c:formatCode>General</c:formatCode>
                <c:ptCount val="5"/>
                <c:pt idx="0">
                  <c:v>26.94</c:v>
                </c:pt>
                <c:pt idx="1">
                  <c:v>33.510000000000005</c:v>
                </c:pt>
                <c:pt idx="2">
                  <c:v>37.06</c:v>
                </c:pt>
                <c:pt idx="3">
                  <c:v>40.06</c:v>
                </c:pt>
                <c:pt idx="4">
                  <c:v>36.700000000000003</c:v>
                </c:pt>
              </c:numCache>
            </c:numRef>
          </c:val>
          <c:extLst>
            <c:ext xmlns:c16="http://schemas.microsoft.com/office/drawing/2014/chart" uri="{C3380CC4-5D6E-409C-BE32-E72D297353CC}">
              <c16:uniqueId val="{00000000-6CDA-DF4A-8048-A161D94670FF}"/>
            </c:ext>
          </c:extLst>
        </c:ser>
        <c:ser>
          <c:idx val="1"/>
          <c:order val="1"/>
          <c:tx>
            <c:strRef>
              <c:f>Sheet1!$B$14</c:f>
              <c:strCache>
                <c:ptCount val="1"/>
                <c:pt idx="0">
                  <c:v>rmt2</c:v>
                </c:pt>
              </c:strCache>
            </c:strRef>
          </c:tx>
          <c:spPr>
            <a:solidFill>
              <a:srgbClr val="FF0000"/>
            </a:solidFill>
            <a:ln>
              <a:noFill/>
            </a:ln>
            <a:effectLst/>
          </c:spPr>
          <c:invertIfNegative val="0"/>
          <c:errBars>
            <c:errBarType val="both"/>
            <c:errValType val="cust"/>
            <c:noEndCap val="0"/>
            <c:plus>
              <c:numRef>
                <c:f>Sheet1!$C$19:$G$19</c:f>
                <c:numCache>
                  <c:formatCode>General</c:formatCode>
                  <c:ptCount val="5"/>
                  <c:pt idx="0">
                    <c:v>0.12020815280171177</c:v>
                  </c:pt>
                  <c:pt idx="1">
                    <c:v>0.16970562748477031</c:v>
                  </c:pt>
                  <c:pt idx="2">
                    <c:v>0.5303300858899106</c:v>
                  </c:pt>
                  <c:pt idx="3">
                    <c:v>2.1213203435596427E-2</c:v>
                  </c:pt>
                  <c:pt idx="4">
                    <c:v>2.121320343559624E-2</c:v>
                  </c:pt>
                </c:numCache>
              </c:numRef>
            </c:plus>
            <c:minus>
              <c:numRef>
                <c:f>Sheet1!$C$19:$G$19</c:f>
                <c:numCache>
                  <c:formatCode>General</c:formatCode>
                  <c:ptCount val="5"/>
                  <c:pt idx="0">
                    <c:v>0.12020815280171177</c:v>
                  </c:pt>
                  <c:pt idx="1">
                    <c:v>0.16970562748477031</c:v>
                  </c:pt>
                  <c:pt idx="2">
                    <c:v>0.5303300858899106</c:v>
                  </c:pt>
                  <c:pt idx="3">
                    <c:v>2.1213203435596427E-2</c:v>
                  </c:pt>
                  <c:pt idx="4">
                    <c:v>2.121320343559624E-2</c:v>
                  </c:pt>
                </c:numCache>
              </c:numRef>
            </c:minus>
            <c:spPr>
              <a:noFill/>
              <a:ln w="9525" cap="flat" cmpd="sng" algn="ctr">
                <a:solidFill>
                  <a:schemeClr val="tx1">
                    <a:lumMod val="65000"/>
                    <a:lumOff val="35000"/>
                  </a:schemeClr>
                </a:solidFill>
                <a:round/>
              </a:ln>
              <a:effectLst/>
            </c:spPr>
          </c:errBars>
          <c:cat>
            <c:numRef>
              <c:f>Sheet1!$C$12:$G$12</c:f>
              <c:numCache>
                <c:formatCode>General</c:formatCode>
                <c:ptCount val="5"/>
                <c:pt idx="0">
                  <c:v>20</c:v>
                </c:pt>
                <c:pt idx="1">
                  <c:v>50</c:v>
                </c:pt>
                <c:pt idx="2">
                  <c:v>100</c:v>
                </c:pt>
                <c:pt idx="3">
                  <c:v>200</c:v>
                </c:pt>
                <c:pt idx="4">
                  <c:v>500</c:v>
                </c:pt>
              </c:numCache>
            </c:numRef>
          </c:cat>
          <c:val>
            <c:numRef>
              <c:f>Sheet1!$C$14:$G$14</c:f>
              <c:numCache>
                <c:formatCode>General</c:formatCode>
                <c:ptCount val="5"/>
                <c:pt idx="0">
                  <c:v>21.405000000000001</c:v>
                </c:pt>
                <c:pt idx="1">
                  <c:v>22.740000000000002</c:v>
                </c:pt>
                <c:pt idx="2">
                  <c:v>5.5049999999999999</c:v>
                </c:pt>
                <c:pt idx="3">
                  <c:v>0.17499999999999999</c:v>
                </c:pt>
                <c:pt idx="4">
                  <c:v>0.14500000000000002</c:v>
                </c:pt>
              </c:numCache>
            </c:numRef>
          </c:val>
          <c:extLst>
            <c:ext xmlns:c16="http://schemas.microsoft.com/office/drawing/2014/chart" uri="{C3380CC4-5D6E-409C-BE32-E72D297353CC}">
              <c16:uniqueId val="{00000001-6CDA-DF4A-8048-A161D94670FF}"/>
            </c:ext>
          </c:extLst>
        </c:ser>
        <c:dLbls>
          <c:showLegendKey val="0"/>
          <c:showVal val="0"/>
          <c:showCatName val="0"/>
          <c:showSerName val="0"/>
          <c:showPercent val="0"/>
          <c:showBubbleSize val="0"/>
        </c:dLbls>
        <c:gapWidth val="50"/>
        <c:axId val="897306496"/>
        <c:axId val="897089600"/>
      </c:barChart>
      <c:catAx>
        <c:axId val="897306496"/>
        <c:scaling>
          <c:orientation val="minMax"/>
        </c:scaling>
        <c:delete val="0"/>
        <c:axPos val="b"/>
        <c:title>
          <c:tx>
            <c:rich>
              <a:bodyPr rot="0" spcFirstLastPara="1" vertOverflow="ellipsis" vert="horz" wrap="square" anchor="ctr" anchorCtr="1"/>
              <a:lstStyle/>
              <a:p>
                <a:pPr>
                  <a:defRPr sz="1400" b="1" i="0" u="none" strike="noStrike" kern="1200" baseline="0">
                    <a:solidFill>
                      <a:schemeClr val="tx1"/>
                    </a:solidFill>
                    <a:latin typeface="Times New Roman" panose="02020603050405020304" pitchFamily="18" charset="0"/>
                    <a:ea typeface="Times New Roman" charset="0"/>
                    <a:cs typeface="Times New Roman" panose="02020603050405020304" pitchFamily="18" charset="0"/>
                  </a:defRPr>
                </a:pPr>
                <a:r>
                  <a:rPr lang="en-US" sz="1400" b="1"/>
                  <a:t>Light intensity (</a:t>
                </a:r>
                <a:r>
                  <a:rPr lang="el-GR" sz="1400" b="1"/>
                  <a:t>μ</a:t>
                </a:r>
                <a:r>
                  <a:rPr lang="en-US" sz="1400" b="1"/>
                  <a:t>E)</a:t>
                </a:r>
              </a:p>
            </c:rich>
          </c:tx>
          <c:layout>
            <c:manualLayout>
              <c:xMode val="edge"/>
              <c:yMode val="edge"/>
              <c:x val="0.32714929979493002"/>
              <c:y val="0.92146408958747705"/>
            </c:manualLayout>
          </c:layout>
          <c:overlay val="0"/>
          <c:spPr>
            <a:noFill/>
            <a:ln>
              <a:noFill/>
            </a:ln>
            <a:effectLst/>
          </c:spPr>
          <c:txPr>
            <a:bodyPr rot="0" spcFirstLastPara="1" vertOverflow="ellipsis" vert="horz" wrap="square" anchor="ctr" anchorCtr="1"/>
            <a:lstStyle/>
            <a:p>
              <a:pPr>
                <a:defRPr sz="1400" b="1" i="0" u="none" strike="noStrike" kern="1200" baseline="0">
                  <a:solidFill>
                    <a:schemeClr val="tx1"/>
                  </a:solidFill>
                  <a:latin typeface="Times New Roman" panose="02020603050405020304" pitchFamily="18" charset="0"/>
                  <a:ea typeface="Times New Roman" charset="0"/>
                  <a:cs typeface="Times New Roman" panose="02020603050405020304" pitchFamily="18" charset="0"/>
                </a:defRPr>
              </a:pPr>
              <a:endParaRPr lang="en-US"/>
            </a:p>
          </c:txPr>
        </c:title>
        <c:numFmt formatCode="General" sourceLinked="1"/>
        <c:majorTickMark val="none"/>
        <c:minorTickMark val="none"/>
        <c:tickLblPos val="nextTo"/>
        <c:spPr>
          <a:noFill/>
          <a:ln w="9525" cap="flat" cmpd="sng" algn="ctr">
            <a:solidFill>
              <a:schemeClr val="tx1">
                <a:lumMod val="50000"/>
                <a:lumOff val="50000"/>
              </a:schemeClr>
            </a:solidFill>
            <a:round/>
          </a:ln>
          <a:effectLst/>
        </c:spPr>
        <c:txPr>
          <a:bodyPr rot="-6000000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Times New Roman" charset="0"/>
                <a:cs typeface="Times New Roman" panose="02020603050405020304" pitchFamily="18" charset="0"/>
              </a:defRPr>
            </a:pPr>
            <a:endParaRPr lang="en-US"/>
          </a:p>
        </c:txPr>
        <c:crossAx val="897089600"/>
        <c:crosses val="autoZero"/>
        <c:auto val="1"/>
        <c:lblAlgn val="ctr"/>
        <c:lblOffset val="100"/>
        <c:noMultiLvlLbl val="0"/>
      </c:catAx>
      <c:valAx>
        <c:axId val="897089600"/>
        <c:scaling>
          <c:orientation val="minMax"/>
          <c:max val="50"/>
        </c:scaling>
        <c:delete val="0"/>
        <c:axPos val="l"/>
        <c:title>
          <c:tx>
            <c:rich>
              <a:bodyPr rot="-5400000" spcFirstLastPara="1" vertOverflow="ellipsis" vert="horz" wrap="square" anchor="ctr" anchorCtr="1"/>
              <a:lstStyle/>
              <a:p>
                <a:pPr>
                  <a:defRPr sz="1400" b="1" i="0" u="none" strike="noStrike" kern="1200" baseline="0">
                    <a:solidFill>
                      <a:schemeClr val="tx1"/>
                    </a:solidFill>
                    <a:latin typeface="Times New Roman" panose="02020603050405020304" pitchFamily="18" charset="0"/>
                    <a:ea typeface="Times New Roman" charset="0"/>
                    <a:cs typeface="Times New Roman" panose="02020603050405020304" pitchFamily="18" charset="0"/>
                  </a:defRPr>
                </a:pPr>
                <a:r>
                  <a:rPr lang="en-US" sz="1400" b="1"/>
                  <a:t>Chl concentration (</a:t>
                </a:r>
                <a:r>
                  <a:rPr lang="el-GR" sz="1400" b="1"/>
                  <a:t>μ</a:t>
                </a:r>
                <a:r>
                  <a:rPr lang="en-US" sz="1400" b="1"/>
                  <a:t>g/mL)</a:t>
                </a:r>
              </a:p>
            </c:rich>
          </c:tx>
          <c:layout>
            <c:manualLayout>
              <c:xMode val="edge"/>
              <c:yMode val="edge"/>
              <c:x val="4.5771318802641497E-3"/>
              <c:y val="0.15759966341752699"/>
            </c:manualLayout>
          </c:layout>
          <c:overlay val="0"/>
          <c:spPr>
            <a:noFill/>
            <a:ln>
              <a:noFill/>
            </a:ln>
            <a:effectLst/>
          </c:spPr>
          <c:txPr>
            <a:bodyPr rot="-5400000" spcFirstLastPara="1" vertOverflow="ellipsis" vert="horz" wrap="square" anchor="ctr" anchorCtr="1"/>
            <a:lstStyle/>
            <a:p>
              <a:pPr>
                <a:defRPr sz="1400" b="1" i="0" u="none" strike="noStrike" kern="1200" baseline="0">
                  <a:solidFill>
                    <a:schemeClr val="tx1"/>
                  </a:solidFill>
                  <a:latin typeface="Times New Roman" panose="02020603050405020304" pitchFamily="18" charset="0"/>
                  <a:ea typeface="Times New Roman" charset="0"/>
                  <a:cs typeface="Times New Roman" panose="02020603050405020304" pitchFamily="18" charset="0"/>
                </a:defRPr>
              </a:pPr>
              <a:endParaRPr lang="en-US"/>
            </a:p>
          </c:txPr>
        </c:title>
        <c:numFmt formatCode="General" sourceLinked="1"/>
        <c:majorTickMark val="none"/>
        <c:minorTickMark val="none"/>
        <c:tickLblPos val="nextTo"/>
        <c:spPr>
          <a:noFill/>
          <a:ln>
            <a:solidFill>
              <a:schemeClr val="tx1">
                <a:lumMod val="50000"/>
                <a:lumOff val="50000"/>
              </a:schemeClr>
            </a:solidFill>
          </a:ln>
          <a:effectLst/>
        </c:spPr>
        <c:txPr>
          <a:bodyPr rot="-6000000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Times New Roman" charset="0"/>
                <a:cs typeface="Times New Roman" panose="02020603050405020304" pitchFamily="18" charset="0"/>
              </a:defRPr>
            </a:pPr>
            <a:endParaRPr lang="en-US"/>
          </a:p>
        </c:txPr>
        <c:crossAx val="897306496"/>
        <c:crosses val="autoZero"/>
        <c:crossBetween val="between"/>
        <c:majorUnit val="10"/>
      </c:valAx>
      <c:spPr>
        <a:noFill/>
        <a:ln>
          <a:noFill/>
        </a:ln>
        <a:effectLst/>
      </c:spPr>
    </c:plotArea>
    <c:legend>
      <c:legendPos val="b"/>
      <c:legendEntry>
        <c:idx val="1"/>
        <c:txPr>
          <a:bodyPr rot="0" spcFirstLastPara="1" vertOverflow="ellipsis" vert="horz" wrap="square" anchor="ctr" anchorCtr="1"/>
          <a:lstStyle/>
          <a:p>
            <a:pPr>
              <a:defRPr sz="1200" b="1" i="1" u="none" strike="noStrike" kern="1200" baseline="0">
                <a:solidFill>
                  <a:schemeClr val="tx1"/>
                </a:solidFill>
                <a:latin typeface="Times New Roman" panose="02020603050405020304" pitchFamily="18" charset="0"/>
                <a:ea typeface="Times New Roman" charset="0"/>
                <a:cs typeface="Times New Roman" panose="02020603050405020304" pitchFamily="18" charset="0"/>
              </a:defRPr>
            </a:pPr>
            <a:endParaRPr lang="en-US"/>
          </a:p>
        </c:txPr>
      </c:legendEntry>
      <c:layout>
        <c:manualLayout>
          <c:xMode val="edge"/>
          <c:yMode val="edge"/>
          <c:x val="0.7978331073920697"/>
          <c:y val="7.2182213757073704E-2"/>
          <c:w val="0.18556765978003273"/>
          <c:h val="0.18729792614537089"/>
        </c:manualLayout>
      </c:layout>
      <c:overlay val="0"/>
      <c:spPr>
        <a:noFill/>
        <a:ln>
          <a:noFill/>
        </a:ln>
        <a:effectLst/>
      </c:spPr>
      <c:txPr>
        <a:bodyPr rot="0" spcFirstLastPara="1" vertOverflow="ellipsis" vert="horz" wrap="square" anchor="ctr" anchorCtr="1"/>
        <a:lstStyle/>
        <a:p>
          <a:pPr>
            <a:defRPr sz="1200" b="1" i="0" u="none" strike="noStrike" kern="1200" baseline="0">
              <a:solidFill>
                <a:schemeClr val="tx1"/>
              </a:solidFill>
              <a:latin typeface="Times New Roman" panose="02020603050405020304" pitchFamily="18" charset="0"/>
              <a:ea typeface="Times New Roman" charset="0"/>
              <a:cs typeface="Times New Roman" panose="02020603050405020304" pitchFamily="18" charset="0"/>
            </a:defRPr>
          </a:pPr>
          <a:endParaRPr lang="en-US"/>
        </a:p>
      </c:txPr>
    </c:legend>
    <c:plotVisOnly val="1"/>
    <c:dispBlanksAs val="gap"/>
    <c:showDLblsOverMax val="0"/>
  </c:chart>
  <c:spPr>
    <a:noFill/>
    <a:ln>
      <a:noFill/>
    </a:ln>
    <a:effectLst/>
  </c:spPr>
  <c:txPr>
    <a:bodyPr/>
    <a:lstStyle/>
    <a:p>
      <a:pPr>
        <a:defRPr sz="1200">
          <a:solidFill>
            <a:schemeClr val="tx1"/>
          </a:solidFill>
          <a:latin typeface="Times New Roman" panose="02020603050405020304" pitchFamily="18" charset="0"/>
          <a:ea typeface="Times New Roman" charset="0"/>
          <a:cs typeface="Times New Roman" panose="02020603050405020304" pitchFamily="18" charset="0"/>
        </a:defRPr>
      </a:pPr>
      <a:endParaRPr lang="en-US"/>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a:solidFill>
                  <a:schemeClr val="tx1"/>
                </a:solidFill>
              </a:rPr>
              <a:t>Protein Levels by MS in rmt2</a:t>
            </a:r>
            <a:r>
              <a:rPr lang="en-US" baseline="0">
                <a:solidFill>
                  <a:schemeClr val="tx1"/>
                </a:solidFill>
              </a:rPr>
              <a:t> compared to </a:t>
            </a:r>
            <a:r>
              <a:rPr lang="en-US">
                <a:solidFill>
                  <a:schemeClr val="tx1"/>
                </a:solidFill>
              </a:rPr>
              <a:t>WT</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barChart>
        <c:barDir val="col"/>
        <c:grouping val="clustered"/>
        <c:varyColors val="0"/>
        <c:ser>
          <c:idx val="0"/>
          <c:order val="0"/>
          <c:spPr>
            <a:solidFill>
              <a:schemeClr val="accent1"/>
            </a:solidFill>
            <a:ln>
              <a:noFill/>
            </a:ln>
            <a:effectLst/>
          </c:spPr>
          <c:invertIfNegative val="0"/>
          <c:errBars>
            <c:errBarType val="plus"/>
            <c:errValType val="cust"/>
            <c:noEndCap val="0"/>
            <c:plus>
              <c:numRef>
                <c:f>Summary!$U$2:$U$7</c:f>
                <c:numCache>
                  <c:formatCode>General</c:formatCode>
                  <c:ptCount val="6"/>
                  <c:pt idx="0">
                    <c:v>0.10569795890831735</c:v>
                  </c:pt>
                  <c:pt idx="1">
                    <c:v>4.7960603412076162E-2</c:v>
                  </c:pt>
                  <c:pt idx="2">
                    <c:v>7.7935034871964265E-2</c:v>
                  </c:pt>
                  <c:pt idx="3">
                    <c:v>0.10301744312371369</c:v>
                  </c:pt>
                  <c:pt idx="4">
                    <c:v>5.3251794201829725E-2</c:v>
                  </c:pt>
                  <c:pt idx="5">
                    <c:v>0.16411768211251479</c:v>
                  </c:pt>
                </c:numCache>
              </c:numRef>
            </c:plus>
            <c:minus>
              <c:numLit>
                <c:formatCode>General</c:formatCode>
                <c:ptCount val="1"/>
                <c:pt idx="0">
                  <c:v>1</c:v>
                </c:pt>
              </c:numLit>
            </c:minus>
            <c:spPr>
              <a:noFill/>
              <a:ln w="9525" cap="flat" cmpd="sng" algn="ctr">
                <a:solidFill>
                  <a:schemeClr val="tx1">
                    <a:lumMod val="65000"/>
                    <a:lumOff val="35000"/>
                  </a:schemeClr>
                </a:solidFill>
                <a:round/>
              </a:ln>
              <a:effectLst/>
            </c:spPr>
          </c:errBars>
          <c:cat>
            <c:strRef>
              <c:f>Summary!$R$2:$R$7</c:f>
              <c:strCache>
                <c:ptCount val="6"/>
                <c:pt idx="0">
                  <c:v>ATP syn</c:v>
                </c:pt>
                <c:pt idx="1">
                  <c:v>cyt b6f</c:v>
                </c:pt>
                <c:pt idx="2">
                  <c:v>PSI</c:v>
                </c:pt>
                <c:pt idx="3">
                  <c:v>PSII</c:v>
                </c:pt>
                <c:pt idx="4">
                  <c:v>LHC1</c:v>
                </c:pt>
                <c:pt idx="5">
                  <c:v>LHC2</c:v>
                </c:pt>
              </c:strCache>
            </c:strRef>
          </c:cat>
          <c:val>
            <c:numRef>
              <c:f>Summary!$T$2:$T$7</c:f>
              <c:numCache>
                <c:formatCode>General</c:formatCode>
                <c:ptCount val="6"/>
                <c:pt idx="0">
                  <c:v>0.54844817932166501</c:v>
                </c:pt>
                <c:pt idx="1">
                  <c:v>0.70483750079296814</c:v>
                </c:pt>
                <c:pt idx="2">
                  <c:v>0.20014806533320725</c:v>
                </c:pt>
                <c:pt idx="3">
                  <c:v>0.61967274085010593</c:v>
                </c:pt>
                <c:pt idx="4">
                  <c:v>0.57667598875758996</c:v>
                </c:pt>
                <c:pt idx="5">
                  <c:v>0.6895622003530677</c:v>
                </c:pt>
              </c:numCache>
            </c:numRef>
          </c:val>
          <c:extLst>
            <c:ext xmlns:c16="http://schemas.microsoft.com/office/drawing/2014/chart" uri="{C3380CC4-5D6E-409C-BE32-E72D297353CC}">
              <c16:uniqueId val="{00000000-9D81-C84B-9F05-E90CBCE4A04C}"/>
            </c:ext>
          </c:extLst>
        </c:ser>
        <c:dLbls>
          <c:showLegendKey val="0"/>
          <c:showVal val="0"/>
          <c:showCatName val="0"/>
          <c:showSerName val="0"/>
          <c:showPercent val="0"/>
          <c:showBubbleSize val="0"/>
        </c:dLbls>
        <c:gapWidth val="219"/>
        <c:overlap val="-27"/>
        <c:axId val="657163568"/>
        <c:axId val="671790544"/>
      </c:barChart>
      <c:catAx>
        <c:axId val="657163568"/>
        <c:scaling>
          <c:orientation val="minMax"/>
        </c:scaling>
        <c:delete val="0"/>
        <c:axPos val="b"/>
        <c:numFmt formatCode="General" sourceLinked="1"/>
        <c:majorTickMark val="none"/>
        <c:minorTickMark val="none"/>
        <c:tickLblPos val="nextTo"/>
        <c:spPr>
          <a:noFill/>
          <a:ln w="9525" cap="flat" cmpd="sng" algn="ctr">
            <a:solidFill>
              <a:srgbClr val="000000"/>
            </a:solidFill>
            <a:round/>
          </a:ln>
          <a:effectLst/>
        </c:spPr>
        <c:txPr>
          <a:bodyPr rot="-6000000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en-US"/>
          </a:p>
        </c:txPr>
        <c:crossAx val="671790544"/>
        <c:crosses val="autoZero"/>
        <c:auto val="1"/>
        <c:lblAlgn val="ctr"/>
        <c:lblOffset val="100"/>
        <c:noMultiLvlLbl val="0"/>
      </c:catAx>
      <c:valAx>
        <c:axId val="671790544"/>
        <c:scaling>
          <c:orientation val="minMax"/>
          <c:max val="1"/>
        </c:scaling>
        <c:delete val="0"/>
        <c:axPos val="l"/>
        <c:majorGridlines>
          <c:spPr>
            <a:ln w="9525" cap="flat" cmpd="sng" algn="ctr">
              <a:solidFill>
                <a:schemeClr val="tx1">
                  <a:lumMod val="15000"/>
                  <a:lumOff val="85000"/>
                </a:schemeClr>
              </a:solidFill>
              <a:round/>
            </a:ln>
            <a:effectLst/>
          </c:spPr>
        </c:majorGridlines>
        <c:title>
          <c:tx>
            <c:rich>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r>
                  <a:rPr lang="en-US" sz="1100" dirty="0">
                    <a:solidFill>
                      <a:schemeClr val="tx1"/>
                    </a:solidFill>
                  </a:rPr>
                  <a:t>Average of relative protein levels in rmt2 cells </a:t>
                </a:r>
              </a:p>
            </c:rich>
          </c:tx>
          <c:layout>
            <c:manualLayout>
              <c:xMode val="edge"/>
              <c:yMode val="edge"/>
              <c:x val="8.8397790055248626E-3"/>
              <c:y val="0.15187174226461128"/>
            </c:manualLayout>
          </c:layout>
          <c:overlay val="0"/>
          <c:spPr>
            <a:noFill/>
            <a:ln>
              <a:noFill/>
            </a:ln>
            <a:effectLst/>
          </c:spPr>
          <c:txPr>
            <a:bodyPr rot="-5400000" spcFirstLastPara="1" vertOverflow="ellipsis" vert="horz" wrap="square" anchor="ctr" anchorCtr="1"/>
            <a:lstStyle/>
            <a:p>
              <a:pPr>
                <a:defRPr sz="1100" b="0" i="0" u="none" strike="noStrike" kern="1200" baseline="0">
                  <a:solidFill>
                    <a:schemeClr val="tx1"/>
                  </a:solidFill>
                  <a:latin typeface="+mn-lt"/>
                  <a:ea typeface="+mn-ea"/>
                  <a:cs typeface="+mn-cs"/>
                </a:defRPr>
              </a:pPr>
              <a:endParaRPr lang="en-US"/>
            </a:p>
          </c:txPr>
        </c:title>
        <c:numFmt formatCode="General" sourceLinked="1"/>
        <c:majorTickMark val="in"/>
        <c:minorTickMark val="none"/>
        <c:tickLblPos val="nextTo"/>
        <c:spPr>
          <a:noFill/>
          <a:ln>
            <a:solidFill>
              <a:srgbClr val="000000"/>
            </a:solidFill>
          </a:ln>
          <a:effectLst/>
        </c:spPr>
        <c:txPr>
          <a:bodyPr rot="-60000000" spcFirstLastPara="1" vertOverflow="ellipsis" vert="horz" wrap="square" anchor="ctr" anchorCtr="1"/>
          <a:lstStyle/>
          <a:p>
            <a:pPr>
              <a:defRPr sz="900" b="0" i="0" u="none" strike="noStrike" kern="1200" baseline="0">
                <a:solidFill>
                  <a:schemeClr val="tx1"/>
                </a:solidFill>
                <a:latin typeface="+mn-lt"/>
                <a:ea typeface="+mn-ea"/>
                <a:cs typeface="+mn-cs"/>
              </a:defRPr>
            </a:pPr>
            <a:endParaRPr lang="en-US"/>
          </a:p>
        </c:txPr>
        <c:crossAx val="657163568"/>
        <c:crosses val="autoZero"/>
        <c:crossBetween val="between"/>
      </c:valAx>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pPr>
      <a:endParaRPr lang="en-US"/>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9846939705453485"/>
          <c:y val="3.2546561679790025E-2"/>
          <c:w val="0.69673055191017785"/>
          <c:h val="0.7649731708001084"/>
        </c:manualLayout>
      </c:layout>
      <c:lineChart>
        <c:grouping val="standard"/>
        <c:varyColors val="0"/>
        <c:ser>
          <c:idx val="0"/>
          <c:order val="0"/>
          <c:tx>
            <c:v>WT</c:v>
          </c:tx>
          <c:spPr>
            <a:ln w="25400" cap="rnd">
              <a:solidFill>
                <a:sysClr val="windowText" lastClr="000000"/>
              </a:solidFill>
              <a:round/>
            </a:ln>
            <a:effectLst/>
          </c:spPr>
          <c:marker>
            <c:symbol val="none"/>
          </c:marker>
          <c:errBars>
            <c:errDir val="y"/>
            <c:errBarType val="both"/>
            <c:errValType val="cust"/>
            <c:noEndCap val="0"/>
            <c:plus>
              <c:numRef>
                <c:f>CAH1_CCP1_LCI1_combined!$U$93:$X$93</c:f>
                <c:numCache>
                  <c:formatCode>General</c:formatCode>
                  <c:ptCount val="4"/>
                  <c:pt idx="0">
                    <c:v>0.31862786989238073</c:v>
                  </c:pt>
                  <c:pt idx="1">
                    <c:v>37.352439235210703</c:v>
                  </c:pt>
                  <c:pt idx="2">
                    <c:v>7.469052357393676</c:v>
                  </c:pt>
                  <c:pt idx="3">
                    <c:v>15.411978039278479</c:v>
                  </c:pt>
                </c:numCache>
              </c:numRef>
            </c:plus>
            <c:minus>
              <c:numRef>
                <c:f>CAH1_CCP1_LCI1_combined!$U$93:$X$93</c:f>
                <c:numCache>
                  <c:formatCode>General</c:formatCode>
                  <c:ptCount val="4"/>
                  <c:pt idx="0">
                    <c:v>0.31862786989238073</c:v>
                  </c:pt>
                  <c:pt idx="1">
                    <c:v>37.352439235210703</c:v>
                  </c:pt>
                  <c:pt idx="2">
                    <c:v>7.469052357393676</c:v>
                  </c:pt>
                  <c:pt idx="3">
                    <c:v>15.411978039278479</c:v>
                  </c:pt>
                </c:numCache>
              </c:numRef>
            </c:minus>
            <c:spPr>
              <a:noFill/>
              <a:ln w="12700" cap="flat" cmpd="sng" algn="ctr">
                <a:solidFill>
                  <a:sysClr val="windowText" lastClr="000000"/>
                </a:solidFill>
                <a:round/>
              </a:ln>
              <a:effectLst/>
            </c:spPr>
          </c:errBars>
          <c:cat>
            <c:numRef>
              <c:f>CAH1_CCP1_LCI1_combined!$U$81:$X$81</c:f>
              <c:numCache>
                <c:formatCode>General</c:formatCode>
                <c:ptCount val="4"/>
                <c:pt idx="0">
                  <c:v>0</c:v>
                </c:pt>
                <c:pt idx="1">
                  <c:v>3</c:v>
                </c:pt>
                <c:pt idx="2">
                  <c:v>6</c:v>
                </c:pt>
                <c:pt idx="3">
                  <c:v>24</c:v>
                </c:pt>
              </c:numCache>
            </c:numRef>
          </c:cat>
          <c:val>
            <c:numRef>
              <c:f>CAH1_CCP1_LCI1_combined!$U$82:$X$82</c:f>
              <c:numCache>
                <c:formatCode>0</c:formatCode>
                <c:ptCount val="4"/>
                <c:pt idx="0" formatCode="0.00">
                  <c:v>1</c:v>
                </c:pt>
                <c:pt idx="1">
                  <c:v>1685.2569030069808</c:v>
                </c:pt>
                <c:pt idx="2">
                  <c:v>1555.9121459777534</c:v>
                </c:pt>
                <c:pt idx="3">
                  <c:v>4733.1039065382192</c:v>
                </c:pt>
              </c:numCache>
            </c:numRef>
          </c:val>
          <c:smooth val="0"/>
          <c:extLst>
            <c:ext xmlns:c16="http://schemas.microsoft.com/office/drawing/2014/chart" uri="{C3380CC4-5D6E-409C-BE32-E72D297353CC}">
              <c16:uniqueId val="{00000000-139B-0441-A1A8-9D68CE758E05}"/>
            </c:ext>
          </c:extLst>
        </c:ser>
        <c:ser>
          <c:idx val="1"/>
          <c:order val="1"/>
          <c:tx>
            <c:v>rmt2-1</c:v>
          </c:tx>
          <c:spPr>
            <a:ln w="25400" cap="rnd">
              <a:solidFill>
                <a:srgbClr val="4472C4"/>
              </a:solidFill>
              <a:prstDash val="solid"/>
              <a:round/>
            </a:ln>
            <a:effectLst/>
          </c:spPr>
          <c:marker>
            <c:symbol val="none"/>
          </c:marker>
          <c:errBars>
            <c:errDir val="y"/>
            <c:errBarType val="both"/>
            <c:errValType val="cust"/>
            <c:noEndCap val="0"/>
            <c:plus>
              <c:numRef>
                <c:f>CAH1_CCP1_LCI1_combined!$U$92:$X$92</c:f>
                <c:numCache>
                  <c:formatCode>General</c:formatCode>
                  <c:ptCount val="4"/>
                  <c:pt idx="0">
                    <c:v>0.46733033333808482</c:v>
                  </c:pt>
                  <c:pt idx="1">
                    <c:v>57.397418867113096</c:v>
                  </c:pt>
                  <c:pt idx="2">
                    <c:v>19.507538855774108</c:v>
                  </c:pt>
                  <c:pt idx="3">
                    <c:v>4.3346791539825169</c:v>
                  </c:pt>
                </c:numCache>
              </c:numRef>
            </c:plus>
            <c:minus>
              <c:numRef>
                <c:f>CAH1_CCP1_LCI1_combined!$U$92:$X$92</c:f>
                <c:numCache>
                  <c:formatCode>General</c:formatCode>
                  <c:ptCount val="4"/>
                  <c:pt idx="0">
                    <c:v>0.46733033333808482</c:v>
                  </c:pt>
                  <c:pt idx="1">
                    <c:v>57.397418867113096</c:v>
                  </c:pt>
                  <c:pt idx="2">
                    <c:v>19.507538855774108</c:v>
                  </c:pt>
                  <c:pt idx="3">
                    <c:v>4.3346791539825169</c:v>
                  </c:pt>
                </c:numCache>
              </c:numRef>
            </c:minus>
            <c:spPr>
              <a:noFill/>
              <a:ln w="12700" cap="flat" cmpd="sng" algn="ctr">
                <a:solidFill>
                  <a:sysClr val="windowText" lastClr="000000"/>
                </a:solidFill>
                <a:round/>
              </a:ln>
              <a:effectLst/>
            </c:spPr>
          </c:errBars>
          <c:cat>
            <c:numRef>
              <c:f>CAH1_CCP1_LCI1_combined!$U$81:$X$81</c:f>
              <c:numCache>
                <c:formatCode>General</c:formatCode>
                <c:ptCount val="4"/>
                <c:pt idx="0">
                  <c:v>0</c:v>
                </c:pt>
                <c:pt idx="1">
                  <c:v>3</c:v>
                </c:pt>
                <c:pt idx="2">
                  <c:v>6</c:v>
                </c:pt>
                <c:pt idx="3">
                  <c:v>24</c:v>
                </c:pt>
              </c:numCache>
            </c:numRef>
          </c:cat>
          <c:val>
            <c:numRef>
              <c:f>CAH1_CCP1_LCI1_combined!$U$83:$X$83</c:f>
              <c:numCache>
                <c:formatCode>0</c:formatCode>
                <c:ptCount val="4"/>
                <c:pt idx="0" formatCode="0.00">
                  <c:v>2.233796304883136</c:v>
                </c:pt>
                <c:pt idx="1">
                  <c:v>2342.369274604469</c:v>
                </c:pt>
                <c:pt idx="2">
                  <c:v>995.08423523586202</c:v>
                </c:pt>
                <c:pt idx="3">
                  <c:v>442.20480114998327</c:v>
                </c:pt>
              </c:numCache>
            </c:numRef>
          </c:val>
          <c:smooth val="0"/>
          <c:extLst>
            <c:ext xmlns:c16="http://schemas.microsoft.com/office/drawing/2014/chart" uri="{C3380CC4-5D6E-409C-BE32-E72D297353CC}">
              <c16:uniqueId val="{00000001-139B-0441-A1A8-9D68CE758E05}"/>
            </c:ext>
          </c:extLst>
        </c:ser>
        <c:ser>
          <c:idx val="2"/>
          <c:order val="2"/>
          <c:tx>
            <c:v>rmt2-2</c:v>
          </c:tx>
          <c:spPr>
            <a:ln w="25400" cap="rnd">
              <a:solidFill>
                <a:srgbClr val="FF0000"/>
              </a:solidFill>
              <a:prstDash val="solid"/>
              <a:round/>
            </a:ln>
            <a:effectLst/>
          </c:spPr>
          <c:marker>
            <c:symbol val="none"/>
          </c:marker>
          <c:errBars>
            <c:errDir val="y"/>
            <c:errBarType val="both"/>
            <c:errValType val="cust"/>
            <c:noEndCap val="0"/>
            <c:plus>
              <c:numRef>
                <c:f>CAH1_CCP1_LCI1_combined!$U$93:$X$93</c:f>
                <c:numCache>
                  <c:formatCode>General</c:formatCode>
                  <c:ptCount val="4"/>
                  <c:pt idx="0">
                    <c:v>0.31862786989238073</c:v>
                  </c:pt>
                  <c:pt idx="1">
                    <c:v>37.352439235210703</c:v>
                  </c:pt>
                  <c:pt idx="2">
                    <c:v>7.469052357393676</c:v>
                  </c:pt>
                  <c:pt idx="3">
                    <c:v>15.411978039278479</c:v>
                  </c:pt>
                </c:numCache>
              </c:numRef>
            </c:plus>
            <c:minus>
              <c:numRef>
                <c:f>CAH1_CCP1_LCI1_combined!$U$93:$X$93</c:f>
                <c:numCache>
                  <c:formatCode>General</c:formatCode>
                  <c:ptCount val="4"/>
                  <c:pt idx="0">
                    <c:v>0.31862786989238073</c:v>
                  </c:pt>
                  <c:pt idx="1">
                    <c:v>37.352439235210703</c:v>
                  </c:pt>
                  <c:pt idx="2">
                    <c:v>7.469052357393676</c:v>
                  </c:pt>
                  <c:pt idx="3">
                    <c:v>15.411978039278479</c:v>
                  </c:pt>
                </c:numCache>
              </c:numRef>
            </c:minus>
            <c:spPr>
              <a:noFill/>
              <a:ln w="12700" cap="flat" cmpd="sng" algn="ctr">
                <a:solidFill>
                  <a:sysClr val="windowText" lastClr="000000"/>
                </a:solidFill>
                <a:round/>
              </a:ln>
              <a:effectLst/>
            </c:spPr>
          </c:errBars>
          <c:cat>
            <c:numRef>
              <c:f>CAH1_CCP1_LCI1_combined!$U$81:$X$81</c:f>
              <c:numCache>
                <c:formatCode>General</c:formatCode>
                <c:ptCount val="4"/>
                <c:pt idx="0">
                  <c:v>0</c:v>
                </c:pt>
                <c:pt idx="1">
                  <c:v>3</c:v>
                </c:pt>
                <c:pt idx="2">
                  <c:v>6</c:v>
                </c:pt>
                <c:pt idx="3">
                  <c:v>24</c:v>
                </c:pt>
              </c:numCache>
            </c:numRef>
          </c:cat>
          <c:val>
            <c:numRef>
              <c:f>CAH1_CCP1_LCI1_combined!$U$84:$X$84</c:f>
              <c:numCache>
                <c:formatCode>0</c:formatCode>
                <c:ptCount val="4"/>
                <c:pt idx="0" formatCode="0.00">
                  <c:v>0.98765964279521057</c:v>
                </c:pt>
                <c:pt idx="1">
                  <c:v>762.39903465150951</c:v>
                </c:pt>
                <c:pt idx="2">
                  <c:v>761.95969647396964</c:v>
                </c:pt>
                <c:pt idx="3">
                  <c:v>524.15442800581854</c:v>
                </c:pt>
              </c:numCache>
            </c:numRef>
          </c:val>
          <c:smooth val="0"/>
          <c:extLst>
            <c:ext xmlns:c16="http://schemas.microsoft.com/office/drawing/2014/chart" uri="{C3380CC4-5D6E-409C-BE32-E72D297353CC}">
              <c16:uniqueId val="{00000002-139B-0441-A1A8-9D68CE758E05}"/>
            </c:ext>
          </c:extLst>
        </c:ser>
        <c:dLbls>
          <c:showLegendKey val="0"/>
          <c:showVal val="0"/>
          <c:showCatName val="0"/>
          <c:showSerName val="0"/>
          <c:showPercent val="0"/>
          <c:showBubbleSize val="0"/>
        </c:dLbls>
        <c:smooth val="0"/>
        <c:axId val="1122461039"/>
        <c:axId val="1081726527"/>
      </c:lineChart>
      <c:catAx>
        <c:axId val="1122461039"/>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dirty="0"/>
                  <a:t>Time at low CO</a:t>
                </a:r>
                <a:r>
                  <a:rPr lang="en-US" baseline="-25000" dirty="0"/>
                  <a:t>2</a:t>
                </a:r>
                <a:r>
                  <a:rPr lang="en-US" dirty="0"/>
                  <a:t> (h)</a:t>
                </a:r>
              </a:p>
            </c:rich>
          </c:tx>
          <c:layout>
            <c:manualLayout>
              <c:xMode val="edge"/>
              <c:yMode val="edge"/>
              <c:x val="0.337425253152494"/>
              <c:y val="0.91387989501312317"/>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1081726527"/>
        <c:crossesAt val="0.1"/>
        <c:auto val="1"/>
        <c:lblAlgn val="ctr"/>
        <c:lblOffset val="100"/>
        <c:noMultiLvlLbl val="0"/>
      </c:catAx>
      <c:valAx>
        <c:axId val="1081726527"/>
        <c:scaling>
          <c:logBase val="10"/>
          <c:orientation val="minMax"/>
          <c:min val="0.1"/>
        </c:scaling>
        <c:delete val="0"/>
        <c:axPos val="l"/>
        <c:numFmt formatCode="0.0"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1122461039"/>
        <c:crosses val="autoZero"/>
        <c:crossBetween val="between"/>
      </c:valAx>
      <c:spPr>
        <a:noFill/>
        <a:ln>
          <a:noFill/>
        </a:ln>
        <a:effectLst/>
      </c:spPr>
    </c:plotArea>
    <c:legend>
      <c:legendPos val="b"/>
      <c:legendEntry>
        <c:idx val="1"/>
        <c:txPr>
          <a:bodyPr rot="0" spcFirstLastPara="1" vertOverflow="ellipsis" vert="horz" wrap="square" anchor="ctr" anchorCtr="1"/>
          <a:lstStyle/>
          <a:p>
            <a:pPr>
              <a:defRPr sz="1200" b="1" i="1"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Entry>
      <c:legendEntry>
        <c:idx val="2"/>
        <c:txPr>
          <a:bodyPr rot="0" spcFirstLastPara="1" vertOverflow="ellipsis" vert="horz" wrap="square" anchor="ctr" anchorCtr="1"/>
          <a:lstStyle/>
          <a:p>
            <a:pPr>
              <a:defRPr sz="1200" b="1" i="1"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Entry>
      <c:layout>
        <c:manualLayout>
          <c:xMode val="edge"/>
          <c:yMode val="edge"/>
          <c:x val="0.56519474451118668"/>
          <c:y val="0.51131383620165849"/>
          <c:w val="0.41812491930476059"/>
          <c:h val="0.24011012124554795"/>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b="1">
          <a:solidFill>
            <a:sysClr val="windowText" lastClr="000000"/>
          </a:solidFill>
          <a:latin typeface="Times New Roman" panose="02020603050405020304" pitchFamily="18" charset="0"/>
          <a:cs typeface="Times New Roman" panose="02020603050405020304" pitchFamily="18" charset="0"/>
        </a:defRPr>
      </a:pPr>
      <a:endParaRPr lang="en-US"/>
    </a:p>
  </c:txPr>
  <c:externalData r:id="rId4">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9747394151526041"/>
          <c:y val="4.639547389305354E-2"/>
          <c:w val="0.70252605848473959"/>
          <c:h val="0.75966715900273907"/>
        </c:manualLayout>
      </c:layout>
      <c:lineChart>
        <c:grouping val="standard"/>
        <c:varyColors val="0"/>
        <c:ser>
          <c:idx val="3"/>
          <c:order val="0"/>
          <c:tx>
            <c:v>WT</c:v>
          </c:tx>
          <c:spPr>
            <a:ln w="25400" cap="rnd">
              <a:solidFill>
                <a:sysClr val="windowText" lastClr="000000"/>
              </a:solidFill>
              <a:round/>
            </a:ln>
            <a:effectLst/>
          </c:spPr>
          <c:marker>
            <c:symbol val="none"/>
          </c:marker>
          <c:errBars>
            <c:errDir val="y"/>
            <c:errBarType val="both"/>
            <c:errValType val="cust"/>
            <c:noEndCap val="0"/>
            <c:plus>
              <c:numRef>
                <c:f>CAH1_CCP1_LCI1_combined!$U$94:$X$94</c:f>
                <c:numCache>
                  <c:formatCode>General</c:formatCode>
                  <c:ptCount val="4"/>
                  <c:pt idx="0">
                    <c:v>0.84538478753768065</c:v>
                  </c:pt>
                  <c:pt idx="1">
                    <c:v>100.80081223787376</c:v>
                  </c:pt>
                  <c:pt idx="2">
                    <c:v>10.73018258826372</c:v>
                  </c:pt>
                  <c:pt idx="3">
                    <c:v>65.915926330791677</c:v>
                  </c:pt>
                </c:numCache>
              </c:numRef>
            </c:plus>
            <c:minus>
              <c:numRef>
                <c:f>CAH1_CCP1_LCI1_combined!$U$94:$X$94</c:f>
                <c:numCache>
                  <c:formatCode>General</c:formatCode>
                  <c:ptCount val="4"/>
                  <c:pt idx="0">
                    <c:v>0.84538478753768065</c:v>
                  </c:pt>
                  <c:pt idx="1">
                    <c:v>100.80081223787376</c:v>
                  </c:pt>
                  <c:pt idx="2">
                    <c:v>10.73018258826372</c:v>
                  </c:pt>
                  <c:pt idx="3">
                    <c:v>65.915926330791677</c:v>
                  </c:pt>
                </c:numCache>
              </c:numRef>
            </c:minus>
            <c:spPr>
              <a:noFill/>
              <a:ln w="12700" cap="flat" cmpd="sng" algn="ctr">
                <a:solidFill>
                  <a:srgbClr val="44546A"/>
                </a:solidFill>
                <a:round/>
              </a:ln>
              <a:effectLst/>
            </c:spPr>
          </c:errBars>
          <c:cat>
            <c:numRef>
              <c:f>CAH1_CCP1_LCI1_combined!$U$81:$X$81</c:f>
              <c:numCache>
                <c:formatCode>General</c:formatCode>
                <c:ptCount val="4"/>
                <c:pt idx="0">
                  <c:v>0</c:v>
                </c:pt>
                <c:pt idx="1">
                  <c:v>3</c:v>
                </c:pt>
                <c:pt idx="2">
                  <c:v>6</c:v>
                </c:pt>
                <c:pt idx="3">
                  <c:v>24</c:v>
                </c:pt>
              </c:numCache>
            </c:numRef>
          </c:cat>
          <c:val>
            <c:numRef>
              <c:f>CAH1_CCP1_LCI1_combined!$U$85:$X$85</c:f>
              <c:numCache>
                <c:formatCode>0.00</c:formatCode>
                <c:ptCount val="4"/>
                <c:pt idx="0">
                  <c:v>1</c:v>
                </c:pt>
                <c:pt idx="1">
                  <c:v>257.52303099744364</c:v>
                </c:pt>
                <c:pt idx="2">
                  <c:v>243.32960533295829</c:v>
                </c:pt>
                <c:pt idx="3">
                  <c:v>90.203860540848297</c:v>
                </c:pt>
              </c:numCache>
            </c:numRef>
          </c:val>
          <c:smooth val="0"/>
          <c:extLst>
            <c:ext xmlns:c16="http://schemas.microsoft.com/office/drawing/2014/chart" uri="{C3380CC4-5D6E-409C-BE32-E72D297353CC}">
              <c16:uniqueId val="{00000000-A203-564B-88EA-E98303439DFA}"/>
            </c:ext>
          </c:extLst>
        </c:ser>
        <c:ser>
          <c:idx val="4"/>
          <c:order val="1"/>
          <c:tx>
            <c:v>rmt2-1</c:v>
          </c:tx>
          <c:spPr>
            <a:ln w="25400" cap="rnd">
              <a:solidFill>
                <a:srgbClr val="4472C4"/>
              </a:solidFill>
              <a:prstDash val="solid"/>
              <a:round/>
            </a:ln>
            <a:effectLst/>
          </c:spPr>
          <c:marker>
            <c:symbol val="none"/>
          </c:marker>
          <c:errBars>
            <c:errDir val="y"/>
            <c:errBarType val="both"/>
            <c:errValType val="cust"/>
            <c:noEndCap val="0"/>
            <c:plus>
              <c:numRef>
                <c:f>CAH1_CCP1_LCI1_combined!$U$95:$X$95</c:f>
                <c:numCache>
                  <c:formatCode>General</c:formatCode>
                  <c:ptCount val="4"/>
                  <c:pt idx="0">
                    <c:v>4.2614094829636781E-2</c:v>
                  </c:pt>
                  <c:pt idx="1">
                    <c:v>8.8781197101066205</c:v>
                  </c:pt>
                  <c:pt idx="2">
                    <c:v>0.13522485758266437</c:v>
                  </c:pt>
                  <c:pt idx="3">
                    <c:v>0.54363741193540271</c:v>
                  </c:pt>
                </c:numCache>
              </c:numRef>
            </c:plus>
            <c:minus>
              <c:numRef>
                <c:f>CAH1_CCP1_LCI1_combined!$U$95:$X$95</c:f>
                <c:numCache>
                  <c:formatCode>General</c:formatCode>
                  <c:ptCount val="4"/>
                  <c:pt idx="0">
                    <c:v>4.2614094829636781E-2</c:v>
                  </c:pt>
                  <c:pt idx="1">
                    <c:v>8.8781197101066205</c:v>
                  </c:pt>
                  <c:pt idx="2">
                    <c:v>0.13522485758266437</c:v>
                  </c:pt>
                  <c:pt idx="3">
                    <c:v>0.54363741193540271</c:v>
                  </c:pt>
                </c:numCache>
              </c:numRef>
            </c:minus>
            <c:spPr>
              <a:noFill/>
              <a:ln w="12700" cap="flat" cmpd="sng" algn="ctr">
                <a:solidFill>
                  <a:srgbClr val="44546A"/>
                </a:solidFill>
                <a:round/>
              </a:ln>
              <a:effectLst/>
            </c:spPr>
          </c:errBars>
          <c:cat>
            <c:numRef>
              <c:f>CAH1_CCP1_LCI1_combined!$U$81:$X$81</c:f>
              <c:numCache>
                <c:formatCode>General</c:formatCode>
                <c:ptCount val="4"/>
                <c:pt idx="0">
                  <c:v>0</c:v>
                </c:pt>
                <c:pt idx="1">
                  <c:v>3</c:v>
                </c:pt>
                <c:pt idx="2">
                  <c:v>6</c:v>
                </c:pt>
                <c:pt idx="3">
                  <c:v>24</c:v>
                </c:pt>
              </c:numCache>
            </c:numRef>
          </c:cat>
          <c:val>
            <c:numRef>
              <c:f>CAH1_CCP1_LCI1_combined!$U$86:$X$86</c:f>
              <c:numCache>
                <c:formatCode>0.00</c:formatCode>
                <c:ptCount val="4"/>
                <c:pt idx="0">
                  <c:v>0.13209209129036942</c:v>
                </c:pt>
                <c:pt idx="1">
                  <c:v>28.765512083706273</c:v>
                </c:pt>
                <c:pt idx="2">
                  <c:v>9.1968788111483128</c:v>
                </c:pt>
                <c:pt idx="3">
                  <c:v>1.87518864942455</c:v>
                </c:pt>
              </c:numCache>
            </c:numRef>
          </c:val>
          <c:smooth val="0"/>
          <c:extLst>
            <c:ext xmlns:c16="http://schemas.microsoft.com/office/drawing/2014/chart" uri="{C3380CC4-5D6E-409C-BE32-E72D297353CC}">
              <c16:uniqueId val="{00000001-A203-564B-88EA-E98303439DFA}"/>
            </c:ext>
          </c:extLst>
        </c:ser>
        <c:ser>
          <c:idx val="5"/>
          <c:order val="2"/>
          <c:tx>
            <c:v>rmt2-2</c:v>
          </c:tx>
          <c:spPr>
            <a:ln w="25400" cap="rnd">
              <a:solidFill>
                <a:srgbClr val="FF0000"/>
              </a:solidFill>
              <a:prstDash val="solid"/>
              <a:round/>
            </a:ln>
            <a:effectLst/>
          </c:spPr>
          <c:marker>
            <c:symbol val="none"/>
          </c:marker>
          <c:errBars>
            <c:errDir val="y"/>
            <c:errBarType val="both"/>
            <c:errValType val="cust"/>
            <c:noEndCap val="0"/>
            <c:plus>
              <c:numRef>
                <c:f>CAH1_CCP1_LCI1_combined!$U$96:$X$96</c:f>
                <c:numCache>
                  <c:formatCode>General</c:formatCode>
                  <c:ptCount val="4"/>
                  <c:pt idx="0">
                    <c:v>8.7553285524904947E-2</c:v>
                  </c:pt>
                  <c:pt idx="1">
                    <c:v>1.3332893513077551</c:v>
                  </c:pt>
                  <c:pt idx="2">
                    <c:v>3.7846818245361473</c:v>
                  </c:pt>
                  <c:pt idx="3">
                    <c:v>1.802996581806964</c:v>
                  </c:pt>
                </c:numCache>
              </c:numRef>
            </c:plus>
            <c:minus>
              <c:numRef>
                <c:f>CAH1_CCP1_LCI1_combined!$U$96:$X$96</c:f>
                <c:numCache>
                  <c:formatCode>General</c:formatCode>
                  <c:ptCount val="4"/>
                  <c:pt idx="0">
                    <c:v>8.7553285524904947E-2</c:v>
                  </c:pt>
                  <c:pt idx="1">
                    <c:v>1.3332893513077551</c:v>
                  </c:pt>
                  <c:pt idx="2">
                    <c:v>3.7846818245361473</c:v>
                  </c:pt>
                  <c:pt idx="3">
                    <c:v>1.802996581806964</c:v>
                  </c:pt>
                </c:numCache>
              </c:numRef>
            </c:minus>
            <c:spPr>
              <a:noFill/>
              <a:ln w="12700" cap="flat" cmpd="sng" algn="ctr">
                <a:solidFill>
                  <a:srgbClr val="44546A"/>
                </a:solidFill>
                <a:round/>
              </a:ln>
              <a:effectLst/>
            </c:spPr>
          </c:errBars>
          <c:cat>
            <c:numRef>
              <c:f>CAH1_CCP1_LCI1_combined!$U$81:$X$81</c:f>
              <c:numCache>
                <c:formatCode>General</c:formatCode>
                <c:ptCount val="4"/>
                <c:pt idx="0">
                  <c:v>0</c:v>
                </c:pt>
                <c:pt idx="1">
                  <c:v>3</c:v>
                </c:pt>
                <c:pt idx="2">
                  <c:v>6</c:v>
                </c:pt>
                <c:pt idx="3">
                  <c:v>24</c:v>
                </c:pt>
              </c:numCache>
            </c:numRef>
          </c:cat>
          <c:val>
            <c:numRef>
              <c:f>CAH1_CCP1_LCI1_combined!$U$87:$X$87</c:f>
              <c:numCache>
                <c:formatCode>0.000</c:formatCode>
                <c:ptCount val="4"/>
                <c:pt idx="0" formatCode="0.00">
                  <c:v>7.2626681117826775E-2</c:v>
                </c:pt>
                <c:pt idx="1">
                  <c:v>6.844215181835434</c:v>
                </c:pt>
                <c:pt idx="2">
                  <c:v>9.0451718883908026</c:v>
                </c:pt>
                <c:pt idx="3">
                  <c:v>5.670530137862575</c:v>
                </c:pt>
              </c:numCache>
            </c:numRef>
          </c:val>
          <c:smooth val="0"/>
          <c:extLst>
            <c:ext xmlns:c16="http://schemas.microsoft.com/office/drawing/2014/chart" uri="{C3380CC4-5D6E-409C-BE32-E72D297353CC}">
              <c16:uniqueId val="{00000002-A203-564B-88EA-E98303439DFA}"/>
            </c:ext>
          </c:extLst>
        </c:ser>
        <c:dLbls>
          <c:showLegendKey val="0"/>
          <c:showVal val="0"/>
          <c:showCatName val="0"/>
          <c:showSerName val="0"/>
          <c:showPercent val="0"/>
          <c:showBubbleSize val="0"/>
        </c:dLbls>
        <c:smooth val="0"/>
        <c:axId val="1122461039"/>
        <c:axId val="1081726527"/>
      </c:lineChart>
      <c:catAx>
        <c:axId val="1122461039"/>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dirty="0"/>
                  <a:t>Time at low CO</a:t>
                </a:r>
                <a:r>
                  <a:rPr lang="en-US" baseline="-25000" dirty="0"/>
                  <a:t>2</a:t>
                </a:r>
                <a:r>
                  <a:rPr lang="en-US" dirty="0"/>
                  <a:t> (h) </a:t>
                </a:r>
              </a:p>
            </c:rich>
          </c:tx>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1081726527"/>
        <c:crossesAt val="0"/>
        <c:auto val="1"/>
        <c:lblAlgn val="ctr"/>
        <c:lblOffset val="100"/>
        <c:noMultiLvlLbl val="0"/>
      </c:catAx>
      <c:valAx>
        <c:axId val="1081726527"/>
        <c:scaling>
          <c:logBase val="10"/>
          <c:orientation val="minMax"/>
          <c:min val="1.0000000000000002E-2"/>
        </c:scaling>
        <c:delete val="0"/>
        <c:axPos val="l"/>
        <c:numFmt formatCode="0.00"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1122461039"/>
        <c:crosses val="autoZero"/>
        <c:crossBetween val="between"/>
      </c:valAx>
      <c:spPr>
        <a:noFill/>
        <a:ln>
          <a:noFill/>
        </a:ln>
        <a:effectLst/>
      </c:spPr>
    </c:plotArea>
    <c:legend>
      <c:legendPos val="b"/>
      <c:legendEntry>
        <c:idx val="1"/>
        <c:txPr>
          <a:bodyPr rot="0" spcFirstLastPara="1" vertOverflow="ellipsis" vert="horz" wrap="square" anchor="ctr" anchorCtr="1"/>
          <a:lstStyle/>
          <a:p>
            <a:pPr>
              <a:defRPr sz="1200" b="1" i="1"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Entry>
      <c:legendEntry>
        <c:idx val="2"/>
        <c:txPr>
          <a:bodyPr rot="0" spcFirstLastPara="1" vertOverflow="ellipsis" vert="horz" wrap="square" anchor="ctr" anchorCtr="1"/>
          <a:lstStyle/>
          <a:p>
            <a:pPr>
              <a:defRPr sz="1200" b="1" i="1"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Entry>
      <c:layout>
        <c:manualLayout>
          <c:xMode val="edge"/>
          <c:yMode val="edge"/>
          <c:x val="0.51856799785487151"/>
          <c:y val="0.49798832908060331"/>
          <c:w val="0.43568805640843655"/>
          <c:h val="0.25313427915614489"/>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b="1">
          <a:solidFill>
            <a:sysClr val="windowText" lastClr="000000"/>
          </a:solidFill>
          <a:latin typeface="Times New Roman" panose="02020603050405020304" pitchFamily="18" charset="0"/>
          <a:cs typeface="Times New Roman" panose="02020603050405020304" pitchFamily="18" charset="0"/>
        </a:defRPr>
      </a:pPr>
      <a:endParaRPr lang="en-US"/>
    </a:p>
  </c:txPr>
  <c:externalData r:id="rId4">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0.25848544372029403"/>
          <c:y val="3.540086362732154E-2"/>
          <c:w val="0.74151455627970597"/>
          <c:h val="0.77304509095766261"/>
        </c:manualLayout>
      </c:layout>
      <c:lineChart>
        <c:grouping val="standard"/>
        <c:varyColors val="0"/>
        <c:ser>
          <c:idx val="6"/>
          <c:order val="0"/>
          <c:tx>
            <c:v>WT</c:v>
          </c:tx>
          <c:spPr>
            <a:ln w="25400" cap="rnd">
              <a:solidFill>
                <a:sysClr val="windowText" lastClr="000000"/>
              </a:solidFill>
              <a:round/>
            </a:ln>
            <a:effectLst/>
          </c:spPr>
          <c:marker>
            <c:symbol val="none"/>
          </c:marker>
          <c:errBars>
            <c:errDir val="y"/>
            <c:errBarType val="both"/>
            <c:errValType val="cust"/>
            <c:noEndCap val="0"/>
            <c:plus>
              <c:numRef>
                <c:f>CAH1_CCP1_LCI1_combined!$U$97:$X$97</c:f>
                <c:numCache>
                  <c:formatCode>General</c:formatCode>
                  <c:ptCount val="4"/>
                  <c:pt idx="0">
                    <c:v>1.9603907051296388E-2</c:v>
                  </c:pt>
                  <c:pt idx="1">
                    <c:v>10.951825358388229</c:v>
                  </c:pt>
                  <c:pt idx="2">
                    <c:v>3.3813917698695359</c:v>
                  </c:pt>
                  <c:pt idx="3">
                    <c:v>40.575022608285011</c:v>
                  </c:pt>
                </c:numCache>
              </c:numRef>
            </c:plus>
            <c:minus>
              <c:numRef>
                <c:f>CAH1_CCP1_LCI1_combined!$U$97:$X$97</c:f>
                <c:numCache>
                  <c:formatCode>General</c:formatCode>
                  <c:ptCount val="4"/>
                  <c:pt idx="0">
                    <c:v>1.9603907051296388E-2</c:v>
                  </c:pt>
                  <c:pt idx="1">
                    <c:v>10.951825358388229</c:v>
                  </c:pt>
                  <c:pt idx="2">
                    <c:v>3.3813917698695359</c:v>
                  </c:pt>
                  <c:pt idx="3">
                    <c:v>40.575022608285011</c:v>
                  </c:pt>
                </c:numCache>
              </c:numRef>
            </c:minus>
            <c:spPr>
              <a:noFill/>
              <a:ln w="12700" cap="flat" cmpd="sng" algn="ctr">
                <a:solidFill>
                  <a:sysClr val="windowText" lastClr="000000"/>
                </a:solidFill>
                <a:round/>
              </a:ln>
              <a:effectLst/>
            </c:spPr>
          </c:errBars>
          <c:cat>
            <c:numRef>
              <c:f>CAH1_CCP1_LCI1_combined!$U$81:$X$81</c:f>
              <c:numCache>
                <c:formatCode>General</c:formatCode>
                <c:ptCount val="4"/>
                <c:pt idx="0">
                  <c:v>0</c:v>
                </c:pt>
                <c:pt idx="1">
                  <c:v>3</c:v>
                </c:pt>
                <c:pt idx="2">
                  <c:v>6</c:v>
                </c:pt>
                <c:pt idx="3">
                  <c:v>24</c:v>
                </c:pt>
              </c:numCache>
            </c:numRef>
          </c:cat>
          <c:val>
            <c:numRef>
              <c:f>CAH1_CCP1_LCI1_combined!$U$88:$X$88</c:f>
              <c:numCache>
                <c:formatCode>0.00</c:formatCode>
                <c:ptCount val="4"/>
                <c:pt idx="0">
                  <c:v>1</c:v>
                </c:pt>
                <c:pt idx="1">
                  <c:v>124.29864870180994</c:v>
                </c:pt>
                <c:pt idx="2">
                  <c:v>57.524661360777856</c:v>
                </c:pt>
                <c:pt idx="3">
                  <c:v>135.57185689735863</c:v>
                </c:pt>
              </c:numCache>
            </c:numRef>
          </c:val>
          <c:smooth val="0"/>
          <c:extLst>
            <c:ext xmlns:c16="http://schemas.microsoft.com/office/drawing/2014/chart" uri="{C3380CC4-5D6E-409C-BE32-E72D297353CC}">
              <c16:uniqueId val="{00000000-5322-3342-B14A-69F9C9FF6F31}"/>
            </c:ext>
          </c:extLst>
        </c:ser>
        <c:ser>
          <c:idx val="7"/>
          <c:order val="1"/>
          <c:tx>
            <c:v>rmt2-1</c:v>
          </c:tx>
          <c:spPr>
            <a:ln w="25400" cap="rnd">
              <a:solidFill>
                <a:srgbClr val="4472C4"/>
              </a:solidFill>
              <a:prstDash val="solid"/>
              <a:round/>
            </a:ln>
            <a:effectLst/>
          </c:spPr>
          <c:marker>
            <c:symbol val="none"/>
          </c:marker>
          <c:errBars>
            <c:errDir val="y"/>
            <c:errBarType val="both"/>
            <c:errValType val="cust"/>
            <c:noEndCap val="0"/>
            <c:plus>
              <c:numRef>
                <c:f>CAH1_CCP1_LCI1_combined!$U$98:$X$98</c:f>
                <c:numCache>
                  <c:formatCode>General</c:formatCode>
                  <c:ptCount val="4"/>
                  <c:pt idx="0">
                    <c:v>1.8159985323252439E-2</c:v>
                  </c:pt>
                  <c:pt idx="1">
                    <c:v>18.379913021908269</c:v>
                  </c:pt>
                  <c:pt idx="2">
                    <c:v>0</c:v>
                  </c:pt>
                  <c:pt idx="3">
                    <c:v>0.62955212698672447</c:v>
                  </c:pt>
                </c:numCache>
              </c:numRef>
            </c:plus>
            <c:minus>
              <c:numRef>
                <c:f>CAH1_CCP1_LCI1_combined!$U$98:$X$98</c:f>
                <c:numCache>
                  <c:formatCode>General</c:formatCode>
                  <c:ptCount val="4"/>
                  <c:pt idx="0">
                    <c:v>1.8159985323252439E-2</c:v>
                  </c:pt>
                  <c:pt idx="1">
                    <c:v>18.379913021908269</c:v>
                  </c:pt>
                  <c:pt idx="2">
                    <c:v>0</c:v>
                  </c:pt>
                  <c:pt idx="3">
                    <c:v>0.62955212698672447</c:v>
                  </c:pt>
                </c:numCache>
              </c:numRef>
            </c:minus>
            <c:spPr>
              <a:noFill/>
              <a:ln w="12700" cap="flat" cmpd="sng" algn="ctr">
                <a:solidFill>
                  <a:sysClr val="windowText" lastClr="000000"/>
                </a:solidFill>
                <a:round/>
              </a:ln>
              <a:effectLst/>
            </c:spPr>
          </c:errBars>
          <c:cat>
            <c:numRef>
              <c:f>CAH1_CCP1_LCI1_combined!$U$81:$X$81</c:f>
              <c:numCache>
                <c:formatCode>General</c:formatCode>
                <c:ptCount val="4"/>
                <c:pt idx="0">
                  <c:v>0</c:v>
                </c:pt>
                <c:pt idx="1">
                  <c:v>3</c:v>
                </c:pt>
                <c:pt idx="2">
                  <c:v>6</c:v>
                </c:pt>
                <c:pt idx="3">
                  <c:v>24</c:v>
                </c:pt>
              </c:numCache>
            </c:numRef>
          </c:cat>
          <c:val>
            <c:numRef>
              <c:f>CAH1_CCP1_LCI1_combined!$U$89:$X$89</c:f>
              <c:numCache>
                <c:formatCode>0.00</c:formatCode>
                <c:ptCount val="4"/>
                <c:pt idx="0">
                  <c:v>8.1227833664491919E-2</c:v>
                </c:pt>
                <c:pt idx="1">
                  <c:v>107.66826452059981</c:v>
                </c:pt>
                <c:pt idx="2">
                  <c:v>20.110281552324789</c:v>
                </c:pt>
                <c:pt idx="3">
                  <c:v>14.276427202996231</c:v>
                </c:pt>
              </c:numCache>
            </c:numRef>
          </c:val>
          <c:smooth val="0"/>
          <c:extLst>
            <c:ext xmlns:c16="http://schemas.microsoft.com/office/drawing/2014/chart" uri="{C3380CC4-5D6E-409C-BE32-E72D297353CC}">
              <c16:uniqueId val="{00000001-5322-3342-B14A-69F9C9FF6F31}"/>
            </c:ext>
          </c:extLst>
        </c:ser>
        <c:ser>
          <c:idx val="8"/>
          <c:order val="2"/>
          <c:tx>
            <c:v>rmt2-2</c:v>
          </c:tx>
          <c:spPr>
            <a:ln w="25400" cap="rnd">
              <a:solidFill>
                <a:srgbClr val="FF0000"/>
              </a:solidFill>
              <a:prstDash val="solid"/>
              <a:round/>
            </a:ln>
            <a:effectLst/>
          </c:spPr>
          <c:marker>
            <c:symbol val="none"/>
          </c:marker>
          <c:errBars>
            <c:errDir val="y"/>
            <c:errBarType val="both"/>
            <c:errValType val="cust"/>
            <c:noEndCap val="0"/>
            <c:plus>
              <c:numRef>
                <c:f>CAH1_CCP1_LCI1_combined!$U$99:$X$99</c:f>
                <c:numCache>
                  <c:formatCode>General</c:formatCode>
                  <c:ptCount val="4"/>
                  <c:pt idx="0">
                    <c:v>2.307215405216928E-2</c:v>
                  </c:pt>
                  <c:pt idx="1">
                    <c:v>2.2151397869955156</c:v>
                  </c:pt>
                  <c:pt idx="2">
                    <c:v>0.41530044016039697</c:v>
                  </c:pt>
                  <c:pt idx="3">
                    <c:v>4.7359029357291798</c:v>
                  </c:pt>
                </c:numCache>
              </c:numRef>
            </c:plus>
            <c:minus>
              <c:numRef>
                <c:f>CAH1_CCP1_LCI1_combined!$U$99:$X$99</c:f>
                <c:numCache>
                  <c:formatCode>General</c:formatCode>
                  <c:ptCount val="4"/>
                  <c:pt idx="0">
                    <c:v>2.307215405216928E-2</c:v>
                  </c:pt>
                  <c:pt idx="1">
                    <c:v>2.2151397869955156</c:v>
                  </c:pt>
                  <c:pt idx="2">
                    <c:v>0.41530044016039697</c:v>
                  </c:pt>
                  <c:pt idx="3">
                    <c:v>4.7359029357291798</c:v>
                  </c:pt>
                </c:numCache>
              </c:numRef>
            </c:minus>
            <c:spPr>
              <a:noFill/>
              <a:ln w="12700" cap="flat" cmpd="sng" algn="ctr">
                <a:solidFill>
                  <a:sysClr val="windowText" lastClr="000000"/>
                </a:solidFill>
                <a:round/>
              </a:ln>
              <a:effectLst/>
            </c:spPr>
          </c:errBars>
          <c:cat>
            <c:numRef>
              <c:f>CAH1_CCP1_LCI1_combined!$U$81:$X$81</c:f>
              <c:numCache>
                <c:formatCode>General</c:formatCode>
                <c:ptCount val="4"/>
                <c:pt idx="0">
                  <c:v>0</c:v>
                </c:pt>
                <c:pt idx="1">
                  <c:v>3</c:v>
                </c:pt>
                <c:pt idx="2">
                  <c:v>6</c:v>
                </c:pt>
                <c:pt idx="3">
                  <c:v>24</c:v>
                </c:pt>
              </c:numCache>
            </c:numRef>
          </c:cat>
          <c:val>
            <c:numRef>
              <c:f>CAH1_CCP1_LCI1_combined!$U$90:$X$90</c:f>
              <c:numCache>
                <c:formatCode>0.00</c:formatCode>
                <c:ptCount val="4"/>
                <c:pt idx="0">
                  <c:v>1.7878915861216385E-2</c:v>
                </c:pt>
                <c:pt idx="1">
                  <c:v>50.232983986358278</c:v>
                </c:pt>
                <c:pt idx="2">
                  <c:v>28.245308493202653</c:v>
                </c:pt>
                <c:pt idx="3">
                  <c:v>17.470680018800863</c:v>
                </c:pt>
              </c:numCache>
            </c:numRef>
          </c:val>
          <c:smooth val="0"/>
          <c:extLst>
            <c:ext xmlns:c16="http://schemas.microsoft.com/office/drawing/2014/chart" uri="{C3380CC4-5D6E-409C-BE32-E72D297353CC}">
              <c16:uniqueId val="{00000002-5322-3342-B14A-69F9C9FF6F31}"/>
            </c:ext>
          </c:extLst>
        </c:ser>
        <c:dLbls>
          <c:showLegendKey val="0"/>
          <c:showVal val="0"/>
          <c:showCatName val="0"/>
          <c:showSerName val="0"/>
          <c:showPercent val="0"/>
          <c:showBubbleSize val="0"/>
        </c:dLbls>
        <c:smooth val="0"/>
        <c:axId val="1122461039"/>
        <c:axId val="1081726527"/>
      </c:lineChart>
      <c:catAx>
        <c:axId val="1122461039"/>
        <c:scaling>
          <c:orientation val="minMax"/>
        </c:scaling>
        <c:delete val="0"/>
        <c:axPos val="b"/>
        <c:title>
          <c:tx>
            <c:rich>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r>
                  <a:rPr lang="en-US" dirty="0"/>
                  <a:t>Time at low CO</a:t>
                </a:r>
                <a:r>
                  <a:rPr lang="en-US" baseline="-25000" dirty="0"/>
                  <a:t>2</a:t>
                </a:r>
                <a:r>
                  <a:rPr lang="en-US" dirty="0"/>
                  <a:t> (h) </a:t>
                </a:r>
              </a:p>
            </c:rich>
          </c:tx>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title>
        <c:numFmt formatCode="General" sourceLinked="1"/>
        <c:majorTickMark val="none"/>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1081726527"/>
        <c:crossesAt val="0"/>
        <c:auto val="1"/>
        <c:lblAlgn val="ctr"/>
        <c:lblOffset val="100"/>
        <c:noMultiLvlLbl val="0"/>
      </c:catAx>
      <c:valAx>
        <c:axId val="1081726527"/>
        <c:scaling>
          <c:logBase val="10"/>
          <c:orientation val="minMax"/>
          <c:min val="1.0000000000000002E-2"/>
        </c:scaling>
        <c:delete val="0"/>
        <c:axPos val="l"/>
        <c:numFmt formatCode="0.00"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crossAx val="1122461039"/>
        <c:crosses val="autoZero"/>
        <c:crossBetween val="between"/>
      </c:valAx>
      <c:spPr>
        <a:noFill/>
        <a:ln>
          <a:noFill/>
        </a:ln>
        <a:effectLst/>
      </c:spPr>
    </c:plotArea>
    <c:legend>
      <c:legendPos val="b"/>
      <c:legendEntry>
        <c:idx val="1"/>
        <c:txPr>
          <a:bodyPr rot="0" spcFirstLastPara="1" vertOverflow="ellipsis" vert="horz" wrap="square" anchor="ctr" anchorCtr="1"/>
          <a:lstStyle/>
          <a:p>
            <a:pPr>
              <a:defRPr sz="1200" b="1" i="1"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Entry>
      <c:legendEntry>
        <c:idx val="2"/>
        <c:txPr>
          <a:bodyPr rot="0" spcFirstLastPara="1" vertOverflow="ellipsis" vert="horz" wrap="square" anchor="ctr" anchorCtr="1"/>
          <a:lstStyle/>
          <a:p>
            <a:pPr>
              <a:defRPr sz="1200" b="1" i="1"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Entry>
      <c:layout>
        <c:manualLayout>
          <c:xMode val="edge"/>
          <c:yMode val="edge"/>
          <c:x val="0.56700754483029314"/>
          <c:y val="0.48910920846222644"/>
          <c:w val="0.43299245516970686"/>
          <c:h val="0.26436076373108142"/>
        </c:manualLayout>
      </c:layout>
      <c:overlay val="0"/>
      <c:spPr>
        <a:noFill/>
        <a:ln>
          <a:noFill/>
        </a:ln>
        <a:effectLst/>
      </c:spPr>
      <c:txPr>
        <a:bodyPr rot="0" spcFirstLastPara="1" vertOverflow="ellipsis" vert="horz" wrap="square" anchor="ctr" anchorCtr="1"/>
        <a:lstStyle/>
        <a:p>
          <a:pPr>
            <a:defRPr sz="1200" b="1" i="0" u="none" strike="noStrike" kern="1200" baseline="0">
              <a:solidFill>
                <a:sysClr val="windowText" lastClr="000000"/>
              </a:solidFill>
              <a:latin typeface="Times New Roman" panose="02020603050405020304" pitchFamily="18" charset="0"/>
              <a:ea typeface="+mn-ea"/>
              <a:cs typeface="Times New Roman" panose="02020603050405020304" pitchFamily="18" charset="0"/>
            </a:defRPr>
          </a:pPr>
          <a:endParaRPr lang="en-US"/>
        </a:p>
      </c:txPr>
    </c:legend>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sz="1200" b="1">
          <a:solidFill>
            <a:sysClr val="windowText" lastClr="000000"/>
          </a:solidFill>
          <a:latin typeface="Times New Roman" panose="02020603050405020304" pitchFamily="18" charset="0"/>
          <a:cs typeface="Times New Roman" panose="02020603050405020304" pitchFamily="18" charset="0"/>
        </a:defRPr>
      </a:pPr>
      <a:endParaRPr lang="en-US"/>
    </a:p>
  </c:txPr>
  <c:externalData r:id="rId4">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r>
              <a:rPr lang="en-US"/>
              <a:t>mRNA level</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mn-lt"/>
              <a:ea typeface="+mn-ea"/>
              <a:cs typeface="+mn-cs"/>
            </a:defRPr>
          </a:pPr>
          <a:endParaRPr lang="en-US"/>
        </a:p>
      </c:txPr>
    </c:title>
    <c:autoTitleDeleted val="0"/>
    <c:plotArea>
      <c:layout>
        <c:manualLayout>
          <c:layoutTarget val="inner"/>
          <c:xMode val="edge"/>
          <c:yMode val="edge"/>
          <c:x val="0.13816734165261027"/>
          <c:y val="0.16947126195274953"/>
          <c:w val="0.83109413732571791"/>
          <c:h val="0.62001067823331368"/>
        </c:manualLayout>
      </c:layout>
      <c:barChart>
        <c:barDir val="col"/>
        <c:grouping val="clustered"/>
        <c:varyColors val="0"/>
        <c:ser>
          <c:idx val="0"/>
          <c:order val="0"/>
          <c:tx>
            <c:strRef>
              <c:f>'CMJ30 and aox2 HUV'!$T$48</c:f>
              <c:strCache>
                <c:ptCount val="1"/>
                <c:pt idx="0">
                  <c:v>WT</c:v>
                </c:pt>
              </c:strCache>
            </c:strRef>
          </c:tx>
          <c:spPr>
            <a:solidFill>
              <a:schemeClr val="tx1"/>
            </a:solidFill>
            <a:ln>
              <a:noFill/>
            </a:ln>
            <a:effectLst/>
          </c:spPr>
          <c:invertIfNegative val="0"/>
          <c:errBars>
            <c:errBarType val="both"/>
            <c:errValType val="cust"/>
            <c:noEndCap val="0"/>
            <c:plus>
              <c:numRef>
                <c:f>'CMJ30 and aox2 HUV'!$U$60:$Y$60</c:f>
                <c:numCache>
                  <c:formatCode>General</c:formatCode>
                  <c:ptCount val="5"/>
                  <c:pt idx="0">
                    <c:v>0.20076466809313584</c:v>
                  </c:pt>
                  <c:pt idx="1">
                    <c:v>0.31435624037114734</c:v>
                  </c:pt>
                  <c:pt idx="2">
                    <c:v>4.8631031887686915E-2</c:v>
                  </c:pt>
                  <c:pt idx="3">
                    <c:v>8.6499622417050143E-2</c:v>
                  </c:pt>
                  <c:pt idx="4">
                    <c:v>0.23</c:v>
                  </c:pt>
                </c:numCache>
              </c:numRef>
            </c:plus>
            <c:minus>
              <c:numRef>
                <c:f>'CMJ30 and aox2 HUV'!$U$60:$Y$60</c:f>
                <c:numCache>
                  <c:formatCode>General</c:formatCode>
                  <c:ptCount val="5"/>
                  <c:pt idx="0">
                    <c:v>0.20076466809313584</c:v>
                  </c:pt>
                  <c:pt idx="1">
                    <c:v>0.31435624037114734</c:v>
                  </c:pt>
                  <c:pt idx="2">
                    <c:v>4.8631031887686915E-2</c:v>
                  </c:pt>
                  <c:pt idx="3">
                    <c:v>8.6499622417050143E-2</c:v>
                  </c:pt>
                  <c:pt idx="4">
                    <c:v>0.23</c:v>
                  </c:pt>
                </c:numCache>
              </c:numRef>
            </c:minus>
            <c:spPr>
              <a:noFill/>
              <a:ln w="9525" cap="flat" cmpd="sng" algn="ctr">
                <a:solidFill>
                  <a:schemeClr val="tx1">
                    <a:lumMod val="65000"/>
                    <a:lumOff val="35000"/>
                  </a:schemeClr>
                </a:solidFill>
                <a:round/>
              </a:ln>
              <a:effectLst/>
            </c:spPr>
          </c:errBars>
          <c:cat>
            <c:strRef>
              <c:f>'CMJ30 and aox2 HUV'!$U$47:$Y$47</c:f>
              <c:strCache>
                <c:ptCount val="5"/>
                <c:pt idx="0">
                  <c:v>PsaA</c:v>
                </c:pt>
                <c:pt idx="1">
                  <c:v>PsaC</c:v>
                </c:pt>
                <c:pt idx="2">
                  <c:v>PSAD</c:v>
                </c:pt>
                <c:pt idx="3">
                  <c:v>PSAE</c:v>
                </c:pt>
                <c:pt idx="4">
                  <c:v>RMT2</c:v>
                </c:pt>
              </c:strCache>
            </c:strRef>
          </c:cat>
          <c:val>
            <c:numRef>
              <c:f>'CMJ30 and aox2 HUV'!$U$48:$Y$48</c:f>
              <c:numCache>
                <c:formatCode>General</c:formatCode>
                <c:ptCount val="5"/>
                <c:pt idx="0">
                  <c:v>100</c:v>
                </c:pt>
                <c:pt idx="1">
                  <c:v>100</c:v>
                </c:pt>
                <c:pt idx="2">
                  <c:v>100</c:v>
                </c:pt>
                <c:pt idx="3">
                  <c:v>100</c:v>
                </c:pt>
                <c:pt idx="4">
                  <c:v>100</c:v>
                </c:pt>
              </c:numCache>
            </c:numRef>
          </c:val>
          <c:extLst>
            <c:ext xmlns:c16="http://schemas.microsoft.com/office/drawing/2014/chart" uri="{C3380CC4-5D6E-409C-BE32-E72D297353CC}">
              <c16:uniqueId val="{00000000-F1B1-2346-95EC-9D5DB9F2620C}"/>
            </c:ext>
          </c:extLst>
        </c:ser>
        <c:ser>
          <c:idx val="1"/>
          <c:order val="1"/>
          <c:tx>
            <c:strRef>
              <c:f>'CMJ30 and aox2 HUV'!$T$49</c:f>
              <c:strCache>
                <c:ptCount val="1"/>
                <c:pt idx="0">
                  <c:v>rmt2-1</c:v>
                </c:pt>
              </c:strCache>
            </c:strRef>
          </c:tx>
          <c:spPr>
            <a:solidFill>
              <a:srgbClr val="FF0000"/>
            </a:solidFill>
            <a:ln>
              <a:noFill/>
            </a:ln>
            <a:effectLst/>
          </c:spPr>
          <c:invertIfNegative val="0"/>
          <c:errBars>
            <c:errBarType val="both"/>
            <c:errValType val="cust"/>
            <c:noEndCap val="0"/>
            <c:plus>
              <c:numRef>
                <c:f>'CMJ30 and aox2 HUV'!$U$61:$Y$61</c:f>
                <c:numCache>
                  <c:formatCode>General</c:formatCode>
                  <c:ptCount val="5"/>
                  <c:pt idx="0">
                    <c:v>0.16498075499078699</c:v>
                  </c:pt>
                  <c:pt idx="1">
                    <c:v>0.1857540663447157</c:v>
                  </c:pt>
                  <c:pt idx="2">
                    <c:v>0.12877693702200185</c:v>
                  </c:pt>
                  <c:pt idx="3">
                    <c:v>0.20276258093682745</c:v>
                  </c:pt>
                  <c:pt idx="4">
                    <c:v>0.03</c:v>
                  </c:pt>
                </c:numCache>
              </c:numRef>
            </c:plus>
            <c:minus>
              <c:numRef>
                <c:f>'CMJ30 and aox2 HUV'!$U$61:$Y$61</c:f>
                <c:numCache>
                  <c:formatCode>General</c:formatCode>
                  <c:ptCount val="5"/>
                  <c:pt idx="0">
                    <c:v>0.16498075499078699</c:v>
                  </c:pt>
                  <c:pt idx="1">
                    <c:v>0.1857540663447157</c:v>
                  </c:pt>
                  <c:pt idx="2">
                    <c:v>0.12877693702200185</c:v>
                  </c:pt>
                  <c:pt idx="3">
                    <c:v>0.20276258093682745</c:v>
                  </c:pt>
                  <c:pt idx="4">
                    <c:v>0.03</c:v>
                  </c:pt>
                </c:numCache>
              </c:numRef>
            </c:minus>
            <c:spPr>
              <a:noFill/>
              <a:ln w="9525" cap="flat" cmpd="sng" algn="ctr">
                <a:solidFill>
                  <a:schemeClr val="tx1">
                    <a:lumMod val="65000"/>
                    <a:lumOff val="35000"/>
                  </a:schemeClr>
                </a:solidFill>
                <a:round/>
              </a:ln>
              <a:effectLst/>
            </c:spPr>
          </c:errBars>
          <c:cat>
            <c:strRef>
              <c:f>'CMJ30 and aox2 HUV'!$U$47:$Y$47</c:f>
              <c:strCache>
                <c:ptCount val="5"/>
                <c:pt idx="0">
                  <c:v>PsaA</c:v>
                </c:pt>
                <c:pt idx="1">
                  <c:v>PsaC</c:v>
                </c:pt>
                <c:pt idx="2">
                  <c:v>PSAD</c:v>
                </c:pt>
                <c:pt idx="3">
                  <c:v>PSAE</c:v>
                </c:pt>
                <c:pt idx="4">
                  <c:v>RMT2</c:v>
                </c:pt>
              </c:strCache>
            </c:strRef>
          </c:cat>
          <c:val>
            <c:numRef>
              <c:f>'CMJ30 and aox2 HUV'!$U$49:$Y$49</c:f>
              <c:numCache>
                <c:formatCode>General</c:formatCode>
                <c:ptCount val="5"/>
                <c:pt idx="0">
                  <c:v>98.766045523656359</c:v>
                </c:pt>
                <c:pt idx="1">
                  <c:v>79.025516594089524</c:v>
                </c:pt>
                <c:pt idx="2">
                  <c:v>42.833292997174091</c:v>
                </c:pt>
                <c:pt idx="3">
                  <c:v>56.051924921717465</c:v>
                </c:pt>
                <c:pt idx="4">
                  <c:v>5.6678323603636702</c:v>
                </c:pt>
              </c:numCache>
            </c:numRef>
          </c:val>
          <c:extLst>
            <c:ext xmlns:c16="http://schemas.microsoft.com/office/drawing/2014/chart" uri="{C3380CC4-5D6E-409C-BE32-E72D297353CC}">
              <c16:uniqueId val="{00000001-F1B1-2346-95EC-9D5DB9F2620C}"/>
            </c:ext>
          </c:extLst>
        </c:ser>
        <c:ser>
          <c:idx val="2"/>
          <c:order val="2"/>
          <c:tx>
            <c:strRef>
              <c:f>'CMJ30 and aox2 HUV'!$T$50</c:f>
              <c:strCache>
                <c:ptCount val="1"/>
                <c:pt idx="0">
                  <c:v>rmt2-2</c:v>
                </c:pt>
              </c:strCache>
            </c:strRef>
          </c:tx>
          <c:spPr>
            <a:solidFill>
              <a:schemeClr val="accent1"/>
            </a:solidFill>
            <a:ln>
              <a:noFill/>
            </a:ln>
            <a:effectLst/>
          </c:spPr>
          <c:invertIfNegative val="0"/>
          <c:errBars>
            <c:errBarType val="both"/>
            <c:errValType val="cust"/>
            <c:noEndCap val="0"/>
            <c:plus>
              <c:numRef>
                <c:f>'CMJ30 and aox2 HUV'!$U$62:$Y$62</c:f>
                <c:numCache>
                  <c:formatCode>General</c:formatCode>
                  <c:ptCount val="5"/>
                  <c:pt idx="0">
                    <c:v>0.47427819775937069</c:v>
                  </c:pt>
                  <c:pt idx="1">
                    <c:v>0.11930856307293321</c:v>
                  </c:pt>
                  <c:pt idx="2">
                    <c:v>0.60285793153661438</c:v>
                  </c:pt>
                  <c:pt idx="3">
                    <c:v>0.36740684143262536</c:v>
                  </c:pt>
                  <c:pt idx="4">
                    <c:v>0.01</c:v>
                  </c:pt>
                </c:numCache>
              </c:numRef>
            </c:plus>
            <c:minus>
              <c:numRef>
                <c:f>'CMJ30 and aox2 HUV'!$U$62:$Y$62</c:f>
                <c:numCache>
                  <c:formatCode>General</c:formatCode>
                  <c:ptCount val="5"/>
                  <c:pt idx="0">
                    <c:v>0.47427819775937069</c:v>
                  </c:pt>
                  <c:pt idx="1">
                    <c:v>0.11930856307293321</c:v>
                  </c:pt>
                  <c:pt idx="2">
                    <c:v>0.60285793153661438</c:v>
                  </c:pt>
                  <c:pt idx="3">
                    <c:v>0.36740684143262536</c:v>
                  </c:pt>
                  <c:pt idx="4">
                    <c:v>0.01</c:v>
                  </c:pt>
                </c:numCache>
              </c:numRef>
            </c:minus>
            <c:spPr>
              <a:noFill/>
              <a:ln w="9525" cap="flat" cmpd="sng" algn="ctr">
                <a:solidFill>
                  <a:schemeClr val="tx1">
                    <a:lumMod val="65000"/>
                    <a:lumOff val="35000"/>
                  </a:schemeClr>
                </a:solidFill>
                <a:round/>
              </a:ln>
              <a:effectLst/>
            </c:spPr>
          </c:errBars>
          <c:cat>
            <c:strRef>
              <c:f>'CMJ30 and aox2 HUV'!$U$47:$Y$47</c:f>
              <c:strCache>
                <c:ptCount val="5"/>
                <c:pt idx="0">
                  <c:v>PsaA</c:v>
                </c:pt>
                <c:pt idx="1">
                  <c:v>PsaC</c:v>
                </c:pt>
                <c:pt idx="2">
                  <c:v>PSAD</c:v>
                </c:pt>
                <c:pt idx="3">
                  <c:v>PSAE</c:v>
                </c:pt>
                <c:pt idx="4">
                  <c:v>RMT2</c:v>
                </c:pt>
              </c:strCache>
            </c:strRef>
          </c:cat>
          <c:val>
            <c:numRef>
              <c:f>'CMJ30 and aox2 HUV'!$U$50:$Y$50</c:f>
              <c:numCache>
                <c:formatCode>General</c:formatCode>
                <c:ptCount val="5"/>
                <c:pt idx="0">
                  <c:v>120.63783800587679</c:v>
                </c:pt>
                <c:pt idx="1">
                  <c:v>123.69525948690475</c:v>
                </c:pt>
                <c:pt idx="2">
                  <c:v>98.414821821684072</c:v>
                </c:pt>
                <c:pt idx="3">
                  <c:v>103.91657072564131</c:v>
                </c:pt>
                <c:pt idx="4">
                  <c:v>1.12906584714103</c:v>
                </c:pt>
              </c:numCache>
            </c:numRef>
          </c:val>
          <c:extLst>
            <c:ext xmlns:c16="http://schemas.microsoft.com/office/drawing/2014/chart" uri="{C3380CC4-5D6E-409C-BE32-E72D297353CC}">
              <c16:uniqueId val="{00000002-F1B1-2346-95EC-9D5DB9F2620C}"/>
            </c:ext>
          </c:extLst>
        </c:ser>
        <c:ser>
          <c:idx val="3"/>
          <c:order val="3"/>
          <c:tx>
            <c:strRef>
              <c:f>'CMJ30 and aox2 HUV'!$T$51</c:f>
              <c:strCache>
                <c:ptCount val="1"/>
                <c:pt idx="0">
                  <c:v>rmt2-2(RMT2-VENUS) #35</c:v>
                </c:pt>
              </c:strCache>
            </c:strRef>
          </c:tx>
          <c:spPr>
            <a:solidFill>
              <a:schemeClr val="accent4"/>
            </a:solidFill>
            <a:ln>
              <a:noFill/>
            </a:ln>
            <a:effectLst/>
          </c:spPr>
          <c:invertIfNegative val="0"/>
          <c:errBars>
            <c:errBarType val="both"/>
            <c:errValType val="cust"/>
            <c:noEndCap val="0"/>
            <c:plus>
              <c:numRef>
                <c:f>'CMJ30 and aox2 HUV'!$U$63:$Y$63</c:f>
                <c:numCache>
                  <c:formatCode>General</c:formatCode>
                  <c:ptCount val="5"/>
                  <c:pt idx="0">
                    <c:v>6.0930738464035739E-2</c:v>
                  </c:pt>
                  <c:pt idx="1">
                    <c:v>0.47313933607224073</c:v>
                  </c:pt>
                  <c:pt idx="2">
                    <c:v>0.53135650049619187</c:v>
                  </c:pt>
                  <c:pt idx="3">
                    <c:v>6.6129816001100489E-2</c:v>
                  </c:pt>
                  <c:pt idx="4">
                    <c:v>0.11</c:v>
                  </c:pt>
                </c:numCache>
              </c:numRef>
            </c:plus>
            <c:minus>
              <c:numRef>
                <c:f>'CMJ30 and aox2 HUV'!$U$63:$Y$63</c:f>
                <c:numCache>
                  <c:formatCode>General</c:formatCode>
                  <c:ptCount val="5"/>
                  <c:pt idx="0">
                    <c:v>6.0930738464035739E-2</c:v>
                  </c:pt>
                  <c:pt idx="1">
                    <c:v>0.47313933607224073</c:v>
                  </c:pt>
                  <c:pt idx="2">
                    <c:v>0.53135650049619187</c:v>
                  </c:pt>
                  <c:pt idx="3">
                    <c:v>6.6129816001100489E-2</c:v>
                  </c:pt>
                  <c:pt idx="4">
                    <c:v>0.11</c:v>
                  </c:pt>
                </c:numCache>
              </c:numRef>
            </c:minus>
            <c:spPr>
              <a:noFill/>
              <a:ln w="9525" cap="flat" cmpd="sng" algn="ctr">
                <a:solidFill>
                  <a:schemeClr val="tx1">
                    <a:lumMod val="65000"/>
                    <a:lumOff val="35000"/>
                  </a:schemeClr>
                </a:solidFill>
                <a:round/>
              </a:ln>
              <a:effectLst/>
            </c:spPr>
          </c:errBars>
          <c:cat>
            <c:strRef>
              <c:f>'CMJ30 and aox2 HUV'!$U$47:$Y$47</c:f>
              <c:strCache>
                <c:ptCount val="5"/>
                <c:pt idx="0">
                  <c:v>PsaA</c:v>
                </c:pt>
                <c:pt idx="1">
                  <c:v>PsaC</c:v>
                </c:pt>
                <c:pt idx="2">
                  <c:v>PSAD</c:v>
                </c:pt>
                <c:pt idx="3">
                  <c:v>PSAE</c:v>
                </c:pt>
                <c:pt idx="4">
                  <c:v>RMT2</c:v>
                </c:pt>
              </c:strCache>
            </c:strRef>
          </c:cat>
          <c:val>
            <c:numRef>
              <c:f>'CMJ30 and aox2 HUV'!$U$51:$Y$51</c:f>
              <c:numCache>
                <c:formatCode>General</c:formatCode>
                <c:ptCount val="5"/>
                <c:pt idx="0">
                  <c:v>116.66676549466548</c:v>
                </c:pt>
                <c:pt idx="1">
                  <c:v>203.02892447992454</c:v>
                </c:pt>
                <c:pt idx="2">
                  <c:v>154.21464100548923</c:v>
                </c:pt>
                <c:pt idx="3">
                  <c:v>152.51147193060368</c:v>
                </c:pt>
                <c:pt idx="4">
                  <c:v>121.97664374416</c:v>
                </c:pt>
              </c:numCache>
            </c:numRef>
          </c:val>
          <c:extLst>
            <c:ext xmlns:c16="http://schemas.microsoft.com/office/drawing/2014/chart" uri="{C3380CC4-5D6E-409C-BE32-E72D297353CC}">
              <c16:uniqueId val="{00000003-F1B1-2346-95EC-9D5DB9F2620C}"/>
            </c:ext>
          </c:extLst>
        </c:ser>
        <c:dLbls>
          <c:showLegendKey val="0"/>
          <c:showVal val="0"/>
          <c:showCatName val="0"/>
          <c:showSerName val="0"/>
          <c:showPercent val="0"/>
          <c:showBubbleSize val="0"/>
        </c:dLbls>
        <c:gapWidth val="219"/>
        <c:overlap val="-27"/>
        <c:axId val="380481760"/>
        <c:axId val="380482152"/>
      </c:barChart>
      <c:catAx>
        <c:axId val="380481760"/>
        <c:scaling>
          <c:orientation val="minMax"/>
        </c:scaling>
        <c:delete val="0"/>
        <c:axPos val="b"/>
        <c:numFmt formatCode="General" sourceLinked="1"/>
        <c:majorTickMark val="none"/>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1200" b="0" i="1" u="none" strike="noStrike" kern="1200" baseline="0">
                <a:solidFill>
                  <a:schemeClr val="tx1"/>
                </a:solidFill>
                <a:latin typeface="+mn-lt"/>
                <a:ea typeface="+mn-ea"/>
                <a:cs typeface="+mn-cs"/>
              </a:defRPr>
            </a:pPr>
            <a:endParaRPr lang="en-US"/>
          </a:p>
        </c:txPr>
        <c:crossAx val="380482152"/>
        <c:crosses val="autoZero"/>
        <c:auto val="1"/>
        <c:lblAlgn val="ctr"/>
        <c:lblOffset val="100"/>
        <c:noMultiLvlLbl val="0"/>
      </c:catAx>
      <c:valAx>
        <c:axId val="380482152"/>
        <c:scaling>
          <c:logBase val="10"/>
          <c:orientation val="minMax"/>
          <c:min val="1"/>
        </c:scaling>
        <c:delete val="0"/>
        <c:axPos val="l"/>
        <c:title>
          <c:tx>
            <c:rich>
              <a:bodyPr rot="-5400000" spcFirstLastPara="1" vertOverflow="ellipsis" vert="horz" wrap="square" anchor="ctr" anchorCtr="1"/>
              <a:lstStyle/>
              <a:p>
                <a:pPr>
                  <a:defRPr sz="1400" b="0" i="0" u="none" strike="noStrike" kern="1200" baseline="0">
                    <a:solidFill>
                      <a:schemeClr val="tx1"/>
                    </a:solidFill>
                    <a:latin typeface="+mn-lt"/>
                    <a:ea typeface="+mn-ea"/>
                    <a:cs typeface="+mn-cs"/>
                  </a:defRPr>
                </a:pPr>
                <a:r>
                  <a:rPr lang="en-US" sz="1400" b="0"/>
                  <a:t>Relative Abundances</a:t>
                </a:r>
              </a:p>
            </c:rich>
          </c:tx>
          <c:layout>
            <c:manualLayout>
              <c:xMode val="edge"/>
              <c:yMode val="edge"/>
              <c:x val="0"/>
              <c:y val="0.13941462558185219"/>
            </c:manualLayout>
          </c:layout>
          <c:overlay val="0"/>
          <c:spPr>
            <a:noFill/>
            <a:ln>
              <a:noFill/>
            </a:ln>
            <a:effectLst/>
          </c:spPr>
          <c:txPr>
            <a:bodyPr rot="-540000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en-US"/>
            </a:p>
          </c:txPr>
        </c:title>
        <c:numFmt formatCode="General" sourceLinked="1"/>
        <c:majorTickMark val="out"/>
        <c:minorTickMark val="none"/>
        <c:tickLblPos val="nextTo"/>
        <c:spPr>
          <a:noFill/>
          <a:ln>
            <a:solidFill>
              <a:schemeClr val="tx1"/>
            </a:solidFill>
          </a:ln>
          <a:effectLst/>
        </c:spPr>
        <c:txPr>
          <a:bodyPr rot="-60000000" spcFirstLastPara="1" vertOverflow="ellipsis" vert="horz" wrap="square" anchor="ctr" anchorCtr="1"/>
          <a:lstStyle/>
          <a:p>
            <a:pPr>
              <a:defRPr sz="1200" b="1" i="0" u="none" strike="noStrike" kern="1200" baseline="0">
                <a:solidFill>
                  <a:schemeClr val="tx1"/>
                </a:solidFill>
                <a:latin typeface="+mn-lt"/>
                <a:ea typeface="+mn-ea"/>
                <a:cs typeface="+mn-cs"/>
              </a:defRPr>
            </a:pPr>
            <a:endParaRPr lang="en-US"/>
          </a:p>
        </c:txPr>
        <c:crossAx val="380481760"/>
        <c:crosses val="autoZero"/>
        <c:crossBetween val="between"/>
      </c:valAx>
      <c:spPr>
        <a:noFill/>
        <a:ln w="25400">
          <a:noFill/>
        </a:ln>
        <a:effectLst/>
      </c:spPr>
    </c:plotArea>
    <c:legend>
      <c:legendPos val="b"/>
      <c:legendEntry>
        <c:idx val="1"/>
        <c:txPr>
          <a:bodyPr rot="0" spcFirstLastPara="1" vertOverflow="ellipsis" vert="horz" wrap="square" anchor="ctr" anchorCtr="1"/>
          <a:lstStyle/>
          <a:p>
            <a:pPr>
              <a:defRPr sz="1400" b="0" i="1" u="none" strike="noStrike" kern="1200" baseline="0">
                <a:solidFill>
                  <a:schemeClr val="tx1"/>
                </a:solidFill>
                <a:latin typeface="+mn-lt"/>
                <a:ea typeface="+mn-ea"/>
                <a:cs typeface="+mn-cs"/>
              </a:defRPr>
            </a:pPr>
            <a:endParaRPr lang="en-US"/>
          </a:p>
        </c:txPr>
      </c:legendEntry>
      <c:legendEntry>
        <c:idx val="2"/>
        <c:txPr>
          <a:bodyPr rot="0" spcFirstLastPara="1" vertOverflow="ellipsis" vert="horz" wrap="square" anchor="ctr" anchorCtr="1"/>
          <a:lstStyle/>
          <a:p>
            <a:pPr>
              <a:defRPr sz="1400" b="0" i="1" u="none" strike="noStrike" kern="1200" baseline="0">
                <a:solidFill>
                  <a:schemeClr val="tx1"/>
                </a:solidFill>
                <a:latin typeface="+mn-lt"/>
                <a:ea typeface="+mn-ea"/>
                <a:cs typeface="+mn-cs"/>
              </a:defRPr>
            </a:pPr>
            <a:endParaRPr lang="en-US"/>
          </a:p>
        </c:txPr>
      </c:legendEntry>
      <c:layout>
        <c:manualLayout>
          <c:xMode val="edge"/>
          <c:yMode val="edge"/>
          <c:x val="0.1080148942161986"/>
          <c:y val="0.87503300970035469"/>
          <c:w val="0.85663521239456264"/>
          <c:h val="9.7551849514622493E-2"/>
        </c:manualLayout>
      </c:layout>
      <c:overlay val="0"/>
      <c:spPr>
        <a:noFill/>
        <a:ln>
          <a:noFill/>
        </a:ln>
        <a:effectLst/>
      </c:spPr>
      <c:txPr>
        <a:bodyPr rot="0" spcFirstLastPara="1" vertOverflow="ellipsis" vert="horz" wrap="square" anchor="ctr" anchorCtr="1"/>
        <a:lstStyle/>
        <a:p>
          <a:pPr>
            <a:defRPr sz="1400" b="0" i="0" u="none" strike="noStrike" kern="1200" baseline="0">
              <a:solidFill>
                <a:schemeClr val="tx1"/>
              </a:solidFill>
              <a:latin typeface="+mn-lt"/>
              <a:ea typeface="+mn-ea"/>
              <a:cs typeface="+mn-cs"/>
            </a:defRPr>
          </a:pPr>
          <a:endParaRPr lang="en-US"/>
        </a:p>
      </c:txPr>
    </c:legend>
    <c:plotVisOnly val="1"/>
    <c:dispBlanksAs val="gap"/>
    <c:showDLblsOverMax val="0"/>
  </c:chart>
  <c:spPr>
    <a:noFill/>
    <a:ln>
      <a:noFill/>
    </a:ln>
    <a:effectLst/>
  </c:spPr>
  <c:txPr>
    <a:bodyPr/>
    <a:lstStyle/>
    <a:p>
      <a:pPr>
        <a:defRPr>
          <a:solidFill>
            <a:schemeClr val="tx1"/>
          </a:solidFill>
        </a:defRPr>
      </a:pPr>
      <a:endParaRPr lang="en-US"/>
    </a:p>
  </c:txPr>
  <c:externalData r:id="rId3">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title>
      <c:tx>
        <c:rich>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r>
              <a:rPr lang="en-US"/>
              <a:t>PSI activity</a:t>
            </a:r>
          </a:p>
        </c:rich>
      </c:tx>
      <c:overlay val="0"/>
      <c:spPr>
        <a:noFill/>
        <a:ln>
          <a:noFill/>
        </a:ln>
        <a:effectLst/>
      </c:spPr>
      <c:txPr>
        <a:bodyPr rot="0" spcFirstLastPara="1" vertOverflow="ellipsis" vert="horz" wrap="square" anchor="ctr" anchorCtr="1"/>
        <a:lstStyle/>
        <a:p>
          <a:pPr>
            <a:defRPr sz="1400" b="0" i="0" u="none" strike="noStrike" kern="1200" spc="0" baseline="0">
              <a:solidFill>
                <a:schemeClr val="tx1"/>
              </a:solidFill>
              <a:latin typeface="Times New Roman" panose="02020603050405020304" pitchFamily="18" charset="0"/>
              <a:ea typeface="+mn-ea"/>
              <a:cs typeface="Times New Roman" panose="02020603050405020304" pitchFamily="18" charset="0"/>
            </a:defRPr>
          </a:pPr>
          <a:endParaRPr lang="en-US"/>
        </a:p>
      </c:txPr>
    </c:title>
    <c:autoTitleDeleted val="0"/>
    <c:plotArea>
      <c:layout/>
      <c:barChart>
        <c:barDir val="col"/>
        <c:grouping val="clustered"/>
        <c:varyColors val="0"/>
        <c:ser>
          <c:idx val="0"/>
          <c:order val="0"/>
          <c:tx>
            <c:strRef>
              <c:f>Summary!$A$37</c:f>
              <c:strCache>
                <c:ptCount val="1"/>
                <c:pt idx="0">
                  <c:v>WT</c:v>
                </c:pt>
              </c:strCache>
            </c:strRef>
          </c:tx>
          <c:spPr>
            <a:solidFill>
              <a:schemeClr val="tx1">
                <a:lumMod val="85000"/>
                <a:lumOff val="15000"/>
              </a:schemeClr>
            </a:solidFill>
            <a:ln>
              <a:noFill/>
            </a:ln>
            <a:effectLst/>
          </c:spPr>
          <c:invertIfNegative val="0"/>
          <c:errBars>
            <c:errBarType val="both"/>
            <c:errValType val="cust"/>
            <c:noEndCap val="0"/>
            <c:plus>
              <c:numRef>
                <c:f>Summary!$B$43:$D$43</c:f>
                <c:numCache>
                  <c:formatCode>General</c:formatCode>
                  <c:ptCount val="3"/>
                  <c:pt idx="0">
                    <c:v>3.496793245867736E-2</c:v>
                  </c:pt>
                  <c:pt idx="1">
                    <c:v>2.5074855334995767E-2</c:v>
                  </c:pt>
                  <c:pt idx="2">
                    <c:v>3.1784865754890361E-2</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cat>
            <c:strRef>
              <c:f>Summary!$B$36:$D$36</c:f>
              <c:strCache>
                <c:ptCount val="3"/>
                <c:pt idx="0">
                  <c:v>Dark-Ox</c:v>
                </c:pt>
                <c:pt idx="1">
                  <c:v>LL-Ox</c:v>
                </c:pt>
                <c:pt idx="2">
                  <c:v>HL-Hy</c:v>
                </c:pt>
              </c:strCache>
            </c:strRef>
          </c:cat>
          <c:val>
            <c:numRef>
              <c:f>Summary!$B$37:$D$37</c:f>
              <c:numCache>
                <c:formatCode>0.0%</c:formatCode>
                <c:ptCount val="3"/>
                <c:pt idx="0">
                  <c:v>1</c:v>
                </c:pt>
                <c:pt idx="1">
                  <c:v>1</c:v>
                </c:pt>
                <c:pt idx="2">
                  <c:v>1.0257903103707999</c:v>
                </c:pt>
              </c:numCache>
            </c:numRef>
          </c:val>
          <c:extLst>
            <c:ext xmlns:c16="http://schemas.microsoft.com/office/drawing/2014/chart" uri="{C3380CC4-5D6E-409C-BE32-E72D297353CC}">
              <c16:uniqueId val="{00000000-EAB4-8C46-AF3F-ABD3D87CEDE8}"/>
            </c:ext>
          </c:extLst>
        </c:ser>
        <c:ser>
          <c:idx val="1"/>
          <c:order val="1"/>
          <c:tx>
            <c:strRef>
              <c:f>Summary!$A$38</c:f>
              <c:strCache>
                <c:ptCount val="1"/>
                <c:pt idx="0">
                  <c:v>rmt2-1</c:v>
                </c:pt>
              </c:strCache>
            </c:strRef>
          </c:tx>
          <c:spPr>
            <a:solidFill>
              <a:srgbClr val="FF0000"/>
            </a:solidFill>
            <a:ln>
              <a:noFill/>
            </a:ln>
            <a:effectLst/>
          </c:spPr>
          <c:invertIfNegative val="0"/>
          <c:errBars>
            <c:errBarType val="both"/>
            <c:errValType val="cust"/>
            <c:noEndCap val="0"/>
            <c:plus>
              <c:numRef>
                <c:f>Summary!$C$44:$E$44</c:f>
                <c:numCache>
                  <c:formatCode>General</c:formatCode>
                  <c:ptCount val="3"/>
                  <c:pt idx="0">
                    <c:v>1.8891437206047829E-2</c:v>
                  </c:pt>
                  <c:pt idx="1">
                    <c:v>1.4365437697023486E-2</c:v>
                  </c:pt>
                  <c:pt idx="2">
                    <c:v>8.1047819499592451E-3</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cat>
            <c:strRef>
              <c:f>Summary!$B$36:$D$36</c:f>
              <c:strCache>
                <c:ptCount val="3"/>
                <c:pt idx="0">
                  <c:v>Dark-Ox</c:v>
                </c:pt>
                <c:pt idx="1">
                  <c:v>LL-Ox</c:v>
                </c:pt>
                <c:pt idx="2">
                  <c:v>HL-Hy</c:v>
                </c:pt>
              </c:strCache>
            </c:strRef>
          </c:cat>
          <c:val>
            <c:numRef>
              <c:f>Summary!$B$38:$D$38</c:f>
              <c:numCache>
                <c:formatCode>0.0%</c:formatCode>
                <c:ptCount val="3"/>
                <c:pt idx="0">
                  <c:v>0.23011403254211998</c:v>
                </c:pt>
                <c:pt idx="1">
                  <c:v>0.21253564885108817</c:v>
                </c:pt>
                <c:pt idx="2">
                  <c:v>0.39583867694464292</c:v>
                </c:pt>
              </c:numCache>
            </c:numRef>
          </c:val>
          <c:extLst>
            <c:ext xmlns:c16="http://schemas.microsoft.com/office/drawing/2014/chart" uri="{C3380CC4-5D6E-409C-BE32-E72D297353CC}">
              <c16:uniqueId val="{00000001-EAB4-8C46-AF3F-ABD3D87CEDE8}"/>
            </c:ext>
          </c:extLst>
        </c:ser>
        <c:ser>
          <c:idx val="2"/>
          <c:order val="2"/>
          <c:tx>
            <c:strRef>
              <c:f>Summary!$A$39</c:f>
              <c:strCache>
                <c:ptCount val="1"/>
                <c:pt idx="0">
                  <c:v>rmt2-2</c:v>
                </c:pt>
              </c:strCache>
            </c:strRef>
          </c:tx>
          <c:spPr>
            <a:pattFill prst="dkUpDiag">
              <a:fgClr>
                <a:srgbClr val="FF0000"/>
              </a:fgClr>
              <a:bgClr>
                <a:schemeClr val="bg1"/>
              </a:bgClr>
            </a:pattFill>
            <a:ln>
              <a:solidFill>
                <a:srgbClr val="FF0000"/>
              </a:solidFill>
            </a:ln>
            <a:effectLst/>
          </c:spPr>
          <c:invertIfNegative val="0"/>
          <c:errBars>
            <c:errBarType val="both"/>
            <c:errValType val="cust"/>
            <c:noEndCap val="0"/>
            <c:plus>
              <c:numRef>
                <c:f>Summary!$C$45:$D$45</c:f>
                <c:numCache>
                  <c:formatCode>General</c:formatCode>
                  <c:ptCount val="2"/>
                  <c:pt idx="0">
                    <c:v>1.9050761989890012E-3</c:v>
                  </c:pt>
                  <c:pt idx="1">
                    <c:v>2.8471498074924633E-3</c:v>
                  </c:pt>
                </c:numCache>
              </c:numRef>
            </c:plus>
            <c:minus>
              <c:numLit>
                <c:formatCode>General</c:formatCode>
                <c:ptCount val="1"/>
                <c:pt idx="0">
                  <c:v>0</c:v>
                </c:pt>
              </c:numLit>
            </c:minus>
            <c:spPr>
              <a:noFill/>
              <a:ln w="9525" cap="flat" cmpd="sng" algn="ctr">
                <a:solidFill>
                  <a:schemeClr val="tx1">
                    <a:lumMod val="65000"/>
                    <a:lumOff val="35000"/>
                  </a:schemeClr>
                </a:solidFill>
                <a:round/>
              </a:ln>
              <a:effectLst/>
            </c:spPr>
          </c:errBars>
          <c:cat>
            <c:strRef>
              <c:f>Summary!$B$36:$D$36</c:f>
              <c:strCache>
                <c:ptCount val="3"/>
                <c:pt idx="0">
                  <c:v>Dark-Ox</c:v>
                </c:pt>
                <c:pt idx="1">
                  <c:v>LL-Ox</c:v>
                </c:pt>
                <c:pt idx="2">
                  <c:v>HL-Hy</c:v>
                </c:pt>
              </c:strCache>
            </c:strRef>
          </c:cat>
          <c:val>
            <c:numRef>
              <c:f>Summary!$B$39:$D$39</c:f>
              <c:numCache>
                <c:formatCode>0.0%</c:formatCode>
                <c:ptCount val="3"/>
                <c:pt idx="0">
                  <c:v>0.28195768180370917</c:v>
                </c:pt>
                <c:pt idx="1">
                  <c:v>0.14565178837861742</c:v>
                </c:pt>
                <c:pt idx="2">
                  <c:v>0.44509882094461245</c:v>
                </c:pt>
              </c:numCache>
            </c:numRef>
          </c:val>
          <c:extLst>
            <c:ext xmlns:c16="http://schemas.microsoft.com/office/drawing/2014/chart" uri="{C3380CC4-5D6E-409C-BE32-E72D297353CC}">
              <c16:uniqueId val="{00000002-EAB4-8C46-AF3F-ABD3D87CEDE8}"/>
            </c:ext>
          </c:extLst>
        </c:ser>
        <c:dLbls>
          <c:showLegendKey val="0"/>
          <c:showVal val="0"/>
          <c:showCatName val="0"/>
          <c:showSerName val="0"/>
          <c:showPercent val="0"/>
          <c:showBubbleSize val="0"/>
        </c:dLbls>
        <c:gapWidth val="219"/>
        <c:overlap val="-27"/>
        <c:axId val="674299647"/>
        <c:axId val="674331951"/>
      </c:barChart>
      <c:catAx>
        <c:axId val="674299647"/>
        <c:scaling>
          <c:orientation val="minMax"/>
        </c:scaling>
        <c:delete val="0"/>
        <c:axPos val="b"/>
        <c:numFmt formatCode="General" sourceLinked="1"/>
        <c:majorTickMark val="none"/>
        <c:minorTickMark val="none"/>
        <c:tickLblPos val="nextTo"/>
        <c:spPr>
          <a:noFill/>
          <a:ln w="9525" cap="flat" cmpd="sng" algn="ctr">
            <a:solidFill>
              <a:schemeClr val="tx1">
                <a:lumMod val="15000"/>
                <a:lumOff val="85000"/>
              </a:schemeClr>
            </a:solidFill>
            <a:round/>
          </a:ln>
          <a:effectLst/>
        </c:spPr>
        <c:txPr>
          <a:bodyPr rot="-60000000" spcFirstLastPara="1" vertOverflow="ellipsis" vert="horz" wrap="square" anchor="ctr" anchorCtr="1"/>
          <a:lstStyle/>
          <a:p>
            <a:pPr>
              <a:defRPr sz="9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674331951"/>
        <c:crosses val="autoZero"/>
        <c:auto val="1"/>
        <c:lblAlgn val="ctr"/>
        <c:lblOffset val="100"/>
        <c:noMultiLvlLbl val="0"/>
      </c:catAx>
      <c:valAx>
        <c:axId val="674331951"/>
        <c:scaling>
          <c:orientation val="minMax"/>
          <c:max val="1.1000000000000001"/>
          <c:min val="0"/>
        </c:scaling>
        <c:delete val="0"/>
        <c:axPos val="l"/>
        <c:numFmt formatCode="0.0%" sourceLinked="1"/>
        <c:majorTickMark val="out"/>
        <c:minorTickMark val="none"/>
        <c:tickLblPos val="nextTo"/>
        <c:spPr>
          <a:noFill/>
          <a:ln>
            <a:solidFill>
              <a:schemeClr val="tx1">
                <a:lumMod val="50000"/>
                <a:lumOff val="50000"/>
              </a:schemeClr>
            </a:solidFill>
          </a:ln>
          <a:effectLst/>
        </c:spPr>
        <c:txPr>
          <a:bodyPr rot="-60000000" spcFirstLastPara="1" vertOverflow="ellipsis" vert="horz" wrap="square" anchor="ctr" anchorCtr="1"/>
          <a:lstStyle/>
          <a:p>
            <a:pPr>
              <a:defRPr sz="1000" b="0"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crossAx val="674299647"/>
        <c:crosses val="autoZero"/>
        <c:crossBetween val="between"/>
      </c:valAx>
      <c:dTable>
        <c:showHorzBorder val="1"/>
        <c:showVertBorder val="1"/>
        <c:showOutline val="1"/>
        <c:showKeys val="1"/>
        <c:spPr>
          <a:noFill/>
          <a:ln w="9525" cap="flat" cmpd="sng" algn="ctr">
            <a:solidFill>
              <a:schemeClr val="tx1">
                <a:lumMod val="15000"/>
                <a:lumOff val="85000"/>
              </a:schemeClr>
            </a:solidFill>
            <a:round/>
          </a:ln>
          <a:effectLst/>
        </c:spPr>
        <c:txPr>
          <a:bodyPr rot="0" spcFirstLastPara="1" vertOverflow="ellipsis" vert="horz" wrap="square" anchor="ctr" anchorCtr="1"/>
          <a:lstStyle/>
          <a:p>
            <a:pPr rtl="0">
              <a:defRPr sz="1000" b="1" i="0" u="none" strike="noStrike" kern="1200" baseline="0">
                <a:solidFill>
                  <a:schemeClr val="tx1"/>
                </a:solidFill>
                <a:latin typeface="Times New Roman" panose="02020603050405020304" pitchFamily="18" charset="0"/>
                <a:ea typeface="+mn-ea"/>
                <a:cs typeface="Times New Roman" panose="02020603050405020304" pitchFamily="18" charset="0"/>
              </a:defRPr>
            </a:pPr>
            <a:endParaRPr lang="en-US"/>
          </a:p>
        </c:txPr>
      </c:dTable>
      <c:spPr>
        <a:noFill/>
        <a:ln>
          <a:noFill/>
        </a:ln>
        <a:effectLst/>
      </c:spPr>
    </c:plotArea>
    <c:plotVisOnly val="1"/>
    <c:dispBlanksAs val="gap"/>
    <c:extLst>
      <c:ext xmlns:c16r3="http://schemas.microsoft.com/office/drawing/2017/03/chart" uri="{56B9EC1D-385E-4148-901F-78D8002777C0}">
        <c16r3:dataDisplayOptions16>
          <c16r3:dispNaAsBlank val="1"/>
        </c16r3:dataDisplayOptions16>
      </c:ext>
    </c:extLst>
    <c:showDLblsOverMax val="0"/>
  </c:chart>
  <c:spPr>
    <a:noFill/>
    <a:ln>
      <a:noFill/>
    </a:ln>
    <a:effectLst/>
  </c:spPr>
  <c:txPr>
    <a:bodyPr/>
    <a:lstStyle/>
    <a:p>
      <a:pPr>
        <a:defRPr>
          <a:solidFill>
            <a:schemeClr val="tx1"/>
          </a:solidFill>
          <a:latin typeface="Times New Roman" panose="02020603050405020304" pitchFamily="18" charset="0"/>
          <a:cs typeface="Times New Roman" panose="02020603050405020304" pitchFamily="18" charset="0"/>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4.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5.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6.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7.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4.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5.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6.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charts/style7.xml><?xml version="1.0" encoding="utf-8"?>
<cs:chartStyle xmlns:cs="http://schemas.microsoft.com/office/drawing/2012/chartStyle" xmlns:a="http://schemas.openxmlformats.org/drawingml/2006/main" id="201">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dk1"/>
    </cs:fontRef>
    <cs:spPr>
      <a:solidFill>
        <a:schemeClr val="dk1">
          <a:lumMod val="65000"/>
          <a:lumOff val="35000"/>
        </a:schemeClr>
      </a:solidFill>
      <a:ln w="9525">
        <a:solidFill>
          <a:schemeClr val="tx1">
            <a:lumMod val="65000"/>
            <a:lumOff val="35000"/>
          </a:schemeClr>
        </a:solidFill>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75000"/>
            <a:lumOff val="25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dk1"/>
    </cs:fontRef>
    <cs:spPr>
      <a:solidFill>
        <a:schemeClr val="lt1"/>
      </a:solidFill>
      <a:ln w="9525">
        <a:solidFill>
          <a:schemeClr val="tx1">
            <a:lumMod val="15000"/>
            <a:lumOff val="85000"/>
          </a:schemeClr>
        </a:solidFill>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0"/>
            <a:ext cx="2971800" cy="466434"/>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0"/>
            <a:ext cx="2971800" cy="466434"/>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829967"/>
            <a:ext cx="2971800" cy="466433"/>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829967"/>
            <a:ext cx="2971800" cy="466433"/>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86" name="Google Shape;86;p1: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8"/>
        <p:cNvGrpSpPr/>
        <p:nvPr/>
      </p:nvGrpSpPr>
      <p:grpSpPr>
        <a:xfrm>
          <a:off x="0" y="0"/>
          <a:ext cx="0" cy="0"/>
          <a:chOff x="0" y="0"/>
          <a:chExt cx="0" cy="0"/>
        </a:xfrm>
      </p:grpSpPr>
      <p:sp>
        <p:nvSpPr>
          <p:cNvPr id="549" name="Google Shape;549;p9: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550" name="Google Shape;550;p9: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55"/>
        <p:cNvGrpSpPr/>
        <p:nvPr/>
      </p:nvGrpSpPr>
      <p:grpSpPr>
        <a:xfrm>
          <a:off x="0" y="0"/>
          <a:ext cx="0" cy="0"/>
          <a:chOff x="0" y="0"/>
          <a:chExt cx="0" cy="0"/>
        </a:xfrm>
      </p:grpSpPr>
      <p:sp>
        <p:nvSpPr>
          <p:cNvPr id="556" name="Google Shape;556;p14: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57" name="Google Shape;557;p14: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Clr>
                <a:schemeClr val="dk1"/>
              </a:buClr>
              <a:buSzPts val="1200"/>
              <a:buFont typeface="Calibri"/>
              <a:buNone/>
            </a:pPr>
            <a:endParaRPr/>
          </a:p>
        </p:txBody>
      </p:sp>
      <p:sp>
        <p:nvSpPr>
          <p:cNvPr id="558" name="Google Shape;558;p14:notes"/>
          <p:cNvSpPr txBox="1">
            <a:spLocks noGrp="1"/>
          </p:cNvSpPr>
          <p:nvPr>
            <p:ph type="sldNum" idx="12"/>
          </p:nvPr>
        </p:nvSpPr>
        <p:spPr>
          <a:xfrm>
            <a:off x="3884613" y="8829967"/>
            <a:ext cx="2971800" cy="466433"/>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chemeClr val="dk1"/>
              </a:buClr>
              <a:buSzPts val="1200"/>
              <a:buFont typeface="Calibri"/>
              <a:buNone/>
            </a:pPr>
            <a:fld id="{00000000-1234-1234-1234-123412341234}" type="slidenum">
              <a:rPr lang="en-US"/>
              <a:t>11</a:t>
            </a:fld>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63"/>
        <p:cNvGrpSpPr/>
        <p:nvPr/>
      </p:nvGrpSpPr>
      <p:grpSpPr>
        <a:xfrm>
          <a:off x="0" y="0"/>
          <a:ext cx="0" cy="0"/>
          <a:chOff x="0" y="0"/>
          <a:chExt cx="0" cy="0"/>
        </a:xfrm>
      </p:grpSpPr>
      <p:sp>
        <p:nvSpPr>
          <p:cNvPr id="564" name="Google Shape;564;g2a0e20f5a8b_0_0: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65" name="Google Shape;565;g2a0e20f5a8b_0_0:notes"/>
          <p:cNvSpPr txBox="1">
            <a:spLocks noGrp="1"/>
          </p:cNvSpPr>
          <p:nvPr>
            <p:ph type="body" idx="1"/>
          </p:nvPr>
        </p:nvSpPr>
        <p:spPr>
          <a:xfrm>
            <a:off x="685800" y="4473892"/>
            <a:ext cx="5486400" cy="3660600"/>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566" name="Google Shape;566;g2a0e20f5a8b_0_0:notes"/>
          <p:cNvSpPr txBox="1">
            <a:spLocks noGrp="1"/>
          </p:cNvSpPr>
          <p:nvPr>
            <p:ph type="sldNum" idx="12"/>
          </p:nvPr>
        </p:nvSpPr>
        <p:spPr>
          <a:xfrm>
            <a:off x="3884613" y="8829967"/>
            <a:ext cx="2971800" cy="466500"/>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Clr>
                <a:srgbClr val="000000"/>
              </a:buClr>
              <a:buSzPts val="1400"/>
              <a:buFont typeface="Arial"/>
              <a:buNone/>
            </a:pPr>
            <a:fld id="{00000000-1234-1234-1234-123412341234}" type="slidenum">
              <a:rPr lang="en-US"/>
              <a:t>12</a:t>
            </a:fld>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9"/>
        <p:cNvGrpSpPr/>
        <p:nvPr/>
      </p:nvGrpSpPr>
      <p:grpSpPr>
        <a:xfrm>
          <a:off x="0" y="0"/>
          <a:ext cx="0" cy="0"/>
          <a:chOff x="0" y="0"/>
          <a:chExt cx="0" cy="0"/>
        </a:xfrm>
      </p:grpSpPr>
      <p:sp>
        <p:nvSpPr>
          <p:cNvPr id="90" name="Google Shape;90;p2: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1" name="Google Shape;91;p2: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92" name="Google Shape;92;p2:notes"/>
          <p:cNvSpPr txBox="1">
            <a:spLocks noGrp="1"/>
          </p:cNvSpPr>
          <p:nvPr>
            <p:ph type="sldNum" idx="12"/>
          </p:nvPr>
        </p:nvSpPr>
        <p:spPr>
          <a:xfrm>
            <a:off x="3884613" y="8829967"/>
            <a:ext cx="2971800" cy="466433"/>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2</a:t>
            </a:fld>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15"/>
        <p:cNvGrpSpPr/>
        <p:nvPr/>
      </p:nvGrpSpPr>
      <p:grpSpPr>
        <a:xfrm>
          <a:off x="0" y="0"/>
          <a:ext cx="0" cy="0"/>
          <a:chOff x="0" y="0"/>
          <a:chExt cx="0" cy="0"/>
        </a:xfrm>
      </p:grpSpPr>
      <p:sp>
        <p:nvSpPr>
          <p:cNvPr id="416" name="Google Shape;416;p3: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17" name="Google Shape;417;p3: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18" name="Google Shape;418;p3:notes"/>
          <p:cNvSpPr txBox="1">
            <a:spLocks noGrp="1"/>
          </p:cNvSpPr>
          <p:nvPr>
            <p:ph type="sldNum" idx="12"/>
          </p:nvPr>
        </p:nvSpPr>
        <p:spPr>
          <a:xfrm>
            <a:off x="3884613" y="8829967"/>
            <a:ext cx="2971800" cy="466433"/>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3</a:t>
            </a:fld>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39"/>
        <p:cNvGrpSpPr/>
        <p:nvPr/>
      </p:nvGrpSpPr>
      <p:grpSpPr>
        <a:xfrm>
          <a:off x="0" y="0"/>
          <a:ext cx="0" cy="0"/>
          <a:chOff x="0" y="0"/>
          <a:chExt cx="0" cy="0"/>
        </a:xfrm>
      </p:grpSpPr>
      <p:sp>
        <p:nvSpPr>
          <p:cNvPr id="440" name="Google Shape;440;p4: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1" name="Google Shape;441;p4: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42" name="Google Shape;442;p4:notes"/>
          <p:cNvSpPr txBox="1">
            <a:spLocks noGrp="1"/>
          </p:cNvSpPr>
          <p:nvPr>
            <p:ph type="sldNum" idx="12"/>
          </p:nvPr>
        </p:nvSpPr>
        <p:spPr>
          <a:xfrm>
            <a:off x="3884613" y="8829967"/>
            <a:ext cx="2971800" cy="466433"/>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7"/>
        <p:cNvGrpSpPr/>
        <p:nvPr/>
      </p:nvGrpSpPr>
      <p:grpSpPr>
        <a:xfrm>
          <a:off x="0" y="0"/>
          <a:ext cx="0" cy="0"/>
          <a:chOff x="0" y="0"/>
          <a:chExt cx="0" cy="0"/>
        </a:xfrm>
      </p:grpSpPr>
      <p:sp>
        <p:nvSpPr>
          <p:cNvPr id="448" name="Google Shape;448;p5: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49" name="Google Shape;449;p5: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50" name="Google Shape;450;p5:notes"/>
          <p:cNvSpPr txBox="1">
            <a:spLocks noGrp="1"/>
          </p:cNvSpPr>
          <p:nvPr>
            <p:ph type="sldNum" idx="12"/>
          </p:nvPr>
        </p:nvSpPr>
        <p:spPr>
          <a:xfrm>
            <a:off x="3884613" y="8829967"/>
            <a:ext cx="2971800" cy="466433"/>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5</a:t>
            </a:fld>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62"/>
        <p:cNvGrpSpPr/>
        <p:nvPr/>
      </p:nvGrpSpPr>
      <p:grpSpPr>
        <a:xfrm>
          <a:off x="0" y="0"/>
          <a:ext cx="0" cy="0"/>
          <a:chOff x="0" y="0"/>
          <a:chExt cx="0" cy="0"/>
        </a:xfrm>
      </p:grpSpPr>
      <p:sp>
        <p:nvSpPr>
          <p:cNvPr id="463" name="Google Shape;463;p6: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64" name="Google Shape;464;p6: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65" name="Google Shape;465;p6:notes"/>
          <p:cNvSpPr txBox="1">
            <a:spLocks noGrp="1"/>
          </p:cNvSpPr>
          <p:nvPr>
            <p:ph type="sldNum" idx="12"/>
          </p:nvPr>
        </p:nvSpPr>
        <p:spPr>
          <a:xfrm>
            <a:off x="3884613" y="8829967"/>
            <a:ext cx="2971800" cy="466433"/>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6</a:t>
            </a:fld>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70"/>
        <p:cNvGrpSpPr/>
        <p:nvPr/>
      </p:nvGrpSpPr>
      <p:grpSpPr>
        <a:xfrm>
          <a:off x="0" y="0"/>
          <a:ext cx="0" cy="0"/>
          <a:chOff x="0" y="0"/>
          <a:chExt cx="0" cy="0"/>
        </a:xfrm>
      </p:grpSpPr>
      <p:sp>
        <p:nvSpPr>
          <p:cNvPr id="471" name="Google Shape;471;p7: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472" name="Google Shape;472;p7: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473" name="Google Shape;473;p7:notes"/>
          <p:cNvSpPr txBox="1">
            <a:spLocks noGrp="1"/>
          </p:cNvSpPr>
          <p:nvPr>
            <p:ph type="sldNum" idx="12"/>
          </p:nvPr>
        </p:nvSpPr>
        <p:spPr>
          <a:xfrm>
            <a:off x="3884613" y="8829967"/>
            <a:ext cx="2971800" cy="466433"/>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7</a:t>
            </a:fld>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31"/>
        <p:cNvGrpSpPr/>
        <p:nvPr/>
      </p:nvGrpSpPr>
      <p:grpSpPr>
        <a:xfrm>
          <a:off x="0" y="0"/>
          <a:ext cx="0" cy="0"/>
          <a:chOff x="0" y="0"/>
          <a:chExt cx="0" cy="0"/>
        </a:xfrm>
      </p:grpSpPr>
      <p:sp>
        <p:nvSpPr>
          <p:cNvPr id="532" name="Google Shape;532;p8: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533" name="Google Shape;533;p8: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540"/>
        <p:cNvGrpSpPr/>
        <p:nvPr/>
      </p:nvGrpSpPr>
      <p:grpSpPr>
        <a:xfrm>
          <a:off x="0" y="0"/>
          <a:ext cx="0" cy="0"/>
          <a:chOff x="0" y="0"/>
          <a:chExt cx="0" cy="0"/>
        </a:xfrm>
      </p:grpSpPr>
      <p:sp>
        <p:nvSpPr>
          <p:cNvPr id="541" name="Google Shape;541;p13:notes"/>
          <p:cNvSpPr>
            <a:spLocks noGrp="1" noRot="1" noChangeAspect="1"/>
          </p:cNvSpPr>
          <p:nvPr>
            <p:ph type="sldImg" idx="2"/>
          </p:nvPr>
        </p:nvSpPr>
        <p:spPr>
          <a:xfrm>
            <a:off x="2217738" y="1162050"/>
            <a:ext cx="2422525" cy="31369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542" name="Google Shape;542;p13:notes"/>
          <p:cNvSpPr txBox="1">
            <a:spLocks noGrp="1"/>
          </p:cNvSpPr>
          <p:nvPr>
            <p:ph type="body" idx="1"/>
          </p:nvPr>
        </p:nvSpPr>
        <p:spPr>
          <a:xfrm>
            <a:off x="685800" y="4473892"/>
            <a:ext cx="5486400" cy="3660458"/>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543" name="Google Shape;543;p13:notes"/>
          <p:cNvSpPr txBox="1">
            <a:spLocks noGrp="1"/>
          </p:cNvSpPr>
          <p:nvPr>
            <p:ph type="sldNum" idx="12"/>
          </p:nvPr>
        </p:nvSpPr>
        <p:spPr>
          <a:xfrm>
            <a:off x="3884613" y="8829967"/>
            <a:ext cx="2971800" cy="466433"/>
          </a:xfrm>
          <a:prstGeom prst="rect">
            <a:avLst/>
          </a:prstGeom>
          <a:noFill/>
          <a:ln>
            <a:noFill/>
          </a:ln>
        </p:spPr>
        <p:txBody>
          <a:bodyPr spcFirstLastPara="1" wrap="square" lIns="91425" tIns="45700" rIns="91425" bIns="45700" anchor="b" anchorCtr="0">
            <a:noAutofit/>
          </a:bodyPr>
          <a:lstStyle/>
          <a:p>
            <a:pPr marL="0" lvl="0" indent="0" algn="r" rtl="0">
              <a:lnSpc>
                <a:spcPct val="100000"/>
              </a:lnSpc>
              <a:spcBef>
                <a:spcPts val="0"/>
              </a:spcBef>
              <a:spcAft>
                <a:spcPts val="0"/>
              </a:spcAft>
              <a:buSzPts val="1400"/>
              <a:buNone/>
            </a:pPr>
            <a:fld id="{00000000-1234-1234-1234-123412341234}" type="slidenum">
              <a:rPr lang="en-US"/>
              <a:t>9</a:t>
            </a:fld>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16"/>
          <p:cNvSpPr txBox="1">
            <a:spLocks noGrp="1"/>
          </p:cNvSpPr>
          <p:nvPr>
            <p:ph type="ctrTitle"/>
          </p:nvPr>
        </p:nvSpPr>
        <p:spPr>
          <a:xfrm>
            <a:off x="582930" y="1646133"/>
            <a:ext cx="6606540" cy="3501813"/>
          </a:xfrm>
          <a:prstGeom prst="rect">
            <a:avLst/>
          </a:prstGeom>
          <a:noFill/>
          <a:ln>
            <a:noFill/>
          </a:ln>
        </p:spPr>
        <p:txBody>
          <a:bodyPr spcFirstLastPara="1" wrap="square" lIns="91425" tIns="45700" rIns="91425" bIns="45700" anchor="b" anchorCtr="0">
            <a:normAutofit/>
          </a:bodyPr>
          <a:lstStyle>
            <a:lvl1pPr lvl="0" algn="ctr">
              <a:lnSpc>
                <a:spcPct val="90000"/>
              </a:lnSpc>
              <a:spcBef>
                <a:spcPts val="0"/>
              </a:spcBef>
              <a:spcAft>
                <a:spcPts val="0"/>
              </a:spcAft>
              <a:buClr>
                <a:schemeClr val="dk1"/>
              </a:buClr>
              <a:buSzPts val="5100"/>
              <a:buFont typeface="Arial"/>
              <a:buNone/>
              <a:defRPr sz="51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7" name="Google Shape;17;p16"/>
          <p:cNvSpPr txBox="1">
            <a:spLocks noGrp="1"/>
          </p:cNvSpPr>
          <p:nvPr>
            <p:ph type="subTitle" idx="1"/>
          </p:nvPr>
        </p:nvSpPr>
        <p:spPr>
          <a:xfrm>
            <a:off x="971550" y="5282989"/>
            <a:ext cx="5829300" cy="2428451"/>
          </a:xfrm>
          <a:prstGeom prst="rect">
            <a:avLst/>
          </a:prstGeom>
          <a:noFill/>
          <a:ln>
            <a:noFill/>
          </a:ln>
        </p:spPr>
        <p:txBody>
          <a:bodyPr spcFirstLastPara="1" wrap="square" lIns="91425" tIns="45700" rIns="91425" bIns="45700" anchor="t" anchorCtr="0">
            <a:normAutofit/>
          </a:bodyPr>
          <a:lstStyle>
            <a:lvl1pPr lvl="0" algn="ctr">
              <a:lnSpc>
                <a:spcPct val="90000"/>
              </a:lnSpc>
              <a:spcBef>
                <a:spcPts val="850"/>
              </a:spcBef>
              <a:spcAft>
                <a:spcPts val="0"/>
              </a:spcAft>
              <a:buClr>
                <a:schemeClr val="dk1"/>
              </a:buClr>
              <a:buSzPts val="2040"/>
              <a:buNone/>
              <a:defRPr sz="2040"/>
            </a:lvl1pPr>
            <a:lvl2pPr lvl="1" algn="ctr">
              <a:lnSpc>
                <a:spcPct val="90000"/>
              </a:lnSpc>
              <a:spcBef>
                <a:spcPts val="425"/>
              </a:spcBef>
              <a:spcAft>
                <a:spcPts val="0"/>
              </a:spcAft>
              <a:buClr>
                <a:schemeClr val="dk1"/>
              </a:buClr>
              <a:buSzPts val="1700"/>
              <a:buNone/>
              <a:defRPr sz="1700"/>
            </a:lvl2pPr>
            <a:lvl3pPr lvl="2" algn="ctr">
              <a:lnSpc>
                <a:spcPct val="90000"/>
              </a:lnSpc>
              <a:spcBef>
                <a:spcPts val="425"/>
              </a:spcBef>
              <a:spcAft>
                <a:spcPts val="0"/>
              </a:spcAft>
              <a:buClr>
                <a:schemeClr val="dk1"/>
              </a:buClr>
              <a:buSzPts val="1530"/>
              <a:buNone/>
              <a:defRPr sz="1530"/>
            </a:lvl3pPr>
            <a:lvl4pPr lvl="3" algn="ctr">
              <a:lnSpc>
                <a:spcPct val="90000"/>
              </a:lnSpc>
              <a:spcBef>
                <a:spcPts val="425"/>
              </a:spcBef>
              <a:spcAft>
                <a:spcPts val="0"/>
              </a:spcAft>
              <a:buClr>
                <a:schemeClr val="dk1"/>
              </a:buClr>
              <a:buSzPts val="1360"/>
              <a:buNone/>
              <a:defRPr sz="1360"/>
            </a:lvl4pPr>
            <a:lvl5pPr lvl="4" algn="ctr">
              <a:lnSpc>
                <a:spcPct val="90000"/>
              </a:lnSpc>
              <a:spcBef>
                <a:spcPts val="425"/>
              </a:spcBef>
              <a:spcAft>
                <a:spcPts val="0"/>
              </a:spcAft>
              <a:buClr>
                <a:schemeClr val="dk1"/>
              </a:buClr>
              <a:buSzPts val="1360"/>
              <a:buNone/>
              <a:defRPr sz="1360"/>
            </a:lvl5pPr>
            <a:lvl6pPr lvl="5" algn="ctr">
              <a:lnSpc>
                <a:spcPct val="90000"/>
              </a:lnSpc>
              <a:spcBef>
                <a:spcPts val="425"/>
              </a:spcBef>
              <a:spcAft>
                <a:spcPts val="0"/>
              </a:spcAft>
              <a:buClr>
                <a:schemeClr val="dk1"/>
              </a:buClr>
              <a:buSzPts val="1360"/>
              <a:buNone/>
              <a:defRPr sz="1360"/>
            </a:lvl6pPr>
            <a:lvl7pPr lvl="6" algn="ctr">
              <a:lnSpc>
                <a:spcPct val="90000"/>
              </a:lnSpc>
              <a:spcBef>
                <a:spcPts val="425"/>
              </a:spcBef>
              <a:spcAft>
                <a:spcPts val="0"/>
              </a:spcAft>
              <a:buClr>
                <a:schemeClr val="dk1"/>
              </a:buClr>
              <a:buSzPts val="1360"/>
              <a:buNone/>
              <a:defRPr sz="1360"/>
            </a:lvl7pPr>
            <a:lvl8pPr lvl="7" algn="ctr">
              <a:lnSpc>
                <a:spcPct val="90000"/>
              </a:lnSpc>
              <a:spcBef>
                <a:spcPts val="425"/>
              </a:spcBef>
              <a:spcAft>
                <a:spcPts val="0"/>
              </a:spcAft>
              <a:buClr>
                <a:schemeClr val="dk1"/>
              </a:buClr>
              <a:buSzPts val="1360"/>
              <a:buNone/>
              <a:defRPr sz="1360"/>
            </a:lvl8pPr>
            <a:lvl9pPr lvl="8" algn="ctr">
              <a:lnSpc>
                <a:spcPct val="90000"/>
              </a:lnSpc>
              <a:spcBef>
                <a:spcPts val="425"/>
              </a:spcBef>
              <a:spcAft>
                <a:spcPts val="0"/>
              </a:spcAft>
              <a:buClr>
                <a:schemeClr val="dk1"/>
              </a:buClr>
              <a:buSzPts val="1360"/>
              <a:buNone/>
              <a:defRPr sz="1360"/>
            </a:lvl9pPr>
          </a:lstStyle>
          <a:p>
            <a:endParaRPr/>
          </a:p>
        </p:txBody>
      </p:sp>
      <p:sp>
        <p:nvSpPr>
          <p:cNvPr id="18" name="Google Shape;18;p16"/>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19" name="Google Shape;19;p16"/>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0" name="Google Shape;20;p16"/>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25"/>
          <p:cNvSpPr txBox="1">
            <a:spLocks noGrp="1"/>
          </p:cNvSpPr>
          <p:nvPr>
            <p:ph type="title"/>
          </p:nvPr>
        </p:nvSpPr>
        <p:spPr>
          <a:xfrm>
            <a:off x="534353" y="535519"/>
            <a:ext cx="6703695" cy="194415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4" name="Google Shape;74;p25"/>
          <p:cNvSpPr txBox="1">
            <a:spLocks noGrp="1"/>
          </p:cNvSpPr>
          <p:nvPr>
            <p:ph type="body" idx="1"/>
          </p:nvPr>
        </p:nvSpPr>
        <p:spPr>
          <a:xfrm rot="5400000">
            <a:off x="695219" y="2516718"/>
            <a:ext cx="6381962" cy="6703695"/>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50"/>
              </a:spcBef>
              <a:spcAft>
                <a:spcPts val="0"/>
              </a:spcAft>
              <a:buClr>
                <a:schemeClr val="dk1"/>
              </a:buClr>
              <a:buSzPts val="1800"/>
              <a:buChar char="•"/>
              <a:defRPr/>
            </a:lvl1pPr>
            <a:lvl2pPr marL="914400" lvl="1" indent="-342900" algn="l">
              <a:lnSpc>
                <a:spcPct val="90000"/>
              </a:lnSpc>
              <a:spcBef>
                <a:spcPts val="425"/>
              </a:spcBef>
              <a:spcAft>
                <a:spcPts val="0"/>
              </a:spcAft>
              <a:buClr>
                <a:schemeClr val="dk1"/>
              </a:buClr>
              <a:buSzPts val="1800"/>
              <a:buChar char="•"/>
              <a:defRPr/>
            </a:lvl2pPr>
            <a:lvl3pPr marL="1371600" lvl="2" indent="-342900" algn="l">
              <a:lnSpc>
                <a:spcPct val="90000"/>
              </a:lnSpc>
              <a:spcBef>
                <a:spcPts val="425"/>
              </a:spcBef>
              <a:spcAft>
                <a:spcPts val="0"/>
              </a:spcAft>
              <a:buClr>
                <a:schemeClr val="dk1"/>
              </a:buClr>
              <a:buSzPts val="1800"/>
              <a:buChar char="•"/>
              <a:defRPr/>
            </a:lvl3pPr>
            <a:lvl4pPr marL="1828800" lvl="3" indent="-342900" algn="l">
              <a:lnSpc>
                <a:spcPct val="90000"/>
              </a:lnSpc>
              <a:spcBef>
                <a:spcPts val="425"/>
              </a:spcBef>
              <a:spcAft>
                <a:spcPts val="0"/>
              </a:spcAft>
              <a:buClr>
                <a:schemeClr val="dk1"/>
              </a:buClr>
              <a:buSzPts val="1800"/>
              <a:buChar char="•"/>
              <a:defRPr/>
            </a:lvl4pPr>
            <a:lvl5pPr marL="2286000" lvl="4" indent="-342900" algn="l">
              <a:lnSpc>
                <a:spcPct val="90000"/>
              </a:lnSpc>
              <a:spcBef>
                <a:spcPts val="425"/>
              </a:spcBef>
              <a:spcAft>
                <a:spcPts val="0"/>
              </a:spcAft>
              <a:buClr>
                <a:schemeClr val="dk1"/>
              </a:buClr>
              <a:buSzPts val="1800"/>
              <a:buChar char="•"/>
              <a:defRPr/>
            </a:lvl5pPr>
            <a:lvl6pPr marL="2743200" lvl="5" indent="-342900" algn="l">
              <a:lnSpc>
                <a:spcPct val="90000"/>
              </a:lnSpc>
              <a:spcBef>
                <a:spcPts val="425"/>
              </a:spcBef>
              <a:spcAft>
                <a:spcPts val="0"/>
              </a:spcAft>
              <a:buClr>
                <a:schemeClr val="dk1"/>
              </a:buClr>
              <a:buSzPts val="1800"/>
              <a:buChar char="•"/>
              <a:defRPr/>
            </a:lvl6pPr>
            <a:lvl7pPr marL="3200400" lvl="6" indent="-342900" algn="l">
              <a:lnSpc>
                <a:spcPct val="90000"/>
              </a:lnSpc>
              <a:spcBef>
                <a:spcPts val="425"/>
              </a:spcBef>
              <a:spcAft>
                <a:spcPts val="0"/>
              </a:spcAft>
              <a:buClr>
                <a:schemeClr val="dk1"/>
              </a:buClr>
              <a:buSzPts val="1800"/>
              <a:buChar char="•"/>
              <a:defRPr/>
            </a:lvl7pPr>
            <a:lvl8pPr marL="3657600" lvl="7" indent="-342900" algn="l">
              <a:lnSpc>
                <a:spcPct val="90000"/>
              </a:lnSpc>
              <a:spcBef>
                <a:spcPts val="425"/>
              </a:spcBef>
              <a:spcAft>
                <a:spcPts val="0"/>
              </a:spcAft>
              <a:buClr>
                <a:schemeClr val="dk1"/>
              </a:buClr>
              <a:buSzPts val="1800"/>
              <a:buChar char="•"/>
              <a:defRPr/>
            </a:lvl8pPr>
            <a:lvl9pPr marL="4114800" lvl="8" indent="-342900" algn="l">
              <a:lnSpc>
                <a:spcPct val="90000"/>
              </a:lnSpc>
              <a:spcBef>
                <a:spcPts val="425"/>
              </a:spcBef>
              <a:spcAft>
                <a:spcPts val="0"/>
              </a:spcAft>
              <a:buClr>
                <a:schemeClr val="dk1"/>
              </a:buClr>
              <a:buSzPts val="1800"/>
              <a:buChar char="•"/>
              <a:defRPr/>
            </a:lvl9pPr>
          </a:lstStyle>
          <a:p>
            <a:endParaRPr/>
          </a:p>
        </p:txBody>
      </p:sp>
      <p:sp>
        <p:nvSpPr>
          <p:cNvPr id="75" name="Google Shape;75;p25"/>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6" name="Google Shape;76;p25"/>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7" name="Google Shape;77;p25"/>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26"/>
          <p:cNvSpPr txBox="1">
            <a:spLocks noGrp="1"/>
          </p:cNvSpPr>
          <p:nvPr>
            <p:ph type="title"/>
          </p:nvPr>
        </p:nvSpPr>
        <p:spPr>
          <a:xfrm rot="5400000">
            <a:off x="2138071" y="3959569"/>
            <a:ext cx="8524029" cy="1675924"/>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0" name="Google Shape;80;p26"/>
          <p:cNvSpPr txBox="1">
            <a:spLocks noGrp="1"/>
          </p:cNvSpPr>
          <p:nvPr>
            <p:ph type="body" idx="1"/>
          </p:nvPr>
        </p:nvSpPr>
        <p:spPr>
          <a:xfrm rot="5400000">
            <a:off x="-1262353" y="2332223"/>
            <a:ext cx="8524029" cy="4930616"/>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50"/>
              </a:spcBef>
              <a:spcAft>
                <a:spcPts val="0"/>
              </a:spcAft>
              <a:buClr>
                <a:schemeClr val="dk1"/>
              </a:buClr>
              <a:buSzPts val="1800"/>
              <a:buChar char="•"/>
              <a:defRPr/>
            </a:lvl1pPr>
            <a:lvl2pPr marL="914400" lvl="1" indent="-342900" algn="l">
              <a:lnSpc>
                <a:spcPct val="90000"/>
              </a:lnSpc>
              <a:spcBef>
                <a:spcPts val="425"/>
              </a:spcBef>
              <a:spcAft>
                <a:spcPts val="0"/>
              </a:spcAft>
              <a:buClr>
                <a:schemeClr val="dk1"/>
              </a:buClr>
              <a:buSzPts val="1800"/>
              <a:buChar char="•"/>
              <a:defRPr/>
            </a:lvl2pPr>
            <a:lvl3pPr marL="1371600" lvl="2" indent="-342900" algn="l">
              <a:lnSpc>
                <a:spcPct val="90000"/>
              </a:lnSpc>
              <a:spcBef>
                <a:spcPts val="425"/>
              </a:spcBef>
              <a:spcAft>
                <a:spcPts val="0"/>
              </a:spcAft>
              <a:buClr>
                <a:schemeClr val="dk1"/>
              </a:buClr>
              <a:buSzPts val="1800"/>
              <a:buChar char="•"/>
              <a:defRPr/>
            </a:lvl3pPr>
            <a:lvl4pPr marL="1828800" lvl="3" indent="-342900" algn="l">
              <a:lnSpc>
                <a:spcPct val="90000"/>
              </a:lnSpc>
              <a:spcBef>
                <a:spcPts val="425"/>
              </a:spcBef>
              <a:spcAft>
                <a:spcPts val="0"/>
              </a:spcAft>
              <a:buClr>
                <a:schemeClr val="dk1"/>
              </a:buClr>
              <a:buSzPts val="1800"/>
              <a:buChar char="•"/>
              <a:defRPr/>
            </a:lvl4pPr>
            <a:lvl5pPr marL="2286000" lvl="4" indent="-342900" algn="l">
              <a:lnSpc>
                <a:spcPct val="90000"/>
              </a:lnSpc>
              <a:spcBef>
                <a:spcPts val="425"/>
              </a:spcBef>
              <a:spcAft>
                <a:spcPts val="0"/>
              </a:spcAft>
              <a:buClr>
                <a:schemeClr val="dk1"/>
              </a:buClr>
              <a:buSzPts val="1800"/>
              <a:buChar char="•"/>
              <a:defRPr/>
            </a:lvl5pPr>
            <a:lvl6pPr marL="2743200" lvl="5" indent="-342900" algn="l">
              <a:lnSpc>
                <a:spcPct val="90000"/>
              </a:lnSpc>
              <a:spcBef>
                <a:spcPts val="425"/>
              </a:spcBef>
              <a:spcAft>
                <a:spcPts val="0"/>
              </a:spcAft>
              <a:buClr>
                <a:schemeClr val="dk1"/>
              </a:buClr>
              <a:buSzPts val="1800"/>
              <a:buChar char="•"/>
              <a:defRPr/>
            </a:lvl6pPr>
            <a:lvl7pPr marL="3200400" lvl="6" indent="-342900" algn="l">
              <a:lnSpc>
                <a:spcPct val="90000"/>
              </a:lnSpc>
              <a:spcBef>
                <a:spcPts val="425"/>
              </a:spcBef>
              <a:spcAft>
                <a:spcPts val="0"/>
              </a:spcAft>
              <a:buClr>
                <a:schemeClr val="dk1"/>
              </a:buClr>
              <a:buSzPts val="1800"/>
              <a:buChar char="•"/>
              <a:defRPr/>
            </a:lvl7pPr>
            <a:lvl8pPr marL="3657600" lvl="7" indent="-342900" algn="l">
              <a:lnSpc>
                <a:spcPct val="90000"/>
              </a:lnSpc>
              <a:spcBef>
                <a:spcPts val="425"/>
              </a:spcBef>
              <a:spcAft>
                <a:spcPts val="0"/>
              </a:spcAft>
              <a:buClr>
                <a:schemeClr val="dk1"/>
              </a:buClr>
              <a:buSzPts val="1800"/>
              <a:buChar char="•"/>
              <a:defRPr/>
            </a:lvl8pPr>
            <a:lvl9pPr marL="4114800" lvl="8" indent="-342900" algn="l">
              <a:lnSpc>
                <a:spcPct val="90000"/>
              </a:lnSpc>
              <a:spcBef>
                <a:spcPts val="425"/>
              </a:spcBef>
              <a:spcAft>
                <a:spcPts val="0"/>
              </a:spcAft>
              <a:buClr>
                <a:schemeClr val="dk1"/>
              </a:buClr>
              <a:buSzPts val="1800"/>
              <a:buChar char="•"/>
              <a:defRPr/>
            </a:lvl9pPr>
          </a:lstStyle>
          <a:p>
            <a:endParaRPr/>
          </a:p>
        </p:txBody>
      </p:sp>
      <p:sp>
        <p:nvSpPr>
          <p:cNvPr id="81" name="Google Shape;81;p26"/>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2" name="Google Shape;82;p26"/>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83" name="Google Shape;83;p26"/>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17"/>
          <p:cNvSpPr txBox="1">
            <a:spLocks noGrp="1"/>
          </p:cNvSpPr>
          <p:nvPr>
            <p:ph type="title"/>
          </p:nvPr>
        </p:nvSpPr>
        <p:spPr>
          <a:xfrm>
            <a:off x="534353" y="535519"/>
            <a:ext cx="6703695" cy="194415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3" name="Google Shape;23;p17"/>
          <p:cNvSpPr txBox="1">
            <a:spLocks noGrp="1"/>
          </p:cNvSpPr>
          <p:nvPr>
            <p:ph type="body" idx="1"/>
          </p:nvPr>
        </p:nvSpPr>
        <p:spPr>
          <a:xfrm>
            <a:off x="534353" y="2677584"/>
            <a:ext cx="6703695" cy="638196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50"/>
              </a:spcBef>
              <a:spcAft>
                <a:spcPts val="0"/>
              </a:spcAft>
              <a:buClr>
                <a:schemeClr val="dk1"/>
              </a:buClr>
              <a:buSzPts val="1800"/>
              <a:buChar char="•"/>
              <a:defRPr/>
            </a:lvl1pPr>
            <a:lvl2pPr marL="914400" lvl="1" indent="-342900" algn="l">
              <a:lnSpc>
                <a:spcPct val="90000"/>
              </a:lnSpc>
              <a:spcBef>
                <a:spcPts val="425"/>
              </a:spcBef>
              <a:spcAft>
                <a:spcPts val="0"/>
              </a:spcAft>
              <a:buClr>
                <a:schemeClr val="dk1"/>
              </a:buClr>
              <a:buSzPts val="1800"/>
              <a:buChar char="•"/>
              <a:defRPr/>
            </a:lvl2pPr>
            <a:lvl3pPr marL="1371600" lvl="2" indent="-342900" algn="l">
              <a:lnSpc>
                <a:spcPct val="90000"/>
              </a:lnSpc>
              <a:spcBef>
                <a:spcPts val="425"/>
              </a:spcBef>
              <a:spcAft>
                <a:spcPts val="0"/>
              </a:spcAft>
              <a:buClr>
                <a:schemeClr val="dk1"/>
              </a:buClr>
              <a:buSzPts val="1800"/>
              <a:buChar char="•"/>
              <a:defRPr/>
            </a:lvl3pPr>
            <a:lvl4pPr marL="1828800" lvl="3" indent="-342900" algn="l">
              <a:lnSpc>
                <a:spcPct val="90000"/>
              </a:lnSpc>
              <a:spcBef>
                <a:spcPts val="425"/>
              </a:spcBef>
              <a:spcAft>
                <a:spcPts val="0"/>
              </a:spcAft>
              <a:buClr>
                <a:schemeClr val="dk1"/>
              </a:buClr>
              <a:buSzPts val="1800"/>
              <a:buChar char="•"/>
              <a:defRPr/>
            </a:lvl4pPr>
            <a:lvl5pPr marL="2286000" lvl="4" indent="-342900" algn="l">
              <a:lnSpc>
                <a:spcPct val="90000"/>
              </a:lnSpc>
              <a:spcBef>
                <a:spcPts val="425"/>
              </a:spcBef>
              <a:spcAft>
                <a:spcPts val="0"/>
              </a:spcAft>
              <a:buClr>
                <a:schemeClr val="dk1"/>
              </a:buClr>
              <a:buSzPts val="1800"/>
              <a:buChar char="•"/>
              <a:defRPr/>
            </a:lvl5pPr>
            <a:lvl6pPr marL="2743200" lvl="5" indent="-342900" algn="l">
              <a:lnSpc>
                <a:spcPct val="90000"/>
              </a:lnSpc>
              <a:spcBef>
                <a:spcPts val="425"/>
              </a:spcBef>
              <a:spcAft>
                <a:spcPts val="0"/>
              </a:spcAft>
              <a:buClr>
                <a:schemeClr val="dk1"/>
              </a:buClr>
              <a:buSzPts val="1800"/>
              <a:buChar char="•"/>
              <a:defRPr/>
            </a:lvl6pPr>
            <a:lvl7pPr marL="3200400" lvl="6" indent="-342900" algn="l">
              <a:lnSpc>
                <a:spcPct val="90000"/>
              </a:lnSpc>
              <a:spcBef>
                <a:spcPts val="425"/>
              </a:spcBef>
              <a:spcAft>
                <a:spcPts val="0"/>
              </a:spcAft>
              <a:buClr>
                <a:schemeClr val="dk1"/>
              </a:buClr>
              <a:buSzPts val="1800"/>
              <a:buChar char="•"/>
              <a:defRPr/>
            </a:lvl7pPr>
            <a:lvl8pPr marL="3657600" lvl="7" indent="-342900" algn="l">
              <a:lnSpc>
                <a:spcPct val="90000"/>
              </a:lnSpc>
              <a:spcBef>
                <a:spcPts val="425"/>
              </a:spcBef>
              <a:spcAft>
                <a:spcPts val="0"/>
              </a:spcAft>
              <a:buClr>
                <a:schemeClr val="dk1"/>
              </a:buClr>
              <a:buSzPts val="1800"/>
              <a:buChar char="•"/>
              <a:defRPr/>
            </a:lvl8pPr>
            <a:lvl9pPr marL="4114800" lvl="8" indent="-342900" algn="l">
              <a:lnSpc>
                <a:spcPct val="90000"/>
              </a:lnSpc>
              <a:spcBef>
                <a:spcPts val="425"/>
              </a:spcBef>
              <a:spcAft>
                <a:spcPts val="0"/>
              </a:spcAft>
              <a:buClr>
                <a:schemeClr val="dk1"/>
              </a:buClr>
              <a:buSzPts val="1800"/>
              <a:buChar char="•"/>
              <a:defRPr/>
            </a:lvl9pPr>
          </a:lstStyle>
          <a:p>
            <a:endParaRPr/>
          </a:p>
        </p:txBody>
      </p:sp>
      <p:sp>
        <p:nvSpPr>
          <p:cNvPr id="24" name="Google Shape;24;p17"/>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5" name="Google Shape;25;p17"/>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6" name="Google Shape;26;p17"/>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27"/>
        <p:cNvGrpSpPr/>
        <p:nvPr/>
      </p:nvGrpSpPr>
      <p:grpSpPr>
        <a:xfrm>
          <a:off x="0" y="0"/>
          <a:ext cx="0" cy="0"/>
          <a:chOff x="0" y="0"/>
          <a:chExt cx="0" cy="0"/>
        </a:xfrm>
      </p:grpSpPr>
      <p:sp>
        <p:nvSpPr>
          <p:cNvPr id="28" name="Google Shape;28;p18"/>
          <p:cNvSpPr txBox="1">
            <a:spLocks noGrp="1"/>
          </p:cNvSpPr>
          <p:nvPr>
            <p:ph type="title"/>
          </p:nvPr>
        </p:nvSpPr>
        <p:spPr>
          <a:xfrm>
            <a:off x="530305" y="2507618"/>
            <a:ext cx="6703695" cy="4184014"/>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5100"/>
              <a:buFont typeface="Arial"/>
              <a:buNone/>
              <a:defRPr sz="510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29" name="Google Shape;29;p18"/>
          <p:cNvSpPr txBox="1">
            <a:spLocks noGrp="1"/>
          </p:cNvSpPr>
          <p:nvPr>
            <p:ph type="body" idx="1"/>
          </p:nvPr>
        </p:nvSpPr>
        <p:spPr>
          <a:xfrm>
            <a:off x="530305" y="6731215"/>
            <a:ext cx="6703695" cy="2200274"/>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50"/>
              </a:spcBef>
              <a:spcAft>
                <a:spcPts val="0"/>
              </a:spcAft>
              <a:buClr>
                <a:schemeClr val="dk1"/>
              </a:buClr>
              <a:buSzPts val="2040"/>
              <a:buNone/>
              <a:defRPr sz="2040">
                <a:solidFill>
                  <a:schemeClr val="dk1"/>
                </a:solidFill>
              </a:defRPr>
            </a:lvl1pPr>
            <a:lvl2pPr marL="914400" lvl="1" indent="-228600" algn="l">
              <a:lnSpc>
                <a:spcPct val="90000"/>
              </a:lnSpc>
              <a:spcBef>
                <a:spcPts val="425"/>
              </a:spcBef>
              <a:spcAft>
                <a:spcPts val="0"/>
              </a:spcAft>
              <a:buClr>
                <a:srgbClr val="888888"/>
              </a:buClr>
              <a:buSzPts val="1700"/>
              <a:buNone/>
              <a:defRPr sz="1700">
                <a:solidFill>
                  <a:srgbClr val="888888"/>
                </a:solidFill>
              </a:defRPr>
            </a:lvl2pPr>
            <a:lvl3pPr marL="1371600" lvl="2" indent="-228600" algn="l">
              <a:lnSpc>
                <a:spcPct val="90000"/>
              </a:lnSpc>
              <a:spcBef>
                <a:spcPts val="425"/>
              </a:spcBef>
              <a:spcAft>
                <a:spcPts val="0"/>
              </a:spcAft>
              <a:buClr>
                <a:srgbClr val="888888"/>
              </a:buClr>
              <a:buSzPts val="1530"/>
              <a:buNone/>
              <a:defRPr sz="1530">
                <a:solidFill>
                  <a:srgbClr val="888888"/>
                </a:solidFill>
              </a:defRPr>
            </a:lvl3pPr>
            <a:lvl4pPr marL="1828800" lvl="3" indent="-228600" algn="l">
              <a:lnSpc>
                <a:spcPct val="90000"/>
              </a:lnSpc>
              <a:spcBef>
                <a:spcPts val="425"/>
              </a:spcBef>
              <a:spcAft>
                <a:spcPts val="0"/>
              </a:spcAft>
              <a:buClr>
                <a:srgbClr val="888888"/>
              </a:buClr>
              <a:buSzPts val="1360"/>
              <a:buNone/>
              <a:defRPr sz="1360">
                <a:solidFill>
                  <a:srgbClr val="888888"/>
                </a:solidFill>
              </a:defRPr>
            </a:lvl4pPr>
            <a:lvl5pPr marL="2286000" lvl="4" indent="-228600" algn="l">
              <a:lnSpc>
                <a:spcPct val="90000"/>
              </a:lnSpc>
              <a:spcBef>
                <a:spcPts val="425"/>
              </a:spcBef>
              <a:spcAft>
                <a:spcPts val="0"/>
              </a:spcAft>
              <a:buClr>
                <a:srgbClr val="888888"/>
              </a:buClr>
              <a:buSzPts val="1360"/>
              <a:buNone/>
              <a:defRPr sz="1360">
                <a:solidFill>
                  <a:srgbClr val="888888"/>
                </a:solidFill>
              </a:defRPr>
            </a:lvl5pPr>
            <a:lvl6pPr marL="2743200" lvl="5" indent="-228600" algn="l">
              <a:lnSpc>
                <a:spcPct val="90000"/>
              </a:lnSpc>
              <a:spcBef>
                <a:spcPts val="425"/>
              </a:spcBef>
              <a:spcAft>
                <a:spcPts val="0"/>
              </a:spcAft>
              <a:buClr>
                <a:srgbClr val="888888"/>
              </a:buClr>
              <a:buSzPts val="1360"/>
              <a:buNone/>
              <a:defRPr sz="1360">
                <a:solidFill>
                  <a:srgbClr val="888888"/>
                </a:solidFill>
              </a:defRPr>
            </a:lvl6pPr>
            <a:lvl7pPr marL="3200400" lvl="6" indent="-228600" algn="l">
              <a:lnSpc>
                <a:spcPct val="90000"/>
              </a:lnSpc>
              <a:spcBef>
                <a:spcPts val="425"/>
              </a:spcBef>
              <a:spcAft>
                <a:spcPts val="0"/>
              </a:spcAft>
              <a:buClr>
                <a:srgbClr val="888888"/>
              </a:buClr>
              <a:buSzPts val="1360"/>
              <a:buNone/>
              <a:defRPr sz="1360">
                <a:solidFill>
                  <a:srgbClr val="888888"/>
                </a:solidFill>
              </a:defRPr>
            </a:lvl7pPr>
            <a:lvl8pPr marL="3657600" lvl="7" indent="-228600" algn="l">
              <a:lnSpc>
                <a:spcPct val="90000"/>
              </a:lnSpc>
              <a:spcBef>
                <a:spcPts val="425"/>
              </a:spcBef>
              <a:spcAft>
                <a:spcPts val="0"/>
              </a:spcAft>
              <a:buClr>
                <a:srgbClr val="888888"/>
              </a:buClr>
              <a:buSzPts val="1360"/>
              <a:buNone/>
              <a:defRPr sz="1360">
                <a:solidFill>
                  <a:srgbClr val="888888"/>
                </a:solidFill>
              </a:defRPr>
            </a:lvl8pPr>
            <a:lvl9pPr marL="4114800" lvl="8" indent="-228600" algn="l">
              <a:lnSpc>
                <a:spcPct val="90000"/>
              </a:lnSpc>
              <a:spcBef>
                <a:spcPts val="425"/>
              </a:spcBef>
              <a:spcAft>
                <a:spcPts val="0"/>
              </a:spcAft>
              <a:buClr>
                <a:srgbClr val="888888"/>
              </a:buClr>
              <a:buSzPts val="1360"/>
              <a:buNone/>
              <a:defRPr sz="1360">
                <a:solidFill>
                  <a:srgbClr val="888888"/>
                </a:solidFill>
              </a:defRPr>
            </a:lvl9pPr>
          </a:lstStyle>
          <a:p>
            <a:endParaRPr/>
          </a:p>
        </p:txBody>
      </p:sp>
      <p:sp>
        <p:nvSpPr>
          <p:cNvPr id="30" name="Google Shape;30;p18"/>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1" name="Google Shape;31;p18"/>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2" name="Google Shape;32;p18"/>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33"/>
        <p:cNvGrpSpPr/>
        <p:nvPr/>
      </p:nvGrpSpPr>
      <p:grpSpPr>
        <a:xfrm>
          <a:off x="0" y="0"/>
          <a:ext cx="0" cy="0"/>
          <a:chOff x="0" y="0"/>
          <a:chExt cx="0" cy="0"/>
        </a:xfrm>
      </p:grpSpPr>
      <p:sp>
        <p:nvSpPr>
          <p:cNvPr id="34" name="Google Shape;34;p19"/>
          <p:cNvSpPr txBox="1">
            <a:spLocks noGrp="1"/>
          </p:cNvSpPr>
          <p:nvPr>
            <p:ph type="title"/>
          </p:nvPr>
        </p:nvSpPr>
        <p:spPr>
          <a:xfrm>
            <a:off x="534353" y="535519"/>
            <a:ext cx="6703695" cy="194415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5" name="Google Shape;35;p19"/>
          <p:cNvSpPr txBox="1">
            <a:spLocks noGrp="1"/>
          </p:cNvSpPr>
          <p:nvPr>
            <p:ph type="body" idx="1"/>
          </p:nvPr>
        </p:nvSpPr>
        <p:spPr>
          <a:xfrm>
            <a:off x="534353" y="2677584"/>
            <a:ext cx="3303270" cy="638196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50"/>
              </a:spcBef>
              <a:spcAft>
                <a:spcPts val="0"/>
              </a:spcAft>
              <a:buClr>
                <a:schemeClr val="dk1"/>
              </a:buClr>
              <a:buSzPts val="1800"/>
              <a:buChar char="•"/>
              <a:defRPr/>
            </a:lvl1pPr>
            <a:lvl2pPr marL="914400" lvl="1" indent="-342900" algn="l">
              <a:lnSpc>
                <a:spcPct val="90000"/>
              </a:lnSpc>
              <a:spcBef>
                <a:spcPts val="425"/>
              </a:spcBef>
              <a:spcAft>
                <a:spcPts val="0"/>
              </a:spcAft>
              <a:buClr>
                <a:schemeClr val="dk1"/>
              </a:buClr>
              <a:buSzPts val="1800"/>
              <a:buChar char="•"/>
              <a:defRPr/>
            </a:lvl2pPr>
            <a:lvl3pPr marL="1371600" lvl="2" indent="-342900" algn="l">
              <a:lnSpc>
                <a:spcPct val="90000"/>
              </a:lnSpc>
              <a:spcBef>
                <a:spcPts val="425"/>
              </a:spcBef>
              <a:spcAft>
                <a:spcPts val="0"/>
              </a:spcAft>
              <a:buClr>
                <a:schemeClr val="dk1"/>
              </a:buClr>
              <a:buSzPts val="1800"/>
              <a:buChar char="•"/>
              <a:defRPr/>
            </a:lvl3pPr>
            <a:lvl4pPr marL="1828800" lvl="3" indent="-342900" algn="l">
              <a:lnSpc>
                <a:spcPct val="90000"/>
              </a:lnSpc>
              <a:spcBef>
                <a:spcPts val="425"/>
              </a:spcBef>
              <a:spcAft>
                <a:spcPts val="0"/>
              </a:spcAft>
              <a:buClr>
                <a:schemeClr val="dk1"/>
              </a:buClr>
              <a:buSzPts val="1800"/>
              <a:buChar char="•"/>
              <a:defRPr/>
            </a:lvl4pPr>
            <a:lvl5pPr marL="2286000" lvl="4" indent="-342900" algn="l">
              <a:lnSpc>
                <a:spcPct val="90000"/>
              </a:lnSpc>
              <a:spcBef>
                <a:spcPts val="425"/>
              </a:spcBef>
              <a:spcAft>
                <a:spcPts val="0"/>
              </a:spcAft>
              <a:buClr>
                <a:schemeClr val="dk1"/>
              </a:buClr>
              <a:buSzPts val="1800"/>
              <a:buChar char="•"/>
              <a:defRPr/>
            </a:lvl5pPr>
            <a:lvl6pPr marL="2743200" lvl="5" indent="-342900" algn="l">
              <a:lnSpc>
                <a:spcPct val="90000"/>
              </a:lnSpc>
              <a:spcBef>
                <a:spcPts val="425"/>
              </a:spcBef>
              <a:spcAft>
                <a:spcPts val="0"/>
              </a:spcAft>
              <a:buClr>
                <a:schemeClr val="dk1"/>
              </a:buClr>
              <a:buSzPts val="1800"/>
              <a:buChar char="•"/>
              <a:defRPr/>
            </a:lvl6pPr>
            <a:lvl7pPr marL="3200400" lvl="6" indent="-342900" algn="l">
              <a:lnSpc>
                <a:spcPct val="90000"/>
              </a:lnSpc>
              <a:spcBef>
                <a:spcPts val="425"/>
              </a:spcBef>
              <a:spcAft>
                <a:spcPts val="0"/>
              </a:spcAft>
              <a:buClr>
                <a:schemeClr val="dk1"/>
              </a:buClr>
              <a:buSzPts val="1800"/>
              <a:buChar char="•"/>
              <a:defRPr/>
            </a:lvl7pPr>
            <a:lvl8pPr marL="3657600" lvl="7" indent="-342900" algn="l">
              <a:lnSpc>
                <a:spcPct val="90000"/>
              </a:lnSpc>
              <a:spcBef>
                <a:spcPts val="425"/>
              </a:spcBef>
              <a:spcAft>
                <a:spcPts val="0"/>
              </a:spcAft>
              <a:buClr>
                <a:schemeClr val="dk1"/>
              </a:buClr>
              <a:buSzPts val="1800"/>
              <a:buChar char="•"/>
              <a:defRPr/>
            </a:lvl8pPr>
            <a:lvl9pPr marL="4114800" lvl="8" indent="-342900" algn="l">
              <a:lnSpc>
                <a:spcPct val="90000"/>
              </a:lnSpc>
              <a:spcBef>
                <a:spcPts val="425"/>
              </a:spcBef>
              <a:spcAft>
                <a:spcPts val="0"/>
              </a:spcAft>
              <a:buClr>
                <a:schemeClr val="dk1"/>
              </a:buClr>
              <a:buSzPts val="1800"/>
              <a:buChar char="•"/>
              <a:defRPr/>
            </a:lvl9pPr>
          </a:lstStyle>
          <a:p>
            <a:endParaRPr/>
          </a:p>
        </p:txBody>
      </p:sp>
      <p:sp>
        <p:nvSpPr>
          <p:cNvPr id="36" name="Google Shape;36;p19"/>
          <p:cNvSpPr txBox="1">
            <a:spLocks noGrp="1"/>
          </p:cNvSpPr>
          <p:nvPr>
            <p:ph type="body" idx="2"/>
          </p:nvPr>
        </p:nvSpPr>
        <p:spPr>
          <a:xfrm>
            <a:off x="3934778" y="2677584"/>
            <a:ext cx="3303270" cy="638196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50"/>
              </a:spcBef>
              <a:spcAft>
                <a:spcPts val="0"/>
              </a:spcAft>
              <a:buClr>
                <a:schemeClr val="dk1"/>
              </a:buClr>
              <a:buSzPts val="1800"/>
              <a:buChar char="•"/>
              <a:defRPr/>
            </a:lvl1pPr>
            <a:lvl2pPr marL="914400" lvl="1" indent="-342900" algn="l">
              <a:lnSpc>
                <a:spcPct val="90000"/>
              </a:lnSpc>
              <a:spcBef>
                <a:spcPts val="425"/>
              </a:spcBef>
              <a:spcAft>
                <a:spcPts val="0"/>
              </a:spcAft>
              <a:buClr>
                <a:schemeClr val="dk1"/>
              </a:buClr>
              <a:buSzPts val="1800"/>
              <a:buChar char="•"/>
              <a:defRPr/>
            </a:lvl2pPr>
            <a:lvl3pPr marL="1371600" lvl="2" indent="-342900" algn="l">
              <a:lnSpc>
                <a:spcPct val="90000"/>
              </a:lnSpc>
              <a:spcBef>
                <a:spcPts val="425"/>
              </a:spcBef>
              <a:spcAft>
                <a:spcPts val="0"/>
              </a:spcAft>
              <a:buClr>
                <a:schemeClr val="dk1"/>
              </a:buClr>
              <a:buSzPts val="1800"/>
              <a:buChar char="•"/>
              <a:defRPr/>
            </a:lvl3pPr>
            <a:lvl4pPr marL="1828800" lvl="3" indent="-342900" algn="l">
              <a:lnSpc>
                <a:spcPct val="90000"/>
              </a:lnSpc>
              <a:spcBef>
                <a:spcPts val="425"/>
              </a:spcBef>
              <a:spcAft>
                <a:spcPts val="0"/>
              </a:spcAft>
              <a:buClr>
                <a:schemeClr val="dk1"/>
              </a:buClr>
              <a:buSzPts val="1800"/>
              <a:buChar char="•"/>
              <a:defRPr/>
            </a:lvl4pPr>
            <a:lvl5pPr marL="2286000" lvl="4" indent="-342900" algn="l">
              <a:lnSpc>
                <a:spcPct val="90000"/>
              </a:lnSpc>
              <a:spcBef>
                <a:spcPts val="425"/>
              </a:spcBef>
              <a:spcAft>
                <a:spcPts val="0"/>
              </a:spcAft>
              <a:buClr>
                <a:schemeClr val="dk1"/>
              </a:buClr>
              <a:buSzPts val="1800"/>
              <a:buChar char="•"/>
              <a:defRPr/>
            </a:lvl5pPr>
            <a:lvl6pPr marL="2743200" lvl="5" indent="-342900" algn="l">
              <a:lnSpc>
                <a:spcPct val="90000"/>
              </a:lnSpc>
              <a:spcBef>
                <a:spcPts val="425"/>
              </a:spcBef>
              <a:spcAft>
                <a:spcPts val="0"/>
              </a:spcAft>
              <a:buClr>
                <a:schemeClr val="dk1"/>
              </a:buClr>
              <a:buSzPts val="1800"/>
              <a:buChar char="•"/>
              <a:defRPr/>
            </a:lvl6pPr>
            <a:lvl7pPr marL="3200400" lvl="6" indent="-342900" algn="l">
              <a:lnSpc>
                <a:spcPct val="90000"/>
              </a:lnSpc>
              <a:spcBef>
                <a:spcPts val="425"/>
              </a:spcBef>
              <a:spcAft>
                <a:spcPts val="0"/>
              </a:spcAft>
              <a:buClr>
                <a:schemeClr val="dk1"/>
              </a:buClr>
              <a:buSzPts val="1800"/>
              <a:buChar char="•"/>
              <a:defRPr/>
            </a:lvl7pPr>
            <a:lvl8pPr marL="3657600" lvl="7" indent="-342900" algn="l">
              <a:lnSpc>
                <a:spcPct val="90000"/>
              </a:lnSpc>
              <a:spcBef>
                <a:spcPts val="425"/>
              </a:spcBef>
              <a:spcAft>
                <a:spcPts val="0"/>
              </a:spcAft>
              <a:buClr>
                <a:schemeClr val="dk1"/>
              </a:buClr>
              <a:buSzPts val="1800"/>
              <a:buChar char="•"/>
              <a:defRPr/>
            </a:lvl8pPr>
            <a:lvl9pPr marL="4114800" lvl="8" indent="-342900" algn="l">
              <a:lnSpc>
                <a:spcPct val="90000"/>
              </a:lnSpc>
              <a:spcBef>
                <a:spcPts val="425"/>
              </a:spcBef>
              <a:spcAft>
                <a:spcPts val="0"/>
              </a:spcAft>
              <a:buClr>
                <a:schemeClr val="dk1"/>
              </a:buClr>
              <a:buSzPts val="1800"/>
              <a:buChar char="•"/>
              <a:defRPr/>
            </a:lvl9pPr>
          </a:lstStyle>
          <a:p>
            <a:endParaRPr/>
          </a:p>
        </p:txBody>
      </p:sp>
      <p:sp>
        <p:nvSpPr>
          <p:cNvPr id="37" name="Google Shape;37;p19"/>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8" name="Google Shape;38;p19"/>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39" name="Google Shape;39;p19"/>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20"/>
          <p:cNvSpPr txBox="1">
            <a:spLocks noGrp="1"/>
          </p:cNvSpPr>
          <p:nvPr>
            <p:ph type="title"/>
          </p:nvPr>
        </p:nvSpPr>
        <p:spPr>
          <a:xfrm>
            <a:off x="535365" y="535519"/>
            <a:ext cx="6703695" cy="194415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2" name="Google Shape;42;p20"/>
          <p:cNvSpPr txBox="1">
            <a:spLocks noGrp="1"/>
          </p:cNvSpPr>
          <p:nvPr>
            <p:ph type="body" idx="1"/>
          </p:nvPr>
        </p:nvSpPr>
        <p:spPr>
          <a:xfrm>
            <a:off x="535366" y="2465706"/>
            <a:ext cx="3288089" cy="1208404"/>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50"/>
              </a:spcBef>
              <a:spcAft>
                <a:spcPts val="0"/>
              </a:spcAft>
              <a:buClr>
                <a:schemeClr val="dk1"/>
              </a:buClr>
              <a:buSzPts val="2040"/>
              <a:buNone/>
              <a:defRPr sz="2040" b="1"/>
            </a:lvl1pPr>
            <a:lvl2pPr marL="914400" lvl="1" indent="-228600" algn="l">
              <a:lnSpc>
                <a:spcPct val="90000"/>
              </a:lnSpc>
              <a:spcBef>
                <a:spcPts val="425"/>
              </a:spcBef>
              <a:spcAft>
                <a:spcPts val="0"/>
              </a:spcAft>
              <a:buClr>
                <a:schemeClr val="dk1"/>
              </a:buClr>
              <a:buSzPts val="1700"/>
              <a:buNone/>
              <a:defRPr sz="1700" b="1"/>
            </a:lvl2pPr>
            <a:lvl3pPr marL="1371600" lvl="2" indent="-228600" algn="l">
              <a:lnSpc>
                <a:spcPct val="90000"/>
              </a:lnSpc>
              <a:spcBef>
                <a:spcPts val="425"/>
              </a:spcBef>
              <a:spcAft>
                <a:spcPts val="0"/>
              </a:spcAft>
              <a:buClr>
                <a:schemeClr val="dk1"/>
              </a:buClr>
              <a:buSzPts val="1530"/>
              <a:buNone/>
              <a:defRPr sz="1530" b="1"/>
            </a:lvl3pPr>
            <a:lvl4pPr marL="1828800" lvl="3" indent="-228600" algn="l">
              <a:lnSpc>
                <a:spcPct val="90000"/>
              </a:lnSpc>
              <a:spcBef>
                <a:spcPts val="425"/>
              </a:spcBef>
              <a:spcAft>
                <a:spcPts val="0"/>
              </a:spcAft>
              <a:buClr>
                <a:schemeClr val="dk1"/>
              </a:buClr>
              <a:buSzPts val="1360"/>
              <a:buNone/>
              <a:defRPr sz="1360" b="1"/>
            </a:lvl4pPr>
            <a:lvl5pPr marL="2286000" lvl="4" indent="-228600" algn="l">
              <a:lnSpc>
                <a:spcPct val="90000"/>
              </a:lnSpc>
              <a:spcBef>
                <a:spcPts val="425"/>
              </a:spcBef>
              <a:spcAft>
                <a:spcPts val="0"/>
              </a:spcAft>
              <a:buClr>
                <a:schemeClr val="dk1"/>
              </a:buClr>
              <a:buSzPts val="1360"/>
              <a:buNone/>
              <a:defRPr sz="1360" b="1"/>
            </a:lvl5pPr>
            <a:lvl6pPr marL="2743200" lvl="5" indent="-228600" algn="l">
              <a:lnSpc>
                <a:spcPct val="90000"/>
              </a:lnSpc>
              <a:spcBef>
                <a:spcPts val="425"/>
              </a:spcBef>
              <a:spcAft>
                <a:spcPts val="0"/>
              </a:spcAft>
              <a:buClr>
                <a:schemeClr val="dk1"/>
              </a:buClr>
              <a:buSzPts val="1360"/>
              <a:buNone/>
              <a:defRPr sz="1360" b="1"/>
            </a:lvl6pPr>
            <a:lvl7pPr marL="3200400" lvl="6" indent="-228600" algn="l">
              <a:lnSpc>
                <a:spcPct val="90000"/>
              </a:lnSpc>
              <a:spcBef>
                <a:spcPts val="425"/>
              </a:spcBef>
              <a:spcAft>
                <a:spcPts val="0"/>
              </a:spcAft>
              <a:buClr>
                <a:schemeClr val="dk1"/>
              </a:buClr>
              <a:buSzPts val="1360"/>
              <a:buNone/>
              <a:defRPr sz="1360" b="1"/>
            </a:lvl7pPr>
            <a:lvl8pPr marL="3657600" lvl="7" indent="-228600" algn="l">
              <a:lnSpc>
                <a:spcPct val="90000"/>
              </a:lnSpc>
              <a:spcBef>
                <a:spcPts val="425"/>
              </a:spcBef>
              <a:spcAft>
                <a:spcPts val="0"/>
              </a:spcAft>
              <a:buClr>
                <a:schemeClr val="dk1"/>
              </a:buClr>
              <a:buSzPts val="1360"/>
              <a:buNone/>
              <a:defRPr sz="1360" b="1"/>
            </a:lvl8pPr>
            <a:lvl9pPr marL="4114800" lvl="8" indent="-228600" algn="l">
              <a:lnSpc>
                <a:spcPct val="90000"/>
              </a:lnSpc>
              <a:spcBef>
                <a:spcPts val="425"/>
              </a:spcBef>
              <a:spcAft>
                <a:spcPts val="0"/>
              </a:spcAft>
              <a:buClr>
                <a:schemeClr val="dk1"/>
              </a:buClr>
              <a:buSzPts val="1360"/>
              <a:buNone/>
              <a:defRPr sz="1360" b="1"/>
            </a:lvl9pPr>
          </a:lstStyle>
          <a:p>
            <a:endParaRPr/>
          </a:p>
        </p:txBody>
      </p:sp>
      <p:sp>
        <p:nvSpPr>
          <p:cNvPr id="43" name="Google Shape;43;p20"/>
          <p:cNvSpPr txBox="1">
            <a:spLocks noGrp="1"/>
          </p:cNvSpPr>
          <p:nvPr>
            <p:ph type="body" idx="2"/>
          </p:nvPr>
        </p:nvSpPr>
        <p:spPr>
          <a:xfrm>
            <a:off x="535366" y="3674110"/>
            <a:ext cx="3288089" cy="540406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50"/>
              </a:spcBef>
              <a:spcAft>
                <a:spcPts val="0"/>
              </a:spcAft>
              <a:buClr>
                <a:schemeClr val="dk1"/>
              </a:buClr>
              <a:buSzPts val="1800"/>
              <a:buChar char="•"/>
              <a:defRPr/>
            </a:lvl1pPr>
            <a:lvl2pPr marL="914400" lvl="1" indent="-342900" algn="l">
              <a:lnSpc>
                <a:spcPct val="90000"/>
              </a:lnSpc>
              <a:spcBef>
                <a:spcPts val="425"/>
              </a:spcBef>
              <a:spcAft>
                <a:spcPts val="0"/>
              </a:spcAft>
              <a:buClr>
                <a:schemeClr val="dk1"/>
              </a:buClr>
              <a:buSzPts val="1800"/>
              <a:buChar char="•"/>
              <a:defRPr/>
            </a:lvl2pPr>
            <a:lvl3pPr marL="1371600" lvl="2" indent="-342900" algn="l">
              <a:lnSpc>
                <a:spcPct val="90000"/>
              </a:lnSpc>
              <a:spcBef>
                <a:spcPts val="425"/>
              </a:spcBef>
              <a:spcAft>
                <a:spcPts val="0"/>
              </a:spcAft>
              <a:buClr>
                <a:schemeClr val="dk1"/>
              </a:buClr>
              <a:buSzPts val="1800"/>
              <a:buChar char="•"/>
              <a:defRPr/>
            </a:lvl3pPr>
            <a:lvl4pPr marL="1828800" lvl="3" indent="-342900" algn="l">
              <a:lnSpc>
                <a:spcPct val="90000"/>
              </a:lnSpc>
              <a:spcBef>
                <a:spcPts val="425"/>
              </a:spcBef>
              <a:spcAft>
                <a:spcPts val="0"/>
              </a:spcAft>
              <a:buClr>
                <a:schemeClr val="dk1"/>
              </a:buClr>
              <a:buSzPts val="1800"/>
              <a:buChar char="•"/>
              <a:defRPr/>
            </a:lvl4pPr>
            <a:lvl5pPr marL="2286000" lvl="4" indent="-342900" algn="l">
              <a:lnSpc>
                <a:spcPct val="90000"/>
              </a:lnSpc>
              <a:spcBef>
                <a:spcPts val="425"/>
              </a:spcBef>
              <a:spcAft>
                <a:spcPts val="0"/>
              </a:spcAft>
              <a:buClr>
                <a:schemeClr val="dk1"/>
              </a:buClr>
              <a:buSzPts val="1800"/>
              <a:buChar char="•"/>
              <a:defRPr/>
            </a:lvl5pPr>
            <a:lvl6pPr marL="2743200" lvl="5" indent="-342900" algn="l">
              <a:lnSpc>
                <a:spcPct val="90000"/>
              </a:lnSpc>
              <a:spcBef>
                <a:spcPts val="425"/>
              </a:spcBef>
              <a:spcAft>
                <a:spcPts val="0"/>
              </a:spcAft>
              <a:buClr>
                <a:schemeClr val="dk1"/>
              </a:buClr>
              <a:buSzPts val="1800"/>
              <a:buChar char="•"/>
              <a:defRPr/>
            </a:lvl6pPr>
            <a:lvl7pPr marL="3200400" lvl="6" indent="-342900" algn="l">
              <a:lnSpc>
                <a:spcPct val="90000"/>
              </a:lnSpc>
              <a:spcBef>
                <a:spcPts val="425"/>
              </a:spcBef>
              <a:spcAft>
                <a:spcPts val="0"/>
              </a:spcAft>
              <a:buClr>
                <a:schemeClr val="dk1"/>
              </a:buClr>
              <a:buSzPts val="1800"/>
              <a:buChar char="•"/>
              <a:defRPr/>
            </a:lvl7pPr>
            <a:lvl8pPr marL="3657600" lvl="7" indent="-342900" algn="l">
              <a:lnSpc>
                <a:spcPct val="90000"/>
              </a:lnSpc>
              <a:spcBef>
                <a:spcPts val="425"/>
              </a:spcBef>
              <a:spcAft>
                <a:spcPts val="0"/>
              </a:spcAft>
              <a:buClr>
                <a:schemeClr val="dk1"/>
              </a:buClr>
              <a:buSzPts val="1800"/>
              <a:buChar char="•"/>
              <a:defRPr/>
            </a:lvl8pPr>
            <a:lvl9pPr marL="4114800" lvl="8" indent="-342900" algn="l">
              <a:lnSpc>
                <a:spcPct val="90000"/>
              </a:lnSpc>
              <a:spcBef>
                <a:spcPts val="425"/>
              </a:spcBef>
              <a:spcAft>
                <a:spcPts val="0"/>
              </a:spcAft>
              <a:buClr>
                <a:schemeClr val="dk1"/>
              </a:buClr>
              <a:buSzPts val="1800"/>
              <a:buChar char="•"/>
              <a:defRPr/>
            </a:lvl9pPr>
          </a:lstStyle>
          <a:p>
            <a:endParaRPr/>
          </a:p>
        </p:txBody>
      </p:sp>
      <p:sp>
        <p:nvSpPr>
          <p:cNvPr id="44" name="Google Shape;44;p20"/>
          <p:cNvSpPr txBox="1">
            <a:spLocks noGrp="1"/>
          </p:cNvSpPr>
          <p:nvPr>
            <p:ph type="body" idx="3"/>
          </p:nvPr>
        </p:nvSpPr>
        <p:spPr>
          <a:xfrm>
            <a:off x="3934778" y="2465706"/>
            <a:ext cx="3304282" cy="1208404"/>
          </a:xfrm>
          <a:prstGeom prst="rect">
            <a:avLst/>
          </a:prstGeom>
          <a:noFill/>
          <a:ln>
            <a:noFill/>
          </a:ln>
        </p:spPr>
        <p:txBody>
          <a:bodyPr spcFirstLastPara="1" wrap="square" lIns="91425" tIns="45700" rIns="91425" bIns="45700" anchor="b" anchorCtr="0">
            <a:normAutofit/>
          </a:bodyPr>
          <a:lstStyle>
            <a:lvl1pPr marL="457200" lvl="0" indent="-228600" algn="l">
              <a:lnSpc>
                <a:spcPct val="90000"/>
              </a:lnSpc>
              <a:spcBef>
                <a:spcPts val="850"/>
              </a:spcBef>
              <a:spcAft>
                <a:spcPts val="0"/>
              </a:spcAft>
              <a:buClr>
                <a:schemeClr val="dk1"/>
              </a:buClr>
              <a:buSzPts val="2040"/>
              <a:buNone/>
              <a:defRPr sz="2040" b="1"/>
            </a:lvl1pPr>
            <a:lvl2pPr marL="914400" lvl="1" indent="-228600" algn="l">
              <a:lnSpc>
                <a:spcPct val="90000"/>
              </a:lnSpc>
              <a:spcBef>
                <a:spcPts val="425"/>
              </a:spcBef>
              <a:spcAft>
                <a:spcPts val="0"/>
              </a:spcAft>
              <a:buClr>
                <a:schemeClr val="dk1"/>
              </a:buClr>
              <a:buSzPts val="1700"/>
              <a:buNone/>
              <a:defRPr sz="1700" b="1"/>
            </a:lvl2pPr>
            <a:lvl3pPr marL="1371600" lvl="2" indent="-228600" algn="l">
              <a:lnSpc>
                <a:spcPct val="90000"/>
              </a:lnSpc>
              <a:spcBef>
                <a:spcPts val="425"/>
              </a:spcBef>
              <a:spcAft>
                <a:spcPts val="0"/>
              </a:spcAft>
              <a:buClr>
                <a:schemeClr val="dk1"/>
              </a:buClr>
              <a:buSzPts val="1530"/>
              <a:buNone/>
              <a:defRPr sz="1530" b="1"/>
            </a:lvl3pPr>
            <a:lvl4pPr marL="1828800" lvl="3" indent="-228600" algn="l">
              <a:lnSpc>
                <a:spcPct val="90000"/>
              </a:lnSpc>
              <a:spcBef>
                <a:spcPts val="425"/>
              </a:spcBef>
              <a:spcAft>
                <a:spcPts val="0"/>
              </a:spcAft>
              <a:buClr>
                <a:schemeClr val="dk1"/>
              </a:buClr>
              <a:buSzPts val="1360"/>
              <a:buNone/>
              <a:defRPr sz="1360" b="1"/>
            </a:lvl4pPr>
            <a:lvl5pPr marL="2286000" lvl="4" indent="-228600" algn="l">
              <a:lnSpc>
                <a:spcPct val="90000"/>
              </a:lnSpc>
              <a:spcBef>
                <a:spcPts val="425"/>
              </a:spcBef>
              <a:spcAft>
                <a:spcPts val="0"/>
              </a:spcAft>
              <a:buClr>
                <a:schemeClr val="dk1"/>
              </a:buClr>
              <a:buSzPts val="1360"/>
              <a:buNone/>
              <a:defRPr sz="1360" b="1"/>
            </a:lvl5pPr>
            <a:lvl6pPr marL="2743200" lvl="5" indent="-228600" algn="l">
              <a:lnSpc>
                <a:spcPct val="90000"/>
              </a:lnSpc>
              <a:spcBef>
                <a:spcPts val="425"/>
              </a:spcBef>
              <a:spcAft>
                <a:spcPts val="0"/>
              </a:spcAft>
              <a:buClr>
                <a:schemeClr val="dk1"/>
              </a:buClr>
              <a:buSzPts val="1360"/>
              <a:buNone/>
              <a:defRPr sz="1360" b="1"/>
            </a:lvl6pPr>
            <a:lvl7pPr marL="3200400" lvl="6" indent="-228600" algn="l">
              <a:lnSpc>
                <a:spcPct val="90000"/>
              </a:lnSpc>
              <a:spcBef>
                <a:spcPts val="425"/>
              </a:spcBef>
              <a:spcAft>
                <a:spcPts val="0"/>
              </a:spcAft>
              <a:buClr>
                <a:schemeClr val="dk1"/>
              </a:buClr>
              <a:buSzPts val="1360"/>
              <a:buNone/>
              <a:defRPr sz="1360" b="1"/>
            </a:lvl7pPr>
            <a:lvl8pPr marL="3657600" lvl="7" indent="-228600" algn="l">
              <a:lnSpc>
                <a:spcPct val="90000"/>
              </a:lnSpc>
              <a:spcBef>
                <a:spcPts val="425"/>
              </a:spcBef>
              <a:spcAft>
                <a:spcPts val="0"/>
              </a:spcAft>
              <a:buClr>
                <a:schemeClr val="dk1"/>
              </a:buClr>
              <a:buSzPts val="1360"/>
              <a:buNone/>
              <a:defRPr sz="1360" b="1"/>
            </a:lvl8pPr>
            <a:lvl9pPr marL="4114800" lvl="8" indent="-228600" algn="l">
              <a:lnSpc>
                <a:spcPct val="90000"/>
              </a:lnSpc>
              <a:spcBef>
                <a:spcPts val="425"/>
              </a:spcBef>
              <a:spcAft>
                <a:spcPts val="0"/>
              </a:spcAft>
              <a:buClr>
                <a:schemeClr val="dk1"/>
              </a:buClr>
              <a:buSzPts val="1360"/>
              <a:buNone/>
              <a:defRPr sz="1360" b="1"/>
            </a:lvl9pPr>
          </a:lstStyle>
          <a:p>
            <a:endParaRPr/>
          </a:p>
        </p:txBody>
      </p:sp>
      <p:sp>
        <p:nvSpPr>
          <p:cNvPr id="45" name="Google Shape;45;p20"/>
          <p:cNvSpPr txBox="1">
            <a:spLocks noGrp="1"/>
          </p:cNvSpPr>
          <p:nvPr>
            <p:ph type="body" idx="4"/>
          </p:nvPr>
        </p:nvSpPr>
        <p:spPr>
          <a:xfrm>
            <a:off x="3934778" y="3674110"/>
            <a:ext cx="3304282" cy="5404062"/>
          </a:xfrm>
          <a:prstGeom prst="rect">
            <a:avLst/>
          </a:prstGeom>
          <a:noFill/>
          <a:ln>
            <a:noFill/>
          </a:ln>
        </p:spPr>
        <p:txBody>
          <a:bodyPr spcFirstLastPara="1" wrap="square" lIns="91425" tIns="45700" rIns="91425" bIns="45700" anchor="t" anchorCtr="0">
            <a:normAutofit/>
          </a:bodyPr>
          <a:lstStyle>
            <a:lvl1pPr marL="457200" lvl="0" indent="-342900" algn="l">
              <a:lnSpc>
                <a:spcPct val="90000"/>
              </a:lnSpc>
              <a:spcBef>
                <a:spcPts val="850"/>
              </a:spcBef>
              <a:spcAft>
                <a:spcPts val="0"/>
              </a:spcAft>
              <a:buClr>
                <a:schemeClr val="dk1"/>
              </a:buClr>
              <a:buSzPts val="1800"/>
              <a:buChar char="•"/>
              <a:defRPr/>
            </a:lvl1pPr>
            <a:lvl2pPr marL="914400" lvl="1" indent="-342900" algn="l">
              <a:lnSpc>
                <a:spcPct val="90000"/>
              </a:lnSpc>
              <a:spcBef>
                <a:spcPts val="425"/>
              </a:spcBef>
              <a:spcAft>
                <a:spcPts val="0"/>
              </a:spcAft>
              <a:buClr>
                <a:schemeClr val="dk1"/>
              </a:buClr>
              <a:buSzPts val="1800"/>
              <a:buChar char="•"/>
              <a:defRPr/>
            </a:lvl2pPr>
            <a:lvl3pPr marL="1371600" lvl="2" indent="-342900" algn="l">
              <a:lnSpc>
                <a:spcPct val="90000"/>
              </a:lnSpc>
              <a:spcBef>
                <a:spcPts val="425"/>
              </a:spcBef>
              <a:spcAft>
                <a:spcPts val="0"/>
              </a:spcAft>
              <a:buClr>
                <a:schemeClr val="dk1"/>
              </a:buClr>
              <a:buSzPts val="1800"/>
              <a:buChar char="•"/>
              <a:defRPr/>
            </a:lvl3pPr>
            <a:lvl4pPr marL="1828800" lvl="3" indent="-342900" algn="l">
              <a:lnSpc>
                <a:spcPct val="90000"/>
              </a:lnSpc>
              <a:spcBef>
                <a:spcPts val="425"/>
              </a:spcBef>
              <a:spcAft>
                <a:spcPts val="0"/>
              </a:spcAft>
              <a:buClr>
                <a:schemeClr val="dk1"/>
              </a:buClr>
              <a:buSzPts val="1800"/>
              <a:buChar char="•"/>
              <a:defRPr/>
            </a:lvl4pPr>
            <a:lvl5pPr marL="2286000" lvl="4" indent="-342900" algn="l">
              <a:lnSpc>
                <a:spcPct val="90000"/>
              </a:lnSpc>
              <a:spcBef>
                <a:spcPts val="425"/>
              </a:spcBef>
              <a:spcAft>
                <a:spcPts val="0"/>
              </a:spcAft>
              <a:buClr>
                <a:schemeClr val="dk1"/>
              </a:buClr>
              <a:buSzPts val="1800"/>
              <a:buChar char="•"/>
              <a:defRPr/>
            </a:lvl5pPr>
            <a:lvl6pPr marL="2743200" lvl="5" indent="-342900" algn="l">
              <a:lnSpc>
                <a:spcPct val="90000"/>
              </a:lnSpc>
              <a:spcBef>
                <a:spcPts val="425"/>
              </a:spcBef>
              <a:spcAft>
                <a:spcPts val="0"/>
              </a:spcAft>
              <a:buClr>
                <a:schemeClr val="dk1"/>
              </a:buClr>
              <a:buSzPts val="1800"/>
              <a:buChar char="•"/>
              <a:defRPr/>
            </a:lvl6pPr>
            <a:lvl7pPr marL="3200400" lvl="6" indent="-342900" algn="l">
              <a:lnSpc>
                <a:spcPct val="90000"/>
              </a:lnSpc>
              <a:spcBef>
                <a:spcPts val="425"/>
              </a:spcBef>
              <a:spcAft>
                <a:spcPts val="0"/>
              </a:spcAft>
              <a:buClr>
                <a:schemeClr val="dk1"/>
              </a:buClr>
              <a:buSzPts val="1800"/>
              <a:buChar char="•"/>
              <a:defRPr/>
            </a:lvl7pPr>
            <a:lvl8pPr marL="3657600" lvl="7" indent="-342900" algn="l">
              <a:lnSpc>
                <a:spcPct val="90000"/>
              </a:lnSpc>
              <a:spcBef>
                <a:spcPts val="425"/>
              </a:spcBef>
              <a:spcAft>
                <a:spcPts val="0"/>
              </a:spcAft>
              <a:buClr>
                <a:schemeClr val="dk1"/>
              </a:buClr>
              <a:buSzPts val="1800"/>
              <a:buChar char="•"/>
              <a:defRPr/>
            </a:lvl8pPr>
            <a:lvl9pPr marL="4114800" lvl="8" indent="-342900" algn="l">
              <a:lnSpc>
                <a:spcPct val="90000"/>
              </a:lnSpc>
              <a:spcBef>
                <a:spcPts val="425"/>
              </a:spcBef>
              <a:spcAft>
                <a:spcPts val="0"/>
              </a:spcAft>
              <a:buClr>
                <a:schemeClr val="dk1"/>
              </a:buClr>
              <a:buSzPts val="1800"/>
              <a:buChar char="•"/>
              <a:defRPr/>
            </a:lvl9pPr>
          </a:lstStyle>
          <a:p>
            <a:endParaRPr/>
          </a:p>
        </p:txBody>
      </p:sp>
      <p:sp>
        <p:nvSpPr>
          <p:cNvPr id="46" name="Google Shape;46;p20"/>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7" name="Google Shape;47;p20"/>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48" name="Google Shape;48;p20"/>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21"/>
          <p:cNvSpPr txBox="1">
            <a:spLocks noGrp="1"/>
          </p:cNvSpPr>
          <p:nvPr>
            <p:ph type="title"/>
          </p:nvPr>
        </p:nvSpPr>
        <p:spPr>
          <a:xfrm>
            <a:off x="534353" y="535519"/>
            <a:ext cx="6703695" cy="1944159"/>
          </a:xfrm>
          <a:prstGeom prst="rect">
            <a:avLst/>
          </a:prstGeom>
          <a:noFill/>
          <a:ln>
            <a:noFill/>
          </a:ln>
        </p:spPr>
        <p:txBody>
          <a:bodyPr spcFirstLastPara="1" wrap="square" lIns="91425" tIns="45700" rIns="91425" bIns="45700" anchor="ctr" anchorCtr="0">
            <a:normAutofit/>
          </a:bodyPr>
          <a:lstStyle>
            <a:lvl1pPr lvl="0" algn="l">
              <a:lnSpc>
                <a:spcPct val="90000"/>
              </a:lnSpc>
              <a:spcBef>
                <a:spcPts val="0"/>
              </a:spcBef>
              <a:spcAft>
                <a:spcPts val="0"/>
              </a:spcAft>
              <a:buClr>
                <a:schemeClr val="dk1"/>
              </a:buClr>
              <a:buSzPts val="18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1" name="Google Shape;51;p21"/>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2" name="Google Shape;52;p21"/>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3" name="Google Shape;53;p21"/>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22"/>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6" name="Google Shape;56;p22"/>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57" name="Google Shape;57;p22"/>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23"/>
          <p:cNvSpPr txBox="1">
            <a:spLocks noGrp="1"/>
          </p:cNvSpPr>
          <p:nvPr>
            <p:ph type="title"/>
          </p:nvPr>
        </p:nvSpPr>
        <p:spPr>
          <a:xfrm>
            <a:off x="535365" y="670560"/>
            <a:ext cx="2506801" cy="234696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720"/>
              <a:buFont typeface="Arial"/>
              <a:buNone/>
              <a:defRPr sz="272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0" name="Google Shape;60;p23"/>
          <p:cNvSpPr txBox="1">
            <a:spLocks noGrp="1"/>
          </p:cNvSpPr>
          <p:nvPr>
            <p:ph type="body" idx="1"/>
          </p:nvPr>
        </p:nvSpPr>
        <p:spPr>
          <a:xfrm>
            <a:off x="3304282" y="1448226"/>
            <a:ext cx="3934778" cy="7147983"/>
          </a:xfrm>
          <a:prstGeom prst="rect">
            <a:avLst/>
          </a:prstGeom>
          <a:noFill/>
          <a:ln>
            <a:noFill/>
          </a:ln>
        </p:spPr>
        <p:txBody>
          <a:bodyPr spcFirstLastPara="1" wrap="square" lIns="91425" tIns="45700" rIns="91425" bIns="45700" anchor="t" anchorCtr="0">
            <a:normAutofit/>
          </a:bodyPr>
          <a:lstStyle>
            <a:lvl1pPr marL="457200" lvl="0" indent="-401320" algn="l">
              <a:lnSpc>
                <a:spcPct val="90000"/>
              </a:lnSpc>
              <a:spcBef>
                <a:spcPts val="850"/>
              </a:spcBef>
              <a:spcAft>
                <a:spcPts val="0"/>
              </a:spcAft>
              <a:buClr>
                <a:schemeClr val="dk1"/>
              </a:buClr>
              <a:buSzPts val="2720"/>
              <a:buChar char="•"/>
              <a:defRPr sz="2720"/>
            </a:lvl1pPr>
            <a:lvl2pPr marL="914400" lvl="1" indent="-379730" algn="l">
              <a:lnSpc>
                <a:spcPct val="90000"/>
              </a:lnSpc>
              <a:spcBef>
                <a:spcPts val="425"/>
              </a:spcBef>
              <a:spcAft>
                <a:spcPts val="0"/>
              </a:spcAft>
              <a:buClr>
                <a:schemeClr val="dk1"/>
              </a:buClr>
              <a:buSzPts val="2380"/>
              <a:buChar char="•"/>
              <a:defRPr sz="2380"/>
            </a:lvl2pPr>
            <a:lvl3pPr marL="1371600" lvl="2" indent="-358139" algn="l">
              <a:lnSpc>
                <a:spcPct val="90000"/>
              </a:lnSpc>
              <a:spcBef>
                <a:spcPts val="425"/>
              </a:spcBef>
              <a:spcAft>
                <a:spcPts val="0"/>
              </a:spcAft>
              <a:buClr>
                <a:schemeClr val="dk1"/>
              </a:buClr>
              <a:buSzPts val="2040"/>
              <a:buChar char="•"/>
              <a:defRPr sz="2040"/>
            </a:lvl3pPr>
            <a:lvl4pPr marL="1828800" lvl="3" indent="-336550" algn="l">
              <a:lnSpc>
                <a:spcPct val="90000"/>
              </a:lnSpc>
              <a:spcBef>
                <a:spcPts val="425"/>
              </a:spcBef>
              <a:spcAft>
                <a:spcPts val="0"/>
              </a:spcAft>
              <a:buClr>
                <a:schemeClr val="dk1"/>
              </a:buClr>
              <a:buSzPts val="1700"/>
              <a:buChar char="•"/>
              <a:defRPr sz="1700"/>
            </a:lvl4pPr>
            <a:lvl5pPr marL="2286000" lvl="4" indent="-336550" algn="l">
              <a:lnSpc>
                <a:spcPct val="90000"/>
              </a:lnSpc>
              <a:spcBef>
                <a:spcPts val="425"/>
              </a:spcBef>
              <a:spcAft>
                <a:spcPts val="0"/>
              </a:spcAft>
              <a:buClr>
                <a:schemeClr val="dk1"/>
              </a:buClr>
              <a:buSzPts val="1700"/>
              <a:buChar char="•"/>
              <a:defRPr sz="1700"/>
            </a:lvl5pPr>
            <a:lvl6pPr marL="2743200" lvl="5" indent="-336550" algn="l">
              <a:lnSpc>
                <a:spcPct val="90000"/>
              </a:lnSpc>
              <a:spcBef>
                <a:spcPts val="425"/>
              </a:spcBef>
              <a:spcAft>
                <a:spcPts val="0"/>
              </a:spcAft>
              <a:buClr>
                <a:schemeClr val="dk1"/>
              </a:buClr>
              <a:buSzPts val="1700"/>
              <a:buChar char="•"/>
              <a:defRPr sz="1700"/>
            </a:lvl6pPr>
            <a:lvl7pPr marL="3200400" lvl="6" indent="-336550" algn="l">
              <a:lnSpc>
                <a:spcPct val="90000"/>
              </a:lnSpc>
              <a:spcBef>
                <a:spcPts val="425"/>
              </a:spcBef>
              <a:spcAft>
                <a:spcPts val="0"/>
              </a:spcAft>
              <a:buClr>
                <a:schemeClr val="dk1"/>
              </a:buClr>
              <a:buSzPts val="1700"/>
              <a:buChar char="•"/>
              <a:defRPr sz="1700"/>
            </a:lvl7pPr>
            <a:lvl8pPr marL="3657600" lvl="7" indent="-336550" algn="l">
              <a:lnSpc>
                <a:spcPct val="90000"/>
              </a:lnSpc>
              <a:spcBef>
                <a:spcPts val="425"/>
              </a:spcBef>
              <a:spcAft>
                <a:spcPts val="0"/>
              </a:spcAft>
              <a:buClr>
                <a:schemeClr val="dk1"/>
              </a:buClr>
              <a:buSzPts val="1700"/>
              <a:buChar char="•"/>
              <a:defRPr sz="1700"/>
            </a:lvl8pPr>
            <a:lvl9pPr marL="4114800" lvl="8" indent="-336550" algn="l">
              <a:lnSpc>
                <a:spcPct val="90000"/>
              </a:lnSpc>
              <a:spcBef>
                <a:spcPts val="425"/>
              </a:spcBef>
              <a:spcAft>
                <a:spcPts val="0"/>
              </a:spcAft>
              <a:buClr>
                <a:schemeClr val="dk1"/>
              </a:buClr>
              <a:buSzPts val="1700"/>
              <a:buChar char="•"/>
              <a:defRPr sz="1700"/>
            </a:lvl9pPr>
          </a:lstStyle>
          <a:p>
            <a:endParaRPr/>
          </a:p>
        </p:txBody>
      </p:sp>
      <p:sp>
        <p:nvSpPr>
          <p:cNvPr id="61" name="Google Shape;61;p23"/>
          <p:cNvSpPr txBox="1">
            <a:spLocks noGrp="1"/>
          </p:cNvSpPr>
          <p:nvPr>
            <p:ph type="body" idx="2"/>
          </p:nvPr>
        </p:nvSpPr>
        <p:spPr>
          <a:xfrm>
            <a:off x="535365" y="3017520"/>
            <a:ext cx="2506801" cy="5590329"/>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50"/>
              </a:spcBef>
              <a:spcAft>
                <a:spcPts val="0"/>
              </a:spcAft>
              <a:buClr>
                <a:schemeClr val="dk1"/>
              </a:buClr>
              <a:buSzPts val="1360"/>
              <a:buNone/>
              <a:defRPr sz="1360"/>
            </a:lvl1pPr>
            <a:lvl2pPr marL="914400" lvl="1" indent="-228600" algn="l">
              <a:lnSpc>
                <a:spcPct val="90000"/>
              </a:lnSpc>
              <a:spcBef>
                <a:spcPts val="425"/>
              </a:spcBef>
              <a:spcAft>
                <a:spcPts val="0"/>
              </a:spcAft>
              <a:buClr>
                <a:schemeClr val="dk1"/>
              </a:buClr>
              <a:buSzPts val="1190"/>
              <a:buNone/>
              <a:defRPr sz="1190"/>
            </a:lvl2pPr>
            <a:lvl3pPr marL="1371600" lvl="2" indent="-228600" algn="l">
              <a:lnSpc>
                <a:spcPct val="90000"/>
              </a:lnSpc>
              <a:spcBef>
                <a:spcPts val="425"/>
              </a:spcBef>
              <a:spcAft>
                <a:spcPts val="0"/>
              </a:spcAft>
              <a:buClr>
                <a:schemeClr val="dk1"/>
              </a:buClr>
              <a:buSzPts val="1020"/>
              <a:buNone/>
              <a:defRPr sz="1020"/>
            </a:lvl3pPr>
            <a:lvl4pPr marL="1828800" lvl="3" indent="-228600" algn="l">
              <a:lnSpc>
                <a:spcPct val="90000"/>
              </a:lnSpc>
              <a:spcBef>
                <a:spcPts val="425"/>
              </a:spcBef>
              <a:spcAft>
                <a:spcPts val="0"/>
              </a:spcAft>
              <a:buClr>
                <a:schemeClr val="dk1"/>
              </a:buClr>
              <a:buSzPts val="850"/>
              <a:buNone/>
              <a:defRPr sz="850"/>
            </a:lvl4pPr>
            <a:lvl5pPr marL="2286000" lvl="4" indent="-228600" algn="l">
              <a:lnSpc>
                <a:spcPct val="90000"/>
              </a:lnSpc>
              <a:spcBef>
                <a:spcPts val="425"/>
              </a:spcBef>
              <a:spcAft>
                <a:spcPts val="0"/>
              </a:spcAft>
              <a:buClr>
                <a:schemeClr val="dk1"/>
              </a:buClr>
              <a:buSzPts val="850"/>
              <a:buNone/>
              <a:defRPr sz="850"/>
            </a:lvl5pPr>
            <a:lvl6pPr marL="2743200" lvl="5" indent="-228600" algn="l">
              <a:lnSpc>
                <a:spcPct val="90000"/>
              </a:lnSpc>
              <a:spcBef>
                <a:spcPts val="425"/>
              </a:spcBef>
              <a:spcAft>
                <a:spcPts val="0"/>
              </a:spcAft>
              <a:buClr>
                <a:schemeClr val="dk1"/>
              </a:buClr>
              <a:buSzPts val="850"/>
              <a:buNone/>
              <a:defRPr sz="850"/>
            </a:lvl6pPr>
            <a:lvl7pPr marL="3200400" lvl="6" indent="-228600" algn="l">
              <a:lnSpc>
                <a:spcPct val="90000"/>
              </a:lnSpc>
              <a:spcBef>
                <a:spcPts val="425"/>
              </a:spcBef>
              <a:spcAft>
                <a:spcPts val="0"/>
              </a:spcAft>
              <a:buClr>
                <a:schemeClr val="dk1"/>
              </a:buClr>
              <a:buSzPts val="850"/>
              <a:buNone/>
              <a:defRPr sz="850"/>
            </a:lvl7pPr>
            <a:lvl8pPr marL="3657600" lvl="7" indent="-228600" algn="l">
              <a:lnSpc>
                <a:spcPct val="90000"/>
              </a:lnSpc>
              <a:spcBef>
                <a:spcPts val="425"/>
              </a:spcBef>
              <a:spcAft>
                <a:spcPts val="0"/>
              </a:spcAft>
              <a:buClr>
                <a:schemeClr val="dk1"/>
              </a:buClr>
              <a:buSzPts val="850"/>
              <a:buNone/>
              <a:defRPr sz="850"/>
            </a:lvl8pPr>
            <a:lvl9pPr marL="4114800" lvl="8" indent="-228600" algn="l">
              <a:lnSpc>
                <a:spcPct val="90000"/>
              </a:lnSpc>
              <a:spcBef>
                <a:spcPts val="425"/>
              </a:spcBef>
              <a:spcAft>
                <a:spcPts val="0"/>
              </a:spcAft>
              <a:buClr>
                <a:schemeClr val="dk1"/>
              </a:buClr>
              <a:buSzPts val="850"/>
              <a:buNone/>
              <a:defRPr sz="850"/>
            </a:lvl9pPr>
          </a:lstStyle>
          <a:p>
            <a:endParaRPr/>
          </a:p>
        </p:txBody>
      </p:sp>
      <p:sp>
        <p:nvSpPr>
          <p:cNvPr id="62" name="Google Shape;62;p23"/>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3" name="Google Shape;63;p23"/>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4" name="Google Shape;64;p23"/>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24"/>
          <p:cNvSpPr txBox="1">
            <a:spLocks noGrp="1"/>
          </p:cNvSpPr>
          <p:nvPr>
            <p:ph type="title"/>
          </p:nvPr>
        </p:nvSpPr>
        <p:spPr>
          <a:xfrm>
            <a:off x="535365" y="670560"/>
            <a:ext cx="2506801" cy="2346960"/>
          </a:xfrm>
          <a:prstGeom prst="rect">
            <a:avLst/>
          </a:prstGeom>
          <a:noFill/>
          <a:ln>
            <a:noFill/>
          </a:ln>
        </p:spPr>
        <p:txBody>
          <a:bodyPr spcFirstLastPara="1" wrap="square" lIns="91425" tIns="45700" rIns="91425" bIns="45700" anchor="b" anchorCtr="0">
            <a:normAutofit/>
          </a:bodyPr>
          <a:lstStyle>
            <a:lvl1pPr lvl="0" algn="l">
              <a:lnSpc>
                <a:spcPct val="90000"/>
              </a:lnSpc>
              <a:spcBef>
                <a:spcPts val="0"/>
              </a:spcBef>
              <a:spcAft>
                <a:spcPts val="0"/>
              </a:spcAft>
              <a:buClr>
                <a:schemeClr val="dk1"/>
              </a:buClr>
              <a:buSzPts val="2720"/>
              <a:buFont typeface="Arial"/>
              <a:buNone/>
              <a:defRPr sz="2720"/>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67" name="Google Shape;67;p24"/>
          <p:cNvSpPr>
            <a:spLocks noGrp="1"/>
          </p:cNvSpPr>
          <p:nvPr>
            <p:ph type="pic" idx="2"/>
          </p:nvPr>
        </p:nvSpPr>
        <p:spPr>
          <a:xfrm>
            <a:off x="3304282" y="1448226"/>
            <a:ext cx="3934778" cy="7147983"/>
          </a:xfrm>
          <a:prstGeom prst="rect">
            <a:avLst/>
          </a:prstGeom>
          <a:noFill/>
          <a:ln>
            <a:noFill/>
          </a:ln>
        </p:spPr>
      </p:sp>
      <p:sp>
        <p:nvSpPr>
          <p:cNvPr id="68" name="Google Shape;68;p24"/>
          <p:cNvSpPr txBox="1">
            <a:spLocks noGrp="1"/>
          </p:cNvSpPr>
          <p:nvPr>
            <p:ph type="body" idx="1"/>
          </p:nvPr>
        </p:nvSpPr>
        <p:spPr>
          <a:xfrm>
            <a:off x="535365" y="3017520"/>
            <a:ext cx="2506801" cy="5590329"/>
          </a:xfrm>
          <a:prstGeom prst="rect">
            <a:avLst/>
          </a:prstGeom>
          <a:noFill/>
          <a:ln>
            <a:noFill/>
          </a:ln>
        </p:spPr>
        <p:txBody>
          <a:bodyPr spcFirstLastPara="1" wrap="square" lIns="91425" tIns="45700" rIns="91425" bIns="45700" anchor="t" anchorCtr="0">
            <a:normAutofit/>
          </a:bodyPr>
          <a:lstStyle>
            <a:lvl1pPr marL="457200" lvl="0" indent="-228600" algn="l">
              <a:lnSpc>
                <a:spcPct val="90000"/>
              </a:lnSpc>
              <a:spcBef>
                <a:spcPts val="850"/>
              </a:spcBef>
              <a:spcAft>
                <a:spcPts val="0"/>
              </a:spcAft>
              <a:buClr>
                <a:schemeClr val="dk1"/>
              </a:buClr>
              <a:buSzPts val="1360"/>
              <a:buNone/>
              <a:defRPr sz="1360"/>
            </a:lvl1pPr>
            <a:lvl2pPr marL="914400" lvl="1" indent="-228600" algn="l">
              <a:lnSpc>
                <a:spcPct val="90000"/>
              </a:lnSpc>
              <a:spcBef>
                <a:spcPts val="425"/>
              </a:spcBef>
              <a:spcAft>
                <a:spcPts val="0"/>
              </a:spcAft>
              <a:buClr>
                <a:schemeClr val="dk1"/>
              </a:buClr>
              <a:buSzPts val="1190"/>
              <a:buNone/>
              <a:defRPr sz="1190"/>
            </a:lvl2pPr>
            <a:lvl3pPr marL="1371600" lvl="2" indent="-228600" algn="l">
              <a:lnSpc>
                <a:spcPct val="90000"/>
              </a:lnSpc>
              <a:spcBef>
                <a:spcPts val="425"/>
              </a:spcBef>
              <a:spcAft>
                <a:spcPts val="0"/>
              </a:spcAft>
              <a:buClr>
                <a:schemeClr val="dk1"/>
              </a:buClr>
              <a:buSzPts val="1020"/>
              <a:buNone/>
              <a:defRPr sz="1020"/>
            </a:lvl3pPr>
            <a:lvl4pPr marL="1828800" lvl="3" indent="-228600" algn="l">
              <a:lnSpc>
                <a:spcPct val="90000"/>
              </a:lnSpc>
              <a:spcBef>
                <a:spcPts val="425"/>
              </a:spcBef>
              <a:spcAft>
                <a:spcPts val="0"/>
              </a:spcAft>
              <a:buClr>
                <a:schemeClr val="dk1"/>
              </a:buClr>
              <a:buSzPts val="850"/>
              <a:buNone/>
              <a:defRPr sz="850"/>
            </a:lvl4pPr>
            <a:lvl5pPr marL="2286000" lvl="4" indent="-228600" algn="l">
              <a:lnSpc>
                <a:spcPct val="90000"/>
              </a:lnSpc>
              <a:spcBef>
                <a:spcPts val="425"/>
              </a:spcBef>
              <a:spcAft>
                <a:spcPts val="0"/>
              </a:spcAft>
              <a:buClr>
                <a:schemeClr val="dk1"/>
              </a:buClr>
              <a:buSzPts val="850"/>
              <a:buNone/>
              <a:defRPr sz="850"/>
            </a:lvl5pPr>
            <a:lvl6pPr marL="2743200" lvl="5" indent="-228600" algn="l">
              <a:lnSpc>
                <a:spcPct val="90000"/>
              </a:lnSpc>
              <a:spcBef>
                <a:spcPts val="425"/>
              </a:spcBef>
              <a:spcAft>
                <a:spcPts val="0"/>
              </a:spcAft>
              <a:buClr>
                <a:schemeClr val="dk1"/>
              </a:buClr>
              <a:buSzPts val="850"/>
              <a:buNone/>
              <a:defRPr sz="850"/>
            </a:lvl6pPr>
            <a:lvl7pPr marL="3200400" lvl="6" indent="-228600" algn="l">
              <a:lnSpc>
                <a:spcPct val="90000"/>
              </a:lnSpc>
              <a:spcBef>
                <a:spcPts val="425"/>
              </a:spcBef>
              <a:spcAft>
                <a:spcPts val="0"/>
              </a:spcAft>
              <a:buClr>
                <a:schemeClr val="dk1"/>
              </a:buClr>
              <a:buSzPts val="850"/>
              <a:buNone/>
              <a:defRPr sz="850"/>
            </a:lvl7pPr>
            <a:lvl8pPr marL="3657600" lvl="7" indent="-228600" algn="l">
              <a:lnSpc>
                <a:spcPct val="90000"/>
              </a:lnSpc>
              <a:spcBef>
                <a:spcPts val="425"/>
              </a:spcBef>
              <a:spcAft>
                <a:spcPts val="0"/>
              </a:spcAft>
              <a:buClr>
                <a:schemeClr val="dk1"/>
              </a:buClr>
              <a:buSzPts val="850"/>
              <a:buNone/>
              <a:defRPr sz="850"/>
            </a:lvl8pPr>
            <a:lvl9pPr marL="4114800" lvl="8" indent="-228600" algn="l">
              <a:lnSpc>
                <a:spcPct val="90000"/>
              </a:lnSpc>
              <a:spcBef>
                <a:spcPts val="425"/>
              </a:spcBef>
              <a:spcAft>
                <a:spcPts val="0"/>
              </a:spcAft>
              <a:buClr>
                <a:schemeClr val="dk1"/>
              </a:buClr>
              <a:buSzPts val="850"/>
              <a:buNone/>
              <a:defRPr sz="850"/>
            </a:lvl9pPr>
          </a:lstStyle>
          <a:p>
            <a:endParaRPr/>
          </a:p>
        </p:txBody>
      </p:sp>
      <p:sp>
        <p:nvSpPr>
          <p:cNvPr id="69" name="Google Shape;69;p24"/>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lvl="0" algn="l">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0" name="Google Shape;70;p24"/>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lvl="0" algn="ctr">
              <a:lnSpc>
                <a:spcPct val="100000"/>
              </a:lnSpc>
              <a:spcBef>
                <a:spcPts val="0"/>
              </a:spcBef>
              <a:spcAft>
                <a:spcPts val="0"/>
              </a:spcAft>
              <a:buSzPts val="1400"/>
              <a:buNone/>
              <a:defRPr/>
            </a:lvl1pPr>
            <a:lvl2pPr lvl="1" algn="l">
              <a:lnSpc>
                <a:spcPct val="100000"/>
              </a:lnSpc>
              <a:spcBef>
                <a:spcPts val="0"/>
              </a:spcBef>
              <a:spcAft>
                <a:spcPts val="0"/>
              </a:spcAft>
              <a:buSzPts val="1400"/>
              <a:buNone/>
              <a:defRPr/>
            </a:lvl2pPr>
            <a:lvl3pPr lvl="2" algn="l">
              <a:lnSpc>
                <a:spcPct val="100000"/>
              </a:lnSpc>
              <a:spcBef>
                <a:spcPts val="0"/>
              </a:spcBef>
              <a:spcAft>
                <a:spcPts val="0"/>
              </a:spcAft>
              <a:buSzPts val="1400"/>
              <a:buNone/>
              <a:defRPr/>
            </a:lvl3pPr>
            <a:lvl4pPr lvl="3" algn="l">
              <a:lnSpc>
                <a:spcPct val="100000"/>
              </a:lnSpc>
              <a:spcBef>
                <a:spcPts val="0"/>
              </a:spcBef>
              <a:spcAft>
                <a:spcPts val="0"/>
              </a:spcAft>
              <a:buSzPts val="1400"/>
              <a:buNone/>
              <a:defRPr/>
            </a:lvl4pPr>
            <a:lvl5pPr lvl="4" algn="l">
              <a:lnSpc>
                <a:spcPct val="100000"/>
              </a:lnSpc>
              <a:spcBef>
                <a:spcPts val="0"/>
              </a:spcBef>
              <a:spcAft>
                <a:spcPts val="0"/>
              </a:spcAft>
              <a:buSzPts val="1400"/>
              <a:buNone/>
              <a:defRPr/>
            </a:lvl5pPr>
            <a:lvl6pPr lvl="5" algn="l">
              <a:lnSpc>
                <a:spcPct val="100000"/>
              </a:lnSpc>
              <a:spcBef>
                <a:spcPts val="0"/>
              </a:spcBef>
              <a:spcAft>
                <a:spcPts val="0"/>
              </a:spcAft>
              <a:buSzPts val="1400"/>
              <a:buNone/>
              <a:defRPr/>
            </a:lvl6pPr>
            <a:lvl7pPr lvl="6" algn="l">
              <a:lnSpc>
                <a:spcPct val="100000"/>
              </a:lnSpc>
              <a:spcBef>
                <a:spcPts val="0"/>
              </a:spcBef>
              <a:spcAft>
                <a:spcPts val="0"/>
              </a:spcAft>
              <a:buSzPts val="1400"/>
              <a:buNone/>
              <a:defRPr/>
            </a:lvl7pPr>
            <a:lvl8pPr lvl="7" algn="l">
              <a:lnSpc>
                <a:spcPct val="100000"/>
              </a:lnSpc>
              <a:spcBef>
                <a:spcPts val="0"/>
              </a:spcBef>
              <a:spcAft>
                <a:spcPts val="0"/>
              </a:spcAft>
              <a:buSzPts val="1400"/>
              <a:buNone/>
              <a:defRPr/>
            </a:lvl8pPr>
            <a:lvl9pPr lvl="8" algn="l">
              <a:lnSpc>
                <a:spcPct val="100000"/>
              </a:lnSpc>
              <a:spcBef>
                <a:spcPts val="0"/>
              </a:spcBef>
              <a:spcAft>
                <a:spcPts val="0"/>
              </a:spcAft>
              <a:buSzPts val="1400"/>
              <a:buNone/>
              <a:defRPr/>
            </a:lvl9pPr>
          </a:lstStyle>
          <a:p>
            <a:endParaRPr/>
          </a:p>
        </p:txBody>
      </p:sp>
      <p:sp>
        <p:nvSpPr>
          <p:cNvPr id="71" name="Google Shape;71;p24"/>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5"/>
          <p:cNvSpPr txBox="1">
            <a:spLocks noGrp="1"/>
          </p:cNvSpPr>
          <p:nvPr>
            <p:ph type="title"/>
          </p:nvPr>
        </p:nvSpPr>
        <p:spPr>
          <a:xfrm>
            <a:off x="534353" y="535519"/>
            <a:ext cx="6703695" cy="1944159"/>
          </a:xfrm>
          <a:prstGeom prst="rect">
            <a:avLst/>
          </a:prstGeom>
          <a:noFill/>
          <a:ln>
            <a:noFill/>
          </a:ln>
        </p:spPr>
        <p:txBody>
          <a:bodyPr spcFirstLastPara="1" wrap="square" lIns="91425" tIns="45700" rIns="91425" bIns="45700" anchor="ctr" anchorCtr="0">
            <a:normAutofit/>
          </a:bodyPr>
          <a:lstStyle>
            <a:lvl1pPr marR="0" lvl="0" algn="l" rtl="0">
              <a:lnSpc>
                <a:spcPct val="90000"/>
              </a:lnSpc>
              <a:spcBef>
                <a:spcPts val="0"/>
              </a:spcBef>
              <a:spcAft>
                <a:spcPts val="0"/>
              </a:spcAft>
              <a:buClr>
                <a:schemeClr val="dk1"/>
              </a:buClr>
              <a:buSzPts val="3740"/>
              <a:buFont typeface="Arial"/>
              <a:buNone/>
              <a:defRPr sz="3740" b="0" i="0" u="none" strike="noStrike" cap="none">
                <a:solidFill>
                  <a:schemeClr val="dk1"/>
                </a:solidFill>
                <a:latin typeface="Arial"/>
                <a:ea typeface="Arial"/>
                <a:cs typeface="Arial"/>
                <a:sym typeface="Arial"/>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15"/>
          <p:cNvSpPr txBox="1">
            <a:spLocks noGrp="1"/>
          </p:cNvSpPr>
          <p:nvPr>
            <p:ph type="body" idx="1"/>
          </p:nvPr>
        </p:nvSpPr>
        <p:spPr>
          <a:xfrm>
            <a:off x="534353" y="2677584"/>
            <a:ext cx="6703695" cy="6381962"/>
          </a:xfrm>
          <a:prstGeom prst="rect">
            <a:avLst/>
          </a:prstGeom>
          <a:noFill/>
          <a:ln>
            <a:noFill/>
          </a:ln>
        </p:spPr>
        <p:txBody>
          <a:bodyPr spcFirstLastPara="1" wrap="square" lIns="91425" tIns="45700" rIns="91425" bIns="45700" anchor="t" anchorCtr="0">
            <a:normAutofit/>
          </a:bodyPr>
          <a:lstStyle>
            <a:lvl1pPr marL="457200" marR="0" lvl="0" indent="-379730" algn="l" rtl="0">
              <a:lnSpc>
                <a:spcPct val="90000"/>
              </a:lnSpc>
              <a:spcBef>
                <a:spcPts val="850"/>
              </a:spcBef>
              <a:spcAft>
                <a:spcPts val="0"/>
              </a:spcAft>
              <a:buClr>
                <a:schemeClr val="dk1"/>
              </a:buClr>
              <a:buSzPts val="2380"/>
              <a:buFont typeface="Arial"/>
              <a:buChar char="•"/>
              <a:defRPr sz="2380" b="0" i="0" u="none" strike="noStrike" cap="none">
                <a:solidFill>
                  <a:schemeClr val="dk1"/>
                </a:solidFill>
                <a:latin typeface="Times New Roman"/>
                <a:ea typeface="Times New Roman"/>
                <a:cs typeface="Times New Roman"/>
                <a:sym typeface="Times New Roman"/>
              </a:defRPr>
            </a:lvl1pPr>
            <a:lvl2pPr marL="914400" marR="0" lvl="1" indent="-358140" algn="l" rtl="0">
              <a:lnSpc>
                <a:spcPct val="90000"/>
              </a:lnSpc>
              <a:spcBef>
                <a:spcPts val="425"/>
              </a:spcBef>
              <a:spcAft>
                <a:spcPts val="0"/>
              </a:spcAft>
              <a:buClr>
                <a:schemeClr val="dk1"/>
              </a:buClr>
              <a:buSzPts val="2040"/>
              <a:buFont typeface="Arial"/>
              <a:buChar char="•"/>
              <a:defRPr sz="2040" b="0" i="0" u="none" strike="noStrike" cap="none">
                <a:solidFill>
                  <a:schemeClr val="dk1"/>
                </a:solidFill>
                <a:latin typeface="Times New Roman"/>
                <a:ea typeface="Times New Roman"/>
                <a:cs typeface="Times New Roman"/>
                <a:sym typeface="Times New Roman"/>
              </a:defRPr>
            </a:lvl2pPr>
            <a:lvl3pPr marL="1371600" marR="0" lvl="2" indent="-336550" algn="l" rtl="0">
              <a:lnSpc>
                <a:spcPct val="90000"/>
              </a:lnSpc>
              <a:spcBef>
                <a:spcPts val="425"/>
              </a:spcBef>
              <a:spcAft>
                <a:spcPts val="0"/>
              </a:spcAft>
              <a:buClr>
                <a:schemeClr val="dk1"/>
              </a:buClr>
              <a:buSzPts val="1700"/>
              <a:buFont typeface="Arial"/>
              <a:buChar char="•"/>
              <a:defRPr sz="1700" b="0" i="0" u="none" strike="noStrike" cap="none">
                <a:solidFill>
                  <a:schemeClr val="dk1"/>
                </a:solidFill>
                <a:latin typeface="Times New Roman"/>
                <a:ea typeface="Times New Roman"/>
                <a:cs typeface="Times New Roman"/>
                <a:sym typeface="Times New Roman"/>
              </a:defRPr>
            </a:lvl3pPr>
            <a:lvl4pPr marL="1828800" marR="0" lvl="3" indent="-325755" algn="l" rtl="0">
              <a:lnSpc>
                <a:spcPct val="90000"/>
              </a:lnSpc>
              <a:spcBef>
                <a:spcPts val="425"/>
              </a:spcBef>
              <a:spcAft>
                <a:spcPts val="0"/>
              </a:spcAft>
              <a:buClr>
                <a:schemeClr val="dk1"/>
              </a:buClr>
              <a:buSzPts val="1530"/>
              <a:buFont typeface="Arial"/>
              <a:buChar char="•"/>
              <a:defRPr sz="1530" b="0" i="0" u="none" strike="noStrike" cap="none">
                <a:solidFill>
                  <a:schemeClr val="dk1"/>
                </a:solidFill>
                <a:latin typeface="Times New Roman"/>
                <a:ea typeface="Times New Roman"/>
                <a:cs typeface="Times New Roman"/>
                <a:sym typeface="Times New Roman"/>
              </a:defRPr>
            </a:lvl4pPr>
            <a:lvl5pPr marL="2286000" marR="0" lvl="4" indent="-325754" algn="l" rtl="0">
              <a:lnSpc>
                <a:spcPct val="90000"/>
              </a:lnSpc>
              <a:spcBef>
                <a:spcPts val="425"/>
              </a:spcBef>
              <a:spcAft>
                <a:spcPts val="0"/>
              </a:spcAft>
              <a:buClr>
                <a:schemeClr val="dk1"/>
              </a:buClr>
              <a:buSzPts val="1530"/>
              <a:buFont typeface="Arial"/>
              <a:buChar char="•"/>
              <a:defRPr sz="1530" b="0" i="0" u="none" strike="noStrike" cap="none">
                <a:solidFill>
                  <a:schemeClr val="dk1"/>
                </a:solidFill>
                <a:latin typeface="Times New Roman"/>
                <a:ea typeface="Times New Roman"/>
                <a:cs typeface="Times New Roman"/>
                <a:sym typeface="Times New Roman"/>
              </a:defRPr>
            </a:lvl5pPr>
            <a:lvl6pPr marL="2743200" marR="0" lvl="5" indent="-325754" algn="l" rtl="0">
              <a:lnSpc>
                <a:spcPct val="90000"/>
              </a:lnSpc>
              <a:spcBef>
                <a:spcPts val="425"/>
              </a:spcBef>
              <a:spcAft>
                <a:spcPts val="0"/>
              </a:spcAft>
              <a:buClr>
                <a:schemeClr val="dk1"/>
              </a:buClr>
              <a:buSzPts val="1530"/>
              <a:buFont typeface="Arial"/>
              <a:buChar char="•"/>
              <a:defRPr sz="1530" b="0" i="0" u="none" strike="noStrike" cap="none">
                <a:solidFill>
                  <a:schemeClr val="dk1"/>
                </a:solidFill>
                <a:latin typeface="Times New Roman"/>
                <a:ea typeface="Times New Roman"/>
                <a:cs typeface="Times New Roman"/>
                <a:sym typeface="Times New Roman"/>
              </a:defRPr>
            </a:lvl6pPr>
            <a:lvl7pPr marL="3200400" marR="0" lvl="6" indent="-325754" algn="l" rtl="0">
              <a:lnSpc>
                <a:spcPct val="90000"/>
              </a:lnSpc>
              <a:spcBef>
                <a:spcPts val="425"/>
              </a:spcBef>
              <a:spcAft>
                <a:spcPts val="0"/>
              </a:spcAft>
              <a:buClr>
                <a:schemeClr val="dk1"/>
              </a:buClr>
              <a:buSzPts val="1530"/>
              <a:buFont typeface="Arial"/>
              <a:buChar char="•"/>
              <a:defRPr sz="1530" b="0" i="0" u="none" strike="noStrike" cap="none">
                <a:solidFill>
                  <a:schemeClr val="dk1"/>
                </a:solidFill>
                <a:latin typeface="Times New Roman"/>
                <a:ea typeface="Times New Roman"/>
                <a:cs typeface="Times New Roman"/>
                <a:sym typeface="Times New Roman"/>
              </a:defRPr>
            </a:lvl7pPr>
            <a:lvl8pPr marL="3657600" marR="0" lvl="7" indent="-325754" algn="l" rtl="0">
              <a:lnSpc>
                <a:spcPct val="90000"/>
              </a:lnSpc>
              <a:spcBef>
                <a:spcPts val="425"/>
              </a:spcBef>
              <a:spcAft>
                <a:spcPts val="0"/>
              </a:spcAft>
              <a:buClr>
                <a:schemeClr val="dk1"/>
              </a:buClr>
              <a:buSzPts val="1530"/>
              <a:buFont typeface="Arial"/>
              <a:buChar char="•"/>
              <a:defRPr sz="1530" b="0" i="0" u="none" strike="noStrike" cap="none">
                <a:solidFill>
                  <a:schemeClr val="dk1"/>
                </a:solidFill>
                <a:latin typeface="Times New Roman"/>
                <a:ea typeface="Times New Roman"/>
                <a:cs typeface="Times New Roman"/>
                <a:sym typeface="Times New Roman"/>
              </a:defRPr>
            </a:lvl8pPr>
            <a:lvl9pPr marL="4114800" marR="0" lvl="8" indent="-325754" algn="l" rtl="0">
              <a:lnSpc>
                <a:spcPct val="90000"/>
              </a:lnSpc>
              <a:spcBef>
                <a:spcPts val="425"/>
              </a:spcBef>
              <a:spcAft>
                <a:spcPts val="0"/>
              </a:spcAft>
              <a:buClr>
                <a:schemeClr val="dk1"/>
              </a:buClr>
              <a:buSzPts val="1530"/>
              <a:buFont typeface="Arial"/>
              <a:buChar char="•"/>
              <a:defRPr sz="1530" b="0" i="0" u="none" strike="noStrike" cap="none">
                <a:solidFill>
                  <a:schemeClr val="dk1"/>
                </a:solidFill>
                <a:latin typeface="Times New Roman"/>
                <a:ea typeface="Times New Roman"/>
                <a:cs typeface="Times New Roman"/>
                <a:sym typeface="Times New Roman"/>
              </a:defRPr>
            </a:lvl9pPr>
          </a:lstStyle>
          <a:p>
            <a:endParaRPr/>
          </a:p>
        </p:txBody>
      </p:sp>
      <p:sp>
        <p:nvSpPr>
          <p:cNvPr id="12" name="Google Shape;12;p15"/>
          <p:cNvSpPr txBox="1">
            <a:spLocks noGrp="1"/>
          </p:cNvSpPr>
          <p:nvPr>
            <p:ph type="dt" idx="10"/>
          </p:nvPr>
        </p:nvSpPr>
        <p:spPr>
          <a:xfrm>
            <a:off x="534353" y="9322649"/>
            <a:ext cx="1748790" cy="535517"/>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020" b="0" i="0" u="none" strike="noStrike" cap="none">
                <a:solidFill>
                  <a:srgbClr val="888888"/>
                </a:solidFill>
                <a:latin typeface="Times New Roman"/>
                <a:ea typeface="Times New Roman"/>
                <a:cs typeface="Times New Roman"/>
                <a:sym typeface="Times New Roman"/>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9pPr>
          </a:lstStyle>
          <a:p>
            <a:endParaRPr/>
          </a:p>
        </p:txBody>
      </p:sp>
      <p:sp>
        <p:nvSpPr>
          <p:cNvPr id="13" name="Google Shape;13;p15"/>
          <p:cNvSpPr txBox="1">
            <a:spLocks noGrp="1"/>
          </p:cNvSpPr>
          <p:nvPr>
            <p:ph type="ftr" idx="11"/>
          </p:nvPr>
        </p:nvSpPr>
        <p:spPr>
          <a:xfrm>
            <a:off x="2574608" y="9322649"/>
            <a:ext cx="2623185" cy="535517"/>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020" b="0" i="0" u="none" strike="noStrike" cap="none">
                <a:solidFill>
                  <a:srgbClr val="888888"/>
                </a:solidFill>
                <a:latin typeface="Times New Roman"/>
                <a:ea typeface="Times New Roman"/>
                <a:cs typeface="Times New Roman"/>
                <a:sym typeface="Times New Roman"/>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Times New Roman"/>
                <a:ea typeface="Times New Roman"/>
                <a:cs typeface="Times New Roman"/>
                <a:sym typeface="Times New Roman"/>
              </a:defRPr>
            </a:lvl9pPr>
          </a:lstStyle>
          <a:p>
            <a:endParaRPr/>
          </a:p>
        </p:txBody>
      </p:sp>
      <p:sp>
        <p:nvSpPr>
          <p:cNvPr id="14" name="Google Shape;14;p15"/>
          <p:cNvSpPr txBox="1">
            <a:spLocks noGrp="1"/>
          </p:cNvSpPr>
          <p:nvPr>
            <p:ph type="sldNum" idx="12"/>
          </p:nvPr>
        </p:nvSpPr>
        <p:spPr>
          <a:xfrm>
            <a:off x="5489258" y="9322649"/>
            <a:ext cx="1748790" cy="535517"/>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1pPr>
            <a:lvl2pPr marL="0" marR="0" lvl="1" indent="0" algn="r" rtl="0">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2pPr>
            <a:lvl3pPr marL="0" marR="0" lvl="2" indent="0" algn="r" rtl="0">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3pPr>
            <a:lvl4pPr marL="0" marR="0" lvl="3" indent="0" algn="r" rtl="0">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4pPr>
            <a:lvl5pPr marL="0" marR="0" lvl="4" indent="0" algn="r" rtl="0">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5pPr>
            <a:lvl6pPr marL="0" marR="0" lvl="5" indent="0" algn="r" rtl="0">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6pPr>
            <a:lvl7pPr marL="0" marR="0" lvl="6" indent="0" algn="r" rtl="0">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7pPr>
            <a:lvl8pPr marL="0" marR="0" lvl="7" indent="0" algn="r" rtl="0">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8pPr>
            <a:lvl9pPr marL="0" marR="0" lvl="8" indent="0" algn="r" rtl="0">
              <a:lnSpc>
                <a:spcPct val="100000"/>
              </a:lnSpc>
              <a:spcBef>
                <a:spcPts val="0"/>
              </a:spcBef>
              <a:spcAft>
                <a:spcPts val="0"/>
              </a:spcAft>
              <a:buClr>
                <a:srgbClr val="000000"/>
              </a:buClr>
              <a:buSzPts val="1020"/>
              <a:buFont typeface="Arial"/>
              <a:buNone/>
              <a:defRPr sz="1020" b="0" i="0" u="none" strike="noStrike" cap="none">
                <a:solidFill>
                  <a:srgbClr val="888888"/>
                </a:solidFill>
                <a:latin typeface="Times New Roman"/>
                <a:ea typeface="Times New Roman"/>
                <a:cs typeface="Times New Roman"/>
                <a:sym typeface="Times New Roman"/>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xml"/><Relationship Id="rId1" Type="http://schemas.openxmlformats.org/officeDocument/2006/relationships/slideLayout" Target="../slideLayouts/slideLayout2.xml"/><Relationship Id="rId5" Type="http://schemas.openxmlformats.org/officeDocument/2006/relationships/image" Target="../media/image3.png"/><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8" Type="http://schemas.openxmlformats.org/officeDocument/2006/relationships/chart" Target="../charts/chart1.xml"/><Relationship Id="rId3" Type="http://schemas.openxmlformats.org/officeDocument/2006/relationships/image" Target="../media/image4.jpg"/><Relationship Id="rId7" Type="http://schemas.openxmlformats.org/officeDocument/2006/relationships/image" Target="../media/image8.jp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7.jpg"/><Relationship Id="rId5" Type="http://schemas.openxmlformats.org/officeDocument/2006/relationships/image" Target="../media/image6.jpg"/><Relationship Id="rId4" Type="http://schemas.openxmlformats.org/officeDocument/2006/relationships/image" Target="../media/image5.jpg"/></Relationships>
</file>

<file path=ppt/slides/_rels/slide4.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chart" Target="../charts/chart3.xml"/><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chart" Target="../charts/chart5.xml"/><Relationship Id="rId4" Type="http://schemas.openxmlformats.org/officeDocument/2006/relationships/chart" Target="../charts/chart4.xml"/></Relationships>
</file>

<file path=ppt/slides/_rels/slide6.xml.rels><?xml version="1.0" encoding="UTF-8" standalone="yes"?>
<Relationships xmlns="http://schemas.openxmlformats.org/package/2006/relationships"><Relationship Id="rId3" Type="http://schemas.openxmlformats.org/officeDocument/2006/relationships/chart" Target="../charts/chart6.xml"/><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8" Type="http://schemas.openxmlformats.org/officeDocument/2006/relationships/image" Target="../media/image14.png"/><Relationship Id="rId3" Type="http://schemas.openxmlformats.org/officeDocument/2006/relationships/image" Target="../media/image9.png"/><Relationship Id="rId7" Type="http://schemas.openxmlformats.org/officeDocument/2006/relationships/image" Target="../media/image13.png"/><Relationship Id="rId2" Type="http://schemas.openxmlformats.org/officeDocument/2006/relationships/notesSlide" Target="../notesSlides/notesSlide7.xml"/><Relationship Id="rId1" Type="http://schemas.openxmlformats.org/officeDocument/2006/relationships/slideLayout" Target="../slideLayouts/slideLayout2.xml"/><Relationship Id="rId6" Type="http://schemas.openxmlformats.org/officeDocument/2006/relationships/image" Target="../media/image12.png"/><Relationship Id="rId11" Type="http://schemas.openxmlformats.org/officeDocument/2006/relationships/image" Target="../media/image17.png"/><Relationship Id="rId5" Type="http://schemas.openxmlformats.org/officeDocument/2006/relationships/image" Target="../media/image11.png"/><Relationship Id="rId10" Type="http://schemas.openxmlformats.org/officeDocument/2006/relationships/image" Target="../media/image16.png"/><Relationship Id="rId4" Type="http://schemas.openxmlformats.org/officeDocument/2006/relationships/image" Target="../media/image10.png"/><Relationship Id="rId9" Type="http://schemas.openxmlformats.org/officeDocument/2006/relationships/image" Target="../media/image15.png"/></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chart" Target="../charts/chart7.xml"/><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87"/>
        <p:cNvGrpSpPr/>
        <p:nvPr/>
      </p:nvGrpSpPr>
      <p:grpSpPr>
        <a:xfrm>
          <a:off x="0" y="0"/>
          <a:ext cx="0" cy="0"/>
          <a:chOff x="0" y="0"/>
          <a:chExt cx="0" cy="0"/>
        </a:xfrm>
      </p:grpSpPr>
      <p:sp>
        <p:nvSpPr>
          <p:cNvPr id="88" name="Google Shape;88;p1"/>
          <p:cNvSpPr txBox="1">
            <a:spLocks noGrp="1"/>
          </p:cNvSpPr>
          <p:nvPr>
            <p:ph type="ctrTitle"/>
          </p:nvPr>
        </p:nvSpPr>
        <p:spPr>
          <a:xfrm>
            <a:off x="906780" y="2254103"/>
            <a:ext cx="5829300" cy="2428451"/>
          </a:xfrm>
          <a:prstGeom prst="rect">
            <a:avLst/>
          </a:prstGeom>
          <a:noFill/>
          <a:ln>
            <a:noFill/>
          </a:ln>
        </p:spPr>
        <p:txBody>
          <a:bodyPr spcFirstLastPara="1" wrap="square" lIns="91425" tIns="45700" rIns="91425" bIns="45700" anchor="ctr" anchorCtr="0">
            <a:normAutofit/>
          </a:bodyPr>
          <a:lstStyle/>
          <a:p>
            <a:pPr marL="0" lvl="0" indent="0" algn="ctr" rtl="0">
              <a:lnSpc>
                <a:spcPct val="90000"/>
              </a:lnSpc>
              <a:spcBef>
                <a:spcPts val="0"/>
              </a:spcBef>
              <a:spcAft>
                <a:spcPts val="0"/>
              </a:spcAft>
              <a:buClr>
                <a:schemeClr val="dk1"/>
              </a:buClr>
              <a:buSzPts val="3060"/>
              <a:buFont typeface="Times New Roman"/>
              <a:buNone/>
            </a:pPr>
            <a:r>
              <a:rPr lang="en-US" sz="3060">
                <a:latin typeface="Times New Roman"/>
                <a:ea typeface="Times New Roman"/>
                <a:cs typeface="Times New Roman"/>
                <a:sym typeface="Times New Roman"/>
              </a:rPr>
              <a:t>RMT2 Supplemental Figures</a:t>
            </a:r>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551"/>
        <p:cNvGrpSpPr/>
        <p:nvPr/>
      </p:nvGrpSpPr>
      <p:grpSpPr>
        <a:xfrm>
          <a:off x="0" y="0"/>
          <a:ext cx="0" cy="0"/>
          <a:chOff x="0" y="0"/>
          <a:chExt cx="0" cy="0"/>
        </a:xfrm>
      </p:grpSpPr>
      <p:graphicFrame>
        <p:nvGraphicFramePr>
          <p:cNvPr id="552" name="Google Shape;552;p9"/>
          <p:cNvGraphicFramePr/>
          <p:nvPr>
            <p:extLst>
              <p:ext uri="{D42A27DB-BD31-4B8C-83A1-F6EECF244321}">
                <p14:modId xmlns:p14="http://schemas.microsoft.com/office/powerpoint/2010/main" val="2395657530"/>
              </p:ext>
            </p:extLst>
          </p:nvPr>
        </p:nvGraphicFramePr>
        <p:xfrm>
          <a:off x="694268" y="778933"/>
          <a:ext cx="6451625" cy="5582300"/>
        </p:xfrm>
        <a:graphic>
          <a:graphicData uri="http://schemas.openxmlformats.org/drawingml/2006/table">
            <a:tbl>
              <a:tblPr>
                <a:noFill/>
                <a:tableStyleId>{3F9B46F7-8DFB-436F-B93C-1C2E9E377E49}</a:tableStyleId>
              </a:tblPr>
              <a:tblGrid>
                <a:gridCol w="923700">
                  <a:extLst>
                    <a:ext uri="{9D8B030D-6E8A-4147-A177-3AD203B41FA5}">
                      <a16:colId xmlns:a16="http://schemas.microsoft.com/office/drawing/2014/main" val="20000"/>
                    </a:ext>
                  </a:extLst>
                </a:gridCol>
                <a:gridCol w="536750">
                  <a:extLst>
                    <a:ext uri="{9D8B030D-6E8A-4147-A177-3AD203B41FA5}">
                      <a16:colId xmlns:a16="http://schemas.microsoft.com/office/drawing/2014/main" val="20001"/>
                    </a:ext>
                  </a:extLst>
                </a:gridCol>
                <a:gridCol w="3434275">
                  <a:extLst>
                    <a:ext uri="{9D8B030D-6E8A-4147-A177-3AD203B41FA5}">
                      <a16:colId xmlns:a16="http://schemas.microsoft.com/office/drawing/2014/main" val="20002"/>
                    </a:ext>
                  </a:extLst>
                </a:gridCol>
                <a:gridCol w="778450">
                  <a:extLst>
                    <a:ext uri="{9D8B030D-6E8A-4147-A177-3AD203B41FA5}">
                      <a16:colId xmlns:a16="http://schemas.microsoft.com/office/drawing/2014/main" val="20003"/>
                    </a:ext>
                  </a:extLst>
                </a:gridCol>
                <a:gridCol w="778450">
                  <a:extLst>
                    <a:ext uri="{9D8B030D-6E8A-4147-A177-3AD203B41FA5}">
                      <a16:colId xmlns:a16="http://schemas.microsoft.com/office/drawing/2014/main" val="20004"/>
                    </a:ext>
                  </a:extLst>
                </a:gridCol>
              </a:tblGrid>
              <a:tr h="585675">
                <a:tc>
                  <a:txBody>
                    <a:bodyPr/>
                    <a:lstStyle/>
                    <a:p>
                      <a:pPr marL="0" marR="0" lvl="0" indent="0" algn="ctr" rtl="0">
                        <a:lnSpc>
                          <a:spcPct val="100000"/>
                        </a:lnSpc>
                        <a:spcBef>
                          <a:spcPts val="0"/>
                        </a:spcBef>
                        <a:spcAft>
                          <a:spcPts val="0"/>
                        </a:spcAft>
                        <a:buClr>
                          <a:srgbClr val="000000"/>
                        </a:buClr>
                        <a:buSzPts val="1000"/>
                        <a:buFont typeface="Arial"/>
                        <a:buNone/>
                      </a:pPr>
                      <a:r>
                        <a:rPr lang="en-US" sz="1000" b="1" u="none" strike="noStrike" cap="none">
                          <a:latin typeface="Times New Roman"/>
                          <a:ea typeface="Times New Roman"/>
                          <a:cs typeface="Times New Roman"/>
                          <a:sym typeface="Times New Roman"/>
                        </a:rPr>
                        <a:t>Cre number</a:t>
                      </a:r>
                      <a:endParaRPr sz="1000" b="1"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b="1" u="none" strike="noStrike" cap="none">
                          <a:latin typeface="Times New Roman"/>
                          <a:ea typeface="Times New Roman"/>
                          <a:cs typeface="Times New Roman"/>
                          <a:sym typeface="Times New Roman"/>
                        </a:rPr>
                        <a:t>Alias</a:t>
                      </a:r>
                      <a:endParaRPr sz="1000" b="1"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b="1" u="none" strike="noStrike" cap="none">
                          <a:latin typeface="Times New Roman"/>
                          <a:ea typeface="Times New Roman"/>
                          <a:cs typeface="Times New Roman"/>
                          <a:sym typeface="Times New Roman"/>
                        </a:rPr>
                        <a:t>Functional annotation</a:t>
                      </a:r>
                      <a:endParaRPr sz="1000" b="1"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b="1" u="none" strike="noStrike" cap="none">
                          <a:latin typeface="Times New Roman"/>
                          <a:ea typeface="Times New Roman"/>
                          <a:cs typeface="Times New Roman"/>
                          <a:sym typeface="Times New Roman"/>
                        </a:rPr>
                        <a:t>Total mutant alleles</a:t>
                      </a:r>
                      <a:endParaRPr sz="1000" b="1"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b="1" i="1" u="none" strike="noStrike" cap="none">
                          <a:latin typeface="Times New Roman"/>
                          <a:ea typeface="Times New Roman"/>
                          <a:cs typeface="Times New Roman"/>
                          <a:sym typeface="Times New Roman"/>
                        </a:rPr>
                        <a:t>p</a:t>
                      </a:r>
                      <a:r>
                        <a:rPr lang="en-US" sz="1000" b="1" u="none" strike="noStrike" cap="none">
                          <a:latin typeface="Times New Roman"/>
                          <a:ea typeface="Times New Roman"/>
                          <a:cs typeface="Times New Roman"/>
                          <a:sym typeface="Times New Roman"/>
                        </a:rPr>
                        <a:t> value</a:t>
                      </a:r>
                      <a:endParaRPr sz="1000" b="1" i="0" u="none" strike="noStrike" cap="none">
                        <a:solidFill>
                          <a:srgbClr val="000000"/>
                        </a:solidFill>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0"/>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Cre16.g659050</a:t>
                      </a:r>
                      <a:endParaRPr sz="1400" u="none" strike="noStrike" cap="none">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dirty="0">
                          <a:latin typeface="Times New Roman"/>
                          <a:ea typeface="Times New Roman"/>
                          <a:cs typeface="Times New Roman"/>
                          <a:sym typeface="Times New Roman"/>
                        </a:rPr>
                        <a:t>2-succinyl-5-enolpyruvyl-6-hydroxy-3-cyclohexene-1-carboxylic-acid synthase (phylloquinone synthesis)</a:t>
                      </a:r>
                      <a:endParaRPr sz="1000" i="0" u="none" strike="noStrike" cap="none" dirty="0">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8</a:t>
                      </a:r>
                      <a:endParaRPr sz="1400" u="none" strike="noStrike" cap="none">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1.99 E-06</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1"/>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02.g07390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arotenoid oxygenase</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3</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2.27 E-06</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2"/>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12.g52450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RMT2</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dirty="0">
                          <a:latin typeface="Times New Roman"/>
                          <a:ea typeface="Times New Roman"/>
                          <a:cs typeface="Times New Roman"/>
                          <a:sym typeface="Times New Roman"/>
                        </a:rPr>
                        <a:t>Rubisco LSMT, substrate binding domain</a:t>
                      </a:r>
                      <a:endParaRPr sz="1000" i="0" u="none" strike="noStrike" cap="none" dirty="0">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3</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2.27 E-06</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3"/>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06.g25920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SELB</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dirty="0">
                          <a:latin typeface="Times New Roman"/>
                          <a:ea typeface="Times New Roman"/>
                          <a:cs typeface="Times New Roman"/>
                          <a:sym typeface="Times New Roman"/>
                        </a:rPr>
                        <a:t>Selenocysteine-specific elongation factor</a:t>
                      </a:r>
                      <a:endParaRPr sz="1000" i="0" u="none" strike="noStrike" cap="none" dirty="0">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5</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2.22 E-05</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4"/>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12.g52430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GL71</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dirty="0">
                          <a:latin typeface="Times New Roman"/>
                          <a:ea typeface="Times New Roman"/>
                          <a:cs typeface="Times New Roman"/>
                          <a:sym typeface="Times New Roman"/>
                        </a:rPr>
                        <a:t>Tetratricopeptide repeat</a:t>
                      </a:r>
                      <a:endParaRPr sz="1000" i="0" u="none" strike="noStrike" cap="none" dirty="0">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2</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0.000173</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5"/>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03.g18870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PLP6</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dirty="0">
                          <a:latin typeface="Times New Roman"/>
                          <a:ea typeface="Times New Roman"/>
                          <a:cs typeface="Times New Roman"/>
                          <a:sym typeface="Times New Roman"/>
                        </a:rPr>
                        <a:t>Plastid lipid associated protein</a:t>
                      </a:r>
                      <a:endParaRPr sz="1000" i="0" u="none" strike="noStrike" cap="none" dirty="0">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3</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0.000515</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6"/>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07.g33825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dirty="0">
                          <a:latin typeface="Times New Roman"/>
                          <a:ea typeface="Times New Roman"/>
                          <a:cs typeface="Times New Roman"/>
                          <a:sym typeface="Times New Roman"/>
                        </a:rPr>
                        <a:t>Aminoacyl-tRNA editing domain</a:t>
                      </a:r>
                      <a:endParaRPr sz="1000" i="0" u="none" strike="noStrike" cap="none" dirty="0">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3</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0.000515</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7"/>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dirty="0">
                          <a:latin typeface="Times New Roman"/>
                          <a:ea typeface="Times New Roman"/>
                          <a:cs typeface="Times New Roman"/>
                          <a:sym typeface="Times New Roman"/>
                        </a:rPr>
                        <a:t>Cre16.g658950</a:t>
                      </a:r>
                      <a:endParaRPr sz="1000" i="0" u="none" strike="noStrike" cap="none" dirty="0">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endParaRPr sz="1000" i="0" u="none" strike="noStrike" cap="none" dirty="0">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3</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0.000515</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8"/>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17.g72885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RAA15</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omponent of psaA trans-splicing sub complex II</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5</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0.001685</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09"/>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09.g388372</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RAT2</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tscA RNA stabilization factor, component of psaA trans-splicing complex I</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7</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0.003478</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10"/>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13.g57940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ERM8</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ERD4-related membrane protein</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7</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0.003478</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11"/>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03.g19935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SNF2-related DNA/RNA helicase</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8</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0.004597</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12"/>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10.g45225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FAP41</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9</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0.005859</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13"/>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12.g51340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EBG1</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Endo-1,3(4)-beta-glucanase</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9</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0.005859</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14"/>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14.g61770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PDE2</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yclic AMP phosphodiesterase</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1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0.00726</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15"/>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05.g23950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FAP38</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RNA binding / Antifreeze protein</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10</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a:solidFill>
                            <a:srgbClr val="000000"/>
                          </a:solidFill>
                          <a:latin typeface="Times New Roman"/>
                          <a:ea typeface="Times New Roman"/>
                          <a:cs typeface="Times New Roman"/>
                          <a:sym typeface="Times New Roman"/>
                        </a:rPr>
                        <a:t>0.00726</a:t>
                      </a:r>
                      <a:endParaRPr sz="1400" u="none" strike="noStrike" cap="none">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16"/>
                  </a:ext>
                </a:extLst>
              </a:tr>
              <a:tr h="280275">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re10.g424775</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ct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CTP2</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l"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Heavy metal transporting ATPase</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u="none" strike="noStrike" cap="none">
                          <a:latin typeface="Times New Roman"/>
                          <a:ea typeface="Times New Roman"/>
                          <a:cs typeface="Times New Roman"/>
                          <a:sym typeface="Times New Roman"/>
                        </a:rPr>
                        <a:t>11</a:t>
                      </a:r>
                      <a:endParaRPr sz="1000" i="0" u="none" strike="noStrike" cap="none">
                        <a:solidFill>
                          <a:srgbClr val="000000"/>
                        </a:solidFill>
                        <a:latin typeface="Times New Roman"/>
                        <a:ea typeface="Times New Roman"/>
                        <a:cs typeface="Times New Roman"/>
                        <a:sym typeface="Times New Roman"/>
                      </a:endParaRPr>
                    </a:p>
                  </a:txBody>
                  <a:tcPr marL="45725" marR="45725" marT="45725" marB="45725" anchor="ctr"/>
                </a:tc>
                <a:tc>
                  <a:txBody>
                    <a:bodyPr/>
                    <a:lstStyle/>
                    <a:p>
                      <a:pPr marL="0" marR="0" lvl="0" indent="0" algn="r" rtl="0">
                        <a:lnSpc>
                          <a:spcPct val="100000"/>
                        </a:lnSpc>
                        <a:spcBef>
                          <a:spcPts val="0"/>
                        </a:spcBef>
                        <a:spcAft>
                          <a:spcPts val="0"/>
                        </a:spcAft>
                        <a:buClr>
                          <a:srgbClr val="000000"/>
                        </a:buClr>
                        <a:buSzPts val="1000"/>
                        <a:buFont typeface="Arial"/>
                        <a:buNone/>
                      </a:pPr>
                      <a:r>
                        <a:rPr lang="en-US" sz="1000" i="0" u="none" strike="noStrike" cap="none" dirty="0">
                          <a:solidFill>
                            <a:srgbClr val="000000"/>
                          </a:solidFill>
                          <a:latin typeface="Times New Roman"/>
                          <a:ea typeface="Times New Roman"/>
                          <a:cs typeface="Times New Roman"/>
                          <a:sym typeface="Times New Roman"/>
                        </a:rPr>
                        <a:t>0.008796</a:t>
                      </a:r>
                      <a:endParaRPr sz="1400" u="none" strike="noStrike" cap="none" dirty="0">
                        <a:latin typeface="Times New Roman"/>
                        <a:ea typeface="Times New Roman"/>
                        <a:cs typeface="Times New Roman"/>
                        <a:sym typeface="Times New Roman"/>
                      </a:endParaRPr>
                    </a:p>
                  </a:txBody>
                  <a:tcPr marL="45725" marR="45725" marT="45725" marB="45725" anchor="ctr"/>
                </a:tc>
                <a:extLst>
                  <a:ext uri="{0D108BD9-81ED-4DB2-BD59-A6C34878D82A}">
                    <a16:rowId xmlns:a16="http://schemas.microsoft.com/office/drawing/2014/main" val="10017"/>
                  </a:ext>
                </a:extLst>
              </a:tr>
            </a:tbl>
          </a:graphicData>
        </a:graphic>
      </p:graphicFrame>
      <p:sp>
        <p:nvSpPr>
          <p:cNvPr id="553" name="Google Shape;553;p9"/>
          <p:cNvSpPr txBox="1"/>
          <p:nvPr/>
        </p:nvSpPr>
        <p:spPr>
          <a:xfrm>
            <a:off x="895513" y="8671303"/>
            <a:ext cx="6264218" cy="46162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200"/>
              <a:buFont typeface="Calibri"/>
              <a:buNone/>
            </a:pPr>
            <a:r>
              <a:rPr lang="en-US" sz="1200" b="1" i="0" u="none" strike="noStrike" cap="none" dirty="0">
                <a:solidFill>
                  <a:schemeClr val="dk1"/>
                </a:solidFill>
                <a:latin typeface="Calibri"/>
                <a:ea typeface="Calibri"/>
                <a:cs typeface="Calibri"/>
                <a:sym typeface="Calibri"/>
              </a:rPr>
              <a:t>Table S1.</a:t>
            </a:r>
            <a:r>
              <a:rPr lang="en-US" sz="1200" b="0" i="0" u="none" strike="noStrike" cap="none" dirty="0">
                <a:solidFill>
                  <a:schemeClr val="dk1"/>
                </a:solidFill>
                <a:latin typeface="Calibri"/>
                <a:ea typeface="Calibri"/>
                <a:cs typeface="Calibri"/>
                <a:sym typeface="Calibri"/>
              </a:rPr>
              <a:t> </a:t>
            </a:r>
            <a:r>
              <a:rPr lang="en-US" sz="1200" b="1" i="0" u="none" strike="noStrike" cap="none" dirty="0">
                <a:solidFill>
                  <a:schemeClr val="dk1"/>
                </a:solidFill>
                <a:latin typeface="Calibri"/>
                <a:ea typeface="Calibri"/>
                <a:cs typeface="Calibri"/>
                <a:sym typeface="Calibri"/>
              </a:rPr>
              <a:t>List of genes with mutants showing enrichment in hypoxic conditions compared to </a:t>
            </a:r>
            <a:r>
              <a:rPr lang="en-US" sz="1200" b="1" i="0" u="none" strike="noStrike" cap="none" dirty="0" err="1">
                <a:solidFill>
                  <a:schemeClr val="dk1"/>
                </a:solidFill>
                <a:latin typeface="Calibri"/>
                <a:ea typeface="Calibri"/>
                <a:cs typeface="Calibri"/>
                <a:sym typeface="Calibri"/>
              </a:rPr>
              <a:t>oxic</a:t>
            </a:r>
            <a:r>
              <a:rPr lang="en-US" sz="1200" b="1" i="0" u="none" strike="noStrike" cap="none" dirty="0">
                <a:solidFill>
                  <a:schemeClr val="dk1"/>
                </a:solidFill>
                <a:latin typeface="Calibri"/>
                <a:ea typeface="Calibri"/>
                <a:cs typeface="Calibri"/>
                <a:sym typeface="Calibri"/>
              </a:rPr>
              <a:t> conditions. </a:t>
            </a:r>
            <a:r>
              <a:rPr lang="en-US" sz="1200" b="0" i="0" u="none" strike="noStrike" cap="none" dirty="0">
                <a:solidFill>
                  <a:schemeClr val="dk1"/>
                </a:solidFill>
                <a:latin typeface="Calibri"/>
                <a:ea typeface="Calibri"/>
                <a:cs typeface="Calibri"/>
                <a:sym typeface="Calibri"/>
              </a:rPr>
              <a:t>Only genes with p-value &lt; 0.05 are displayed.</a:t>
            </a:r>
            <a:endParaRPr sz="1200" b="0" i="0" u="none" strike="noStrike" cap="none" dirty="0">
              <a:solidFill>
                <a:schemeClr val="dk1"/>
              </a:solidFill>
              <a:latin typeface="Calibri"/>
              <a:ea typeface="Calibri"/>
              <a:cs typeface="Calibri"/>
              <a:sym typeface="Calibri"/>
            </a:endParaRPr>
          </a:p>
        </p:txBody>
      </p:sp>
      <p:sp>
        <p:nvSpPr>
          <p:cNvPr id="554" name="Google Shape;554;p9"/>
          <p:cNvSpPr txBox="1"/>
          <p:nvPr/>
        </p:nvSpPr>
        <p:spPr>
          <a:xfrm>
            <a:off x="336529" y="347028"/>
            <a:ext cx="739305" cy="27007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155"/>
              <a:buFont typeface="Times New Roman"/>
              <a:buNone/>
            </a:pPr>
            <a:r>
              <a:rPr lang="en-US" sz="1155" b="1" i="0" u="none" strike="noStrike" cap="none">
                <a:solidFill>
                  <a:schemeClr val="dk1"/>
                </a:solidFill>
                <a:latin typeface="Times New Roman"/>
                <a:ea typeface="Times New Roman"/>
                <a:cs typeface="Times New Roman"/>
                <a:sym typeface="Times New Roman"/>
              </a:rPr>
              <a:t>Table S1</a:t>
            </a:r>
            <a:endParaRPr sz="1114" b="0" i="0" u="none" strike="noStrike" cap="none">
              <a:solidFill>
                <a:schemeClr val="dk1"/>
              </a:solidFill>
              <a:latin typeface="Times New Roman"/>
              <a:ea typeface="Times New Roman"/>
              <a:cs typeface="Times New Roman"/>
              <a:sym typeface="Times New Roman"/>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559"/>
        <p:cNvGrpSpPr/>
        <p:nvPr/>
      </p:nvGrpSpPr>
      <p:grpSpPr>
        <a:xfrm>
          <a:off x="0" y="0"/>
          <a:ext cx="0" cy="0"/>
          <a:chOff x="0" y="0"/>
          <a:chExt cx="0" cy="0"/>
        </a:xfrm>
      </p:grpSpPr>
      <p:sp>
        <p:nvSpPr>
          <p:cNvPr id="560" name="Google Shape;560;p14"/>
          <p:cNvSpPr txBox="1"/>
          <p:nvPr/>
        </p:nvSpPr>
        <p:spPr>
          <a:xfrm>
            <a:off x="336529" y="347028"/>
            <a:ext cx="739305" cy="270074"/>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155"/>
              <a:buFont typeface="Times New Roman"/>
              <a:buNone/>
            </a:pPr>
            <a:r>
              <a:rPr lang="en-US" sz="1155" b="1" i="0" u="none" strike="noStrike" cap="none">
                <a:solidFill>
                  <a:schemeClr val="dk1"/>
                </a:solidFill>
                <a:latin typeface="Times New Roman"/>
                <a:ea typeface="Times New Roman"/>
                <a:cs typeface="Times New Roman"/>
                <a:sym typeface="Times New Roman"/>
              </a:rPr>
              <a:t>Table S2</a:t>
            </a:r>
            <a:endParaRPr sz="1114" b="0" i="0" u="none" strike="noStrike" cap="none">
              <a:solidFill>
                <a:schemeClr val="dk1"/>
              </a:solidFill>
              <a:latin typeface="Times New Roman"/>
              <a:ea typeface="Times New Roman"/>
              <a:cs typeface="Times New Roman"/>
              <a:sym typeface="Times New Roman"/>
            </a:endParaRPr>
          </a:p>
        </p:txBody>
      </p:sp>
      <p:sp>
        <p:nvSpPr>
          <p:cNvPr id="561" name="Google Shape;561;p14"/>
          <p:cNvSpPr txBox="1"/>
          <p:nvPr/>
        </p:nvSpPr>
        <p:spPr>
          <a:xfrm>
            <a:off x="895513" y="8535837"/>
            <a:ext cx="6264218" cy="646290"/>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chemeClr val="dk1"/>
              </a:buClr>
              <a:buSzPts val="1200"/>
              <a:buFont typeface="Calibri"/>
              <a:buNone/>
            </a:pPr>
            <a:r>
              <a:rPr lang="en-US" sz="1200" b="1" i="0" u="none" strike="noStrike" cap="none">
                <a:solidFill>
                  <a:schemeClr val="dk1"/>
                </a:solidFill>
                <a:latin typeface="Calibri"/>
                <a:ea typeface="Calibri"/>
                <a:cs typeface="Calibri"/>
                <a:sym typeface="Calibri"/>
              </a:rPr>
              <a:t>Table S2.</a:t>
            </a:r>
            <a:r>
              <a:rPr lang="en-US" sz="1200" b="0" i="0" u="none" strike="noStrike" cap="none">
                <a:solidFill>
                  <a:schemeClr val="dk1"/>
                </a:solidFill>
                <a:latin typeface="Calibri"/>
                <a:ea typeface="Calibri"/>
                <a:cs typeface="Calibri"/>
                <a:sym typeface="Calibri"/>
              </a:rPr>
              <a:t> </a:t>
            </a:r>
            <a:r>
              <a:rPr lang="en-US" sz="1200" b="1" i="0" u="none" strike="noStrike" cap="none">
                <a:solidFill>
                  <a:schemeClr val="dk1"/>
                </a:solidFill>
                <a:latin typeface="Calibri"/>
                <a:ea typeface="Calibri"/>
                <a:cs typeface="Calibri"/>
                <a:sym typeface="Calibri"/>
              </a:rPr>
              <a:t>The functional categories of 27 proteins increased and 21 proteins decreased by at least 3-fold in </a:t>
            </a:r>
            <a:r>
              <a:rPr lang="en-US" sz="1200" b="1" i="1" u="none" strike="noStrike" cap="none">
                <a:solidFill>
                  <a:schemeClr val="dk1"/>
                </a:solidFill>
                <a:latin typeface="Calibri"/>
                <a:ea typeface="Calibri"/>
                <a:cs typeface="Calibri"/>
                <a:sym typeface="Calibri"/>
              </a:rPr>
              <a:t>rmt2 </a:t>
            </a:r>
            <a:r>
              <a:rPr lang="en-US" sz="1200" b="1" i="0" u="none" strike="noStrike" cap="none">
                <a:solidFill>
                  <a:schemeClr val="dk1"/>
                </a:solidFill>
                <a:latin typeface="Calibri"/>
                <a:ea typeface="Calibri"/>
                <a:cs typeface="Calibri"/>
                <a:sym typeface="Calibri"/>
              </a:rPr>
              <a:t>cells relative to WT.</a:t>
            </a:r>
            <a:r>
              <a:rPr lang="en-US" sz="1200" b="0" i="0" u="none" strike="noStrike" cap="none">
                <a:solidFill>
                  <a:schemeClr val="dk1"/>
                </a:solidFill>
                <a:latin typeface="Calibri"/>
                <a:ea typeface="Calibri"/>
                <a:cs typeface="Calibri"/>
                <a:sym typeface="Calibri"/>
              </a:rPr>
              <a:t> The Cre number (Chlamydomonas gene accession number) for each protein and the fold change is shown. The fold change is given as Log2 values.</a:t>
            </a:r>
            <a:endParaRPr sz="1200" b="0" i="0" u="none" strike="noStrike" cap="none">
              <a:solidFill>
                <a:schemeClr val="dk1"/>
              </a:solidFill>
              <a:latin typeface="Calibri"/>
              <a:ea typeface="Calibri"/>
              <a:cs typeface="Calibri"/>
              <a:sym typeface="Calibri"/>
            </a:endParaRPr>
          </a:p>
        </p:txBody>
      </p:sp>
      <p:graphicFrame>
        <p:nvGraphicFramePr>
          <p:cNvPr id="562" name="Google Shape;562;p14"/>
          <p:cNvGraphicFramePr/>
          <p:nvPr>
            <p:extLst>
              <p:ext uri="{D42A27DB-BD31-4B8C-83A1-F6EECF244321}">
                <p14:modId xmlns:p14="http://schemas.microsoft.com/office/powerpoint/2010/main" val="2379687117"/>
              </p:ext>
            </p:extLst>
          </p:nvPr>
        </p:nvGraphicFramePr>
        <p:xfrm>
          <a:off x="534988" y="1112931"/>
          <a:ext cx="6702375" cy="6319750"/>
        </p:xfrm>
        <a:graphic>
          <a:graphicData uri="http://schemas.openxmlformats.org/drawingml/2006/table">
            <a:tbl>
              <a:tblPr>
                <a:noFill/>
                <a:tableStyleId>{EF749503-7E41-47C8-9E7A-A9317FD33F2B}</a:tableStyleId>
              </a:tblPr>
              <a:tblGrid>
                <a:gridCol w="212325">
                  <a:extLst>
                    <a:ext uri="{9D8B030D-6E8A-4147-A177-3AD203B41FA5}">
                      <a16:colId xmlns:a16="http://schemas.microsoft.com/office/drawing/2014/main" val="20000"/>
                    </a:ext>
                  </a:extLst>
                </a:gridCol>
                <a:gridCol w="990025">
                  <a:extLst>
                    <a:ext uri="{9D8B030D-6E8A-4147-A177-3AD203B41FA5}">
                      <a16:colId xmlns:a16="http://schemas.microsoft.com/office/drawing/2014/main" val="20001"/>
                    </a:ext>
                  </a:extLst>
                </a:gridCol>
                <a:gridCol w="807725">
                  <a:extLst>
                    <a:ext uri="{9D8B030D-6E8A-4147-A177-3AD203B41FA5}">
                      <a16:colId xmlns:a16="http://schemas.microsoft.com/office/drawing/2014/main" val="20002"/>
                    </a:ext>
                  </a:extLst>
                </a:gridCol>
                <a:gridCol w="106675">
                  <a:extLst>
                    <a:ext uri="{9D8B030D-6E8A-4147-A177-3AD203B41FA5}">
                      <a16:colId xmlns:a16="http://schemas.microsoft.com/office/drawing/2014/main" val="20003"/>
                    </a:ext>
                  </a:extLst>
                </a:gridCol>
                <a:gridCol w="1142125">
                  <a:extLst>
                    <a:ext uri="{9D8B030D-6E8A-4147-A177-3AD203B41FA5}">
                      <a16:colId xmlns:a16="http://schemas.microsoft.com/office/drawing/2014/main" val="20004"/>
                    </a:ext>
                  </a:extLst>
                </a:gridCol>
                <a:gridCol w="212325">
                  <a:extLst>
                    <a:ext uri="{9D8B030D-6E8A-4147-A177-3AD203B41FA5}">
                      <a16:colId xmlns:a16="http://schemas.microsoft.com/office/drawing/2014/main" val="20005"/>
                    </a:ext>
                  </a:extLst>
                </a:gridCol>
                <a:gridCol w="962025">
                  <a:extLst>
                    <a:ext uri="{9D8B030D-6E8A-4147-A177-3AD203B41FA5}">
                      <a16:colId xmlns:a16="http://schemas.microsoft.com/office/drawing/2014/main" val="20006"/>
                    </a:ext>
                  </a:extLst>
                </a:gridCol>
                <a:gridCol w="822950">
                  <a:extLst>
                    <a:ext uri="{9D8B030D-6E8A-4147-A177-3AD203B41FA5}">
                      <a16:colId xmlns:a16="http://schemas.microsoft.com/office/drawing/2014/main" val="20007"/>
                    </a:ext>
                  </a:extLst>
                </a:gridCol>
                <a:gridCol w="106675">
                  <a:extLst>
                    <a:ext uri="{9D8B030D-6E8A-4147-A177-3AD203B41FA5}">
                      <a16:colId xmlns:a16="http://schemas.microsoft.com/office/drawing/2014/main" val="20008"/>
                    </a:ext>
                  </a:extLst>
                </a:gridCol>
                <a:gridCol w="1339525">
                  <a:extLst>
                    <a:ext uri="{9D8B030D-6E8A-4147-A177-3AD203B41FA5}">
                      <a16:colId xmlns:a16="http://schemas.microsoft.com/office/drawing/2014/main" val="20009"/>
                    </a:ext>
                  </a:extLst>
                </a:gridCol>
              </a:tblGrid>
              <a:tr h="197500">
                <a:tc gridSpan="10">
                  <a:txBody>
                    <a:bodyPr/>
                    <a:lstStyle/>
                    <a:p>
                      <a:pPr marL="0" marR="0" lvl="0" indent="0" algn="l" rtl="0">
                        <a:lnSpc>
                          <a:spcPct val="100000"/>
                        </a:lnSpc>
                        <a:spcBef>
                          <a:spcPts val="0"/>
                        </a:spcBef>
                        <a:spcAft>
                          <a:spcPts val="0"/>
                        </a:spcAft>
                        <a:buClr>
                          <a:srgbClr val="000000"/>
                        </a:buClr>
                        <a:buSzPts val="1600"/>
                        <a:buFont typeface="Times New Roman"/>
                        <a:buNone/>
                      </a:pPr>
                      <a:r>
                        <a:rPr lang="en-US" sz="1600" b="1" i="0" u="none" strike="noStrike" cap="none">
                          <a:solidFill>
                            <a:srgbClr val="000000"/>
                          </a:solidFill>
                          <a:latin typeface="Times New Roman"/>
                          <a:ea typeface="Times New Roman"/>
                          <a:cs typeface="Times New Roman"/>
                          <a:sym typeface="Times New Roman"/>
                        </a:rPr>
                        <a:t>[Increased Proteins]</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00"/>
                  </a:ext>
                </a:extLst>
              </a:tr>
              <a:tr h="197500">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Cre Number</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Fold Change</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B w="9525" cap="flat" cmpd="sng">
                      <a:solidFill>
                        <a:srgbClr val="000000"/>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Protein Name</a:t>
                      </a:r>
                      <a:endParaRPr sz="1200" b="1" i="0" u="none" strike="noStrike" cap="none">
                        <a:solidFill>
                          <a:srgbClr val="000000"/>
                        </a:solidFill>
                        <a:latin typeface="Times New Roman"/>
                        <a:ea typeface="Times New Roman"/>
                        <a:cs typeface="Times New Roman"/>
                        <a:sym typeface="Times New Roman"/>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Cre Number</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Fold Change</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B w="9525" cap="flat" cmpd="sng">
                      <a:solidFill>
                        <a:srgbClr val="000000"/>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Protein Name</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01"/>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4.g6174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4.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HSP22F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6</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4.g2141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THI4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2"/>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1.g4680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3.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u="none" strike="noStrike" cap="none">
                          <a:latin typeface="Times New Roman"/>
                          <a:ea typeface="Times New Roman"/>
                          <a:cs typeface="Times New Roman"/>
                          <a:sym typeface="Times New Roman"/>
                        </a:rPr>
                        <a:t>VIPP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7</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7.g7268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3"/>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3</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9.g4080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3.4</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u="none" strike="noStrike" cap="none">
                          <a:latin typeface="Times New Roman"/>
                          <a:ea typeface="Times New Roman"/>
                          <a:cs typeface="Times New Roman"/>
                          <a:sym typeface="Times New Roman"/>
                        </a:rPr>
                        <a:t>POB2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8</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0.g4508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4"/>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4</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1.g0530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3.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GPD2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9</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5.g2394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5"/>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5</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2.g4985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6</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DEG11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0</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3.g14468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6"/>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6</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2.g5372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6</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1</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5.g2370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GLD27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7"/>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2.g0952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5</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2</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1.g467753</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9</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HMO2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8"/>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8</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1.g053288</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5</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3</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5.g64010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8</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09"/>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9</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2.g5446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4</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4</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9.g394065</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u="none" strike="noStrike" cap="none">
                          <a:latin typeface="Times New Roman"/>
                          <a:ea typeface="Times New Roman"/>
                          <a:cs typeface="Times New Roman"/>
                          <a:sym typeface="Times New Roman"/>
                        </a:rPr>
                        <a:t>FAP414</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10"/>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6.g2870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4</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5</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6.g27815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11"/>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2.g1186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3</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FTSZ1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6</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0.g4450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SLT3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12"/>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0.g4478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7</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7.g3331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6</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13"/>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3</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6.g6766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 </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chemeClr val="dk1"/>
                        </a:buClr>
                        <a:buSzPts val="1100"/>
                        <a:buFont typeface="Times New Roman"/>
                        <a:buNone/>
                      </a:pPr>
                      <a:endParaRPr sz="1100" b="0" i="0" u="none" strike="noStrike" cap="none">
                        <a:solidFill>
                          <a:srgbClr val="000000"/>
                        </a:solidFill>
                        <a:latin typeface="Times New Roman"/>
                        <a:ea typeface="Times New Roman"/>
                        <a:cs typeface="Times New Roman"/>
                        <a:sym typeface="Times New Roman"/>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chemeClr val="dk1"/>
                        </a:buClr>
                        <a:buSzPts val="1100"/>
                        <a:buFont typeface="Times New Roman"/>
                        <a:buNone/>
                      </a:pPr>
                      <a:endParaRPr sz="1100" b="0" i="0" u="none" strike="noStrike" cap="none">
                        <a:solidFill>
                          <a:srgbClr val="000000"/>
                        </a:solidFill>
                        <a:latin typeface="Times New Roman"/>
                        <a:ea typeface="Times New Roman"/>
                        <a:cs typeface="Times New Roman"/>
                        <a:sym typeface="Times New Roman"/>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chemeClr val="dk1"/>
                        </a:buClr>
                        <a:buSzPts val="1100"/>
                        <a:buFont typeface="Times New Roman"/>
                        <a:buNone/>
                      </a:pPr>
                      <a:endParaRPr sz="1100" b="0" i="0" u="none" strike="noStrike" cap="none">
                        <a:solidFill>
                          <a:srgbClr val="000000"/>
                        </a:solidFill>
                        <a:latin typeface="Times New Roman"/>
                        <a:ea typeface="Times New Roman"/>
                        <a:cs typeface="Times New Roman"/>
                        <a:sym typeface="Times New Roman"/>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14"/>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4</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7.g7257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 </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chemeClr val="dk1"/>
                        </a:buClr>
                        <a:buSzPts val="1100"/>
                        <a:buFont typeface="Times New Roman"/>
                        <a:buNone/>
                      </a:pPr>
                      <a:endParaRPr sz="1100" b="0" i="0" u="none" strike="noStrike" cap="none">
                        <a:solidFill>
                          <a:srgbClr val="000000"/>
                        </a:solidFill>
                        <a:latin typeface="Times New Roman"/>
                        <a:ea typeface="Times New Roman"/>
                        <a:cs typeface="Times New Roman"/>
                        <a:sym typeface="Times New Roman"/>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chemeClr val="dk1"/>
                        </a:buClr>
                        <a:buSzPts val="1100"/>
                        <a:buFont typeface="Times New Roman"/>
                        <a:buNone/>
                      </a:pPr>
                      <a:endParaRPr sz="1100" b="0" i="0" u="none" strike="noStrike" cap="none">
                        <a:solidFill>
                          <a:srgbClr val="000000"/>
                        </a:solidFill>
                        <a:latin typeface="Times New Roman"/>
                        <a:ea typeface="Times New Roman"/>
                        <a:cs typeface="Times New Roman"/>
                        <a:sym typeface="Times New Roman"/>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chemeClr val="dk1"/>
                        </a:buClr>
                        <a:buSzPts val="1100"/>
                        <a:buFont typeface="Times New Roman"/>
                        <a:buNone/>
                      </a:pPr>
                      <a:endParaRPr sz="1100" b="0" i="0" u="none" strike="noStrike" cap="none">
                        <a:solidFill>
                          <a:srgbClr val="000000"/>
                        </a:solidFill>
                        <a:latin typeface="Times New Roman"/>
                        <a:ea typeface="Times New Roman"/>
                        <a:cs typeface="Times New Roman"/>
                        <a:sym typeface="Times New Roman"/>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15"/>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5</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6.g3064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 </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6"/>
                  </a:ext>
                </a:extLst>
              </a:tr>
              <a:tr h="234525">
                <a:tc>
                  <a:txBody>
                    <a:bodyPr/>
                    <a:lstStyle/>
                    <a:p>
                      <a:pPr marL="0" marR="0" lvl="0" indent="0" algn="l" rtl="0">
                        <a:lnSpc>
                          <a:spcPct val="100000"/>
                        </a:lnSpc>
                        <a:spcBef>
                          <a:spcPts val="0"/>
                        </a:spcBef>
                        <a:spcAft>
                          <a:spcPts val="0"/>
                        </a:spcAft>
                        <a:buClr>
                          <a:schemeClr val="dk1"/>
                        </a:buClr>
                        <a:buSzPts val="1600"/>
                        <a:buFont typeface="Times New Roman"/>
                        <a:buNone/>
                      </a:pPr>
                      <a:endParaRPr sz="1600" b="0" i="0" u="none" strike="noStrike" cap="none">
                        <a:solidFill>
                          <a:srgbClr val="000000"/>
                        </a:solidFill>
                        <a:latin typeface="Calibri"/>
                        <a:ea typeface="Calibri"/>
                        <a:cs typeface="Calibri"/>
                        <a:sym typeface="Calibri"/>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chemeClr val="dk1"/>
                        </a:buClr>
                        <a:buSzPts val="1600"/>
                        <a:buFont typeface="Times New Roman"/>
                        <a:buNone/>
                      </a:pPr>
                      <a:endParaRPr sz="1600" b="0" i="0" u="none" strike="noStrike" cap="none">
                        <a:solidFill>
                          <a:srgbClr val="000000"/>
                        </a:solidFill>
                        <a:latin typeface="Calibri"/>
                        <a:ea typeface="Calibri"/>
                        <a:cs typeface="Calibri"/>
                        <a:sym typeface="Calibri"/>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l" rtl="0">
                        <a:lnSpc>
                          <a:spcPct val="100000"/>
                        </a:lnSpc>
                        <a:spcBef>
                          <a:spcPts val="0"/>
                        </a:spcBef>
                        <a:spcAft>
                          <a:spcPts val="0"/>
                        </a:spcAft>
                        <a:buClr>
                          <a:schemeClr val="dk1"/>
                        </a:buClr>
                        <a:buSzPts val="1600"/>
                        <a:buFont typeface="Times New Roman"/>
                        <a:buNone/>
                      </a:pPr>
                      <a:endParaRPr sz="1600" b="0" i="0" u="none" strike="noStrike" cap="none">
                        <a:solidFill>
                          <a:srgbClr val="000000"/>
                        </a:solidFill>
                        <a:latin typeface="Calibri"/>
                        <a:ea typeface="Calibri"/>
                        <a:cs typeface="Calibri"/>
                        <a:sym typeface="Calibri"/>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l" rtl="0">
                        <a:lnSpc>
                          <a:spcPct val="100000"/>
                        </a:lnSpc>
                        <a:spcBef>
                          <a:spcPts val="0"/>
                        </a:spcBef>
                        <a:spcAft>
                          <a:spcPts val="0"/>
                        </a:spcAft>
                        <a:buClr>
                          <a:schemeClr val="dk1"/>
                        </a:buClr>
                        <a:buSzPts val="1600"/>
                        <a:buFont typeface="Times New Roman"/>
                        <a:buNone/>
                      </a:pPr>
                      <a:endParaRPr sz="1600" b="0" i="0" u="none" strike="noStrike" cap="none">
                        <a:solidFill>
                          <a:srgbClr val="000000"/>
                        </a:solidFill>
                        <a:latin typeface="Calibri"/>
                        <a:ea typeface="Calibri"/>
                        <a:cs typeface="Calibri"/>
                        <a:sym typeface="Calibri"/>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chemeClr val="dk1"/>
                        </a:buClr>
                        <a:buSzPts val="1800"/>
                        <a:buFont typeface="Times New Roman"/>
                        <a:buNone/>
                      </a:pPr>
                      <a:endParaRPr sz="1800" b="1" i="0" u="none" strike="noStrike" cap="none">
                        <a:solidFill>
                          <a:srgbClr val="000000"/>
                        </a:solidFill>
                        <a:latin typeface="Calibri"/>
                        <a:ea typeface="Calibri"/>
                        <a:cs typeface="Calibri"/>
                        <a:sym typeface="Calibri"/>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l" rtl="0">
                        <a:lnSpc>
                          <a:spcPct val="100000"/>
                        </a:lnSpc>
                        <a:spcBef>
                          <a:spcPts val="0"/>
                        </a:spcBef>
                        <a:spcAft>
                          <a:spcPts val="0"/>
                        </a:spcAft>
                        <a:buClr>
                          <a:schemeClr val="dk1"/>
                        </a:buClr>
                        <a:buSzPts val="1600"/>
                        <a:buFont typeface="Times New Roman"/>
                        <a:buNone/>
                      </a:pPr>
                      <a:endParaRPr sz="1600" b="0" i="0" u="none" strike="noStrike" cap="none">
                        <a:solidFill>
                          <a:srgbClr val="000000"/>
                        </a:solidFill>
                        <a:latin typeface="Calibri"/>
                        <a:ea typeface="Calibri"/>
                        <a:cs typeface="Calibri"/>
                        <a:sym typeface="Calibri"/>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l" rtl="0">
                        <a:lnSpc>
                          <a:spcPct val="100000"/>
                        </a:lnSpc>
                        <a:spcBef>
                          <a:spcPts val="0"/>
                        </a:spcBef>
                        <a:spcAft>
                          <a:spcPts val="0"/>
                        </a:spcAft>
                        <a:buClr>
                          <a:schemeClr val="dk1"/>
                        </a:buClr>
                        <a:buSzPts val="1600"/>
                        <a:buFont typeface="Times New Roman"/>
                        <a:buNone/>
                      </a:pPr>
                      <a:endParaRPr sz="1600" b="0" i="0" u="none" strike="noStrike" cap="none">
                        <a:solidFill>
                          <a:srgbClr val="000000"/>
                        </a:solidFill>
                        <a:latin typeface="Calibri"/>
                        <a:ea typeface="Calibri"/>
                        <a:cs typeface="Calibri"/>
                        <a:sym typeface="Calibri"/>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l" rtl="0">
                        <a:lnSpc>
                          <a:spcPct val="100000"/>
                        </a:lnSpc>
                        <a:spcBef>
                          <a:spcPts val="0"/>
                        </a:spcBef>
                        <a:spcAft>
                          <a:spcPts val="0"/>
                        </a:spcAft>
                        <a:buClr>
                          <a:schemeClr val="dk1"/>
                        </a:buClr>
                        <a:buSzPts val="1600"/>
                        <a:buFont typeface="Times New Roman"/>
                        <a:buNone/>
                      </a:pPr>
                      <a:endParaRPr sz="1600" b="0" i="0" u="none" strike="noStrike" cap="none">
                        <a:solidFill>
                          <a:srgbClr val="000000"/>
                        </a:solidFill>
                        <a:latin typeface="Calibri"/>
                        <a:ea typeface="Calibri"/>
                        <a:cs typeface="Calibri"/>
                        <a:sym typeface="Calibri"/>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extLst>
                  <a:ext uri="{0D108BD9-81ED-4DB2-BD59-A6C34878D82A}">
                    <a16:rowId xmlns:a16="http://schemas.microsoft.com/office/drawing/2014/main" val="10017"/>
                  </a:ext>
                </a:extLst>
              </a:tr>
              <a:tr h="197500">
                <a:tc gridSpan="10">
                  <a:txBody>
                    <a:bodyPr/>
                    <a:lstStyle/>
                    <a:p>
                      <a:pPr marL="0" marR="0" lvl="0" indent="0" algn="l" rtl="0">
                        <a:lnSpc>
                          <a:spcPct val="100000"/>
                        </a:lnSpc>
                        <a:spcBef>
                          <a:spcPts val="0"/>
                        </a:spcBef>
                        <a:spcAft>
                          <a:spcPts val="0"/>
                        </a:spcAft>
                        <a:buClr>
                          <a:srgbClr val="000000"/>
                        </a:buClr>
                        <a:buSzPts val="1600"/>
                        <a:buFont typeface="Times New Roman"/>
                        <a:buNone/>
                      </a:pPr>
                      <a:r>
                        <a:rPr lang="en-US" sz="1600" b="1" i="0" u="none" strike="noStrike" cap="none">
                          <a:solidFill>
                            <a:srgbClr val="000000"/>
                          </a:solidFill>
                          <a:latin typeface="Times New Roman"/>
                          <a:ea typeface="Times New Roman"/>
                          <a:cs typeface="Times New Roman"/>
                          <a:sym typeface="Times New Roman"/>
                        </a:rPr>
                        <a:t>[Decreased Proteins]</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tc hMerge="1">
                  <a:txBody>
                    <a:bodyPr/>
                    <a:lstStyle/>
                    <a:p>
                      <a:endParaRPr lang="en-US"/>
                    </a:p>
                  </a:txBody>
                  <a:tcPr/>
                </a:tc>
                <a:extLst>
                  <a:ext uri="{0D108BD9-81ED-4DB2-BD59-A6C34878D82A}">
                    <a16:rowId xmlns:a16="http://schemas.microsoft.com/office/drawing/2014/main" val="10018"/>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1"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Cre Number</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Fold Change</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B w="9525" cap="flat" cmpd="sng">
                      <a:solidFill>
                        <a:srgbClr val="000000"/>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Protein Name</a:t>
                      </a:r>
                      <a:endParaRPr sz="1200" b="1" i="0" u="none" strike="noStrike" cap="none">
                        <a:solidFill>
                          <a:srgbClr val="000000"/>
                        </a:solidFill>
                        <a:latin typeface="Times New Roman"/>
                        <a:ea typeface="Times New Roman"/>
                        <a:cs typeface="Times New Roman"/>
                        <a:sym typeface="Times New Roman"/>
                      </a:endParaRPr>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Cre Number</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Fold Change</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B w="9525" cap="flat" cmpd="sng">
                      <a:solidFill>
                        <a:srgbClr val="000000"/>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200"/>
                        <a:buFont typeface="Times New Roman"/>
                        <a:buNone/>
                      </a:pPr>
                      <a:r>
                        <a:rPr lang="en-US" sz="1200" b="1" i="0" u="none" strike="noStrike" cap="none">
                          <a:solidFill>
                            <a:srgbClr val="000000"/>
                          </a:solidFill>
                          <a:latin typeface="Times New Roman"/>
                          <a:ea typeface="Times New Roman"/>
                          <a:cs typeface="Times New Roman"/>
                          <a:sym typeface="Times New Roman"/>
                        </a:rPr>
                        <a:t>Protein Name</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solidFill>
                      <a:prstDash val="solid"/>
                      <a:round/>
                      <a:headEnd type="none" w="sm" len="sm"/>
                      <a:tailEnd type="none" w="sm" len="sm"/>
                    </a:lnB>
                  </a:tcPr>
                </a:tc>
                <a:extLst>
                  <a:ext uri="{0D108BD9-81ED-4DB2-BD59-A6C34878D82A}">
                    <a16:rowId xmlns:a16="http://schemas.microsoft.com/office/drawing/2014/main" val="10019"/>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re04.g223100</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3.4</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AH1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2</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3.g5842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5</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0"/>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hreCp067</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3.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C</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3</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9.g4086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5</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1"/>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3</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0.g46337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3.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4</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2.g09508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5</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2"/>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4</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re05.g238332</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3.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D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5</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3.g1952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4</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u="none" strike="noStrike" cap="none">
                          <a:latin typeface="Times New Roman"/>
                          <a:ea typeface="Times New Roman"/>
                          <a:cs typeface="Times New Roman"/>
                          <a:sym typeface="Times New Roman"/>
                        </a:rPr>
                        <a:t>CGL76</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3"/>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5</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re07.g330250</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9</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H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6</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7.g3492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3</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4"/>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6</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hreCp019</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8</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A</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7</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0.g4203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3</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E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5"/>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re09.g412100</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8</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F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8</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6.g2614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u="none" strike="noStrike" cap="none">
                          <a:latin typeface="Times New Roman"/>
                          <a:ea typeface="Times New Roman"/>
                          <a:cs typeface="Times New Roman"/>
                          <a:sym typeface="Times New Roman"/>
                        </a:rPr>
                        <a:t>DTH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6"/>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8</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re02.g082500</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N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9</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3.g59050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u="none" strike="noStrike" cap="none">
                          <a:latin typeface="Times New Roman"/>
                          <a:ea typeface="Times New Roman"/>
                          <a:cs typeface="Times New Roman"/>
                          <a:sym typeface="Times New Roman"/>
                        </a:rPr>
                        <a:t>FAD6</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7"/>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9</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hreCp048</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B</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0</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01.g0301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2</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8"/>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re17.g724300</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6</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K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1</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Cre16.g663450</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7</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u="none" strike="noStrike" cap="none">
                          <a:latin typeface="Times New Roman"/>
                          <a:ea typeface="Times New Roman"/>
                          <a:cs typeface="Times New Roman"/>
                          <a:sym typeface="Times New Roman"/>
                        </a:rPr>
                        <a:t>BST3</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alpha val="0"/>
                        </a:srgbClr>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29"/>
                  </a:ext>
                </a:extLst>
              </a:tr>
              <a:tr h="197500">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11</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just"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Cre12.g486300</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2.6</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PSAL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 </a:t>
                      </a:r>
                      <a:endParaRPr sz="1530" u="none" strike="noStrike" cap="none"/>
                    </a:p>
                  </a:txBody>
                  <a:tcPr marL="9250" marR="9250" marT="9250" marB="0" anchor="b">
                    <a:lnL w="9525" cap="flat" cmpd="sng">
                      <a:solidFill>
                        <a:srgbClr val="000000"/>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a:solidFill>
                            <a:srgbClr val="000000"/>
                          </a:solidFill>
                          <a:latin typeface="Times New Roman"/>
                          <a:ea typeface="Times New Roman"/>
                          <a:cs typeface="Times New Roman"/>
                          <a:sym typeface="Times New Roman"/>
                        </a:rPr>
                        <a:t> </a:t>
                      </a:r>
                      <a:endParaRPr sz="1530" u="none" strike="noStrike" cap="none"/>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gridSpan="2">
                  <a:txBody>
                    <a:bodyPr/>
                    <a:lstStyle/>
                    <a:p>
                      <a:pPr marL="0" marR="0" lvl="0" indent="0" algn="ctr" rtl="0">
                        <a:lnSpc>
                          <a:spcPct val="100000"/>
                        </a:lnSpc>
                        <a:spcBef>
                          <a:spcPts val="0"/>
                        </a:spcBef>
                        <a:spcAft>
                          <a:spcPts val="0"/>
                        </a:spcAft>
                        <a:buClr>
                          <a:srgbClr val="000000"/>
                        </a:buClr>
                        <a:buSzPts val="1100"/>
                        <a:buFont typeface="Times New Roman"/>
                        <a:buNone/>
                      </a:pPr>
                      <a:r>
                        <a:rPr lang="en-US" sz="1100" b="0" i="0" u="none" strike="noStrike" cap="none" dirty="0">
                          <a:solidFill>
                            <a:srgbClr val="000000"/>
                          </a:solidFill>
                          <a:latin typeface="Times New Roman"/>
                          <a:ea typeface="Times New Roman"/>
                          <a:cs typeface="Times New Roman"/>
                          <a:sym typeface="Times New Roman"/>
                        </a:rPr>
                        <a:t> </a:t>
                      </a:r>
                      <a:endParaRPr sz="1530" u="none" strike="noStrike" cap="none" dirty="0"/>
                    </a:p>
                  </a:txBody>
                  <a:tcPr marL="9250" marR="9250" marT="9250" marB="0" anchor="b">
                    <a:lnL w="9525" cap="flat" cmpd="sng">
                      <a:solidFill>
                        <a:srgbClr val="000000">
                          <a:alpha val="0"/>
                        </a:srgbClr>
                      </a:solidFill>
                      <a:prstDash val="solid"/>
                      <a:round/>
                      <a:headEnd type="none" w="sm" len="sm"/>
                      <a:tailEnd type="none" w="sm" len="sm"/>
                    </a:lnL>
                    <a:lnR w="9525" cap="flat" cmpd="sng">
                      <a:solidFill>
                        <a:srgbClr val="000000">
                          <a:alpha val="0"/>
                        </a:srgbClr>
                      </a:solidFill>
                      <a:prstDash val="solid"/>
                      <a:round/>
                      <a:headEnd type="none" w="sm" len="sm"/>
                      <a:tailEnd type="none" w="sm" len="sm"/>
                    </a:lnR>
                    <a:lnT w="9525" cap="flat" cmpd="sng">
                      <a:solidFill>
                        <a:srgbClr val="000000">
                          <a:alpha val="0"/>
                        </a:srgbClr>
                      </a:solidFill>
                      <a:prstDash val="solid"/>
                      <a:round/>
                      <a:headEnd type="none" w="sm" len="sm"/>
                      <a:tailEnd type="none" w="sm" len="sm"/>
                    </a:lnT>
                    <a:lnB w="9525" cap="flat" cmpd="sng">
                      <a:solidFill>
                        <a:srgbClr val="000000"/>
                      </a:solidFill>
                      <a:prstDash val="solid"/>
                      <a:round/>
                      <a:headEnd type="none" w="sm" len="sm"/>
                      <a:tailEnd type="none" w="sm" len="sm"/>
                    </a:lnB>
                  </a:tcPr>
                </a:tc>
                <a:tc hMerge="1">
                  <a:txBody>
                    <a:bodyPr/>
                    <a:lstStyle/>
                    <a:p>
                      <a:endParaRPr lang="en-US"/>
                    </a:p>
                  </a:txBody>
                  <a:tcPr/>
                </a:tc>
                <a:extLst>
                  <a:ext uri="{0D108BD9-81ED-4DB2-BD59-A6C34878D82A}">
                    <a16:rowId xmlns:a16="http://schemas.microsoft.com/office/drawing/2014/main" val="10030"/>
                  </a:ext>
                </a:extLst>
              </a:tr>
            </a:tbl>
          </a:graphicData>
        </a:graphic>
      </p:graphicFrame>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567"/>
        <p:cNvGrpSpPr/>
        <p:nvPr/>
      </p:nvGrpSpPr>
      <p:grpSpPr>
        <a:xfrm>
          <a:off x="0" y="0"/>
          <a:ext cx="0" cy="0"/>
          <a:chOff x="0" y="0"/>
          <a:chExt cx="0" cy="0"/>
        </a:xfrm>
      </p:grpSpPr>
      <p:sp>
        <p:nvSpPr>
          <p:cNvPr id="568" name="Google Shape;568;g2a0e20f5a8b_0_0"/>
          <p:cNvSpPr txBox="1"/>
          <p:nvPr/>
        </p:nvSpPr>
        <p:spPr>
          <a:xfrm>
            <a:off x="895513" y="8535837"/>
            <a:ext cx="6264300" cy="830956"/>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chemeClr val="dk1"/>
              </a:buClr>
              <a:buSzPts val="1200"/>
              <a:buFont typeface="Calibri"/>
              <a:buNone/>
            </a:pPr>
            <a:r>
              <a:rPr lang="en-US" sz="1200" b="1" i="0" u="none" strike="noStrike" cap="none">
                <a:solidFill>
                  <a:schemeClr val="dk1"/>
                </a:solidFill>
                <a:latin typeface="Calibri"/>
                <a:ea typeface="Calibri"/>
                <a:cs typeface="Calibri"/>
                <a:sym typeface="Calibri"/>
              </a:rPr>
              <a:t>Table S3.</a:t>
            </a:r>
            <a:r>
              <a:rPr lang="en-US" sz="1200" b="0" i="0" u="none" strike="noStrike" cap="none">
                <a:solidFill>
                  <a:schemeClr val="dk1"/>
                </a:solidFill>
                <a:latin typeface="Calibri"/>
                <a:ea typeface="Calibri"/>
                <a:cs typeface="Calibri"/>
                <a:sym typeface="Calibri"/>
              </a:rPr>
              <a:t> </a:t>
            </a:r>
            <a:r>
              <a:rPr lang="en-US" sz="1200" b="1" i="0" u="none" strike="noStrike" cap="none">
                <a:solidFill>
                  <a:schemeClr val="dk1"/>
                </a:solidFill>
                <a:latin typeface="Calibri"/>
                <a:ea typeface="Calibri"/>
                <a:cs typeface="Calibri"/>
                <a:sym typeface="Calibri"/>
              </a:rPr>
              <a:t>List of proteins with detected methylation site in Chlamydomonas thylakoids.</a:t>
            </a:r>
            <a:r>
              <a:rPr lang="en-US" sz="1200" b="0" i="0" u="none" strike="noStrike" cap="none">
                <a:solidFill>
                  <a:schemeClr val="dk1"/>
                </a:solidFill>
                <a:latin typeface="Calibri"/>
                <a:ea typeface="Calibri"/>
                <a:cs typeface="Calibri"/>
                <a:sym typeface="Calibri"/>
              </a:rPr>
              <a:t> The Cre number (Chlamydomonas gene accession number) and alias for each protein is shown. For each protein, one or several methylated lysine residue is indicated, “tri” and “di” indicate trimethylated and dimethylated peptides.</a:t>
            </a:r>
            <a:endParaRPr sz="1200" b="0" i="0" u="none" strike="noStrike" cap="none">
              <a:solidFill>
                <a:schemeClr val="dk1"/>
              </a:solidFill>
              <a:latin typeface="Calibri"/>
              <a:ea typeface="Calibri"/>
              <a:cs typeface="Calibri"/>
              <a:sym typeface="Calibri"/>
            </a:endParaRPr>
          </a:p>
        </p:txBody>
      </p:sp>
      <p:sp>
        <p:nvSpPr>
          <p:cNvPr id="569" name="Google Shape;569;g2a0e20f5a8b_0_0"/>
          <p:cNvSpPr txBox="1"/>
          <p:nvPr/>
        </p:nvSpPr>
        <p:spPr>
          <a:xfrm>
            <a:off x="336529" y="347028"/>
            <a:ext cx="739200" cy="2700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chemeClr val="dk1"/>
              </a:buClr>
              <a:buSzPts val="1155"/>
              <a:buFont typeface="Times New Roman"/>
              <a:buNone/>
            </a:pPr>
            <a:r>
              <a:rPr lang="en-US" sz="1155" b="1" i="0" u="none" strike="noStrike" cap="none">
                <a:solidFill>
                  <a:schemeClr val="dk1"/>
                </a:solidFill>
                <a:latin typeface="Times New Roman"/>
                <a:ea typeface="Times New Roman"/>
                <a:cs typeface="Times New Roman"/>
                <a:sym typeface="Times New Roman"/>
              </a:rPr>
              <a:t>Table S3</a:t>
            </a:r>
            <a:endParaRPr sz="1114" b="0" i="0" u="none" strike="noStrike" cap="none">
              <a:solidFill>
                <a:schemeClr val="dk1"/>
              </a:solidFill>
              <a:latin typeface="Times New Roman"/>
              <a:ea typeface="Times New Roman"/>
              <a:cs typeface="Times New Roman"/>
              <a:sym typeface="Times New Roman"/>
            </a:endParaRPr>
          </a:p>
        </p:txBody>
      </p:sp>
      <p:graphicFrame>
        <p:nvGraphicFramePr>
          <p:cNvPr id="570" name="Google Shape;570;g2a0e20f5a8b_0_0"/>
          <p:cNvGraphicFramePr/>
          <p:nvPr/>
        </p:nvGraphicFramePr>
        <p:xfrm>
          <a:off x="1676475" y="2723675"/>
          <a:ext cx="5032575" cy="2440325"/>
        </p:xfrm>
        <a:graphic>
          <a:graphicData uri="http://schemas.openxmlformats.org/drawingml/2006/table">
            <a:tbl>
              <a:tblPr>
                <a:noFill/>
                <a:tableStyleId>{3F9B46F7-8DFB-436F-B93C-1C2E9E377E49}</a:tableStyleId>
              </a:tblPr>
              <a:tblGrid>
                <a:gridCol w="1758700">
                  <a:extLst>
                    <a:ext uri="{9D8B030D-6E8A-4147-A177-3AD203B41FA5}">
                      <a16:colId xmlns:a16="http://schemas.microsoft.com/office/drawing/2014/main" val="20000"/>
                    </a:ext>
                  </a:extLst>
                </a:gridCol>
                <a:gridCol w="1283425">
                  <a:extLst>
                    <a:ext uri="{9D8B030D-6E8A-4147-A177-3AD203B41FA5}">
                      <a16:colId xmlns:a16="http://schemas.microsoft.com/office/drawing/2014/main" val="20001"/>
                    </a:ext>
                  </a:extLst>
                </a:gridCol>
                <a:gridCol w="1990450">
                  <a:extLst>
                    <a:ext uri="{9D8B030D-6E8A-4147-A177-3AD203B41FA5}">
                      <a16:colId xmlns:a16="http://schemas.microsoft.com/office/drawing/2014/main" val="20002"/>
                    </a:ext>
                  </a:extLst>
                </a:gridCol>
              </a:tblGrid>
              <a:tr h="459275">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latin typeface="Times New Roman"/>
                          <a:ea typeface="Times New Roman"/>
                          <a:cs typeface="Times New Roman"/>
                          <a:sym typeface="Times New Roman"/>
                        </a:rPr>
                        <a:t>Accession Number</a:t>
                      </a:r>
                      <a:endParaRPr sz="1400" b="1"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latin typeface="Times New Roman"/>
                          <a:ea typeface="Times New Roman"/>
                          <a:cs typeface="Times New Roman"/>
                          <a:sym typeface="Times New Roman"/>
                        </a:rPr>
                        <a:t>Protein name</a:t>
                      </a:r>
                      <a:endParaRPr sz="1400" b="1"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b="1" u="none" strike="noStrike" cap="none">
                          <a:latin typeface="Times New Roman"/>
                          <a:ea typeface="Times New Roman"/>
                          <a:cs typeface="Times New Roman"/>
                          <a:sym typeface="Times New Roman"/>
                        </a:rPr>
                        <a:t>Methylation site</a:t>
                      </a:r>
                      <a:endParaRPr sz="1400" b="1" u="none" strike="noStrike" cap="none">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0"/>
                  </a:ext>
                </a:extLst>
              </a:tr>
              <a:tr h="381000">
                <a:tc>
                  <a:txBody>
                    <a:bodyPr/>
                    <a:lstStyle/>
                    <a:p>
                      <a:pPr marL="0" marR="0" lvl="0" indent="0" algn="l" rtl="0">
                        <a:lnSpc>
                          <a:spcPct val="100000"/>
                        </a:lnSpc>
                        <a:spcBef>
                          <a:spcPts val="0"/>
                        </a:spcBef>
                        <a:spcAft>
                          <a:spcPts val="0"/>
                        </a:spcAft>
                        <a:buClr>
                          <a:srgbClr val="000000"/>
                        </a:buClr>
                        <a:buSzPts val="1200"/>
                        <a:buFont typeface="Arial"/>
                        <a:buNone/>
                      </a:pPr>
                      <a:r>
                        <a:rPr lang="en-US" sz="1400" u="none" strike="noStrike" cap="none">
                          <a:solidFill>
                            <a:schemeClr val="dk1"/>
                          </a:solidFill>
                          <a:latin typeface="Times New Roman"/>
                          <a:ea typeface="Times New Roman"/>
                          <a:cs typeface="Times New Roman"/>
                          <a:sym typeface="Times New Roman"/>
                        </a:rPr>
                        <a:t>ChreCp058</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latin typeface="Times New Roman"/>
                          <a:ea typeface="Times New Roman"/>
                          <a:cs typeface="Times New Roman"/>
                          <a:sym typeface="Times New Roman"/>
                        </a:rPr>
                        <a:t>atpB</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baseline="30000">
                          <a:latin typeface="Times New Roman"/>
                          <a:ea typeface="Times New Roman"/>
                          <a:cs typeface="Times New Roman"/>
                          <a:sym typeface="Times New Roman"/>
                        </a:rPr>
                        <a:t>115(tri)</a:t>
                      </a:r>
                      <a:r>
                        <a:rPr lang="en-US" sz="1400" u="none" strike="noStrike" cap="none">
                          <a:latin typeface="Times New Roman"/>
                          <a:ea typeface="Times New Roman"/>
                          <a:cs typeface="Times New Roman"/>
                          <a:sym typeface="Times New Roman"/>
                        </a:rPr>
                        <a:t>K, </a:t>
                      </a:r>
                      <a:r>
                        <a:rPr lang="en-US" sz="1400" u="none" strike="noStrike" cap="none" baseline="30000">
                          <a:latin typeface="Times New Roman"/>
                          <a:ea typeface="Times New Roman"/>
                          <a:cs typeface="Times New Roman"/>
                          <a:sym typeface="Times New Roman"/>
                        </a:rPr>
                        <a:t>373(tri)</a:t>
                      </a:r>
                      <a:r>
                        <a:rPr lang="en-US" sz="1400" u="none" strike="noStrike" cap="none">
                          <a:latin typeface="Times New Roman"/>
                          <a:ea typeface="Times New Roman"/>
                          <a:cs typeface="Times New Roman"/>
                          <a:sym typeface="Times New Roman"/>
                        </a:rPr>
                        <a:t>K, </a:t>
                      </a:r>
                      <a:r>
                        <a:rPr lang="en-US" sz="1400" u="none" strike="noStrike" cap="none" baseline="30000">
                          <a:latin typeface="Times New Roman"/>
                          <a:ea typeface="Times New Roman"/>
                          <a:cs typeface="Times New Roman"/>
                          <a:sym typeface="Times New Roman"/>
                        </a:rPr>
                        <a:t>437(di)</a:t>
                      </a:r>
                      <a:r>
                        <a:rPr lang="en-US" sz="1400" u="none" strike="noStrike" cap="none">
                          <a:latin typeface="Times New Roman"/>
                          <a:ea typeface="Times New Roman"/>
                          <a:cs typeface="Times New Roman"/>
                          <a:sym typeface="Times New Roman"/>
                        </a:rPr>
                        <a:t>K</a:t>
                      </a:r>
                      <a:endParaRPr sz="1400" u="none" strike="noStrike" cap="none">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1"/>
                  </a:ext>
                </a:extLst>
              </a:tr>
              <a:tr h="381000">
                <a:tc>
                  <a:txBody>
                    <a:bodyPr/>
                    <a:lstStyle/>
                    <a:p>
                      <a:pPr marL="0" marR="0" lvl="0" indent="0" algn="l" rtl="0">
                        <a:lnSpc>
                          <a:spcPct val="100000"/>
                        </a:lnSpc>
                        <a:spcBef>
                          <a:spcPts val="0"/>
                        </a:spcBef>
                        <a:spcAft>
                          <a:spcPts val="0"/>
                        </a:spcAft>
                        <a:buClr>
                          <a:srgbClr val="000000"/>
                        </a:buClr>
                        <a:buSzPts val="1200"/>
                        <a:buFont typeface="Arial"/>
                        <a:buNone/>
                      </a:pPr>
                      <a:r>
                        <a:rPr lang="en-US" sz="1400" u="none" strike="noStrike" cap="none">
                          <a:solidFill>
                            <a:schemeClr val="dk1"/>
                          </a:solidFill>
                          <a:latin typeface="Times New Roman"/>
                          <a:ea typeface="Times New Roman"/>
                          <a:cs typeface="Times New Roman"/>
                          <a:sym typeface="Times New Roman"/>
                        </a:rPr>
                        <a:t>Cre06.g278213.t1.1</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latin typeface="Times New Roman"/>
                          <a:ea typeface="Times New Roman"/>
                          <a:cs typeface="Times New Roman"/>
                          <a:sym typeface="Times New Roman"/>
                        </a:rPr>
                        <a:t>LHCA6</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baseline="30000">
                          <a:latin typeface="Times New Roman"/>
                          <a:ea typeface="Times New Roman"/>
                          <a:cs typeface="Times New Roman"/>
                          <a:sym typeface="Times New Roman"/>
                        </a:rPr>
                        <a:t>234</a:t>
                      </a:r>
                      <a:r>
                        <a:rPr lang="en-US" sz="1400" u="none" strike="noStrike" cap="none">
                          <a:latin typeface="Times New Roman"/>
                          <a:ea typeface="Times New Roman"/>
                          <a:cs typeface="Times New Roman"/>
                          <a:sym typeface="Times New Roman"/>
                        </a:rPr>
                        <a:t>K</a:t>
                      </a:r>
                      <a:endParaRPr sz="1400" u="none" strike="noStrike" cap="none">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2"/>
                  </a:ext>
                </a:extLst>
              </a:tr>
              <a:tr h="381000">
                <a:tc>
                  <a:txBody>
                    <a:bodyPr/>
                    <a:lstStyle/>
                    <a:p>
                      <a:pPr marL="0" marR="0" lvl="0" indent="0" algn="l" rtl="0">
                        <a:lnSpc>
                          <a:spcPct val="100000"/>
                        </a:lnSpc>
                        <a:spcBef>
                          <a:spcPts val="0"/>
                        </a:spcBef>
                        <a:spcAft>
                          <a:spcPts val="0"/>
                        </a:spcAft>
                        <a:buClr>
                          <a:srgbClr val="000000"/>
                        </a:buClr>
                        <a:buSzPts val="1200"/>
                        <a:buFont typeface="Arial"/>
                        <a:buNone/>
                      </a:pPr>
                      <a:r>
                        <a:rPr lang="en-US" sz="1400" u="none" strike="noStrike" cap="none">
                          <a:solidFill>
                            <a:schemeClr val="dk1"/>
                          </a:solidFill>
                          <a:latin typeface="Times New Roman"/>
                          <a:ea typeface="Times New Roman"/>
                          <a:cs typeface="Times New Roman"/>
                          <a:sym typeface="Times New Roman"/>
                        </a:rPr>
                        <a:t>ChreCp019</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latin typeface="Times New Roman"/>
                          <a:ea typeface="Times New Roman"/>
                          <a:cs typeface="Times New Roman"/>
                          <a:sym typeface="Times New Roman"/>
                        </a:rPr>
                        <a:t>PsaA</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baseline="30000">
                          <a:latin typeface="Times New Roman"/>
                          <a:ea typeface="Times New Roman"/>
                          <a:cs typeface="Times New Roman"/>
                          <a:sym typeface="Times New Roman"/>
                        </a:rPr>
                        <a:t>235(tri)</a:t>
                      </a:r>
                      <a:r>
                        <a:rPr lang="en-US" sz="1400" u="none" strike="noStrike" cap="none">
                          <a:latin typeface="Times New Roman"/>
                          <a:ea typeface="Times New Roman"/>
                          <a:cs typeface="Times New Roman"/>
                          <a:sym typeface="Times New Roman"/>
                        </a:rPr>
                        <a:t>K</a:t>
                      </a:r>
                      <a:endParaRPr sz="1400" u="none" strike="noStrike" cap="none">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3"/>
                  </a:ext>
                </a:extLst>
              </a:tr>
              <a:tr h="381000">
                <a:tc>
                  <a:txBody>
                    <a:bodyPr/>
                    <a:lstStyle/>
                    <a:p>
                      <a:pPr marL="0" marR="0" lvl="0" indent="0" algn="l" rtl="0">
                        <a:lnSpc>
                          <a:spcPct val="100000"/>
                        </a:lnSpc>
                        <a:spcBef>
                          <a:spcPts val="0"/>
                        </a:spcBef>
                        <a:spcAft>
                          <a:spcPts val="0"/>
                        </a:spcAft>
                        <a:buClr>
                          <a:srgbClr val="000000"/>
                        </a:buClr>
                        <a:buSzPts val="1200"/>
                        <a:buFont typeface="Arial"/>
                        <a:buNone/>
                      </a:pPr>
                      <a:r>
                        <a:rPr lang="en-US" sz="1400" u="none" strike="noStrike" cap="none">
                          <a:solidFill>
                            <a:schemeClr val="dk1"/>
                          </a:solidFill>
                          <a:latin typeface="Times New Roman"/>
                          <a:ea typeface="Times New Roman"/>
                          <a:cs typeface="Times New Roman"/>
                          <a:sym typeface="Times New Roman"/>
                        </a:rPr>
                        <a:t>Cre05.g238332.t1.1</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latin typeface="Times New Roman"/>
                          <a:ea typeface="Times New Roman"/>
                          <a:cs typeface="Times New Roman"/>
                          <a:sym typeface="Times New Roman"/>
                        </a:rPr>
                        <a:t>PSAD</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baseline="30000">
                          <a:latin typeface="Times New Roman"/>
                          <a:ea typeface="Times New Roman"/>
                          <a:cs typeface="Times New Roman"/>
                          <a:sym typeface="Times New Roman"/>
                        </a:rPr>
                        <a:t>118</a:t>
                      </a:r>
                      <a:r>
                        <a:rPr lang="en-US" sz="1400" u="none" strike="noStrike" cap="none">
                          <a:latin typeface="Times New Roman"/>
                          <a:ea typeface="Times New Roman"/>
                          <a:cs typeface="Times New Roman"/>
                          <a:sym typeface="Times New Roman"/>
                        </a:rPr>
                        <a:t>K, </a:t>
                      </a:r>
                      <a:r>
                        <a:rPr lang="en-US" sz="1400" u="none" strike="noStrike" cap="none" baseline="30000">
                          <a:latin typeface="Times New Roman"/>
                          <a:ea typeface="Times New Roman"/>
                          <a:cs typeface="Times New Roman"/>
                          <a:sym typeface="Times New Roman"/>
                        </a:rPr>
                        <a:t>160(tri)</a:t>
                      </a:r>
                      <a:r>
                        <a:rPr lang="en-US" sz="1400" u="none" strike="noStrike" cap="none">
                          <a:latin typeface="Times New Roman"/>
                          <a:ea typeface="Times New Roman"/>
                          <a:cs typeface="Times New Roman"/>
                          <a:sym typeface="Times New Roman"/>
                        </a:rPr>
                        <a:t>K</a:t>
                      </a:r>
                      <a:endParaRPr sz="1400" u="none" strike="noStrike" cap="none">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4"/>
                  </a:ext>
                </a:extLst>
              </a:tr>
              <a:tr h="381000">
                <a:tc>
                  <a:txBody>
                    <a:bodyPr/>
                    <a:lstStyle/>
                    <a:p>
                      <a:pPr marL="0" marR="0" lvl="0" indent="0" algn="l" rtl="0">
                        <a:lnSpc>
                          <a:spcPct val="100000"/>
                        </a:lnSpc>
                        <a:spcBef>
                          <a:spcPts val="0"/>
                        </a:spcBef>
                        <a:spcAft>
                          <a:spcPts val="0"/>
                        </a:spcAft>
                        <a:buClr>
                          <a:srgbClr val="000000"/>
                        </a:buClr>
                        <a:buSzPts val="1200"/>
                        <a:buFont typeface="Arial"/>
                        <a:buNone/>
                      </a:pPr>
                      <a:r>
                        <a:rPr lang="en-US" sz="1400" u="none" strike="noStrike" cap="none">
                          <a:solidFill>
                            <a:schemeClr val="dk1"/>
                          </a:solidFill>
                          <a:latin typeface="Times New Roman"/>
                          <a:ea typeface="Times New Roman"/>
                          <a:cs typeface="Times New Roman"/>
                          <a:sym typeface="Times New Roman"/>
                        </a:rPr>
                        <a:t>ChreCp064</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a:latin typeface="Times New Roman"/>
                          <a:ea typeface="Times New Roman"/>
                          <a:cs typeface="Times New Roman"/>
                          <a:sym typeface="Times New Roman"/>
                        </a:rPr>
                        <a:t>PsbD</a:t>
                      </a:r>
                      <a:endParaRPr sz="1400" u="none" strike="noStrike" cap="none">
                        <a:latin typeface="Times New Roman"/>
                        <a:ea typeface="Times New Roman"/>
                        <a:cs typeface="Times New Roman"/>
                        <a:sym typeface="Times New Roman"/>
                      </a:endParaRPr>
                    </a:p>
                  </a:txBody>
                  <a:tcPr marL="91425" marR="91425" marT="91425" marB="91425"/>
                </a:tc>
                <a:tc>
                  <a:txBody>
                    <a:bodyPr/>
                    <a:lstStyle/>
                    <a:p>
                      <a:pPr marL="0" marR="0" lvl="0" indent="0" algn="l" rtl="0">
                        <a:lnSpc>
                          <a:spcPct val="100000"/>
                        </a:lnSpc>
                        <a:spcBef>
                          <a:spcPts val="0"/>
                        </a:spcBef>
                        <a:spcAft>
                          <a:spcPts val="0"/>
                        </a:spcAft>
                        <a:buClr>
                          <a:srgbClr val="000000"/>
                        </a:buClr>
                        <a:buSzPts val="1400"/>
                        <a:buFont typeface="Arial"/>
                        <a:buNone/>
                      </a:pPr>
                      <a:r>
                        <a:rPr lang="en-US" sz="1400" u="none" strike="noStrike" cap="none" baseline="30000">
                          <a:latin typeface="Times New Roman"/>
                          <a:ea typeface="Times New Roman"/>
                          <a:cs typeface="Times New Roman"/>
                          <a:sym typeface="Times New Roman"/>
                        </a:rPr>
                        <a:t>317(tri)</a:t>
                      </a:r>
                      <a:r>
                        <a:rPr lang="en-US" sz="1400" u="none" strike="noStrike" cap="none">
                          <a:latin typeface="Times New Roman"/>
                          <a:ea typeface="Times New Roman"/>
                          <a:cs typeface="Times New Roman"/>
                          <a:sym typeface="Times New Roman"/>
                        </a:rPr>
                        <a:t>K</a:t>
                      </a:r>
                      <a:endParaRPr sz="1400" u="none" strike="noStrike" cap="none">
                        <a:latin typeface="Times New Roman"/>
                        <a:ea typeface="Times New Roman"/>
                        <a:cs typeface="Times New Roman"/>
                        <a:sym typeface="Times New Roman"/>
                      </a:endParaRPr>
                    </a:p>
                  </a:txBody>
                  <a:tcPr marL="91425" marR="91425" marT="91425" marB="91425"/>
                </a:tc>
                <a:extLst>
                  <a:ext uri="{0D108BD9-81ED-4DB2-BD59-A6C34878D82A}">
                    <a16:rowId xmlns:a16="http://schemas.microsoft.com/office/drawing/2014/main" val="10005"/>
                  </a:ext>
                </a:extLst>
              </a:tr>
            </a:tbl>
          </a:graphicData>
        </a:graphic>
      </p:graphicFrame>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3"/>
        <p:cNvGrpSpPr/>
        <p:nvPr/>
      </p:nvGrpSpPr>
      <p:grpSpPr>
        <a:xfrm>
          <a:off x="0" y="0"/>
          <a:ext cx="0" cy="0"/>
          <a:chOff x="0" y="0"/>
          <a:chExt cx="0" cy="0"/>
        </a:xfrm>
      </p:grpSpPr>
      <p:sp>
        <p:nvSpPr>
          <p:cNvPr id="94" name="Google Shape;94;p2"/>
          <p:cNvSpPr txBox="1"/>
          <p:nvPr/>
        </p:nvSpPr>
        <p:spPr>
          <a:xfrm>
            <a:off x="111347" y="151182"/>
            <a:ext cx="1088760"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Times New Roman"/>
                <a:ea typeface="Times New Roman"/>
                <a:cs typeface="Times New Roman"/>
                <a:sym typeface="Times New Roman"/>
              </a:rPr>
              <a:t>Figure S1</a:t>
            </a:r>
            <a:endParaRPr sz="1400" b="0" i="0" u="none" strike="noStrike" cap="none">
              <a:solidFill>
                <a:srgbClr val="000000"/>
              </a:solidFill>
              <a:latin typeface="Arial"/>
              <a:ea typeface="Arial"/>
              <a:cs typeface="Arial"/>
              <a:sym typeface="Arial"/>
            </a:endParaRPr>
          </a:p>
        </p:txBody>
      </p:sp>
      <p:sp>
        <p:nvSpPr>
          <p:cNvPr id="95" name="Google Shape;95;p2"/>
          <p:cNvSpPr txBox="1"/>
          <p:nvPr/>
        </p:nvSpPr>
        <p:spPr>
          <a:xfrm>
            <a:off x="597998" y="7156869"/>
            <a:ext cx="6619782" cy="1938952"/>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000000"/>
              </a:buClr>
              <a:buSzPts val="1200"/>
              <a:buFont typeface="Arial"/>
              <a:buNone/>
            </a:pPr>
            <a:r>
              <a:rPr lang="en-US" sz="1200" b="1" i="0" u="none" strike="noStrike" cap="none" dirty="0">
                <a:solidFill>
                  <a:schemeClr val="dk1"/>
                </a:solidFill>
                <a:latin typeface="Calibri"/>
                <a:ea typeface="Calibri"/>
                <a:cs typeface="Calibri"/>
                <a:sym typeface="Calibri"/>
              </a:rPr>
              <a:t>Figure S1. Experimental procedures for pooled mutant library screen.</a:t>
            </a:r>
            <a:r>
              <a:rPr lang="en-US" sz="1200" b="0" i="0" u="none" strike="noStrike" cap="none" dirty="0">
                <a:solidFill>
                  <a:schemeClr val="dk1"/>
                </a:solidFill>
                <a:latin typeface="Calibri"/>
                <a:ea typeface="Calibri"/>
                <a:cs typeface="Calibri"/>
                <a:sym typeface="Calibri"/>
              </a:rPr>
              <a:t> The </a:t>
            </a:r>
            <a:r>
              <a:rPr lang="en-US" sz="1200" b="0" i="0" u="none" strike="noStrike" cap="none" dirty="0" err="1">
                <a:solidFill>
                  <a:schemeClr val="dk1"/>
                </a:solidFill>
                <a:latin typeface="Calibri"/>
                <a:ea typeface="Calibri"/>
                <a:cs typeface="Calibri"/>
                <a:sym typeface="Calibri"/>
              </a:rPr>
              <a:t>CLiP</a:t>
            </a:r>
            <a:r>
              <a:rPr lang="en-US" sz="1200" b="0" i="0" u="none" strike="noStrike" cap="none" dirty="0">
                <a:solidFill>
                  <a:schemeClr val="dk1"/>
                </a:solidFill>
                <a:latin typeface="Calibri"/>
                <a:ea typeface="Calibri"/>
                <a:cs typeface="Calibri"/>
                <a:sym typeface="Calibri"/>
              </a:rPr>
              <a:t> mutant library was grown in the dark until large colonies formed on solid TAP-agar medium; the mutant colonies were collected by scraping them from the plates and placing them into liquid TAP medium. The density of the pooled cells was calculated and then inoculated  to a density of 20,000 cells mL</a:t>
            </a:r>
            <a:r>
              <a:rPr lang="en-US" sz="1200" b="0" i="0" u="none" strike="noStrike" cap="none" baseline="30000" dirty="0">
                <a:solidFill>
                  <a:schemeClr val="dk1"/>
                </a:solidFill>
                <a:latin typeface="Calibri"/>
                <a:ea typeface="Calibri"/>
                <a:cs typeface="Calibri"/>
                <a:sym typeface="Calibri"/>
              </a:rPr>
              <a:t>-1</a:t>
            </a:r>
            <a:r>
              <a:rPr lang="en-US" sz="1200" b="0" i="0" u="none" strike="noStrike" cap="none" dirty="0">
                <a:solidFill>
                  <a:schemeClr val="dk1"/>
                </a:solidFill>
                <a:latin typeface="Calibri"/>
                <a:ea typeface="Calibri"/>
                <a:cs typeface="Calibri"/>
                <a:sym typeface="Calibri"/>
              </a:rPr>
              <a:t> into four separate liquid TAP cultures maintained under different conditions (LL-Hy, LL-Ox, HL-Hy, and HL-Ox) and grown to a final density of 2.5 million cells mL</a:t>
            </a:r>
            <a:r>
              <a:rPr lang="en-US" sz="1200" b="0" i="0" u="none" strike="noStrike" cap="none" baseline="30000" dirty="0">
                <a:solidFill>
                  <a:schemeClr val="dk1"/>
                </a:solidFill>
                <a:latin typeface="Calibri"/>
                <a:ea typeface="Calibri"/>
                <a:cs typeface="Calibri"/>
                <a:sym typeface="Calibri"/>
              </a:rPr>
              <a:t>-1</a:t>
            </a:r>
            <a:r>
              <a:rPr lang="en-US" sz="1200" b="0" i="0" u="none" strike="noStrike" cap="none" dirty="0">
                <a:solidFill>
                  <a:schemeClr val="dk1"/>
                </a:solidFill>
                <a:latin typeface="Calibri"/>
                <a:ea typeface="Calibri"/>
                <a:cs typeface="Calibri"/>
                <a:sym typeface="Calibri"/>
              </a:rPr>
              <a:t> (7 doubling on average). Barcode DNAs (</a:t>
            </a:r>
            <a:r>
              <a:rPr lang="en-US" sz="1200" b="0" i="0" u="none" strike="noStrike" cap="none" dirty="0" err="1">
                <a:solidFill>
                  <a:schemeClr val="dk1"/>
                </a:solidFill>
                <a:latin typeface="Calibri"/>
                <a:ea typeface="Calibri"/>
                <a:cs typeface="Calibri"/>
                <a:sym typeface="Calibri"/>
              </a:rPr>
              <a:t>bcDNAs</a:t>
            </a:r>
            <a:r>
              <a:rPr lang="en-US" sz="1200" b="0" i="0" u="none" strike="noStrike" cap="none" dirty="0">
                <a:solidFill>
                  <a:schemeClr val="dk1"/>
                </a:solidFill>
                <a:latin typeface="Calibri"/>
                <a:ea typeface="Calibri"/>
                <a:cs typeface="Calibri"/>
                <a:sym typeface="Calibri"/>
              </a:rPr>
              <a:t>) were amplified from genomic DNA isolated from each culture and sequenced using the Illumina platform at the Stanford Functional Genomics Facility. Low light (LL): 30 µmol photons m</a:t>
            </a:r>
            <a:r>
              <a:rPr lang="en-US" sz="1200" b="0" i="0" u="none" strike="noStrike" cap="none" baseline="30000" dirty="0">
                <a:solidFill>
                  <a:schemeClr val="dk1"/>
                </a:solidFill>
                <a:latin typeface="Calibri"/>
                <a:ea typeface="Calibri"/>
                <a:cs typeface="Calibri"/>
                <a:sym typeface="Calibri"/>
              </a:rPr>
              <a:t>-2</a:t>
            </a:r>
            <a:r>
              <a:rPr lang="en-US" sz="1200" b="0" i="0" u="none" strike="noStrike" cap="none" dirty="0">
                <a:solidFill>
                  <a:schemeClr val="dk1"/>
                </a:solidFill>
                <a:latin typeface="Calibri"/>
                <a:ea typeface="Calibri"/>
                <a:cs typeface="Calibri"/>
                <a:sym typeface="Calibri"/>
              </a:rPr>
              <a:t> s</a:t>
            </a:r>
            <a:r>
              <a:rPr lang="en-US" sz="1200" b="0" i="0" u="none" strike="noStrike" cap="none" baseline="30000" dirty="0">
                <a:solidFill>
                  <a:schemeClr val="dk1"/>
                </a:solidFill>
                <a:latin typeface="Calibri"/>
                <a:ea typeface="Calibri"/>
                <a:cs typeface="Calibri"/>
                <a:sym typeface="Calibri"/>
              </a:rPr>
              <a:t>-1</a:t>
            </a:r>
            <a:r>
              <a:rPr lang="en-US" sz="1200" b="0" i="0" u="none" strike="noStrike" cap="none" dirty="0">
                <a:solidFill>
                  <a:schemeClr val="dk1"/>
                </a:solidFill>
                <a:latin typeface="Calibri"/>
                <a:ea typeface="Calibri"/>
                <a:cs typeface="Calibri"/>
                <a:sym typeface="Calibri"/>
              </a:rPr>
              <a:t>; High light (HL): 300 µmol photons m</a:t>
            </a:r>
            <a:r>
              <a:rPr lang="en-US" sz="1200" b="0" i="0" u="none" strike="noStrike" cap="none" baseline="30000" dirty="0">
                <a:solidFill>
                  <a:schemeClr val="dk1"/>
                </a:solidFill>
                <a:latin typeface="Calibri"/>
                <a:ea typeface="Calibri"/>
                <a:cs typeface="Calibri"/>
                <a:sym typeface="Calibri"/>
              </a:rPr>
              <a:t>-2</a:t>
            </a:r>
            <a:r>
              <a:rPr lang="en-US" sz="1200" b="0" i="0" u="none" strike="noStrike" cap="none" dirty="0">
                <a:solidFill>
                  <a:schemeClr val="dk1"/>
                </a:solidFill>
                <a:latin typeface="Calibri"/>
                <a:ea typeface="Calibri"/>
                <a:cs typeface="Calibri"/>
                <a:sym typeface="Calibri"/>
              </a:rPr>
              <a:t> s</a:t>
            </a:r>
            <a:r>
              <a:rPr lang="en-US" sz="1200" b="0" i="0" u="none" strike="noStrike" cap="none" baseline="30000" dirty="0">
                <a:solidFill>
                  <a:schemeClr val="dk1"/>
                </a:solidFill>
                <a:latin typeface="Calibri"/>
                <a:ea typeface="Calibri"/>
                <a:cs typeface="Calibri"/>
                <a:sym typeface="Calibri"/>
              </a:rPr>
              <a:t>-1</a:t>
            </a:r>
            <a:r>
              <a:rPr lang="en-US" sz="1200" b="0" i="0" u="none" strike="noStrike" cap="none" dirty="0">
                <a:solidFill>
                  <a:schemeClr val="dk1"/>
                </a:solidFill>
                <a:latin typeface="Calibri"/>
                <a:ea typeface="Calibri"/>
                <a:cs typeface="Calibri"/>
                <a:sym typeface="Calibri"/>
              </a:rPr>
              <a:t>. Air was used for maintaining </a:t>
            </a:r>
            <a:r>
              <a:rPr lang="en-US" sz="1200" b="0" i="0" u="none" strike="noStrike" cap="none" dirty="0" err="1">
                <a:solidFill>
                  <a:schemeClr val="dk1"/>
                </a:solidFill>
                <a:latin typeface="Calibri"/>
                <a:ea typeface="Calibri"/>
                <a:cs typeface="Calibri"/>
                <a:sym typeface="Calibri"/>
              </a:rPr>
              <a:t>oxic</a:t>
            </a:r>
            <a:r>
              <a:rPr lang="en-US" sz="1200" b="0" i="0" u="none" strike="noStrike" cap="none" dirty="0">
                <a:solidFill>
                  <a:schemeClr val="dk1"/>
                </a:solidFill>
                <a:latin typeface="Calibri"/>
                <a:ea typeface="Calibri"/>
                <a:cs typeface="Calibri"/>
                <a:sym typeface="Calibri"/>
              </a:rPr>
              <a:t> conditions (Ox) while 10% air, 89.96% N</a:t>
            </a:r>
            <a:r>
              <a:rPr lang="en-US" sz="1200" b="0" i="0" u="none" strike="noStrike" cap="none" baseline="-25000" dirty="0">
                <a:solidFill>
                  <a:schemeClr val="dk1"/>
                </a:solidFill>
                <a:latin typeface="Calibri"/>
                <a:ea typeface="Calibri"/>
                <a:cs typeface="Calibri"/>
                <a:sym typeface="Calibri"/>
              </a:rPr>
              <a:t>2</a:t>
            </a:r>
            <a:r>
              <a:rPr lang="en-US" sz="1200" b="0" i="0" u="none" strike="noStrike" cap="none" dirty="0">
                <a:solidFill>
                  <a:schemeClr val="dk1"/>
                </a:solidFill>
                <a:latin typeface="Calibri"/>
                <a:ea typeface="Calibri"/>
                <a:cs typeface="Calibri"/>
                <a:sym typeface="Calibri"/>
              </a:rPr>
              <a:t> and 0.04% CO</a:t>
            </a:r>
            <a:r>
              <a:rPr lang="en-US" sz="1200" b="0" i="0" u="none" strike="noStrike" cap="none" baseline="-25000" dirty="0">
                <a:solidFill>
                  <a:schemeClr val="dk1"/>
                </a:solidFill>
                <a:latin typeface="Calibri"/>
                <a:ea typeface="Calibri"/>
                <a:cs typeface="Calibri"/>
                <a:sym typeface="Calibri"/>
              </a:rPr>
              <a:t>2</a:t>
            </a:r>
            <a:r>
              <a:rPr lang="en-US" sz="1200" b="0" i="0" u="none" strike="noStrike" cap="none" dirty="0">
                <a:solidFill>
                  <a:schemeClr val="dk1"/>
                </a:solidFill>
                <a:latin typeface="Calibri"/>
                <a:ea typeface="Calibri"/>
                <a:cs typeface="Calibri"/>
                <a:sym typeface="Calibri"/>
              </a:rPr>
              <a:t> was used to maintain hypoxic conditions (Hy). </a:t>
            </a:r>
            <a:endParaRPr sz="1400" b="0" i="0" u="none" strike="noStrike" cap="none" dirty="0">
              <a:solidFill>
                <a:srgbClr val="000000"/>
              </a:solidFill>
              <a:latin typeface="Arial"/>
              <a:ea typeface="Arial"/>
              <a:cs typeface="Arial"/>
              <a:sym typeface="Arial"/>
            </a:endParaRPr>
          </a:p>
        </p:txBody>
      </p:sp>
      <p:grpSp>
        <p:nvGrpSpPr>
          <p:cNvPr id="96" name="Google Shape;96;p2"/>
          <p:cNvGrpSpPr/>
          <p:nvPr/>
        </p:nvGrpSpPr>
        <p:grpSpPr>
          <a:xfrm>
            <a:off x="1155449" y="777116"/>
            <a:ext cx="5650171" cy="6306391"/>
            <a:chOff x="1155449" y="777116"/>
            <a:chExt cx="5650171" cy="6306391"/>
          </a:xfrm>
        </p:grpSpPr>
        <p:sp>
          <p:nvSpPr>
            <p:cNvPr id="97" name="Google Shape;97;p2"/>
            <p:cNvSpPr/>
            <p:nvPr/>
          </p:nvSpPr>
          <p:spPr>
            <a:xfrm>
              <a:off x="5735109" y="2899031"/>
              <a:ext cx="975291" cy="640186"/>
            </a:xfrm>
            <a:prstGeom prst="roundRect">
              <a:avLst>
                <a:gd name="adj" fmla="val 16667"/>
              </a:avLst>
            </a:prstGeom>
            <a:gradFill>
              <a:gsLst>
                <a:gs pos="0">
                  <a:srgbClr val="FF0000"/>
                </a:gs>
                <a:gs pos="74000">
                  <a:srgbClr val="FF0000">
                    <a:alpha val="85098"/>
                  </a:srgbClr>
                </a:gs>
                <a:gs pos="89000">
                  <a:srgbClr val="FF0000">
                    <a:alpha val="60000"/>
                  </a:srgbClr>
                </a:gs>
                <a:gs pos="100000">
                  <a:srgbClr val="FF8080">
                    <a:alpha val="4000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sp>
          <p:nvSpPr>
            <p:cNvPr id="98" name="Google Shape;98;p2"/>
            <p:cNvSpPr/>
            <p:nvPr/>
          </p:nvSpPr>
          <p:spPr>
            <a:xfrm>
              <a:off x="4755779" y="2887657"/>
              <a:ext cx="964930" cy="698591"/>
            </a:xfrm>
            <a:prstGeom prst="roundRect">
              <a:avLst>
                <a:gd name="adj" fmla="val 16667"/>
              </a:avLst>
            </a:prstGeom>
            <a:gradFill>
              <a:gsLst>
                <a:gs pos="0">
                  <a:srgbClr val="FBE6D6"/>
                </a:gs>
                <a:gs pos="85000">
                  <a:srgbClr val="FBE6D6"/>
                </a:gs>
                <a:gs pos="92000">
                  <a:srgbClr val="FBE6D6">
                    <a:alpha val="49411"/>
                  </a:srgbClr>
                </a:gs>
                <a:gs pos="100000">
                  <a:srgbClr val="FFFFFF">
                    <a:alpha val="2000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cxnSp>
          <p:nvCxnSpPr>
            <p:cNvPr id="99" name="Google Shape;99;p2"/>
            <p:cNvCxnSpPr/>
            <p:nvPr/>
          </p:nvCxnSpPr>
          <p:spPr>
            <a:xfrm>
              <a:off x="2773863" y="1234939"/>
              <a:ext cx="457200" cy="0"/>
            </a:xfrm>
            <a:prstGeom prst="straightConnector1">
              <a:avLst/>
            </a:prstGeom>
            <a:noFill/>
            <a:ln w="25400" cap="flat" cmpd="sng">
              <a:solidFill>
                <a:schemeClr val="dk1"/>
              </a:solidFill>
              <a:prstDash val="solid"/>
              <a:miter lim="800000"/>
              <a:headEnd type="none" w="sm" len="sm"/>
              <a:tailEnd type="stealth" w="med" len="med"/>
            </a:ln>
          </p:spPr>
        </p:cxnSp>
        <p:sp>
          <p:nvSpPr>
            <p:cNvPr id="100" name="Google Shape;100;p2"/>
            <p:cNvSpPr txBox="1"/>
            <p:nvPr/>
          </p:nvSpPr>
          <p:spPr>
            <a:xfrm>
              <a:off x="2670183" y="1247501"/>
              <a:ext cx="670376"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Transfer</a:t>
              </a:r>
              <a:endParaRPr sz="1400" b="0" i="0" u="none" strike="noStrike" cap="none">
                <a:solidFill>
                  <a:srgbClr val="000000"/>
                </a:solidFill>
                <a:latin typeface="Arial"/>
                <a:ea typeface="Arial"/>
                <a:cs typeface="Arial"/>
                <a:sym typeface="Arial"/>
              </a:endParaRPr>
            </a:p>
          </p:txBody>
        </p:sp>
        <p:grpSp>
          <p:nvGrpSpPr>
            <p:cNvPr id="101" name="Google Shape;101;p2"/>
            <p:cNvGrpSpPr/>
            <p:nvPr/>
          </p:nvGrpSpPr>
          <p:grpSpPr>
            <a:xfrm>
              <a:off x="1231580" y="880733"/>
              <a:ext cx="1055345" cy="806512"/>
              <a:chOff x="5284180" y="1383022"/>
              <a:chExt cx="1055345" cy="806512"/>
            </a:xfrm>
          </p:grpSpPr>
          <p:sp>
            <p:nvSpPr>
              <p:cNvPr id="102" name="Google Shape;102;p2"/>
              <p:cNvSpPr/>
              <p:nvPr/>
            </p:nvSpPr>
            <p:spPr>
              <a:xfrm>
                <a:off x="5284180" y="1383022"/>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03" name="Google Shape;103;p2"/>
              <p:cNvSpPr/>
              <p:nvPr/>
            </p:nvSpPr>
            <p:spPr>
              <a:xfrm>
                <a:off x="5308424" y="1408301"/>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04" name="Google Shape;104;p2"/>
              <p:cNvSpPr/>
              <p:nvPr/>
            </p:nvSpPr>
            <p:spPr>
              <a:xfrm>
                <a:off x="5332668" y="1433580"/>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05" name="Google Shape;105;p2"/>
              <p:cNvSpPr/>
              <p:nvPr/>
            </p:nvSpPr>
            <p:spPr>
              <a:xfrm>
                <a:off x="5356912" y="1458859"/>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06" name="Google Shape;106;p2"/>
              <p:cNvSpPr/>
              <p:nvPr/>
            </p:nvSpPr>
            <p:spPr>
              <a:xfrm>
                <a:off x="5381156" y="1484138"/>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07" name="Google Shape;107;p2"/>
              <p:cNvSpPr/>
              <p:nvPr/>
            </p:nvSpPr>
            <p:spPr>
              <a:xfrm>
                <a:off x="5405400" y="1509417"/>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08" name="Google Shape;108;p2"/>
              <p:cNvSpPr/>
              <p:nvPr/>
            </p:nvSpPr>
            <p:spPr>
              <a:xfrm>
                <a:off x="5429644" y="1534696"/>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09" name="Google Shape;109;p2"/>
              <p:cNvSpPr/>
              <p:nvPr/>
            </p:nvSpPr>
            <p:spPr>
              <a:xfrm>
                <a:off x="5453888" y="1559975"/>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10" name="Google Shape;110;p2"/>
              <p:cNvSpPr/>
              <p:nvPr/>
            </p:nvSpPr>
            <p:spPr>
              <a:xfrm>
                <a:off x="5478132" y="1585254"/>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11" name="Google Shape;111;p2"/>
              <p:cNvSpPr/>
              <p:nvPr/>
            </p:nvSpPr>
            <p:spPr>
              <a:xfrm>
                <a:off x="5502376" y="1610533"/>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12" name="Google Shape;112;p2"/>
              <p:cNvSpPr/>
              <p:nvPr/>
            </p:nvSpPr>
            <p:spPr>
              <a:xfrm>
                <a:off x="5526620" y="1635812"/>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13" name="Google Shape;113;p2"/>
              <p:cNvSpPr/>
              <p:nvPr/>
            </p:nvSpPr>
            <p:spPr>
              <a:xfrm>
                <a:off x="5550864" y="1661091"/>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14" name="Google Shape;114;p2"/>
              <p:cNvSpPr/>
              <p:nvPr/>
            </p:nvSpPr>
            <p:spPr>
              <a:xfrm>
                <a:off x="5575106" y="1686372"/>
                <a:ext cx="764419" cy="503162"/>
              </a:xfrm>
              <a:prstGeom prst="rect">
                <a:avLst/>
              </a:prstGeom>
              <a:solidFill>
                <a:srgbClr val="F0F2EF"/>
              </a:solidFill>
              <a:ln w="12700" cap="flat" cmpd="sng">
                <a:solidFill>
                  <a:srgbClr val="A2A4A2"/>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15" name="Google Shape;115;p2"/>
              <p:cNvSpPr/>
              <p:nvPr/>
            </p:nvSpPr>
            <p:spPr>
              <a:xfrm>
                <a:off x="5608932" y="1732210"/>
                <a:ext cx="704157" cy="429768"/>
              </a:xfrm>
              <a:custGeom>
                <a:avLst/>
                <a:gdLst/>
                <a:ahLst/>
                <a:cxnLst/>
                <a:rect l="l" t="t" r="r" b="b"/>
                <a:pathLst>
                  <a:path w="1478136" h="908506" extrusionOk="0">
                    <a:moveTo>
                      <a:pt x="1459848" y="871930"/>
                    </a:moveTo>
                    <a:cubicBezTo>
                      <a:pt x="1469948" y="871930"/>
                      <a:pt x="1478136" y="880118"/>
                      <a:pt x="1478136" y="890218"/>
                    </a:cubicBezTo>
                    <a:cubicBezTo>
                      <a:pt x="1478136" y="900318"/>
                      <a:pt x="1469948" y="908506"/>
                      <a:pt x="1459848" y="908506"/>
                    </a:cubicBezTo>
                    <a:cubicBezTo>
                      <a:pt x="1449748" y="908506"/>
                      <a:pt x="1441560" y="900318"/>
                      <a:pt x="1441560" y="890218"/>
                    </a:cubicBezTo>
                    <a:cubicBezTo>
                      <a:pt x="1441560" y="880118"/>
                      <a:pt x="1449748" y="871930"/>
                      <a:pt x="1459848" y="871930"/>
                    </a:cubicBezTo>
                    <a:close/>
                    <a:moveTo>
                      <a:pt x="1402176" y="871930"/>
                    </a:moveTo>
                    <a:cubicBezTo>
                      <a:pt x="1412276" y="871930"/>
                      <a:pt x="1420464" y="880118"/>
                      <a:pt x="1420464" y="890218"/>
                    </a:cubicBezTo>
                    <a:cubicBezTo>
                      <a:pt x="1420464" y="900318"/>
                      <a:pt x="1412276" y="908506"/>
                      <a:pt x="1402176" y="908506"/>
                    </a:cubicBezTo>
                    <a:cubicBezTo>
                      <a:pt x="1392076" y="908506"/>
                      <a:pt x="1383888" y="900318"/>
                      <a:pt x="1383888" y="890218"/>
                    </a:cubicBezTo>
                    <a:cubicBezTo>
                      <a:pt x="1383888" y="880118"/>
                      <a:pt x="1392076" y="871930"/>
                      <a:pt x="1402176" y="871930"/>
                    </a:cubicBezTo>
                    <a:close/>
                    <a:moveTo>
                      <a:pt x="1344514" y="871930"/>
                    </a:moveTo>
                    <a:cubicBezTo>
                      <a:pt x="1354614" y="871930"/>
                      <a:pt x="1362802" y="880118"/>
                      <a:pt x="1362802" y="890218"/>
                    </a:cubicBezTo>
                    <a:cubicBezTo>
                      <a:pt x="1362802" y="900318"/>
                      <a:pt x="1354614" y="908506"/>
                      <a:pt x="1344514" y="908506"/>
                    </a:cubicBezTo>
                    <a:cubicBezTo>
                      <a:pt x="1334414" y="908506"/>
                      <a:pt x="1326226" y="900318"/>
                      <a:pt x="1326226" y="890218"/>
                    </a:cubicBezTo>
                    <a:cubicBezTo>
                      <a:pt x="1326226" y="880118"/>
                      <a:pt x="1334414" y="871930"/>
                      <a:pt x="1344514" y="871930"/>
                    </a:cubicBezTo>
                    <a:close/>
                    <a:moveTo>
                      <a:pt x="1286852" y="871930"/>
                    </a:moveTo>
                    <a:cubicBezTo>
                      <a:pt x="1296952" y="871930"/>
                      <a:pt x="1305140" y="880118"/>
                      <a:pt x="1305140" y="890218"/>
                    </a:cubicBezTo>
                    <a:cubicBezTo>
                      <a:pt x="1305140" y="900318"/>
                      <a:pt x="1296952" y="908506"/>
                      <a:pt x="1286852" y="908506"/>
                    </a:cubicBezTo>
                    <a:cubicBezTo>
                      <a:pt x="1276752" y="908506"/>
                      <a:pt x="1268564" y="900318"/>
                      <a:pt x="1268564" y="890218"/>
                    </a:cubicBezTo>
                    <a:cubicBezTo>
                      <a:pt x="1268564" y="880118"/>
                      <a:pt x="1276752" y="871930"/>
                      <a:pt x="1286852" y="871930"/>
                    </a:cubicBezTo>
                    <a:close/>
                    <a:moveTo>
                      <a:pt x="1229190" y="871930"/>
                    </a:moveTo>
                    <a:cubicBezTo>
                      <a:pt x="1239290" y="871930"/>
                      <a:pt x="1247478" y="880118"/>
                      <a:pt x="1247478" y="890218"/>
                    </a:cubicBezTo>
                    <a:cubicBezTo>
                      <a:pt x="1247478" y="900318"/>
                      <a:pt x="1239290" y="908506"/>
                      <a:pt x="1229190" y="908506"/>
                    </a:cubicBezTo>
                    <a:cubicBezTo>
                      <a:pt x="1219090" y="908506"/>
                      <a:pt x="1210902" y="900318"/>
                      <a:pt x="1210902" y="890218"/>
                    </a:cubicBezTo>
                    <a:cubicBezTo>
                      <a:pt x="1210902" y="880118"/>
                      <a:pt x="1219090" y="871930"/>
                      <a:pt x="1229190" y="871930"/>
                    </a:cubicBezTo>
                    <a:close/>
                    <a:moveTo>
                      <a:pt x="1171528" y="871930"/>
                    </a:moveTo>
                    <a:cubicBezTo>
                      <a:pt x="1181628" y="871930"/>
                      <a:pt x="1189816" y="880118"/>
                      <a:pt x="1189816" y="890218"/>
                    </a:cubicBezTo>
                    <a:cubicBezTo>
                      <a:pt x="1189816" y="900318"/>
                      <a:pt x="1181628" y="908506"/>
                      <a:pt x="1171528" y="908506"/>
                    </a:cubicBezTo>
                    <a:cubicBezTo>
                      <a:pt x="1161428" y="908506"/>
                      <a:pt x="1153240" y="900318"/>
                      <a:pt x="1153240" y="890218"/>
                    </a:cubicBezTo>
                    <a:cubicBezTo>
                      <a:pt x="1153240" y="880118"/>
                      <a:pt x="1161428" y="871930"/>
                      <a:pt x="1171528" y="871930"/>
                    </a:cubicBezTo>
                    <a:close/>
                    <a:moveTo>
                      <a:pt x="1113866" y="871930"/>
                    </a:moveTo>
                    <a:cubicBezTo>
                      <a:pt x="1123966" y="871930"/>
                      <a:pt x="1132154" y="880118"/>
                      <a:pt x="1132154" y="890218"/>
                    </a:cubicBezTo>
                    <a:cubicBezTo>
                      <a:pt x="1132154" y="900318"/>
                      <a:pt x="1123966" y="908506"/>
                      <a:pt x="1113866" y="908506"/>
                    </a:cubicBezTo>
                    <a:cubicBezTo>
                      <a:pt x="1103766" y="908506"/>
                      <a:pt x="1095578" y="900318"/>
                      <a:pt x="1095578" y="890218"/>
                    </a:cubicBezTo>
                    <a:cubicBezTo>
                      <a:pt x="1095578" y="880118"/>
                      <a:pt x="1103766" y="871930"/>
                      <a:pt x="1113866" y="871930"/>
                    </a:cubicBezTo>
                    <a:close/>
                    <a:moveTo>
                      <a:pt x="1056204" y="871930"/>
                    </a:moveTo>
                    <a:cubicBezTo>
                      <a:pt x="1066304" y="871930"/>
                      <a:pt x="1074492" y="880118"/>
                      <a:pt x="1074492" y="890218"/>
                    </a:cubicBezTo>
                    <a:cubicBezTo>
                      <a:pt x="1074492" y="900318"/>
                      <a:pt x="1066304" y="908506"/>
                      <a:pt x="1056204" y="908506"/>
                    </a:cubicBezTo>
                    <a:cubicBezTo>
                      <a:pt x="1046104" y="908506"/>
                      <a:pt x="1037916" y="900318"/>
                      <a:pt x="1037916" y="890218"/>
                    </a:cubicBezTo>
                    <a:cubicBezTo>
                      <a:pt x="1037916" y="880118"/>
                      <a:pt x="1046104" y="871930"/>
                      <a:pt x="1056204" y="871930"/>
                    </a:cubicBezTo>
                    <a:close/>
                    <a:moveTo>
                      <a:pt x="998542" y="871930"/>
                    </a:moveTo>
                    <a:cubicBezTo>
                      <a:pt x="1008642" y="871930"/>
                      <a:pt x="1016830" y="880118"/>
                      <a:pt x="1016830" y="890218"/>
                    </a:cubicBezTo>
                    <a:cubicBezTo>
                      <a:pt x="1016830" y="900318"/>
                      <a:pt x="1008642" y="908506"/>
                      <a:pt x="998542" y="908506"/>
                    </a:cubicBezTo>
                    <a:cubicBezTo>
                      <a:pt x="988442" y="908506"/>
                      <a:pt x="980254" y="900318"/>
                      <a:pt x="980254" y="890218"/>
                    </a:cubicBezTo>
                    <a:cubicBezTo>
                      <a:pt x="980254" y="880118"/>
                      <a:pt x="988442" y="871930"/>
                      <a:pt x="998542" y="871930"/>
                    </a:cubicBezTo>
                    <a:close/>
                    <a:moveTo>
                      <a:pt x="940880" y="871930"/>
                    </a:moveTo>
                    <a:cubicBezTo>
                      <a:pt x="950980" y="871930"/>
                      <a:pt x="959168" y="880118"/>
                      <a:pt x="959168" y="890218"/>
                    </a:cubicBezTo>
                    <a:cubicBezTo>
                      <a:pt x="959168" y="900318"/>
                      <a:pt x="950980" y="908506"/>
                      <a:pt x="940880" y="908506"/>
                    </a:cubicBezTo>
                    <a:cubicBezTo>
                      <a:pt x="930780" y="908506"/>
                      <a:pt x="922592" y="900318"/>
                      <a:pt x="922592" y="890218"/>
                    </a:cubicBezTo>
                    <a:cubicBezTo>
                      <a:pt x="922592" y="880118"/>
                      <a:pt x="930780" y="871930"/>
                      <a:pt x="940880" y="871930"/>
                    </a:cubicBezTo>
                    <a:close/>
                    <a:moveTo>
                      <a:pt x="883218" y="871930"/>
                    </a:moveTo>
                    <a:cubicBezTo>
                      <a:pt x="893318" y="871930"/>
                      <a:pt x="901506" y="880118"/>
                      <a:pt x="901506" y="890218"/>
                    </a:cubicBezTo>
                    <a:cubicBezTo>
                      <a:pt x="901506" y="900318"/>
                      <a:pt x="893318" y="908506"/>
                      <a:pt x="883218" y="908506"/>
                    </a:cubicBezTo>
                    <a:cubicBezTo>
                      <a:pt x="873118" y="908506"/>
                      <a:pt x="864930" y="900318"/>
                      <a:pt x="864930" y="890218"/>
                    </a:cubicBezTo>
                    <a:cubicBezTo>
                      <a:pt x="864930" y="880118"/>
                      <a:pt x="873118" y="871930"/>
                      <a:pt x="883218" y="871930"/>
                    </a:cubicBezTo>
                    <a:close/>
                    <a:moveTo>
                      <a:pt x="825556" y="871930"/>
                    </a:moveTo>
                    <a:cubicBezTo>
                      <a:pt x="835656" y="871930"/>
                      <a:pt x="843844" y="880118"/>
                      <a:pt x="843844" y="890218"/>
                    </a:cubicBezTo>
                    <a:cubicBezTo>
                      <a:pt x="843844" y="900318"/>
                      <a:pt x="835656" y="908506"/>
                      <a:pt x="825556" y="908506"/>
                    </a:cubicBezTo>
                    <a:cubicBezTo>
                      <a:pt x="815456" y="908506"/>
                      <a:pt x="807268" y="900318"/>
                      <a:pt x="807268" y="890218"/>
                    </a:cubicBezTo>
                    <a:cubicBezTo>
                      <a:pt x="807268" y="880118"/>
                      <a:pt x="815456" y="871930"/>
                      <a:pt x="825556" y="871930"/>
                    </a:cubicBezTo>
                    <a:close/>
                    <a:moveTo>
                      <a:pt x="767894" y="871930"/>
                    </a:moveTo>
                    <a:cubicBezTo>
                      <a:pt x="777994" y="871930"/>
                      <a:pt x="786182" y="880118"/>
                      <a:pt x="786182" y="890218"/>
                    </a:cubicBezTo>
                    <a:cubicBezTo>
                      <a:pt x="786182" y="900318"/>
                      <a:pt x="777994" y="908506"/>
                      <a:pt x="767894" y="908506"/>
                    </a:cubicBezTo>
                    <a:cubicBezTo>
                      <a:pt x="757794" y="908506"/>
                      <a:pt x="749606" y="900318"/>
                      <a:pt x="749606" y="890218"/>
                    </a:cubicBezTo>
                    <a:cubicBezTo>
                      <a:pt x="749606" y="880118"/>
                      <a:pt x="757794" y="871930"/>
                      <a:pt x="767894" y="871930"/>
                    </a:cubicBezTo>
                    <a:close/>
                    <a:moveTo>
                      <a:pt x="710232" y="871930"/>
                    </a:moveTo>
                    <a:cubicBezTo>
                      <a:pt x="720332" y="871930"/>
                      <a:pt x="728520" y="880118"/>
                      <a:pt x="728520" y="890218"/>
                    </a:cubicBezTo>
                    <a:cubicBezTo>
                      <a:pt x="728520" y="900318"/>
                      <a:pt x="720332" y="908506"/>
                      <a:pt x="710232" y="908506"/>
                    </a:cubicBezTo>
                    <a:cubicBezTo>
                      <a:pt x="700132" y="908506"/>
                      <a:pt x="691944" y="900318"/>
                      <a:pt x="691944" y="890218"/>
                    </a:cubicBezTo>
                    <a:cubicBezTo>
                      <a:pt x="691944" y="880118"/>
                      <a:pt x="700132" y="871930"/>
                      <a:pt x="710232" y="871930"/>
                    </a:cubicBezTo>
                    <a:close/>
                    <a:moveTo>
                      <a:pt x="652570" y="871930"/>
                    </a:moveTo>
                    <a:cubicBezTo>
                      <a:pt x="662670" y="871930"/>
                      <a:pt x="670858" y="880118"/>
                      <a:pt x="670858" y="890218"/>
                    </a:cubicBezTo>
                    <a:cubicBezTo>
                      <a:pt x="670858" y="900318"/>
                      <a:pt x="662670" y="908506"/>
                      <a:pt x="652570" y="908506"/>
                    </a:cubicBezTo>
                    <a:cubicBezTo>
                      <a:pt x="642470" y="908506"/>
                      <a:pt x="634282" y="900318"/>
                      <a:pt x="634282" y="890218"/>
                    </a:cubicBezTo>
                    <a:cubicBezTo>
                      <a:pt x="634282" y="880118"/>
                      <a:pt x="642470" y="871930"/>
                      <a:pt x="652570" y="871930"/>
                    </a:cubicBezTo>
                    <a:close/>
                    <a:moveTo>
                      <a:pt x="594908" y="871930"/>
                    </a:moveTo>
                    <a:cubicBezTo>
                      <a:pt x="605008" y="871930"/>
                      <a:pt x="613196" y="880118"/>
                      <a:pt x="613196" y="890218"/>
                    </a:cubicBezTo>
                    <a:cubicBezTo>
                      <a:pt x="613196" y="900318"/>
                      <a:pt x="605008" y="908506"/>
                      <a:pt x="594908" y="908506"/>
                    </a:cubicBezTo>
                    <a:cubicBezTo>
                      <a:pt x="584808" y="908506"/>
                      <a:pt x="576620" y="900318"/>
                      <a:pt x="576620" y="890218"/>
                    </a:cubicBezTo>
                    <a:cubicBezTo>
                      <a:pt x="576620" y="880118"/>
                      <a:pt x="584808" y="871930"/>
                      <a:pt x="594908" y="871930"/>
                    </a:cubicBezTo>
                    <a:close/>
                    <a:moveTo>
                      <a:pt x="537246" y="871930"/>
                    </a:moveTo>
                    <a:cubicBezTo>
                      <a:pt x="547346" y="871930"/>
                      <a:pt x="555534" y="880118"/>
                      <a:pt x="555534" y="890218"/>
                    </a:cubicBezTo>
                    <a:cubicBezTo>
                      <a:pt x="555534" y="900318"/>
                      <a:pt x="547346" y="908506"/>
                      <a:pt x="537246" y="908506"/>
                    </a:cubicBezTo>
                    <a:cubicBezTo>
                      <a:pt x="527146" y="908506"/>
                      <a:pt x="518958" y="900318"/>
                      <a:pt x="518958" y="890218"/>
                    </a:cubicBezTo>
                    <a:cubicBezTo>
                      <a:pt x="518958" y="880118"/>
                      <a:pt x="527146" y="871930"/>
                      <a:pt x="537246" y="871930"/>
                    </a:cubicBezTo>
                    <a:close/>
                    <a:moveTo>
                      <a:pt x="479584" y="871930"/>
                    </a:moveTo>
                    <a:cubicBezTo>
                      <a:pt x="489684" y="871930"/>
                      <a:pt x="497872" y="880118"/>
                      <a:pt x="497872" y="890218"/>
                    </a:cubicBezTo>
                    <a:cubicBezTo>
                      <a:pt x="497872" y="900318"/>
                      <a:pt x="489684" y="908506"/>
                      <a:pt x="479584" y="908506"/>
                    </a:cubicBezTo>
                    <a:cubicBezTo>
                      <a:pt x="469484" y="908506"/>
                      <a:pt x="461296" y="900318"/>
                      <a:pt x="461296" y="890218"/>
                    </a:cubicBezTo>
                    <a:cubicBezTo>
                      <a:pt x="461296" y="880118"/>
                      <a:pt x="469484" y="871930"/>
                      <a:pt x="479584" y="871930"/>
                    </a:cubicBezTo>
                    <a:close/>
                    <a:moveTo>
                      <a:pt x="421922" y="871930"/>
                    </a:moveTo>
                    <a:cubicBezTo>
                      <a:pt x="432022" y="871930"/>
                      <a:pt x="440210" y="880118"/>
                      <a:pt x="440210" y="890218"/>
                    </a:cubicBezTo>
                    <a:cubicBezTo>
                      <a:pt x="440210" y="900318"/>
                      <a:pt x="432022" y="908506"/>
                      <a:pt x="421922" y="908506"/>
                    </a:cubicBezTo>
                    <a:cubicBezTo>
                      <a:pt x="411822" y="908506"/>
                      <a:pt x="403634" y="900318"/>
                      <a:pt x="403634" y="890218"/>
                    </a:cubicBezTo>
                    <a:cubicBezTo>
                      <a:pt x="403634" y="880118"/>
                      <a:pt x="411822" y="871930"/>
                      <a:pt x="421922" y="871930"/>
                    </a:cubicBezTo>
                    <a:close/>
                    <a:moveTo>
                      <a:pt x="364260" y="871930"/>
                    </a:moveTo>
                    <a:cubicBezTo>
                      <a:pt x="374360" y="871930"/>
                      <a:pt x="382548" y="880118"/>
                      <a:pt x="382548" y="890218"/>
                    </a:cubicBezTo>
                    <a:cubicBezTo>
                      <a:pt x="382548" y="900318"/>
                      <a:pt x="374360" y="908506"/>
                      <a:pt x="364260" y="908506"/>
                    </a:cubicBezTo>
                    <a:cubicBezTo>
                      <a:pt x="354160" y="908506"/>
                      <a:pt x="345972" y="900318"/>
                      <a:pt x="345972" y="890218"/>
                    </a:cubicBezTo>
                    <a:cubicBezTo>
                      <a:pt x="345972" y="880118"/>
                      <a:pt x="354160" y="871930"/>
                      <a:pt x="364260" y="871930"/>
                    </a:cubicBezTo>
                    <a:close/>
                    <a:moveTo>
                      <a:pt x="306598" y="871930"/>
                    </a:moveTo>
                    <a:cubicBezTo>
                      <a:pt x="316698" y="871930"/>
                      <a:pt x="324886" y="880118"/>
                      <a:pt x="324886" y="890218"/>
                    </a:cubicBezTo>
                    <a:cubicBezTo>
                      <a:pt x="324886" y="900318"/>
                      <a:pt x="316698" y="908506"/>
                      <a:pt x="306598" y="908506"/>
                    </a:cubicBezTo>
                    <a:cubicBezTo>
                      <a:pt x="296498" y="908506"/>
                      <a:pt x="288310" y="900318"/>
                      <a:pt x="288310" y="890218"/>
                    </a:cubicBezTo>
                    <a:cubicBezTo>
                      <a:pt x="288310" y="880118"/>
                      <a:pt x="296498" y="871930"/>
                      <a:pt x="306598" y="871930"/>
                    </a:cubicBezTo>
                    <a:close/>
                    <a:moveTo>
                      <a:pt x="248936" y="871930"/>
                    </a:moveTo>
                    <a:cubicBezTo>
                      <a:pt x="259036" y="871930"/>
                      <a:pt x="267224" y="880118"/>
                      <a:pt x="267224" y="890218"/>
                    </a:cubicBezTo>
                    <a:cubicBezTo>
                      <a:pt x="267224" y="900318"/>
                      <a:pt x="259036" y="908506"/>
                      <a:pt x="248936" y="908506"/>
                    </a:cubicBezTo>
                    <a:cubicBezTo>
                      <a:pt x="238836" y="908506"/>
                      <a:pt x="230648" y="900318"/>
                      <a:pt x="230648" y="890218"/>
                    </a:cubicBezTo>
                    <a:cubicBezTo>
                      <a:pt x="230648" y="880118"/>
                      <a:pt x="238836" y="871930"/>
                      <a:pt x="248936" y="871930"/>
                    </a:cubicBezTo>
                    <a:close/>
                    <a:moveTo>
                      <a:pt x="191274" y="871930"/>
                    </a:moveTo>
                    <a:cubicBezTo>
                      <a:pt x="201374" y="871930"/>
                      <a:pt x="209562" y="880118"/>
                      <a:pt x="209562" y="890218"/>
                    </a:cubicBezTo>
                    <a:cubicBezTo>
                      <a:pt x="209562" y="900318"/>
                      <a:pt x="201374" y="908506"/>
                      <a:pt x="191274" y="908506"/>
                    </a:cubicBezTo>
                    <a:cubicBezTo>
                      <a:pt x="181174" y="908506"/>
                      <a:pt x="172986" y="900318"/>
                      <a:pt x="172986" y="890218"/>
                    </a:cubicBezTo>
                    <a:cubicBezTo>
                      <a:pt x="172986" y="880118"/>
                      <a:pt x="181174" y="871930"/>
                      <a:pt x="191274" y="871930"/>
                    </a:cubicBezTo>
                    <a:close/>
                    <a:moveTo>
                      <a:pt x="133612" y="871930"/>
                    </a:moveTo>
                    <a:cubicBezTo>
                      <a:pt x="143712" y="871930"/>
                      <a:pt x="151900" y="880118"/>
                      <a:pt x="151900" y="890218"/>
                    </a:cubicBezTo>
                    <a:cubicBezTo>
                      <a:pt x="151900" y="900318"/>
                      <a:pt x="143712" y="908506"/>
                      <a:pt x="133612" y="908506"/>
                    </a:cubicBezTo>
                    <a:cubicBezTo>
                      <a:pt x="123512" y="908506"/>
                      <a:pt x="115324" y="900318"/>
                      <a:pt x="115324" y="890218"/>
                    </a:cubicBezTo>
                    <a:cubicBezTo>
                      <a:pt x="115324" y="880118"/>
                      <a:pt x="123512" y="871930"/>
                      <a:pt x="133612" y="871930"/>
                    </a:cubicBezTo>
                    <a:close/>
                    <a:moveTo>
                      <a:pt x="75950" y="871930"/>
                    </a:moveTo>
                    <a:cubicBezTo>
                      <a:pt x="86050" y="871930"/>
                      <a:pt x="94238" y="880118"/>
                      <a:pt x="94238" y="890218"/>
                    </a:cubicBezTo>
                    <a:cubicBezTo>
                      <a:pt x="94238" y="900318"/>
                      <a:pt x="86050" y="908506"/>
                      <a:pt x="75950" y="908506"/>
                    </a:cubicBezTo>
                    <a:cubicBezTo>
                      <a:pt x="65850" y="908506"/>
                      <a:pt x="57662" y="900318"/>
                      <a:pt x="57662" y="890218"/>
                    </a:cubicBezTo>
                    <a:cubicBezTo>
                      <a:pt x="57662" y="880118"/>
                      <a:pt x="65850" y="871930"/>
                      <a:pt x="75950" y="871930"/>
                    </a:cubicBezTo>
                    <a:close/>
                    <a:moveTo>
                      <a:pt x="18288" y="871930"/>
                    </a:moveTo>
                    <a:cubicBezTo>
                      <a:pt x="28388" y="871930"/>
                      <a:pt x="36576" y="880118"/>
                      <a:pt x="36576" y="890218"/>
                    </a:cubicBezTo>
                    <a:cubicBezTo>
                      <a:pt x="36576" y="900318"/>
                      <a:pt x="28388" y="908506"/>
                      <a:pt x="18288" y="908506"/>
                    </a:cubicBezTo>
                    <a:cubicBezTo>
                      <a:pt x="8188" y="908506"/>
                      <a:pt x="0" y="900318"/>
                      <a:pt x="0" y="890218"/>
                    </a:cubicBezTo>
                    <a:cubicBezTo>
                      <a:pt x="0" y="880118"/>
                      <a:pt x="8188" y="871930"/>
                      <a:pt x="18288" y="871930"/>
                    </a:cubicBezTo>
                    <a:close/>
                    <a:moveTo>
                      <a:pt x="1459848" y="820640"/>
                    </a:moveTo>
                    <a:cubicBezTo>
                      <a:pt x="1469948" y="820640"/>
                      <a:pt x="1478136" y="828828"/>
                      <a:pt x="1478136" y="838928"/>
                    </a:cubicBezTo>
                    <a:cubicBezTo>
                      <a:pt x="1478136" y="849028"/>
                      <a:pt x="1469948" y="857216"/>
                      <a:pt x="1459848" y="857216"/>
                    </a:cubicBezTo>
                    <a:cubicBezTo>
                      <a:pt x="1449748" y="857216"/>
                      <a:pt x="1441560" y="849028"/>
                      <a:pt x="1441560" y="838928"/>
                    </a:cubicBezTo>
                    <a:cubicBezTo>
                      <a:pt x="1441560" y="828828"/>
                      <a:pt x="1449748" y="820640"/>
                      <a:pt x="1459848" y="820640"/>
                    </a:cubicBezTo>
                    <a:close/>
                    <a:moveTo>
                      <a:pt x="1402176" y="820640"/>
                    </a:moveTo>
                    <a:cubicBezTo>
                      <a:pt x="1412276" y="820640"/>
                      <a:pt x="1420464" y="828828"/>
                      <a:pt x="1420464" y="838928"/>
                    </a:cubicBezTo>
                    <a:cubicBezTo>
                      <a:pt x="1420464" y="849028"/>
                      <a:pt x="1412276" y="857216"/>
                      <a:pt x="1402176" y="857216"/>
                    </a:cubicBezTo>
                    <a:cubicBezTo>
                      <a:pt x="1392076" y="857216"/>
                      <a:pt x="1383888" y="849028"/>
                      <a:pt x="1383888" y="838928"/>
                    </a:cubicBezTo>
                    <a:cubicBezTo>
                      <a:pt x="1383888" y="828828"/>
                      <a:pt x="1392076" y="820640"/>
                      <a:pt x="1402176" y="820640"/>
                    </a:cubicBezTo>
                    <a:close/>
                    <a:moveTo>
                      <a:pt x="1344514" y="820640"/>
                    </a:moveTo>
                    <a:cubicBezTo>
                      <a:pt x="1354614" y="820640"/>
                      <a:pt x="1362802" y="828828"/>
                      <a:pt x="1362802" y="838928"/>
                    </a:cubicBezTo>
                    <a:cubicBezTo>
                      <a:pt x="1362802" y="849028"/>
                      <a:pt x="1354614" y="857216"/>
                      <a:pt x="1344514" y="857216"/>
                    </a:cubicBezTo>
                    <a:cubicBezTo>
                      <a:pt x="1334414" y="857216"/>
                      <a:pt x="1326226" y="849028"/>
                      <a:pt x="1326226" y="838928"/>
                    </a:cubicBezTo>
                    <a:cubicBezTo>
                      <a:pt x="1326226" y="828828"/>
                      <a:pt x="1334414" y="820640"/>
                      <a:pt x="1344514" y="820640"/>
                    </a:cubicBezTo>
                    <a:close/>
                    <a:moveTo>
                      <a:pt x="1286852" y="820640"/>
                    </a:moveTo>
                    <a:cubicBezTo>
                      <a:pt x="1296952" y="820640"/>
                      <a:pt x="1305140" y="828828"/>
                      <a:pt x="1305140" y="838928"/>
                    </a:cubicBezTo>
                    <a:cubicBezTo>
                      <a:pt x="1305140" y="849028"/>
                      <a:pt x="1296952" y="857216"/>
                      <a:pt x="1286852" y="857216"/>
                    </a:cubicBezTo>
                    <a:cubicBezTo>
                      <a:pt x="1276752" y="857216"/>
                      <a:pt x="1268564" y="849028"/>
                      <a:pt x="1268564" y="838928"/>
                    </a:cubicBezTo>
                    <a:cubicBezTo>
                      <a:pt x="1268564" y="828828"/>
                      <a:pt x="1276752" y="820640"/>
                      <a:pt x="1286852" y="820640"/>
                    </a:cubicBezTo>
                    <a:close/>
                    <a:moveTo>
                      <a:pt x="1229190" y="820640"/>
                    </a:moveTo>
                    <a:cubicBezTo>
                      <a:pt x="1239290" y="820640"/>
                      <a:pt x="1247478" y="828828"/>
                      <a:pt x="1247478" y="838928"/>
                    </a:cubicBezTo>
                    <a:cubicBezTo>
                      <a:pt x="1247478" y="849028"/>
                      <a:pt x="1239290" y="857216"/>
                      <a:pt x="1229190" y="857216"/>
                    </a:cubicBezTo>
                    <a:cubicBezTo>
                      <a:pt x="1219090" y="857216"/>
                      <a:pt x="1210902" y="849028"/>
                      <a:pt x="1210902" y="838928"/>
                    </a:cubicBezTo>
                    <a:cubicBezTo>
                      <a:pt x="1210902" y="828828"/>
                      <a:pt x="1219090" y="820640"/>
                      <a:pt x="1229190" y="820640"/>
                    </a:cubicBezTo>
                    <a:close/>
                    <a:moveTo>
                      <a:pt x="1171528" y="820640"/>
                    </a:moveTo>
                    <a:cubicBezTo>
                      <a:pt x="1181628" y="820640"/>
                      <a:pt x="1189816" y="828828"/>
                      <a:pt x="1189816" y="838928"/>
                    </a:cubicBezTo>
                    <a:cubicBezTo>
                      <a:pt x="1189816" y="849028"/>
                      <a:pt x="1181628" y="857216"/>
                      <a:pt x="1171528" y="857216"/>
                    </a:cubicBezTo>
                    <a:cubicBezTo>
                      <a:pt x="1161428" y="857216"/>
                      <a:pt x="1153240" y="849028"/>
                      <a:pt x="1153240" y="838928"/>
                    </a:cubicBezTo>
                    <a:cubicBezTo>
                      <a:pt x="1153240" y="828828"/>
                      <a:pt x="1161428" y="820640"/>
                      <a:pt x="1171528" y="820640"/>
                    </a:cubicBezTo>
                    <a:close/>
                    <a:moveTo>
                      <a:pt x="1113866" y="820640"/>
                    </a:moveTo>
                    <a:cubicBezTo>
                      <a:pt x="1123966" y="820640"/>
                      <a:pt x="1132154" y="828828"/>
                      <a:pt x="1132154" y="838928"/>
                    </a:cubicBezTo>
                    <a:cubicBezTo>
                      <a:pt x="1132154" y="849028"/>
                      <a:pt x="1123966" y="857216"/>
                      <a:pt x="1113866" y="857216"/>
                    </a:cubicBezTo>
                    <a:cubicBezTo>
                      <a:pt x="1103766" y="857216"/>
                      <a:pt x="1095578" y="849028"/>
                      <a:pt x="1095578" y="838928"/>
                    </a:cubicBezTo>
                    <a:cubicBezTo>
                      <a:pt x="1095578" y="828828"/>
                      <a:pt x="1103766" y="820640"/>
                      <a:pt x="1113866" y="820640"/>
                    </a:cubicBezTo>
                    <a:close/>
                    <a:moveTo>
                      <a:pt x="1056204" y="820640"/>
                    </a:moveTo>
                    <a:cubicBezTo>
                      <a:pt x="1066304" y="820640"/>
                      <a:pt x="1074492" y="828828"/>
                      <a:pt x="1074492" y="838928"/>
                    </a:cubicBezTo>
                    <a:cubicBezTo>
                      <a:pt x="1074492" y="849028"/>
                      <a:pt x="1066304" y="857216"/>
                      <a:pt x="1056204" y="857216"/>
                    </a:cubicBezTo>
                    <a:cubicBezTo>
                      <a:pt x="1046104" y="857216"/>
                      <a:pt x="1037916" y="849028"/>
                      <a:pt x="1037916" y="838928"/>
                    </a:cubicBezTo>
                    <a:cubicBezTo>
                      <a:pt x="1037916" y="828828"/>
                      <a:pt x="1046104" y="820640"/>
                      <a:pt x="1056204" y="820640"/>
                    </a:cubicBezTo>
                    <a:close/>
                    <a:moveTo>
                      <a:pt x="998542" y="820640"/>
                    </a:moveTo>
                    <a:cubicBezTo>
                      <a:pt x="1008642" y="820640"/>
                      <a:pt x="1016830" y="828828"/>
                      <a:pt x="1016830" y="838928"/>
                    </a:cubicBezTo>
                    <a:cubicBezTo>
                      <a:pt x="1016830" y="849028"/>
                      <a:pt x="1008642" y="857216"/>
                      <a:pt x="998542" y="857216"/>
                    </a:cubicBezTo>
                    <a:cubicBezTo>
                      <a:pt x="988442" y="857216"/>
                      <a:pt x="980254" y="849028"/>
                      <a:pt x="980254" y="838928"/>
                    </a:cubicBezTo>
                    <a:cubicBezTo>
                      <a:pt x="980254" y="828828"/>
                      <a:pt x="988442" y="820640"/>
                      <a:pt x="998542" y="820640"/>
                    </a:cubicBezTo>
                    <a:close/>
                    <a:moveTo>
                      <a:pt x="940880" y="820640"/>
                    </a:moveTo>
                    <a:cubicBezTo>
                      <a:pt x="950980" y="820640"/>
                      <a:pt x="959168" y="828828"/>
                      <a:pt x="959168" y="838928"/>
                    </a:cubicBezTo>
                    <a:cubicBezTo>
                      <a:pt x="959168" y="849028"/>
                      <a:pt x="950980" y="857216"/>
                      <a:pt x="940880" y="857216"/>
                    </a:cubicBezTo>
                    <a:cubicBezTo>
                      <a:pt x="930780" y="857216"/>
                      <a:pt x="922592" y="849028"/>
                      <a:pt x="922592" y="838928"/>
                    </a:cubicBezTo>
                    <a:cubicBezTo>
                      <a:pt x="922592" y="828828"/>
                      <a:pt x="930780" y="820640"/>
                      <a:pt x="940880" y="820640"/>
                    </a:cubicBezTo>
                    <a:close/>
                    <a:moveTo>
                      <a:pt x="883218" y="820640"/>
                    </a:moveTo>
                    <a:cubicBezTo>
                      <a:pt x="893318" y="820640"/>
                      <a:pt x="901506" y="828828"/>
                      <a:pt x="901506" y="838928"/>
                    </a:cubicBezTo>
                    <a:cubicBezTo>
                      <a:pt x="901506" y="849028"/>
                      <a:pt x="893318" y="857216"/>
                      <a:pt x="883218" y="857216"/>
                    </a:cubicBezTo>
                    <a:cubicBezTo>
                      <a:pt x="873118" y="857216"/>
                      <a:pt x="864930" y="849028"/>
                      <a:pt x="864930" y="838928"/>
                    </a:cubicBezTo>
                    <a:cubicBezTo>
                      <a:pt x="864930" y="828828"/>
                      <a:pt x="873118" y="820640"/>
                      <a:pt x="883218" y="820640"/>
                    </a:cubicBezTo>
                    <a:close/>
                    <a:moveTo>
                      <a:pt x="825556" y="820640"/>
                    </a:moveTo>
                    <a:cubicBezTo>
                      <a:pt x="835656" y="820640"/>
                      <a:pt x="843844" y="828828"/>
                      <a:pt x="843844" y="838928"/>
                    </a:cubicBezTo>
                    <a:cubicBezTo>
                      <a:pt x="843844" y="849028"/>
                      <a:pt x="835656" y="857216"/>
                      <a:pt x="825556" y="857216"/>
                    </a:cubicBezTo>
                    <a:cubicBezTo>
                      <a:pt x="815456" y="857216"/>
                      <a:pt x="807268" y="849028"/>
                      <a:pt x="807268" y="838928"/>
                    </a:cubicBezTo>
                    <a:cubicBezTo>
                      <a:pt x="807268" y="828828"/>
                      <a:pt x="815456" y="820640"/>
                      <a:pt x="825556" y="820640"/>
                    </a:cubicBezTo>
                    <a:close/>
                    <a:moveTo>
                      <a:pt x="767894" y="820640"/>
                    </a:moveTo>
                    <a:cubicBezTo>
                      <a:pt x="777994" y="820640"/>
                      <a:pt x="786182" y="828828"/>
                      <a:pt x="786182" y="838928"/>
                    </a:cubicBezTo>
                    <a:cubicBezTo>
                      <a:pt x="786182" y="849028"/>
                      <a:pt x="777994" y="857216"/>
                      <a:pt x="767894" y="857216"/>
                    </a:cubicBezTo>
                    <a:cubicBezTo>
                      <a:pt x="757794" y="857216"/>
                      <a:pt x="749606" y="849028"/>
                      <a:pt x="749606" y="838928"/>
                    </a:cubicBezTo>
                    <a:cubicBezTo>
                      <a:pt x="749606" y="828828"/>
                      <a:pt x="757794" y="820640"/>
                      <a:pt x="767894" y="820640"/>
                    </a:cubicBezTo>
                    <a:close/>
                    <a:moveTo>
                      <a:pt x="710232" y="820640"/>
                    </a:moveTo>
                    <a:cubicBezTo>
                      <a:pt x="720332" y="820640"/>
                      <a:pt x="728520" y="828828"/>
                      <a:pt x="728520" y="838928"/>
                    </a:cubicBezTo>
                    <a:cubicBezTo>
                      <a:pt x="728520" y="849028"/>
                      <a:pt x="720332" y="857216"/>
                      <a:pt x="710232" y="857216"/>
                    </a:cubicBezTo>
                    <a:cubicBezTo>
                      <a:pt x="700132" y="857216"/>
                      <a:pt x="691944" y="849028"/>
                      <a:pt x="691944" y="838928"/>
                    </a:cubicBezTo>
                    <a:cubicBezTo>
                      <a:pt x="691944" y="828828"/>
                      <a:pt x="700132" y="820640"/>
                      <a:pt x="710232" y="820640"/>
                    </a:cubicBezTo>
                    <a:close/>
                    <a:moveTo>
                      <a:pt x="652570" y="820640"/>
                    </a:moveTo>
                    <a:cubicBezTo>
                      <a:pt x="662670" y="820640"/>
                      <a:pt x="670858" y="828828"/>
                      <a:pt x="670858" y="838928"/>
                    </a:cubicBezTo>
                    <a:cubicBezTo>
                      <a:pt x="670858" y="849028"/>
                      <a:pt x="662670" y="857216"/>
                      <a:pt x="652570" y="857216"/>
                    </a:cubicBezTo>
                    <a:cubicBezTo>
                      <a:pt x="642470" y="857216"/>
                      <a:pt x="634282" y="849028"/>
                      <a:pt x="634282" y="838928"/>
                    </a:cubicBezTo>
                    <a:cubicBezTo>
                      <a:pt x="634282" y="828828"/>
                      <a:pt x="642470" y="820640"/>
                      <a:pt x="652570" y="820640"/>
                    </a:cubicBezTo>
                    <a:close/>
                    <a:moveTo>
                      <a:pt x="594908" y="820640"/>
                    </a:moveTo>
                    <a:cubicBezTo>
                      <a:pt x="605008" y="820640"/>
                      <a:pt x="613196" y="828828"/>
                      <a:pt x="613196" y="838928"/>
                    </a:cubicBezTo>
                    <a:cubicBezTo>
                      <a:pt x="613196" y="849028"/>
                      <a:pt x="605008" y="857216"/>
                      <a:pt x="594908" y="857216"/>
                    </a:cubicBezTo>
                    <a:cubicBezTo>
                      <a:pt x="584808" y="857216"/>
                      <a:pt x="576620" y="849028"/>
                      <a:pt x="576620" y="838928"/>
                    </a:cubicBezTo>
                    <a:cubicBezTo>
                      <a:pt x="576620" y="828828"/>
                      <a:pt x="584808" y="820640"/>
                      <a:pt x="594908" y="820640"/>
                    </a:cubicBezTo>
                    <a:close/>
                    <a:moveTo>
                      <a:pt x="537246" y="820640"/>
                    </a:moveTo>
                    <a:cubicBezTo>
                      <a:pt x="547346" y="820640"/>
                      <a:pt x="555534" y="828828"/>
                      <a:pt x="555534" y="838928"/>
                    </a:cubicBezTo>
                    <a:cubicBezTo>
                      <a:pt x="555534" y="849028"/>
                      <a:pt x="547346" y="857216"/>
                      <a:pt x="537246" y="857216"/>
                    </a:cubicBezTo>
                    <a:cubicBezTo>
                      <a:pt x="527146" y="857216"/>
                      <a:pt x="518958" y="849028"/>
                      <a:pt x="518958" y="838928"/>
                    </a:cubicBezTo>
                    <a:cubicBezTo>
                      <a:pt x="518958" y="828828"/>
                      <a:pt x="527146" y="820640"/>
                      <a:pt x="537246" y="820640"/>
                    </a:cubicBezTo>
                    <a:close/>
                    <a:moveTo>
                      <a:pt x="479584" y="820640"/>
                    </a:moveTo>
                    <a:cubicBezTo>
                      <a:pt x="489684" y="820640"/>
                      <a:pt x="497872" y="828828"/>
                      <a:pt x="497872" y="838928"/>
                    </a:cubicBezTo>
                    <a:cubicBezTo>
                      <a:pt x="497872" y="849028"/>
                      <a:pt x="489684" y="857216"/>
                      <a:pt x="479584" y="857216"/>
                    </a:cubicBezTo>
                    <a:cubicBezTo>
                      <a:pt x="469484" y="857216"/>
                      <a:pt x="461296" y="849028"/>
                      <a:pt x="461296" y="838928"/>
                    </a:cubicBezTo>
                    <a:cubicBezTo>
                      <a:pt x="461296" y="828828"/>
                      <a:pt x="469484" y="820640"/>
                      <a:pt x="479584" y="820640"/>
                    </a:cubicBezTo>
                    <a:close/>
                    <a:moveTo>
                      <a:pt x="421922" y="820640"/>
                    </a:moveTo>
                    <a:cubicBezTo>
                      <a:pt x="432022" y="820640"/>
                      <a:pt x="440210" y="828828"/>
                      <a:pt x="440210" y="838928"/>
                    </a:cubicBezTo>
                    <a:cubicBezTo>
                      <a:pt x="440210" y="849028"/>
                      <a:pt x="432022" y="857216"/>
                      <a:pt x="421922" y="857216"/>
                    </a:cubicBezTo>
                    <a:cubicBezTo>
                      <a:pt x="411822" y="857216"/>
                      <a:pt x="403634" y="849028"/>
                      <a:pt x="403634" y="838928"/>
                    </a:cubicBezTo>
                    <a:cubicBezTo>
                      <a:pt x="403634" y="828828"/>
                      <a:pt x="411822" y="820640"/>
                      <a:pt x="421922" y="820640"/>
                    </a:cubicBezTo>
                    <a:close/>
                    <a:moveTo>
                      <a:pt x="364260" y="820640"/>
                    </a:moveTo>
                    <a:cubicBezTo>
                      <a:pt x="374360" y="820640"/>
                      <a:pt x="382548" y="828828"/>
                      <a:pt x="382548" y="838928"/>
                    </a:cubicBezTo>
                    <a:cubicBezTo>
                      <a:pt x="382548" y="849028"/>
                      <a:pt x="374360" y="857216"/>
                      <a:pt x="364260" y="857216"/>
                    </a:cubicBezTo>
                    <a:cubicBezTo>
                      <a:pt x="354160" y="857216"/>
                      <a:pt x="345972" y="849028"/>
                      <a:pt x="345972" y="838928"/>
                    </a:cubicBezTo>
                    <a:cubicBezTo>
                      <a:pt x="345972" y="828828"/>
                      <a:pt x="354160" y="820640"/>
                      <a:pt x="364260" y="820640"/>
                    </a:cubicBezTo>
                    <a:close/>
                    <a:moveTo>
                      <a:pt x="306598" y="820640"/>
                    </a:moveTo>
                    <a:cubicBezTo>
                      <a:pt x="316698" y="820640"/>
                      <a:pt x="324886" y="828828"/>
                      <a:pt x="324886" y="838928"/>
                    </a:cubicBezTo>
                    <a:cubicBezTo>
                      <a:pt x="324886" y="849028"/>
                      <a:pt x="316698" y="857216"/>
                      <a:pt x="306598" y="857216"/>
                    </a:cubicBezTo>
                    <a:cubicBezTo>
                      <a:pt x="296498" y="857216"/>
                      <a:pt x="288310" y="849028"/>
                      <a:pt x="288310" y="838928"/>
                    </a:cubicBezTo>
                    <a:cubicBezTo>
                      <a:pt x="288310" y="828828"/>
                      <a:pt x="296498" y="820640"/>
                      <a:pt x="306598" y="820640"/>
                    </a:cubicBezTo>
                    <a:close/>
                    <a:moveTo>
                      <a:pt x="248936" y="820640"/>
                    </a:moveTo>
                    <a:cubicBezTo>
                      <a:pt x="259036" y="820640"/>
                      <a:pt x="267224" y="828828"/>
                      <a:pt x="267224" y="838928"/>
                    </a:cubicBezTo>
                    <a:cubicBezTo>
                      <a:pt x="267224" y="849028"/>
                      <a:pt x="259036" y="857216"/>
                      <a:pt x="248936" y="857216"/>
                    </a:cubicBezTo>
                    <a:cubicBezTo>
                      <a:pt x="238836" y="857216"/>
                      <a:pt x="230648" y="849028"/>
                      <a:pt x="230648" y="838928"/>
                    </a:cubicBezTo>
                    <a:cubicBezTo>
                      <a:pt x="230648" y="828828"/>
                      <a:pt x="238836" y="820640"/>
                      <a:pt x="248936" y="820640"/>
                    </a:cubicBezTo>
                    <a:close/>
                    <a:moveTo>
                      <a:pt x="191274" y="820640"/>
                    </a:moveTo>
                    <a:cubicBezTo>
                      <a:pt x="201374" y="820640"/>
                      <a:pt x="209562" y="828828"/>
                      <a:pt x="209562" y="838928"/>
                    </a:cubicBezTo>
                    <a:cubicBezTo>
                      <a:pt x="209562" y="849028"/>
                      <a:pt x="201374" y="857216"/>
                      <a:pt x="191274" y="857216"/>
                    </a:cubicBezTo>
                    <a:cubicBezTo>
                      <a:pt x="181174" y="857216"/>
                      <a:pt x="172986" y="849028"/>
                      <a:pt x="172986" y="838928"/>
                    </a:cubicBezTo>
                    <a:cubicBezTo>
                      <a:pt x="172986" y="828828"/>
                      <a:pt x="181174" y="820640"/>
                      <a:pt x="191274" y="820640"/>
                    </a:cubicBezTo>
                    <a:close/>
                    <a:moveTo>
                      <a:pt x="133612" y="820640"/>
                    </a:moveTo>
                    <a:cubicBezTo>
                      <a:pt x="143712" y="820640"/>
                      <a:pt x="151900" y="828828"/>
                      <a:pt x="151900" y="838928"/>
                    </a:cubicBezTo>
                    <a:cubicBezTo>
                      <a:pt x="151900" y="849028"/>
                      <a:pt x="143712" y="857216"/>
                      <a:pt x="133612" y="857216"/>
                    </a:cubicBezTo>
                    <a:cubicBezTo>
                      <a:pt x="123512" y="857216"/>
                      <a:pt x="115324" y="849028"/>
                      <a:pt x="115324" y="838928"/>
                    </a:cubicBezTo>
                    <a:cubicBezTo>
                      <a:pt x="115324" y="828828"/>
                      <a:pt x="123512" y="820640"/>
                      <a:pt x="133612" y="820640"/>
                    </a:cubicBezTo>
                    <a:close/>
                    <a:moveTo>
                      <a:pt x="75950" y="820640"/>
                    </a:moveTo>
                    <a:cubicBezTo>
                      <a:pt x="86050" y="820640"/>
                      <a:pt x="94238" y="828828"/>
                      <a:pt x="94238" y="838928"/>
                    </a:cubicBezTo>
                    <a:cubicBezTo>
                      <a:pt x="94238" y="849028"/>
                      <a:pt x="86050" y="857216"/>
                      <a:pt x="75950" y="857216"/>
                    </a:cubicBezTo>
                    <a:cubicBezTo>
                      <a:pt x="65850" y="857216"/>
                      <a:pt x="57662" y="849028"/>
                      <a:pt x="57662" y="838928"/>
                    </a:cubicBezTo>
                    <a:cubicBezTo>
                      <a:pt x="57662" y="828828"/>
                      <a:pt x="65850" y="820640"/>
                      <a:pt x="75950" y="820640"/>
                    </a:cubicBezTo>
                    <a:close/>
                    <a:moveTo>
                      <a:pt x="18288" y="820640"/>
                    </a:moveTo>
                    <a:cubicBezTo>
                      <a:pt x="28388" y="820640"/>
                      <a:pt x="36576" y="828828"/>
                      <a:pt x="36576" y="838928"/>
                    </a:cubicBezTo>
                    <a:cubicBezTo>
                      <a:pt x="36576" y="849028"/>
                      <a:pt x="28388" y="857216"/>
                      <a:pt x="18288" y="857216"/>
                    </a:cubicBezTo>
                    <a:cubicBezTo>
                      <a:pt x="8188" y="857216"/>
                      <a:pt x="0" y="849028"/>
                      <a:pt x="0" y="838928"/>
                    </a:cubicBezTo>
                    <a:cubicBezTo>
                      <a:pt x="0" y="828828"/>
                      <a:pt x="8188" y="820640"/>
                      <a:pt x="18288" y="820640"/>
                    </a:cubicBezTo>
                    <a:close/>
                    <a:moveTo>
                      <a:pt x="1459848" y="769350"/>
                    </a:moveTo>
                    <a:cubicBezTo>
                      <a:pt x="1469948" y="769350"/>
                      <a:pt x="1478136" y="777538"/>
                      <a:pt x="1478136" y="787638"/>
                    </a:cubicBezTo>
                    <a:cubicBezTo>
                      <a:pt x="1478136" y="797738"/>
                      <a:pt x="1469948" y="805926"/>
                      <a:pt x="1459848" y="805926"/>
                    </a:cubicBezTo>
                    <a:cubicBezTo>
                      <a:pt x="1449748" y="805926"/>
                      <a:pt x="1441560" y="797738"/>
                      <a:pt x="1441560" y="787638"/>
                    </a:cubicBezTo>
                    <a:cubicBezTo>
                      <a:pt x="1441560" y="777538"/>
                      <a:pt x="1449748" y="769350"/>
                      <a:pt x="1459848" y="769350"/>
                    </a:cubicBezTo>
                    <a:close/>
                    <a:moveTo>
                      <a:pt x="1402176" y="769350"/>
                    </a:moveTo>
                    <a:cubicBezTo>
                      <a:pt x="1412276" y="769350"/>
                      <a:pt x="1420464" y="777538"/>
                      <a:pt x="1420464" y="787638"/>
                    </a:cubicBezTo>
                    <a:cubicBezTo>
                      <a:pt x="1420464" y="797738"/>
                      <a:pt x="1412276" y="805926"/>
                      <a:pt x="1402176" y="805926"/>
                    </a:cubicBezTo>
                    <a:cubicBezTo>
                      <a:pt x="1392076" y="805926"/>
                      <a:pt x="1383888" y="797738"/>
                      <a:pt x="1383888" y="787638"/>
                    </a:cubicBezTo>
                    <a:cubicBezTo>
                      <a:pt x="1383888" y="777538"/>
                      <a:pt x="1392076" y="769350"/>
                      <a:pt x="1402176" y="769350"/>
                    </a:cubicBezTo>
                    <a:close/>
                    <a:moveTo>
                      <a:pt x="1344514" y="769350"/>
                    </a:moveTo>
                    <a:cubicBezTo>
                      <a:pt x="1354614" y="769350"/>
                      <a:pt x="1362802" y="777538"/>
                      <a:pt x="1362802" y="787638"/>
                    </a:cubicBezTo>
                    <a:cubicBezTo>
                      <a:pt x="1362802" y="797738"/>
                      <a:pt x="1354614" y="805926"/>
                      <a:pt x="1344514" y="805926"/>
                    </a:cubicBezTo>
                    <a:cubicBezTo>
                      <a:pt x="1334414" y="805926"/>
                      <a:pt x="1326226" y="797738"/>
                      <a:pt x="1326226" y="787638"/>
                    </a:cubicBezTo>
                    <a:cubicBezTo>
                      <a:pt x="1326226" y="777538"/>
                      <a:pt x="1334414" y="769350"/>
                      <a:pt x="1344514" y="769350"/>
                    </a:cubicBezTo>
                    <a:close/>
                    <a:moveTo>
                      <a:pt x="1286852" y="769350"/>
                    </a:moveTo>
                    <a:cubicBezTo>
                      <a:pt x="1296952" y="769350"/>
                      <a:pt x="1305140" y="777538"/>
                      <a:pt x="1305140" y="787638"/>
                    </a:cubicBezTo>
                    <a:cubicBezTo>
                      <a:pt x="1305140" y="797738"/>
                      <a:pt x="1296952" y="805926"/>
                      <a:pt x="1286852" y="805926"/>
                    </a:cubicBezTo>
                    <a:cubicBezTo>
                      <a:pt x="1276752" y="805926"/>
                      <a:pt x="1268564" y="797738"/>
                      <a:pt x="1268564" y="787638"/>
                    </a:cubicBezTo>
                    <a:cubicBezTo>
                      <a:pt x="1268564" y="777538"/>
                      <a:pt x="1276752" y="769350"/>
                      <a:pt x="1286852" y="769350"/>
                    </a:cubicBezTo>
                    <a:close/>
                    <a:moveTo>
                      <a:pt x="1229190" y="769350"/>
                    </a:moveTo>
                    <a:cubicBezTo>
                      <a:pt x="1239290" y="769350"/>
                      <a:pt x="1247478" y="777538"/>
                      <a:pt x="1247478" y="787638"/>
                    </a:cubicBezTo>
                    <a:cubicBezTo>
                      <a:pt x="1247478" y="797738"/>
                      <a:pt x="1239290" y="805926"/>
                      <a:pt x="1229190" y="805926"/>
                    </a:cubicBezTo>
                    <a:cubicBezTo>
                      <a:pt x="1219090" y="805926"/>
                      <a:pt x="1210902" y="797738"/>
                      <a:pt x="1210902" y="787638"/>
                    </a:cubicBezTo>
                    <a:cubicBezTo>
                      <a:pt x="1210902" y="777538"/>
                      <a:pt x="1219090" y="769350"/>
                      <a:pt x="1229190" y="769350"/>
                    </a:cubicBezTo>
                    <a:close/>
                    <a:moveTo>
                      <a:pt x="1171528" y="769350"/>
                    </a:moveTo>
                    <a:cubicBezTo>
                      <a:pt x="1181628" y="769350"/>
                      <a:pt x="1189816" y="777538"/>
                      <a:pt x="1189816" y="787638"/>
                    </a:cubicBezTo>
                    <a:cubicBezTo>
                      <a:pt x="1189816" y="797738"/>
                      <a:pt x="1181628" y="805926"/>
                      <a:pt x="1171528" y="805926"/>
                    </a:cubicBezTo>
                    <a:cubicBezTo>
                      <a:pt x="1161428" y="805926"/>
                      <a:pt x="1153240" y="797738"/>
                      <a:pt x="1153240" y="787638"/>
                    </a:cubicBezTo>
                    <a:cubicBezTo>
                      <a:pt x="1153240" y="777538"/>
                      <a:pt x="1161428" y="769350"/>
                      <a:pt x="1171528" y="769350"/>
                    </a:cubicBezTo>
                    <a:close/>
                    <a:moveTo>
                      <a:pt x="1113866" y="769350"/>
                    </a:moveTo>
                    <a:cubicBezTo>
                      <a:pt x="1123966" y="769350"/>
                      <a:pt x="1132154" y="777538"/>
                      <a:pt x="1132154" y="787638"/>
                    </a:cubicBezTo>
                    <a:cubicBezTo>
                      <a:pt x="1132154" y="797738"/>
                      <a:pt x="1123966" y="805926"/>
                      <a:pt x="1113866" y="805926"/>
                    </a:cubicBezTo>
                    <a:cubicBezTo>
                      <a:pt x="1103766" y="805926"/>
                      <a:pt x="1095578" y="797738"/>
                      <a:pt x="1095578" y="787638"/>
                    </a:cubicBezTo>
                    <a:cubicBezTo>
                      <a:pt x="1095578" y="777538"/>
                      <a:pt x="1103766" y="769350"/>
                      <a:pt x="1113866" y="769350"/>
                    </a:cubicBezTo>
                    <a:close/>
                    <a:moveTo>
                      <a:pt x="1056204" y="769350"/>
                    </a:moveTo>
                    <a:cubicBezTo>
                      <a:pt x="1066304" y="769350"/>
                      <a:pt x="1074492" y="777538"/>
                      <a:pt x="1074492" y="787638"/>
                    </a:cubicBezTo>
                    <a:cubicBezTo>
                      <a:pt x="1074492" y="797738"/>
                      <a:pt x="1066304" y="805926"/>
                      <a:pt x="1056204" y="805926"/>
                    </a:cubicBezTo>
                    <a:cubicBezTo>
                      <a:pt x="1046104" y="805926"/>
                      <a:pt x="1037916" y="797738"/>
                      <a:pt x="1037916" y="787638"/>
                    </a:cubicBezTo>
                    <a:cubicBezTo>
                      <a:pt x="1037916" y="777538"/>
                      <a:pt x="1046104" y="769350"/>
                      <a:pt x="1056204" y="769350"/>
                    </a:cubicBezTo>
                    <a:close/>
                    <a:moveTo>
                      <a:pt x="998542" y="769350"/>
                    </a:moveTo>
                    <a:cubicBezTo>
                      <a:pt x="1008642" y="769350"/>
                      <a:pt x="1016830" y="777538"/>
                      <a:pt x="1016830" y="787638"/>
                    </a:cubicBezTo>
                    <a:cubicBezTo>
                      <a:pt x="1016830" y="797738"/>
                      <a:pt x="1008642" y="805926"/>
                      <a:pt x="998542" y="805926"/>
                    </a:cubicBezTo>
                    <a:cubicBezTo>
                      <a:pt x="988442" y="805926"/>
                      <a:pt x="980254" y="797738"/>
                      <a:pt x="980254" y="787638"/>
                    </a:cubicBezTo>
                    <a:cubicBezTo>
                      <a:pt x="980254" y="777538"/>
                      <a:pt x="988442" y="769350"/>
                      <a:pt x="998542" y="769350"/>
                    </a:cubicBezTo>
                    <a:close/>
                    <a:moveTo>
                      <a:pt x="940880" y="769350"/>
                    </a:moveTo>
                    <a:cubicBezTo>
                      <a:pt x="950980" y="769350"/>
                      <a:pt x="959168" y="777538"/>
                      <a:pt x="959168" y="787638"/>
                    </a:cubicBezTo>
                    <a:cubicBezTo>
                      <a:pt x="959168" y="797738"/>
                      <a:pt x="950980" y="805926"/>
                      <a:pt x="940880" y="805926"/>
                    </a:cubicBezTo>
                    <a:cubicBezTo>
                      <a:pt x="930780" y="805926"/>
                      <a:pt x="922592" y="797738"/>
                      <a:pt x="922592" y="787638"/>
                    </a:cubicBezTo>
                    <a:cubicBezTo>
                      <a:pt x="922592" y="777538"/>
                      <a:pt x="930780" y="769350"/>
                      <a:pt x="940880" y="769350"/>
                    </a:cubicBezTo>
                    <a:close/>
                    <a:moveTo>
                      <a:pt x="883218" y="769350"/>
                    </a:moveTo>
                    <a:cubicBezTo>
                      <a:pt x="893318" y="769350"/>
                      <a:pt x="901506" y="777538"/>
                      <a:pt x="901506" y="787638"/>
                    </a:cubicBezTo>
                    <a:cubicBezTo>
                      <a:pt x="901506" y="797738"/>
                      <a:pt x="893318" y="805926"/>
                      <a:pt x="883218" y="805926"/>
                    </a:cubicBezTo>
                    <a:cubicBezTo>
                      <a:pt x="873118" y="805926"/>
                      <a:pt x="864930" y="797738"/>
                      <a:pt x="864930" y="787638"/>
                    </a:cubicBezTo>
                    <a:cubicBezTo>
                      <a:pt x="864930" y="777538"/>
                      <a:pt x="873118" y="769350"/>
                      <a:pt x="883218" y="769350"/>
                    </a:cubicBezTo>
                    <a:close/>
                    <a:moveTo>
                      <a:pt x="825556" y="769350"/>
                    </a:moveTo>
                    <a:cubicBezTo>
                      <a:pt x="835656" y="769350"/>
                      <a:pt x="843844" y="777538"/>
                      <a:pt x="843844" y="787638"/>
                    </a:cubicBezTo>
                    <a:cubicBezTo>
                      <a:pt x="843844" y="797738"/>
                      <a:pt x="835656" y="805926"/>
                      <a:pt x="825556" y="805926"/>
                    </a:cubicBezTo>
                    <a:cubicBezTo>
                      <a:pt x="815456" y="805926"/>
                      <a:pt x="807268" y="797738"/>
                      <a:pt x="807268" y="787638"/>
                    </a:cubicBezTo>
                    <a:cubicBezTo>
                      <a:pt x="807268" y="777538"/>
                      <a:pt x="815456" y="769350"/>
                      <a:pt x="825556" y="769350"/>
                    </a:cubicBezTo>
                    <a:close/>
                    <a:moveTo>
                      <a:pt x="767894" y="769350"/>
                    </a:moveTo>
                    <a:cubicBezTo>
                      <a:pt x="777994" y="769350"/>
                      <a:pt x="786182" y="777538"/>
                      <a:pt x="786182" y="787638"/>
                    </a:cubicBezTo>
                    <a:cubicBezTo>
                      <a:pt x="786182" y="797738"/>
                      <a:pt x="777994" y="805926"/>
                      <a:pt x="767894" y="805926"/>
                    </a:cubicBezTo>
                    <a:cubicBezTo>
                      <a:pt x="757794" y="805926"/>
                      <a:pt x="749606" y="797738"/>
                      <a:pt x="749606" y="787638"/>
                    </a:cubicBezTo>
                    <a:cubicBezTo>
                      <a:pt x="749606" y="777538"/>
                      <a:pt x="757794" y="769350"/>
                      <a:pt x="767894" y="769350"/>
                    </a:cubicBezTo>
                    <a:close/>
                    <a:moveTo>
                      <a:pt x="710232" y="769350"/>
                    </a:moveTo>
                    <a:cubicBezTo>
                      <a:pt x="720332" y="769350"/>
                      <a:pt x="728520" y="777538"/>
                      <a:pt x="728520" y="787638"/>
                    </a:cubicBezTo>
                    <a:cubicBezTo>
                      <a:pt x="728520" y="797738"/>
                      <a:pt x="720332" y="805926"/>
                      <a:pt x="710232" y="805926"/>
                    </a:cubicBezTo>
                    <a:cubicBezTo>
                      <a:pt x="700132" y="805926"/>
                      <a:pt x="691944" y="797738"/>
                      <a:pt x="691944" y="787638"/>
                    </a:cubicBezTo>
                    <a:cubicBezTo>
                      <a:pt x="691944" y="777538"/>
                      <a:pt x="700132" y="769350"/>
                      <a:pt x="710232" y="769350"/>
                    </a:cubicBezTo>
                    <a:close/>
                    <a:moveTo>
                      <a:pt x="652570" y="769350"/>
                    </a:moveTo>
                    <a:cubicBezTo>
                      <a:pt x="662670" y="769350"/>
                      <a:pt x="670858" y="777538"/>
                      <a:pt x="670858" y="787638"/>
                    </a:cubicBezTo>
                    <a:cubicBezTo>
                      <a:pt x="670858" y="797738"/>
                      <a:pt x="662670" y="805926"/>
                      <a:pt x="652570" y="805926"/>
                    </a:cubicBezTo>
                    <a:cubicBezTo>
                      <a:pt x="642470" y="805926"/>
                      <a:pt x="634282" y="797738"/>
                      <a:pt x="634282" y="787638"/>
                    </a:cubicBezTo>
                    <a:cubicBezTo>
                      <a:pt x="634282" y="777538"/>
                      <a:pt x="642470" y="769350"/>
                      <a:pt x="652570" y="769350"/>
                    </a:cubicBezTo>
                    <a:close/>
                    <a:moveTo>
                      <a:pt x="594908" y="769350"/>
                    </a:moveTo>
                    <a:cubicBezTo>
                      <a:pt x="605008" y="769350"/>
                      <a:pt x="613196" y="777538"/>
                      <a:pt x="613196" y="787638"/>
                    </a:cubicBezTo>
                    <a:cubicBezTo>
                      <a:pt x="613196" y="797738"/>
                      <a:pt x="605008" y="805926"/>
                      <a:pt x="594908" y="805926"/>
                    </a:cubicBezTo>
                    <a:cubicBezTo>
                      <a:pt x="584808" y="805926"/>
                      <a:pt x="576620" y="797738"/>
                      <a:pt x="576620" y="787638"/>
                    </a:cubicBezTo>
                    <a:cubicBezTo>
                      <a:pt x="576620" y="777538"/>
                      <a:pt x="584808" y="769350"/>
                      <a:pt x="594908" y="769350"/>
                    </a:cubicBezTo>
                    <a:close/>
                    <a:moveTo>
                      <a:pt x="537246" y="769350"/>
                    </a:moveTo>
                    <a:cubicBezTo>
                      <a:pt x="547346" y="769350"/>
                      <a:pt x="555534" y="777538"/>
                      <a:pt x="555534" y="787638"/>
                    </a:cubicBezTo>
                    <a:cubicBezTo>
                      <a:pt x="555534" y="797738"/>
                      <a:pt x="547346" y="805926"/>
                      <a:pt x="537246" y="805926"/>
                    </a:cubicBezTo>
                    <a:cubicBezTo>
                      <a:pt x="527146" y="805926"/>
                      <a:pt x="518958" y="797738"/>
                      <a:pt x="518958" y="787638"/>
                    </a:cubicBezTo>
                    <a:cubicBezTo>
                      <a:pt x="518958" y="777538"/>
                      <a:pt x="527146" y="769350"/>
                      <a:pt x="537246" y="769350"/>
                    </a:cubicBezTo>
                    <a:close/>
                    <a:moveTo>
                      <a:pt x="479584" y="769350"/>
                    </a:moveTo>
                    <a:cubicBezTo>
                      <a:pt x="489684" y="769350"/>
                      <a:pt x="497872" y="777538"/>
                      <a:pt x="497872" y="787638"/>
                    </a:cubicBezTo>
                    <a:cubicBezTo>
                      <a:pt x="497872" y="797738"/>
                      <a:pt x="489684" y="805926"/>
                      <a:pt x="479584" y="805926"/>
                    </a:cubicBezTo>
                    <a:cubicBezTo>
                      <a:pt x="469484" y="805926"/>
                      <a:pt x="461296" y="797738"/>
                      <a:pt x="461296" y="787638"/>
                    </a:cubicBezTo>
                    <a:cubicBezTo>
                      <a:pt x="461296" y="777538"/>
                      <a:pt x="469484" y="769350"/>
                      <a:pt x="479584" y="769350"/>
                    </a:cubicBezTo>
                    <a:close/>
                    <a:moveTo>
                      <a:pt x="421922" y="769350"/>
                    </a:moveTo>
                    <a:cubicBezTo>
                      <a:pt x="432022" y="769350"/>
                      <a:pt x="440210" y="777538"/>
                      <a:pt x="440210" y="787638"/>
                    </a:cubicBezTo>
                    <a:cubicBezTo>
                      <a:pt x="440210" y="797738"/>
                      <a:pt x="432022" y="805926"/>
                      <a:pt x="421922" y="805926"/>
                    </a:cubicBezTo>
                    <a:cubicBezTo>
                      <a:pt x="411822" y="805926"/>
                      <a:pt x="403634" y="797738"/>
                      <a:pt x="403634" y="787638"/>
                    </a:cubicBezTo>
                    <a:cubicBezTo>
                      <a:pt x="403634" y="777538"/>
                      <a:pt x="411822" y="769350"/>
                      <a:pt x="421922" y="769350"/>
                    </a:cubicBezTo>
                    <a:close/>
                    <a:moveTo>
                      <a:pt x="364260" y="769350"/>
                    </a:moveTo>
                    <a:cubicBezTo>
                      <a:pt x="374360" y="769350"/>
                      <a:pt x="382548" y="777538"/>
                      <a:pt x="382548" y="787638"/>
                    </a:cubicBezTo>
                    <a:cubicBezTo>
                      <a:pt x="382548" y="797738"/>
                      <a:pt x="374360" y="805926"/>
                      <a:pt x="364260" y="805926"/>
                    </a:cubicBezTo>
                    <a:cubicBezTo>
                      <a:pt x="354160" y="805926"/>
                      <a:pt x="345972" y="797738"/>
                      <a:pt x="345972" y="787638"/>
                    </a:cubicBezTo>
                    <a:cubicBezTo>
                      <a:pt x="345972" y="777538"/>
                      <a:pt x="354160" y="769350"/>
                      <a:pt x="364260" y="769350"/>
                    </a:cubicBezTo>
                    <a:close/>
                    <a:moveTo>
                      <a:pt x="306598" y="769350"/>
                    </a:moveTo>
                    <a:cubicBezTo>
                      <a:pt x="316698" y="769350"/>
                      <a:pt x="324886" y="777538"/>
                      <a:pt x="324886" y="787638"/>
                    </a:cubicBezTo>
                    <a:cubicBezTo>
                      <a:pt x="324886" y="797738"/>
                      <a:pt x="316698" y="805926"/>
                      <a:pt x="306598" y="805926"/>
                    </a:cubicBezTo>
                    <a:cubicBezTo>
                      <a:pt x="296498" y="805926"/>
                      <a:pt x="288310" y="797738"/>
                      <a:pt x="288310" y="787638"/>
                    </a:cubicBezTo>
                    <a:cubicBezTo>
                      <a:pt x="288310" y="777538"/>
                      <a:pt x="296498" y="769350"/>
                      <a:pt x="306598" y="769350"/>
                    </a:cubicBezTo>
                    <a:close/>
                    <a:moveTo>
                      <a:pt x="248936" y="769350"/>
                    </a:moveTo>
                    <a:cubicBezTo>
                      <a:pt x="259036" y="769350"/>
                      <a:pt x="267224" y="777538"/>
                      <a:pt x="267224" y="787638"/>
                    </a:cubicBezTo>
                    <a:cubicBezTo>
                      <a:pt x="267224" y="797738"/>
                      <a:pt x="259036" y="805926"/>
                      <a:pt x="248936" y="805926"/>
                    </a:cubicBezTo>
                    <a:cubicBezTo>
                      <a:pt x="238836" y="805926"/>
                      <a:pt x="230648" y="797738"/>
                      <a:pt x="230648" y="787638"/>
                    </a:cubicBezTo>
                    <a:cubicBezTo>
                      <a:pt x="230648" y="777538"/>
                      <a:pt x="238836" y="769350"/>
                      <a:pt x="248936" y="769350"/>
                    </a:cubicBezTo>
                    <a:close/>
                    <a:moveTo>
                      <a:pt x="191274" y="769350"/>
                    </a:moveTo>
                    <a:cubicBezTo>
                      <a:pt x="201374" y="769350"/>
                      <a:pt x="209562" y="777538"/>
                      <a:pt x="209562" y="787638"/>
                    </a:cubicBezTo>
                    <a:cubicBezTo>
                      <a:pt x="209562" y="797738"/>
                      <a:pt x="201374" y="805926"/>
                      <a:pt x="191274" y="805926"/>
                    </a:cubicBezTo>
                    <a:cubicBezTo>
                      <a:pt x="181174" y="805926"/>
                      <a:pt x="172986" y="797738"/>
                      <a:pt x="172986" y="787638"/>
                    </a:cubicBezTo>
                    <a:cubicBezTo>
                      <a:pt x="172986" y="777538"/>
                      <a:pt x="181174" y="769350"/>
                      <a:pt x="191274" y="769350"/>
                    </a:cubicBezTo>
                    <a:close/>
                    <a:moveTo>
                      <a:pt x="133612" y="769350"/>
                    </a:moveTo>
                    <a:cubicBezTo>
                      <a:pt x="143712" y="769350"/>
                      <a:pt x="151900" y="777538"/>
                      <a:pt x="151900" y="787638"/>
                    </a:cubicBezTo>
                    <a:cubicBezTo>
                      <a:pt x="151900" y="797738"/>
                      <a:pt x="143712" y="805926"/>
                      <a:pt x="133612" y="805926"/>
                    </a:cubicBezTo>
                    <a:cubicBezTo>
                      <a:pt x="123512" y="805926"/>
                      <a:pt x="115324" y="797738"/>
                      <a:pt x="115324" y="787638"/>
                    </a:cubicBezTo>
                    <a:cubicBezTo>
                      <a:pt x="115324" y="777538"/>
                      <a:pt x="123512" y="769350"/>
                      <a:pt x="133612" y="769350"/>
                    </a:cubicBezTo>
                    <a:close/>
                    <a:moveTo>
                      <a:pt x="75950" y="769350"/>
                    </a:moveTo>
                    <a:cubicBezTo>
                      <a:pt x="86050" y="769350"/>
                      <a:pt x="94238" y="777538"/>
                      <a:pt x="94238" y="787638"/>
                    </a:cubicBezTo>
                    <a:cubicBezTo>
                      <a:pt x="94238" y="797738"/>
                      <a:pt x="86050" y="805926"/>
                      <a:pt x="75950" y="805926"/>
                    </a:cubicBezTo>
                    <a:cubicBezTo>
                      <a:pt x="65850" y="805926"/>
                      <a:pt x="57662" y="797738"/>
                      <a:pt x="57662" y="787638"/>
                    </a:cubicBezTo>
                    <a:cubicBezTo>
                      <a:pt x="57662" y="777538"/>
                      <a:pt x="65850" y="769350"/>
                      <a:pt x="75950" y="769350"/>
                    </a:cubicBezTo>
                    <a:close/>
                    <a:moveTo>
                      <a:pt x="18288" y="769350"/>
                    </a:moveTo>
                    <a:cubicBezTo>
                      <a:pt x="28388" y="769350"/>
                      <a:pt x="36576" y="777538"/>
                      <a:pt x="36576" y="787638"/>
                    </a:cubicBezTo>
                    <a:cubicBezTo>
                      <a:pt x="36576" y="797738"/>
                      <a:pt x="28388" y="805926"/>
                      <a:pt x="18288" y="805926"/>
                    </a:cubicBezTo>
                    <a:cubicBezTo>
                      <a:pt x="8188" y="805926"/>
                      <a:pt x="0" y="797738"/>
                      <a:pt x="0" y="787638"/>
                    </a:cubicBezTo>
                    <a:cubicBezTo>
                      <a:pt x="0" y="777538"/>
                      <a:pt x="8188" y="769350"/>
                      <a:pt x="18288" y="769350"/>
                    </a:cubicBezTo>
                    <a:close/>
                    <a:moveTo>
                      <a:pt x="1459848" y="718060"/>
                    </a:moveTo>
                    <a:cubicBezTo>
                      <a:pt x="1469948" y="718060"/>
                      <a:pt x="1478136" y="726248"/>
                      <a:pt x="1478136" y="736348"/>
                    </a:cubicBezTo>
                    <a:cubicBezTo>
                      <a:pt x="1478136" y="746448"/>
                      <a:pt x="1469948" y="754636"/>
                      <a:pt x="1459848" y="754636"/>
                    </a:cubicBezTo>
                    <a:cubicBezTo>
                      <a:pt x="1449748" y="754636"/>
                      <a:pt x="1441560" y="746448"/>
                      <a:pt x="1441560" y="736348"/>
                    </a:cubicBezTo>
                    <a:cubicBezTo>
                      <a:pt x="1441560" y="726248"/>
                      <a:pt x="1449748" y="718060"/>
                      <a:pt x="1459848" y="718060"/>
                    </a:cubicBezTo>
                    <a:close/>
                    <a:moveTo>
                      <a:pt x="1402176" y="718060"/>
                    </a:moveTo>
                    <a:cubicBezTo>
                      <a:pt x="1412276" y="718060"/>
                      <a:pt x="1420464" y="726248"/>
                      <a:pt x="1420464" y="736348"/>
                    </a:cubicBezTo>
                    <a:cubicBezTo>
                      <a:pt x="1420464" y="746448"/>
                      <a:pt x="1412276" y="754636"/>
                      <a:pt x="1402176" y="754636"/>
                    </a:cubicBezTo>
                    <a:cubicBezTo>
                      <a:pt x="1392076" y="754636"/>
                      <a:pt x="1383888" y="746448"/>
                      <a:pt x="1383888" y="736348"/>
                    </a:cubicBezTo>
                    <a:cubicBezTo>
                      <a:pt x="1383888" y="726248"/>
                      <a:pt x="1392076" y="718060"/>
                      <a:pt x="1402176" y="718060"/>
                    </a:cubicBezTo>
                    <a:close/>
                    <a:moveTo>
                      <a:pt x="1344514" y="718060"/>
                    </a:moveTo>
                    <a:cubicBezTo>
                      <a:pt x="1354614" y="718060"/>
                      <a:pt x="1362802" y="726248"/>
                      <a:pt x="1362802" y="736348"/>
                    </a:cubicBezTo>
                    <a:cubicBezTo>
                      <a:pt x="1362802" y="746448"/>
                      <a:pt x="1354614" y="754636"/>
                      <a:pt x="1344514" y="754636"/>
                    </a:cubicBezTo>
                    <a:cubicBezTo>
                      <a:pt x="1334414" y="754636"/>
                      <a:pt x="1326226" y="746448"/>
                      <a:pt x="1326226" y="736348"/>
                    </a:cubicBezTo>
                    <a:cubicBezTo>
                      <a:pt x="1326226" y="726248"/>
                      <a:pt x="1334414" y="718060"/>
                      <a:pt x="1344514" y="718060"/>
                    </a:cubicBezTo>
                    <a:close/>
                    <a:moveTo>
                      <a:pt x="1286852" y="718060"/>
                    </a:moveTo>
                    <a:cubicBezTo>
                      <a:pt x="1296952" y="718060"/>
                      <a:pt x="1305140" y="726248"/>
                      <a:pt x="1305140" y="736348"/>
                    </a:cubicBezTo>
                    <a:cubicBezTo>
                      <a:pt x="1305140" y="746448"/>
                      <a:pt x="1296952" y="754636"/>
                      <a:pt x="1286852" y="754636"/>
                    </a:cubicBezTo>
                    <a:cubicBezTo>
                      <a:pt x="1276752" y="754636"/>
                      <a:pt x="1268564" y="746448"/>
                      <a:pt x="1268564" y="736348"/>
                    </a:cubicBezTo>
                    <a:cubicBezTo>
                      <a:pt x="1268564" y="726248"/>
                      <a:pt x="1276752" y="718060"/>
                      <a:pt x="1286852" y="718060"/>
                    </a:cubicBezTo>
                    <a:close/>
                    <a:moveTo>
                      <a:pt x="1229190" y="718060"/>
                    </a:moveTo>
                    <a:cubicBezTo>
                      <a:pt x="1239290" y="718060"/>
                      <a:pt x="1247478" y="726248"/>
                      <a:pt x="1247478" y="736348"/>
                    </a:cubicBezTo>
                    <a:cubicBezTo>
                      <a:pt x="1247478" y="746448"/>
                      <a:pt x="1239290" y="754636"/>
                      <a:pt x="1229190" y="754636"/>
                    </a:cubicBezTo>
                    <a:cubicBezTo>
                      <a:pt x="1219090" y="754636"/>
                      <a:pt x="1210902" y="746448"/>
                      <a:pt x="1210902" y="736348"/>
                    </a:cubicBezTo>
                    <a:cubicBezTo>
                      <a:pt x="1210902" y="726248"/>
                      <a:pt x="1219090" y="718060"/>
                      <a:pt x="1229190" y="718060"/>
                    </a:cubicBezTo>
                    <a:close/>
                    <a:moveTo>
                      <a:pt x="1171528" y="718060"/>
                    </a:moveTo>
                    <a:cubicBezTo>
                      <a:pt x="1181628" y="718060"/>
                      <a:pt x="1189816" y="726248"/>
                      <a:pt x="1189816" y="736348"/>
                    </a:cubicBezTo>
                    <a:cubicBezTo>
                      <a:pt x="1189816" y="746448"/>
                      <a:pt x="1181628" y="754636"/>
                      <a:pt x="1171528" y="754636"/>
                    </a:cubicBezTo>
                    <a:cubicBezTo>
                      <a:pt x="1161428" y="754636"/>
                      <a:pt x="1153240" y="746448"/>
                      <a:pt x="1153240" y="736348"/>
                    </a:cubicBezTo>
                    <a:cubicBezTo>
                      <a:pt x="1153240" y="726248"/>
                      <a:pt x="1161428" y="718060"/>
                      <a:pt x="1171528" y="718060"/>
                    </a:cubicBezTo>
                    <a:close/>
                    <a:moveTo>
                      <a:pt x="1113866" y="718060"/>
                    </a:moveTo>
                    <a:cubicBezTo>
                      <a:pt x="1123966" y="718060"/>
                      <a:pt x="1132154" y="726248"/>
                      <a:pt x="1132154" y="736348"/>
                    </a:cubicBezTo>
                    <a:cubicBezTo>
                      <a:pt x="1132154" y="746448"/>
                      <a:pt x="1123966" y="754636"/>
                      <a:pt x="1113866" y="754636"/>
                    </a:cubicBezTo>
                    <a:cubicBezTo>
                      <a:pt x="1103766" y="754636"/>
                      <a:pt x="1095578" y="746448"/>
                      <a:pt x="1095578" y="736348"/>
                    </a:cubicBezTo>
                    <a:cubicBezTo>
                      <a:pt x="1095578" y="726248"/>
                      <a:pt x="1103766" y="718060"/>
                      <a:pt x="1113866" y="718060"/>
                    </a:cubicBezTo>
                    <a:close/>
                    <a:moveTo>
                      <a:pt x="1056204" y="718060"/>
                    </a:moveTo>
                    <a:cubicBezTo>
                      <a:pt x="1066304" y="718060"/>
                      <a:pt x="1074492" y="726248"/>
                      <a:pt x="1074492" y="736348"/>
                    </a:cubicBezTo>
                    <a:cubicBezTo>
                      <a:pt x="1074492" y="746448"/>
                      <a:pt x="1066304" y="754636"/>
                      <a:pt x="1056204" y="754636"/>
                    </a:cubicBezTo>
                    <a:cubicBezTo>
                      <a:pt x="1046104" y="754636"/>
                      <a:pt x="1037916" y="746448"/>
                      <a:pt x="1037916" y="736348"/>
                    </a:cubicBezTo>
                    <a:cubicBezTo>
                      <a:pt x="1037916" y="726248"/>
                      <a:pt x="1046104" y="718060"/>
                      <a:pt x="1056204" y="718060"/>
                    </a:cubicBezTo>
                    <a:close/>
                    <a:moveTo>
                      <a:pt x="998542" y="718060"/>
                    </a:moveTo>
                    <a:cubicBezTo>
                      <a:pt x="1008642" y="718060"/>
                      <a:pt x="1016830" y="726248"/>
                      <a:pt x="1016830" y="736348"/>
                    </a:cubicBezTo>
                    <a:cubicBezTo>
                      <a:pt x="1016830" y="746448"/>
                      <a:pt x="1008642" y="754636"/>
                      <a:pt x="998542" y="754636"/>
                    </a:cubicBezTo>
                    <a:cubicBezTo>
                      <a:pt x="988442" y="754636"/>
                      <a:pt x="980254" y="746448"/>
                      <a:pt x="980254" y="736348"/>
                    </a:cubicBezTo>
                    <a:cubicBezTo>
                      <a:pt x="980254" y="726248"/>
                      <a:pt x="988442" y="718060"/>
                      <a:pt x="998542" y="718060"/>
                    </a:cubicBezTo>
                    <a:close/>
                    <a:moveTo>
                      <a:pt x="940880" y="718060"/>
                    </a:moveTo>
                    <a:cubicBezTo>
                      <a:pt x="950980" y="718060"/>
                      <a:pt x="959168" y="726248"/>
                      <a:pt x="959168" y="736348"/>
                    </a:cubicBezTo>
                    <a:cubicBezTo>
                      <a:pt x="959168" y="746448"/>
                      <a:pt x="950980" y="754636"/>
                      <a:pt x="940880" y="754636"/>
                    </a:cubicBezTo>
                    <a:cubicBezTo>
                      <a:pt x="930780" y="754636"/>
                      <a:pt x="922592" y="746448"/>
                      <a:pt x="922592" y="736348"/>
                    </a:cubicBezTo>
                    <a:cubicBezTo>
                      <a:pt x="922592" y="726248"/>
                      <a:pt x="930780" y="718060"/>
                      <a:pt x="940880" y="718060"/>
                    </a:cubicBezTo>
                    <a:close/>
                    <a:moveTo>
                      <a:pt x="883218" y="718060"/>
                    </a:moveTo>
                    <a:cubicBezTo>
                      <a:pt x="893318" y="718060"/>
                      <a:pt x="901506" y="726248"/>
                      <a:pt x="901506" y="736348"/>
                    </a:cubicBezTo>
                    <a:cubicBezTo>
                      <a:pt x="901506" y="746448"/>
                      <a:pt x="893318" y="754636"/>
                      <a:pt x="883218" y="754636"/>
                    </a:cubicBezTo>
                    <a:cubicBezTo>
                      <a:pt x="873118" y="754636"/>
                      <a:pt x="864930" y="746448"/>
                      <a:pt x="864930" y="736348"/>
                    </a:cubicBezTo>
                    <a:cubicBezTo>
                      <a:pt x="864930" y="726248"/>
                      <a:pt x="873118" y="718060"/>
                      <a:pt x="883218" y="718060"/>
                    </a:cubicBezTo>
                    <a:close/>
                    <a:moveTo>
                      <a:pt x="825556" y="718060"/>
                    </a:moveTo>
                    <a:cubicBezTo>
                      <a:pt x="835656" y="718060"/>
                      <a:pt x="843844" y="726248"/>
                      <a:pt x="843844" y="736348"/>
                    </a:cubicBezTo>
                    <a:cubicBezTo>
                      <a:pt x="843844" y="746448"/>
                      <a:pt x="835656" y="754636"/>
                      <a:pt x="825556" y="754636"/>
                    </a:cubicBezTo>
                    <a:cubicBezTo>
                      <a:pt x="815456" y="754636"/>
                      <a:pt x="807268" y="746448"/>
                      <a:pt x="807268" y="736348"/>
                    </a:cubicBezTo>
                    <a:cubicBezTo>
                      <a:pt x="807268" y="726248"/>
                      <a:pt x="815456" y="718060"/>
                      <a:pt x="825556" y="718060"/>
                    </a:cubicBezTo>
                    <a:close/>
                    <a:moveTo>
                      <a:pt x="767894" y="718060"/>
                    </a:moveTo>
                    <a:cubicBezTo>
                      <a:pt x="777994" y="718060"/>
                      <a:pt x="786182" y="726248"/>
                      <a:pt x="786182" y="736348"/>
                    </a:cubicBezTo>
                    <a:cubicBezTo>
                      <a:pt x="786182" y="746448"/>
                      <a:pt x="777994" y="754636"/>
                      <a:pt x="767894" y="754636"/>
                    </a:cubicBezTo>
                    <a:cubicBezTo>
                      <a:pt x="757794" y="754636"/>
                      <a:pt x="749606" y="746448"/>
                      <a:pt x="749606" y="736348"/>
                    </a:cubicBezTo>
                    <a:cubicBezTo>
                      <a:pt x="749606" y="726248"/>
                      <a:pt x="757794" y="718060"/>
                      <a:pt x="767894" y="718060"/>
                    </a:cubicBezTo>
                    <a:close/>
                    <a:moveTo>
                      <a:pt x="710232" y="718060"/>
                    </a:moveTo>
                    <a:cubicBezTo>
                      <a:pt x="720332" y="718060"/>
                      <a:pt x="728520" y="726248"/>
                      <a:pt x="728520" y="736348"/>
                    </a:cubicBezTo>
                    <a:cubicBezTo>
                      <a:pt x="728520" y="746448"/>
                      <a:pt x="720332" y="754636"/>
                      <a:pt x="710232" y="754636"/>
                    </a:cubicBezTo>
                    <a:cubicBezTo>
                      <a:pt x="700132" y="754636"/>
                      <a:pt x="691944" y="746448"/>
                      <a:pt x="691944" y="736348"/>
                    </a:cubicBezTo>
                    <a:cubicBezTo>
                      <a:pt x="691944" y="726248"/>
                      <a:pt x="700132" y="718060"/>
                      <a:pt x="710232" y="718060"/>
                    </a:cubicBezTo>
                    <a:close/>
                    <a:moveTo>
                      <a:pt x="652570" y="718060"/>
                    </a:moveTo>
                    <a:cubicBezTo>
                      <a:pt x="662670" y="718060"/>
                      <a:pt x="670858" y="726248"/>
                      <a:pt x="670858" y="736348"/>
                    </a:cubicBezTo>
                    <a:cubicBezTo>
                      <a:pt x="670858" y="746448"/>
                      <a:pt x="662670" y="754636"/>
                      <a:pt x="652570" y="754636"/>
                    </a:cubicBezTo>
                    <a:cubicBezTo>
                      <a:pt x="642470" y="754636"/>
                      <a:pt x="634282" y="746448"/>
                      <a:pt x="634282" y="736348"/>
                    </a:cubicBezTo>
                    <a:cubicBezTo>
                      <a:pt x="634282" y="726248"/>
                      <a:pt x="642470" y="718060"/>
                      <a:pt x="652570" y="718060"/>
                    </a:cubicBezTo>
                    <a:close/>
                    <a:moveTo>
                      <a:pt x="594908" y="718060"/>
                    </a:moveTo>
                    <a:cubicBezTo>
                      <a:pt x="605008" y="718060"/>
                      <a:pt x="613196" y="726248"/>
                      <a:pt x="613196" y="736348"/>
                    </a:cubicBezTo>
                    <a:cubicBezTo>
                      <a:pt x="613196" y="746448"/>
                      <a:pt x="605008" y="754636"/>
                      <a:pt x="594908" y="754636"/>
                    </a:cubicBezTo>
                    <a:cubicBezTo>
                      <a:pt x="584808" y="754636"/>
                      <a:pt x="576620" y="746448"/>
                      <a:pt x="576620" y="736348"/>
                    </a:cubicBezTo>
                    <a:cubicBezTo>
                      <a:pt x="576620" y="726248"/>
                      <a:pt x="584808" y="718060"/>
                      <a:pt x="594908" y="718060"/>
                    </a:cubicBezTo>
                    <a:close/>
                    <a:moveTo>
                      <a:pt x="537246" y="718060"/>
                    </a:moveTo>
                    <a:cubicBezTo>
                      <a:pt x="547346" y="718060"/>
                      <a:pt x="555534" y="726248"/>
                      <a:pt x="555534" y="736348"/>
                    </a:cubicBezTo>
                    <a:cubicBezTo>
                      <a:pt x="555534" y="746448"/>
                      <a:pt x="547346" y="754636"/>
                      <a:pt x="537246" y="754636"/>
                    </a:cubicBezTo>
                    <a:cubicBezTo>
                      <a:pt x="527146" y="754636"/>
                      <a:pt x="518958" y="746448"/>
                      <a:pt x="518958" y="736348"/>
                    </a:cubicBezTo>
                    <a:cubicBezTo>
                      <a:pt x="518958" y="726248"/>
                      <a:pt x="527146" y="718060"/>
                      <a:pt x="537246" y="718060"/>
                    </a:cubicBezTo>
                    <a:close/>
                    <a:moveTo>
                      <a:pt x="479584" y="718060"/>
                    </a:moveTo>
                    <a:cubicBezTo>
                      <a:pt x="489684" y="718060"/>
                      <a:pt x="497872" y="726248"/>
                      <a:pt x="497872" y="736348"/>
                    </a:cubicBezTo>
                    <a:cubicBezTo>
                      <a:pt x="497872" y="746448"/>
                      <a:pt x="489684" y="754636"/>
                      <a:pt x="479584" y="754636"/>
                    </a:cubicBezTo>
                    <a:cubicBezTo>
                      <a:pt x="469484" y="754636"/>
                      <a:pt x="461296" y="746448"/>
                      <a:pt x="461296" y="736348"/>
                    </a:cubicBezTo>
                    <a:cubicBezTo>
                      <a:pt x="461296" y="726248"/>
                      <a:pt x="469484" y="718060"/>
                      <a:pt x="479584" y="718060"/>
                    </a:cubicBezTo>
                    <a:close/>
                    <a:moveTo>
                      <a:pt x="421922" y="718060"/>
                    </a:moveTo>
                    <a:cubicBezTo>
                      <a:pt x="432022" y="718060"/>
                      <a:pt x="440210" y="726248"/>
                      <a:pt x="440210" y="736348"/>
                    </a:cubicBezTo>
                    <a:cubicBezTo>
                      <a:pt x="440210" y="746448"/>
                      <a:pt x="432022" y="754636"/>
                      <a:pt x="421922" y="754636"/>
                    </a:cubicBezTo>
                    <a:cubicBezTo>
                      <a:pt x="411822" y="754636"/>
                      <a:pt x="403634" y="746448"/>
                      <a:pt x="403634" y="736348"/>
                    </a:cubicBezTo>
                    <a:cubicBezTo>
                      <a:pt x="403634" y="726248"/>
                      <a:pt x="411822" y="718060"/>
                      <a:pt x="421922" y="718060"/>
                    </a:cubicBezTo>
                    <a:close/>
                    <a:moveTo>
                      <a:pt x="364260" y="718060"/>
                    </a:moveTo>
                    <a:cubicBezTo>
                      <a:pt x="374360" y="718060"/>
                      <a:pt x="382548" y="726248"/>
                      <a:pt x="382548" y="736348"/>
                    </a:cubicBezTo>
                    <a:cubicBezTo>
                      <a:pt x="382548" y="746448"/>
                      <a:pt x="374360" y="754636"/>
                      <a:pt x="364260" y="754636"/>
                    </a:cubicBezTo>
                    <a:cubicBezTo>
                      <a:pt x="354160" y="754636"/>
                      <a:pt x="345972" y="746448"/>
                      <a:pt x="345972" y="736348"/>
                    </a:cubicBezTo>
                    <a:cubicBezTo>
                      <a:pt x="345972" y="726248"/>
                      <a:pt x="354160" y="718060"/>
                      <a:pt x="364260" y="718060"/>
                    </a:cubicBezTo>
                    <a:close/>
                    <a:moveTo>
                      <a:pt x="306598" y="718060"/>
                    </a:moveTo>
                    <a:cubicBezTo>
                      <a:pt x="316698" y="718060"/>
                      <a:pt x="324886" y="726248"/>
                      <a:pt x="324886" y="736348"/>
                    </a:cubicBezTo>
                    <a:cubicBezTo>
                      <a:pt x="324886" y="746448"/>
                      <a:pt x="316698" y="754636"/>
                      <a:pt x="306598" y="754636"/>
                    </a:cubicBezTo>
                    <a:cubicBezTo>
                      <a:pt x="296498" y="754636"/>
                      <a:pt x="288310" y="746448"/>
                      <a:pt x="288310" y="736348"/>
                    </a:cubicBezTo>
                    <a:cubicBezTo>
                      <a:pt x="288310" y="726248"/>
                      <a:pt x="296498" y="718060"/>
                      <a:pt x="306598" y="718060"/>
                    </a:cubicBezTo>
                    <a:close/>
                    <a:moveTo>
                      <a:pt x="248936" y="718060"/>
                    </a:moveTo>
                    <a:cubicBezTo>
                      <a:pt x="259036" y="718060"/>
                      <a:pt x="267224" y="726248"/>
                      <a:pt x="267224" y="736348"/>
                    </a:cubicBezTo>
                    <a:cubicBezTo>
                      <a:pt x="267224" y="746448"/>
                      <a:pt x="259036" y="754636"/>
                      <a:pt x="248936" y="754636"/>
                    </a:cubicBezTo>
                    <a:cubicBezTo>
                      <a:pt x="238836" y="754636"/>
                      <a:pt x="230648" y="746448"/>
                      <a:pt x="230648" y="736348"/>
                    </a:cubicBezTo>
                    <a:cubicBezTo>
                      <a:pt x="230648" y="726248"/>
                      <a:pt x="238836" y="718060"/>
                      <a:pt x="248936" y="718060"/>
                    </a:cubicBezTo>
                    <a:close/>
                    <a:moveTo>
                      <a:pt x="191274" y="718060"/>
                    </a:moveTo>
                    <a:cubicBezTo>
                      <a:pt x="201374" y="718060"/>
                      <a:pt x="209562" y="726248"/>
                      <a:pt x="209562" y="736348"/>
                    </a:cubicBezTo>
                    <a:cubicBezTo>
                      <a:pt x="209562" y="746448"/>
                      <a:pt x="201374" y="754636"/>
                      <a:pt x="191274" y="754636"/>
                    </a:cubicBezTo>
                    <a:cubicBezTo>
                      <a:pt x="181174" y="754636"/>
                      <a:pt x="172986" y="746448"/>
                      <a:pt x="172986" y="736348"/>
                    </a:cubicBezTo>
                    <a:cubicBezTo>
                      <a:pt x="172986" y="726248"/>
                      <a:pt x="181174" y="718060"/>
                      <a:pt x="191274" y="718060"/>
                    </a:cubicBezTo>
                    <a:close/>
                    <a:moveTo>
                      <a:pt x="133612" y="718060"/>
                    </a:moveTo>
                    <a:cubicBezTo>
                      <a:pt x="143712" y="718060"/>
                      <a:pt x="151900" y="726248"/>
                      <a:pt x="151900" y="736348"/>
                    </a:cubicBezTo>
                    <a:cubicBezTo>
                      <a:pt x="151900" y="746448"/>
                      <a:pt x="143712" y="754636"/>
                      <a:pt x="133612" y="754636"/>
                    </a:cubicBezTo>
                    <a:cubicBezTo>
                      <a:pt x="123512" y="754636"/>
                      <a:pt x="115324" y="746448"/>
                      <a:pt x="115324" y="736348"/>
                    </a:cubicBezTo>
                    <a:cubicBezTo>
                      <a:pt x="115324" y="726248"/>
                      <a:pt x="123512" y="718060"/>
                      <a:pt x="133612" y="718060"/>
                    </a:cubicBezTo>
                    <a:close/>
                    <a:moveTo>
                      <a:pt x="75950" y="718060"/>
                    </a:moveTo>
                    <a:cubicBezTo>
                      <a:pt x="86050" y="718060"/>
                      <a:pt x="94238" y="726248"/>
                      <a:pt x="94238" y="736348"/>
                    </a:cubicBezTo>
                    <a:cubicBezTo>
                      <a:pt x="94238" y="746448"/>
                      <a:pt x="86050" y="754636"/>
                      <a:pt x="75950" y="754636"/>
                    </a:cubicBezTo>
                    <a:cubicBezTo>
                      <a:pt x="65850" y="754636"/>
                      <a:pt x="57662" y="746448"/>
                      <a:pt x="57662" y="736348"/>
                    </a:cubicBezTo>
                    <a:cubicBezTo>
                      <a:pt x="57662" y="726248"/>
                      <a:pt x="65850" y="718060"/>
                      <a:pt x="75950" y="718060"/>
                    </a:cubicBezTo>
                    <a:close/>
                    <a:moveTo>
                      <a:pt x="18288" y="718060"/>
                    </a:moveTo>
                    <a:cubicBezTo>
                      <a:pt x="28388" y="718060"/>
                      <a:pt x="36576" y="726248"/>
                      <a:pt x="36576" y="736348"/>
                    </a:cubicBezTo>
                    <a:cubicBezTo>
                      <a:pt x="36576" y="746448"/>
                      <a:pt x="28388" y="754636"/>
                      <a:pt x="18288" y="754636"/>
                    </a:cubicBezTo>
                    <a:cubicBezTo>
                      <a:pt x="8188" y="754636"/>
                      <a:pt x="0" y="746448"/>
                      <a:pt x="0" y="736348"/>
                    </a:cubicBezTo>
                    <a:cubicBezTo>
                      <a:pt x="0" y="726248"/>
                      <a:pt x="8188" y="718060"/>
                      <a:pt x="18288" y="718060"/>
                    </a:cubicBezTo>
                    <a:close/>
                    <a:moveTo>
                      <a:pt x="1459848" y="666770"/>
                    </a:moveTo>
                    <a:cubicBezTo>
                      <a:pt x="1469948" y="666770"/>
                      <a:pt x="1478136" y="674958"/>
                      <a:pt x="1478136" y="685058"/>
                    </a:cubicBezTo>
                    <a:cubicBezTo>
                      <a:pt x="1478136" y="695158"/>
                      <a:pt x="1469948" y="703346"/>
                      <a:pt x="1459848" y="703346"/>
                    </a:cubicBezTo>
                    <a:cubicBezTo>
                      <a:pt x="1449748" y="703346"/>
                      <a:pt x="1441560" y="695158"/>
                      <a:pt x="1441560" y="685058"/>
                    </a:cubicBezTo>
                    <a:cubicBezTo>
                      <a:pt x="1441560" y="674958"/>
                      <a:pt x="1449748" y="666770"/>
                      <a:pt x="1459848" y="666770"/>
                    </a:cubicBezTo>
                    <a:close/>
                    <a:moveTo>
                      <a:pt x="1402176" y="666770"/>
                    </a:moveTo>
                    <a:cubicBezTo>
                      <a:pt x="1412276" y="666770"/>
                      <a:pt x="1420464" y="674958"/>
                      <a:pt x="1420464" y="685058"/>
                    </a:cubicBezTo>
                    <a:cubicBezTo>
                      <a:pt x="1420464" y="695158"/>
                      <a:pt x="1412276" y="703346"/>
                      <a:pt x="1402176" y="703346"/>
                    </a:cubicBezTo>
                    <a:cubicBezTo>
                      <a:pt x="1392076" y="703346"/>
                      <a:pt x="1383888" y="695158"/>
                      <a:pt x="1383888" y="685058"/>
                    </a:cubicBezTo>
                    <a:cubicBezTo>
                      <a:pt x="1383888" y="674958"/>
                      <a:pt x="1392076" y="666770"/>
                      <a:pt x="1402176" y="666770"/>
                    </a:cubicBezTo>
                    <a:close/>
                    <a:moveTo>
                      <a:pt x="1344514" y="666770"/>
                    </a:moveTo>
                    <a:cubicBezTo>
                      <a:pt x="1354614" y="666770"/>
                      <a:pt x="1362802" y="674958"/>
                      <a:pt x="1362802" y="685058"/>
                    </a:cubicBezTo>
                    <a:cubicBezTo>
                      <a:pt x="1362802" y="695158"/>
                      <a:pt x="1354614" y="703346"/>
                      <a:pt x="1344514" y="703346"/>
                    </a:cubicBezTo>
                    <a:cubicBezTo>
                      <a:pt x="1334414" y="703346"/>
                      <a:pt x="1326226" y="695158"/>
                      <a:pt x="1326226" y="685058"/>
                    </a:cubicBezTo>
                    <a:cubicBezTo>
                      <a:pt x="1326226" y="674958"/>
                      <a:pt x="1334414" y="666770"/>
                      <a:pt x="1344514" y="666770"/>
                    </a:cubicBezTo>
                    <a:close/>
                    <a:moveTo>
                      <a:pt x="1286852" y="666770"/>
                    </a:moveTo>
                    <a:cubicBezTo>
                      <a:pt x="1296952" y="666770"/>
                      <a:pt x="1305140" y="674958"/>
                      <a:pt x="1305140" y="685058"/>
                    </a:cubicBezTo>
                    <a:cubicBezTo>
                      <a:pt x="1305140" y="695158"/>
                      <a:pt x="1296952" y="703346"/>
                      <a:pt x="1286852" y="703346"/>
                    </a:cubicBezTo>
                    <a:cubicBezTo>
                      <a:pt x="1276752" y="703346"/>
                      <a:pt x="1268564" y="695158"/>
                      <a:pt x="1268564" y="685058"/>
                    </a:cubicBezTo>
                    <a:cubicBezTo>
                      <a:pt x="1268564" y="674958"/>
                      <a:pt x="1276752" y="666770"/>
                      <a:pt x="1286852" y="666770"/>
                    </a:cubicBezTo>
                    <a:close/>
                    <a:moveTo>
                      <a:pt x="1229190" y="666770"/>
                    </a:moveTo>
                    <a:cubicBezTo>
                      <a:pt x="1239290" y="666770"/>
                      <a:pt x="1247478" y="674958"/>
                      <a:pt x="1247478" y="685058"/>
                    </a:cubicBezTo>
                    <a:cubicBezTo>
                      <a:pt x="1247478" y="695158"/>
                      <a:pt x="1239290" y="703346"/>
                      <a:pt x="1229190" y="703346"/>
                    </a:cubicBezTo>
                    <a:cubicBezTo>
                      <a:pt x="1219090" y="703346"/>
                      <a:pt x="1210902" y="695158"/>
                      <a:pt x="1210902" y="685058"/>
                    </a:cubicBezTo>
                    <a:cubicBezTo>
                      <a:pt x="1210902" y="674958"/>
                      <a:pt x="1219090" y="666770"/>
                      <a:pt x="1229190" y="666770"/>
                    </a:cubicBezTo>
                    <a:close/>
                    <a:moveTo>
                      <a:pt x="1171528" y="666770"/>
                    </a:moveTo>
                    <a:cubicBezTo>
                      <a:pt x="1181628" y="666770"/>
                      <a:pt x="1189816" y="674958"/>
                      <a:pt x="1189816" y="685058"/>
                    </a:cubicBezTo>
                    <a:cubicBezTo>
                      <a:pt x="1189816" y="695158"/>
                      <a:pt x="1181628" y="703346"/>
                      <a:pt x="1171528" y="703346"/>
                    </a:cubicBezTo>
                    <a:cubicBezTo>
                      <a:pt x="1161428" y="703346"/>
                      <a:pt x="1153240" y="695158"/>
                      <a:pt x="1153240" y="685058"/>
                    </a:cubicBezTo>
                    <a:cubicBezTo>
                      <a:pt x="1153240" y="674958"/>
                      <a:pt x="1161428" y="666770"/>
                      <a:pt x="1171528" y="666770"/>
                    </a:cubicBezTo>
                    <a:close/>
                    <a:moveTo>
                      <a:pt x="1113866" y="666770"/>
                    </a:moveTo>
                    <a:cubicBezTo>
                      <a:pt x="1123966" y="666770"/>
                      <a:pt x="1132154" y="674958"/>
                      <a:pt x="1132154" y="685058"/>
                    </a:cubicBezTo>
                    <a:cubicBezTo>
                      <a:pt x="1132154" y="695158"/>
                      <a:pt x="1123966" y="703346"/>
                      <a:pt x="1113866" y="703346"/>
                    </a:cubicBezTo>
                    <a:cubicBezTo>
                      <a:pt x="1103766" y="703346"/>
                      <a:pt x="1095578" y="695158"/>
                      <a:pt x="1095578" y="685058"/>
                    </a:cubicBezTo>
                    <a:cubicBezTo>
                      <a:pt x="1095578" y="674958"/>
                      <a:pt x="1103766" y="666770"/>
                      <a:pt x="1113866" y="666770"/>
                    </a:cubicBezTo>
                    <a:close/>
                    <a:moveTo>
                      <a:pt x="1056204" y="666770"/>
                    </a:moveTo>
                    <a:cubicBezTo>
                      <a:pt x="1066304" y="666770"/>
                      <a:pt x="1074492" y="674958"/>
                      <a:pt x="1074492" y="685058"/>
                    </a:cubicBezTo>
                    <a:cubicBezTo>
                      <a:pt x="1074492" y="695158"/>
                      <a:pt x="1066304" y="703346"/>
                      <a:pt x="1056204" y="703346"/>
                    </a:cubicBezTo>
                    <a:cubicBezTo>
                      <a:pt x="1046104" y="703346"/>
                      <a:pt x="1037916" y="695158"/>
                      <a:pt x="1037916" y="685058"/>
                    </a:cubicBezTo>
                    <a:cubicBezTo>
                      <a:pt x="1037916" y="674958"/>
                      <a:pt x="1046104" y="666770"/>
                      <a:pt x="1056204" y="666770"/>
                    </a:cubicBezTo>
                    <a:close/>
                    <a:moveTo>
                      <a:pt x="998542" y="666770"/>
                    </a:moveTo>
                    <a:cubicBezTo>
                      <a:pt x="1008642" y="666770"/>
                      <a:pt x="1016830" y="674958"/>
                      <a:pt x="1016830" y="685058"/>
                    </a:cubicBezTo>
                    <a:cubicBezTo>
                      <a:pt x="1016830" y="695158"/>
                      <a:pt x="1008642" y="703346"/>
                      <a:pt x="998542" y="703346"/>
                    </a:cubicBezTo>
                    <a:cubicBezTo>
                      <a:pt x="988442" y="703346"/>
                      <a:pt x="980254" y="695158"/>
                      <a:pt x="980254" y="685058"/>
                    </a:cubicBezTo>
                    <a:cubicBezTo>
                      <a:pt x="980254" y="674958"/>
                      <a:pt x="988442" y="666770"/>
                      <a:pt x="998542" y="666770"/>
                    </a:cubicBezTo>
                    <a:close/>
                    <a:moveTo>
                      <a:pt x="940880" y="666770"/>
                    </a:moveTo>
                    <a:cubicBezTo>
                      <a:pt x="950980" y="666770"/>
                      <a:pt x="959168" y="674958"/>
                      <a:pt x="959168" y="685058"/>
                    </a:cubicBezTo>
                    <a:cubicBezTo>
                      <a:pt x="959168" y="695158"/>
                      <a:pt x="950980" y="703346"/>
                      <a:pt x="940880" y="703346"/>
                    </a:cubicBezTo>
                    <a:cubicBezTo>
                      <a:pt x="930780" y="703346"/>
                      <a:pt x="922592" y="695158"/>
                      <a:pt x="922592" y="685058"/>
                    </a:cubicBezTo>
                    <a:cubicBezTo>
                      <a:pt x="922592" y="674958"/>
                      <a:pt x="930780" y="666770"/>
                      <a:pt x="940880" y="666770"/>
                    </a:cubicBezTo>
                    <a:close/>
                    <a:moveTo>
                      <a:pt x="883218" y="666770"/>
                    </a:moveTo>
                    <a:cubicBezTo>
                      <a:pt x="893318" y="666770"/>
                      <a:pt x="901506" y="674958"/>
                      <a:pt x="901506" y="685058"/>
                    </a:cubicBezTo>
                    <a:cubicBezTo>
                      <a:pt x="901506" y="695158"/>
                      <a:pt x="893318" y="703346"/>
                      <a:pt x="883218" y="703346"/>
                    </a:cubicBezTo>
                    <a:cubicBezTo>
                      <a:pt x="873118" y="703346"/>
                      <a:pt x="864930" y="695158"/>
                      <a:pt x="864930" y="685058"/>
                    </a:cubicBezTo>
                    <a:cubicBezTo>
                      <a:pt x="864930" y="674958"/>
                      <a:pt x="873118" y="666770"/>
                      <a:pt x="883218" y="666770"/>
                    </a:cubicBezTo>
                    <a:close/>
                    <a:moveTo>
                      <a:pt x="825556" y="666770"/>
                    </a:moveTo>
                    <a:cubicBezTo>
                      <a:pt x="835656" y="666770"/>
                      <a:pt x="843844" y="674958"/>
                      <a:pt x="843844" y="685058"/>
                    </a:cubicBezTo>
                    <a:cubicBezTo>
                      <a:pt x="843844" y="695158"/>
                      <a:pt x="835656" y="703346"/>
                      <a:pt x="825556" y="703346"/>
                    </a:cubicBezTo>
                    <a:cubicBezTo>
                      <a:pt x="815456" y="703346"/>
                      <a:pt x="807268" y="695158"/>
                      <a:pt x="807268" y="685058"/>
                    </a:cubicBezTo>
                    <a:cubicBezTo>
                      <a:pt x="807268" y="674958"/>
                      <a:pt x="815456" y="666770"/>
                      <a:pt x="825556" y="666770"/>
                    </a:cubicBezTo>
                    <a:close/>
                    <a:moveTo>
                      <a:pt x="767894" y="666770"/>
                    </a:moveTo>
                    <a:cubicBezTo>
                      <a:pt x="777994" y="666770"/>
                      <a:pt x="786182" y="674958"/>
                      <a:pt x="786182" y="685058"/>
                    </a:cubicBezTo>
                    <a:cubicBezTo>
                      <a:pt x="786182" y="695158"/>
                      <a:pt x="777994" y="703346"/>
                      <a:pt x="767894" y="703346"/>
                    </a:cubicBezTo>
                    <a:cubicBezTo>
                      <a:pt x="757794" y="703346"/>
                      <a:pt x="749606" y="695158"/>
                      <a:pt x="749606" y="685058"/>
                    </a:cubicBezTo>
                    <a:cubicBezTo>
                      <a:pt x="749606" y="674958"/>
                      <a:pt x="757794" y="666770"/>
                      <a:pt x="767894" y="666770"/>
                    </a:cubicBezTo>
                    <a:close/>
                    <a:moveTo>
                      <a:pt x="710232" y="666770"/>
                    </a:moveTo>
                    <a:cubicBezTo>
                      <a:pt x="720332" y="666770"/>
                      <a:pt x="728520" y="674958"/>
                      <a:pt x="728520" y="685058"/>
                    </a:cubicBezTo>
                    <a:cubicBezTo>
                      <a:pt x="728520" y="695158"/>
                      <a:pt x="720332" y="703346"/>
                      <a:pt x="710232" y="703346"/>
                    </a:cubicBezTo>
                    <a:cubicBezTo>
                      <a:pt x="700132" y="703346"/>
                      <a:pt x="691944" y="695158"/>
                      <a:pt x="691944" y="685058"/>
                    </a:cubicBezTo>
                    <a:cubicBezTo>
                      <a:pt x="691944" y="674958"/>
                      <a:pt x="700132" y="666770"/>
                      <a:pt x="710232" y="666770"/>
                    </a:cubicBezTo>
                    <a:close/>
                    <a:moveTo>
                      <a:pt x="652570" y="666770"/>
                    </a:moveTo>
                    <a:cubicBezTo>
                      <a:pt x="662670" y="666770"/>
                      <a:pt x="670858" y="674958"/>
                      <a:pt x="670858" y="685058"/>
                    </a:cubicBezTo>
                    <a:cubicBezTo>
                      <a:pt x="670858" y="695158"/>
                      <a:pt x="662670" y="703346"/>
                      <a:pt x="652570" y="703346"/>
                    </a:cubicBezTo>
                    <a:cubicBezTo>
                      <a:pt x="642470" y="703346"/>
                      <a:pt x="634282" y="695158"/>
                      <a:pt x="634282" y="685058"/>
                    </a:cubicBezTo>
                    <a:cubicBezTo>
                      <a:pt x="634282" y="674958"/>
                      <a:pt x="642470" y="666770"/>
                      <a:pt x="652570" y="666770"/>
                    </a:cubicBezTo>
                    <a:close/>
                    <a:moveTo>
                      <a:pt x="594908" y="666770"/>
                    </a:moveTo>
                    <a:cubicBezTo>
                      <a:pt x="605008" y="666770"/>
                      <a:pt x="613196" y="674958"/>
                      <a:pt x="613196" y="685058"/>
                    </a:cubicBezTo>
                    <a:cubicBezTo>
                      <a:pt x="613196" y="695158"/>
                      <a:pt x="605008" y="703346"/>
                      <a:pt x="594908" y="703346"/>
                    </a:cubicBezTo>
                    <a:cubicBezTo>
                      <a:pt x="584808" y="703346"/>
                      <a:pt x="576620" y="695158"/>
                      <a:pt x="576620" y="685058"/>
                    </a:cubicBezTo>
                    <a:cubicBezTo>
                      <a:pt x="576620" y="674958"/>
                      <a:pt x="584808" y="666770"/>
                      <a:pt x="594908" y="666770"/>
                    </a:cubicBezTo>
                    <a:close/>
                    <a:moveTo>
                      <a:pt x="537246" y="666770"/>
                    </a:moveTo>
                    <a:cubicBezTo>
                      <a:pt x="547346" y="666770"/>
                      <a:pt x="555534" y="674958"/>
                      <a:pt x="555534" y="685058"/>
                    </a:cubicBezTo>
                    <a:cubicBezTo>
                      <a:pt x="555534" y="695158"/>
                      <a:pt x="547346" y="703346"/>
                      <a:pt x="537246" y="703346"/>
                    </a:cubicBezTo>
                    <a:cubicBezTo>
                      <a:pt x="527146" y="703346"/>
                      <a:pt x="518958" y="695158"/>
                      <a:pt x="518958" y="685058"/>
                    </a:cubicBezTo>
                    <a:cubicBezTo>
                      <a:pt x="518958" y="674958"/>
                      <a:pt x="527146" y="666770"/>
                      <a:pt x="537246" y="666770"/>
                    </a:cubicBezTo>
                    <a:close/>
                    <a:moveTo>
                      <a:pt x="479584" y="666770"/>
                    </a:moveTo>
                    <a:cubicBezTo>
                      <a:pt x="489684" y="666770"/>
                      <a:pt x="497872" y="674958"/>
                      <a:pt x="497872" y="685058"/>
                    </a:cubicBezTo>
                    <a:cubicBezTo>
                      <a:pt x="497872" y="695158"/>
                      <a:pt x="489684" y="703346"/>
                      <a:pt x="479584" y="703346"/>
                    </a:cubicBezTo>
                    <a:cubicBezTo>
                      <a:pt x="469484" y="703346"/>
                      <a:pt x="461296" y="695158"/>
                      <a:pt x="461296" y="685058"/>
                    </a:cubicBezTo>
                    <a:cubicBezTo>
                      <a:pt x="461296" y="674958"/>
                      <a:pt x="469484" y="666770"/>
                      <a:pt x="479584" y="666770"/>
                    </a:cubicBezTo>
                    <a:close/>
                    <a:moveTo>
                      <a:pt x="421922" y="666770"/>
                    </a:moveTo>
                    <a:cubicBezTo>
                      <a:pt x="432022" y="666770"/>
                      <a:pt x="440210" y="674958"/>
                      <a:pt x="440210" y="685058"/>
                    </a:cubicBezTo>
                    <a:cubicBezTo>
                      <a:pt x="440210" y="695158"/>
                      <a:pt x="432022" y="703346"/>
                      <a:pt x="421922" y="703346"/>
                    </a:cubicBezTo>
                    <a:cubicBezTo>
                      <a:pt x="411822" y="703346"/>
                      <a:pt x="403634" y="695158"/>
                      <a:pt x="403634" y="685058"/>
                    </a:cubicBezTo>
                    <a:cubicBezTo>
                      <a:pt x="403634" y="674958"/>
                      <a:pt x="411822" y="666770"/>
                      <a:pt x="421922" y="666770"/>
                    </a:cubicBezTo>
                    <a:close/>
                    <a:moveTo>
                      <a:pt x="364260" y="666770"/>
                    </a:moveTo>
                    <a:cubicBezTo>
                      <a:pt x="374360" y="666770"/>
                      <a:pt x="382548" y="674958"/>
                      <a:pt x="382548" y="685058"/>
                    </a:cubicBezTo>
                    <a:cubicBezTo>
                      <a:pt x="382548" y="695158"/>
                      <a:pt x="374360" y="703346"/>
                      <a:pt x="364260" y="703346"/>
                    </a:cubicBezTo>
                    <a:cubicBezTo>
                      <a:pt x="354160" y="703346"/>
                      <a:pt x="345972" y="695158"/>
                      <a:pt x="345972" y="685058"/>
                    </a:cubicBezTo>
                    <a:cubicBezTo>
                      <a:pt x="345972" y="674958"/>
                      <a:pt x="354160" y="666770"/>
                      <a:pt x="364260" y="666770"/>
                    </a:cubicBezTo>
                    <a:close/>
                    <a:moveTo>
                      <a:pt x="306598" y="666770"/>
                    </a:moveTo>
                    <a:cubicBezTo>
                      <a:pt x="316698" y="666770"/>
                      <a:pt x="324886" y="674958"/>
                      <a:pt x="324886" y="685058"/>
                    </a:cubicBezTo>
                    <a:cubicBezTo>
                      <a:pt x="324886" y="695158"/>
                      <a:pt x="316698" y="703346"/>
                      <a:pt x="306598" y="703346"/>
                    </a:cubicBezTo>
                    <a:cubicBezTo>
                      <a:pt x="296498" y="703346"/>
                      <a:pt x="288310" y="695158"/>
                      <a:pt x="288310" y="685058"/>
                    </a:cubicBezTo>
                    <a:cubicBezTo>
                      <a:pt x="288310" y="674958"/>
                      <a:pt x="296498" y="666770"/>
                      <a:pt x="306598" y="666770"/>
                    </a:cubicBezTo>
                    <a:close/>
                    <a:moveTo>
                      <a:pt x="248936" y="666770"/>
                    </a:moveTo>
                    <a:cubicBezTo>
                      <a:pt x="259036" y="666770"/>
                      <a:pt x="267224" y="674958"/>
                      <a:pt x="267224" y="685058"/>
                    </a:cubicBezTo>
                    <a:cubicBezTo>
                      <a:pt x="267224" y="695158"/>
                      <a:pt x="259036" y="703346"/>
                      <a:pt x="248936" y="703346"/>
                    </a:cubicBezTo>
                    <a:cubicBezTo>
                      <a:pt x="238836" y="703346"/>
                      <a:pt x="230648" y="695158"/>
                      <a:pt x="230648" y="685058"/>
                    </a:cubicBezTo>
                    <a:cubicBezTo>
                      <a:pt x="230648" y="674958"/>
                      <a:pt x="238836" y="666770"/>
                      <a:pt x="248936" y="666770"/>
                    </a:cubicBezTo>
                    <a:close/>
                    <a:moveTo>
                      <a:pt x="191274" y="666770"/>
                    </a:moveTo>
                    <a:cubicBezTo>
                      <a:pt x="201374" y="666770"/>
                      <a:pt x="209562" y="674958"/>
                      <a:pt x="209562" y="685058"/>
                    </a:cubicBezTo>
                    <a:cubicBezTo>
                      <a:pt x="209562" y="695158"/>
                      <a:pt x="201374" y="703346"/>
                      <a:pt x="191274" y="703346"/>
                    </a:cubicBezTo>
                    <a:cubicBezTo>
                      <a:pt x="181174" y="703346"/>
                      <a:pt x="172986" y="695158"/>
                      <a:pt x="172986" y="685058"/>
                    </a:cubicBezTo>
                    <a:cubicBezTo>
                      <a:pt x="172986" y="674958"/>
                      <a:pt x="181174" y="666770"/>
                      <a:pt x="191274" y="666770"/>
                    </a:cubicBezTo>
                    <a:close/>
                    <a:moveTo>
                      <a:pt x="133612" y="666770"/>
                    </a:moveTo>
                    <a:cubicBezTo>
                      <a:pt x="143712" y="666770"/>
                      <a:pt x="151900" y="674958"/>
                      <a:pt x="151900" y="685058"/>
                    </a:cubicBezTo>
                    <a:cubicBezTo>
                      <a:pt x="151900" y="695158"/>
                      <a:pt x="143712" y="703346"/>
                      <a:pt x="133612" y="703346"/>
                    </a:cubicBezTo>
                    <a:cubicBezTo>
                      <a:pt x="123512" y="703346"/>
                      <a:pt x="115324" y="695158"/>
                      <a:pt x="115324" y="685058"/>
                    </a:cubicBezTo>
                    <a:cubicBezTo>
                      <a:pt x="115324" y="674958"/>
                      <a:pt x="123512" y="666770"/>
                      <a:pt x="133612" y="666770"/>
                    </a:cubicBezTo>
                    <a:close/>
                    <a:moveTo>
                      <a:pt x="75950" y="666770"/>
                    </a:moveTo>
                    <a:cubicBezTo>
                      <a:pt x="86050" y="666770"/>
                      <a:pt x="94238" y="674958"/>
                      <a:pt x="94238" y="685058"/>
                    </a:cubicBezTo>
                    <a:cubicBezTo>
                      <a:pt x="94238" y="695158"/>
                      <a:pt x="86050" y="703346"/>
                      <a:pt x="75950" y="703346"/>
                    </a:cubicBezTo>
                    <a:cubicBezTo>
                      <a:pt x="65850" y="703346"/>
                      <a:pt x="57662" y="695158"/>
                      <a:pt x="57662" y="685058"/>
                    </a:cubicBezTo>
                    <a:cubicBezTo>
                      <a:pt x="57662" y="674958"/>
                      <a:pt x="65850" y="666770"/>
                      <a:pt x="75950" y="666770"/>
                    </a:cubicBezTo>
                    <a:close/>
                    <a:moveTo>
                      <a:pt x="18288" y="666770"/>
                    </a:moveTo>
                    <a:cubicBezTo>
                      <a:pt x="28388" y="666770"/>
                      <a:pt x="36576" y="674958"/>
                      <a:pt x="36576" y="685058"/>
                    </a:cubicBezTo>
                    <a:cubicBezTo>
                      <a:pt x="36576" y="695158"/>
                      <a:pt x="28388" y="703346"/>
                      <a:pt x="18288" y="703346"/>
                    </a:cubicBezTo>
                    <a:cubicBezTo>
                      <a:pt x="8188" y="703346"/>
                      <a:pt x="0" y="695158"/>
                      <a:pt x="0" y="685058"/>
                    </a:cubicBezTo>
                    <a:cubicBezTo>
                      <a:pt x="0" y="674958"/>
                      <a:pt x="8188" y="666770"/>
                      <a:pt x="18288" y="666770"/>
                    </a:cubicBezTo>
                    <a:close/>
                    <a:moveTo>
                      <a:pt x="1459848" y="615480"/>
                    </a:moveTo>
                    <a:cubicBezTo>
                      <a:pt x="1469948" y="615480"/>
                      <a:pt x="1478136" y="623668"/>
                      <a:pt x="1478136" y="633768"/>
                    </a:cubicBezTo>
                    <a:cubicBezTo>
                      <a:pt x="1478136" y="643868"/>
                      <a:pt x="1469948" y="652056"/>
                      <a:pt x="1459848" y="652056"/>
                    </a:cubicBezTo>
                    <a:cubicBezTo>
                      <a:pt x="1449748" y="652056"/>
                      <a:pt x="1441560" y="643868"/>
                      <a:pt x="1441560" y="633768"/>
                    </a:cubicBezTo>
                    <a:cubicBezTo>
                      <a:pt x="1441560" y="623668"/>
                      <a:pt x="1449748" y="615480"/>
                      <a:pt x="1459848" y="615480"/>
                    </a:cubicBezTo>
                    <a:close/>
                    <a:moveTo>
                      <a:pt x="1402176" y="615480"/>
                    </a:moveTo>
                    <a:cubicBezTo>
                      <a:pt x="1412276" y="615480"/>
                      <a:pt x="1420464" y="623668"/>
                      <a:pt x="1420464" y="633768"/>
                    </a:cubicBezTo>
                    <a:cubicBezTo>
                      <a:pt x="1420464" y="643868"/>
                      <a:pt x="1412276" y="652056"/>
                      <a:pt x="1402176" y="652056"/>
                    </a:cubicBezTo>
                    <a:cubicBezTo>
                      <a:pt x="1392076" y="652056"/>
                      <a:pt x="1383888" y="643868"/>
                      <a:pt x="1383888" y="633768"/>
                    </a:cubicBezTo>
                    <a:cubicBezTo>
                      <a:pt x="1383888" y="623668"/>
                      <a:pt x="1392076" y="615480"/>
                      <a:pt x="1402176" y="615480"/>
                    </a:cubicBezTo>
                    <a:close/>
                    <a:moveTo>
                      <a:pt x="1344514" y="615480"/>
                    </a:moveTo>
                    <a:cubicBezTo>
                      <a:pt x="1354614" y="615480"/>
                      <a:pt x="1362802" y="623668"/>
                      <a:pt x="1362802" y="633768"/>
                    </a:cubicBezTo>
                    <a:cubicBezTo>
                      <a:pt x="1362802" y="643868"/>
                      <a:pt x="1354614" y="652056"/>
                      <a:pt x="1344514" y="652056"/>
                    </a:cubicBezTo>
                    <a:cubicBezTo>
                      <a:pt x="1334414" y="652056"/>
                      <a:pt x="1326226" y="643868"/>
                      <a:pt x="1326226" y="633768"/>
                    </a:cubicBezTo>
                    <a:cubicBezTo>
                      <a:pt x="1326226" y="623668"/>
                      <a:pt x="1334414" y="615480"/>
                      <a:pt x="1344514" y="615480"/>
                    </a:cubicBezTo>
                    <a:close/>
                    <a:moveTo>
                      <a:pt x="1286852" y="615480"/>
                    </a:moveTo>
                    <a:cubicBezTo>
                      <a:pt x="1296952" y="615480"/>
                      <a:pt x="1305140" y="623668"/>
                      <a:pt x="1305140" y="633768"/>
                    </a:cubicBezTo>
                    <a:cubicBezTo>
                      <a:pt x="1305140" y="643868"/>
                      <a:pt x="1296952" y="652056"/>
                      <a:pt x="1286852" y="652056"/>
                    </a:cubicBezTo>
                    <a:cubicBezTo>
                      <a:pt x="1276752" y="652056"/>
                      <a:pt x="1268564" y="643868"/>
                      <a:pt x="1268564" y="633768"/>
                    </a:cubicBezTo>
                    <a:cubicBezTo>
                      <a:pt x="1268564" y="623668"/>
                      <a:pt x="1276752" y="615480"/>
                      <a:pt x="1286852" y="615480"/>
                    </a:cubicBezTo>
                    <a:close/>
                    <a:moveTo>
                      <a:pt x="1229190" y="615480"/>
                    </a:moveTo>
                    <a:cubicBezTo>
                      <a:pt x="1239290" y="615480"/>
                      <a:pt x="1247478" y="623668"/>
                      <a:pt x="1247478" y="633768"/>
                    </a:cubicBezTo>
                    <a:cubicBezTo>
                      <a:pt x="1247478" y="643868"/>
                      <a:pt x="1239290" y="652056"/>
                      <a:pt x="1229190" y="652056"/>
                    </a:cubicBezTo>
                    <a:cubicBezTo>
                      <a:pt x="1219090" y="652056"/>
                      <a:pt x="1210902" y="643868"/>
                      <a:pt x="1210902" y="633768"/>
                    </a:cubicBezTo>
                    <a:cubicBezTo>
                      <a:pt x="1210902" y="623668"/>
                      <a:pt x="1219090" y="615480"/>
                      <a:pt x="1229190" y="615480"/>
                    </a:cubicBezTo>
                    <a:close/>
                    <a:moveTo>
                      <a:pt x="1171528" y="615480"/>
                    </a:moveTo>
                    <a:cubicBezTo>
                      <a:pt x="1181628" y="615480"/>
                      <a:pt x="1189816" y="623668"/>
                      <a:pt x="1189816" y="633768"/>
                    </a:cubicBezTo>
                    <a:cubicBezTo>
                      <a:pt x="1189816" y="643868"/>
                      <a:pt x="1181628" y="652056"/>
                      <a:pt x="1171528" y="652056"/>
                    </a:cubicBezTo>
                    <a:cubicBezTo>
                      <a:pt x="1161428" y="652056"/>
                      <a:pt x="1153240" y="643868"/>
                      <a:pt x="1153240" y="633768"/>
                    </a:cubicBezTo>
                    <a:cubicBezTo>
                      <a:pt x="1153240" y="623668"/>
                      <a:pt x="1161428" y="615480"/>
                      <a:pt x="1171528" y="615480"/>
                    </a:cubicBezTo>
                    <a:close/>
                    <a:moveTo>
                      <a:pt x="1113866" y="615480"/>
                    </a:moveTo>
                    <a:cubicBezTo>
                      <a:pt x="1123966" y="615480"/>
                      <a:pt x="1132154" y="623668"/>
                      <a:pt x="1132154" y="633768"/>
                    </a:cubicBezTo>
                    <a:cubicBezTo>
                      <a:pt x="1132154" y="643868"/>
                      <a:pt x="1123966" y="652056"/>
                      <a:pt x="1113866" y="652056"/>
                    </a:cubicBezTo>
                    <a:cubicBezTo>
                      <a:pt x="1103766" y="652056"/>
                      <a:pt x="1095578" y="643868"/>
                      <a:pt x="1095578" y="633768"/>
                    </a:cubicBezTo>
                    <a:cubicBezTo>
                      <a:pt x="1095578" y="623668"/>
                      <a:pt x="1103766" y="615480"/>
                      <a:pt x="1113866" y="615480"/>
                    </a:cubicBezTo>
                    <a:close/>
                    <a:moveTo>
                      <a:pt x="1056204" y="615480"/>
                    </a:moveTo>
                    <a:cubicBezTo>
                      <a:pt x="1066304" y="615480"/>
                      <a:pt x="1074492" y="623668"/>
                      <a:pt x="1074492" y="633768"/>
                    </a:cubicBezTo>
                    <a:cubicBezTo>
                      <a:pt x="1074492" y="643868"/>
                      <a:pt x="1066304" y="652056"/>
                      <a:pt x="1056204" y="652056"/>
                    </a:cubicBezTo>
                    <a:cubicBezTo>
                      <a:pt x="1046104" y="652056"/>
                      <a:pt x="1037916" y="643868"/>
                      <a:pt x="1037916" y="633768"/>
                    </a:cubicBezTo>
                    <a:cubicBezTo>
                      <a:pt x="1037916" y="623668"/>
                      <a:pt x="1046104" y="615480"/>
                      <a:pt x="1056204" y="615480"/>
                    </a:cubicBezTo>
                    <a:close/>
                    <a:moveTo>
                      <a:pt x="998542" y="615480"/>
                    </a:moveTo>
                    <a:cubicBezTo>
                      <a:pt x="1008642" y="615480"/>
                      <a:pt x="1016830" y="623668"/>
                      <a:pt x="1016830" y="633768"/>
                    </a:cubicBezTo>
                    <a:cubicBezTo>
                      <a:pt x="1016830" y="643868"/>
                      <a:pt x="1008642" y="652056"/>
                      <a:pt x="998542" y="652056"/>
                    </a:cubicBezTo>
                    <a:cubicBezTo>
                      <a:pt x="988442" y="652056"/>
                      <a:pt x="980254" y="643868"/>
                      <a:pt x="980254" y="633768"/>
                    </a:cubicBezTo>
                    <a:cubicBezTo>
                      <a:pt x="980254" y="623668"/>
                      <a:pt x="988442" y="615480"/>
                      <a:pt x="998542" y="615480"/>
                    </a:cubicBezTo>
                    <a:close/>
                    <a:moveTo>
                      <a:pt x="940880" y="615480"/>
                    </a:moveTo>
                    <a:cubicBezTo>
                      <a:pt x="950980" y="615480"/>
                      <a:pt x="959168" y="623668"/>
                      <a:pt x="959168" y="633768"/>
                    </a:cubicBezTo>
                    <a:cubicBezTo>
                      <a:pt x="959168" y="643868"/>
                      <a:pt x="950980" y="652056"/>
                      <a:pt x="940880" y="652056"/>
                    </a:cubicBezTo>
                    <a:cubicBezTo>
                      <a:pt x="930780" y="652056"/>
                      <a:pt x="922592" y="643868"/>
                      <a:pt x="922592" y="633768"/>
                    </a:cubicBezTo>
                    <a:cubicBezTo>
                      <a:pt x="922592" y="623668"/>
                      <a:pt x="930780" y="615480"/>
                      <a:pt x="940880" y="615480"/>
                    </a:cubicBezTo>
                    <a:close/>
                    <a:moveTo>
                      <a:pt x="883218" y="615480"/>
                    </a:moveTo>
                    <a:cubicBezTo>
                      <a:pt x="893318" y="615480"/>
                      <a:pt x="901506" y="623668"/>
                      <a:pt x="901506" y="633768"/>
                    </a:cubicBezTo>
                    <a:cubicBezTo>
                      <a:pt x="901506" y="643868"/>
                      <a:pt x="893318" y="652056"/>
                      <a:pt x="883218" y="652056"/>
                    </a:cubicBezTo>
                    <a:cubicBezTo>
                      <a:pt x="873118" y="652056"/>
                      <a:pt x="864930" y="643868"/>
                      <a:pt x="864930" y="633768"/>
                    </a:cubicBezTo>
                    <a:cubicBezTo>
                      <a:pt x="864930" y="623668"/>
                      <a:pt x="873118" y="615480"/>
                      <a:pt x="883218" y="615480"/>
                    </a:cubicBezTo>
                    <a:close/>
                    <a:moveTo>
                      <a:pt x="825556" y="615480"/>
                    </a:moveTo>
                    <a:cubicBezTo>
                      <a:pt x="835656" y="615480"/>
                      <a:pt x="843844" y="623668"/>
                      <a:pt x="843844" y="633768"/>
                    </a:cubicBezTo>
                    <a:cubicBezTo>
                      <a:pt x="843844" y="643868"/>
                      <a:pt x="835656" y="652056"/>
                      <a:pt x="825556" y="652056"/>
                    </a:cubicBezTo>
                    <a:cubicBezTo>
                      <a:pt x="815456" y="652056"/>
                      <a:pt x="807268" y="643868"/>
                      <a:pt x="807268" y="633768"/>
                    </a:cubicBezTo>
                    <a:cubicBezTo>
                      <a:pt x="807268" y="623668"/>
                      <a:pt x="815456" y="615480"/>
                      <a:pt x="825556" y="615480"/>
                    </a:cubicBezTo>
                    <a:close/>
                    <a:moveTo>
                      <a:pt x="767894" y="615480"/>
                    </a:moveTo>
                    <a:cubicBezTo>
                      <a:pt x="777994" y="615480"/>
                      <a:pt x="786182" y="623668"/>
                      <a:pt x="786182" y="633768"/>
                    </a:cubicBezTo>
                    <a:cubicBezTo>
                      <a:pt x="786182" y="643868"/>
                      <a:pt x="777994" y="652056"/>
                      <a:pt x="767894" y="652056"/>
                    </a:cubicBezTo>
                    <a:cubicBezTo>
                      <a:pt x="757794" y="652056"/>
                      <a:pt x="749606" y="643868"/>
                      <a:pt x="749606" y="633768"/>
                    </a:cubicBezTo>
                    <a:cubicBezTo>
                      <a:pt x="749606" y="623668"/>
                      <a:pt x="757794" y="615480"/>
                      <a:pt x="767894" y="615480"/>
                    </a:cubicBezTo>
                    <a:close/>
                    <a:moveTo>
                      <a:pt x="710232" y="615480"/>
                    </a:moveTo>
                    <a:cubicBezTo>
                      <a:pt x="720332" y="615480"/>
                      <a:pt x="728520" y="623668"/>
                      <a:pt x="728520" y="633768"/>
                    </a:cubicBezTo>
                    <a:cubicBezTo>
                      <a:pt x="728520" y="643868"/>
                      <a:pt x="720332" y="652056"/>
                      <a:pt x="710232" y="652056"/>
                    </a:cubicBezTo>
                    <a:cubicBezTo>
                      <a:pt x="700132" y="652056"/>
                      <a:pt x="691944" y="643868"/>
                      <a:pt x="691944" y="633768"/>
                    </a:cubicBezTo>
                    <a:cubicBezTo>
                      <a:pt x="691944" y="623668"/>
                      <a:pt x="700132" y="615480"/>
                      <a:pt x="710232" y="615480"/>
                    </a:cubicBezTo>
                    <a:close/>
                    <a:moveTo>
                      <a:pt x="652570" y="615480"/>
                    </a:moveTo>
                    <a:cubicBezTo>
                      <a:pt x="662670" y="615480"/>
                      <a:pt x="670858" y="623668"/>
                      <a:pt x="670858" y="633768"/>
                    </a:cubicBezTo>
                    <a:cubicBezTo>
                      <a:pt x="670858" y="643868"/>
                      <a:pt x="662670" y="652056"/>
                      <a:pt x="652570" y="652056"/>
                    </a:cubicBezTo>
                    <a:cubicBezTo>
                      <a:pt x="642470" y="652056"/>
                      <a:pt x="634282" y="643868"/>
                      <a:pt x="634282" y="633768"/>
                    </a:cubicBezTo>
                    <a:cubicBezTo>
                      <a:pt x="634282" y="623668"/>
                      <a:pt x="642470" y="615480"/>
                      <a:pt x="652570" y="615480"/>
                    </a:cubicBezTo>
                    <a:close/>
                    <a:moveTo>
                      <a:pt x="594908" y="615480"/>
                    </a:moveTo>
                    <a:cubicBezTo>
                      <a:pt x="605008" y="615480"/>
                      <a:pt x="613196" y="623668"/>
                      <a:pt x="613196" y="633768"/>
                    </a:cubicBezTo>
                    <a:cubicBezTo>
                      <a:pt x="613196" y="643868"/>
                      <a:pt x="605008" y="652056"/>
                      <a:pt x="594908" y="652056"/>
                    </a:cubicBezTo>
                    <a:cubicBezTo>
                      <a:pt x="584808" y="652056"/>
                      <a:pt x="576620" y="643868"/>
                      <a:pt x="576620" y="633768"/>
                    </a:cubicBezTo>
                    <a:cubicBezTo>
                      <a:pt x="576620" y="623668"/>
                      <a:pt x="584808" y="615480"/>
                      <a:pt x="594908" y="615480"/>
                    </a:cubicBezTo>
                    <a:close/>
                    <a:moveTo>
                      <a:pt x="537246" y="615480"/>
                    </a:moveTo>
                    <a:cubicBezTo>
                      <a:pt x="547346" y="615480"/>
                      <a:pt x="555534" y="623668"/>
                      <a:pt x="555534" y="633768"/>
                    </a:cubicBezTo>
                    <a:cubicBezTo>
                      <a:pt x="555534" y="643868"/>
                      <a:pt x="547346" y="652056"/>
                      <a:pt x="537246" y="652056"/>
                    </a:cubicBezTo>
                    <a:cubicBezTo>
                      <a:pt x="527146" y="652056"/>
                      <a:pt x="518958" y="643868"/>
                      <a:pt x="518958" y="633768"/>
                    </a:cubicBezTo>
                    <a:cubicBezTo>
                      <a:pt x="518958" y="623668"/>
                      <a:pt x="527146" y="615480"/>
                      <a:pt x="537246" y="615480"/>
                    </a:cubicBezTo>
                    <a:close/>
                    <a:moveTo>
                      <a:pt x="479584" y="615480"/>
                    </a:moveTo>
                    <a:cubicBezTo>
                      <a:pt x="489684" y="615480"/>
                      <a:pt x="497872" y="623668"/>
                      <a:pt x="497872" y="633768"/>
                    </a:cubicBezTo>
                    <a:cubicBezTo>
                      <a:pt x="497872" y="643868"/>
                      <a:pt x="489684" y="652056"/>
                      <a:pt x="479584" y="652056"/>
                    </a:cubicBezTo>
                    <a:cubicBezTo>
                      <a:pt x="469484" y="652056"/>
                      <a:pt x="461296" y="643868"/>
                      <a:pt x="461296" y="633768"/>
                    </a:cubicBezTo>
                    <a:cubicBezTo>
                      <a:pt x="461296" y="623668"/>
                      <a:pt x="469484" y="615480"/>
                      <a:pt x="479584" y="615480"/>
                    </a:cubicBezTo>
                    <a:close/>
                    <a:moveTo>
                      <a:pt x="421922" y="615480"/>
                    </a:moveTo>
                    <a:cubicBezTo>
                      <a:pt x="432022" y="615480"/>
                      <a:pt x="440210" y="623668"/>
                      <a:pt x="440210" y="633768"/>
                    </a:cubicBezTo>
                    <a:cubicBezTo>
                      <a:pt x="440210" y="643868"/>
                      <a:pt x="432022" y="652056"/>
                      <a:pt x="421922" y="652056"/>
                    </a:cubicBezTo>
                    <a:cubicBezTo>
                      <a:pt x="411822" y="652056"/>
                      <a:pt x="403634" y="643868"/>
                      <a:pt x="403634" y="633768"/>
                    </a:cubicBezTo>
                    <a:cubicBezTo>
                      <a:pt x="403634" y="623668"/>
                      <a:pt x="411822" y="615480"/>
                      <a:pt x="421922" y="615480"/>
                    </a:cubicBezTo>
                    <a:close/>
                    <a:moveTo>
                      <a:pt x="364260" y="615480"/>
                    </a:moveTo>
                    <a:cubicBezTo>
                      <a:pt x="374360" y="615480"/>
                      <a:pt x="382548" y="623668"/>
                      <a:pt x="382548" y="633768"/>
                    </a:cubicBezTo>
                    <a:cubicBezTo>
                      <a:pt x="382548" y="643868"/>
                      <a:pt x="374360" y="652056"/>
                      <a:pt x="364260" y="652056"/>
                    </a:cubicBezTo>
                    <a:cubicBezTo>
                      <a:pt x="354160" y="652056"/>
                      <a:pt x="345972" y="643868"/>
                      <a:pt x="345972" y="633768"/>
                    </a:cubicBezTo>
                    <a:cubicBezTo>
                      <a:pt x="345972" y="623668"/>
                      <a:pt x="354160" y="615480"/>
                      <a:pt x="364260" y="615480"/>
                    </a:cubicBezTo>
                    <a:close/>
                    <a:moveTo>
                      <a:pt x="306598" y="615480"/>
                    </a:moveTo>
                    <a:cubicBezTo>
                      <a:pt x="316698" y="615480"/>
                      <a:pt x="324886" y="623668"/>
                      <a:pt x="324886" y="633768"/>
                    </a:cubicBezTo>
                    <a:cubicBezTo>
                      <a:pt x="324886" y="643868"/>
                      <a:pt x="316698" y="652056"/>
                      <a:pt x="306598" y="652056"/>
                    </a:cubicBezTo>
                    <a:cubicBezTo>
                      <a:pt x="296498" y="652056"/>
                      <a:pt x="288310" y="643868"/>
                      <a:pt x="288310" y="633768"/>
                    </a:cubicBezTo>
                    <a:cubicBezTo>
                      <a:pt x="288310" y="623668"/>
                      <a:pt x="296498" y="615480"/>
                      <a:pt x="306598" y="615480"/>
                    </a:cubicBezTo>
                    <a:close/>
                    <a:moveTo>
                      <a:pt x="248936" y="615480"/>
                    </a:moveTo>
                    <a:cubicBezTo>
                      <a:pt x="259036" y="615480"/>
                      <a:pt x="267224" y="623668"/>
                      <a:pt x="267224" y="633768"/>
                    </a:cubicBezTo>
                    <a:cubicBezTo>
                      <a:pt x="267224" y="643868"/>
                      <a:pt x="259036" y="652056"/>
                      <a:pt x="248936" y="652056"/>
                    </a:cubicBezTo>
                    <a:cubicBezTo>
                      <a:pt x="238836" y="652056"/>
                      <a:pt x="230648" y="643868"/>
                      <a:pt x="230648" y="633768"/>
                    </a:cubicBezTo>
                    <a:cubicBezTo>
                      <a:pt x="230648" y="623668"/>
                      <a:pt x="238836" y="615480"/>
                      <a:pt x="248936" y="615480"/>
                    </a:cubicBezTo>
                    <a:close/>
                    <a:moveTo>
                      <a:pt x="191274" y="615480"/>
                    </a:moveTo>
                    <a:cubicBezTo>
                      <a:pt x="201374" y="615480"/>
                      <a:pt x="209562" y="623668"/>
                      <a:pt x="209562" y="633768"/>
                    </a:cubicBezTo>
                    <a:cubicBezTo>
                      <a:pt x="209562" y="643868"/>
                      <a:pt x="201374" y="652056"/>
                      <a:pt x="191274" y="652056"/>
                    </a:cubicBezTo>
                    <a:cubicBezTo>
                      <a:pt x="181174" y="652056"/>
                      <a:pt x="172986" y="643868"/>
                      <a:pt x="172986" y="633768"/>
                    </a:cubicBezTo>
                    <a:cubicBezTo>
                      <a:pt x="172986" y="623668"/>
                      <a:pt x="181174" y="615480"/>
                      <a:pt x="191274" y="615480"/>
                    </a:cubicBezTo>
                    <a:close/>
                    <a:moveTo>
                      <a:pt x="133612" y="615480"/>
                    </a:moveTo>
                    <a:cubicBezTo>
                      <a:pt x="143712" y="615480"/>
                      <a:pt x="151900" y="623668"/>
                      <a:pt x="151900" y="633768"/>
                    </a:cubicBezTo>
                    <a:cubicBezTo>
                      <a:pt x="151900" y="643868"/>
                      <a:pt x="143712" y="652056"/>
                      <a:pt x="133612" y="652056"/>
                    </a:cubicBezTo>
                    <a:cubicBezTo>
                      <a:pt x="123512" y="652056"/>
                      <a:pt x="115324" y="643868"/>
                      <a:pt x="115324" y="633768"/>
                    </a:cubicBezTo>
                    <a:cubicBezTo>
                      <a:pt x="115324" y="623668"/>
                      <a:pt x="123512" y="615480"/>
                      <a:pt x="133612" y="615480"/>
                    </a:cubicBezTo>
                    <a:close/>
                    <a:moveTo>
                      <a:pt x="75950" y="615480"/>
                    </a:moveTo>
                    <a:cubicBezTo>
                      <a:pt x="86050" y="615480"/>
                      <a:pt x="94238" y="623668"/>
                      <a:pt x="94238" y="633768"/>
                    </a:cubicBezTo>
                    <a:cubicBezTo>
                      <a:pt x="94238" y="643868"/>
                      <a:pt x="86050" y="652056"/>
                      <a:pt x="75950" y="652056"/>
                    </a:cubicBezTo>
                    <a:cubicBezTo>
                      <a:pt x="65850" y="652056"/>
                      <a:pt x="57662" y="643868"/>
                      <a:pt x="57662" y="633768"/>
                    </a:cubicBezTo>
                    <a:cubicBezTo>
                      <a:pt x="57662" y="623668"/>
                      <a:pt x="65850" y="615480"/>
                      <a:pt x="75950" y="615480"/>
                    </a:cubicBezTo>
                    <a:close/>
                    <a:moveTo>
                      <a:pt x="18288" y="615480"/>
                    </a:moveTo>
                    <a:cubicBezTo>
                      <a:pt x="28388" y="615480"/>
                      <a:pt x="36576" y="623668"/>
                      <a:pt x="36576" y="633768"/>
                    </a:cubicBezTo>
                    <a:cubicBezTo>
                      <a:pt x="36576" y="643868"/>
                      <a:pt x="28388" y="652056"/>
                      <a:pt x="18288" y="652056"/>
                    </a:cubicBezTo>
                    <a:cubicBezTo>
                      <a:pt x="8188" y="652056"/>
                      <a:pt x="0" y="643868"/>
                      <a:pt x="0" y="633768"/>
                    </a:cubicBezTo>
                    <a:cubicBezTo>
                      <a:pt x="0" y="623668"/>
                      <a:pt x="8188" y="615480"/>
                      <a:pt x="18288" y="615480"/>
                    </a:cubicBezTo>
                    <a:close/>
                    <a:moveTo>
                      <a:pt x="1459848" y="564190"/>
                    </a:moveTo>
                    <a:cubicBezTo>
                      <a:pt x="1469948" y="564190"/>
                      <a:pt x="1478136" y="572378"/>
                      <a:pt x="1478136" y="582478"/>
                    </a:cubicBezTo>
                    <a:cubicBezTo>
                      <a:pt x="1478136" y="592578"/>
                      <a:pt x="1469948" y="600766"/>
                      <a:pt x="1459848" y="600766"/>
                    </a:cubicBezTo>
                    <a:cubicBezTo>
                      <a:pt x="1449748" y="600766"/>
                      <a:pt x="1441560" y="592578"/>
                      <a:pt x="1441560" y="582478"/>
                    </a:cubicBezTo>
                    <a:cubicBezTo>
                      <a:pt x="1441560" y="572378"/>
                      <a:pt x="1449748" y="564190"/>
                      <a:pt x="1459848" y="564190"/>
                    </a:cubicBezTo>
                    <a:close/>
                    <a:moveTo>
                      <a:pt x="1402176" y="564190"/>
                    </a:moveTo>
                    <a:cubicBezTo>
                      <a:pt x="1412276" y="564190"/>
                      <a:pt x="1420464" y="572378"/>
                      <a:pt x="1420464" y="582478"/>
                    </a:cubicBezTo>
                    <a:cubicBezTo>
                      <a:pt x="1420464" y="592578"/>
                      <a:pt x="1412276" y="600766"/>
                      <a:pt x="1402176" y="600766"/>
                    </a:cubicBezTo>
                    <a:cubicBezTo>
                      <a:pt x="1392076" y="600766"/>
                      <a:pt x="1383888" y="592578"/>
                      <a:pt x="1383888" y="582478"/>
                    </a:cubicBezTo>
                    <a:cubicBezTo>
                      <a:pt x="1383888" y="572378"/>
                      <a:pt x="1392076" y="564190"/>
                      <a:pt x="1402176" y="564190"/>
                    </a:cubicBezTo>
                    <a:close/>
                    <a:moveTo>
                      <a:pt x="1344514" y="564190"/>
                    </a:moveTo>
                    <a:cubicBezTo>
                      <a:pt x="1354614" y="564190"/>
                      <a:pt x="1362802" y="572378"/>
                      <a:pt x="1362802" y="582478"/>
                    </a:cubicBezTo>
                    <a:cubicBezTo>
                      <a:pt x="1362802" y="592578"/>
                      <a:pt x="1354614" y="600766"/>
                      <a:pt x="1344514" y="600766"/>
                    </a:cubicBezTo>
                    <a:cubicBezTo>
                      <a:pt x="1334414" y="600766"/>
                      <a:pt x="1326226" y="592578"/>
                      <a:pt x="1326226" y="582478"/>
                    </a:cubicBezTo>
                    <a:cubicBezTo>
                      <a:pt x="1326226" y="572378"/>
                      <a:pt x="1334414" y="564190"/>
                      <a:pt x="1344514" y="564190"/>
                    </a:cubicBezTo>
                    <a:close/>
                    <a:moveTo>
                      <a:pt x="1286852" y="564190"/>
                    </a:moveTo>
                    <a:cubicBezTo>
                      <a:pt x="1296952" y="564190"/>
                      <a:pt x="1305140" y="572378"/>
                      <a:pt x="1305140" y="582478"/>
                    </a:cubicBezTo>
                    <a:cubicBezTo>
                      <a:pt x="1305140" y="592578"/>
                      <a:pt x="1296952" y="600766"/>
                      <a:pt x="1286852" y="600766"/>
                    </a:cubicBezTo>
                    <a:cubicBezTo>
                      <a:pt x="1276752" y="600766"/>
                      <a:pt x="1268564" y="592578"/>
                      <a:pt x="1268564" y="582478"/>
                    </a:cubicBezTo>
                    <a:cubicBezTo>
                      <a:pt x="1268564" y="572378"/>
                      <a:pt x="1276752" y="564190"/>
                      <a:pt x="1286852" y="564190"/>
                    </a:cubicBezTo>
                    <a:close/>
                    <a:moveTo>
                      <a:pt x="1229190" y="564190"/>
                    </a:moveTo>
                    <a:cubicBezTo>
                      <a:pt x="1239290" y="564190"/>
                      <a:pt x="1247478" y="572378"/>
                      <a:pt x="1247478" y="582478"/>
                    </a:cubicBezTo>
                    <a:cubicBezTo>
                      <a:pt x="1247478" y="592578"/>
                      <a:pt x="1239290" y="600766"/>
                      <a:pt x="1229190" y="600766"/>
                    </a:cubicBezTo>
                    <a:cubicBezTo>
                      <a:pt x="1219090" y="600766"/>
                      <a:pt x="1210902" y="592578"/>
                      <a:pt x="1210902" y="582478"/>
                    </a:cubicBezTo>
                    <a:cubicBezTo>
                      <a:pt x="1210902" y="572378"/>
                      <a:pt x="1219090" y="564190"/>
                      <a:pt x="1229190" y="564190"/>
                    </a:cubicBezTo>
                    <a:close/>
                    <a:moveTo>
                      <a:pt x="1171528" y="564190"/>
                    </a:moveTo>
                    <a:cubicBezTo>
                      <a:pt x="1181628" y="564190"/>
                      <a:pt x="1189816" y="572378"/>
                      <a:pt x="1189816" y="582478"/>
                    </a:cubicBezTo>
                    <a:cubicBezTo>
                      <a:pt x="1189816" y="592578"/>
                      <a:pt x="1181628" y="600766"/>
                      <a:pt x="1171528" y="600766"/>
                    </a:cubicBezTo>
                    <a:cubicBezTo>
                      <a:pt x="1161428" y="600766"/>
                      <a:pt x="1153240" y="592578"/>
                      <a:pt x="1153240" y="582478"/>
                    </a:cubicBezTo>
                    <a:cubicBezTo>
                      <a:pt x="1153240" y="572378"/>
                      <a:pt x="1161428" y="564190"/>
                      <a:pt x="1171528" y="564190"/>
                    </a:cubicBezTo>
                    <a:close/>
                    <a:moveTo>
                      <a:pt x="1113866" y="564190"/>
                    </a:moveTo>
                    <a:cubicBezTo>
                      <a:pt x="1123966" y="564190"/>
                      <a:pt x="1132154" y="572378"/>
                      <a:pt x="1132154" y="582478"/>
                    </a:cubicBezTo>
                    <a:cubicBezTo>
                      <a:pt x="1132154" y="592578"/>
                      <a:pt x="1123966" y="600766"/>
                      <a:pt x="1113866" y="600766"/>
                    </a:cubicBezTo>
                    <a:cubicBezTo>
                      <a:pt x="1103766" y="600766"/>
                      <a:pt x="1095578" y="592578"/>
                      <a:pt x="1095578" y="582478"/>
                    </a:cubicBezTo>
                    <a:cubicBezTo>
                      <a:pt x="1095578" y="572378"/>
                      <a:pt x="1103766" y="564190"/>
                      <a:pt x="1113866" y="564190"/>
                    </a:cubicBezTo>
                    <a:close/>
                    <a:moveTo>
                      <a:pt x="1056204" y="564190"/>
                    </a:moveTo>
                    <a:cubicBezTo>
                      <a:pt x="1066304" y="564190"/>
                      <a:pt x="1074492" y="572378"/>
                      <a:pt x="1074492" y="582478"/>
                    </a:cubicBezTo>
                    <a:cubicBezTo>
                      <a:pt x="1074492" y="592578"/>
                      <a:pt x="1066304" y="600766"/>
                      <a:pt x="1056204" y="600766"/>
                    </a:cubicBezTo>
                    <a:cubicBezTo>
                      <a:pt x="1046104" y="600766"/>
                      <a:pt x="1037916" y="592578"/>
                      <a:pt x="1037916" y="582478"/>
                    </a:cubicBezTo>
                    <a:cubicBezTo>
                      <a:pt x="1037916" y="572378"/>
                      <a:pt x="1046104" y="564190"/>
                      <a:pt x="1056204" y="564190"/>
                    </a:cubicBezTo>
                    <a:close/>
                    <a:moveTo>
                      <a:pt x="998542" y="564190"/>
                    </a:moveTo>
                    <a:cubicBezTo>
                      <a:pt x="1008642" y="564190"/>
                      <a:pt x="1016830" y="572378"/>
                      <a:pt x="1016830" y="582478"/>
                    </a:cubicBezTo>
                    <a:cubicBezTo>
                      <a:pt x="1016830" y="592578"/>
                      <a:pt x="1008642" y="600766"/>
                      <a:pt x="998542" y="600766"/>
                    </a:cubicBezTo>
                    <a:cubicBezTo>
                      <a:pt x="988442" y="600766"/>
                      <a:pt x="980254" y="592578"/>
                      <a:pt x="980254" y="582478"/>
                    </a:cubicBezTo>
                    <a:cubicBezTo>
                      <a:pt x="980254" y="572378"/>
                      <a:pt x="988442" y="564190"/>
                      <a:pt x="998542" y="564190"/>
                    </a:cubicBezTo>
                    <a:close/>
                    <a:moveTo>
                      <a:pt x="940880" y="564190"/>
                    </a:moveTo>
                    <a:cubicBezTo>
                      <a:pt x="950980" y="564190"/>
                      <a:pt x="959168" y="572378"/>
                      <a:pt x="959168" y="582478"/>
                    </a:cubicBezTo>
                    <a:cubicBezTo>
                      <a:pt x="959168" y="592578"/>
                      <a:pt x="950980" y="600766"/>
                      <a:pt x="940880" y="600766"/>
                    </a:cubicBezTo>
                    <a:cubicBezTo>
                      <a:pt x="930780" y="600766"/>
                      <a:pt x="922592" y="592578"/>
                      <a:pt x="922592" y="582478"/>
                    </a:cubicBezTo>
                    <a:cubicBezTo>
                      <a:pt x="922592" y="572378"/>
                      <a:pt x="930780" y="564190"/>
                      <a:pt x="940880" y="564190"/>
                    </a:cubicBezTo>
                    <a:close/>
                    <a:moveTo>
                      <a:pt x="883218" y="564190"/>
                    </a:moveTo>
                    <a:cubicBezTo>
                      <a:pt x="893318" y="564190"/>
                      <a:pt x="901506" y="572378"/>
                      <a:pt x="901506" y="582478"/>
                    </a:cubicBezTo>
                    <a:cubicBezTo>
                      <a:pt x="901506" y="592578"/>
                      <a:pt x="893318" y="600766"/>
                      <a:pt x="883218" y="600766"/>
                    </a:cubicBezTo>
                    <a:cubicBezTo>
                      <a:pt x="873118" y="600766"/>
                      <a:pt x="864930" y="592578"/>
                      <a:pt x="864930" y="582478"/>
                    </a:cubicBezTo>
                    <a:cubicBezTo>
                      <a:pt x="864930" y="572378"/>
                      <a:pt x="873118" y="564190"/>
                      <a:pt x="883218" y="564190"/>
                    </a:cubicBezTo>
                    <a:close/>
                    <a:moveTo>
                      <a:pt x="825556" y="564190"/>
                    </a:moveTo>
                    <a:cubicBezTo>
                      <a:pt x="835656" y="564190"/>
                      <a:pt x="843844" y="572378"/>
                      <a:pt x="843844" y="582478"/>
                    </a:cubicBezTo>
                    <a:cubicBezTo>
                      <a:pt x="843844" y="592578"/>
                      <a:pt x="835656" y="600766"/>
                      <a:pt x="825556" y="600766"/>
                    </a:cubicBezTo>
                    <a:cubicBezTo>
                      <a:pt x="815456" y="600766"/>
                      <a:pt x="807268" y="592578"/>
                      <a:pt x="807268" y="582478"/>
                    </a:cubicBezTo>
                    <a:cubicBezTo>
                      <a:pt x="807268" y="572378"/>
                      <a:pt x="815456" y="564190"/>
                      <a:pt x="825556" y="564190"/>
                    </a:cubicBezTo>
                    <a:close/>
                    <a:moveTo>
                      <a:pt x="767894" y="564190"/>
                    </a:moveTo>
                    <a:cubicBezTo>
                      <a:pt x="777994" y="564190"/>
                      <a:pt x="786182" y="572378"/>
                      <a:pt x="786182" y="582478"/>
                    </a:cubicBezTo>
                    <a:cubicBezTo>
                      <a:pt x="786182" y="592578"/>
                      <a:pt x="777994" y="600766"/>
                      <a:pt x="767894" y="600766"/>
                    </a:cubicBezTo>
                    <a:cubicBezTo>
                      <a:pt x="757794" y="600766"/>
                      <a:pt x="749606" y="592578"/>
                      <a:pt x="749606" y="582478"/>
                    </a:cubicBezTo>
                    <a:cubicBezTo>
                      <a:pt x="749606" y="572378"/>
                      <a:pt x="757794" y="564190"/>
                      <a:pt x="767894" y="564190"/>
                    </a:cubicBezTo>
                    <a:close/>
                    <a:moveTo>
                      <a:pt x="710232" y="564190"/>
                    </a:moveTo>
                    <a:cubicBezTo>
                      <a:pt x="720332" y="564190"/>
                      <a:pt x="728520" y="572378"/>
                      <a:pt x="728520" y="582478"/>
                    </a:cubicBezTo>
                    <a:cubicBezTo>
                      <a:pt x="728520" y="592578"/>
                      <a:pt x="720332" y="600766"/>
                      <a:pt x="710232" y="600766"/>
                    </a:cubicBezTo>
                    <a:cubicBezTo>
                      <a:pt x="700132" y="600766"/>
                      <a:pt x="691944" y="592578"/>
                      <a:pt x="691944" y="582478"/>
                    </a:cubicBezTo>
                    <a:cubicBezTo>
                      <a:pt x="691944" y="572378"/>
                      <a:pt x="700132" y="564190"/>
                      <a:pt x="710232" y="564190"/>
                    </a:cubicBezTo>
                    <a:close/>
                    <a:moveTo>
                      <a:pt x="652570" y="564190"/>
                    </a:moveTo>
                    <a:cubicBezTo>
                      <a:pt x="662670" y="564190"/>
                      <a:pt x="670858" y="572378"/>
                      <a:pt x="670858" y="582478"/>
                    </a:cubicBezTo>
                    <a:cubicBezTo>
                      <a:pt x="670858" y="592578"/>
                      <a:pt x="662670" y="600766"/>
                      <a:pt x="652570" y="600766"/>
                    </a:cubicBezTo>
                    <a:cubicBezTo>
                      <a:pt x="642470" y="600766"/>
                      <a:pt x="634282" y="592578"/>
                      <a:pt x="634282" y="582478"/>
                    </a:cubicBezTo>
                    <a:cubicBezTo>
                      <a:pt x="634282" y="572378"/>
                      <a:pt x="642470" y="564190"/>
                      <a:pt x="652570" y="564190"/>
                    </a:cubicBezTo>
                    <a:close/>
                    <a:moveTo>
                      <a:pt x="594908" y="564190"/>
                    </a:moveTo>
                    <a:cubicBezTo>
                      <a:pt x="605008" y="564190"/>
                      <a:pt x="613196" y="572378"/>
                      <a:pt x="613196" y="582478"/>
                    </a:cubicBezTo>
                    <a:cubicBezTo>
                      <a:pt x="613196" y="592578"/>
                      <a:pt x="605008" y="600766"/>
                      <a:pt x="594908" y="600766"/>
                    </a:cubicBezTo>
                    <a:cubicBezTo>
                      <a:pt x="584808" y="600766"/>
                      <a:pt x="576620" y="592578"/>
                      <a:pt x="576620" y="582478"/>
                    </a:cubicBezTo>
                    <a:cubicBezTo>
                      <a:pt x="576620" y="572378"/>
                      <a:pt x="584808" y="564190"/>
                      <a:pt x="594908" y="564190"/>
                    </a:cubicBezTo>
                    <a:close/>
                    <a:moveTo>
                      <a:pt x="537246" y="564190"/>
                    </a:moveTo>
                    <a:cubicBezTo>
                      <a:pt x="547346" y="564190"/>
                      <a:pt x="555534" y="572378"/>
                      <a:pt x="555534" y="582478"/>
                    </a:cubicBezTo>
                    <a:cubicBezTo>
                      <a:pt x="555534" y="592578"/>
                      <a:pt x="547346" y="600766"/>
                      <a:pt x="537246" y="600766"/>
                    </a:cubicBezTo>
                    <a:cubicBezTo>
                      <a:pt x="527146" y="600766"/>
                      <a:pt x="518958" y="592578"/>
                      <a:pt x="518958" y="582478"/>
                    </a:cubicBezTo>
                    <a:cubicBezTo>
                      <a:pt x="518958" y="572378"/>
                      <a:pt x="527146" y="564190"/>
                      <a:pt x="537246" y="564190"/>
                    </a:cubicBezTo>
                    <a:close/>
                    <a:moveTo>
                      <a:pt x="479584" y="564190"/>
                    </a:moveTo>
                    <a:cubicBezTo>
                      <a:pt x="489684" y="564190"/>
                      <a:pt x="497872" y="572378"/>
                      <a:pt x="497872" y="582478"/>
                    </a:cubicBezTo>
                    <a:cubicBezTo>
                      <a:pt x="497872" y="592578"/>
                      <a:pt x="489684" y="600766"/>
                      <a:pt x="479584" y="600766"/>
                    </a:cubicBezTo>
                    <a:cubicBezTo>
                      <a:pt x="469484" y="600766"/>
                      <a:pt x="461296" y="592578"/>
                      <a:pt x="461296" y="582478"/>
                    </a:cubicBezTo>
                    <a:cubicBezTo>
                      <a:pt x="461296" y="572378"/>
                      <a:pt x="469484" y="564190"/>
                      <a:pt x="479584" y="564190"/>
                    </a:cubicBezTo>
                    <a:close/>
                    <a:moveTo>
                      <a:pt x="421922" y="564190"/>
                    </a:moveTo>
                    <a:cubicBezTo>
                      <a:pt x="432022" y="564190"/>
                      <a:pt x="440210" y="572378"/>
                      <a:pt x="440210" y="582478"/>
                    </a:cubicBezTo>
                    <a:cubicBezTo>
                      <a:pt x="440210" y="592578"/>
                      <a:pt x="432022" y="600766"/>
                      <a:pt x="421922" y="600766"/>
                    </a:cubicBezTo>
                    <a:cubicBezTo>
                      <a:pt x="411822" y="600766"/>
                      <a:pt x="403634" y="592578"/>
                      <a:pt x="403634" y="582478"/>
                    </a:cubicBezTo>
                    <a:cubicBezTo>
                      <a:pt x="403634" y="572378"/>
                      <a:pt x="411822" y="564190"/>
                      <a:pt x="421922" y="564190"/>
                    </a:cubicBezTo>
                    <a:close/>
                    <a:moveTo>
                      <a:pt x="364260" y="564190"/>
                    </a:moveTo>
                    <a:cubicBezTo>
                      <a:pt x="374360" y="564190"/>
                      <a:pt x="382548" y="572378"/>
                      <a:pt x="382548" y="582478"/>
                    </a:cubicBezTo>
                    <a:cubicBezTo>
                      <a:pt x="382548" y="592578"/>
                      <a:pt x="374360" y="600766"/>
                      <a:pt x="364260" y="600766"/>
                    </a:cubicBezTo>
                    <a:cubicBezTo>
                      <a:pt x="354160" y="600766"/>
                      <a:pt x="345972" y="592578"/>
                      <a:pt x="345972" y="582478"/>
                    </a:cubicBezTo>
                    <a:cubicBezTo>
                      <a:pt x="345972" y="572378"/>
                      <a:pt x="354160" y="564190"/>
                      <a:pt x="364260" y="564190"/>
                    </a:cubicBezTo>
                    <a:close/>
                    <a:moveTo>
                      <a:pt x="306598" y="564190"/>
                    </a:moveTo>
                    <a:cubicBezTo>
                      <a:pt x="316698" y="564190"/>
                      <a:pt x="324886" y="572378"/>
                      <a:pt x="324886" y="582478"/>
                    </a:cubicBezTo>
                    <a:cubicBezTo>
                      <a:pt x="324886" y="592578"/>
                      <a:pt x="316698" y="600766"/>
                      <a:pt x="306598" y="600766"/>
                    </a:cubicBezTo>
                    <a:cubicBezTo>
                      <a:pt x="296498" y="600766"/>
                      <a:pt x="288310" y="592578"/>
                      <a:pt x="288310" y="582478"/>
                    </a:cubicBezTo>
                    <a:cubicBezTo>
                      <a:pt x="288310" y="572378"/>
                      <a:pt x="296498" y="564190"/>
                      <a:pt x="306598" y="564190"/>
                    </a:cubicBezTo>
                    <a:close/>
                    <a:moveTo>
                      <a:pt x="248936" y="564190"/>
                    </a:moveTo>
                    <a:cubicBezTo>
                      <a:pt x="259036" y="564190"/>
                      <a:pt x="267224" y="572378"/>
                      <a:pt x="267224" y="582478"/>
                    </a:cubicBezTo>
                    <a:cubicBezTo>
                      <a:pt x="267224" y="592578"/>
                      <a:pt x="259036" y="600766"/>
                      <a:pt x="248936" y="600766"/>
                    </a:cubicBezTo>
                    <a:cubicBezTo>
                      <a:pt x="238836" y="600766"/>
                      <a:pt x="230648" y="592578"/>
                      <a:pt x="230648" y="582478"/>
                    </a:cubicBezTo>
                    <a:cubicBezTo>
                      <a:pt x="230648" y="572378"/>
                      <a:pt x="238836" y="564190"/>
                      <a:pt x="248936" y="564190"/>
                    </a:cubicBezTo>
                    <a:close/>
                    <a:moveTo>
                      <a:pt x="191274" y="564190"/>
                    </a:moveTo>
                    <a:cubicBezTo>
                      <a:pt x="201374" y="564190"/>
                      <a:pt x="209562" y="572378"/>
                      <a:pt x="209562" y="582478"/>
                    </a:cubicBezTo>
                    <a:cubicBezTo>
                      <a:pt x="209562" y="592578"/>
                      <a:pt x="201374" y="600766"/>
                      <a:pt x="191274" y="600766"/>
                    </a:cubicBezTo>
                    <a:cubicBezTo>
                      <a:pt x="181174" y="600766"/>
                      <a:pt x="172986" y="592578"/>
                      <a:pt x="172986" y="582478"/>
                    </a:cubicBezTo>
                    <a:cubicBezTo>
                      <a:pt x="172986" y="572378"/>
                      <a:pt x="181174" y="564190"/>
                      <a:pt x="191274" y="564190"/>
                    </a:cubicBezTo>
                    <a:close/>
                    <a:moveTo>
                      <a:pt x="133612" y="564190"/>
                    </a:moveTo>
                    <a:cubicBezTo>
                      <a:pt x="143712" y="564190"/>
                      <a:pt x="151900" y="572378"/>
                      <a:pt x="151900" y="582478"/>
                    </a:cubicBezTo>
                    <a:cubicBezTo>
                      <a:pt x="151900" y="592578"/>
                      <a:pt x="143712" y="600766"/>
                      <a:pt x="133612" y="600766"/>
                    </a:cubicBezTo>
                    <a:cubicBezTo>
                      <a:pt x="123512" y="600766"/>
                      <a:pt x="115324" y="592578"/>
                      <a:pt x="115324" y="582478"/>
                    </a:cubicBezTo>
                    <a:cubicBezTo>
                      <a:pt x="115324" y="572378"/>
                      <a:pt x="123512" y="564190"/>
                      <a:pt x="133612" y="564190"/>
                    </a:cubicBezTo>
                    <a:close/>
                    <a:moveTo>
                      <a:pt x="75950" y="564190"/>
                    </a:moveTo>
                    <a:cubicBezTo>
                      <a:pt x="86050" y="564190"/>
                      <a:pt x="94238" y="572378"/>
                      <a:pt x="94238" y="582478"/>
                    </a:cubicBezTo>
                    <a:cubicBezTo>
                      <a:pt x="94238" y="592578"/>
                      <a:pt x="86050" y="600766"/>
                      <a:pt x="75950" y="600766"/>
                    </a:cubicBezTo>
                    <a:cubicBezTo>
                      <a:pt x="65850" y="600766"/>
                      <a:pt x="57662" y="592578"/>
                      <a:pt x="57662" y="582478"/>
                    </a:cubicBezTo>
                    <a:cubicBezTo>
                      <a:pt x="57662" y="572378"/>
                      <a:pt x="65850" y="564190"/>
                      <a:pt x="75950" y="564190"/>
                    </a:cubicBezTo>
                    <a:close/>
                    <a:moveTo>
                      <a:pt x="18288" y="564190"/>
                    </a:moveTo>
                    <a:cubicBezTo>
                      <a:pt x="28388" y="564190"/>
                      <a:pt x="36576" y="572378"/>
                      <a:pt x="36576" y="582478"/>
                    </a:cubicBezTo>
                    <a:cubicBezTo>
                      <a:pt x="36576" y="592578"/>
                      <a:pt x="28388" y="600766"/>
                      <a:pt x="18288" y="600766"/>
                    </a:cubicBezTo>
                    <a:cubicBezTo>
                      <a:pt x="8188" y="600766"/>
                      <a:pt x="0" y="592578"/>
                      <a:pt x="0" y="582478"/>
                    </a:cubicBezTo>
                    <a:cubicBezTo>
                      <a:pt x="0" y="572378"/>
                      <a:pt x="8188" y="564190"/>
                      <a:pt x="18288" y="564190"/>
                    </a:cubicBezTo>
                    <a:close/>
                    <a:moveTo>
                      <a:pt x="1459848" y="512900"/>
                    </a:moveTo>
                    <a:cubicBezTo>
                      <a:pt x="1469948" y="512900"/>
                      <a:pt x="1478136" y="521088"/>
                      <a:pt x="1478136" y="531188"/>
                    </a:cubicBezTo>
                    <a:cubicBezTo>
                      <a:pt x="1478136" y="541288"/>
                      <a:pt x="1469948" y="549476"/>
                      <a:pt x="1459848" y="549476"/>
                    </a:cubicBezTo>
                    <a:cubicBezTo>
                      <a:pt x="1449748" y="549476"/>
                      <a:pt x="1441560" y="541288"/>
                      <a:pt x="1441560" y="531188"/>
                    </a:cubicBezTo>
                    <a:cubicBezTo>
                      <a:pt x="1441560" y="521088"/>
                      <a:pt x="1449748" y="512900"/>
                      <a:pt x="1459848" y="512900"/>
                    </a:cubicBezTo>
                    <a:close/>
                    <a:moveTo>
                      <a:pt x="1402176" y="512900"/>
                    </a:moveTo>
                    <a:cubicBezTo>
                      <a:pt x="1412276" y="512900"/>
                      <a:pt x="1420464" y="521088"/>
                      <a:pt x="1420464" y="531188"/>
                    </a:cubicBezTo>
                    <a:cubicBezTo>
                      <a:pt x="1420464" y="541288"/>
                      <a:pt x="1412276" y="549476"/>
                      <a:pt x="1402176" y="549476"/>
                    </a:cubicBezTo>
                    <a:cubicBezTo>
                      <a:pt x="1392076" y="549476"/>
                      <a:pt x="1383888" y="541288"/>
                      <a:pt x="1383888" y="531188"/>
                    </a:cubicBezTo>
                    <a:cubicBezTo>
                      <a:pt x="1383888" y="521088"/>
                      <a:pt x="1392076" y="512900"/>
                      <a:pt x="1402176" y="512900"/>
                    </a:cubicBezTo>
                    <a:close/>
                    <a:moveTo>
                      <a:pt x="1344514" y="512900"/>
                    </a:moveTo>
                    <a:cubicBezTo>
                      <a:pt x="1354614" y="512900"/>
                      <a:pt x="1362802" y="521088"/>
                      <a:pt x="1362802" y="531188"/>
                    </a:cubicBezTo>
                    <a:cubicBezTo>
                      <a:pt x="1362802" y="541288"/>
                      <a:pt x="1354614" y="549476"/>
                      <a:pt x="1344514" y="549476"/>
                    </a:cubicBezTo>
                    <a:cubicBezTo>
                      <a:pt x="1334414" y="549476"/>
                      <a:pt x="1326226" y="541288"/>
                      <a:pt x="1326226" y="531188"/>
                    </a:cubicBezTo>
                    <a:cubicBezTo>
                      <a:pt x="1326226" y="521088"/>
                      <a:pt x="1334414" y="512900"/>
                      <a:pt x="1344514" y="512900"/>
                    </a:cubicBezTo>
                    <a:close/>
                    <a:moveTo>
                      <a:pt x="1286852" y="512900"/>
                    </a:moveTo>
                    <a:cubicBezTo>
                      <a:pt x="1296952" y="512900"/>
                      <a:pt x="1305140" y="521088"/>
                      <a:pt x="1305140" y="531188"/>
                    </a:cubicBezTo>
                    <a:cubicBezTo>
                      <a:pt x="1305140" y="541288"/>
                      <a:pt x="1296952" y="549476"/>
                      <a:pt x="1286852" y="549476"/>
                    </a:cubicBezTo>
                    <a:cubicBezTo>
                      <a:pt x="1276752" y="549476"/>
                      <a:pt x="1268564" y="541288"/>
                      <a:pt x="1268564" y="531188"/>
                    </a:cubicBezTo>
                    <a:cubicBezTo>
                      <a:pt x="1268564" y="521088"/>
                      <a:pt x="1276752" y="512900"/>
                      <a:pt x="1286852" y="512900"/>
                    </a:cubicBezTo>
                    <a:close/>
                    <a:moveTo>
                      <a:pt x="1229190" y="512900"/>
                    </a:moveTo>
                    <a:cubicBezTo>
                      <a:pt x="1239290" y="512900"/>
                      <a:pt x="1247478" y="521088"/>
                      <a:pt x="1247478" y="531188"/>
                    </a:cubicBezTo>
                    <a:cubicBezTo>
                      <a:pt x="1247478" y="541288"/>
                      <a:pt x="1239290" y="549476"/>
                      <a:pt x="1229190" y="549476"/>
                    </a:cubicBezTo>
                    <a:cubicBezTo>
                      <a:pt x="1219090" y="549476"/>
                      <a:pt x="1210902" y="541288"/>
                      <a:pt x="1210902" y="531188"/>
                    </a:cubicBezTo>
                    <a:cubicBezTo>
                      <a:pt x="1210902" y="521088"/>
                      <a:pt x="1219090" y="512900"/>
                      <a:pt x="1229190" y="512900"/>
                    </a:cubicBezTo>
                    <a:close/>
                    <a:moveTo>
                      <a:pt x="1171528" y="512900"/>
                    </a:moveTo>
                    <a:cubicBezTo>
                      <a:pt x="1181628" y="512900"/>
                      <a:pt x="1189816" y="521088"/>
                      <a:pt x="1189816" y="531188"/>
                    </a:cubicBezTo>
                    <a:cubicBezTo>
                      <a:pt x="1189816" y="541288"/>
                      <a:pt x="1181628" y="549476"/>
                      <a:pt x="1171528" y="549476"/>
                    </a:cubicBezTo>
                    <a:cubicBezTo>
                      <a:pt x="1161428" y="549476"/>
                      <a:pt x="1153240" y="541288"/>
                      <a:pt x="1153240" y="531188"/>
                    </a:cubicBezTo>
                    <a:cubicBezTo>
                      <a:pt x="1153240" y="521088"/>
                      <a:pt x="1161428" y="512900"/>
                      <a:pt x="1171528" y="512900"/>
                    </a:cubicBezTo>
                    <a:close/>
                    <a:moveTo>
                      <a:pt x="1113866" y="512900"/>
                    </a:moveTo>
                    <a:cubicBezTo>
                      <a:pt x="1123966" y="512900"/>
                      <a:pt x="1132154" y="521088"/>
                      <a:pt x="1132154" y="531188"/>
                    </a:cubicBezTo>
                    <a:cubicBezTo>
                      <a:pt x="1132154" y="541288"/>
                      <a:pt x="1123966" y="549476"/>
                      <a:pt x="1113866" y="549476"/>
                    </a:cubicBezTo>
                    <a:cubicBezTo>
                      <a:pt x="1103766" y="549476"/>
                      <a:pt x="1095578" y="541288"/>
                      <a:pt x="1095578" y="531188"/>
                    </a:cubicBezTo>
                    <a:cubicBezTo>
                      <a:pt x="1095578" y="521088"/>
                      <a:pt x="1103766" y="512900"/>
                      <a:pt x="1113866" y="512900"/>
                    </a:cubicBezTo>
                    <a:close/>
                    <a:moveTo>
                      <a:pt x="1056204" y="512900"/>
                    </a:moveTo>
                    <a:cubicBezTo>
                      <a:pt x="1066304" y="512900"/>
                      <a:pt x="1074492" y="521088"/>
                      <a:pt x="1074492" y="531188"/>
                    </a:cubicBezTo>
                    <a:cubicBezTo>
                      <a:pt x="1074492" y="541288"/>
                      <a:pt x="1066304" y="549476"/>
                      <a:pt x="1056204" y="549476"/>
                    </a:cubicBezTo>
                    <a:cubicBezTo>
                      <a:pt x="1046104" y="549476"/>
                      <a:pt x="1037916" y="541288"/>
                      <a:pt x="1037916" y="531188"/>
                    </a:cubicBezTo>
                    <a:cubicBezTo>
                      <a:pt x="1037916" y="521088"/>
                      <a:pt x="1046104" y="512900"/>
                      <a:pt x="1056204" y="512900"/>
                    </a:cubicBezTo>
                    <a:close/>
                    <a:moveTo>
                      <a:pt x="998542" y="512900"/>
                    </a:moveTo>
                    <a:cubicBezTo>
                      <a:pt x="1008642" y="512900"/>
                      <a:pt x="1016830" y="521088"/>
                      <a:pt x="1016830" y="531188"/>
                    </a:cubicBezTo>
                    <a:cubicBezTo>
                      <a:pt x="1016830" y="541288"/>
                      <a:pt x="1008642" y="549476"/>
                      <a:pt x="998542" y="549476"/>
                    </a:cubicBezTo>
                    <a:cubicBezTo>
                      <a:pt x="988442" y="549476"/>
                      <a:pt x="980254" y="541288"/>
                      <a:pt x="980254" y="531188"/>
                    </a:cubicBezTo>
                    <a:cubicBezTo>
                      <a:pt x="980254" y="521088"/>
                      <a:pt x="988442" y="512900"/>
                      <a:pt x="998542" y="512900"/>
                    </a:cubicBezTo>
                    <a:close/>
                    <a:moveTo>
                      <a:pt x="940880" y="512900"/>
                    </a:moveTo>
                    <a:cubicBezTo>
                      <a:pt x="950980" y="512900"/>
                      <a:pt x="959168" y="521088"/>
                      <a:pt x="959168" y="531188"/>
                    </a:cubicBezTo>
                    <a:cubicBezTo>
                      <a:pt x="959168" y="541288"/>
                      <a:pt x="950980" y="549476"/>
                      <a:pt x="940880" y="549476"/>
                    </a:cubicBezTo>
                    <a:cubicBezTo>
                      <a:pt x="930780" y="549476"/>
                      <a:pt x="922592" y="541288"/>
                      <a:pt x="922592" y="531188"/>
                    </a:cubicBezTo>
                    <a:cubicBezTo>
                      <a:pt x="922592" y="521088"/>
                      <a:pt x="930780" y="512900"/>
                      <a:pt x="940880" y="512900"/>
                    </a:cubicBezTo>
                    <a:close/>
                    <a:moveTo>
                      <a:pt x="883218" y="512900"/>
                    </a:moveTo>
                    <a:cubicBezTo>
                      <a:pt x="893318" y="512900"/>
                      <a:pt x="901506" y="521088"/>
                      <a:pt x="901506" y="531188"/>
                    </a:cubicBezTo>
                    <a:cubicBezTo>
                      <a:pt x="901506" y="541288"/>
                      <a:pt x="893318" y="549476"/>
                      <a:pt x="883218" y="549476"/>
                    </a:cubicBezTo>
                    <a:cubicBezTo>
                      <a:pt x="873118" y="549476"/>
                      <a:pt x="864930" y="541288"/>
                      <a:pt x="864930" y="531188"/>
                    </a:cubicBezTo>
                    <a:cubicBezTo>
                      <a:pt x="864930" y="521088"/>
                      <a:pt x="873118" y="512900"/>
                      <a:pt x="883218" y="512900"/>
                    </a:cubicBezTo>
                    <a:close/>
                    <a:moveTo>
                      <a:pt x="825556" y="512900"/>
                    </a:moveTo>
                    <a:cubicBezTo>
                      <a:pt x="835656" y="512900"/>
                      <a:pt x="843844" y="521088"/>
                      <a:pt x="843844" y="531188"/>
                    </a:cubicBezTo>
                    <a:cubicBezTo>
                      <a:pt x="843844" y="541288"/>
                      <a:pt x="835656" y="549476"/>
                      <a:pt x="825556" y="549476"/>
                    </a:cubicBezTo>
                    <a:cubicBezTo>
                      <a:pt x="815456" y="549476"/>
                      <a:pt x="807268" y="541288"/>
                      <a:pt x="807268" y="531188"/>
                    </a:cubicBezTo>
                    <a:cubicBezTo>
                      <a:pt x="807268" y="521088"/>
                      <a:pt x="815456" y="512900"/>
                      <a:pt x="825556" y="512900"/>
                    </a:cubicBezTo>
                    <a:close/>
                    <a:moveTo>
                      <a:pt x="767894" y="512900"/>
                    </a:moveTo>
                    <a:cubicBezTo>
                      <a:pt x="777994" y="512900"/>
                      <a:pt x="786182" y="521088"/>
                      <a:pt x="786182" y="531188"/>
                    </a:cubicBezTo>
                    <a:cubicBezTo>
                      <a:pt x="786182" y="541288"/>
                      <a:pt x="777994" y="549476"/>
                      <a:pt x="767894" y="549476"/>
                    </a:cubicBezTo>
                    <a:cubicBezTo>
                      <a:pt x="757794" y="549476"/>
                      <a:pt x="749606" y="541288"/>
                      <a:pt x="749606" y="531188"/>
                    </a:cubicBezTo>
                    <a:cubicBezTo>
                      <a:pt x="749606" y="521088"/>
                      <a:pt x="757794" y="512900"/>
                      <a:pt x="767894" y="512900"/>
                    </a:cubicBezTo>
                    <a:close/>
                    <a:moveTo>
                      <a:pt x="710232" y="512900"/>
                    </a:moveTo>
                    <a:cubicBezTo>
                      <a:pt x="720332" y="512900"/>
                      <a:pt x="728520" y="521088"/>
                      <a:pt x="728520" y="531188"/>
                    </a:cubicBezTo>
                    <a:cubicBezTo>
                      <a:pt x="728520" y="541288"/>
                      <a:pt x="720332" y="549476"/>
                      <a:pt x="710232" y="549476"/>
                    </a:cubicBezTo>
                    <a:cubicBezTo>
                      <a:pt x="700132" y="549476"/>
                      <a:pt x="691944" y="541288"/>
                      <a:pt x="691944" y="531188"/>
                    </a:cubicBezTo>
                    <a:cubicBezTo>
                      <a:pt x="691944" y="521088"/>
                      <a:pt x="700132" y="512900"/>
                      <a:pt x="710232" y="512900"/>
                    </a:cubicBezTo>
                    <a:close/>
                    <a:moveTo>
                      <a:pt x="652570" y="512900"/>
                    </a:moveTo>
                    <a:cubicBezTo>
                      <a:pt x="662670" y="512900"/>
                      <a:pt x="670858" y="521088"/>
                      <a:pt x="670858" y="531188"/>
                    </a:cubicBezTo>
                    <a:cubicBezTo>
                      <a:pt x="670858" y="541288"/>
                      <a:pt x="662670" y="549476"/>
                      <a:pt x="652570" y="549476"/>
                    </a:cubicBezTo>
                    <a:cubicBezTo>
                      <a:pt x="642470" y="549476"/>
                      <a:pt x="634282" y="541288"/>
                      <a:pt x="634282" y="531188"/>
                    </a:cubicBezTo>
                    <a:cubicBezTo>
                      <a:pt x="634282" y="521088"/>
                      <a:pt x="642470" y="512900"/>
                      <a:pt x="652570" y="512900"/>
                    </a:cubicBezTo>
                    <a:close/>
                    <a:moveTo>
                      <a:pt x="594908" y="512900"/>
                    </a:moveTo>
                    <a:cubicBezTo>
                      <a:pt x="605008" y="512900"/>
                      <a:pt x="613196" y="521088"/>
                      <a:pt x="613196" y="531188"/>
                    </a:cubicBezTo>
                    <a:cubicBezTo>
                      <a:pt x="613196" y="541288"/>
                      <a:pt x="605008" y="549476"/>
                      <a:pt x="594908" y="549476"/>
                    </a:cubicBezTo>
                    <a:cubicBezTo>
                      <a:pt x="584808" y="549476"/>
                      <a:pt x="576620" y="541288"/>
                      <a:pt x="576620" y="531188"/>
                    </a:cubicBezTo>
                    <a:cubicBezTo>
                      <a:pt x="576620" y="521088"/>
                      <a:pt x="584808" y="512900"/>
                      <a:pt x="594908" y="512900"/>
                    </a:cubicBezTo>
                    <a:close/>
                    <a:moveTo>
                      <a:pt x="537246" y="512900"/>
                    </a:moveTo>
                    <a:cubicBezTo>
                      <a:pt x="547346" y="512900"/>
                      <a:pt x="555534" y="521088"/>
                      <a:pt x="555534" y="531188"/>
                    </a:cubicBezTo>
                    <a:cubicBezTo>
                      <a:pt x="555534" y="541288"/>
                      <a:pt x="547346" y="549476"/>
                      <a:pt x="537246" y="549476"/>
                    </a:cubicBezTo>
                    <a:cubicBezTo>
                      <a:pt x="527146" y="549476"/>
                      <a:pt x="518958" y="541288"/>
                      <a:pt x="518958" y="531188"/>
                    </a:cubicBezTo>
                    <a:cubicBezTo>
                      <a:pt x="518958" y="521088"/>
                      <a:pt x="527146" y="512900"/>
                      <a:pt x="537246" y="512900"/>
                    </a:cubicBezTo>
                    <a:close/>
                    <a:moveTo>
                      <a:pt x="479584" y="512900"/>
                    </a:moveTo>
                    <a:cubicBezTo>
                      <a:pt x="489684" y="512900"/>
                      <a:pt x="497872" y="521088"/>
                      <a:pt x="497872" y="531188"/>
                    </a:cubicBezTo>
                    <a:cubicBezTo>
                      <a:pt x="497872" y="541288"/>
                      <a:pt x="489684" y="549476"/>
                      <a:pt x="479584" y="549476"/>
                    </a:cubicBezTo>
                    <a:cubicBezTo>
                      <a:pt x="469484" y="549476"/>
                      <a:pt x="461296" y="541288"/>
                      <a:pt x="461296" y="531188"/>
                    </a:cubicBezTo>
                    <a:cubicBezTo>
                      <a:pt x="461296" y="521088"/>
                      <a:pt x="469484" y="512900"/>
                      <a:pt x="479584" y="512900"/>
                    </a:cubicBezTo>
                    <a:close/>
                    <a:moveTo>
                      <a:pt x="421922" y="512900"/>
                    </a:moveTo>
                    <a:cubicBezTo>
                      <a:pt x="432022" y="512900"/>
                      <a:pt x="440210" y="521088"/>
                      <a:pt x="440210" y="531188"/>
                    </a:cubicBezTo>
                    <a:cubicBezTo>
                      <a:pt x="440210" y="541288"/>
                      <a:pt x="432022" y="549476"/>
                      <a:pt x="421922" y="549476"/>
                    </a:cubicBezTo>
                    <a:cubicBezTo>
                      <a:pt x="411822" y="549476"/>
                      <a:pt x="403634" y="541288"/>
                      <a:pt x="403634" y="531188"/>
                    </a:cubicBezTo>
                    <a:cubicBezTo>
                      <a:pt x="403634" y="521088"/>
                      <a:pt x="411822" y="512900"/>
                      <a:pt x="421922" y="512900"/>
                    </a:cubicBezTo>
                    <a:close/>
                    <a:moveTo>
                      <a:pt x="364260" y="512900"/>
                    </a:moveTo>
                    <a:cubicBezTo>
                      <a:pt x="374360" y="512900"/>
                      <a:pt x="382548" y="521088"/>
                      <a:pt x="382548" y="531188"/>
                    </a:cubicBezTo>
                    <a:cubicBezTo>
                      <a:pt x="382548" y="541288"/>
                      <a:pt x="374360" y="549476"/>
                      <a:pt x="364260" y="549476"/>
                    </a:cubicBezTo>
                    <a:cubicBezTo>
                      <a:pt x="354160" y="549476"/>
                      <a:pt x="345972" y="541288"/>
                      <a:pt x="345972" y="531188"/>
                    </a:cubicBezTo>
                    <a:cubicBezTo>
                      <a:pt x="345972" y="521088"/>
                      <a:pt x="354160" y="512900"/>
                      <a:pt x="364260" y="512900"/>
                    </a:cubicBezTo>
                    <a:close/>
                    <a:moveTo>
                      <a:pt x="306598" y="512900"/>
                    </a:moveTo>
                    <a:cubicBezTo>
                      <a:pt x="316698" y="512900"/>
                      <a:pt x="324886" y="521088"/>
                      <a:pt x="324886" y="531188"/>
                    </a:cubicBezTo>
                    <a:cubicBezTo>
                      <a:pt x="324886" y="541288"/>
                      <a:pt x="316698" y="549476"/>
                      <a:pt x="306598" y="549476"/>
                    </a:cubicBezTo>
                    <a:cubicBezTo>
                      <a:pt x="296498" y="549476"/>
                      <a:pt x="288310" y="541288"/>
                      <a:pt x="288310" y="531188"/>
                    </a:cubicBezTo>
                    <a:cubicBezTo>
                      <a:pt x="288310" y="521088"/>
                      <a:pt x="296498" y="512900"/>
                      <a:pt x="306598" y="512900"/>
                    </a:cubicBezTo>
                    <a:close/>
                    <a:moveTo>
                      <a:pt x="248936" y="512900"/>
                    </a:moveTo>
                    <a:cubicBezTo>
                      <a:pt x="259036" y="512900"/>
                      <a:pt x="267224" y="521088"/>
                      <a:pt x="267224" y="531188"/>
                    </a:cubicBezTo>
                    <a:cubicBezTo>
                      <a:pt x="267224" y="541288"/>
                      <a:pt x="259036" y="549476"/>
                      <a:pt x="248936" y="549476"/>
                    </a:cubicBezTo>
                    <a:cubicBezTo>
                      <a:pt x="238836" y="549476"/>
                      <a:pt x="230648" y="541288"/>
                      <a:pt x="230648" y="531188"/>
                    </a:cubicBezTo>
                    <a:cubicBezTo>
                      <a:pt x="230648" y="521088"/>
                      <a:pt x="238836" y="512900"/>
                      <a:pt x="248936" y="512900"/>
                    </a:cubicBezTo>
                    <a:close/>
                    <a:moveTo>
                      <a:pt x="191274" y="512900"/>
                    </a:moveTo>
                    <a:cubicBezTo>
                      <a:pt x="201374" y="512900"/>
                      <a:pt x="209562" y="521088"/>
                      <a:pt x="209562" y="531188"/>
                    </a:cubicBezTo>
                    <a:cubicBezTo>
                      <a:pt x="209562" y="541288"/>
                      <a:pt x="201374" y="549476"/>
                      <a:pt x="191274" y="549476"/>
                    </a:cubicBezTo>
                    <a:cubicBezTo>
                      <a:pt x="181174" y="549476"/>
                      <a:pt x="172986" y="541288"/>
                      <a:pt x="172986" y="531188"/>
                    </a:cubicBezTo>
                    <a:cubicBezTo>
                      <a:pt x="172986" y="521088"/>
                      <a:pt x="181174" y="512900"/>
                      <a:pt x="191274" y="512900"/>
                    </a:cubicBezTo>
                    <a:close/>
                    <a:moveTo>
                      <a:pt x="133612" y="512900"/>
                    </a:moveTo>
                    <a:cubicBezTo>
                      <a:pt x="143712" y="512900"/>
                      <a:pt x="151900" y="521088"/>
                      <a:pt x="151900" y="531188"/>
                    </a:cubicBezTo>
                    <a:cubicBezTo>
                      <a:pt x="151900" y="541288"/>
                      <a:pt x="143712" y="549476"/>
                      <a:pt x="133612" y="549476"/>
                    </a:cubicBezTo>
                    <a:cubicBezTo>
                      <a:pt x="123512" y="549476"/>
                      <a:pt x="115324" y="541288"/>
                      <a:pt x="115324" y="531188"/>
                    </a:cubicBezTo>
                    <a:cubicBezTo>
                      <a:pt x="115324" y="521088"/>
                      <a:pt x="123512" y="512900"/>
                      <a:pt x="133612" y="512900"/>
                    </a:cubicBezTo>
                    <a:close/>
                    <a:moveTo>
                      <a:pt x="75950" y="512900"/>
                    </a:moveTo>
                    <a:cubicBezTo>
                      <a:pt x="86050" y="512900"/>
                      <a:pt x="94238" y="521088"/>
                      <a:pt x="94238" y="531188"/>
                    </a:cubicBezTo>
                    <a:cubicBezTo>
                      <a:pt x="94238" y="541288"/>
                      <a:pt x="86050" y="549476"/>
                      <a:pt x="75950" y="549476"/>
                    </a:cubicBezTo>
                    <a:cubicBezTo>
                      <a:pt x="65850" y="549476"/>
                      <a:pt x="57662" y="541288"/>
                      <a:pt x="57662" y="531188"/>
                    </a:cubicBezTo>
                    <a:cubicBezTo>
                      <a:pt x="57662" y="521088"/>
                      <a:pt x="65850" y="512900"/>
                      <a:pt x="75950" y="512900"/>
                    </a:cubicBezTo>
                    <a:close/>
                    <a:moveTo>
                      <a:pt x="18288" y="512900"/>
                    </a:moveTo>
                    <a:cubicBezTo>
                      <a:pt x="28388" y="512900"/>
                      <a:pt x="36576" y="521088"/>
                      <a:pt x="36576" y="531188"/>
                    </a:cubicBezTo>
                    <a:cubicBezTo>
                      <a:pt x="36576" y="541288"/>
                      <a:pt x="28388" y="549476"/>
                      <a:pt x="18288" y="549476"/>
                    </a:cubicBezTo>
                    <a:cubicBezTo>
                      <a:pt x="8188" y="549476"/>
                      <a:pt x="0" y="541288"/>
                      <a:pt x="0" y="531188"/>
                    </a:cubicBezTo>
                    <a:cubicBezTo>
                      <a:pt x="0" y="521088"/>
                      <a:pt x="8188" y="512900"/>
                      <a:pt x="18288" y="512900"/>
                    </a:cubicBezTo>
                    <a:close/>
                    <a:moveTo>
                      <a:pt x="1459848" y="461610"/>
                    </a:moveTo>
                    <a:cubicBezTo>
                      <a:pt x="1469948" y="461610"/>
                      <a:pt x="1478136" y="469798"/>
                      <a:pt x="1478136" y="479898"/>
                    </a:cubicBezTo>
                    <a:cubicBezTo>
                      <a:pt x="1478136" y="489998"/>
                      <a:pt x="1469948" y="498186"/>
                      <a:pt x="1459848" y="498186"/>
                    </a:cubicBezTo>
                    <a:cubicBezTo>
                      <a:pt x="1449748" y="498186"/>
                      <a:pt x="1441560" y="489998"/>
                      <a:pt x="1441560" y="479898"/>
                    </a:cubicBezTo>
                    <a:cubicBezTo>
                      <a:pt x="1441560" y="469798"/>
                      <a:pt x="1449748" y="461610"/>
                      <a:pt x="1459848" y="461610"/>
                    </a:cubicBezTo>
                    <a:close/>
                    <a:moveTo>
                      <a:pt x="1402176" y="461610"/>
                    </a:moveTo>
                    <a:cubicBezTo>
                      <a:pt x="1412276" y="461610"/>
                      <a:pt x="1420464" y="469798"/>
                      <a:pt x="1420464" y="479898"/>
                    </a:cubicBezTo>
                    <a:cubicBezTo>
                      <a:pt x="1420464" y="489998"/>
                      <a:pt x="1412276" y="498186"/>
                      <a:pt x="1402176" y="498186"/>
                    </a:cubicBezTo>
                    <a:cubicBezTo>
                      <a:pt x="1392076" y="498186"/>
                      <a:pt x="1383888" y="489998"/>
                      <a:pt x="1383888" y="479898"/>
                    </a:cubicBezTo>
                    <a:cubicBezTo>
                      <a:pt x="1383888" y="469798"/>
                      <a:pt x="1392076" y="461610"/>
                      <a:pt x="1402176" y="461610"/>
                    </a:cubicBezTo>
                    <a:close/>
                    <a:moveTo>
                      <a:pt x="1344514" y="461610"/>
                    </a:moveTo>
                    <a:cubicBezTo>
                      <a:pt x="1354614" y="461610"/>
                      <a:pt x="1362802" y="469798"/>
                      <a:pt x="1362802" y="479898"/>
                    </a:cubicBezTo>
                    <a:cubicBezTo>
                      <a:pt x="1362802" y="489998"/>
                      <a:pt x="1354614" y="498186"/>
                      <a:pt x="1344514" y="498186"/>
                    </a:cubicBezTo>
                    <a:cubicBezTo>
                      <a:pt x="1334414" y="498186"/>
                      <a:pt x="1326226" y="489998"/>
                      <a:pt x="1326226" y="479898"/>
                    </a:cubicBezTo>
                    <a:cubicBezTo>
                      <a:pt x="1326226" y="469798"/>
                      <a:pt x="1334414" y="461610"/>
                      <a:pt x="1344514" y="461610"/>
                    </a:cubicBezTo>
                    <a:close/>
                    <a:moveTo>
                      <a:pt x="1286852" y="461610"/>
                    </a:moveTo>
                    <a:cubicBezTo>
                      <a:pt x="1296952" y="461610"/>
                      <a:pt x="1305140" y="469798"/>
                      <a:pt x="1305140" y="479898"/>
                    </a:cubicBezTo>
                    <a:cubicBezTo>
                      <a:pt x="1305140" y="489998"/>
                      <a:pt x="1296952" y="498186"/>
                      <a:pt x="1286852" y="498186"/>
                    </a:cubicBezTo>
                    <a:cubicBezTo>
                      <a:pt x="1276752" y="498186"/>
                      <a:pt x="1268564" y="489998"/>
                      <a:pt x="1268564" y="479898"/>
                    </a:cubicBezTo>
                    <a:cubicBezTo>
                      <a:pt x="1268564" y="469798"/>
                      <a:pt x="1276752" y="461610"/>
                      <a:pt x="1286852" y="461610"/>
                    </a:cubicBezTo>
                    <a:close/>
                    <a:moveTo>
                      <a:pt x="1229190" y="461610"/>
                    </a:moveTo>
                    <a:cubicBezTo>
                      <a:pt x="1239290" y="461610"/>
                      <a:pt x="1247478" y="469798"/>
                      <a:pt x="1247478" y="479898"/>
                    </a:cubicBezTo>
                    <a:cubicBezTo>
                      <a:pt x="1247478" y="489998"/>
                      <a:pt x="1239290" y="498186"/>
                      <a:pt x="1229190" y="498186"/>
                    </a:cubicBezTo>
                    <a:cubicBezTo>
                      <a:pt x="1219090" y="498186"/>
                      <a:pt x="1210902" y="489998"/>
                      <a:pt x="1210902" y="479898"/>
                    </a:cubicBezTo>
                    <a:cubicBezTo>
                      <a:pt x="1210902" y="469798"/>
                      <a:pt x="1219090" y="461610"/>
                      <a:pt x="1229190" y="461610"/>
                    </a:cubicBezTo>
                    <a:close/>
                    <a:moveTo>
                      <a:pt x="1171528" y="461610"/>
                    </a:moveTo>
                    <a:cubicBezTo>
                      <a:pt x="1181628" y="461610"/>
                      <a:pt x="1189816" y="469798"/>
                      <a:pt x="1189816" y="479898"/>
                    </a:cubicBezTo>
                    <a:cubicBezTo>
                      <a:pt x="1189816" y="489998"/>
                      <a:pt x="1181628" y="498186"/>
                      <a:pt x="1171528" y="498186"/>
                    </a:cubicBezTo>
                    <a:cubicBezTo>
                      <a:pt x="1161428" y="498186"/>
                      <a:pt x="1153240" y="489998"/>
                      <a:pt x="1153240" y="479898"/>
                    </a:cubicBezTo>
                    <a:cubicBezTo>
                      <a:pt x="1153240" y="469798"/>
                      <a:pt x="1161428" y="461610"/>
                      <a:pt x="1171528" y="461610"/>
                    </a:cubicBezTo>
                    <a:close/>
                    <a:moveTo>
                      <a:pt x="1113866" y="461610"/>
                    </a:moveTo>
                    <a:cubicBezTo>
                      <a:pt x="1123966" y="461610"/>
                      <a:pt x="1132154" y="469798"/>
                      <a:pt x="1132154" y="479898"/>
                    </a:cubicBezTo>
                    <a:cubicBezTo>
                      <a:pt x="1132154" y="489998"/>
                      <a:pt x="1123966" y="498186"/>
                      <a:pt x="1113866" y="498186"/>
                    </a:cubicBezTo>
                    <a:cubicBezTo>
                      <a:pt x="1103766" y="498186"/>
                      <a:pt x="1095578" y="489998"/>
                      <a:pt x="1095578" y="479898"/>
                    </a:cubicBezTo>
                    <a:cubicBezTo>
                      <a:pt x="1095578" y="469798"/>
                      <a:pt x="1103766" y="461610"/>
                      <a:pt x="1113866" y="461610"/>
                    </a:cubicBezTo>
                    <a:close/>
                    <a:moveTo>
                      <a:pt x="1056204" y="461610"/>
                    </a:moveTo>
                    <a:cubicBezTo>
                      <a:pt x="1066304" y="461610"/>
                      <a:pt x="1074492" y="469798"/>
                      <a:pt x="1074492" y="479898"/>
                    </a:cubicBezTo>
                    <a:cubicBezTo>
                      <a:pt x="1074492" y="489998"/>
                      <a:pt x="1066304" y="498186"/>
                      <a:pt x="1056204" y="498186"/>
                    </a:cubicBezTo>
                    <a:cubicBezTo>
                      <a:pt x="1046104" y="498186"/>
                      <a:pt x="1037916" y="489998"/>
                      <a:pt x="1037916" y="479898"/>
                    </a:cubicBezTo>
                    <a:cubicBezTo>
                      <a:pt x="1037916" y="469798"/>
                      <a:pt x="1046104" y="461610"/>
                      <a:pt x="1056204" y="461610"/>
                    </a:cubicBezTo>
                    <a:close/>
                    <a:moveTo>
                      <a:pt x="998542" y="461610"/>
                    </a:moveTo>
                    <a:cubicBezTo>
                      <a:pt x="1008642" y="461610"/>
                      <a:pt x="1016830" y="469798"/>
                      <a:pt x="1016830" y="479898"/>
                    </a:cubicBezTo>
                    <a:cubicBezTo>
                      <a:pt x="1016830" y="489998"/>
                      <a:pt x="1008642" y="498186"/>
                      <a:pt x="998542" y="498186"/>
                    </a:cubicBezTo>
                    <a:cubicBezTo>
                      <a:pt x="988442" y="498186"/>
                      <a:pt x="980254" y="489998"/>
                      <a:pt x="980254" y="479898"/>
                    </a:cubicBezTo>
                    <a:cubicBezTo>
                      <a:pt x="980254" y="469798"/>
                      <a:pt x="988442" y="461610"/>
                      <a:pt x="998542" y="461610"/>
                    </a:cubicBezTo>
                    <a:close/>
                    <a:moveTo>
                      <a:pt x="940880" y="461610"/>
                    </a:moveTo>
                    <a:cubicBezTo>
                      <a:pt x="950980" y="461610"/>
                      <a:pt x="959168" y="469798"/>
                      <a:pt x="959168" y="479898"/>
                    </a:cubicBezTo>
                    <a:cubicBezTo>
                      <a:pt x="959168" y="489998"/>
                      <a:pt x="950980" y="498186"/>
                      <a:pt x="940880" y="498186"/>
                    </a:cubicBezTo>
                    <a:cubicBezTo>
                      <a:pt x="930780" y="498186"/>
                      <a:pt x="922592" y="489998"/>
                      <a:pt x="922592" y="479898"/>
                    </a:cubicBezTo>
                    <a:cubicBezTo>
                      <a:pt x="922592" y="469798"/>
                      <a:pt x="930780" y="461610"/>
                      <a:pt x="940880" y="461610"/>
                    </a:cubicBezTo>
                    <a:close/>
                    <a:moveTo>
                      <a:pt x="883218" y="461610"/>
                    </a:moveTo>
                    <a:cubicBezTo>
                      <a:pt x="893318" y="461610"/>
                      <a:pt x="901506" y="469798"/>
                      <a:pt x="901506" y="479898"/>
                    </a:cubicBezTo>
                    <a:cubicBezTo>
                      <a:pt x="901506" y="489998"/>
                      <a:pt x="893318" y="498186"/>
                      <a:pt x="883218" y="498186"/>
                    </a:cubicBezTo>
                    <a:cubicBezTo>
                      <a:pt x="873118" y="498186"/>
                      <a:pt x="864930" y="489998"/>
                      <a:pt x="864930" y="479898"/>
                    </a:cubicBezTo>
                    <a:cubicBezTo>
                      <a:pt x="864930" y="469798"/>
                      <a:pt x="873118" y="461610"/>
                      <a:pt x="883218" y="461610"/>
                    </a:cubicBezTo>
                    <a:close/>
                    <a:moveTo>
                      <a:pt x="825556" y="461610"/>
                    </a:moveTo>
                    <a:cubicBezTo>
                      <a:pt x="835656" y="461610"/>
                      <a:pt x="843844" y="469798"/>
                      <a:pt x="843844" y="479898"/>
                    </a:cubicBezTo>
                    <a:cubicBezTo>
                      <a:pt x="843844" y="489998"/>
                      <a:pt x="835656" y="498186"/>
                      <a:pt x="825556" y="498186"/>
                    </a:cubicBezTo>
                    <a:cubicBezTo>
                      <a:pt x="815456" y="498186"/>
                      <a:pt x="807268" y="489998"/>
                      <a:pt x="807268" y="479898"/>
                    </a:cubicBezTo>
                    <a:cubicBezTo>
                      <a:pt x="807268" y="469798"/>
                      <a:pt x="815456" y="461610"/>
                      <a:pt x="825556" y="461610"/>
                    </a:cubicBezTo>
                    <a:close/>
                    <a:moveTo>
                      <a:pt x="767894" y="461610"/>
                    </a:moveTo>
                    <a:cubicBezTo>
                      <a:pt x="777994" y="461610"/>
                      <a:pt x="786182" y="469798"/>
                      <a:pt x="786182" y="479898"/>
                    </a:cubicBezTo>
                    <a:cubicBezTo>
                      <a:pt x="786182" y="489998"/>
                      <a:pt x="777994" y="498186"/>
                      <a:pt x="767894" y="498186"/>
                    </a:cubicBezTo>
                    <a:cubicBezTo>
                      <a:pt x="757794" y="498186"/>
                      <a:pt x="749606" y="489998"/>
                      <a:pt x="749606" y="479898"/>
                    </a:cubicBezTo>
                    <a:cubicBezTo>
                      <a:pt x="749606" y="469798"/>
                      <a:pt x="757794" y="461610"/>
                      <a:pt x="767894" y="461610"/>
                    </a:cubicBezTo>
                    <a:close/>
                    <a:moveTo>
                      <a:pt x="710232" y="461610"/>
                    </a:moveTo>
                    <a:cubicBezTo>
                      <a:pt x="720332" y="461610"/>
                      <a:pt x="728520" y="469798"/>
                      <a:pt x="728520" y="479898"/>
                    </a:cubicBezTo>
                    <a:cubicBezTo>
                      <a:pt x="728520" y="489998"/>
                      <a:pt x="720332" y="498186"/>
                      <a:pt x="710232" y="498186"/>
                    </a:cubicBezTo>
                    <a:cubicBezTo>
                      <a:pt x="700132" y="498186"/>
                      <a:pt x="691944" y="489998"/>
                      <a:pt x="691944" y="479898"/>
                    </a:cubicBezTo>
                    <a:cubicBezTo>
                      <a:pt x="691944" y="469798"/>
                      <a:pt x="700132" y="461610"/>
                      <a:pt x="710232" y="461610"/>
                    </a:cubicBezTo>
                    <a:close/>
                    <a:moveTo>
                      <a:pt x="652570" y="461610"/>
                    </a:moveTo>
                    <a:cubicBezTo>
                      <a:pt x="662670" y="461610"/>
                      <a:pt x="670858" y="469798"/>
                      <a:pt x="670858" y="479898"/>
                    </a:cubicBezTo>
                    <a:cubicBezTo>
                      <a:pt x="670858" y="489998"/>
                      <a:pt x="662670" y="498186"/>
                      <a:pt x="652570" y="498186"/>
                    </a:cubicBezTo>
                    <a:cubicBezTo>
                      <a:pt x="642470" y="498186"/>
                      <a:pt x="634282" y="489998"/>
                      <a:pt x="634282" y="479898"/>
                    </a:cubicBezTo>
                    <a:cubicBezTo>
                      <a:pt x="634282" y="469798"/>
                      <a:pt x="642470" y="461610"/>
                      <a:pt x="652570" y="461610"/>
                    </a:cubicBezTo>
                    <a:close/>
                    <a:moveTo>
                      <a:pt x="594908" y="461610"/>
                    </a:moveTo>
                    <a:cubicBezTo>
                      <a:pt x="605008" y="461610"/>
                      <a:pt x="613196" y="469798"/>
                      <a:pt x="613196" y="479898"/>
                    </a:cubicBezTo>
                    <a:cubicBezTo>
                      <a:pt x="613196" y="489998"/>
                      <a:pt x="605008" y="498186"/>
                      <a:pt x="594908" y="498186"/>
                    </a:cubicBezTo>
                    <a:cubicBezTo>
                      <a:pt x="584808" y="498186"/>
                      <a:pt x="576620" y="489998"/>
                      <a:pt x="576620" y="479898"/>
                    </a:cubicBezTo>
                    <a:cubicBezTo>
                      <a:pt x="576620" y="469798"/>
                      <a:pt x="584808" y="461610"/>
                      <a:pt x="594908" y="461610"/>
                    </a:cubicBezTo>
                    <a:close/>
                    <a:moveTo>
                      <a:pt x="537246" y="461610"/>
                    </a:moveTo>
                    <a:cubicBezTo>
                      <a:pt x="547346" y="461610"/>
                      <a:pt x="555534" y="469798"/>
                      <a:pt x="555534" y="479898"/>
                    </a:cubicBezTo>
                    <a:cubicBezTo>
                      <a:pt x="555534" y="489998"/>
                      <a:pt x="547346" y="498186"/>
                      <a:pt x="537246" y="498186"/>
                    </a:cubicBezTo>
                    <a:cubicBezTo>
                      <a:pt x="527146" y="498186"/>
                      <a:pt x="518958" y="489998"/>
                      <a:pt x="518958" y="479898"/>
                    </a:cubicBezTo>
                    <a:cubicBezTo>
                      <a:pt x="518958" y="469798"/>
                      <a:pt x="527146" y="461610"/>
                      <a:pt x="537246" y="461610"/>
                    </a:cubicBezTo>
                    <a:close/>
                    <a:moveTo>
                      <a:pt x="479584" y="461610"/>
                    </a:moveTo>
                    <a:cubicBezTo>
                      <a:pt x="489684" y="461610"/>
                      <a:pt x="497872" y="469798"/>
                      <a:pt x="497872" y="479898"/>
                    </a:cubicBezTo>
                    <a:cubicBezTo>
                      <a:pt x="497872" y="489998"/>
                      <a:pt x="489684" y="498186"/>
                      <a:pt x="479584" y="498186"/>
                    </a:cubicBezTo>
                    <a:cubicBezTo>
                      <a:pt x="469484" y="498186"/>
                      <a:pt x="461296" y="489998"/>
                      <a:pt x="461296" y="479898"/>
                    </a:cubicBezTo>
                    <a:cubicBezTo>
                      <a:pt x="461296" y="469798"/>
                      <a:pt x="469484" y="461610"/>
                      <a:pt x="479584" y="461610"/>
                    </a:cubicBezTo>
                    <a:close/>
                    <a:moveTo>
                      <a:pt x="421922" y="461610"/>
                    </a:moveTo>
                    <a:cubicBezTo>
                      <a:pt x="432022" y="461610"/>
                      <a:pt x="440210" y="469798"/>
                      <a:pt x="440210" y="479898"/>
                    </a:cubicBezTo>
                    <a:cubicBezTo>
                      <a:pt x="440210" y="489998"/>
                      <a:pt x="432022" y="498186"/>
                      <a:pt x="421922" y="498186"/>
                    </a:cubicBezTo>
                    <a:cubicBezTo>
                      <a:pt x="411822" y="498186"/>
                      <a:pt x="403634" y="489998"/>
                      <a:pt x="403634" y="479898"/>
                    </a:cubicBezTo>
                    <a:cubicBezTo>
                      <a:pt x="403634" y="469798"/>
                      <a:pt x="411822" y="461610"/>
                      <a:pt x="421922" y="461610"/>
                    </a:cubicBezTo>
                    <a:close/>
                    <a:moveTo>
                      <a:pt x="364260" y="461610"/>
                    </a:moveTo>
                    <a:cubicBezTo>
                      <a:pt x="374360" y="461610"/>
                      <a:pt x="382548" y="469798"/>
                      <a:pt x="382548" y="479898"/>
                    </a:cubicBezTo>
                    <a:cubicBezTo>
                      <a:pt x="382548" y="489998"/>
                      <a:pt x="374360" y="498186"/>
                      <a:pt x="364260" y="498186"/>
                    </a:cubicBezTo>
                    <a:cubicBezTo>
                      <a:pt x="354160" y="498186"/>
                      <a:pt x="345972" y="489998"/>
                      <a:pt x="345972" y="479898"/>
                    </a:cubicBezTo>
                    <a:cubicBezTo>
                      <a:pt x="345972" y="469798"/>
                      <a:pt x="354160" y="461610"/>
                      <a:pt x="364260" y="461610"/>
                    </a:cubicBezTo>
                    <a:close/>
                    <a:moveTo>
                      <a:pt x="306598" y="461610"/>
                    </a:moveTo>
                    <a:cubicBezTo>
                      <a:pt x="316698" y="461610"/>
                      <a:pt x="324886" y="469798"/>
                      <a:pt x="324886" y="479898"/>
                    </a:cubicBezTo>
                    <a:cubicBezTo>
                      <a:pt x="324886" y="489998"/>
                      <a:pt x="316698" y="498186"/>
                      <a:pt x="306598" y="498186"/>
                    </a:cubicBezTo>
                    <a:cubicBezTo>
                      <a:pt x="296498" y="498186"/>
                      <a:pt x="288310" y="489998"/>
                      <a:pt x="288310" y="479898"/>
                    </a:cubicBezTo>
                    <a:cubicBezTo>
                      <a:pt x="288310" y="469798"/>
                      <a:pt x="296498" y="461610"/>
                      <a:pt x="306598" y="461610"/>
                    </a:cubicBezTo>
                    <a:close/>
                    <a:moveTo>
                      <a:pt x="248936" y="461610"/>
                    </a:moveTo>
                    <a:cubicBezTo>
                      <a:pt x="259036" y="461610"/>
                      <a:pt x="267224" y="469798"/>
                      <a:pt x="267224" y="479898"/>
                    </a:cubicBezTo>
                    <a:cubicBezTo>
                      <a:pt x="267224" y="489998"/>
                      <a:pt x="259036" y="498186"/>
                      <a:pt x="248936" y="498186"/>
                    </a:cubicBezTo>
                    <a:cubicBezTo>
                      <a:pt x="238836" y="498186"/>
                      <a:pt x="230648" y="489998"/>
                      <a:pt x="230648" y="479898"/>
                    </a:cubicBezTo>
                    <a:cubicBezTo>
                      <a:pt x="230648" y="469798"/>
                      <a:pt x="238836" y="461610"/>
                      <a:pt x="248936" y="461610"/>
                    </a:cubicBezTo>
                    <a:close/>
                    <a:moveTo>
                      <a:pt x="191274" y="461610"/>
                    </a:moveTo>
                    <a:cubicBezTo>
                      <a:pt x="201374" y="461610"/>
                      <a:pt x="209562" y="469798"/>
                      <a:pt x="209562" y="479898"/>
                    </a:cubicBezTo>
                    <a:cubicBezTo>
                      <a:pt x="209562" y="489998"/>
                      <a:pt x="201374" y="498186"/>
                      <a:pt x="191274" y="498186"/>
                    </a:cubicBezTo>
                    <a:cubicBezTo>
                      <a:pt x="181174" y="498186"/>
                      <a:pt x="172986" y="489998"/>
                      <a:pt x="172986" y="479898"/>
                    </a:cubicBezTo>
                    <a:cubicBezTo>
                      <a:pt x="172986" y="469798"/>
                      <a:pt x="181174" y="461610"/>
                      <a:pt x="191274" y="461610"/>
                    </a:cubicBezTo>
                    <a:close/>
                    <a:moveTo>
                      <a:pt x="133612" y="461610"/>
                    </a:moveTo>
                    <a:cubicBezTo>
                      <a:pt x="143712" y="461610"/>
                      <a:pt x="151900" y="469798"/>
                      <a:pt x="151900" y="479898"/>
                    </a:cubicBezTo>
                    <a:cubicBezTo>
                      <a:pt x="151900" y="489998"/>
                      <a:pt x="143712" y="498186"/>
                      <a:pt x="133612" y="498186"/>
                    </a:cubicBezTo>
                    <a:cubicBezTo>
                      <a:pt x="123512" y="498186"/>
                      <a:pt x="115324" y="489998"/>
                      <a:pt x="115324" y="479898"/>
                    </a:cubicBezTo>
                    <a:cubicBezTo>
                      <a:pt x="115324" y="469798"/>
                      <a:pt x="123512" y="461610"/>
                      <a:pt x="133612" y="461610"/>
                    </a:cubicBezTo>
                    <a:close/>
                    <a:moveTo>
                      <a:pt x="75950" y="461610"/>
                    </a:moveTo>
                    <a:cubicBezTo>
                      <a:pt x="86050" y="461610"/>
                      <a:pt x="94238" y="469798"/>
                      <a:pt x="94238" y="479898"/>
                    </a:cubicBezTo>
                    <a:cubicBezTo>
                      <a:pt x="94238" y="489998"/>
                      <a:pt x="86050" y="498186"/>
                      <a:pt x="75950" y="498186"/>
                    </a:cubicBezTo>
                    <a:cubicBezTo>
                      <a:pt x="65850" y="498186"/>
                      <a:pt x="57662" y="489998"/>
                      <a:pt x="57662" y="479898"/>
                    </a:cubicBezTo>
                    <a:cubicBezTo>
                      <a:pt x="57662" y="469798"/>
                      <a:pt x="65850" y="461610"/>
                      <a:pt x="75950" y="461610"/>
                    </a:cubicBezTo>
                    <a:close/>
                    <a:moveTo>
                      <a:pt x="18288" y="461610"/>
                    </a:moveTo>
                    <a:cubicBezTo>
                      <a:pt x="28388" y="461610"/>
                      <a:pt x="36576" y="469798"/>
                      <a:pt x="36576" y="479898"/>
                    </a:cubicBezTo>
                    <a:cubicBezTo>
                      <a:pt x="36576" y="489998"/>
                      <a:pt x="28388" y="498186"/>
                      <a:pt x="18288" y="498186"/>
                    </a:cubicBezTo>
                    <a:cubicBezTo>
                      <a:pt x="8188" y="498186"/>
                      <a:pt x="0" y="489998"/>
                      <a:pt x="0" y="479898"/>
                    </a:cubicBezTo>
                    <a:cubicBezTo>
                      <a:pt x="0" y="469798"/>
                      <a:pt x="8188" y="461610"/>
                      <a:pt x="18288" y="461610"/>
                    </a:cubicBezTo>
                    <a:close/>
                    <a:moveTo>
                      <a:pt x="1459848" y="410320"/>
                    </a:moveTo>
                    <a:cubicBezTo>
                      <a:pt x="1469948" y="410320"/>
                      <a:pt x="1478136" y="418508"/>
                      <a:pt x="1478136" y="428608"/>
                    </a:cubicBezTo>
                    <a:cubicBezTo>
                      <a:pt x="1478136" y="438708"/>
                      <a:pt x="1469948" y="446896"/>
                      <a:pt x="1459848" y="446896"/>
                    </a:cubicBezTo>
                    <a:cubicBezTo>
                      <a:pt x="1449748" y="446896"/>
                      <a:pt x="1441560" y="438708"/>
                      <a:pt x="1441560" y="428608"/>
                    </a:cubicBezTo>
                    <a:cubicBezTo>
                      <a:pt x="1441560" y="418508"/>
                      <a:pt x="1449748" y="410320"/>
                      <a:pt x="1459848" y="410320"/>
                    </a:cubicBezTo>
                    <a:close/>
                    <a:moveTo>
                      <a:pt x="1402176" y="410320"/>
                    </a:moveTo>
                    <a:cubicBezTo>
                      <a:pt x="1412276" y="410320"/>
                      <a:pt x="1420464" y="418508"/>
                      <a:pt x="1420464" y="428608"/>
                    </a:cubicBezTo>
                    <a:cubicBezTo>
                      <a:pt x="1420464" y="438708"/>
                      <a:pt x="1412276" y="446896"/>
                      <a:pt x="1402176" y="446896"/>
                    </a:cubicBezTo>
                    <a:cubicBezTo>
                      <a:pt x="1392076" y="446896"/>
                      <a:pt x="1383888" y="438708"/>
                      <a:pt x="1383888" y="428608"/>
                    </a:cubicBezTo>
                    <a:cubicBezTo>
                      <a:pt x="1383888" y="418508"/>
                      <a:pt x="1392076" y="410320"/>
                      <a:pt x="1402176" y="410320"/>
                    </a:cubicBezTo>
                    <a:close/>
                    <a:moveTo>
                      <a:pt x="1344514" y="410320"/>
                    </a:moveTo>
                    <a:cubicBezTo>
                      <a:pt x="1354614" y="410320"/>
                      <a:pt x="1362802" y="418508"/>
                      <a:pt x="1362802" y="428608"/>
                    </a:cubicBezTo>
                    <a:cubicBezTo>
                      <a:pt x="1362802" y="438708"/>
                      <a:pt x="1354614" y="446896"/>
                      <a:pt x="1344514" y="446896"/>
                    </a:cubicBezTo>
                    <a:cubicBezTo>
                      <a:pt x="1334414" y="446896"/>
                      <a:pt x="1326226" y="438708"/>
                      <a:pt x="1326226" y="428608"/>
                    </a:cubicBezTo>
                    <a:cubicBezTo>
                      <a:pt x="1326226" y="418508"/>
                      <a:pt x="1334414" y="410320"/>
                      <a:pt x="1344514" y="410320"/>
                    </a:cubicBezTo>
                    <a:close/>
                    <a:moveTo>
                      <a:pt x="1286852" y="410320"/>
                    </a:moveTo>
                    <a:cubicBezTo>
                      <a:pt x="1296952" y="410320"/>
                      <a:pt x="1305140" y="418508"/>
                      <a:pt x="1305140" y="428608"/>
                    </a:cubicBezTo>
                    <a:cubicBezTo>
                      <a:pt x="1305140" y="438708"/>
                      <a:pt x="1296952" y="446896"/>
                      <a:pt x="1286852" y="446896"/>
                    </a:cubicBezTo>
                    <a:cubicBezTo>
                      <a:pt x="1276752" y="446896"/>
                      <a:pt x="1268564" y="438708"/>
                      <a:pt x="1268564" y="428608"/>
                    </a:cubicBezTo>
                    <a:cubicBezTo>
                      <a:pt x="1268564" y="418508"/>
                      <a:pt x="1276752" y="410320"/>
                      <a:pt x="1286852" y="410320"/>
                    </a:cubicBezTo>
                    <a:close/>
                    <a:moveTo>
                      <a:pt x="1229190" y="410320"/>
                    </a:moveTo>
                    <a:cubicBezTo>
                      <a:pt x="1239290" y="410320"/>
                      <a:pt x="1247478" y="418508"/>
                      <a:pt x="1247478" y="428608"/>
                    </a:cubicBezTo>
                    <a:cubicBezTo>
                      <a:pt x="1247478" y="438708"/>
                      <a:pt x="1239290" y="446896"/>
                      <a:pt x="1229190" y="446896"/>
                    </a:cubicBezTo>
                    <a:cubicBezTo>
                      <a:pt x="1219090" y="446896"/>
                      <a:pt x="1210902" y="438708"/>
                      <a:pt x="1210902" y="428608"/>
                    </a:cubicBezTo>
                    <a:cubicBezTo>
                      <a:pt x="1210902" y="418508"/>
                      <a:pt x="1219090" y="410320"/>
                      <a:pt x="1229190" y="410320"/>
                    </a:cubicBezTo>
                    <a:close/>
                    <a:moveTo>
                      <a:pt x="1171528" y="410320"/>
                    </a:moveTo>
                    <a:cubicBezTo>
                      <a:pt x="1181628" y="410320"/>
                      <a:pt x="1189816" y="418508"/>
                      <a:pt x="1189816" y="428608"/>
                    </a:cubicBezTo>
                    <a:cubicBezTo>
                      <a:pt x="1189816" y="438708"/>
                      <a:pt x="1181628" y="446896"/>
                      <a:pt x="1171528" y="446896"/>
                    </a:cubicBezTo>
                    <a:cubicBezTo>
                      <a:pt x="1161428" y="446896"/>
                      <a:pt x="1153240" y="438708"/>
                      <a:pt x="1153240" y="428608"/>
                    </a:cubicBezTo>
                    <a:cubicBezTo>
                      <a:pt x="1153240" y="418508"/>
                      <a:pt x="1161428" y="410320"/>
                      <a:pt x="1171528" y="410320"/>
                    </a:cubicBezTo>
                    <a:close/>
                    <a:moveTo>
                      <a:pt x="1113866" y="410320"/>
                    </a:moveTo>
                    <a:cubicBezTo>
                      <a:pt x="1123966" y="410320"/>
                      <a:pt x="1132154" y="418508"/>
                      <a:pt x="1132154" y="428608"/>
                    </a:cubicBezTo>
                    <a:cubicBezTo>
                      <a:pt x="1132154" y="438708"/>
                      <a:pt x="1123966" y="446896"/>
                      <a:pt x="1113866" y="446896"/>
                    </a:cubicBezTo>
                    <a:cubicBezTo>
                      <a:pt x="1103766" y="446896"/>
                      <a:pt x="1095578" y="438708"/>
                      <a:pt x="1095578" y="428608"/>
                    </a:cubicBezTo>
                    <a:cubicBezTo>
                      <a:pt x="1095578" y="418508"/>
                      <a:pt x="1103766" y="410320"/>
                      <a:pt x="1113866" y="410320"/>
                    </a:cubicBezTo>
                    <a:close/>
                    <a:moveTo>
                      <a:pt x="1056204" y="410320"/>
                    </a:moveTo>
                    <a:cubicBezTo>
                      <a:pt x="1066304" y="410320"/>
                      <a:pt x="1074492" y="418508"/>
                      <a:pt x="1074492" y="428608"/>
                    </a:cubicBezTo>
                    <a:cubicBezTo>
                      <a:pt x="1074492" y="438708"/>
                      <a:pt x="1066304" y="446896"/>
                      <a:pt x="1056204" y="446896"/>
                    </a:cubicBezTo>
                    <a:cubicBezTo>
                      <a:pt x="1046104" y="446896"/>
                      <a:pt x="1037916" y="438708"/>
                      <a:pt x="1037916" y="428608"/>
                    </a:cubicBezTo>
                    <a:cubicBezTo>
                      <a:pt x="1037916" y="418508"/>
                      <a:pt x="1046104" y="410320"/>
                      <a:pt x="1056204" y="410320"/>
                    </a:cubicBezTo>
                    <a:close/>
                    <a:moveTo>
                      <a:pt x="998542" y="410320"/>
                    </a:moveTo>
                    <a:cubicBezTo>
                      <a:pt x="1008642" y="410320"/>
                      <a:pt x="1016830" y="418508"/>
                      <a:pt x="1016830" y="428608"/>
                    </a:cubicBezTo>
                    <a:cubicBezTo>
                      <a:pt x="1016830" y="438708"/>
                      <a:pt x="1008642" y="446896"/>
                      <a:pt x="998542" y="446896"/>
                    </a:cubicBezTo>
                    <a:cubicBezTo>
                      <a:pt x="988442" y="446896"/>
                      <a:pt x="980254" y="438708"/>
                      <a:pt x="980254" y="428608"/>
                    </a:cubicBezTo>
                    <a:cubicBezTo>
                      <a:pt x="980254" y="418508"/>
                      <a:pt x="988442" y="410320"/>
                      <a:pt x="998542" y="410320"/>
                    </a:cubicBezTo>
                    <a:close/>
                    <a:moveTo>
                      <a:pt x="940880" y="410320"/>
                    </a:moveTo>
                    <a:cubicBezTo>
                      <a:pt x="950980" y="410320"/>
                      <a:pt x="959168" y="418508"/>
                      <a:pt x="959168" y="428608"/>
                    </a:cubicBezTo>
                    <a:cubicBezTo>
                      <a:pt x="959168" y="438708"/>
                      <a:pt x="950980" y="446896"/>
                      <a:pt x="940880" y="446896"/>
                    </a:cubicBezTo>
                    <a:cubicBezTo>
                      <a:pt x="930780" y="446896"/>
                      <a:pt x="922592" y="438708"/>
                      <a:pt x="922592" y="428608"/>
                    </a:cubicBezTo>
                    <a:cubicBezTo>
                      <a:pt x="922592" y="418508"/>
                      <a:pt x="930780" y="410320"/>
                      <a:pt x="940880" y="410320"/>
                    </a:cubicBezTo>
                    <a:close/>
                    <a:moveTo>
                      <a:pt x="883218" y="410320"/>
                    </a:moveTo>
                    <a:cubicBezTo>
                      <a:pt x="893318" y="410320"/>
                      <a:pt x="901506" y="418508"/>
                      <a:pt x="901506" y="428608"/>
                    </a:cubicBezTo>
                    <a:cubicBezTo>
                      <a:pt x="901506" y="438708"/>
                      <a:pt x="893318" y="446896"/>
                      <a:pt x="883218" y="446896"/>
                    </a:cubicBezTo>
                    <a:cubicBezTo>
                      <a:pt x="873118" y="446896"/>
                      <a:pt x="864930" y="438708"/>
                      <a:pt x="864930" y="428608"/>
                    </a:cubicBezTo>
                    <a:cubicBezTo>
                      <a:pt x="864930" y="418508"/>
                      <a:pt x="873118" y="410320"/>
                      <a:pt x="883218" y="410320"/>
                    </a:cubicBezTo>
                    <a:close/>
                    <a:moveTo>
                      <a:pt x="825556" y="410320"/>
                    </a:moveTo>
                    <a:cubicBezTo>
                      <a:pt x="835656" y="410320"/>
                      <a:pt x="843844" y="418508"/>
                      <a:pt x="843844" y="428608"/>
                    </a:cubicBezTo>
                    <a:cubicBezTo>
                      <a:pt x="843844" y="438708"/>
                      <a:pt x="835656" y="446896"/>
                      <a:pt x="825556" y="446896"/>
                    </a:cubicBezTo>
                    <a:cubicBezTo>
                      <a:pt x="815456" y="446896"/>
                      <a:pt x="807268" y="438708"/>
                      <a:pt x="807268" y="428608"/>
                    </a:cubicBezTo>
                    <a:cubicBezTo>
                      <a:pt x="807268" y="418508"/>
                      <a:pt x="815456" y="410320"/>
                      <a:pt x="825556" y="410320"/>
                    </a:cubicBezTo>
                    <a:close/>
                    <a:moveTo>
                      <a:pt x="767894" y="410320"/>
                    </a:moveTo>
                    <a:cubicBezTo>
                      <a:pt x="777994" y="410320"/>
                      <a:pt x="786182" y="418508"/>
                      <a:pt x="786182" y="428608"/>
                    </a:cubicBezTo>
                    <a:cubicBezTo>
                      <a:pt x="786182" y="438708"/>
                      <a:pt x="777994" y="446896"/>
                      <a:pt x="767894" y="446896"/>
                    </a:cubicBezTo>
                    <a:cubicBezTo>
                      <a:pt x="757794" y="446896"/>
                      <a:pt x="749606" y="438708"/>
                      <a:pt x="749606" y="428608"/>
                    </a:cubicBezTo>
                    <a:cubicBezTo>
                      <a:pt x="749606" y="418508"/>
                      <a:pt x="757794" y="410320"/>
                      <a:pt x="767894" y="410320"/>
                    </a:cubicBezTo>
                    <a:close/>
                    <a:moveTo>
                      <a:pt x="710232" y="410320"/>
                    </a:moveTo>
                    <a:cubicBezTo>
                      <a:pt x="720332" y="410320"/>
                      <a:pt x="728520" y="418508"/>
                      <a:pt x="728520" y="428608"/>
                    </a:cubicBezTo>
                    <a:cubicBezTo>
                      <a:pt x="728520" y="438708"/>
                      <a:pt x="720332" y="446896"/>
                      <a:pt x="710232" y="446896"/>
                    </a:cubicBezTo>
                    <a:cubicBezTo>
                      <a:pt x="700132" y="446896"/>
                      <a:pt x="691944" y="438708"/>
                      <a:pt x="691944" y="428608"/>
                    </a:cubicBezTo>
                    <a:cubicBezTo>
                      <a:pt x="691944" y="418508"/>
                      <a:pt x="700132" y="410320"/>
                      <a:pt x="710232" y="410320"/>
                    </a:cubicBezTo>
                    <a:close/>
                    <a:moveTo>
                      <a:pt x="652570" y="410320"/>
                    </a:moveTo>
                    <a:cubicBezTo>
                      <a:pt x="662670" y="410320"/>
                      <a:pt x="670858" y="418508"/>
                      <a:pt x="670858" y="428608"/>
                    </a:cubicBezTo>
                    <a:cubicBezTo>
                      <a:pt x="670858" y="438708"/>
                      <a:pt x="662670" y="446896"/>
                      <a:pt x="652570" y="446896"/>
                    </a:cubicBezTo>
                    <a:cubicBezTo>
                      <a:pt x="642470" y="446896"/>
                      <a:pt x="634282" y="438708"/>
                      <a:pt x="634282" y="428608"/>
                    </a:cubicBezTo>
                    <a:cubicBezTo>
                      <a:pt x="634282" y="418508"/>
                      <a:pt x="642470" y="410320"/>
                      <a:pt x="652570" y="410320"/>
                    </a:cubicBezTo>
                    <a:close/>
                    <a:moveTo>
                      <a:pt x="594908" y="410320"/>
                    </a:moveTo>
                    <a:cubicBezTo>
                      <a:pt x="605008" y="410320"/>
                      <a:pt x="613196" y="418508"/>
                      <a:pt x="613196" y="428608"/>
                    </a:cubicBezTo>
                    <a:cubicBezTo>
                      <a:pt x="613196" y="438708"/>
                      <a:pt x="605008" y="446896"/>
                      <a:pt x="594908" y="446896"/>
                    </a:cubicBezTo>
                    <a:cubicBezTo>
                      <a:pt x="584808" y="446896"/>
                      <a:pt x="576620" y="438708"/>
                      <a:pt x="576620" y="428608"/>
                    </a:cubicBezTo>
                    <a:cubicBezTo>
                      <a:pt x="576620" y="418508"/>
                      <a:pt x="584808" y="410320"/>
                      <a:pt x="594908" y="410320"/>
                    </a:cubicBezTo>
                    <a:close/>
                    <a:moveTo>
                      <a:pt x="537246" y="410320"/>
                    </a:moveTo>
                    <a:cubicBezTo>
                      <a:pt x="547346" y="410320"/>
                      <a:pt x="555534" y="418508"/>
                      <a:pt x="555534" y="428608"/>
                    </a:cubicBezTo>
                    <a:cubicBezTo>
                      <a:pt x="555534" y="438708"/>
                      <a:pt x="547346" y="446896"/>
                      <a:pt x="537246" y="446896"/>
                    </a:cubicBezTo>
                    <a:cubicBezTo>
                      <a:pt x="527146" y="446896"/>
                      <a:pt x="518958" y="438708"/>
                      <a:pt x="518958" y="428608"/>
                    </a:cubicBezTo>
                    <a:cubicBezTo>
                      <a:pt x="518958" y="418508"/>
                      <a:pt x="527146" y="410320"/>
                      <a:pt x="537246" y="410320"/>
                    </a:cubicBezTo>
                    <a:close/>
                    <a:moveTo>
                      <a:pt x="479584" y="410320"/>
                    </a:moveTo>
                    <a:cubicBezTo>
                      <a:pt x="489684" y="410320"/>
                      <a:pt x="497872" y="418508"/>
                      <a:pt x="497872" y="428608"/>
                    </a:cubicBezTo>
                    <a:cubicBezTo>
                      <a:pt x="497872" y="438708"/>
                      <a:pt x="489684" y="446896"/>
                      <a:pt x="479584" y="446896"/>
                    </a:cubicBezTo>
                    <a:cubicBezTo>
                      <a:pt x="469484" y="446896"/>
                      <a:pt x="461296" y="438708"/>
                      <a:pt x="461296" y="428608"/>
                    </a:cubicBezTo>
                    <a:cubicBezTo>
                      <a:pt x="461296" y="418508"/>
                      <a:pt x="469484" y="410320"/>
                      <a:pt x="479584" y="410320"/>
                    </a:cubicBezTo>
                    <a:close/>
                    <a:moveTo>
                      <a:pt x="421922" y="410320"/>
                    </a:moveTo>
                    <a:cubicBezTo>
                      <a:pt x="432022" y="410320"/>
                      <a:pt x="440210" y="418508"/>
                      <a:pt x="440210" y="428608"/>
                    </a:cubicBezTo>
                    <a:cubicBezTo>
                      <a:pt x="440210" y="438708"/>
                      <a:pt x="432022" y="446896"/>
                      <a:pt x="421922" y="446896"/>
                    </a:cubicBezTo>
                    <a:cubicBezTo>
                      <a:pt x="411822" y="446896"/>
                      <a:pt x="403634" y="438708"/>
                      <a:pt x="403634" y="428608"/>
                    </a:cubicBezTo>
                    <a:cubicBezTo>
                      <a:pt x="403634" y="418508"/>
                      <a:pt x="411822" y="410320"/>
                      <a:pt x="421922" y="410320"/>
                    </a:cubicBezTo>
                    <a:close/>
                    <a:moveTo>
                      <a:pt x="364260" y="410320"/>
                    </a:moveTo>
                    <a:cubicBezTo>
                      <a:pt x="374360" y="410320"/>
                      <a:pt x="382548" y="418508"/>
                      <a:pt x="382548" y="428608"/>
                    </a:cubicBezTo>
                    <a:cubicBezTo>
                      <a:pt x="382548" y="438708"/>
                      <a:pt x="374360" y="446896"/>
                      <a:pt x="364260" y="446896"/>
                    </a:cubicBezTo>
                    <a:cubicBezTo>
                      <a:pt x="354160" y="446896"/>
                      <a:pt x="345972" y="438708"/>
                      <a:pt x="345972" y="428608"/>
                    </a:cubicBezTo>
                    <a:cubicBezTo>
                      <a:pt x="345972" y="418508"/>
                      <a:pt x="354160" y="410320"/>
                      <a:pt x="364260" y="410320"/>
                    </a:cubicBezTo>
                    <a:close/>
                    <a:moveTo>
                      <a:pt x="306598" y="410320"/>
                    </a:moveTo>
                    <a:cubicBezTo>
                      <a:pt x="316698" y="410320"/>
                      <a:pt x="324886" y="418508"/>
                      <a:pt x="324886" y="428608"/>
                    </a:cubicBezTo>
                    <a:cubicBezTo>
                      <a:pt x="324886" y="438708"/>
                      <a:pt x="316698" y="446896"/>
                      <a:pt x="306598" y="446896"/>
                    </a:cubicBezTo>
                    <a:cubicBezTo>
                      <a:pt x="296498" y="446896"/>
                      <a:pt x="288310" y="438708"/>
                      <a:pt x="288310" y="428608"/>
                    </a:cubicBezTo>
                    <a:cubicBezTo>
                      <a:pt x="288310" y="418508"/>
                      <a:pt x="296498" y="410320"/>
                      <a:pt x="306598" y="410320"/>
                    </a:cubicBezTo>
                    <a:close/>
                    <a:moveTo>
                      <a:pt x="248936" y="410320"/>
                    </a:moveTo>
                    <a:cubicBezTo>
                      <a:pt x="259036" y="410320"/>
                      <a:pt x="267224" y="418508"/>
                      <a:pt x="267224" y="428608"/>
                    </a:cubicBezTo>
                    <a:cubicBezTo>
                      <a:pt x="267224" y="438708"/>
                      <a:pt x="259036" y="446896"/>
                      <a:pt x="248936" y="446896"/>
                    </a:cubicBezTo>
                    <a:cubicBezTo>
                      <a:pt x="238836" y="446896"/>
                      <a:pt x="230648" y="438708"/>
                      <a:pt x="230648" y="428608"/>
                    </a:cubicBezTo>
                    <a:cubicBezTo>
                      <a:pt x="230648" y="418508"/>
                      <a:pt x="238836" y="410320"/>
                      <a:pt x="248936" y="410320"/>
                    </a:cubicBezTo>
                    <a:close/>
                    <a:moveTo>
                      <a:pt x="191274" y="410320"/>
                    </a:moveTo>
                    <a:cubicBezTo>
                      <a:pt x="201374" y="410320"/>
                      <a:pt x="209562" y="418508"/>
                      <a:pt x="209562" y="428608"/>
                    </a:cubicBezTo>
                    <a:cubicBezTo>
                      <a:pt x="209562" y="438708"/>
                      <a:pt x="201374" y="446896"/>
                      <a:pt x="191274" y="446896"/>
                    </a:cubicBezTo>
                    <a:cubicBezTo>
                      <a:pt x="181174" y="446896"/>
                      <a:pt x="172986" y="438708"/>
                      <a:pt x="172986" y="428608"/>
                    </a:cubicBezTo>
                    <a:cubicBezTo>
                      <a:pt x="172986" y="418508"/>
                      <a:pt x="181174" y="410320"/>
                      <a:pt x="191274" y="410320"/>
                    </a:cubicBezTo>
                    <a:close/>
                    <a:moveTo>
                      <a:pt x="133612" y="410320"/>
                    </a:moveTo>
                    <a:cubicBezTo>
                      <a:pt x="143712" y="410320"/>
                      <a:pt x="151900" y="418508"/>
                      <a:pt x="151900" y="428608"/>
                    </a:cubicBezTo>
                    <a:cubicBezTo>
                      <a:pt x="151900" y="438708"/>
                      <a:pt x="143712" y="446896"/>
                      <a:pt x="133612" y="446896"/>
                    </a:cubicBezTo>
                    <a:cubicBezTo>
                      <a:pt x="123512" y="446896"/>
                      <a:pt x="115324" y="438708"/>
                      <a:pt x="115324" y="428608"/>
                    </a:cubicBezTo>
                    <a:cubicBezTo>
                      <a:pt x="115324" y="418508"/>
                      <a:pt x="123512" y="410320"/>
                      <a:pt x="133612" y="410320"/>
                    </a:cubicBezTo>
                    <a:close/>
                    <a:moveTo>
                      <a:pt x="75950" y="410320"/>
                    </a:moveTo>
                    <a:cubicBezTo>
                      <a:pt x="86050" y="410320"/>
                      <a:pt x="94238" y="418508"/>
                      <a:pt x="94238" y="428608"/>
                    </a:cubicBezTo>
                    <a:cubicBezTo>
                      <a:pt x="94238" y="438708"/>
                      <a:pt x="86050" y="446896"/>
                      <a:pt x="75950" y="446896"/>
                    </a:cubicBezTo>
                    <a:cubicBezTo>
                      <a:pt x="65850" y="446896"/>
                      <a:pt x="57662" y="438708"/>
                      <a:pt x="57662" y="428608"/>
                    </a:cubicBezTo>
                    <a:cubicBezTo>
                      <a:pt x="57662" y="418508"/>
                      <a:pt x="65850" y="410320"/>
                      <a:pt x="75950" y="410320"/>
                    </a:cubicBezTo>
                    <a:close/>
                    <a:moveTo>
                      <a:pt x="18288" y="410320"/>
                    </a:moveTo>
                    <a:cubicBezTo>
                      <a:pt x="28388" y="410320"/>
                      <a:pt x="36576" y="418508"/>
                      <a:pt x="36576" y="428608"/>
                    </a:cubicBezTo>
                    <a:cubicBezTo>
                      <a:pt x="36576" y="438708"/>
                      <a:pt x="28388" y="446896"/>
                      <a:pt x="18288" y="446896"/>
                    </a:cubicBezTo>
                    <a:cubicBezTo>
                      <a:pt x="8188" y="446896"/>
                      <a:pt x="0" y="438708"/>
                      <a:pt x="0" y="428608"/>
                    </a:cubicBezTo>
                    <a:cubicBezTo>
                      <a:pt x="0" y="418508"/>
                      <a:pt x="8188" y="410320"/>
                      <a:pt x="18288" y="410320"/>
                    </a:cubicBezTo>
                    <a:close/>
                    <a:moveTo>
                      <a:pt x="1459848" y="359030"/>
                    </a:moveTo>
                    <a:cubicBezTo>
                      <a:pt x="1469948" y="359030"/>
                      <a:pt x="1478136" y="367218"/>
                      <a:pt x="1478136" y="377318"/>
                    </a:cubicBezTo>
                    <a:cubicBezTo>
                      <a:pt x="1478136" y="387418"/>
                      <a:pt x="1469948" y="395606"/>
                      <a:pt x="1459848" y="395606"/>
                    </a:cubicBezTo>
                    <a:cubicBezTo>
                      <a:pt x="1449748" y="395606"/>
                      <a:pt x="1441560" y="387418"/>
                      <a:pt x="1441560" y="377318"/>
                    </a:cubicBezTo>
                    <a:cubicBezTo>
                      <a:pt x="1441560" y="367218"/>
                      <a:pt x="1449748" y="359030"/>
                      <a:pt x="1459848" y="359030"/>
                    </a:cubicBezTo>
                    <a:close/>
                    <a:moveTo>
                      <a:pt x="1402176" y="359030"/>
                    </a:moveTo>
                    <a:cubicBezTo>
                      <a:pt x="1412276" y="359030"/>
                      <a:pt x="1420464" y="367218"/>
                      <a:pt x="1420464" y="377318"/>
                    </a:cubicBezTo>
                    <a:cubicBezTo>
                      <a:pt x="1420464" y="387418"/>
                      <a:pt x="1412276" y="395606"/>
                      <a:pt x="1402176" y="395606"/>
                    </a:cubicBezTo>
                    <a:cubicBezTo>
                      <a:pt x="1392076" y="395606"/>
                      <a:pt x="1383888" y="387418"/>
                      <a:pt x="1383888" y="377318"/>
                    </a:cubicBezTo>
                    <a:cubicBezTo>
                      <a:pt x="1383888" y="367218"/>
                      <a:pt x="1392076" y="359030"/>
                      <a:pt x="1402176" y="359030"/>
                    </a:cubicBezTo>
                    <a:close/>
                    <a:moveTo>
                      <a:pt x="1344514" y="359030"/>
                    </a:moveTo>
                    <a:cubicBezTo>
                      <a:pt x="1354614" y="359030"/>
                      <a:pt x="1362802" y="367218"/>
                      <a:pt x="1362802" y="377318"/>
                    </a:cubicBezTo>
                    <a:cubicBezTo>
                      <a:pt x="1362802" y="387418"/>
                      <a:pt x="1354614" y="395606"/>
                      <a:pt x="1344514" y="395606"/>
                    </a:cubicBezTo>
                    <a:cubicBezTo>
                      <a:pt x="1334414" y="395606"/>
                      <a:pt x="1326226" y="387418"/>
                      <a:pt x="1326226" y="377318"/>
                    </a:cubicBezTo>
                    <a:cubicBezTo>
                      <a:pt x="1326226" y="367218"/>
                      <a:pt x="1334414" y="359030"/>
                      <a:pt x="1344514" y="359030"/>
                    </a:cubicBezTo>
                    <a:close/>
                    <a:moveTo>
                      <a:pt x="1286852" y="359030"/>
                    </a:moveTo>
                    <a:cubicBezTo>
                      <a:pt x="1296952" y="359030"/>
                      <a:pt x="1305140" y="367218"/>
                      <a:pt x="1305140" y="377318"/>
                    </a:cubicBezTo>
                    <a:cubicBezTo>
                      <a:pt x="1305140" y="387418"/>
                      <a:pt x="1296952" y="395606"/>
                      <a:pt x="1286852" y="395606"/>
                    </a:cubicBezTo>
                    <a:cubicBezTo>
                      <a:pt x="1276752" y="395606"/>
                      <a:pt x="1268564" y="387418"/>
                      <a:pt x="1268564" y="377318"/>
                    </a:cubicBezTo>
                    <a:cubicBezTo>
                      <a:pt x="1268564" y="367218"/>
                      <a:pt x="1276752" y="359030"/>
                      <a:pt x="1286852" y="359030"/>
                    </a:cubicBezTo>
                    <a:close/>
                    <a:moveTo>
                      <a:pt x="1229190" y="359030"/>
                    </a:moveTo>
                    <a:cubicBezTo>
                      <a:pt x="1239290" y="359030"/>
                      <a:pt x="1247478" y="367218"/>
                      <a:pt x="1247478" y="377318"/>
                    </a:cubicBezTo>
                    <a:cubicBezTo>
                      <a:pt x="1247478" y="387418"/>
                      <a:pt x="1239290" y="395606"/>
                      <a:pt x="1229190" y="395606"/>
                    </a:cubicBezTo>
                    <a:cubicBezTo>
                      <a:pt x="1219090" y="395606"/>
                      <a:pt x="1210902" y="387418"/>
                      <a:pt x="1210902" y="377318"/>
                    </a:cubicBezTo>
                    <a:cubicBezTo>
                      <a:pt x="1210902" y="367218"/>
                      <a:pt x="1219090" y="359030"/>
                      <a:pt x="1229190" y="359030"/>
                    </a:cubicBezTo>
                    <a:close/>
                    <a:moveTo>
                      <a:pt x="1171528" y="359030"/>
                    </a:moveTo>
                    <a:cubicBezTo>
                      <a:pt x="1181628" y="359030"/>
                      <a:pt x="1189816" y="367218"/>
                      <a:pt x="1189816" y="377318"/>
                    </a:cubicBezTo>
                    <a:cubicBezTo>
                      <a:pt x="1189816" y="387418"/>
                      <a:pt x="1181628" y="395606"/>
                      <a:pt x="1171528" y="395606"/>
                    </a:cubicBezTo>
                    <a:cubicBezTo>
                      <a:pt x="1161428" y="395606"/>
                      <a:pt x="1153240" y="387418"/>
                      <a:pt x="1153240" y="377318"/>
                    </a:cubicBezTo>
                    <a:cubicBezTo>
                      <a:pt x="1153240" y="367218"/>
                      <a:pt x="1161428" y="359030"/>
                      <a:pt x="1171528" y="359030"/>
                    </a:cubicBezTo>
                    <a:close/>
                    <a:moveTo>
                      <a:pt x="1113866" y="359030"/>
                    </a:moveTo>
                    <a:cubicBezTo>
                      <a:pt x="1123966" y="359030"/>
                      <a:pt x="1132154" y="367218"/>
                      <a:pt x="1132154" y="377318"/>
                    </a:cubicBezTo>
                    <a:cubicBezTo>
                      <a:pt x="1132154" y="387418"/>
                      <a:pt x="1123966" y="395606"/>
                      <a:pt x="1113866" y="395606"/>
                    </a:cubicBezTo>
                    <a:cubicBezTo>
                      <a:pt x="1103766" y="395606"/>
                      <a:pt x="1095578" y="387418"/>
                      <a:pt x="1095578" y="377318"/>
                    </a:cubicBezTo>
                    <a:cubicBezTo>
                      <a:pt x="1095578" y="367218"/>
                      <a:pt x="1103766" y="359030"/>
                      <a:pt x="1113866" y="359030"/>
                    </a:cubicBezTo>
                    <a:close/>
                    <a:moveTo>
                      <a:pt x="1056204" y="359030"/>
                    </a:moveTo>
                    <a:cubicBezTo>
                      <a:pt x="1066304" y="359030"/>
                      <a:pt x="1074492" y="367218"/>
                      <a:pt x="1074492" y="377318"/>
                    </a:cubicBezTo>
                    <a:cubicBezTo>
                      <a:pt x="1074492" y="387418"/>
                      <a:pt x="1066304" y="395606"/>
                      <a:pt x="1056204" y="395606"/>
                    </a:cubicBezTo>
                    <a:cubicBezTo>
                      <a:pt x="1046104" y="395606"/>
                      <a:pt x="1037916" y="387418"/>
                      <a:pt x="1037916" y="377318"/>
                    </a:cubicBezTo>
                    <a:cubicBezTo>
                      <a:pt x="1037916" y="367218"/>
                      <a:pt x="1046104" y="359030"/>
                      <a:pt x="1056204" y="359030"/>
                    </a:cubicBezTo>
                    <a:close/>
                    <a:moveTo>
                      <a:pt x="998542" y="359030"/>
                    </a:moveTo>
                    <a:cubicBezTo>
                      <a:pt x="1008642" y="359030"/>
                      <a:pt x="1016830" y="367218"/>
                      <a:pt x="1016830" y="377318"/>
                    </a:cubicBezTo>
                    <a:cubicBezTo>
                      <a:pt x="1016830" y="387418"/>
                      <a:pt x="1008642" y="395606"/>
                      <a:pt x="998542" y="395606"/>
                    </a:cubicBezTo>
                    <a:cubicBezTo>
                      <a:pt x="988442" y="395606"/>
                      <a:pt x="980254" y="387418"/>
                      <a:pt x="980254" y="377318"/>
                    </a:cubicBezTo>
                    <a:cubicBezTo>
                      <a:pt x="980254" y="367218"/>
                      <a:pt x="988442" y="359030"/>
                      <a:pt x="998542" y="359030"/>
                    </a:cubicBezTo>
                    <a:close/>
                    <a:moveTo>
                      <a:pt x="940880" y="359030"/>
                    </a:moveTo>
                    <a:cubicBezTo>
                      <a:pt x="950980" y="359030"/>
                      <a:pt x="959168" y="367218"/>
                      <a:pt x="959168" y="377318"/>
                    </a:cubicBezTo>
                    <a:cubicBezTo>
                      <a:pt x="959168" y="387418"/>
                      <a:pt x="950980" y="395606"/>
                      <a:pt x="940880" y="395606"/>
                    </a:cubicBezTo>
                    <a:cubicBezTo>
                      <a:pt x="930780" y="395606"/>
                      <a:pt x="922592" y="387418"/>
                      <a:pt x="922592" y="377318"/>
                    </a:cubicBezTo>
                    <a:cubicBezTo>
                      <a:pt x="922592" y="367218"/>
                      <a:pt x="930780" y="359030"/>
                      <a:pt x="940880" y="359030"/>
                    </a:cubicBezTo>
                    <a:close/>
                    <a:moveTo>
                      <a:pt x="883218" y="359030"/>
                    </a:moveTo>
                    <a:cubicBezTo>
                      <a:pt x="893318" y="359030"/>
                      <a:pt x="901506" y="367218"/>
                      <a:pt x="901506" y="377318"/>
                    </a:cubicBezTo>
                    <a:cubicBezTo>
                      <a:pt x="901506" y="387418"/>
                      <a:pt x="893318" y="395606"/>
                      <a:pt x="883218" y="395606"/>
                    </a:cubicBezTo>
                    <a:cubicBezTo>
                      <a:pt x="873118" y="395606"/>
                      <a:pt x="864930" y="387418"/>
                      <a:pt x="864930" y="377318"/>
                    </a:cubicBezTo>
                    <a:cubicBezTo>
                      <a:pt x="864930" y="367218"/>
                      <a:pt x="873118" y="359030"/>
                      <a:pt x="883218" y="359030"/>
                    </a:cubicBezTo>
                    <a:close/>
                    <a:moveTo>
                      <a:pt x="825556" y="359030"/>
                    </a:moveTo>
                    <a:cubicBezTo>
                      <a:pt x="835656" y="359030"/>
                      <a:pt x="843844" y="367218"/>
                      <a:pt x="843844" y="377318"/>
                    </a:cubicBezTo>
                    <a:cubicBezTo>
                      <a:pt x="843844" y="387418"/>
                      <a:pt x="835656" y="395606"/>
                      <a:pt x="825556" y="395606"/>
                    </a:cubicBezTo>
                    <a:cubicBezTo>
                      <a:pt x="815456" y="395606"/>
                      <a:pt x="807268" y="387418"/>
                      <a:pt x="807268" y="377318"/>
                    </a:cubicBezTo>
                    <a:cubicBezTo>
                      <a:pt x="807268" y="367218"/>
                      <a:pt x="815456" y="359030"/>
                      <a:pt x="825556" y="359030"/>
                    </a:cubicBezTo>
                    <a:close/>
                    <a:moveTo>
                      <a:pt x="767894" y="359030"/>
                    </a:moveTo>
                    <a:cubicBezTo>
                      <a:pt x="777994" y="359030"/>
                      <a:pt x="786182" y="367218"/>
                      <a:pt x="786182" y="377318"/>
                    </a:cubicBezTo>
                    <a:cubicBezTo>
                      <a:pt x="786182" y="387418"/>
                      <a:pt x="777994" y="395606"/>
                      <a:pt x="767894" y="395606"/>
                    </a:cubicBezTo>
                    <a:cubicBezTo>
                      <a:pt x="757794" y="395606"/>
                      <a:pt x="749606" y="387418"/>
                      <a:pt x="749606" y="377318"/>
                    </a:cubicBezTo>
                    <a:cubicBezTo>
                      <a:pt x="749606" y="367218"/>
                      <a:pt x="757794" y="359030"/>
                      <a:pt x="767894" y="359030"/>
                    </a:cubicBezTo>
                    <a:close/>
                    <a:moveTo>
                      <a:pt x="710232" y="359030"/>
                    </a:moveTo>
                    <a:cubicBezTo>
                      <a:pt x="720332" y="359030"/>
                      <a:pt x="728520" y="367218"/>
                      <a:pt x="728520" y="377318"/>
                    </a:cubicBezTo>
                    <a:cubicBezTo>
                      <a:pt x="728520" y="387418"/>
                      <a:pt x="720332" y="395606"/>
                      <a:pt x="710232" y="395606"/>
                    </a:cubicBezTo>
                    <a:cubicBezTo>
                      <a:pt x="700132" y="395606"/>
                      <a:pt x="691944" y="387418"/>
                      <a:pt x="691944" y="377318"/>
                    </a:cubicBezTo>
                    <a:cubicBezTo>
                      <a:pt x="691944" y="367218"/>
                      <a:pt x="700132" y="359030"/>
                      <a:pt x="710232" y="359030"/>
                    </a:cubicBezTo>
                    <a:close/>
                    <a:moveTo>
                      <a:pt x="652570" y="359030"/>
                    </a:moveTo>
                    <a:cubicBezTo>
                      <a:pt x="662670" y="359030"/>
                      <a:pt x="670858" y="367218"/>
                      <a:pt x="670858" y="377318"/>
                    </a:cubicBezTo>
                    <a:cubicBezTo>
                      <a:pt x="670858" y="387418"/>
                      <a:pt x="662670" y="395606"/>
                      <a:pt x="652570" y="395606"/>
                    </a:cubicBezTo>
                    <a:cubicBezTo>
                      <a:pt x="642470" y="395606"/>
                      <a:pt x="634282" y="387418"/>
                      <a:pt x="634282" y="377318"/>
                    </a:cubicBezTo>
                    <a:cubicBezTo>
                      <a:pt x="634282" y="367218"/>
                      <a:pt x="642470" y="359030"/>
                      <a:pt x="652570" y="359030"/>
                    </a:cubicBezTo>
                    <a:close/>
                    <a:moveTo>
                      <a:pt x="594908" y="359030"/>
                    </a:moveTo>
                    <a:cubicBezTo>
                      <a:pt x="605008" y="359030"/>
                      <a:pt x="613196" y="367218"/>
                      <a:pt x="613196" y="377318"/>
                    </a:cubicBezTo>
                    <a:cubicBezTo>
                      <a:pt x="613196" y="387418"/>
                      <a:pt x="605008" y="395606"/>
                      <a:pt x="594908" y="395606"/>
                    </a:cubicBezTo>
                    <a:cubicBezTo>
                      <a:pt x="584808" y="395606"/>
                      <a:pt x="576620" y="387418"/>
                      <a:pt x="576620" y="377318"/>
                    </a:cubicBezTo>
                    <a:cubicBezTo>
                      <a:pt x="576620" y="367218"/>
                      <a:pt x="584808" y="359030"/>
                      <a:pt x="594908" y="359030"/>
                    </a:cubicBezTo>
                    <a:close/>
                    <a:moveTo>
                      <a:pt x="537246" y="359030"/>
                    </a:moveTo>
                    <a:cubicBezTo>
                      <a:pt x="547346" y="359030"/>
                      <a:pt x="555534" y="367218"/>
                      <a:pt x="555534" y="377318"/>
                    </a:cubicBezTo>
                    <a:cubicBezTo>
                      <a:pt x="555534" y="387418"/>
                      <a:pt x="547346" y="395606"/>
                      <a:pt x="537246" y="395606"/>
                    </a:cubicBezTo>
                    <a:cubicBezTo>
                      <a:pt x="527146" y="395606"/>
                      <a:pt x="518958" y="387418"/>
                      <a:pt x="518958" y="377318"/>
                    </a:cubicBezTo>
                    <a:cubicBezTo>
                      <a:pt x="518958" y="367218"/>
                      <a:pt x="527146" y="359030"/>
                      <a:pt x="537246" y="359030"/>
                    </a:cubicBezTo>
                    <a:close/>
                    <a:moveTo>
                      <a:pt x="479584" y="359030"/>
                    </a:moveTo>
                    <a:cubicBezTo>
                      <a:pt x="489684" y="359030"/>
                      <a:pt x="497872" y="367218"/>
                      <a:pt x="497872" y="377318"/>
                    </a:cubicBezTo>
                    <a:cubicBezTo>
                      <a:pt x="497872" y="387418"/>
                      <a:pt x="489684" y="395606"/>
                      <a:pt x="479584" y="395606"/>
                    </a:cubicBezTo>
                    <a:cubicBezTo>
                      <a:pt x="469484" y="395606"/>
                      <a:pt x="461296" y="387418"/>
                      <a:pt x="461296" y="377318"/>
                    </a:cubicBezTo>
                    <a:cubicBezTo>
                      <a:pt x="461296" y="367218"/>
                      <a:pt x="469484" y="359030"/>
                      <a:pt x="479584" y="359030"/>
                    </a:cubicBezTo>
                    <a:close/>
                    <a:moveTo>
                      <a:pt x="421922" y="359030"/>
                    </a:moveTo>
                    <a:cubicBezTo>
                      <a:pt x="432022" y="359030"/>
                      <a:pt x="440210" y="367218"/>
                      <a:pt x="440210" y="377318"/>
                    </a:cubicBezTo>
                    <a:cubicBezTo>
                      <a:pt x="440210" y="387418"/>
                      <a:pt x="432022" y="395606"/>
                      <a:pt x="421922" y="395606"/>
                    </a:cubicBezTo>
                    <a:cubicBezTo>
                      <a:pt x="411822" y="395606"/>
                      <a:pt x="403634" y="387418"/>
                      <a:pt x="403634" y="377318"/>
                    </a:cubicBezTo>
                    <a:cubicBezTo>
                      <a:pt x="403634" y="367218"/>
                      <a:pt x="411822" y="359030"/>
                      <a:pt x="421922" y="359030"/>
                    </a:cubicBezTo>
                    <a:close/>
                    <a:moveTo>
                      <a:pt x="364260" y="359030"/>
                    </a:moveTo>
                    <a:cubicBezTo>
                      <a:pt x="374360" y="359030"/>
                      <a:pt x="382548" y="367218"/>
                      <a:pt x="382548" y="377318"/>
                    </a:cubicBezTo>
                    <a:cubicBezTo>
                      <a:pt x="382548" y="387418"/>
                      <a:pt x="374360" y="395606"/>
                      <a:pt x="364260" y="395606"/>
                    </a:cubicBezTo>
                    <a:cubicBezTo>
                      <a:pt x="354160" y="395606"/>
                      <a:pt x="345972" y="387418"/>
                      <a:pt x="345972" y="377318"/>
                    </a:cubicBezTo>
                    <a:cubicBezTo>
                      <a:pt x="345972" y="367218"/>
                      <a:pt x="354160" y="359030"/>
                      <a:pt x="364260" y="359030"/>
                    </a:cubicBezTo>
                    <a:close/>
                    <a:moveTo>
                      <a:pt x="306598" y="359030"/>
                    </a:moveTo>
                    <a:cubicBezTo>
                      <a:pt x="316698" y="359030"/>
                      <a:pt x="324886" y="367218"/>
                      <a:pt x="324886" y="377318"/>
                    </a:cubicBezTo>
                    <a:cubicBezTo>
                      <a:pt x="324886" y="387418"/>
                      <a:pt x="316698" y="395606"/>
                      <a:pt x="306598" y="395606"/>
                    </a:cubicBezTo>
                    <a:cubicBezTo>
                      <a:pt x="296498" y="395606"/>
                      <a:pt x="288310" y="387418"/>
                      <a:pt x="288310" y="377318"/>
                    </a:cubicBezTo>
                    <a:cubicBezTo>
                      <a:pt x="288310" y="367218"/>
                      <a:pt x="296498" y="359030"/>
                      <a:pt x="306598" y="359030"/>
                    </a:cubicBezTo>
                    <a:close/>
                    <a:moveTo>
                      <a:pt x="248936" y="359030"/>
                    </a:moveTo>
                    <a:cubicBezTo>
                      <a:pt x="259036" y="359030"/>
                      <a:pt x="267224" y="367218"/>
                      <a:pt x="267224" y="377318"/>
                    </a:cubicBezTo>
                    <a:cubicBezTo>
                      <a:pt x="267224" y="387418"/>
                      <a:pt x="259036" y="395606"/>
                      <a:pt x="248936" y="395606"/>
                    </a:cubicBezTo>
                    <a:cubicBezTo>
                      <a:pt x="238836" y="395606"/>
                      <a:pt x="230648" y="387418"/>
                      <a:pt x="230648" y="377318"/>
                    </a:cubicBezTo>
                    <a:cubicBezTo>
                      <a:pt x="230648" y="367218"/>
                      <a:pt x="238836" y="359030"/>
                      <a:pt x="248936" y="359030"/>
                    </a:cubicBezTo>
                    <a:close/>
                    <a:moveTo>
                      <a:pt x="191274" y="359030"/>
                    </a:moveTo>
                    <a:cubicBezTo>
                      <a:pt x="201374" y="359030"/>
                      <a:pt x="209562" y="367218"/>
                      <a:pt x="209562" y="377318"/>
                    </a:cubicBezTo>
                    <a:cubicBezTo>
                      <a:pt x="209562" y="387418"/>
                      <a:pt x="201374" y="395606"/>
                      <a:pt x="191274" y="395606"/>
                    </a:cubicBezTo>
                    <a:cubicBezTo>
                      <a:pt x="181174" y="395606"/>
                      <a:pt x="172986" y="387418"/>
                      <a:pt x="172986" y="377318"/>
                    </a:cubicBezTo>
                    <a:cubicBezTo>
                      <a:pt x="172986" y="367218"/>
                      <a:pt x="181174" y="359030"/>
                      <a:pt x="191274" y="359030"/>
                    </a:cubicBezTo>
                    <a:close/>
                    <a:moveTo>
                      <a:pt x="133612" y="359030"/>
                    </a:moveTo>
                    <a:cubicBezTo>
                      <a:pt x="143712" y="359030"/>
                      <a:pt x="151900" y="367218"/>
                      <a:pt x="151900" y="377318"/>
                    </a:cubicBezTo>
                    <a:cubicBezTo>
                      <a:pt x="151900" y="387418"/>
                      <a:pt x="143712" y="395606"/>
                      <a:pt x="133612" y="395606"/>
                    </a:cubicBezTo>
                    <a:cubicBezTo>
                      <a:pt x="123512" y="395606"/>
                      <a:pt x="115324" y="387418"/>
                      <a:pt x="115324" y="377318"/>
                    </a:cubicBezTo>
                    <a:cubicBezTo>
                      <a:pt x="115324" y="367218"/>
                      <a:pt x="123512" y="359030"/>
                      <a:pt x="133612" y="359030"/>
                    </a:cubicBezTo>
                    <a:close/>
                    <a:moveTo>
                      <a:pt x="75950" y="359030"/>
                    </a:moveTo>
                    <a:cubicBezTo>
                      <a:pt x="86050" y="359030"/>
                      <a:pt x="94238" y="367218"/>
                      <a:pt x="94238" y="377318"/>
                    </a:cubicBezTo>
                    <a:cubicBezTo>
                      <a:pt x="94238" y="387418"/>
                      <a:pt x="86050" y="395606"/>
                      <a:pt x="75950" y="395606"/>
                    </a:cubicBezTo>
                    <a:cubicBezTo>
                      <a:pt x="65850" y="395606"/>
                      <a:pt x="57662" y="387418"/>
                      <a:pt x="57662" y="377318"/>
                    </a:cubicBezTo>
                    <a:cubicBezTo>
                      <a:pt x="57662" y="367218"/>
                      <a:pt x="65850" y="359030"/>
                      <a:pt x="75950" y="359030"/>
                    </a:cubicBezTo>
                    <a:close/>
                    <a:moveTo>
                      <a:pt x="18288" y="359030"/>
                    </a:moveTo>
                    <a:cubicBezTo>
                      <a:pt x="28388" y="359030"/>
                      <a:pt x="36576" y="367218"/>
                      <a:pt x="36576" y="377318"/>
                    </a:cubicBezTo>
                    <a:cubicBezTo>
                      <a:pt x="36576" y="387418"/>
                      <a:pt x="28388" y="395606"/>
                      <a:pt x="18288" y="395606"/>
                    </a:cubicBezTo>
                    <a:cubicBezTo>
                      <a:pt x="8188" y="395606"/>
                      <a:pt x="0" y="387418"/>
                      <a:pt x="0" y="377318"/>
                    </a:cubicBezTo>
                    <a:cubicBezTo>
                      <a:pt x="0" y="367218"/>
                      <a:pt x="8188" y="359030"/>
                      <a:pt x="18288" y="359030"/>
                    </a:cubicBezTo>
                    <a:close/>
                    <a:moveTo>
                      <a:pt x="1459848" y="307740"/>
                    </a:moveTo>
                    <a:cubicBezTo>
                      <a:pt x="1469948" y="307740"/>
                      <a:pt x="1478136" y="315928"/>
                      <a:pt x="1478136" y="326028"/>
                    </a:cubicBezTo>
                    <a:cubicBezTo>
                      <a:pt x="1478136" y="336128"/>
                      <a:pt x="1469948" y="344316"/>
                      <a:pt x="1459848" y="344316"/>
                    </a:cubicBezTo>
                    <a:cubicBezTo>
                      <a:pt x="1449748" y="344316"/>
                      <a:pt x="1441560" y="336128"/>
                      <a:pt x="1441560" y="326028"/>
                    </a:cubicBezTo>
                    <a:cubicBezTo>
                      <a:pt x="1441560" y="315928"/>
                      <a:pt x="1449748" y="307740"/>
                      <a:pt x="1459848" y="307740"/>
                    </a:cubicBezTo>
                    <a:close/>
                    <a:moveTo>
                      <a:pt x="1402176" y="307740"/>
                    </a:moveTo>
                    <a:cubicBezTo>
                      <a:pt x="1412276" y="307740"/>
                      <a:pt x="1420464" y="315928"/>
                      <a:pt x="1420464" y="326028"/>
                    </a:cubicBezTo>
                    <a:cubicBezTo>
                      <a:pt x="1420464" y="336128"/>
                      <a:pt x="1412276" y="344316"/>
                      <a:pt x="1402176" y="344316"/>
                    </a:cubicBezTo>
                    <a:cubicBezTo>
                      <a:pt x="1392076" y="344316"/>
                      <a:pt x="1383888" y="336128"/>
                      <a:pt x="1383888" y="326028"/>
                    </a:cubicBezTo>
                    <a:cubicBezTo>
                      <a:pt x="1383888" y="315928"/>
                      <a:pt x="1392076" y="307740"/>
                      <a:pt x="1402176" y="307740"/>
                    </a:cubicBezTo>
                    <a:close/>
                    <a:moveTo>
                      <a:pt x="1344514" y="307740"/>
                    </a:moveTo>
                    <a:cubicBezTo>
                      <a:pt x="1354614" y="307740"/>
                      <a:pt x="1362802" y="315928"/>
                      <a:pt x="1362802" y="326028"/>
                    </a:cubicBezTo>
                    <a:cubicBezTo>
                      <a:pt x="1362802" y="336128"/>
                      <a:pt x="1354614" y="344316"/>
                      <a:pt x="1344514" y="344316"/>
                    </a:cubicBezTo>
                    <a:cubicBezTo>
                      <a:pt x="1334414" y="344316"/>
                      <a:pt x="1326226" y="336128"/>
                      <a:pt x="1326226" y="326028"/>
                    </a:cubicBezTo>
                    <a:cubicBezTo>
                      <a:pt x="1326226" y="315928"/>
                      <a:pt x="1334414" y="307740"/>
                      <a:pt x="1344514" y="307740"/>
                    </a:cubicBezTo>
                    <a:close/>
                    <a:moveTo>
                      <a:pt x="1286852" y="307740"/>
                    </a:moveTo>
                    <a:cubicBezTo>
                      <a:pt x="1296952" y="307740"/>
                      <a:pt x="1305140" y="315928"/>
                      <a:pt x="1305140" y="326028"/>
                    </a:cubicBezTo>
                    <a:cubicBezTo>
                      <a:pt x="1305140" y="336128"/>
                      <a:pt x="1296952" y="344316"/>
                      <a:pt x="1286852" y="344316"/>
                    </a:cubicBezTo>
                    <a:cubicBezTo>
                      <a:pt x="1276752" y="344316"/>
                      <a:pt x="1268564" y="336128"/>
                      <a:pt x="1268564" y="326028"/>
                    </a:cubicBezTo>
                    <a:cubicBezTo>
                      <a:pt x="1268564" y="315928"/>
                      <a:pt x="1276752" y="307740"/>
                      <a:pt x="1286852" y="307740"/>
                    </a:cubicBezTo>
                    <a:close/>
                    <a:moveTo>
                      <a:pt x="1229190" y="307740"/>
                    </a:moveTo>
                    <a:cubicBezTo>
                      <a:pt x="1239290" y="307740"/>
                      <a:pt x="1247478" y="315928"/>
                      <a:pt x="1247478" y="326028"/>
                    </a:cubicBezTo>
                    <a:cubicBezTo>
                      <a:pt x="1247478" y="336128"/>
                      <a:pt x="1239290" y="344316"/>
                      <a:pt x="1229190" y="344316"/>
                    </a:cubicBezTo>
                    <a:cubicBezTo>
                      <a:pt x="1219090" y="344316"/>
                      <a:pt x="1210902" y="336128"/>
                      <a:pt x="1210902" y="326028"/>
                    </a:cubicBezTo>
                    <a:cubicBezTo>
                      <a:pt x="1210902" y="315928"/>
                      <a:pt x="1219090" y="307740"/>
                      <a:pt x="1229190" y="307740"/>
                    </a:cubicBezTo>
                    <a:close/>
                    <a:moveTo>
                      <a:pt x="1171528" y="307740"/>
                    </a:moveTo>
                    <a:cubicBezTo>
                      <a:pt x="1181628" y="307740"/>
                      <a:pt x="1189816" y="315928"/>
                      <a:pt x="1189816" y="326028"/>
                    </a:cubicBezTo>
                    <a:cubicBezTo>
                      <a:pt x="1189816" y="336128"/>
                      <a:pt x="1181628" y="344316"/>
                      <a:pt x="1171528" y="344316"/>
                    </a:cubicBezTo>
                    <a:cubicBezTo>
                      <a:pt x="1161428" y="344316"/>
                      <a:pt x="1153240" y="336128"/>
                      <a:pt x="1153240" y="326028"/>
                    </a:cubicBezTo>
                    <a:cubicBezTo>
                      <a:pt x="1153240" y="315928"/>
                      <a:pt x="1161428" y="307740"/>
                      <a:pt x="1171528" y="307740"/>
                    </a:cubicBezTo>
                    <a:close/>
                    <a:moveTo>
                      <a:pt x="1113866" y="307740"/>
                    </a:moveTo>
                    <a:cubicBezTo>
                      <a:pt x="1123966" y="307740"/>
                      <a:pt x="1132154" y="315928"/>
                      <a:pt x="1132154" y="326028"/>
                    </a:cubicBezTo>
                    <a:cubicBezTo>
                      <a:pt x="1132154" y="336128"/>
                      <a:pt x="1123966" y="344316"/>
                      <a:pt x="1113866" y="344316"/>
                    </a:cubicBezTo>
                    <a:cubicBezTo>
                      <a:pt x="1103766" y="344316"/>
                      <a:pt x="1095578" y="336128"/>
                      <a:pt x="1095578" y="326028"/>
                    </a:cubicBezTo>
                    <a:cubicBezTo>
                      <a:pt x="1095578" y="315928"/>
                      <a:pt x="1103766" y="307740"/>
                      <a:pt x="1113866" y="307740"/>
                    </a:cubicBezTo>
                    <a:close/>
                    <a:moveTo>
                      <a:pt x="1056204" y="307740"/>
                    </a:moveTo>
                    <a:cubicBezTo>
                      <a:pt x="1066304" y="307740"/>
                      <a:pt x="1074492" y="315928"/>
                      <a:pt x="1074492" y="326028"/>
                    </a:cubicBezTo>
                    <a:cubicBezTo>
                      <a:pt x="1074492" y="336128"/>
                      <a:pt x="1066304" y="344316"/>
                      <a:pt x="1056204" y="344316"/>
                    </a:cubicBezTo>
                    <a:cubicBezTo>
                      <a:pt x="1046104" y="344316"/>
                      <a:pt x="1037916" y="336128"/>
                      <a:pt x="1037916" y="326028"/>
                    </a:cubicBezTo>
                    <a:cubicBezTo>
                      <a:pt x="1037916" y="315928"/>
                      <a:pt x="1046104" y="307740"/>
                      <a:pt x="1056204" y="307740"/>
                    </a:cubicBezTo>
                    <a:close/>
                    <a:moveTo>
                      <a:pt x="998542" y="307740"/>
                    </a:moveTo>
                    <a:cubicBezTo>
                      <a:pt x="1008642" y="307740"/>
                      <a:pt x="1016830" y="315928"/>
                      <a:pt x="1016830" y="326028"/>
                    </a:cubicBezTo>
                    <a:cubicBezTo>
                      <a:pt x="1016830" y="336128"/>
                      <a:pt x="1008642" y="344316"/>
                      <a:pt x="998542" y="344316"/>
                    </a:cubicBezTo>
                    <a:cubicBezTo>
                      <a:pt x="988442" y="344316"/>
                      <a:pt x="980254" y="336128"/>
                      <a:pt x="980254" y="326028"/>
                    </a:cubicBezTo>
                    <a:cubicBezTo>
                      <a:pt x="980254" y="315928"/>
                      <a:pt x="988442" y="307740"/>
                      <a:pt x="998542" y="307740"/>
                    </a:cubicBezTo>
                    <a:close/>
                    <a:moveTo>
                      <a:pt x="940880" y="307740"/>
                    </a:moveTo>
                    <a:cubicBezTo>
                      <a:pt x="950980" y="307740"/>
                      <a:pt x="959168" y="315928"/>
                      <a:pt x="959168" y="326028"/>
                    </a:cubicBezTo>
                    <a:cubicBezTo>
                      <a:pt x="959168" y="336128"/>
                      <a:pt x="950980" y="344316"/>
                      <a:pt x="940880" y="344316"/>
                    </a:cubicBezTo>
                    <a:cubicBezTo>
                      <a:pt x="930780" y="344316"/>
                      <a:pt x="922592" y="336128"/>
                      <a:pt x="922592" y="326028"/>
                    </a:cubicBezTo>
                    <a:cubicBezTo>
                      <a:pt x="922592" y="315928"/>
                      <a:pt x="930780" y="307740"/>
                      <a:pt x="940880" y="307740"/>
                    </a:cubicBezTo>
                    <a:close/>
                    <a:moveTo>
                      <a:pt x="883218" y="307740"/>
                    </a:moveTo>
                    <a:cubicBezTo>
                      <a:pt x="893318" y="307740"/>
                      <a:pt x="901506" y="315928"/>
                      <a:pt x="901506" y="326028"/>
                    </a:cubicBezTo>
                    <a:cubicBezTo>
                      <a:pt x="901506" y="336128"/>
                      <a:pt x="893318" y="344316"/>
                      <a:pt x="883218" y="344316"/>
                    </a:cubicBezTo>
                    <a:cubicBezTo>
                      <a:pt x="873118" y="344316"/>
                      <a:pt x="864930" y="336128"/>
                      <a:pt x="864930" y="326028"/>
                    </a:cubicBezTo>
                    <a:cubicBezTo>
                      <a:pt x="864930" y="315928"/>
                      <a:pt x="873118" y="307740"/>
                      <a:pt x="883218" y="307740"/>
                    </a:cubicBezTo>
                    <a:close/>
                    <a:moveTo>
                      <a:pt x="825556" y="307740"/>
                    </a:moveTo>
                    <a:cubicBezTo>
                      <a:pt x="835656" y="307740"/>
                      <a:pt x="843844" y="315928"/>
                      <a:pt x="843844" y="326028"/>
                    </a:cubicBezTo>
                    <a:cubicBezTo>
                      <a:pt x="843844" y="336128"/>
                      <a:pt x="835656" y="344316"/>
                      <a:pt x="825556" y="344316"/>
                    </a:cubicBezTo>
                    <a:cubicBezTo>
                      <a:pt x="815456" y="344316"/>
                      <a:pt x="807268" y="336128"/>
                      <a:pt x="807268" y="326028"/>
                    </a:cubicBezTo>
                    <a:cubicBezTo>
                      <a:pt x="807268" y="315928"/>
                      <a:pt x="815456" y="307740"/>
                      <a:pt x="825556" y="307740"/>
                    </a:cubicBezTo>
                    <a:close/>
                    <a:moveTo>
                      <a:pt x="767894" y="307740"/>
                    </a:moveTo>
                    <a:cubicBezTo>
                      <a:pt x="777994" y="307740"/>
                      <a:pt x="786182" y="315928"/>
                      <a:pt x="786182" y="326028"/>
                    </a:cubicBezTo>
                    <a:cubicBezTo>
                      <a:pt x="786182" y="336128"/>
                      <a:pt x="777994" y="344316"/>
                      <a:pt x="767894" y="344316"/>
                    </a:cubicBezTo>
                    <a:cubicBezTo>
                      <a:pt x="757794" y="344316"/>
                      <a:pt x="749606" y="336128"/>
                      <a:pt x="749606" y="326028"/>
                    </a:cubicBezTo>
                    <a:cubicBezTo>
                      <a:pt x="749606" y="315928"/>
                      <a:pt x="757794" y="307740"/>
                      <a:pt x="767894" y="307740"/>
                    </a:cubicBezTo>
                    <a:close/>
                    <a:moveTo>
                      <a:pt x="710232" y="307740"/>
                    </a:moveTo>
                    <a:cubicBezTo>
                      <a:pt x="720332" y="307740"/>
                      <a:pt x="728520" y="315928"/>
                      <a:pt x="728520" y="326028"/>
                    </a:cubicBezTo>
                    <a:cubicBezTo>
                      <a:pt x="728520" y="336128"/>
                      <a:pt x="720332" y="344316"/>
                      <a:pt x="710232" y="344316"/>
                    </a:cubicBezTo>
                    <a:cubicBezTo>
                      <a:pt x="700132" y="344316"/>
                      <a:pt x="691944" y="336128"/>
                      <a:pt x="691944" y="326028"/>
                    </a:cubicBezTo>
                    <a:cubicBezTo>
                      <a:pt x="691944" y="315928"/>
                      <a:pt x="700132" y="307740"/>
                      <a:pt x="710232" y="307740"/>
                    </a:cubicBezTo>
                    <a:close/>
                    <a:moveTo>
                      <a:pt x="652570" y="307740"/>
                    </a:moveTo>
                    <a:cubicBezTo>
                      <a:pt x="662670" y="307740"/>
                      <a:pt x="670858" y="315928"/>
                      <a:pt x="670858" y="326028"/>
                    </a:cubicBezTo>
                    <a:cubicBezTo>
                      <a:pt x="670858" y="336128"/>
                      <a:pt x="662670" y="344316"/>
                      <a:pt x="652570" y="344316"/>
                    </a:cubicBezTo>
                    <a:cubicBezTo>
                      <a:pt x="642470" y="344316"/>
                      <a:pt x="634282" y="336128"/>
                      <a:pt x="634282" y="326028"/>
                    </a:cubicBezTo>
                    <a:cubicBezTo>
                      <a:pt x="634282" y="315928"/>
                      <a:pt x="642470" y="307740"/>
                      <a:pt x="652570" y="307740"/>
                    </a:cubicBezTo>
                    <a:close/>
                    <a:moveTo>
                      <a:pt x="594908" y="307740"/>
                    </a:moveTo>
                    <a:cubicBezTo>
                      <a:pt x="605008" y="307740"/>
                      <a:pt x="613196" y="315928"/>
                      <a:pt x="613196" y="326028"/>
                    </a:cubicBezTo>
                    <a:cubicBezTo>
                      <a:pt x="613196" y="336128"/>
                      <a:pt x="605008" y="344316"/>
                      <a:pt x="594908" y="344316"/>
                    </a:cubicBezTo>
                    <a:cubicBezTo>
                      <a:pt x="584808" y="344316"/>
                      <a:pt x="576620" y="336128"/>
                      <a:pt x="576620" y="326028"/>
                    </a:cubicBezTo>
                    <a:cubicBezTo>
                      <a:pt x="576620" y="315928"/>
                      <a:pt x="584808" y="307740"/>
                      <a:pt x="594908" y="307740"/>
                    </a:cubicBezTo>
                    <a:close/>
                    <a:moveTo>
                      <a:pt x="537246" y="307740"/>
                    </a:moveTo>
                    <a:cubicBezTo>
                      <a:pt x="547346" y="307740"/>
                      <a:pt x="555534" y="315928"/>
                      <a:pt x="555534" y="326028"/>
                    </a:cubicBezTo>
                    <a:cubicBezTo>
                      <a:pt x="555534" y="336128"/>
                      <a:pt x="547346" y="344316"/>
                      <a:pt x="537246" y="344316"/>
                    </a:cubicBezTo>
                    <a:cubicBezTo>
                      <a:pt x="527146" y="344316"/>
                      <a:pt x="518958" y="336128"/>
                      <a:pt x="518958" y="326028"/>
                    </a:cubicBezTo>
                    <a:cubicBezTo>
                      <a:pt x="518958" y="315928"/>
                      <a:pt x="527146" y="307740"/>
                      <a:pt x="537246" y="307740"/>
                    </a:cubicBezTo>
                    <a:close/>
                    <a:moveTo>
                      <a:pt x="479584" y="307740"/>
                    </a:moveTo>
                    <a:cubicBezTo>
                      <a:pt x="489684" y="307740"/>
                      <a:pt x="497872" y="315928"/>
                      <a:pt x="497872" y="326028"/>
                    </a:cubicBezTo>
                    <a:cubicBezTo>
                      <a:pt x="497872" y="336128"/>
                      <a:pt x="489684" y="344316"/>
                      <a:pt x="479584" y="344316"/>
                    </a:cubicBezTo>
                    <a:cubicBezTo>
                      <a:pt x="469484" y="344316"/>
                      <a:pt x="461296" y="336128"/>
                      <a:pt x="461296" y="326028"/>
                    </a:cubicBezTo>
                    <a:cubicBezTo>
                      <a:pt x="461296" y="315928"/>
                      <a:pt x="469484" y="307740"/>
                      <a:pt x="479584" y="307740"/>
                    </a:cubicBezTo>
                    <a:close/>
                    <a:moveTo>
                      <a:pt x="421922" y="307740"/>
                    </a:moveTo>
                    <a:cubicBezTo>
                      <a:pt x="432022" y="307740"/>
                      <a:pt x="440210" y="315928"/>
                      <a:pt x="440210" y="326028"/>
                    </a:cubicBezTo>
                    <a:cubicBezTo>
                      <a:pt x="440210" y="336128"/>
                      <a:pt x="432022" y="344316"/>
                      <a:pt x="421922" y="344316"/>
                    </a:cubicBezTo>
                    <a:cubicBezTo>
                      <a:pt x="411822" y="344316"/>
                      <a:pt x="403634" y="336128"/>
                      <a:pt x="403634" y="326028"/>
                    </a:cubicBezTo>
                    <a:cubicBezTo>
                      <a:pt x="403634" y="315928"/>
                      <a:pt x="411822" y="307740"/>
                      <a:pt x="421922" y="307740"/>
                    </a:cubicBezTo>
                    <a:close/>
                    <a:moveTo>
                      <a:pt x="364260" y="307740"/>
                    </a:moveTo>
                    <a:cubicBezTo>
                      <a:pt x="374360" y="307740"/>
                      <a:pt x="382548" y="315928"/>
                      <a:pt x="382548" y="326028"/>
                    </a:cubicBezTo>
                    <a:cubicBezTo>
                      <a:pt x="382548" y="336128"/>
                      <a:pt x="374360" y="344316"/>
                      <a:pt x="364260" y="344316"/>
                    </a:cubicBezTo>
                    <a:cubicBezTo>
                      <a:pt x="354160" y="344316"/>
                      <a:pt x="345972" y="336128"/>
                      <a:pt x="345972" y="326028"/>
                    </a:cubicBezTo>
                    <a:cubicBezTo>
                      <a:pt x="345972" y="315928"/>
                      <a:pt x="354160" y="307740"/>
                      <a:pt x="364260" y="307740"/>
                    </a:cubicBezTo>
                    <a:close/>
                    <a:moveTo>
                      <a:pt x="306598" y="307740"/>
                    </a:moveTo>
                    <a:cubicBezTo>
                      <a:pt x="316698" y="307740"/>
                      <a:pt x="324886" y="315928"/>
                      <a:pt x="324886" y="326028"/>
                    </a:cubicBezTo>
                    <a:cubicBezTo>
                      <a:pt x="324886" y="336128"/>
                      <a:pt x="316698" y="344316"/>
                      <a:pt x="306598" y="344316"/>
                    </a:cubicBezTo>
                    <a:cubicBezTo>
                      <a:pt x="296498" y="344316"/>
                      <a:pt x="288310" y="336128"/>
                      <a:pt x="288310" y="326028"/>
                    </a:cubicBezTo>
                    <a:cubicBezTo>
                      <a:pt x="288310" y="315928"/>
                      <a:pt x="296498" y="307740"/>
                      <a:pt x="306598" y="307740"/>
                    </a:cubicBezTo>
                    <a:close/>
                    <a:moveTo>
                      <a:pt x="248936" y="307740"/>
                    </a:moveTo>
                    <a:cubicBezTo>
                      <a:pt x="259036" y="307740"/>
                      <a:pt x="267224" y="315928"/>
                      <a:pt x="267224" y="326028"/>
                    </a:cubicBezTo>
                    <a:cubicBezTo>
                      <a:pt x="267224" y="336128"/>
                      <a:pt x="259036" y="344316"/>
                      <a:pt x="248936" y="344316"/>
                    </a:cubicBezTo>
                    <a:cubicBezTo>
                      <a:pt x="238836" y="344316"/>
                      <a:pt x="230648" y="336128"/>
                      <a:pt x="230648" y="326028"/>
                    </a:cubicBezTo>
                    <a:cubicBezTo>
                      <a:pt x="230648" y="315928"/>
                      <a:pt x="238836" y="307740"/>
                      <a:pt x="248936" y="307740"/>
                    </a:cubicBezTo>
                    <a:close/>
                    <a:moveTo>
                      <a:pt x="191274" y="307740"/>
                    </a:moveTo>
                    <a:cubicBezTo>
                      <a:pt x="201374" y="307740"/>
                      <a:pt x="209562" y="315928"/>
                      <a:pt x="209562" y="326028"/>
                    </a:cubicBezTo>
                    <a:cubicBezTo>
                      <a:pt x="209562" y="336128"/>
                      <a:pt x="201374" y="344316"/>
                      <a:pt x="191274" y="344316"/>
                    </a:cubicBezTo>
                    <a:cubicBezTo>
                      <a:pt x="181174" y="344316"/>
                      <a:pt x="172986" y="336128"/>
                      <a:pt x="172986" y="326028"/>
                    </a:cubicBezTo>
                    <a:cubicBezTo>
                      <a:pt x="172986" y="315928"/>
                      <a:pt x="181174" y="307740"/>
                      <a:pt x="191274" y="307740"/>
                    </a:cubicBezTo>
                    <a:close/>
                    <a:moveTo>
                      <a:pt x="133612" y="307740"/>
                    </a:moveTo>
                    <a:cubicBezTo>
                      <a:pt x="143712" y="307740"/>
                      <a:pt x="151900" y="315928"/>
                      <a:pt x="151900" y="326028"/>
                    </a:cubicBezTo>
                    <a:cubicBezTo>
                      <a:pt x="151900" y="336128"/>
                      <a:pt x="143712" y="344316"/>
                      <a:pt x="133612" y="344316"/>
                    </a:cubicBezTo>
                    <a:cubicBezTo>
                      <a:pt x="123512" y="344316"/>
                      <a:pt x="115324" y="336128"/>
                      <a:pt x="115324" y="326028"/>
                    </a:cubicBezTo>
                    <a:cubicBezTo>
                      <a:pt x="115324" y="315928"/>
                      <a:pt x="123512" y="307740"/>
                      <a:pt x="133612" y="307740"/>
                    </a:cubicBezTo>
                    <a:close/>
                    <a:moveTo>
                      <a:pt x="75950" y="307740"/>
                    </a:moveTo>
                    <a:cubicBezTo>
                      <a:pt x="86050" y="307740"/>
                      <a:pt x="94238" y="315928"/>
                      <a:pt x="94238" y="326028"/>
                    </a:cubicBezTo>
                    <a:cubicBezTo>
                      <a:pt x="94238" y="336128"/>
                      <a:pt x="86050" y="344316"/>
                      <a:pt x="75950" y="344316"/>
                    </a:cubicBezTo>
                    <a:cubicBezTo>
                      <a:pt x="65850" y="344316"/>
                      <a:pt x="57662" y="336128"/>
                      <a:pt x="57662" y="326028"/>
                    </a:cubicBezTo>
                    <a:cubicBezTo>
                      <a:pt x="57662" y="315928"/>
                      <a:pt x="65850" y="307740"/>
                      <a:pt x="75950" y="307740"/>
                    </a:cubicBezTo>
                    <a:close/>
                    <a:moveTo>
                      <a:pt x="18288" y="307740"/>
                    </a:moveTo>
                    <a:cubicBezTo>
                      <a:pt x="28388" y="307740"/>
                      <a:pt x="36576" y="315928"/>
                      <a:pt x="36576" y="326028"/>
                    </a:cubicBezTo>
                    <a:cubicBezTo>
                      <a:pt x="36576" y="336128"/>
                      <a:pt x="28388" y="344316"/>
                      <a:pt x="18288" y="344316"/>
                    </a:cubicBezTo>
                    <a:cubicBezTo>
                      <a:pt x="8188" y="344316"/>
                      <a:pt x="0" y="336128"/>
                      <a:pt x="0" y="326028"/>
                    </a:cubicBezTo>
                    <a:cubicBezTo>
                      <a:pt x="0" y="315928"/>
                      <a:pt x="8188" y="307740"/>
                      <a:pt x="18288" y="307740"/>
                    </a:cubicBezTo>
                    <a:close/>
                    <a:moveTo>
                      <a:pt x="1459848" y="256450"/>
                    </a:moveTo>
                    <a:cubicBezTo>
                      <a:pt x="1469948" y="256450"/>
                      <a:pt x="1478136" y="264638"/>
                      <a:pt x="1478136" y="274738"/>
                    </a:cubicBezTo>
                    <a:cubicBezTo>
                      <a:pt x="1478136" y="284838"/>
                      <a:pt x="1469948" y="293026"/>
                      <a:pt x="1459848" y="293026"/>
                    </a:cubicBezTo>
                    <a:cubicBezTo>
                      <a:pt x="1449748" y="293026"/>
                      <a:pt x="1441560" y="284838"/>
                      <a:pt x="1441560" y="274738"/>
                    </a:cubicBezTo>
                    <a:cubicBezTo>
                      <a:pt x="1441560" y="264638"/>
                      <a:pt x="1449748" y="256450"/>
                      <a:pt x="1459848" y="256450"/>
                    </a:cubicBezTo>
                    <a:close/>
                    <a:moveTo>
                      <a:pt x="1402176" y="256450"/>
                    </a:moveTo>
                    <a:cubicBezTo>
                      <a:pt x="1412276" y="256450"/>
                      <a:pt x="1420464" y="264638"/>
                      <a:pt x="1420464" y="274738"/>
                    </a:cubicBezTo>
                    <a:cubicBezTo>
                      <a:pt x="1420464" y="284838"/>
                      <a:pt x="1412276" y="293026"/>
                      <a:pt x="1402176" y="293026"/>
                    </a:cubicBezTo>
                    <a:cubicBezTo>
                      <a:pt x="1392076" y="293026"/>
                      <a:pt x="1383888" y="284838"/>
                      <a:pt x="1383888" y="274738"/>
                    </a:cubicBezTo>
                    <a:cubicBezTo>
                      <a:pt x="1383888" y="264638"/>
                      <a:pt x="1392076" y="256450"/>
                      <a:pt x="1402176" y="256450"/>
                    </a:cubicBezTo>
                    <a:close/>
                    <a:moveTo>
                      <a:pt x="1344514" y="256450"/>
                    </a:moveTo>
                    <a:cubicBezTo>
                      <a:pt x="1354614" y="256450"/>
                      <a:pt x="1362802" y="264638"/>
                      <a:pt x="1362802" y="274738"/>
                    </a:cubicBezTo>
                    <a:cubicBezTo>
                      <a:pt x="1362802" y="284838"/>
                      <a:pt x="1354614" y="293026"/>
                      <a:pt x="1344514" y="293026"/>
                    </a:cubicBezTo>
                    <a:cubicBezTo>
                      <a:pt x="1334414" y="293026"/>
                      <a:pt x="1326226" y="284838"/>
                      <a:pt x="1326226" y="274738"/>
                    </a:cubicBezTo>
                    <a:cubicBezTo>
                      <a:pt x="1326226" y="264638"/>
                      <a:pt x="1334414" y="256450"/>
                      <a:pt x="1344514" y="256450"/>
                    </a:cubicBezTo>
                    <a:close/>
                    <a:moveTo>
                      <a:pt x="1286852" y="256450"/>
                    </a:moveTo>
                    <a:cubicBezTo>
                      <a:pt x="1296952" y="256450"/>
                      <a:pt x="1305140" y="264638"/>
                      <a:pt x="1305140" y="274738"/>
                    </a:cubicBezTo>
                    <a:cubicBezTo>
                      <a:pt x="1305140" y="284838"/>
                      <a:pt x="1296952" y="293026"/>
                      <a:pt x="1286852" y="293026"/>
                    </a:cubicBezTo>
                    <a:cubicBezTo>
                      <a:pt x="1276752" y="293026"/>
                      <a:pt x="1268564" y="284838"/>
                      <a:pt x="1268564" y="274738"/>
                    </a:cubicBezTo>
                    <a:cubicBezTo>
                      <a:pt x="1268564" y="264638"/>
                      <a:pt x="1276752" y="256450"/>
                      <a:pt x="1286852" y="256450"/>
                    </a:cubicBezTo>
                    <a:close/>
                    <a:moveTo>
                      <a:pt x="1229190" y="256450"/>
                    </a:moveTo>
                    <a:cubicBezTo>
                      <a:pt x="1239290" y="256450"/>
                      <a:pt x="1247478" y="264638"/>
                      <a:pt x="1247478" y="274738"/>
                    </a:cubicBezTo>
                    <a:cubicBezTo>
                      <a:pt x="1247478" y="284838"/>
                      <a:pt x="1239290" y="293026"/>
                      <a:pt x="1229190" y="293026"/>
                    </a:cubicBezTo>
                    <a:cubicBezTo>
                      <a:pt x="1219090" y="293026"/>
                      <a:pt x="1210902" y="284838"/>
                      <a:pt x="1210902" y="274738"/>
                    </a:cubicBezTo>
                    <a:cubicBezTo>
                      <a:pt x="1210902" y="264638"/>
                      <a:pt x="1219090" y="256450"/>
                      <a:pt x="1229190" y="256450"/>
                    </a:cubicBezTo>
                    <a:close/>
                    <a:moveTo>
                      <a:pt x="1171528" y="256450"/>
                    </a:moveTo>
                    <a:cubicBezTo>
                      <a:pt x="1181628" y="256450"/>
                      <a:pt x="1189816" y="264638"/>
                      <a:pt x="1189816" y="274738"/>
                    </a:cubicBezTo>
                    <a:cubicBezTo>
                      <a:pt x="1189816" y="284838"/>
                      <a:pt x="1181628" y="293026"/>
                      <a:pt x="1171528" y="293026"/>
                    </a:cubicBezTo>
                    <a:cubicBezTo>
                      <a:pt x="1161428" y="293026"/>
                      <a:pt x="1153240" y="284838"/>
                      <a:pt x="1153240" y="274738"/>
                    </a:cubicBezTo>
                    <a:cubicBezTo>
                      <a:pt x="1153240" y="264638"/>
                      <a:pt x="1161428" y="256450"/>
                      <a:pt x="1171528" y="256450"/>
                    </a:cubicBezTo>
                    <a:close/>
                    <a:moveTo>
                      <a:pt x="1113866" y="256450"/>
                    </a:moveTo>
                    <a:cubicBezTo>
                      <a:pt x="1123966" y="256450"/>
                      <a:pt x="1132154" y="264638"/>
                      <a:pt x="1132154" y="274738"/>
                    </a:cubicBezTo>
                    <a:cubicBezTo>
                      <a:pt x="1132154" y="284838"/>
                      <a:pt x="1123966" y="293026"/>
                      <a:pt x="1113866" y="293026"/>
                    </a:cubicBezTo>
                    <a:cubicBezTo>
                      <a:pt x="1103766" y="293026"/>
                      <a:pt x="1095578" y="284838"/>
                      <a:pt x="1095578" y="274738"/>
                    </a:cubicBezTo>
                    <a:cubicBezTo>
                      <a:pt x="1095578" y="264638"/>
                      <a:pt x="1103766" y="256450"/>
                      <a:pt x="1113866" y="256450"/>
                    </a:cubicBezTo>
                    <a:close/>
                    <a:moveTo>
                      <a:pt x="1056204" y="256450"/>
                    </a:moveTo>
                    <a:cubicBezTo>
                      <a:pt x="1066304" y="256450"/>
                      <a:pt x="1074492" y="264638"/>
                      <a:pt x="1074492" y="274738"/>
                    </a:cubicBezTo>
                    <a:cubicBezTo>
                      <a:pt x="1074492" y="284838"/>
                      <a:pt x="1066304" y="293026"/>
                      <a:pt x="1056204" y="293026"/>
                    </a:cubicBezTo>
                    <a:cubicBezTo>
                      <a:pt x="1046104" y="293026"/>
                      <a:pt x="1037916" y="284838"/>
                      <a:pt x="1037916" y="274738"/>
                    </a:cubicBezTo>
                    <a:cubicBezTo>
                      <a:pt x="1037916" y="264638"/>
                      <a:pt x="1046104" y="256450"/>
                      <a:pt x="1056204" y="256450"/>
                    </a:cubicBezTo>
                    <a:close/>
                    <a:moveTo>
                      <a:pt x="998542" y="256450"/>
                    </a:moveTo>
                    <a:cubicBezTo>
                      <a:pt x="1008642" y="256450"/>
                      <a:pt x="1016830" y="264638"/>
                      <a:pt x="1016830" y="274738"/>
                    </a:cubicBezTo>
                    <a:cubicBezTo>
                      <a:pt x="1016830" y="284838"/>
                      <a:pt x="1008642" y="293026"/>
                      <a:pt x="998542" y="293026"/>
                    </a:cubicBezTo>
                    <a:cubicBezTo>
                      <a:pt x="988442" y="293026"/>
                      <a:pt x="980254" y="284838"/>
                      <a:pt x="980254" y="274738"/>
                    </a:cubicBezTo>
                    <a:cubicBezTo>
                      <a:pt x="980254" y="264638"/>
                      <a:pt x="988442" y="256450"/>
                      <a:pt x="998542" y="256450"/>
                    </a:cubicBezTo>
                    <a:close/>
                    <a:moveTo>
                      <a:pt x="940880" y="256450"/>
                    </a:moveTo>
                    <a:cubicBezTo>
                      <a:pt x="950980" y="256450"/>
                      <a:pt x="959168" y="264638"/>
                      <a:pt x="959168" y="274738"/>
                    </a:cubicBezTo>
                    <a:cubicBezTo>
                      <a:pt x="959168" y="284838"/>
                      <a:pt x="950980" y="293026"/>
                      <a:pt x="940880" y="293026"/>
                    </a:cubicBezTo>
                    <a:cubicBezTo>
                      <a:pt x="930780" y="293026"/>
                      <a:pt x="922592" y="284838"/>
                      <a:pt x="922592" y="274738"/>
                    </a:cubicBezTo>
                    <a:cubicBezTo>
                      <a:pt x="922592" y="264638"/>
                      <a:pt x="930780" y="256450"/>
                      <a:pt x="940880" y="256450"/>
                    </a:cubicBezTo>
                    <a:close/>
                    <a:moveTo>
                      <a:pt x="883218" y="256450"/>
                    </a:moveTo>
                    <a:cubicBezTo>
                      <a:pt x="893318" y="256450"/>
                      <a:pt x="901506" y="264638"/>
                      <a:pt x="901506" y="274738"/>
                    </a:cubicBezTo>
                    <a:cubicBezTo>
                      <a:pt x="901506" y="284838"/>
                      <a:pt x="893318" y="293026"/>
                      <a:pt x="883218" y="293026"/>
                    </a:cubicBezTo>
                    <a:cubicBezTo>
                      <a:pt x="873118" y="293026"/>
                      <a:pt x="864930" y="284838"/>
                      <a:pt x="864930" y="274738"/>
                    </a:cubicBezTo>
                    <a:cubicBezTo>
                      <a:pt x="864930" y="264638"/>
                      <a:pt x="873118" y="256450"/>
                      <a:pt x="883218" y="256450"/>
                    </a:cubicBezTo>
                    <a:close/>
                    <a:moveTo>
                      <a:pt x="825556" y="256450"/>
                    </a:moveTo>
                    <a:cubicBezTo>
                      <a:pt x="835656" y="256450"/>
                      <a:pt x="843844" y="264638"/>
                      <a:pt x="843844" y="274738"/>
                    </a:cubicBezTo>
                    <a:cubicBezTo>
                      <a:pt x="843844" y="284838"/>
                      <a:pt x="835656" y="293026"/>
                      <a:pt x="825556" y="293026"/>
                    </a:cubicBezTo>
                    <a:cubicBezTo>
                      <a:pt x="815456" y="293026"/>
                      <a:pt x="807268" y="284838"/>
                      <a:pt x="807268" y="274738"/>
                    </a:cubicBezTo>
                    <a:cubicBezTo>
                      <a:pt x="807268" y="264638"/>
                      <a:pt x="815456" y="256450"/>
                      <a:pt x="825556" y="256450"/>
                    </a:cubicBezTo>
                    <a:close/>
                    <a:moveTo>
                      <a:pt x="767894" y="256450"/>
                    </a:moveTo>
                    <a:cubicBezTo>
                      <a:pt x="777994" y="256450"/>
                      <a:pt x="786182" y="264638"/>
                      <a:pt x="786182" y="274738"/>
                    </a:cubicBezTo>
                    <a:cubicBezTo>
                      <a:pt x="786182" y="284838"/>
                      <a:pt x="777994" y="293026"/>
                      <a:pt x="767894" y="293026"/>
                    </a:cubicBezTo>
                    <a:cubicBezTo>
                      <a:pt x="757794" y="293026"/>
                      <a:pt x="749606" y="284838"/>
                      <a:pt x="749606" y="274738"/>
                    </a:cubicBezTo>
                    <a:cubicBezTo>
                      <a:pt x="749606" y="264638"/>
                      <a:pt x="757794" y="256450"/>
                      <a:pt x="767894" y="256450"/>
                    </a:cubicBezTo>
                    <a:close/>
                    <a:moveTo>
                      <a:pt x="710232" y="256450"/>
                    </a:moveTo>
                    <a:cubicBezTo>
                      <a:pt x="720332" y="256450"/>
                      <a:pt x="728520" y="264638"/>
                      <a:pt x="728520" y="274738"/>
                    </a:cubicBezTo>
                    <a:cubicBezTo>
                      <a:pt x="728520" y="284838"/>
                      <a:pt x="720332" y="293026"/>
                      <a:pt x="710232" y="293026"/>
                    </a:cubicBezTo>
                    <a:cubicBezTo>
                      <a:pt x="700132" y="293026"/>
                      <a:pt x="691944" y="284838"/>
                      <a:pt x="691944" y="274738"/>
                    </a:cubicBezTo>
                    <a:cubicBezTo>
                      <a:pt x="691944" y="264638"/>
                      <a:pt x="700132" y="256450"/>
                      <a:pt x="710232" y="256450"/>
                    </a:cubicBezTo>
                    <a:close/>
                    <a:moveTo>
                      <a:pt x="652570" y="256450"/>
                    </a:moveTo>
                    <a:cubicBezTo>
                      <a:pt x="662670" y="256450"/>
                      <a:pt x="670858" y="264638"/>
                      <a:pt x="670858" y="274738"/>
                    </a:cubicBezTo>
                    <a:cubicBezTo>
                      <a:pt x="670858" y="284838"/>
                      <a:pt x="662670" y="293026"/>
                      <a:pt x="652570" y="293026"/>
                    </a:cubicBezTo>
                    <a:cubicBezTo>
                      <a:pt x="642470" y="293026"/>
                      <a:pt x="634282" y="284838"/>
                      <a:pt x="634282" y="274738"/>
                    </a:cubicBezTo>
                    <a:cubicBezTo>
                      <a:pt x="634282" y="264638"/>
                      <a:pt x="642470" y="256450"/>
                      <a:pt x="652570" y="256450"/>
                    </a:cubicBezTo>
                    <a:close/>
                    <a:moveTo>
                      <a:pt x="594908" y="256450"/>
                    </a:moveTo>
                    <a:cubicBezTo>
                      <a:pt x="605008" y="256450"/>
                      <a:pt x="613196" y="264638"/>
                      <a:pt x="613196" y="274738"/>
                    </a:cubicBezTo>
                    <a:cubicBezTo>
                      <a:pt x="613196" y="284838"/>
                      <a:pt x="605008" y="293026"/>
                      <a:pt x="594908" y="293026"/>
                    </a:cubicBezTo>
                    <a:cubicBezTo>
                      <a:pt x="584808" y="293026"/>
                      <a:pt x="576620" y="284838"/>
                      <a:pt x="576620" y="274738"/>
                    </a:cubicBezTo>
                    <a:cubicBezTo>
                      <a:pt x="576620" y="264638"/>
                      <a:pt x="584808" y="256450"/>
                      <a:pt x="594908" y="256450"/>
                    </a:cubicBezTo>
                    <a:close/>
                    <a:moveTo>
                      <a:pt x="537246" y="256450"/>
                    </a:moveTo>
                    <a:cubicBezTo>
                      <a:pt x="547346" y="256450"/>
                      <a:pt x="555534" y="264638"/>
                      <a:pt x="555534" y="274738"/>
                    </a:cubicBezTo>
                    <a:cubicBezTo>
                      <a:pt x="555534" y="284838"/>
                      <a:pt x="547346" y="293026"/>
                      <a:pt x="537246" y="293026"/>
                    </a:cubicBezTo>
                    <a:cubicBezTo>
                      <a:pt x="527146" y="293026"/>
                      <a:pt x="518958" y="284838"/>
                      <a:pt x="518958" y="274738"/>
                    </a:cubicBezTo>
                    <a:cubicBezTo>
                      <a:pt x="518958" y="264638"/>
                      <a:pt x="527146" y="256450"/>
                      <a:pt x="537246" y="256450"/>
                    </a:cubicBezTo>
                    <a:close/>
                    <a:moveTo>
                      <a:pt x="479584" y="256450"/>
                    </a:moveTo>
                    <a:cubicBezTo>
                      <a:pt x="489684" y="256450"/>
                      <a:pt x="497872" y="264638"/>
                      <a:pt x="497872" y="274738"/>
                    </a:cubicBezTo>
                    <a:cubicBezTo>
                      <a:pt x="497872" y="284838"/>
                      <a:pt x="489684" y="293026"/>
                      <a:pt x="479584" y="293026"/>
                    </a:cubicBezTo>
                    <a:cubicBezTo>
                      <a:pt x="469484" y="293026"/>
                      <a:pt x="461296" y="284838"/>
                      <a:pt x="461296" y="274738"/>
                    </a:cubicBezTo>
                    <a:cubicBezTo>
                      <a:pt x="461296" y="264638"/>
                      <a:pt x="469484" y="256450"/>
                      <a:pt x="479584" y="256450"/>
                    </a:cubicBezTo>
                    <a:close/>
                    <a:moveTo>
                      <a:pt x="421922" y="256450"/>
                    </a:moveTo>
                    <a:cubicBezTo>
                      <a:pt x="432022" y="256450"/>
                      <a:pt x="440210" y="264638"/>
                      <a:pt x="440210" y="274738"/>
                    </a:cubicBezTo>
                    <a:cubicBezTo>
                      <a:pt x="440210" y="284838"/>
                      <a:pt x="432022" y="293026"/>
                      <a:pt x="421922" y="293026"/>
                    </a:cubicBezTo>
                    <a:cubicBezTo>
                      <a:pt x="411822" y="293026"/>
                      <a:pt x="403634" y="284838"/>
                      <a:pt x="403634" y="274738"/>
                    </a:cubicBezTo>
                    <a:cubicBezTo>
                      <a:pt x="403634" y="264638"/>
                      <a:pt x="411822" y="256450"/>
                      <a:pt x="421922" y="256450"/>
                    </a:cubicBezTo>
                    <a:close/>
                    <a:moveTo>
                      <a:pt x="364260" y="256450"/>
                    </a:moveTo>
                    <a:cubicBezTo>
                      <a:pt x="374360" y="256450"/>
                      <a:pt x="382548" y="264638"/>
                      <a:pt x="382548" y="274738"/>
                    </a:cubicBezTo>
                    <a:cubicBezTo>
                      <a:pt x="382548" y="284838"/>
                      <a:pt x="374360" y="293026"/>
                      <a:pt x="364260" y="293026"/>
                    </a:cubicBezTo>
                    <a:cubicBezTo>
                      <a:pt x="354160" y="293026"/>
                      <a:pt x="345972" y="284838"/>
                      <a:pt x="345972" y="274738"/>
                    </a:cubicBezTo>
                    <a:cubicBezTo>
                      <a:pt x="345972" y="264638"/>
                      <a:pt x="354160" y="256450"/>
                      <a:pt x="364260" y="256450"/>
                    </a:cubicBezTo>
                    <a:close/>
                    <a:moveTo>
                      <a:pt x="306598" y="256450"/>
                    </a:moveTo>
                    <a:cubicBezTo>
                      <a:pt x="316698" y="256450"/>
                      <a:pt x="324886" y="264638"/>
                      <a:pt x="324886" y="274738"/>
                    </a:cubicBezTo>
                    <a:cubicBezTo>
                      <a:pt x="324886" y="284838"/>
                      <a:pt x="316698" y="293026"/>
                      <a:pt x="306598" y="293026"/>
                    </a:cubicBezTo>
                    <a:cubicBezTo>
                      <a:pt x="296498" y="293026"/>
                      <a:pt x="288310" y="284838"/>
                      <a:pt x="288310" y="274738"/>
                    </a:cubicBezTo>
                    <a:cubicBezTo>
                      <a:pt x="288310" y="264638"/>
                      <a:pt x="296498" y="256450"/>
                      <a:pt x="306598" y="256450"/>
                    </a:cubicBezTo>
                    <a:close/>
                    <a:moveTo>
                      <a:pt x="248936" y="256450"/>
                    </a:moveTo>
                    <a:cubicBezTo>
                      <a:pt x="259036" y="256450"/>
                      <a:pt x="267224" y="264638"/>
                      <a:pt x="267224" y="274738"/>
                    </a:cubicBezTo>
                    <a:cubicBezTo>
                      <a:pt x="267224" y="284838"/>
                      <a:pt x="259036" y="293026"/>
                      <a:pt x="248936" y="293026"/>
                    </a:cubicBezTo>
                    <a:cubicBezTo>
                      <a:pt x="238836" y="293026"/>
                      <a:pt x="230648" y="284838"/>
                      <a:pt x="230648" y="274738"/>
                    </a:cubicBezTo>
                    <a:cubicBezTo>
                      <a:pt x="230648" y="264638"/>
                      <a:pt x="238836" y="256450"/>
                      <a:pt x="248936" y="256450"/>
                    </a:cubicBezTo>
                    <a:close/>
                    <a:moveTo>
                      <a:pt x="191274" y="256450"/>
                    </a:moveTo>
                    <a:cubicBezTo>
                      <a:pt x="201374" y="256450"/>
                      <a:pt x="209562" y="264638"/>
                      <a:pt x="209562" y="274738"/>
                    </a:cubicBezTo>
                    <a:cubicBezTo>
                      <a:pt x="209562" y="284838"/>
                      <a:pt x="201374" y="293026"/>
                      <a:pt x="191274" y="293026"/>
                    </a:cubicBezTo>
                    <a:cubicBezTo>
                      <a:pt x="181174" y="293026"/>
                      <a:pt x="172986" y="284838"/>
                      <a:pt x="172986" y="274738"/>
                    </a:cubicBezTo>
                    <a:cubicBezTo>
                      <a:pt x="172986" y="264638"/>
                      <a:pt x="181174" y="256450"/>
                      <a:pt x="191274" y="256450"/>
                    </a:cubicBezTo>
                    <a:close/>
                    <a:moveTo>
                      <a:pt x="133612" y="256450"/>
                    </a:moveTo>
                    <a:cubicBezTo>
                      <a:pt x="143712" y="256450"/>
                      <a:pt x="151900" y="264638"/>
                      <a:pt x="151900" y="274738"/>
                    </a:cubicBezTo>
                    <a:cubicBezTo>
                      <a:pt x="151900" y="284838"/>
                      <a:pt x="143712" y="293026"/>
                      <a:pt x="133612" y="293026"/>
                    </a:cubicBezTo>
                    <a:cubicBezTo>
                      <a:pt x="123512" y="293026"/>
                      <a:pt x="115324" y="284838"/>
                      <a:pt x="115324" y="274738"/>
                    </a:cubicBezTo>
                    <a:cubicBezTo>
                      <a:pt x="115324" y="264638"/>
                      <a:pt x="123512" y="256450"/>
                      <a:pt x="133612" y="256450"/>
                    </a:cubicBezTo>
                    <a:close/>
                    <a:moveTo>
                      <a:pt x="75950" y="256450"/>
                    </a:moveTo>
                    <a:cubicBezTo>
                      <a:pt x="86050" y="256450"/>
                      <a:pt x="94238" y="264638"/>
                      <a:pt x="94238" y="274738"/>
                    </a:cubicBezTo>
                    <a:cubicBezTo>
                      <a:pt x="94238" y="284838"/>
                      <a:pt x="86050" y="293026"/>
                      <a:pt x="75950" y="293026"/>
                    </a:cubicBezTo>
                    <a:cubicBezTo>
                      <a:pt x="65850" y="293026"/>
                      <a:pt x="57662" y="284838"/>
                      <a:pt x="57662" y="274738"/>
                    </a:cubicBezTo>
                    <a:cubicBezTo>
                      <a:pt x="57662" y="264638"/>
                      <a:pt x="65850" y="256450"/>
                      <a:pt x="75950" y="256450"/>
                    </a:cubicBezTo>
                    <a:close/>
                    <a:moveTo>
                      <a:pt x="18288" y="256450"/>
                    </a:moveTo>
                    <a:cubicBezTo>
                      <a:pt x="28388" y="256450"/>
                      <a:pt x="36576" y="264638"/>
                      <a:pt x="36576" y="274738"/>
                    </a:cubicBezTo>
                    <a:cubicBezTo>
                      <a:pt x="36576" y="284838"/>
                      <a:pt x="28388" y="293026"/>
                      <a:pt x="18288" y="293026"/>
                    </a:cubicBezTo>
                    <a:cubicBezTo>
                      <a:pt x="8188" y="293026"/>
                      <a:pt x="0" y="284838"/>
                      <a:pt x="0" y="274738"/>
                    </a:cubicBezTo>
                    <a:cubicBezTo>
                      <a:pt x="0" y="264638"/>
                      <a:pt x="8188" y="256450"/>
                      <a:pt x="18288" y="256450"/>
                    </a:cubicBezTo>
                    <a:close/>
                    <a:moveTo>
                      <a:pt x="1459848" y="205160"/>
                    </a:moveTo>
                    <a:cubicBezTo>
                      <a:pt x="1469948" y="205160"/>
                      <a:pt x="1478136" y="213348"/>
                      <a:pt x="1478136" y="223448"/>
                    </a:cubicBezTo>
                    <a:cubicBezTo>
                      <a:pt x="1478136" y="233548"/>
                      <a:pt x="1469948" y="241736"/>
                      <a:pt x="1459848" y="241736"/>
                    </a:cubicBezTo>
                    <a:cubicBezTo>
                      <a:pt x="1449748" y="241736"/>
                      <a:pt x="1441560" y="233548"/>
                      <a:pt x="1441560" y="223448"/>
                    </a:cubicBezTo>
                    <a:cubicBezTo>
                      <a:pt x="1441560" y="213348"/>
                      <a:pt x="1449748" y="205160"/>
                      <a:pt x="1459848" y="205160"/>
                    </a:cubicBezTo>
                    <a:close/>
                    <a:moveTo>
                      <a:pt x="1402176" y="205160"/>
                    </a:moveTo>
                    <a:cubicBezTo>
                      <a:pt x="1412276" y="205160"/>
                      <a:pt x="1420464" y="213348"/>
                      <a:pt x="1420464" y="223448"/>
                    </a:cubicBezTo>
                    <a:cubicBezTo>
                      <a:pt x="1420464" y="233548"/>
                      <a:pt x="1412276" y="241736"/>
                      <a:pt x="1402176" y="241736"/>
                    </a:cubicBezTo>
                    <a:cubicBezTo>
                      <a:pt x="1392076" y="241736"/>
                      <a:pt x="1383888" y="233548"/>
                      <a:pt x="1383888" y="223448"/>
                    </a:cubicBezTo>
                    <a:cubicBezTo>
                      <a:pt x="1383888" y="213348"/>
                      <a:pt x="1392076" y="205160"/>
                      <a:pt x="1402176" y="205160"/>
                    </a:cubicBezTo>
                    <a:close/>
                    <a:moveTo>
                      <a:pt x="1344514" y="205160"/>
                    </a:moveTo>
                    <a:cubicBezTo>
                      <a:pt x="1354614" y="205160"/>
                      <a:pt x="1362802" y="213348"/>
                      <a:pt x="1362802" y="223448"/>
                    </a:cubicBezTo>
                    <a:cubicBezTo>
                      <a:pt x="1362802" y="233548"/>
                      <a:pt x="1354614" y="241736"/>
                      <a:pt x="1344514" y="241736"/>
                    </a:cubicBezTo>
                    <a:cubicBezTo>
                      <a:pt x="1334414" y="241736"/>
                      <a:pt x="1326226" y="233548"/>
                      <a:pt x="1326226" y="223448"/>
                    </a:cubicBezTo>
                    <a:cubicBezTo>
                      <a:pt x="1326226" y="213348"/>
                      <a:pt x="1334414" y="205160"/>
                      <a:pt x="1344514" y="205160"/>
                    </a:cubicBezTo>
                    <a:close/>
                    <a:moveTo>
                      <a:pt x="1286852" y="205160"/>
                    </a:moveTo>
                    <a:cubicBezTo>
                      <a:pt x="1296952" y="205160"/>
                      <a:pt x="1305140" y="213348"/>
                      <a:pt x="1305140" y="223448"/>
                    </a:cubicBezTo>
                    <a:cubicBezTo>
                      <a:pt x="1305140" y="233548"/>
                      <a:pt x="1296952" y="241736"/>
                      <a:pt x="1286852" y="241736"/>
                    </a:cubicBezTo>
                    <a:cubicBezTo>
                      <a:pt x="1276752" y="241736"/>
                      <a:pt x="1268564" y="233548"/>
                      <a:pt x="1268564" y="223448"/>
                    </a:cubicBezTo>
                    <a:cubicBezTo>
                      <a:pt x="1268564" y="213348"/>
                      <a:pt x="1276752" y="205160"/>
                      <a:pt x="1286852" y="205160"/>
                    </a:cubicBezTo>
                    <a:close/>
                    <a:moveTo>
                      <a:pt x="1229190" y="205160"/>
                    </a:moveTo>
                    <a:cubicBezTo>
                      <a:pt x="1239290" y="205160"/>
                      <a:pt x="1247478" y="213348"/>
                      <a:pt x="1247478" y="223448"/>
                    </a:cubicBezTo>
                    <a:cubicBezTo>
                      <a:pt x="1247478" y="233548"/>
                      <a:pt x="1239290" y="241736"/>
                      <a:pt x="1229190" y="241736"/>
                    </a:cubicBezTo>
                    <a:cubicBezTo>
                      <a:pt x="1219090" y="241736"/>
                      <a:pt x="1210902" y="233548"/>
                      <a:pt x="1210902" y="223448"/>
                    </a:cubicBezTo>
                    <a:cubicBezTo>
                      <a:pt x="1210902" y="213348"/>
                      <a:pt x="1219090" y="205160"/>
                      <a:pt x="1229190" y="205160"/>
                    </a:cubicBezTo>
                    <a:close/>
                    <a:moveTo>
                      <a:pt x="1171528" y="205160"/>
                    </a:moveTo>
                    <a:cubicBezTo>
                      <a:pt x="1181628" y="205160"/>
                      <a:pt x="1189816" y="213348"/>
                      <a:pt x="1189816" y="223448"/>
                    </a:cubicBezTo>
                    <a:cubicBezTo>
                      <a:pt x="1189816" y="233548"/>
                      <a:pt x="1181628" y="241736"/>
                      <a:pt x="1171528" y="241736"/>
                    </a:cubicBezTo>
                    <a:cubicBezTo>
                      <a:pt x="1161428" y="241736"/>
                      <a:pt x="1153240" y="233548"/>
                      <a:pt x="1153240" y="223448"/>
                    </a:cubicBezTo>
                    <a:cubicBezTo>
                      <a:pt x="1153240" y="213348"/>
                      <a:pt x="1161428" y="205160"/>
                      <a:pt x="1171528" y="205160"/>
                    </a:cubicBezTo>
                    <a:close/>
                    <a:moveTo>
                      <a:pt x="1113866" y="205160"/>
                    </a:moveTo>
                    <a:cubicBezTo>
                      <a:pt x="1123966" y="205160"/>
                      <a:pt x="1132154" y="213348"/>
                      <a:pt x="1132154" y="223448"/>
                    </a:cubicBezTo>
                    <a:cubicBezTo>
                      <a:pt x="1132154" y="233548"/>
                      <a:pt x="1123966" y="241736"/>
                      <a:pt x="1113866" y="241736"/>
                    </a:cubicBezTo>
                    <a:cubicBezTo>
                      <a:pt x="1103766" y="241736"/>
                      <a:pt x="1095578" y="233548"/>
                      <a:pt x="1095578" y="223448"/>
                    </a:cubicBezTo>
                    <a:cubicBezTo>
                      <a:pt x="1095578" y="213348"/>
                      <a:pt x="1103766" y="205160"/>
                      <a:pt x="1113866" y="205160"/>
                    </a:cubicBezTo>
                    <a:close/>
                    <a:moveTo>
                      <a:pt x="1056204" y="205160"/>
                    </a:moveTo>
                    <a:cubicBezTo>
                      <a:pt x="1066304" y="205160"/>
                      <a:pt x="1074492" y="213348"/>
                      <a:pt x="1074492" y="223448"/>
                    </a:cubicBezTo>
                    <a:cubicBezTo>
                      <a:pt x="1074492" y="233548"/>
                      <a:pt x="1066304" y="241736"/>
                      <a:pt x="1056204" y="241736"/>
                    </a:cubicBezTo>
                    <a:cubicBezTo>
                      <a:pt x="1046104" y="241736"/>
                      <a:pt x="1037916" y="233548"/>
                      <a:pt x="1037916" y="223448"/>
                    </a:cubicBezTo>
                    <a:cubicBezTo>
                      <a:pt x="1037916" y="213348"/>
                      <a:pt x="1046104" y="205160"/>
                      <a:pt x="1056204" y="205160"/>
                    </a:cubicBezTo>
                    <a:close/>
                    <a:moveTo>
                      <a:pt x="998542" y="205160"/>
                    </a:moveTo>
                    <a:cubicBezTo>
                      <a:pt x="1008642" y="205160"/>
                      <a:pt x="1016830" y="213348"/>
                      <a:pt x="1016830" y="223448"/>
                    </a:cubicBezTo>
                    <a:cubicBezTo>
                      <a:pt x="1016830" y="233548"/>
                      <a:pt x="1008642" y="241736"/>
                      <a:pt x="998542" y="241736"/>
                    </a:cubicBezTo>
                    <a:cubicBezTo>
                      <a:pt x="988442" y="241736"/>
                      <a:pt x="980254" y="233548"/>
                      <a:pt x="980254" y="223448"/>
                    </a:cubicBezTo>
                    <a:cubicBezTo>
                      <a:pt x="980254" y="213348"/>
                      <a:pt x="988442" y="205160"/>
                      <a:pt x="998542" y="205160"/>
                    </a:cubicBezTo>
                    <a:close/>
                    <a:moveTo>
                      <a:pt x="940880" y="205160"/>
                    </a:moveTo>
                    <a:cubicBezTo>
                      <a:pt x="950980" y="205160"/>
                      <a:pt x="959168" y="213348"/>
                      <a:pt x="959168" y="223448"/>
                    </a:cubicBezTo>
                    <a:cubicBezTo>
                      <a:pt x="959168" y="233548"/>
                      <a:pt x="950980" y="241736"/>
                      <a:pt x="940880" y="241736"/>
                    </a:cubicBezTo>
                    <a:cubicBezTo>
                      <a:pt x="930780" y="241736"/>
                      <a:pt x="922592" y="233548"/>
                      <a:pt x="922592" y="223448"/>
                    </a:cubicBezTo>
                    <a:cubicBezTo>
                      <a:pt x="922592" y="213348"/>
                      <a:pt x="930780" y="205160"/>
                      <a:pt x="940880" y="205160"/>
                    </a:cubicBezTo>
                    <a:close/>
                    <a:moveTo>
                      <a:pt x="883218" y="205160"/>
                    </a:moveTo>
                    <a:cubicBezTo>
                      <a:pt x="893318" y="205160"/>
                      <a:pt x="901506" y="213348"/>
                      <a:pt x="901506" y="223448"/>
                    </a:cubicBezTo>
                    <a:cubicBezTo>
                      <a:pt x="901506" y="233548"/>
                      <a:pt x="893318" y="241736"/>
                      <a:pt x="883218" y="241736"/>
                    </a:cubicBezTo>
                    <a:cubicBezTo>
                      <a:pt x="873118" y="241736"/>
                      <a:pt x="864930" y="233548"/>
                      <a:pt x="864930" y="223448"/>
                    </a:cubicBezTo>
                    <a:cubicBezTo>
                      <a:pt x="864930" y="213348"/>
                      <a:pt x="873118" y="205160"/>
                      <a:pt x="883218" y="205160"/>
                    </a:cubicBezTo>
                    <a:close/>
                    <a:moveTo>
                      <a:pt x="825556" y="205160"/>
                    </a:moveTo>
                    <a:cubicBezTo>
                      <a:pt x="835656" y="205160"/>
                      <a:pt x="843844" y="213348"/>
                      <a:pt x="843844" y="223448"/>
                    </a:cubicBezTo>
                    <a:cubicBezTo>
                      <a:pt x="843844" y="233548"/>
                      <a:pt x="835656" y="241736"/>
                      <a:pt x="825556" y="241736"/>
                    </a:cubicBezTo>
                    <a:cubicBezTo>
                      <a:pt x="815456" y="241736"/>
                      <a:pt x="807268" y="233548"/>
                      <a:pt x="807268" y="223448"/>
                    </a:cubicBezTo>
                    <a:cubicBezTo>
                      <a:pt x="807268" y="213348"/>
                      <a:pt x="815456" y="205160"/>
                      <a:pt x="825556" y="205160"/>
                    </a:cubicBezTo>
                    <a:close/>
                    <a:moveTo>
                      <a:pt x="767894" y="205160"/>
                    </a:moveTo>
                    <a:cubicBezTo>
                      <a:pt x="777994" y="205160"/>
                      <a:pt x="786182" y="213348"/>
                      <a:pt x="786182" y="223448"/>
                    </a:cubicBezTo>
                    <a:cubicBezTo>
                      <a:pt x="786182" y="233548"/>
                      <a:pt x="777994" y="241736"/>
                      <a:pt x="767894" y="241736"/>
                    </a:cubicBezTo>
                    <a:cubicBezTo>
                      <a:pt x="757794" y="241736"/>
                      <a:pt x="749606" y="233548"/>
                      <a:pt x="749606" y="223448"/>
                    </a:cubicBezTo>
                    <a:cubicBezTo>
                      <a:pt x="749606" y="213348"/>
                      <a:pt x="757794" y="205160"/>
                      <a:pt x="767894" y="205160"/>
                    </a:cubicBezTo>
                    <a:close/>
                    <a:moveTo>
                      <a:pt x="710232" y="205160"/>
                    </a:moveTo>
                    <a:cubicBezTo>
                      <a:pt x="720332" y="205160"/>
                      <a:pt x="728520" y="213348"/>
                      <a:pt x="728520" y="223448"/>
                    </a:cubicBezTo>
                    <a:cubicBezTo>
                      <a:pt x="728520" y="233548"/>
                      <a:pt x="720332" y="241736"/>
                      <a:pt x="710232" y="241736"/>
                    </a:cubicBezTo>
                    <a:cubicBezTo>
                      <a:pt x="700132" y="241736"/>
                      <a:pt x="691944" y="233548"/>
                      <a:pt x="691944" y="223448"/>
                    </a:cubicBezTo>
                    <a:cubicBezTo>
                      <a:pt x="691944" y="213348"/>
                      <a:pt x="700132" y="205160"/>
                      <a:pt x="710232" y="205160"/>
                    </a:cubicBezTo>
                    <a:close/>
                    <a:moveTo>
                      <a:pt x="652570" y="205160"/>
                    </a:moveTo>
                    <a:cubicBezTo>
                      <a:pt x="662670" y="205160"/>
                      <a:pt x="670858" y="213348"/>
                      <a:pt x="670858" y="223448"/>
                    </a:cubicBezTo>
                    <a:cubicBezTo>
                      <a:pt x="670858" y="233548"/>
                      <a:pt x="662670" y="241736"/>
                      <a:pt x="652570" y="241736"/>
                    </a:cubicBezTo>
                    <a:cubicBezTo>
                      <a:pt x="642470" y="241736"/>
                      <a:pt x="634282" y="233548"/>
                      <a:pt x="634282" y="223448"/>
                    </a:cubicBezTo>
                    <a:cubicBezTo>
                      <a:pt x="634282" y="213348"/>
                      <a:pt x="642470" y="205160"/>
                      <a:pt x="652570" y="205160"/>
                    </a:cubicBezTo>
                    <a:close/>
                    <a:moveTo>
                      <a:pt x="594908" y="205160"/>
                    </a:moveTo>
                    <a:cubicBezTo>
                      <a:pt x="605008" y="205160"/>
                      <a:pt x="613196" y="213348"/>
                      <a:pt x="613196" y="223448"/>
                    </a:cubicBezTo>
                    <a:cubicBezTo>
                      <a:pt x="613196" y="233548"/>
                      <a:pt x="605008" y="241736"/>
                      <a:pt x="594908" y="241736"/>
                    </a:cubicBezTo>
                    <a:cubicBezTo>
                      <a:pt x="584808" y="241736"/>
                      <a:pt x="576620" y="233548"/>
                      <a:pt x="576620" y="223448"/>
                    </a:cubicBezTo>
                    <a:cubicBezTo>
                      <a:pt x="576620" y="213348"/>
                      <a:pt x="584808" y="205160"/>
                      <a:pt x="594908" y="205160"/>
                    </a:cubicBezTo>
                    <a:close/>
                    <a:moveTo>
                      <a:pt x="537246" y="205160"/>
                    </a:moveTo>
                    <a:cubicBezTo>
                      <a:pt x="547346" y="205160"/>
                      <a:pt x="555534" y="213348"/>
                      <a:pt x="555534" y="223448"/>
                    </a:cubicBezTo>
                    <a:cubicBezTo>
                      <a:pt x="555534" y="233548"/>
                      <a:pt x="547346" y="241736"/>
                      <a:pt x="537246" y="241736"/>
                    </a:cubicBezTo>
                    <a:cubicBezTo>
                      <a:pt x="527146" y="241736"/>
                      <a:pt x="518958" y="233548"/>
                      <a:pt x="518958" y="223448"/>
                    </a:cubicBezTo>
                    <a:cubicBezTo>
                      <a:pt x="518958" y="213348"/>
                      <a:pt x="527146" y="205160"/>
                      <a:pt x="537246" y="205160"/>
                    </a:cubicBezTo>
                    <a:close/>
                    <a:moveTo>
                      <a:pt x="479584" y="205160"/>
                    </a:moveTo>
                    <a:cubicBezTo>
                      <a:pt x="489684" y="205160"/>
                      <a:pt x="497872" y="213348"/>
                      <a:pt x="497872" y="223448"/>
                    </a:cubicBezTo>
                    <a:cubicBezTo>
                      <a:pt x="497872" y="233548"/>
                      <a:pt x="489684" y="241736"/>
                      <a:pt x="479584" y="241736"/>
                    </a:cubicBezTo>
                    <a:cubicBezTo>
                      <a:pt x="469484" y="241736"/>
                      <a:pt x="461296" y="233548"/>
                      <a:pt x="461296" y="223448"/>
                    </a:cubicBezTo>
                    <a:cubicBezTo>
                      <a:pt x="461296" y="213348"/>
                      <a:pt x="469484" y="205160"/>
                      <a:pt x="479584" y="205160"/>
                    </a:cubicBezTo>
                    <a:close/>
                    <a:moveTo>
                      <a:pt x="421922" y="205160"/>
                    </a:moveTo>
                    <a:cubicBezTo>
                      <a:pt x="432022" y="205160"/>
                      <a:pt x="440210" y="213348"/>
                      <a:pt x="440210" y="223448"/>
                    </a:cubicBezTo>
                    <a:cubicBezTo>
                      <a:pt x="440210" y="233548"/>
                      <a:pt x="432022" y="241736"/>
                      <a:pt x="421922" y="241736"/>
                    </a:cubicBezTo>
                    <a:cubicBezTo>
                      <a:pt x="411822" y="241736"/>
                      <a:pt x="403634" y="233548"/>
                      <a:pt x="403634" y="223448"/>
                    </a:cubicBezTo>
                    <a:cubicBezTo>
                      <a:pt x="403634" y="213348"/>
                      <a:pt x="411822" y="205160"/>
                      <a:pt x="421922" y="205160"/>
                    </a:cubicBezTo>
                    <a:close/>
                    <a:moveTo>
                      <a:pt x="364260" y="205160"/>
                    </a:moveTo>
                    <a:cubicBezTo>
                      <a:pt x="374360" y="205160"/>
                      <a:pt x="382548" y="213348"/>
                      <a:pt x="382548" y="223448"/>
                    </a:cubicBezTo>
                    <a:cubicBezTo>
                      <a:pt x="382548" y="233548"/>
                      <a:pt x="374360" y="241736"/>
                      <a:pt x="364260" y="241736"/>
                    </a:cubicBezTo>
                    <a:cubicBezTo>
                      <a:pt x="354160" y="241736"/>
                      <a:pt x="345972" y="233548"/>
                      <a:pt x="345972" y="223448"/>
                    </a:cubicBezTo>
                    <a:cubicBezTo>
                      <a:pt x="345972" y="213348"/>
                      <a:pt x="354160" y="205160"/>
                      <a:pt x="364260" y="205160"/>
                    </a:cubicBezTo>
                    <a:close/>
                    <a:moveTo>
                      <a:pt x="306598" y="205160"/>
                    </a:moveTo>
                    <a:cubicBezTo>
                      <a:pt x="316698" y="205160"/>
                      <a:pt x="324886" y="213348"/>
                      <a:pt x="324886" y="223448"/>
                    </a:cubicBezTo>
                    <a:cubicBezTo>
                      <a:pt x="324886" y="233548"/>
                      <a:pt x="316698" y="241736"/>
                      <a:pt x="306598" y="241736"/>
                    </a:cubicBezTo>
                    <a:cubicBezTo>
                      <a:pt x="296498" y="241736"/>
                      <a:pt x="288310" y="233548"/>
                      <a:pt x="288310" y="223448"/>
                    </a:cubicBezTo>
                    <a:cubicBezTo>
                      <a:pt x="288310" y="213348"/>
                      <a:pt x="296498" y="205160"/>
                      <a:pt x="306598" y="205160"/>
                    </a:cubicBezTo>
                    <a:close/>
                    <a:moveTo>
                      <a:pt x="248936" y="205160"/>
                    </a:moveTo>
                    <a:cubicBezTo>
                      <a:pt x="259036" y="205160"/>
                      <a:pt x="267224" y="213348"/>
                      <a:pt x="267224" y="223448"/>
                    </a:cubicBezTo>
                    <a:cubicBezTo>
                      <a:pt x="267224" y="233548"/>
                      <a:pt x="259036" y="241736"/>
                      <a:pt x="248936" y="241736"/>
                    </a:cubicBezTo>
                    <a:cubicBezTo>
                      <a:pt x="238836" y="241736"/>
                      <a:pt x="230648" y="233548"/>
                      <a:pt x="230648" y="223448"/>
                    </a:cubicBezTo>
                    <a:cubicBezTo>
                      <a:pt x="230648" y="213348"/>
                      <a:pt x="238836" y="205160"/>
                      <a:pt x="248936" y="205160"/>
                    </a:cubicBezTo>
                    <a:close/>
                    <a:moveTo>
                      <a:pt x="191274" y="205160"/>
                    </a:moveTo>
                    <a:cubicBezTo>
                      <a:pt x="201374" y="205160"/>
                      <a:pt x="209562" y="213348"/>
                      <a:pt x="209562" y="223448"/>
                    </a:cubicBezTo>
                    <a:cubicBezTo>
                      <a:pt x="209562" y="233548"/>
                      <a:pt x="201374" y="241736"/>
                      <a:pt x="191274" y="241736"/>
                    </a:cubicBezTo>
                    <a:cubicBezTo>
                      <a:pt x="181174" y="241736"/>
                      <a:pt x="172986" y="233548"/>
                      <a:pt x="172986" y="223448"/>
                    </a:cubicBezTo>
                    <a:cubicBezTo>
                      <a:pt x="172986" y="213348"/>
                      <a:pt x="181174" y="205160"/>
                      <a:pt x="191274" y="205160"/>
                    </a:cubicBezTo>
                    <a:close/>
                    <a:moveTo>
                      <a:pt x="133612" y="205160"/>
                    </a:moveTo>
                    <a:cubicBezTo>
                      <a:pt x="143712" y="205160"/>
                      <a:pt x="151900" y="213348"/>
                      <a:pt x="151900" y="223448"/>
                    </a:cubicBezTo>
                    <a:cubicBezTo>
                      <a:pt x="151900" y="233548"/>
                      <a:pt x="143712" y="241736"/>
                      <a:pt x="133612" y="241736"/>
                    </a:cubicBezTo>
                    <a:cubicBezTo>
                      <a:pt x="123512" y="241736"/>
                      <a:pt x="115324" y="233548"/>
                      <a:pt x="115324" y="223448"/>
                    </a:cubicBezTo>
                    <a:cubicBezTo>
                      <a:pt x="115324" y="213348"/>
                      <a:pt x="123512" y="205160"/>
                      <a:pt x="133612" y="205160"/>
                    </a:cubicBezTo>
                    <a:close/>
                    <a:moveTo>
                      <a:pt x="75950" y="205160"/>
                    </a:moveTo>
                    <a:cubicBezTo>
                      <a:pt x="86050" y="205160"/>
                      <a:pt x="94238" y="213348"/>
                      <a:pt x="94238" y="223448"/>
                    </a:cubicBezTo>
                    <a:cubicBezTo>
                      <a:pt x="94238" y="233548"/>
                      <a:pt x="86050" y="241736"/>
                      <a:pt x="75950" y="241736"/>
                    </a:cubicBezTo>
                    <a:cubicBezTo>
                      <a:pt x="65850" y="241736"/>
                      <a:pt x="57662" y="233548"/>
                      <a:pt x="57662" y="223448"/>
                    </a:cubicBezTo>
                    <a:cubicBezTo>
                      <a:pt x="57662" y="213348"/>
                      <a:pt x="65850" y="205160"/>
                      <a:pt x="75950" y="205160"/>
                    </a:cubicBezTo>
                    <a:close/>
                    <a:moveTo>
                      <a:pt x="18288" y="205160"/>
                    </a:moveTo>
                    <a:cubicBezTo>
                      <a:pt x="28388" y="205160"/>
                      <a:pt x="36576" y="213348"/>
                      <a:pt x="36576" y="223448"/>
                    </a:cubicBezTo>
                    <a:cubicBezTo>
                      <a:pt x="36576" y="233548"/>
                      <a:pt x="28388" y="241736"/>
                      <a:pt x="18288" y="241736"/>
                    </a:cubicBezTo>
                    <a:cubicBezTo>
                      <a:pt x="8188" y="241736"/>
                      <a:pt x="0" y="233548"/>
                      <a:pt x="0" y="223448"/>
                    </a:cubicBezTo>
                    <a:cubicBezTo>
                      <a:pt x="0" y="213348"/>
                      <a:pt x="8188" y="205160"/>
                      <a:pt x="18288" y="205160"/>
                    </a:cubicBezTo>
                    <a:close/>
                    <a:moveTo>
                      <a:pt x="1459848" y="153870"/>
                    </a:moveTo>
                    <a:cubicBezTo>
                      <a:pt x="1469948" y="153870"/>
                      <a:pt x="1478136" y="162058"/>
                      <a:pt x="1478136" y="172158"/>
                    </a:cubicBezTo>
                    <a:cubicBezTo>
                      <a:pt x="1478136" y="182258"/>
                      <a:pt x="1469948" y="190446"/>
                      <a:pt x="1459848" y="190446"/>
                    </a:cubicBezTo>
                    <a:cubicBezTo>
                      <a:pt x="1449748" y="190446"/>
                      <a:pt x="1441560" y="182258"/>
                      <a:pt x="1441560" y="172158"/>
                    </a:cubicBezTo>
                    <a:cubicBezTo>
                      <a:pt x="1441560" y="162058"/>
                      <a:pt x="1449748" y="153870"/>
                      <a:pt x="1459848" y="153870"/>
                    </a:cubicBezTo>
                    <a:close/>
                    <a:moveTo>
                      <a:pt x="1402176" y="153870"/>
                    </a:moveTo>
                    <a:cubicBezTo>
                      <a:pt x="1412276" y="153870"/>
                      <a:pt x="1420464" y="162058"/>
                      <a:pt x="1420464" y="172158"/>
                    </a:cubicBezTo>
                    <a:cubicBezTo>
                      <a:pt x="1420464" y="182258"/>
                      <a:pt x="1412276" y="190446"/>
                      <a:pt x="1402176" y="190446"/>
                    </a:cubicBezTo>
                    <a:cubicBezTo>
                      <a:pt x="1392076" y="190446"/>
                      <a:pt x="1383888" y="182258"/>
                      <a:pt x="1383888" y="172158"/>
                    </a:cubicBezTo>
                    <a:cubicBezTo>
                      <a:pt x="1383888" y="162058"/>
                      <a:pt x="1392076" y="153870"/>
                      <a:pt x="1402176" y="153870"/>
                    </a:cubicBezTo>
                    <a:close/>
                    <a:moveTo>
                      <a:pt x="1344514" y="153870"/>
                    </a:moveTo>
                    <a:cubicBezTo>
                      <a:pt x="1354614" y="153870"/>
                      <a:pt x="1362802" y="162058"/>
                      <a:pt x="1362802" y="172158"/>
                    </a:cubicBezTo>
                    <a:cubicBezTo>
                      <a:pt x="1362802" y="182258"/>
                      <a:pt x="1354614" y="190446"/>
                      <a:pt x="1344514" y="190446"/>
                    </a:cubicBezTo>
                    <a:cubicBezTo>
                      <a:pt x="1334414" y="190446"/>
                      <a:pt x="1326226" y="182258"/>
                      <a:pt x="1326226" y="172158"/>
                    </a:cubicBezTo>
                    <a:cubicBezTo>
                      <a:pt x="1326226" y="162058"/>
                      <a:pt x="1334414" y="153870"/>
                      <a:pt x="1344514" y="153870"/>
                    </a:cubicBezTo>
                    <a:close/>
                    <a:moveTo>
                      <a:pt x="1286852" y="153870"/>
                    </a:moveTo>
                    <a:cubicBezTo>
                      <a:pt x="1296952" y="153870"/>
                      <a:pt x="1305140" y="162058"/>
                      <a:pt x="1305140" y="172158"/>
                    </a:cubicBezTo>
                    <a:cubicBezTo>
                      <a:pt x="1305140" y="182258"/>
                      <a:pt x="1296952" y="190446"/>
                      <a:pt x="1286852" y="190446"/>
                    </a:cubicBezTo>
                    <a:cubicBezTo>
                      <a:pt x="1276752" y="190446"/>
                      <a:pt x="1268564" y="182258"/>
                      <a:pt x="1268564" y="172158"/>
                    </a:cubicBezTo>
                    <a:cubicBezTo>
                      <a:pt x="1268564" y="162058"/>
                      <a:pt x="1276752" y="153870"/>
                      <a:pt x="1286852" y="153870"/>
                    </a:cubicBezTo>
                    <a:close/>
                    <a:moveTo>
                      <a:pt x="1229190" y="153870"/>
                    </a:moveTo>
                    <a:cubicBezTo>
                      <a:pt x="1239290" y="153870"/>
                      <a:pt x="1247478" y="162058"/>
                      <a:pt x="1247478" y="172158"/>
                    </a:cubicBezTo>
                    <a:cubicBezTo>
                      <a:pt x="1247478" y="182258"/>
                      <a:pt x="1239290" y="190446"/>
                      <a:pt x="1229190" y="190446"/>
                    </a:cubicBezTo>
                    <a:cubicBezTo>
                      <a:pt x="1219090" y="190446"/>
                      <a:pt x="1210902" y="182258"/>
                      <a:pt x="1210902" y="172158"/>
                    </a:cubicBezTo>
                    <a:cubicBezTo>
                      <a:pt x="1210902" y="162058"/>
                      <a:pt x="1219090" y="153870"/>
                      <a:pt x="1229190" y="153870"/>
                    </a:cubicBezTo>
                    <a:close/>
                    <a:moveTo>
                      <a:pt x="1171528" y="153870"/>
                    </a:moveTo>
                    <a:cubicBezTo>
                      <a:pt x="1181628" y="153870"/>
                      <a:pt x="1189816" y="162058"/>
                      <a:pt x="1189816" y="172158"/>
                    </a:cubicBezTo>
                    <a:cubicBezTo>
                      <a:pt x="1189816" y="182258"/>
                      <a:pt x="1181628" y="190446"/>
                      <a:pt x="1171528" y="190446"/>
                    </a:cubicBezTo>
                    <a:cubicBezTo>
                      <a:pt x="1161428" y="190446"/>
                      <a:pt x="1153240" y="182258"/>
                      <a:pt x="1153240" y="172158"/>
                    </a:cubicBezTo>
                    <a:cubicBezTo>
                      <a:pt x="1153240" y="162058"/>
                      <a:pt x="1161428" y="153870"/>
                      <a:pt x="1171528" y="153870"/>
                    </a:cubicBezTo>
                    <a:close/>
                    <a:moveTo>
                      <a:pt x="1113866" y="153870"/>
                    </a:moveTo>
                    <a:cubicBezTo>
                      <a:pt x="1123966" y="153870"/>
                      <a:pt x="1132154" y="162058"/>
                      <a:pt x="1132154" y="172158"/>
                    </a:cubicBezTo>
                    <a:cubicBezTo>
                      <a:pt x="1132154" y="182258"/>
                      <a:pt x="1123966" y="190446"/>
                      <a:pt x="1113866" y="190446"/>
                    </a:cubicBezTo>
                    <a:cubicBezTo>
                      <a:pt x="1103766" y="190446"/>
                      <a:pt x="1095578" y="182258"/>
                      <a:pt x="1095578" y="172158"/>
                    </a:cubicBezTo>
                    <a:cubicBezTo>
                      <a:pt x="1095578" y="162058"/>
                      <a:pt x="1103766" y="153870"/>
                      <a:pt x="1113866" y="153870"/>
                    </a:cubicBezTo>
                    <a:close/>
                    <a:moveTo>
                      <a:pt x="1056204" y="153870"/>
                    </a:moveTo>
                    <a:cubicBezTo>
                      <a:pt x="1066304" y="153870"/>
                      <a:pt x="1074492" y="162058"/>
                      <a:pt x="1074492" y="172158"/>
                    </a:cubicBezTo>
                    <a:cubicBezTo>
                      <a:pt x="1074492" y="182258"/>
                      <a:pt x="1066304" y="190446"/>
                      <a:pt x="1056204" y="190446"/>
                    </a:cubicBezTo>
                    <a:cubicBezTo>
                      <a:pt x="1046104" y="190446"/>
                      <a:pt x="1037916" y="182258"/>
                      <a:pt x="1037916" y="172158"/>
                    </a:cubicBezTo>
                    <a:cubicBezTo>
                      <a:pt x="1037916" y="162058"/>
                      <a:pt x="1046104" y="153870"/>
                      <a:pt x="1056204" y="153870"/>
                    </a:cubicBezTo>
                    <a:close/>
                    <a:moveTo>
                      <a:pt x="998542" y="153870"/>
                    </a:moveTo>
                    <a:cubicBezTo>
                      <a:pt x="1008642" y="153870"/>
                      <a:pt x="1016830" y="162058"/>
                      <a:pt x="1016830" y="172158"/>
                    </a:cubicBezTo>
                    <a:cubicBezTo>
                      <a:pt x="1016830" y="182258"/>
                      <a:pt x="1008642" y="190446"/>
                      <a:pt x="998542" y="190446"/>
                    </a:cubicBezTo>
                    <a:cubicBezTo>
                      <a:pt x="988442" y="190446"/>
                      <a:pt x="980254" y="182258"/>
                      <a:pt x="980254" y="172158"/>
                    </a:cubicBezTo>
                    <a:cubicBezTo>
                      <a:pt x="980254" y="162058"/>
                      <a:pt x="988442" y="153870"/>
                      <a:pt x="998542" y="153870"/>
                    </a:cubicBezTo>
                    <a:close/>
                    <a:moveTo>
                      <a:pt x="940880" y="153870"/>
                    </a:moveTo>
                    <a:cubicBezTo>
                      <a:pt x="950980" y="153870"/>
                      <a:pt x="959168" y="162058"/>
                      <a:pt x="959168" y="172158"/>
                    </a:cubicBezTo>
                    <a:cubicBezTo>
                      <a:pt x="959168" y="182258"/>
                      <a:pt x="950980" y="190446"/>
                      <a:pt x="940880" y="190446"/>
                    </a:cubicBezTo>
                    <a:cubicBezTo>
                      <a:pt x="930780" y="190446"/>
                      <a:pt x="922592" y="182258"/>
                      <a:pt x="922592" y="172158"/>
                    </a:cubicBezTo>
                    <a:cubicBezTo>
                      <a:pt x="922592" y="162058"/>
                      <a:pt x="930780" y="153870"/>
                      <a:pt x="940880" y="153870"/>
                    </a:cubicBezTo>
                    <a:close/>
                    <a:moveTo>
                      <a:pt x="883218" y="153870"/>
                    </a:moveTo>
                    <a:cubicBezTo>
                      <a:pt x="893318" y="153870"/>
                      <a:pt x="901506" y="162058"/>
                      <a:pt x="901506" y="172158"/>
                    </a:cubicBezTo>
                    <a:cubicBezTo>
                      <a:pt x="901506" y="182258"/>
                      <a:pt x="893318" y="190446"/>
                      <a:pt x="883218" y="190446"/>
                    </a:cubicBezTo>
                    <a:cubicBezTo>
                      <a:pt x="873118" y="190446"/>
                      <a:pt x="864930" y="182258"/>
                      <a:pt x="864930" y="172158"/>
                    </a:cubicBezTo>
                    <a:cubicBezTo>
                      <a:pt x="864930" y="162058"/>
                      <a:pt x="873118" y="153870"/>
                      <a:pt x="883218" y="153870"/>
                    </a:cubicBezTo>
                    <a:close/>
                    <a:moveTo>
                      <a:pt x="825556" y="153870"/>
                    </a:moveTo>
                    <a:cubicBezTo>
                      <a:pt x="835656" y="153870"/>
                      <a:pt x="843844" y="162058"/>
                      <a:pt x="843844" y="172158"/>
                    </a:cubicBezTo>
                    <a:cubicBezTo>
                      <a:pt x="843844" y="182258"/>
                      <a:pt x="835656" y="190446"/>
                      <a:pt x="825556" y="190446"/>
                    </a:cubicBezTo>
                    <a:cubicBezTo>
                      <a:pt x="815456" y="190446"/>
                      <a:pt x="807268" y="182258"/>
                      <a:pt x="807268" y="172158"/>
                    </a:cubicBezTo>
                    <a:cubicBezTo>
                      <a:pt x="807268" y="162058"/>
                      <a:pt x="815456" y="153870"/>
                      <a:pt x="825556" y="153870"/>
                    </a:cubicBezTo>
                    <a:close/>
                    <a:moveTo>
                      <a:pt x="767894" y="153870"/>
                    </a:moveTo>
                    <a:cubicBezTo>
                      <a:pt x="777994" y="153870"/>
                      <a:pt x="786182" y="162058"/>
                      <a:pt x="786182" y="172158"/>
                    </a:cubicBezTo>
                    <a:cubicBezTo>
                      <a:pt x="786182" y="182258"/>
                      <a:pt x="777994" y="190446"/>
                      <a:pt x="767894" y="190446"/>
                    </a:cubicBezTo>
                    <a:cubicBezTo>
                      <a:pt x="757794" y="190446"/>
                      <a:pt x="749606" y="182258"/>
                      <a:pt x="749606" y="172158"/>
                    </a:cubicBezTo>
                    <a:cubicBezTo>
                      <a:pt x="749606" y="162058"/>
                      <a:pt x="757794" y="153870"/>
                      <a:pt x="767894" y="153870"/>
                    </a:cubicBezTo>
                    <a:close/>
                    <a:moveTo>
                      <a:pt x="710232" y="153870"/>
                    </a:moveTo>
                    <a:cubicBezTo>
                      <a:pt x="720332" y="153870"/>
                      <a:pt x="728520" y="162058"/>
                      <a:pt x="728520" y="172158"/>
                    </a:cubicBezTo>
                    <a:cubicBezTo>
                      <a:pt x="728520" y="182258"/>
                      <a:pt x="720332" y="190446"/>
                      <a:pt x="710232" y="190446"/>
                    </a:cubicBezTo>
                    <a:cubicBezTo>
                      <a:pt x="700132" y="190446"/>
                      <a:pt x="691944" y="182258"/>
                      <a:pt x="691944" y="172158"/>
                    </a:cubicBezTo>
                    <a:cubicBezTo>
                      <a:pt x="691944" y="162058"/>
                      <a:pt x="700132" y="153870"/>
                      <a:pt x="710232" y="153870"/>
                    </a:cubicBezTo>
                    <a:close/>
                    <a:moveTo>
                      <a:pt x="652570" y="153870"/>
                    </a:moveTo>
                    <a:cubicBezTo>
                      <a:pt x="662670" y="153870"/>
                      <a:pt x="670858" y="162058"/>
                      <a:pt x="670858" y="172158"/>
                    </a:cubicBezTo>
                    <a:cubicBezTo>
                      <a:pt x="670858" y="182258"/>
                      <a:pt x="662670" y="190446"/>
                      <a:pt x="652570" y="190446"/>
                    </a:cubicBezTo>
                    <a:cubicBezTo>
                      <a:pt x="642470" y="190446"/>
                      <a:pt x="634282" y="182258"/>
                      <a:pt x="634282" y="172158"/>
                    </a:cubicBezTo>
                    <a:cubicBezTo>
                      <a:pt x="634282" y="162058"/>
                      <a:pt x="642470" y="153870"/>
                      <a:pt x="652570" y="153870"/>
                    </a:cubicBezTo>
                    <a:close/>
                    <a:moveTo>
                      <a:pt x="594908" y="153870"/>
                    </a:moveTo>
                    <a:cubicBezTo>
                      <a:pt x="605008" y="153870"/>
                      <a:pt x="613196" y="162058"/>
                      <a:pt x="613196" y="172158"/>
                    </a:cubicBezTo>
                    <a:cubicBezTo>
                      <a:pt x="613196" y="182258"/>
                      <a:pt x="605008" y="190446"/>
                      <a:pt x="594908" y="190446"/>
                    </a:cubicBezTo>
                    <a:cubicBezTo>
                      <a:pt x="584808" y="190446"/>
                      <a:pt x="576620" y="182258"/>
                      <a:pt x="576620" y="172158"/>
                    </a:cubicBezTo>
                    <a:cubicBezTo>
                      <a:pt x="576620" y="162058"/>
                      <a:pt x="584808" y="153870"/>
                      <a:pt x="594908" y="153870"/>
                    </a:cubicBezTo>
                    <a:close/>
                    <a:moveTo>
                      <a:pt x="537246" y="153870"/>
                    </a:moveTo>
                    <a:cubicBezTo>
                      <a:pt x="547346" y="153870"/>
                      <a:pt x="555534" y="162058"/>
                      <a:pt x="555534" y="172158"/>
                    </a:cubicBezTo>
                    <a:cubicBezTo>
                      <a:pt x="555534" y="182258"/>
                      <a:pt x="547346" y="190446"/>
                      <a:pt x="537246" y="190446"/>
                    </a:cubicBezTo>
                    <a:cubicBezTo>
                      <a:pt x="527146" y="190446"/>
                      <a:pt x="518958" y="182258"/>
                      <a:pt x="518958" y="172158"/>
                    </a:cubicBezTo>
                    <a:cubicBezTo>
                      <a:pt x="518958" y="162058"/>
                      <a:pt x="527146" y="153870"/>
                      <a:pt x="537246" y="153870"/>
                    </a:cubicBezTo>
                    <a:close/>
                    <a:moveTo>
                      <a:pt x="479584" y="153870"/>
                    </a:moveTo>
                    <a:cubicBezTo>
                      <a:pt x="489684" y="153870"/>
                      <a:pt x="497872" y="162058"/>
                      <a:pt x="497872" y="172158"/>
                    </a:cubicBezTo>
                    <a:cubicBezTo>
                      <a:pt x="497872" y="182258"/>
                      <a:pt x="489684" y="190446"/>
                      <a:pt x="479584" y="190446"/>
                    </a:cubicBezTo>
                    <a:cubicBezTo>
                      <a:pt x="469484" y="190446"/>
                      <a:pt x="461296" y="182258"/>
                      <a:pt x="461296" y="172158"/>
                    </a:cubicBezTo>
                    <a:cubicBezTo>
                      <a:pt x="461296" y="162058"/>
                      <a:pt x="469484" y="153870"/>
                      <a:pt x="479584" y="153870"/>
                    </a:cubicBezTo>
                    <a:close/>
                    <a:moveTo>
                      <a:pt x="421922" y="153870"/>
                    </a:moveTo>
                    <a:cubicBezTo>
                      <a:pt x="432022" y="153870"/>
                      <a:pt x="440210" y="162058"/>
                      <a:pt x="440210" y="172158"/>
                    </a:cubicBezTo>
                    <a:cubicBezTo>
                      <a:pt x="440210" y="182258"/>
                      <a:pt x="432022" y="190446"/>
                      <a:pt x="421922" y="190446"/>
                    </a:cubicBezTo>
                    <a:cubicBezTo>
                      <a:pt x="411822" y="190446"/>
                      <a:pt x="403634" y="182258"/>
                      <a:pt x="403634" y="172158"/>
                    </a:cubicBezTo>
                    <a:cubicBezTo>
                      <a:pt x="403634" y="162058"/>
                      <a:pt x="411822" y="153870"/>
                      <a:pt x="421922" y="153870"/>
                    </a:cubicBezTo>
                    <a:close/>
                    <a:moveTo>
                      <a:pt x="364260" y="153870"/>
                    </a:moveTo>
                    <a:cubicBezTo>
                      <a:pt x="374360" y="153870"/>
                      <a:pt x="382548" y="162058"/>
                      <a:pt x="382548" y="172158"/>
                    </a:cubicBezTo>
                    <a:cubicBezTo>
                      <a:pt x="382548" y="182258"/>
                      <a:pt x="374360" y="190446"/>
                      <a:pt x="364260" y="190446"/>
                    </a:cubicBezTo>
                    <a:cubicBezTo>
                      <a:pt x="354160" y="190446"/>
                      <a:pt x="345972" y="182258"/>
                      <a:pt x="345972" y="172158"/>
                    </a:cubicBezTo>
                    <a:cubicBezTo>
                      <a:pt x="345972" y="162058"/>
                      <a:pt x="354160" y="153870"/>
                      <a:pt x="364260" y="153870"/>
                    </a:cubicBezTo>
                    <a:close/>
                    <a:moveTo>
                      <a:pt x="306598" y="153870"/>
                    </a:moveTo>
                    <a:cubicBezTo>
                      <a:pt x="316698" y="153870"/>
                      <a:pt x="324886" y="162058"/>
                      <a:pt x="324886" y="172158"/>
                    </a:cubicBezTo>
                    <a:cubicBezTo>
                      <a:pt x="324886" y="182258"/>
                      <a:pt x="316698" y="190446"/>
                      <a:pt x="306598" y="190446"/>
                    </a:cubicBezTo>
                    <a:cubicBezTo>
                      <a:pt x="296498" y="190446"/>
                      <a:pt x="288310" y="182258"/>
                      <a:pt x="288310" y="172158"/>
                    </a:cubicBezTo>
                    <a:cubicBezTo>
                      <a:pt x="288310" y="162058"/>
                      <a:pt x="296498" y="153870"/>
                      <a:pt x="306598" y="153870"/>
                    </a:cubicBezTo>
                    <a:close/>
                    <a:moveTo>
                      <a:pt x="248936" y="153870"/>
                    </a:moveTo>
                    <a:cubicBezTo>
                      <a:pt x="259036" y="153870"/>
                      <a:pt x="267224" y="162058"/>
                      <a:pt x="267224" y="172158"/>
                    </a:cubicBezTo>
                    <a:cubicBezTo>
                      <a:pt x="267224" y="182258"/>
                      <a:pt x="259036" y="190446"/>
                      <a:pt x="248936" y="190446"/>
                    </a:cubicBezTo>
                    <a:cubicBezTo>
                      <a:pt x="238836" y="190446"/>
                      <a:pt x="230648" y="182258"/>
                      <a:pt x="230648" y="172158"/>
                    </a:cubicBezTo>
                    <a:cubicBezTo>
                      <a:pt x="230648" y="162058"/>
                      <a:pt x="238836" y="153870"/>
                      <a:pt x="248936" y="153870"/>
                    </a:cubicBezTo>
                    <a:close/>
                    <a:moveTo>
                      <a:pt x="191274" y="153870"/>
                    </a:moveTo>
                    <a:cubicBezTo>
                      <a:pt x="201374" y="153870"/>
                      <a:pt x="209562" y="162058"/>
                      <a:pt x="209562" y="172158"/>
                    </a:cubicBezTo>
                    <a:cubicBezTo>
                      <a:pt x="209562" y="182258"/>
                      <a:pt x="201374" y="190446"/>
                      <a:pt x="191274" y="190446"/>
                    </a:cubicBezTo>
                    <a:cubicBezTo>
                      <a:pt x="181174" y="190446"/>
                      <a:pt x="172986" y="182258"/>
                      <a:pt x="172986" y="172158"/>
                    </a:cubicBezTo>
                    <a:cubicBezTo>
                      <a:pt x="172986" y="162058"/>
                      <a:pt x="181174" y="153870"/>
                      <a:pt x="191274" y="153870"/>
                    </a:cubicBezTo>
                    <a:close/>
                    <a:moveTo>
                      <a:pt x="133612" y="153870"/>
                    </a:moveTo>
                    <a:cubicBezTo>
                      <a:pt x="143712" y="153870"/>
                      <a:pt x="151900" y="162058"/>
                      <a:pt x="151900" y="172158"/>
                    </a:cubicBezTo>
                    <a:cubicBezTo>
                      <a:pt x="151900" y="182258"/>
                      <a:pt x="143712" y="190446"/>
                      <a:pt x="133612" y="190446"/>
                    </a:cubicBezTo>
                    <a:cubicBezTo>
                      <a:pt x="123512" y="190446"/>
                      <a:pt x="115324" y="182258"/>
                      <a:pt x="115324" y="172158"/>
                    </a:cubicBezTo>
                    <a:cubicBezTo>
                      <a:pt x="115324" y="162058"/>
                      <a:pt x="123512" y="153870"/>
                      <a:pt x="133612" y="153870"/>
                    </a:cubicBezTo>
                    <a:close/>
                    <a:moveTo>
                      <a:pt x="75950" y="153870"/>
                    </a:moveTo>
                    <a:cubicBezTo>
                      <a:pt x="86050" y="153870"/>
                      <a:pt x="94238" y="162058"/>
                      <a:pt x="94238" y="172158"/>
                    </a:cubicBezTo>
                    <a:cubicBezTo>
                      <a:pt x="94238" y="182258"/>
                      <a:pt x="86050" y="190446"/>
                      <a:pt x="75950" y="190446"/>
                    </a:cubicBezTo>
                    <a:cubicBezTo>
                      <a:pt x="65850" y="190446"/>
                      <a:pt x="57662" y="182258"/>
                      <a:pt x="57662" y="172158"/>
                    </a:cubicBezTo>
                    <a:cubicBezTo>
                      <a:pt x="57662" y="162058"/>
                      <a:pt x="65850" y="153870"/>
                      <a:pt x="75950" y="153870"/>
                    </a:cubicBezTo>
                    <a:close/>
                    <a:moveTo>
                      <a:pt x="18288" y="153870"/>
                    </a:moveTo>
                    <a:cubicBezTo>
                      <a:pt x="28388" y="153870"/>
                      <a:pt x="36576" y="162058"/>
                      <a:pt x="36576" y="172158"/>
                    </a:cubicBezTo>
                    <a:cubicBezTo>
                      <a:pt x="36576" y="182258"/>
                      <a:pt x="28388" y="190446"/>
                      <a:pt x="18288" y="190446"/>
                    </a:cubicBezTo>
                    <a:cubicBezTo>
                      <a:pt x="8188" y="190446"/>
                      <a:pt x="0" y="182258"/>
                      <a:pt x="0" y="172158"/>
                    </a:cubicBezTo>
                    <a:cubicBezTo>
                      <a:pt x="0" y="162058"/>
                      <a:pt x="8188" y="153870"/>
                      <a:pt x="18288" y="153870"/>
                    </a:cubicBezTo>
                    <a:close/>
                    <a:moveTo>
                      <a:pt x="1459848" y="102580"/>
                    </a:moveTo>
                    <a:cubicBezTo>
                      <a:pt x="1469948" y="102580"/>
                      <a:pt x="1478136" y="110768"/>
                      <a:pt x="1478136" y="120868"/>
                    </a:cubicBezTo>
                    <a:cubicBezTo>
                      <a:pt x="1478136" y="130968"/>
                      <a:pt x="1469948" y="139156"/>
                      <a:pt x="1459848" y="139156"/>
                    </a:cubicBezTo>
                    <a:cubicBezTo>
                      <a:pt x="1449748" y="139156"/>
                      <a:pt x="1441560" y="130968"/>
                      <a:pt x="1441560" y="120868"/>
                    </a:cubicBezTo>
                    <a:cubicBezTo>
                      <a:pt x="1441560" y="110768"/>
                      <a:pt x="1449748" y="102580"/>
                      <a:pt x="1459848" y="102580"/>
                    </a:cubicBezTo>
                    <a:close/>
                    <a:moveTo>
                      <a:pt x="1402176" y="102580"/>
                    </a:moveTo>
                    <a:cubicBezTo>
                      <a:pt x="1412276" y="102580"/>
                      <a:pt x="1420464" y="110768"/>
                      <a:pt x="1420464" y="120868"/>
                    </a:cubicBezTo>
                    <a:cubicBezTo>
                      <a:pt x="1420464" y="130968"/>
                      <a:pt x="1412276" y="139156"/>
                      <a:pt x="1402176" y="139156"/>
                    </a:cubicBezTo>
                    <a:cubicBezTo>
                      <a:pt x="1392076" y="139156"/>
                      <a:pt x="1383888" y="130968"/>
                      <a:pt x="1383888" y="120868"/>
                    </a:cubicBezTo>
                    <a:cubicBezTo>
                      <a:pt x="1383888" y="110768"/>
                      <a:pt x="1392076" y="102580"/>
                      <a:pt x="1402176" y="102580"/>
                    </a:cubicBezTo>
                    <a:close/>
                    <a:moveTo>
                      <a:pt x="1344514" y="102580"/>
                    </a:moveTo>
                    <a:cubicBezTo>
                      <a:pt x="1354614" y="102580"/>
                      <a:pt x="1362802" y="110768"/>
                      <a:pt x="1362802" y="120868"/>
                    </a:cubicBezTo>
                    <a:cubicBezTo>
                      <a:pt x="1362802" y="130968"/>
                      <a:pt x="1354614" y="139156"/>
                      <a:pt x="1344514" y="139156"/>
                    </a:cubicBezTo>
                    <a:cubicBezTo>
                      <a:pt x="1334414" y="139156"/>
                      <a:pt x="1326226" y="130968"/>
                      <a:pt x="1326226" y="120868"/>
                    </a:cubicBezTo>
                    <a:cubicBezTo>
                      <a:pt x="1326226" y="110768"/>
                      <a:pt x="1334414" y="102580"/>
                      <a:pt x="1344514" y="102580"/>
                    </a:cubicBezTo>
                    <a:close/>
                    <a:moveTo>
                      <a:pt x="1286852" y="102580"/>
                    </a:moveTo>
                    <a:cubicBezTo>
                      <a:pt x="1296952" y="102580"/>
                      <a:pt x="1305140" y="110768"/>
                      <a:pt x="1305140" y="120868"/>
                    </a:cubicBezTo>
                    <a:cubicBezTo>
                      <a:pt x="1305140" y="130968"/>
                      <a:pt x="1296952" y="139156"/>
                      <a:pt x="1286852" y="139156"/>
                    </a:cubicBezTo>
                    <a:cubicBezTo>
                      <a:pt x="1276752" y="139156"/>
                      <a:pt x="1268564" y="130968"/>
                      <a:pt x="1268564" y="120868"/>
                    </a:cubicBezTo>
                    <a:cubicBezTo>
                      <a:pt x="1268564" y="110768"/>
                      <a:pt x="1276752" y="102580"/>
                      <a:pt x="1286852" y="102580"/>
                    </a:cubicBezTo>
                    <a:close/>
                    <a:moveTo>
                      <a:pt x="1229190" y="102580"/>
                    </a:moveTo>
                    <a:cubicBezTo>
                      <a:pt x="1239290" y="102580"/>
                      <a:pt x="1247478" y="110768"/>
                      <a:pt x="1247478" y="120868"/>
                    </a:cubicBezTo>
                    <a:cubicBezTo>
                      <a:pt x="1247478" y="130968"/>
                      <a:pt x="1239290" y="139156"/>
                      <a:pt x="1229190" y="139156"/>
                    </a:cubicBezTo>
                    <a:cubicBezTo>
                      <a:pt x="1219090" y="139156"/>
                      <a:pt x="1210902" y="130968"/>
                      <a:pt x="1210902" y="120868"/>
                    </a:cubicBezTo>
                    <a:cubicBezTo>
                      <a:pt x="1210902" y="110768"/>
                      <a:pt x="1219090" y="102580"/>
                      <a:pt x="1229190" y="102580"/>
                    </a:cubicBezTo>
                    <a:close/>
                    <a:moveTo>
                      <a:pt x="1171528" y="102580"/>
                    </a:moveTo>
                    <a:cubicBezTo>
                      <a:pt x="1181628" y="102580"/>
                      <a:pt x="1189816" y="110768"/>
                      <a:pt x="1189816" y="120868"/>
                    </a:cubicBezTo>
                    <a:cubicBezTo>
                      <a:pt x="1189816" y="130968"/>
                      <a:pt x="1181628" y="139156"/>
                      <a:pt x="1171528" y="139156"/>
                    </a:cubicBezTo>
                    <a:cubicBezTo>
                      <a:pt x="1161428" y="139156"/>
                      <a:pt x="1153240" y="130968"/>
                      <a:pt x="1153240" y="120868"/>
                    </a:cubicBezTo>
                    <a:cubicBezTo>
                      <a:pt x="1153240" y="110768"/>
                      <a:pt x="1161428" y="102580"/>
                      <a:pt x="1171528" y="102580"/>
                    </a:cubicBezTo>
                    <a:close/>
                    <a:moveTo>
                      <a:pt x="1113866" y="102580"/>
                    </a:moveTo>
                    <a:cubicBezTo>
                      <a:pt x="1123966" y="102580"/>
                      <a:pt x="1132154" y="110768"/>
                      <a:pt x="1132154" y="120868"/>
                    </a:cubicBezTo>
                    <a:cubicBezTo>
                      <a:pt x="1132154" y="130968"/>
                      <a:pt x="1123966" y="139156"/>
                      <a:pt x="1113866" y="139156"/>
                    </a:cubicBezTo>
                    <a:cubicBezTo>
                      <a:pt x="1103766" y="139156"/>
                      <a:pt x="1095578" y="130968"/>
                      <a:pt x="1095578" y="120868"/>
                    </a:cubicBezTo>
                    <a:cubicBezTo>
                      <a:pt x="1095578" y="110768"/>
                      <a:pt x="1103766" y="102580"/>
                      <a:pt x="1113866" y="102580"/>
                    </a:cubicBezTo>
                    <a:close/>
                    <a:moveTo>
                      <a:pt x="1056204" y="102580"/>
                    </a:moveTo>
                    <a:cubicBezTo>
                      <a:pt x="1066304" y="102580"/>
                      <a:pt x="1074492" y="110768"/>
                      <a:pt x="1074492" y="120868"/>
                    </a:cubicBezTo>
                    <a:cubicBezTo>
                      <a:pt x="1074492" y="130968"/>
                      <a:pt x="1066304" y="139156"/>
                      <a:pt x="1056204" y="139156"/>
                    </a:cubicBezTo>
                    <a:cubicBezTo>
                      <a:pt x="1046104" y="139156"/>
                      <a:pt x="1037916" y="130968"/>
                      <a:pt x="1037916" y="120868"/>
                    </a:cubicBezTo>
                    <a:cubicBezTo>
                      <a:pt x="1037916" y="110768"/>
                      <a:pt x="1046104" y="102580"/>
                      <a:pt x="1056204" y="102580"/>
                    </a:cubicBezTo>
                    <a:close/>
                    <a:moveTo>
                      <a:pt x="998542" y="102580"/>
                    </a:moveTo>
                    <a:cubicBezTo>
                      <a:pt x="1008642" y="102580"/>
                      <a:pt x="1016830" y="110768"/>
                      <a:pt x="1016830" y="120868"/>
                    </a:cubicBezTo>
                    <a:cubicBezTo>
                      <a:pt x="1016830" y="130968"/>
                      <a:pt x="1008642" y="139156"/>
                      <a:pt x="998542" y="139156"/>
                    </a:cubicBezTo>
                    <a:cubicBezTo>
                      <a:pt x="988442" y="139156"/>
                      <a:pt x="980254" y="130968"/>
                      <a:pt x="980254" y="120868"/>
                    </a:cubicBezTo>
                    <a:cubicBezTo>
                      <a:pt x="980254" y="110768"/>
                      <a:pt x="988442" y="102580"/>
                      <a:pt x="998542" y="102580"/>
                    </a:cubicBezTo>
                    <a:close/>
                    <a:moveTo>
                      <a:pt x="940880" y="102580"/>
                    </a:moveTo>
                    <a:cubicBezTo>
                      <a:pt x="950980" y="102580"/>
                      <a:pt x="959168" y="110768"/>
                      <a:pt x="959168" y="120868"/>
                    </a:cubicBezTo>
                    <a:cubicBezTo>
                      <a:pt x="959168" y="130968"/>
                      <a:pt x="950980" y="139156"/>
                      <a:pt x="940880" y="139156"/>
                    </a:cubicBezTo>
                    <a:cubicBezTo>
                      <a:pt x="930780" y="139156"/>
                      <a:pt x="922592" y="130968"/>
                      <a:pt x="922592" y="120868"/>
                    </a:cubicBezTo>
                    <a:cubicBezTo>
                      <a:pt x="922592" y="110768"/>
                      <a:pt x="930780" y="102580"/>
                      <a:pt x="940880" y="102580"/>
                    </a:cubicBezTo>
                    <a:close/>
                    <a:moveTo>
                      <a:pt x="883218" y="102580"/>
                    </a:moveTo>
                    <a:cubicBezTo>
                      <a:pt x="893318" y="102580"/>
                      <a:pt x="901506" y="110768"/>
                      <a:pt x="901506" y="120868"/>
                    </a:cubicBezTo>
                    <a:cubicBezTo>
                      <a:pt x="901506" y="130968"/>
                      <a:pt x="893318" y="139156"/>
                      <a:pt x="883218" y="139156"/>
                    </a:cubicBezTo>
                    <a:cubicBezTo>
                      <a:pt x="873118" y="139156"/>
                      <a:pt x="864930" y="130968"/>
                      <a:pt x="864930" y="120868"/>
                    </a:cubicBezTo>
                    <a:cubicBezTo>
                      <a:pt x="864930" y="110768"/>
                      <a:pt x="873118" y="102580"/>
                      <a:pt x="883218" y="102580"/>
                    </a:cubicBezTo>
                    <a:close/>
                    <a:moveTo>
                      <a:pt x="825556" y="102580"/>
                    </a:moveTo>
                    <a:cubicBezTo>
                      <a:pt x="835656" y="102580"/>
                      <a:pt x="843844" y="110768"/>
                      <a:pt x="843844" y="120868"/>
                    </a:cubicBezTo>
                    <a:cubicBezTo>
                      <a:pt x="843844" y="130968"/>
                      <a:pt x="835656" y="139156"/>
                      <a:pt x="825556" y="139156"/>
                    </a:cubicBezTo>
                    <a:cubicBezTo>
                      <a:pt x="815456" y="139156"/>
                      <a:pt x="807268" y="130968"/>
                      <a:pt x="807268" y="120868"/>
                    </a:cubicBezTo>
                    <a:cubicBezTo>
                      <a:pt x="807268" y="110768"/>
                      <a:pt x="815456" y="102580"/>
                      <a:pt x="825556" y="102580"/>
                    </a:cubicBezTo>
                    <a:close/>
                    <a:moveTo>
                      <a:pt x="767894" y="102580"/>
                    </a:moveTo>
                    <a:cubicBezTo>
                      <a:pt x="777994" y="102580"/>
                      <a:pt x="786182" y="110768"/>
                      <a:pt x="786182" y="120868"/>
                    </a:cubicBezTo>
                    <a:cubicBezTo>
                      <a:pt x="786182" y="130968"/>
                      <a:pt x="777994" y="139156"/>
                      <a:pt x="767894" y="139156"/>
                    </a:cubicBezTo>
                    <a:cubicBezTo>
                      <a:pt x="757794" y="139156"/>
                      <a:pt x="749606" y="130968"/>
                      <a:pt x="749606" y="120868"/>
                    </a:cubicBezTo>
                    <a:cubicBezTo>
                      <a:pt x="749606" y="110768"/>
                      <a:pt x="757794" y="102580"/>
                      <a:pt x="767894" y="102580"/>
                    </a:cubicBezTo>
                    <a:close/>
                    <a:moveTo>
                      <a:pt x="710232" y="102580"/>
                    </a:moveTo>
                    <a:cubicBezTo>
                      <a:pt x="720332" y="102580"/>
                      <a:pt x="728520" y="110768"/>
                      <a:pt x="728520" y="120868"/>
                    </a:cubicBezTo>
                    <a:cubicBezTo>
                      <a:pt x="728520" y="130968"/>
                      <a:pt x="720332" y="139156"/>
                      <a:pt x="710232" y="139156"/>
                    </a:cubicBezTo>
                    <a:cubicBezTo>
                      <a:pt x="700132" y="139156"/>
                      <a:pt x="691944" y="130968"/>
                      <a:pt x="691944" y="120868"/>
                    </a:cubicBezTo>
                    <a:cubicBezTo>
                      <a:pt x="691944" y="110768"/>
                      <a:pt x="700132" y="102580"/>
                      <a:pt x="710232" y="102580"/>
                    </a:cubicBezTo>
                    <a:close/>
                    <a:moveTo>
                      <a:pt x="652570" y="102580"/>
                    </a:moveTo>
                    <a:cubicBezTo>
                      <a:pt x="662670" y="102580"/>
                      <a:pt x="670858" y="110768"/>
                      <a:pt x="670858" y="120868"/>
                    </a:cubicBezTo>
                    <a:cubicBezTo>
                      <a:pt x="670858" y="130968"/>
                      <a:pt x="662670" y="139156"/>
                      <a:pt x="652570" y="139156"/>
                    </a:cubicBezTo>
                    <a:cubicBezTo>
                      <a:pt x="642470" y="139156"/>
                      <a:pt x="634282" y="130968"/>
                      <a:pt x="634282" y="120868"/>
                    </a:cubicBezTo>
                    <a:cubicBezTo>
                      <a:pt x="634282" y="110768"/>
                      <a:pt x="642470" y="102580"/>
                      <a:pt x="652570" y="102580"/>
                    </a:cubicBezTo>
                    <a:close/>
                    <a:moveTo>
                      <a:pt x="594908" y="102580"/>
                    </a:moveTo>
                    <a:cubicBezTo>
                      <a:pt x="605008" y="102580"/>
                      <a:pt x="613196" y="110768"/>
                      <a:pt x="613196" y="120868"/>
                    </a:cubicBezTo>
                    <a:cubicBezTo>
                      <a:pt x="613196" y="130968"/>
                      <a:pt x="605008" y="139156"/>
                      <a:pt x="594908" y="139156"/>
                    </a:cubicBezTo>
                    <a:cubicBezTo>
                      <a:pt x="584808" y="139156"/>
                      <a:pt x="576620" y="130968"/>
                      <a:pt x="576620" y="120868"/>
                    </a:cubicBezTo>
                    <a:cubicBezTo>
                      <a:pt x="576620" y="110768"/>
                      <a:pt x="584808" y="102580"/>
                      <a:pt x="594908" y="102580"/>
                    </a:cubicBezTo>
                    <a:close/>
                    <a:moveTo>
                      <a:pt x="537246" y="102580"/>
                    </a:moveTo>
                    <a:cubicBezTo>
                      <a:pt x="547346" y="102580"/>
                      <a:pt x="555534" y="110768"/>
                      <a:pt x="555534" y="120868"/>
                    </a:cubicBezTo>
                    <a:cubicBezTo>
                      <a:pt x="555534" y="130968"/>
                      <a:pt x="547346" y="139156"/>
                      <a:pt x="537246" y="139156"/>
                    </a:cubicBezTo>
                    <a:cubicBezTo>
                      <a:pt x="527146" y="139156"/>
                      <a:pt x="518958" y="130968"/>
                      <a:pt x="518958" y="120868"/>
                    </a:cubicBezTo>
                    <a:cubicBezTo>
                      <a:pt x="518958" y="110768"/>
                      <a:pt x="527146" y="102580"/>
                      <a:pt x="537246" y="102580"/>
                    </a:cubicBezTo>
                    <a:close/>
                    <a:moveTo>
                      <a:pt x="479584" y="102580"/>
                    </a:moveTo>
                    <a:cubicBezTo>
                      <a:pt x="489684" y="102580"/>
                      <a:pt x="497872" y="110768"/>
                      <a:pt x="497872" y="120868"/>
                    </a:cubicBezTo>
                    <a:cubicBezTo>
                      <a:pt x="497872" y="130968"/>
                      <a:pt x="489684" y="139156"/>
                      <a:pt x="479584" y="139156"/>
                    </a:cubicBezTo>
                    <a:cubicBezTo>
                      <a:pt x="469484" y="139156"/>
                      <a:pt x="461296" y="130968"/>
                      <a:pt x="461296" y="120868"/>
                    </a:cubicBezTo>
                    <a:cubicBezTo>
                      <a:pt x="461296" y="110768"/>
                      <a:pt x="469484" y="102580"/>
                      <a:pt x="479584" y="102580"/>
                    </a:cubicBezTo>
                    <a:close/>
                    <a:moveTo>
                      <a:pt x="421922" y="102580"/>
                    </a:moveTo>
                    <a:cubicBezTo>
                      <a:pt x="432022" y="102580"/>
                      <a:pt x="440210" y="110768"/>
                      <a:pt x="440210" y="120868"/>
                    </a:cubicBezTo>
                    <a:cubicBezTo>
                      <a:pt x="440210" y="130968"/>
                      <a:pt x="432022" y="139156"/>
                      <a:pt x="421922" y="139156"/>
                    </a:cubicBezTo>
                    <a:cubicBezTo>
                      <a:pt x="411822" y="139156"/>
                      <a:pt x="403634" y="130968"/>
                      <a:pt x="403634" y="120868"/>
                    </a:cubicBezTo>
                    <a:cubicBezTo>
                      <a:pt x="403634" y="110768"/>
                      <a:pt x="411822" y="102580"/>
                      <a:pt x="421922" y="102580"/>
                    </a:cubicBezTo>
                    <a:close/>
                    <a:moveTo>
                      <a:pt x="364260" y="102580"/>
                    </a:moveTo>
                    <a:cubicBezTo>
                      <a:pt x="374360" y="102580"/>
                      <a:pt x="382548" y="110768"/>
                      <a:pt x="382548" y="120868"/>
                    </a:cubicBezTo>
                    <a:cubicBezTo>
                      <a:pt x="382548" y="130968"/>
                      <a:pt x="374360" y="139156"/>
                      <a:pt x="364260" y="139156"/>
                    </a:cubicBezTo>
                    <a:cubicBezTo>
                      <a:pt x="354160" y="139156"/>
                      <a:pt x="345972" y="130968"/>
                      <a:pt x="345972" y="120868"/>
                    </a:cubicBezTo>
                    <a:cubicBezTo>
                      <a:pt x="345972" y="110768"/>
                      <a:pt x="354160" y="102580"/>
                      <a:pt x="364260" y="102580"/>
                    </a:cubicBezTo>
                    <a:close/>
                    <a:moveTo>
                      <a:pt x="306598" y="102580"/>
                    </a:moveTo>
                    <a:cubicBezTo>
                      <a:pt x="316698" y="102580"/>
                      <a:pt x="324886" y="110768"/>
                      <a:pt x="324886" y="120868"/>
                    </a:cubicBezTo>
                    <a:cubicBezTo>
                      <a:pt x="324886" y="130968"/>
                      <a:pt x="316698" y="139156"/>
                      <a:pt x="306598" y="139156"/>
                    </a:cubicBezTo>
                    <a:cubicBezTo>
                      <a:pt x="296498" y="139156"/>
                      <a:pt x="288310" y="130968"/>
                      <a:pt x="288310" y="120868"/>
                    </a:cubicBezTo>
                    <a:cubicBezTo>
                      <a:pt x="288310" y="110768"/>
                      <a:pt x="296498" y="102580"/>
                      <a:pt x="306598" y="102580"/>
                    </a:cubicBezTo>
                    <a:close/>
                    <a:moveTo>
                      <a:pt x="248936" y="102580"/>
                    </a:moveTo>
                    <a:cubicBezTo>
                      <a:pt x="259036" y="102580"/>
                      <a:pt x="267224" y="110768"/>
                      <a:pt x="267224" y="120868"/>
                    </a:cubicBezTo>
                    <a:cubicBezTo>
                      <a:pt x="267224" y="130968"/>
                      <a:pt x="259036" y="139156"/>
                      <a:pt x="248936" y="139156"/>
                    </a:cubicBezTo>
                    <a:cubicBezTo>
                      <a:pt x="238836" y="139156"/>
                      <a:pt x="230648" y="130968"/>
                      <a:pt x="230648" y="120868"/>
                    </a:cubicBezTo>
                    <a:cubicBezTo>
                      <a:pt x="230648" y="110768"/>
                      <a:pt x="238836" y="102580"/>
                      <a:pt x="248936" y="102580"/>
                    </a:cubicBezTo>
                    <a:close/>
                    <a:moveTo>
                      <a:pt x="191274" y="102580"/>
                    </a:moveTo>
                    <a:cubicBezTo>
                      <a:pt x="201374" y="102580"/>
                      <a:pt x="209562" y="110768"/>
                      <a:pt x="209562" y="120868"/>
                    </a:cubicBezTo>
                    <a:cubicBezTo>
                      <a:pt x="209562" y="130968"/>
                      <a:pt x="201374" y="139156"/>
                      <a:pt x="191274" y="139156"/>
                    </a:cubicBezTo>
                    <a:cubicBezTo>
                      <a:pt x="181174" y="139156"/>
                      <a:pt x="172986" y="130968"/>
                      <a:pt x="172986" y="120868"/>
                    </a:cubicBezTo>
                    <a:cubicBezTo>
                      <a:pt x="172986" y="110768"/>
                      <a:pt x="181174" y="102580"/>
                      <a:pt x="191274" y="102580"/>
                    </a:cubicBezTo>
                    <a:close/>
                    <a:moveTo>
                      <a:pt x="133612" y="102580"/>
                    </a:moveTo>
                    <a:cubicBezTo>
                      <a:pt x="143712" y="102580"/>
                      <a:pt x="151900" y="110768"/>
                      <a:pt x="151900" y="120868"/>
                    </a:cubicBezTo>
                    <a:cubicBezTo>
                      <a:pt x="151900" y="130968"/>
                      <a:pt x="143712" y="139156"/>
                      <a:pt x="133612" y="139156"/>
                    </a:cubicBezTo>
                    <a:cubicBezTo>
                      <a:pt x="123512" y="139156"/>
                      <a:pt x="115324" y="130968"/>
                      <a:pt x="115324" y="120868"/>
                    </a:cubicBezTo>
                    <a:cubicBezTo>
                      <a:pt x="115324" y="110768"/>
                      <a:pt x="123512" y="102580"/>
                      <a:pt x="133612" y="102580"/>
                    </a:cubicBezTo>
                    <a:close/>
                    <a:moveTo>
                      <a:pt x="75950" y="102580"/>
                    </a:moveTo>
                    <a:cubicBezTo>
                      <a:pt x="86050" y="102580"/>
                      <a:pt x="94238" y="110768"/>
                      <a:pt x="94238" y="120868"/>
                    </a:cubicBezTo>
                    <a:cubicBezTo>
                      <a:pt x="94238" y="130968"/>
                      <a:pt x="86050" y="139156"/>
                      <a:pt x="75950" y="139156"/>
                    </a:cubicBezTo>
                    <a:cubicBezTo>
                      <a:pt x="65850" y="139156"/>
                      <a:pt x="57662" y="130968"/>
                      <a:pt x="57662" y="120868"/>
                    </a:cubicBezTo>
                    <a:cubicBezTo>
                      <a:pt x="57662" y="110768"/>
                      <a:pt x="65850" y="102580"/>
                      <a:pt x="75950" y="102580"/>
                    </a:cubicBezTo>
                    <a:close/>
                    <a:moveTo>
                      <a:pt x="18288" y="102580"/>
                    </a:moveTo>
                    <a:cubicBezTo>
                      <a:pt x="28388" y="102580"/>
                      <a:pt x="36576" y="110768"/>
                      <a:pt x="36576" y="120868"/>
                    </a:cubicBezTo>
                    <a:cubicBezTo>
                      <a:pt x="36576" y="130968"/>
                      <a:pt x="28388" y="139156"/>
                      <a:pt x="18288" y="139156"/>
                    </a:cubicBezTo>
                    <a:cubicBezTo>
                      <a:pt x="8188" y="139156"/>
                      <a:pt x="0" y="130968"/>
                      <a:pt x="0" y="120868"/>
                    </a:cubicBezTo>
                    <a:cubicBezTo>
                      <a:pt x="0" y="110768"/>
                      <a:pt x="8188" y="102580"/>
                      <a:pt x="18288" y="102580"/>
                    </a:cubicBezTo>
                    <a:close/>
                    <a:moveTo>
                      <a:pt x="1459848" y="51290"/>
                    </a:moveTo>
                    <a:cubicBezTo>
                      <a:pt x="1469948" y="51290"/>
                      <a:pt x="1478136" y="59478"/>
                      <a:pt x="1478136" y="69578"/>
                    </a:cubicBezTo>
                    <a:cubicBezTo>
                      <a:pt x="1478136" y="79678"/>
                      <a:pt x="1469948" y="87866"/>
                      <a:pt x="1459848" y="87866"/>
                    </a:cubicBezTo>
                    <a:cubicBezTo>
                      <a:pt x="1449748" y="87866"/>
                      <a:pt x="1441560" y="79678"/>
                      <a:pt x="1441560" y="69578"/>
                    </a:cubicBezTo>
                    <a:cubicBezTo>
                      <a:pt x="1441560" y="59478"/>
                      <a:pt x="1449748" y="51290"/>
                      <a:pt x="1459848" y="51290"/>
                    </a:cubicBezTo>
                    <a:close/>
                    <a:moveTo>
                      <a:pt x="1402176" y="51290"/>
                    </a:moveTo>
                    <a:cubicBezTo>
                      <a:pt x="1412276" y="51290"/>
                      <a:pt x="1420464" y="59478"/>
                      <a:pt x="1420464" y="69578"/>
                    </a:cubicBezTo>
                    <a:cubicBezTo>
                      <a:pt x="1420464" y="79678"/>
                      <a:pt x="1412276" y="87866"/>
                      <a:pt x="1402176" y="87866"/>
                    </a:cubicBezTo>
                    <a:cubicBezTo>
                      <a:pt x="1392076" y="87866"/>
                      <a:pt x="1383888" y="79678"/>
                      <a:pt x="1383888" y="69578"/>
                    </a:cubicBezTo>
                    <a:cubicBezTo>
                      <a:pt x="1383888" y="59478"/>
                      <a:pt x="1392076" y="51290"/>
                      <a:pt x="1402176" y="51290"/>
                    </a:cubicBezTo>
                    <a:close/>
                    <a:moveTo>
                      <a:pt x="1344514" y="51290"/>
                    </a:moveTo>
                    <a:cubicBezTo>
                      <a:pt x="1354614" y="51290"/>
                      <a:pt x="1362802" y="59478"/>
                      <a:pt x="1362802" y="69578"/>
                    </a:cubicBezTo>
                    <a:cubicBezTo>
                      <a:pt x="1362802" y="79678"/>
                      <a:pt x="1354614" y="87866"/>
                      <a:pt x="1344514" y="87866"/>
                    </a:cubicBezTo>
                    <a:cubicBezTo>
                      <a:pt x="1334414" y="87866"/>
                      <a:pt x="1326226" y="79678"/>
                      <a:pt x="1326226" y="69578"/>
                    </a:cubicBezTo>
                    <a:cubicBezTo>
                      <a:pt x="1326226" y="59478"/>
                      <a:pt x="1334414" y="51290"/>
                      <a:pt x="1344514" y="51290"/>
                    </a:cubicBezTo>
                    <a:close/>
                    <a:moveTo>
                      <a:pt x="1286852" y="51290"/>
                    </a:moveTo>
                    <a:cubicBezTo>
                      <a:pt x="1296952" y="51290"/>
                      <a:pt x="1305140" y="59478"/>
                      <a:pt x="1305140" y="69578"/>
                    </a:cubicBezTo>
                    <a:cubicBezTo>
                      <a:pt x="1305140" y="79678"/>
                      <a:pt x="1296952" y="87866"/>
                      <a:pt x="1286852" y="87866"/>
                    </a:cubicBezTo>
                    <a:cubicBezTo>
                      <a:pt x="1276752" y="87866"/>
                      <a:pt x="1268564" y="79678"/>
                      <a:pt x="1268564" y="69578"/>
                    </a:cubicBezTo>
                    <a:cubicBezTo>
                      <a:pt x="1268564" y="59478"/>
                      <a:pt x="1276752" y="51290"/>
                      <a:pt x="1286852" y="51290"/>
                    </a:cubicBezTo>
                    <a:close/>
                    <a:moveTo>
                      <a:pt x="1229190" y="51290"/>
                    </a:moveTo>
                    <a:cubicBezTo>
                      <a:pt x="1239290" y="51290"/>
                      <a:pt x="1247478" y="59478"/>
                      <a:pt x="1247478" y="69578"/>
                    </a:cubicBezTo>
                    <a:cubicBezTo>
                      <a:pt x="1247478" y="79678"/>
                      <a:pt x="1239290" y="87866"/>
                      <a:pt x="1229190" y="87866"/>
                    </a:cubicBezTo>
                    <a:cubicBezTo>
                      <a:pt x="1219090" y="87866"/>
                      <a:pt x="1210902" y="79678"/>
                      <a:pt x="1210902" y="69578"/>
                    </a:cubicBezTo>
                    <a:cubicBezTo>
                      <a:pt x="1210902" y="59478"/>
                      <a:pt x="1219090" y="51290"/>
                      <a:pt x="1229190" y="51290"/>
                    </a:cubicBezTo>
                    <a:close/>
                    <a:moveTo>
                      <a:pt x="1171528" y="51290"/>
                    </a:moveTo>
                    <a:cubicBezTo>
                      <a:pt x="1181628" y="51290"/>
                      <a:pt x="1189816" y="59478"/>
                      <a:pt x="1189816" y="69578"/>
                    </a:cubicBezTo>
                    <a:cubicBezTo>
                      <a:pt x="1189816" y="79678"/>
                      <a:pt x="1181628" y="87866"/>
                      <a:pt x="1171528" y="87866"/>
                    </a:cubicBezTo>
                    <a:cubicBezTo>
                      <a:pt x="1161428" y="87866"/>
                      <a:pt x="1153240" y="79678"/>
                      <a:pt x="1153240" y="69578"/>
                    </a:cubicBezTo>
                    <a:cubicBezTo>
                      <a:pt x="1153240" y="59478"/>
                      <a:pt x="1161428" y="51290"/>
                      <a:pt x="1171528" y="51290"/>
                    </a:cubicBezTo>
                    <a:close/>
                    <a:moveTo>
                      <a:pt x="1113866" y="51290"/>
                    </a:moveTo>
                    <a:cubicBezTo>
                      <a:pt x="1123966" y="51290"/>
                      <a:pt x="1132154" y="59478"/>
                      <a:pt x="1132154" y="69578"/>
                    </a:cubicBezTo>
                    <a:cubicBezTo>
                      <a:pt x="1132154" y="79678"/>
                      <a:pt x="1123966" y="87866"/>
                      <a:pt x="1113866" y="87866"/>
                    </a:cubicBezTo>
                    <a:cubicBezTo>
                      <a:pt x="1103766" y="87866"/>
                      <a:pt x="1095578" y="79678"/>
                      <a:pt x="1095578" y="69578"/>
                    </a:cubicBezTo>
                    <a:cubicBezTo>
                      <a:pt x="1095578" y="59478"/>
                      <a:pt x="1103766" y="51290"/>
                      <a:pt x="1113866" y="51290"/>
                    </a:cubicBezTo>
                    <a:close/>
                    <a:moveTo>
                      <a:pt x="1056204" y="51290"/>
                    </a:moveTo>
                    <a:cubicBezTo>
                      <a:pt x="1066304" y="51290"/>
                      <a:pt x="1074492" y="59478"/>
                      <a:pt x="1074492" y="69578"/>
                    </a:cubicBezTo>
                    <a:cubicBezTo>
                      <a:pt x="1074492" y="79678"/>
                      <a:pt x="1066304" y="87866"/>
                      <a:pt x="1056204" y="87866"/>
                    </a:cubicBezTo>
                    <a:cubicBezTo>
                      <a:pt x="1046104" y="87866"/>
                      <a:pt x="1037916" y="79678"/>
                      <a:pt x="1037916" y="69578"/>
                    </a:cubicBezTo>
                    <a:cubicBezTo>
                      <a:pt x="1037916" y="59478"/>
                      <a:pt x="1046104" y="51290"/>
                      <a:pt x="1056204" y="51290"/>
                    </a:cubicBezTo>
                    <a:close/>
                    <a:moveTo>
                      <a:pt x="998542" y="51290"/>
                    </a:moveTo>
                    <a:cubicBezTo>
                      <a:pt x="1008642" y="51290"/>
                      <a:pt x="1016830" y="59478"/>
                      <a:pt x="1016830" y="69578"/>
                    </a:cubicBezTo>
                    <a:cubicBezTo>
                      <a:pt x="1016830" y="79678"/>
                      <a:pt x="1008642" y="87866"/>
                      <a:pt x="998542" y="87866"/>
                    </a:cubicBezTo>
                    <a:cubicBezTo>
                      <a:pt x="988442" y="87866"/>
                      <a:pt x="980254" y="79678"/>
                      <a:pt x="980254" y="69578"/>
                    </a:cubicBezTo>
                    <a:cubicBezTo>
                      <a:pt x="980254" y="59478"/>
                      <a:pt x="988442" y="51290"/>
                      <a:pt x="998542" y="51290"/>
                    </a:cubicBezTo>
                    <a:close/>
                    <a:moveTo>
                      <a:pt x="940880" y="51290"/>
                    </a:moveTo>
                    <a:cubicBezTo>
                      <a:pt x="950980" y="51290"/>
                      <a:pt x="959168" y="59478"/>
                      <a:pt x="959168" y="69578"/>
                    </a:cubicBezTo>
                    <a:cubicBezTo>
                      <a:pt x="959168" y="79678"/>
                      <a:pt x="950980" y="87866"/>
                      <a:pt x="940880" y="87866"/>
                    </a:cubicBezTo>
                    <a:cubicBezTo>
                      <a:pt x="930780" y="87866"/>
                      <a:pt x="922592" y="79678"/>
                      <a:pt x="922592" y="69578"/>
                    </a:cubicBezTo>
                    <a:cubicBezTo>
                      <a:pt x="922592" y="59478"/>
                      <a:pt x="930780" y="51290"/>
                      <a:pt x="940880" y="51290"/>
                    </a:cubicBezTo>
                    <a:close/>
                    <a:moveTo>
                      <a:pt x="883218" y="51290"/>
                    </a:moveTo>
                    <a:cubicBezTo>
                      <a:pt x="893318" y="51290"/>
                      <a:pt x="901506" y="59478"/>
                      <a:pt x="901506" y="69578"/>
                    </a:cubicBezTo>
                    <a:cubicBezTo>
                      <a:pt x="901506" y="79678"/>
                      <a:pt x="893318" y="87866"/>
                      <a:pt x="883218" y="87866"/>
                    </a:cubicBezTo>
                    <a:cubicBezTo>
                      <a:pt x="873118" y="87866"/>
                      <a:pt x="864930" y="79678"/>
                      <a:pt x="864930" y="69578"/>
                    </a:cubicBezTo>
                    <a:cubicBezTo>
                      <a:pt x="864930" y="59478"/>
                      <a:pt x="873118" y="51290"/>
                      <a:pt x="883218" y="51290"/>
                    </a:cubicBezTo>
                    <a:close/>
                    <a:moveTo>
                      <a:pt x="825556" y="51290"/>
                    </a:moveTo>
                    <a:cubicBezTo>
                      <a:pt x="835656" y="51290"/>
                      <a:pt x="843844" y="59478"/>
                      <a:pt x="843844" y="69578"/>
                    </a:cubicBezTo>
                    <a:cubicBezTo>
                      <a:pt x="843844" y="79678"/>
                      <a:pt x="835656" y="87866"/>
                      <a:pt x="825556" y="87866"/>
                    </a:cubicBezTo>
                    <a:cubicBezTo>
                      <a:pt x="815456" y="87866"/>
                      <a:pt x="807268" y="79678"/>
                      <a:pt x="807268" y="69578"/>
                    </a:cubicBezTo>
                    <a:cubicBezTo>
                      <a:pt x="807268" y="59478"/>
                      <a:pt x="815456" y="51290"/>
                      <a:pt x="825556" y="51290"/>
                    </a:cubicBezTo>
                    <a:close/>
                    <a:moveTo>
                      <a:pt x="767894" y="51290"/>
                    </a:moveTo>
                    <a:cubicBezTo>
                      <a:pt x="777994" y="51290"/>
                      <a:pt x="786182" y="59478"/>
                      <a:pt x="786182" y="69578"/>
                    </a:cubicBezTo>
                    <a:cubicBezTo>
                      <a:pt x="786182" y="79678"/>
                      <a:pt x="777994" y="87866"/>
                      <a:pt x="767894" y="87866"/>
                    </a:cubicBezTo>
                    <a:cubicBezTo>
                      <a:pt x="757794" y="87866"/>
                      <a:pt x="749606" y="79678"/>
                      <a:pt x="749606" y="69578"/>
                    </a:cubicBezTo>
                    <a:cubicBezTo>
                      <a:pt x="749606" y="59478"/>
                      <a:pt x="757794" y="51290"/>
                      <a:pt x="767894" y="51290"/>
                    </a:cubicBezTo>
                    <a:close/>
                    <a:moveTo>
                      <a:pt x="710232" y="51290"/>
                    </a:moveTo>
                    <a:cubicBezTo>
                      <a:pt x="720332" y="51290"/>
                      <a:pt x="728520" y="59478"/>
                      <a:pt x="728520" y="69578"/>
                    </a:cubicBezTo>
                    <a:cubicBezTo>
                      <a:pt x="728520" y="79678"/>
                      <a:pt x="720332" y="87866"/>
                      <a:pt x="710232" y="87866"/>
                    </a:cubicBezTo>
                    <a:cubicBezTo>
                      <a:pt x="700132" y="87866"/>
                      <a:pt x="691944" y="79678"/>
                      <a:pt x="691944" y="69578"/>
                    </a:cubicBezTo>
                    <a:cubicBezTo>
                      <a:pt x="691944" y="59478"/>
                      <a:pt x="700132" y="51290"/>
                      <a:pt x="710232" y="51290"/>
                    </a:cubicBezTo>
                    <a:close/>
                    <a:moveTo>
                      <a:pt x="652570" y="51290"/>
                    </a:moveTo>
                    <a:cubicBezTo>
                      <a:pt x="662670" y="51290"/>
                      <a:pt x="670858" y="59478"/>
                      <a:pt x="670858" y="69578"/>
                    </a:cubicBezTo>
                    <a:cubicBezTo>
                      <a:pt x="670858" y="79678"/>
                      <a:pt x="662670" y="87866"/>
                      <a:pt x="652570" y="87866"/>
                    </a:cubicBezTo>
                    <a:cubicBezTo>
                      <a:pt x="642470" y="87866"/>
                      <a:pt x="634282" y="79678"/>
                      <a:pt x="634282" y="69578"/>
                    </a:cubicBezTo>
                    <a:cubicBezTo>
                      <a:pt x="634282" y="59478"/>
                      <a:pt x="642470" y="51290"/>
                      <a:pt x="652570" y="51290"/>
                    </a:cubicBezTo>
                    <a:close/>
                    <a:moveTo>
                      <a:pt x="594908" y="51290"/>
                    </a:moveTo>
                    <a:cubicBezTo>
                      <a:pt x="605008" y="51290"/>
                      <a:pt x="613196" y="59478"/>
                      <a:pt x="613196" y="69578"/>
                    </a:cubicBezTo>
                    <a:cubicBezTo>
                      <a:pt x="613196" y="79678"/>
                      <a:pt x="605008" y="87866"/>
                      <a:pt x="594908" y="87866"/>
                    </a:cubicBezTo>
                    <a:cubicBezTo>
                      <a:pt x="584808" y="87866"/>
                      <a:pt x="576620" y="79678"/>
                      <a:pt x="576620" y="69578"/>
                    </a:cubicBezTo>
                    <a:cubicBezTo>
                      <a:pt x="576620" y="59478"/>
                      <a:pt x="584808" y="51290"/>
                      <a:pt x="594908" y="51290"/>
                    </a:cubicBezTo>
                    <a:close/>
                    <a:moveTo>
                      <a:pt x="537246" y="51290"/>
                    </a:moveTo>
                    <a:cubicBezTo>
                      <a:pt x="547346" y="51290"/>
                      <a:pt x="555534" y="59478"/>
                      <a:pt x="555534" y="69578"/>
                    </a:cubicBezTo>
                    <a:cubicBezTo>
                      <a:pt x="555534" y="79678"/>
                      <a:pt x="547346" y="87866"/>
                      <a:pt x="537246" y="87866"/>
                    </a:cubicBezTo>
                    <a:cubicBezTo>
                      <a:pt x="527146" y="87866"/>
                      <a:pt x="518958" y="79678"/>
                      <a:pt x="518958" y="69578"/>
                    </a:cubicBezTo>
                    <a:cubicBezTo>
                      <a:pt x="518958" y="59478"/>
                      <a:pt x="527146" y="51290"/>
                      <a:pt x="537246" y="51290"/>
                    </a:cubicBezTo>
                    <a:close/>
                    <a:moveTo>
                      <a:pt x="479584" y="51290"/>
                    </a:moveTo>
                    <a:cubicBezTo>
                      <a:pt x="489684" y="51290"/>
                      <a:pt x="497872" y="59478"/>
                      <a:pt x="497872" y="69578"/>
                    </a:cubicBezTo>
                    <a:cubicBezTo>
                      <a:pt x="497872" y="79678"/>
                      <a:pt x="489684" y="87866"/>
                      <a:pt x="479584" y="87866"/>
                    </a:cubicBezTo>
                    <a:cubicBezTo>
                      <a:pt x="469484" y="87866"/>
                      <a:pt x="461296" y="79678"/>
                      <a:pt x="461296" y="69578"/>
                    </a:cubicBezTo>
                    <a:cubicBezTo>
                      <a:pt x="461296" y="59478"/>
                      <a:pt x="469484" y="51290"/>
                      <a:pt x="479584" y="51290"/>
                    </a:cubicBezTo>
                    <a:close/>
                    <a:moveTo>
                      <a:pt x="421922" y="51290"/>
                    </a:moveTo>
                    <a:cubicBezTo>
                      <a:pt x="432022" y="51290"/>
                      <a:pt x="440210" y="59478"/>
                      <a:pt x="440210" y="69578"/>
                    </a:cubicBezTo>
                    <a:cubicBezTo>
                      <a:pt x="440210" y="79678"/>
                      <a:pt x="432022" y="87866"/>
                      <a:pt x="421922" y="87866"/>
                    </a:cubicBezTo>
                    <a:cubicBezTo>
                      <a:pt x="411822" y="87866"/>
                      <a:pt x="403634" y="79678"/>
                      <a:pt x="403634" y="69578"/>
                    </a:cubicBezTo>
                    <a:cubicBezTo>
                      <a:pt x="403634" y="59478"/>
                      <a:pt x="411822" y="51290"/>
                      <a:pt x="421922" y="51290"/>
                    </a:cubicBezTo>
                    <a:close/>
                    <a:moveTo>
                      <a:pt x="364260" y="51290"/>
                    </a:moveTo>
                    <a:cubicBezTo>
                      <a:pt x="374360" y="51290"/>
                      <a:pt x="382548" y="59478"/>
                      <a:pt x="382548" y="69578"/>
                    </a:cubicBezTo>
                    <a:cubicBezTo>
                      <a:pt x="382548" y="79678"/>
                      <a:pt x="374360" y="87866"/>
                      <a:pt x="364260" y="87866"/>
                    </a:cubicBezTo>
                    <a:cubicBezTo>
                      <a:pt x="354160" y="87866"/>
                      <a:pt x="345972" y="79678"/>
                      <a:pt x="345972" y="69578"/>
                    </a:cubicBezTo>
                    <a:cubicBezTo>
                      <a:pt x="345972" y="59478"/>
                      <a:pt x="354160" y="51290"/>
                      <a:pt x="364260" y="51290"/>
                    </a:cubicBezTo>
                    <a:close/>
                    <a:moveTo>
                      <a:pt x="306598" y="51290"/>
                    </a:moveTo>
                    <a:cubicBezTo>
                      <a:pt x="316698" y="51290"/>
                      <a:pt x="324886" y="59478"/>
                      <a:pt x="324886" y="69578"/>
                    </a:cubicBezTo>
                    <a:cubicBezTo>
                      <a:pt x="324886" y="79678"/>
                      <a:pt x="316698" y="87866"/>
                      <a:pt x="306598" y="87866"/>
                    </a:cubicBezTo>
                    <a:cubicBezTo>
                      <a:pt x="296498" y="87866"/>
                      <a:pt x="288310" y="79678"/>
                      <a:pt x="288310" y="69578"/>
                    </a:cubicBezTo>
                    <a:cubicBezTo>
                      <a:pt x="288310" y="59478"/>
                      <a:pt x="296498" y="51290"/>
                      <a:pt x="306598" y="51290"/>
                    </a:cubicBezTo>
                    <a:close/>
                    <a:moveTo>
                      <a:pt x="248936" y="51290"/>
                    </a:moveTo>
                    <a:cubicBezTo>
                      <a:pt x="259036" y="51290"/>
                      <a:pt x="267224" y="59478"/>
                      <a:pt x="267224" y="69578"/>
                    </a:cubicBezTo>
                    <a:cubicBezTo>
                      <a:pt x="267224" y="79678"/>
                      <a:pt x="259036" y="87866"/>
                      <a:pt x="248936" y="87866"/>
                    </a:cubicBezTo>
                    <a:cubicBezTo>
                      <a:pt x="238836" y="87866"/>
                      <a:pt x="230648" y="79678"/>
                      <a:pt x="230648" y="69578"/>
                    </a:cubicBezTo>
                    <a:cubicBezTo>
                      <a:pt x="230648" y="59478"/>
                      <a:pt x="238836" y="51290"/>
                      <a:pt x="248936" y="51290"/>
                    </a:cubicBezTo>
                    <a:close/>
                    <a:moveTo>
                      <a:pt x="191274" y="51290"/>
                    </a:moveTo>
                    <a:cubicBezTo>
                      <a:pt x="201374" y="51290"/>
                      <a:pt x="209562" y="59478"/>
                      <a:pt x="209562" y="69578"/>
                    </a:cubicBezTo>
                    <a:cubicBezTo>
                      <a:pt x="209562" y="79678"/>
                      <a:pt x="201374" y="87866"/>
                      <a:pt x="191274" y="87866"/>
                    </a:cubicBezTo>
                    <a:cubicBezTo>
                      <a:pt x="181174" y="87866"/>
                      <a:pt x="172986" y="79678"/>
                      <a:pt x="172986" y="69578"/>
                    </a:cubicBezTo>
                    <a:cubicBezTo>
                      <a:pt x="172986" y="59478"/>
                      <a:pt x="181174" y="51290"/>
                      <a:pt x="191274" y="51290"/>
                    </a:cubicBezTo>
                    <a:close/>
                    <a:moveTo>
                      <a:pt x="133612" y="51290"/>
                    </a:moveTo>
                    <a:cubicBezTo>
                      <a:pt x="143712" y="51290"/>
                      <a:pt x="151900" y="59478"/>
                      <a:pt x="151900" y="69578"/>
                    </a:cubicBezTo>
                    <a:cubicBezTo>
                      <a:pt x="151900" y="79678"/>
                      <a:pt x="143712" y="87866"/>
                      <a:pt x="133612" y="87866"/>
                    </a:cubicBezTo>
                    <a:cubicBezTo>
                      <a:pt x="123512" y="87866"/>
                      <a:pt x="115324" y="79678"/>
                      <a:pt x="115324" y="69578"/>
                    </a:cubicBezTo>
                    <a:cubicBezTo>
                      <a:pt x="115324" y="59478"/>
                      <a:pt x="123512" y="51290"/>
                      <a:pt x="133612" y="51290"/>
                    </a:cubicBezTo>
                    <a:close/>
                    <a:moveTo>
                      <a:pt x="75950" y="51290"/>
                    </a:moveTo>
                    <a:cubicBezTo>
                      <a:pt x="86050" y="51290"/>
                      <a:pt x="94238" y="59478"/>
                      <a:pt x="94238" y="69578"/>
                    </a:cubicBezTo>
                    <a:cubicBezTo>
                      <a:pt x="94238" y="79678"/>
                      <a:pt x="86050" y="87866"/>
                      <a:pt x="75950" y="87866"/>
                    </a:cubicBezTo>
                    <a:cubicBezTo>
                      <a:pt x="65850" y="87866"/>
                      <a:pt x="57662" y="79678"/>
                      <a:pt x="57662" y="69578"/>
                    </a:cubicBezTo>
                    <a:cubicBezTo>
                      <a:pt x="57662" y="59478"/>
                      <a:pt x="65850" y="51290"/>
                      <a:pt x="75950" y="51290"/>
                    </a:cubicBezTo>
                    <a:close/>
                    <a:moveTo>
                      <a:pt x="18288" y="51290"/>
                    </a:moveTo>
                    <a:cubicBezTo>
                      <a:pt x="28388" y="51290"/>
                      <a:pt x="36576" y="59478"/>
                      <a:pt x="36576" y="69578"/>
                    </a:cubicBezTo>
                    <a:cubicBezTo>
                      <a:pt x="36576" y="79678"/>
                      <a:pt x="28388" y="87866"/>
                      <a:pt x="18288" y="87866"/>
                    </a:cubicBezTo>
                    <a:cubicBezTo>
                      <a:pt x="8188" y="87866"/>
                      <a:pt x="0" y="79678"/>
                      <a:pt x="0" y="69578"/>
                    </a:cubicBezTo>
                    <a:cubicBezTo>
                      <a:pt x="0" y="59478"/>
                      <a:pt x="8188" y="51290"/>
                      <a:pt x="18288" y="51290"/>
                    </a:cubicBezTo>
                    <a:close/>
                    <a:moveTo>
                      <a:pt x="1459848" y="0"/>
                    </a:moveTo>
                    <a:cubicBezTo>
                      <a:pt x="1469948" y="0"/>
                      <a:pt x="1478136" y="8188"/>
                      <a:pt x="1478136" y="18288"/>
                    </a:cubicBezTo>
                    <a:cubicBezTo>
                      <a:pt x="1478136" y="28388"/>
                      <a:pt x="1469948" y="36576"/>
                      <a:pt x="1459848" y="36576"/>
                    </a:cubicBezTo>
                    <a:cubicBezTo>
                      <a:pt x="1449748" y="36576"/>
                      <a:pt x="1441560" y="28388"/>
                      <a:pt x="1441560" y="18288"/>
                    </a:cubicBezTo>
                    <a:cubicBezTo>
                      <a:pt x="1441560" y="8188"/>
                      <a:pt x="1449748" y="0"/>
                      <a:pt x="1459848" y="0"/>
                    </a:cubicBezTo>
                    <a:close/>
                    <a:moveTo>
                      <a:pt x="1402176" y="0"/>
                    </a:moveTo>
                    <a:cubicBezTo>
                      <a:pt x="1412276" y="0"/>
                      <a:pt x="1420464" y="8188"/>
                      <a:pt x="1420464" y="18288"/>
                    </a:cubicBezTo>
                    <a:cubicBezTo>
                      <a:pt x="1420464" y="28388"/>
                      <a:pt x="1412276" y="36576"/>
                      <a:pt x="1402176" y="36576"/>
                    </a:cubicBezTo>
                    <a:cubicBezTo>
                      <a:pt x="1392076" y="36576"/>
                      <a:pt x="1383888" y="28388"/>
                      <a:pt x="1383888" y="18288"/>
                    </a:cubicBezTo>
                    <a:cubicBezTo>
                      <a:pt x="1383888" y="8188"/>
                      <a:pt x="1392076" y="0"/>
                      <a:pt x="1402176" y="0"/>
                    </a:cubicBezTo>
                    <a:close/>
                    <a:moveTo>
                      <a:pt x="1344514" y="0"/>
                    </a:moveTo>
                    <a:cubicBezTo>
                      <a:pt x="1354614" y="0"/>
                      <a:pt x="1362802" y="8188"/>
                      <a:pt x="1362802" y="18288"/>
                    </a:cubicBezTo>
                    <a:cubicBezTo>
                      <a:pt x="1362802" y="28388"/>
                      <a:pt x="1354614" y="36576"/>
                      <a:pt x="1344514" y="36576"/>
                    </a:cubicBezTo>
                    <a:cubicBezTo>
                      <a:pt x="1334414" y="36576"/>
                      <a:pt x="1326226" y="28388"/>
                      <a:pt x="1326226" y="18288"/>
                    </a:cubicBezTo>
                    <a:cubicBezTo>
                      <a:pt x="1326226" y="8188"/>
                      <a:pt x="1334414" y="0"/>
                      <a:pt x="1344514" y="0"/>
                    </a:cubicBezTo>
                    <a:close/>
                    <a:moveTo>
                      <a:pt x="1286852" y="0"/>
                    </a:moveTo>
                    <a:cubicBezTo>
                      <a:pt x="1296952" y="0"/>
                      <a:pt x="1305140" y="8188"/>
                      <a:pt x="1305140" y="18288"/>
                    </a:cubicBezTo>
                    <a:cubicBezTo>
                      <a:pt x="1305140" y="28388"/>
                      <a:pt x="1296952" y="36576"/>
                      <a:pt x="1286852" y="36576"/>
                    </a:cubicBezTo>
                    <a:cubicBezTo>
                      <a:pt x="1276752" y="36576"/>
                      <a:pt x="1268564" y="28388"/>
                      <a:pt x="1268564" y="18288"/>
                    </a:cubicBezTo>
                    <a:cubicBezTo>
                      <a:pt x="1268564" y="8188"/>
                      <a:pt x="1276752" y="0"/>
                      <a:pt x="1286852" y="0"/>
                    </a:cubicBezTo>
                    <a:close/>
                    <a:moveTo>
                      <a:pt x="1229190" y="0"/>
                    </a:moveTo>
                    <a:cubicBezTo>
                      <a:pt x="1239290" y="0"/>
                      <a:pt x="1247478" y="8188"/>
                      <a:pt x="1247478" y="18288"/>
                    </a:cubicBezTo>
                    <a:cubicBezTo>
                      <a:pt x="1247478" y="28388"/>
                      <a:pt x="1239290" y="36576"/>
                      <a:pt x="1229190" y="36576"/>
                    </a:cubicBezTo>
                    <a:cubicBezTo>
                      <a:pt x="1219090" y="36576"/>
                      <a:pt x="1210902" y="28388"/>
                      <a:pt x="1210902" y="18288"/>
                    </a:cubicBezTo>
                    <a:cubicBezTo>
                      <a:pt x="1210902" y="8188"/>
                      <a:pt x="1219090" y="0"/>
                      <a:pt x="1229190" y="0"/>
                    </a:cubicBezTo>
                    <a:close/>
                    <a:moveTo>
                      <a:pt x="1171528" y="0"/>
                    </a:moveTo>
                    <a:cubicBezTo>
                      <a:pt x="1181628" y="0"/>
                      <a:pt x="1189816" y="8188"/>
                      <a:pt x="1189816" y="18288"/>
                    </a:cubicBezTo>
                    <a:cubicBezTo>
                      <a:pt x="1189816" y="28388"/>
                      <a:pt x="1181628" y="36576"/>
                      <a:pt x="1171528" y="36576"/>
                    </a:cubicBezTo>
                    <a:cubicBezTo>
                      <a:pt x="1161428" y="36576"/>
                      <a:pt x="1153240" y="28388"/>
                      <a:pt x="1153240" y="18288"/>
                    </a:cubicBezTo>
                    <a:cubicBezTo>
                      <a:pt x="1153240" y="8188"/>
                      <a:pt x="1161428" y="0"/>
                      <a:pt x="1171528" y="0"/>
                    </a:cubicBezTo>
                    <a:close/>
                    <a:moveTo>
                      <a:pt x="1113866" y="0"/>
                    </a:moveTo>
                    <a:cubicBezTo>
                      <a:pt x="1123966" y="0"/>
                      <a:pt x="1132154" y="8188"/>
                      <a:pt x="1132154" y="18288"/>
                    </a:cubicBezTo>
                    <a:cubicBezTo>
                      <a:pt x="1132154" y="28388"/>
                      <a:pt x="1123966" y="36576"/>
                      <a:pt x="1113866" y="36576"/>
                    </a:cubicBezTo>
                    <a:cubicBezTo>
                      <a:pt x="1103766" y="36576"/>
                      <a:pt x="1095578" y="28388"/>
                      <a:pt x="1095578" y="18288"/>
                    </a:cubicBezTo>
                    <a:cubicBezTo>
                      <a:pt x="1095578" y="8188"/>
                      <a:pt x="1103766" y="0"/>
                      <a:pt x="1113866" y="0"/>
                    </a:cubicBezTo>
                    <a:close/>
                    <a:moveTo>
                      <a:pt x="1056204" y="0"/>
                    </a:moveTo>
                    <a:cubicBezTo>
                      <a:pt x="1066304" y="0"/>
                      <a:pt x="1074492" y="8188"/>
                      <a:pt x="1074492" y="18288"/>
                    </a:cubicBezTo>
                    <a:cubicBezTo>
                      <a:pt x="1074492" y="28388"/>
                      <a:pt x="1066304" y="36576"/>
                      <a:pt x="1056204" y="36576"/>
                    </a:cubicBezTo>
                    <a:cubicBezTo>
                      <a:pt x="1046104" y="36576"/>
                      <a:pt x="1037916" y="28388"/>
                      <a:pt x="1037916" y="18288"/>
                    </a:cubicBezTo>
                    <a:cubicBezTo>
                      <a:pt x="1037916" y="8188"/>
                      <a:pt x="1046104" y="0"/>
                      <a:pt x="1056204" y="0"/>
                    </a:cubicBezTo>
                    <a:close/>
                    <a:moveTo>
                      <a:pt x="998542" y="0"/>
                    </a:moveTo>
                    <a:cubicBezTo>
                      <a:pt x="1008642" y="0"/>
                      <a:pt x="1016830" y="8188"/>
                      <a:pt x="1016830" y="18288"/>
                    </a:cubicBezTo>
                    <a:cubicBezTo>
                      <a:pt x="1016830" y="28388"/>
                      <a:pt x="1008642" y="36576"/>
                      <a:pt x="998542" y="36576"/>
                    </a:cubicBezTo>
                    <a:cubicBezTo>
                      <a:pt x="988442" y="36576"/>
                      <a:pt x="980254" y="28388"/>
                      <a:pt x="980254" y="18288"/>
                    </a:cubicBezTo>
                    <a:cubicBezTo>
                      <a:pt x="980254" y="8188"/>
                      <a:pt x="988442" y="0"/>
                      <a:pt x="998542" y="0"/>
                    </a:cubicBezTo>
                    <a:close/>
                    <a:moveTo>
                      <a:pt x="940880" y="0"/>
                    </a:moveTo>
                    <a:cubicBezTo>
                      <a:pt x="950980" y="0"/>
                      <a:pt x="959168" y="8188"/>
                      <a:pt x="959168" y="18288"/>
                    </a:cubicBezTo>
                    <a:cubicBezTo>
                      <a:pt x="959168" y="28388"/>
                      <a:pt x="950980" y="36576"/>
                      <a:pt x="940880" y="36576"/>
                    </a:cubicBezTo>
                    <a:cubicBezTo>
                      <a:pt x="930780" y="36576"/>
                      <a:pt x="922592" y="28388"/>
                      <a:pt x="922592" y="18288"/>
                    </a:cubicBezTo>
                    <a:cubicBezTo>
                      <a:pt x="922592" y="8188"/>
                      <a:pt x="930780" y="0"/>
                      <a:pt x="940880" y="0"/>
                    </a:cubicBezTo>
                    <a:close/>
                    <a:moveTo>
                      <a:pt x="883218" y="0"/>
                    </a:moveTo>
                    <a:cubicBezTo>
                      <a:pt x="893318" y="0"/>
                      <a:pt x="901506" y="8188"/>
                      <a:pt x="901506" y="18288"/>
                    </a:cubicBezTo>
                    <a:cubicBezTo>
                      <a:pt x="901506" y="28388"/>
                      <a:pt x="893318" y="36576"/>
                      <a:pt x="883218" y="36576"/>
                    </a:cubicBezTo>
                    <a:cubicBezTo>
                      <a:pt x="873118" y="36576"/>
                      <a:pt x="864930" y="28388"/>
                      <a:pt x="864930" y="18288"/>
                    </a:cubicBezTo>
                    <a:cubicBezTo>
                      <a:pt x="864930" y="8188"/>
                      <a:pt x="873118" y="0"/>
                      <a:pt x="883218" y="0"/>
                    </a:cubicBezTo>
                    <a:close/>
                    <a:moveTo>
                      <a:pt x="825556" y="0"/>
                    </a:moveTo>
                    <a:cubicBezTo>
                      <a:pt x="835656" y="0"/>
                      <a:pt x="843844" y="8188"/>
                      <a:pt x="843844" y="18288"/>
                    </a:cubicBezTo>
                    <a:cubicBezTo>
                      <a:pt x="843844" y="28388"/>
                      <a:pt x="835656" y="36576"/>
                      <a:pt x="825556" y="36576"/>
                    </a:cubicBezTo>
                    <a:cubicBezTo>
                      <a:pt x="815456" y="36576"/>
                      <a:pt x="807268" y="28388"/>
                      <a:pt x="807268" y="18288"/>
                    </a:cubicBezTo>
                    <a:cubicBezTo>
                      <a:pt x="807268" y="8188"/>
                      <a:pt x="815456" y="0"/>
                      <a:pt x="825556" y="0"/>
                    </a:cubicBezTo>
                    <a:close/>
                    <a:moveTo>
                      <a:pt x="767894" y="0"/>
                    </a:moveTo>
                    <a:cubicBezTo>
                      <a:pt x="777994" y="0"/>
                      <a:pt x="786182" y="8188"/>
                      <a:pt x="786182" y="18288"/>
                    </a:cubicBezTo>
                    <a:cubicBezTo>
                      <a:pt x="786182" y="28388"/>
                      <a:pt x="777994" y="36576"/>
                      <a:pt x="767894" y="36576"/>
                    </a:cubicBezTo>
                    <a:cubicBezTo>
                      <a:pt x="757794" y="36576"/>
                      <a:pt x="749606" y="28388"/>
                      <a:pt x="749606" y="18288"/>
                    </a:cubicBezTo>
                    <a:cubicBezTo>
                      <a:pt x="749606" y="8188"/>
                      <a:pt x="757794" y="0"/>
                      <a:pt x="767894" y="0"/>
                    </a:cubicBezTo>
                    <a:close/>
                    <a:moveTo>
                      <a:pt x="710232" y="0"/>
                    </a:moveTo>
                    <a:cubicBezTo>
                      <a:pt x="720332" y="0"/>
                      <a:pt x="728520" y="8188"/>
                      <a:pt x="728520" y="18288"/>
                    </a:cubicBezTo>
                    <a:cubicBezTo>
                      <a:pt x="728520" y="28388"/>
                      <a:pt x="720332" y="36576"/>
                      <a:pt x="710232" y="36576"/>
                    </a:cubicBezTo>
                    <a:cubicBezTo>
                      <a:pt x="700132" y="36576"/>
                      <a:pt x="691944" y="28388"/>
                      <a:pt x="691944" y="18288"/>
                    </a:cubicBezTo>
                    <a:cubicBezTo>
                      <a:pt x="691944" y="8188"/>
                      <a:pt x="700132" y="0"/>
                      <a:pt x="710232" y="0"/>
                    </a:cubicBezTo>
                    <a:close/>
                    <a:moveTo>
                      <a:pt x="652570" y="0"/>
                    </a:moveTo>
                    <a:cubicBezTo>
                      <a:pt x="662670" y="0"/>
                      <a:pt x="670858" y="8188"/>
                      <a:pt x="670858" y="18288"/>
                    </a:cubicBezTo>
                    <a:cubicBezTo>
                      <a:pt x="670858" y="28388"/>
                      <a:pt x="662670" y="36576"/>
                      <a:pt x="652570" y="36576"/>
                    </a:cubicBezTo>
                    <a:cubicBezTo>
                      <a:pt x="642470" y="36576"/>
                      <a:pt x="634282" y="28388"/>
                      <a:pt x="634282" y="18288"/>
                    </a:cubicBezTo>
                    <a:cubicBezTo>
                      <a:pt x="634282" y="8188"/>
                      <a:pt x="642470" y="0"/>
                      <a:pt x="652570" y="0"/>
                    </a:cubicBezTo>
                    <a:close/>
                    <a:moveTo>
                      <a:pt x="594908" y="0"/>
                    </a:moveTo>
                    <a:cubicBezTo>
                      <a:pt x="605008" y="0"/>
                      <a:pt x="613196" y="8188"/>
                      <a:pt x="613196" y="18288"/>
                    </a:cubicBezTo>
                    <a:cubicBezTo>
                      <a:pt x="613196" y="28388"/>
                      <a:pt x="605008" y="36576"/>
                      <a:pt x="594908" y="36576"/>
                    </a:cubicBezTo>
                    <a:cubicBezTo>
                      <a:pt x="584808" y="36576"/>
                      <a:pt x="576620" y="28388"/>
                      <a:pt x="576620" y="18288"/>
                    </a:cubicBezTo>
                    <a:cubicBezTo>
                      <a:pt x="576620" y="8188"/>
                      <a:pt x="584808" y="0"/>
                      <a:pt x="594908" y="0"/>
                    </a:cubicBezTo>
                    <a:close/>
                    <a:moveTo>
                      <a:pt x="537246" y="0"/>
                    </a:moveTo>
                    <a:cubicBezTo>
                      <a:pt x="547346" y="0"/>
                      <a:pt x="555534" y="8188"/>
                      <a:pt x="555534" y="18288"/>
                    </a:cubicBezTo>
                    <a:cubicBezTo>
                      <a:pt x="555534" y="28388"/>
                      <a:pt x="547346" y="36576"/>
                      <a:pt x="537246" y="36576"/>
                    </a:cubicBezTo>
                    <a:cubicBezTo>
                      <a:pt x="527146" y="36576"/>
                      <a:pt x="518958" y="28388"/>
                      <a:pt x="518958" y="18288"/>
                    </a:cubicBezTo>
                    <a:cubicBezTo>
                      <a:pt x="518958" y="8188"/>
                      <a:pt x="527146" y="0"/>
                      <a:pt x="537246" y="0"/>
                    </a:cubicBezTo>
                    <a:close/>
                    <a:moveTo>
                      <a:pt x="479584" y="0"/>
                    </a:moveTo>
                    <a:cubicBezTo>
                      <a:pt x="489684" y="0"/>
                      <a:pt x="497872" y="8188"/>
                      <a:pt x="497872" y="18288"/>
                    </a:cubicBezTo>
                    <a:cubicBezTo>
                      <a:pt x="497872" y="28388"/>
                      <a:pt x="489684" y="36576"/>
                      <a:pt x="479584" y="36576"/>
                    </a:cubicBezTo>
                    <a:cubicBezTo>
                      <a:pt x="469484" y="36576"/>
                      <a:pt x="461296" y="28388"/>
                      <a:pt x="461296" y="18288"/>
                    </a:cubicBezTo>
                    <a:cubicBezTo>
                      <a:pt x="461296" y="8188"/>
                      <a:pt x="469484" y="0"/>
                      <a:pt x="479584" y="0"/>
                    </a:cubicBezTo>
                    <a:close/>
                    <a:moveTo>
                      <a:pt x="421922" y="0"/>
                    </a:moveTo>
                    <a:cubicBezTo>
                      <a:pt x="432022" y="0"/>
                      <a:pt x="440210" y="8188"/>
                      <a:pt x="440210" y="18288"/>
                    </a:cubicBezTo>
                    <a:cubicBezTo>
                      <a:pt x="440210" y="28388"/>
                      <a:pt x="432022" y="36576"/>
                      <a:pt x="421922" y="36576"/>
                    </a:cubicBezTo>
                    <a:cubicBezTo>
                      <a:pt x="411822" y="36576"/>
                      <a:pt x="403634" y="28388"/>
                      <a:pt x="403634" y="18288"/>
                    </a:cubicBezTo>
                    <a:cubicBezTo>
                      <a:pt x="403634" y="8188"/>
                      <a:pt x="411822" y="0"/>
                      <a:pt x="421922" y="0"/>
                    </a:cubicBezTo>
                    <a:close/>
                    <a:moveTo>
                      <a:pt x="364260" y="0"/>
                    </a:moveTo>
                    <a:cubicBezTo>
                      <a:pt x="374360" y="0"/>
                      <a:pt x="382548" y="8188"/>
                      <a:pt x="382548" y="18288"/>
                    </a:cubicBezTo>
                    <a:cubicBezTo>
                      <a:pt x="382548" y="28388"/>
                      <a:pt x="374360" y="36576"/>
                      <a:pt x="364260" y="36576"/>
                    </a:cubicBezTo>
                    <a:cubicBezTo>
                      <a:pt x="354160" y="36576"/>
                      <a:pt x="345972" y="28388"/>
                      <a:pt x="345972" y="18288"/>
                    </a:cubicBezTo>
                    <a:cubicBezTo>
                      <a:pt x="345972" y="8188"/>
                      <a:pt x="354160" y="0"/>
                      <a:pt x="364260" y="0"/>
                    </a:cubicBezTo>
                    <a:close/>
                    <a:moveTo>
                      <a:pt x="306598" y="0"/>
                    </a:moveTo>
                    <a:cubicBezTo>
                      <a:pt x="316698" y="0"/>
                      <a:pt x="324886" y="8188"/>
                      <a:pt x="324886" y="18288"/>
                    </a:cubicBezTo>
                    <a:cubicBezTo>
                      <a:pt x="324886" y="28388"/>
                      <a:pt x="316698" y="36576"/>
                      <a:pt x="306598" y="36576"/>
                    </a:cubicBezTo>
                    <a:cubicBezTo>
                      <a:pt x="296498" y="36576"/>
                      <a:pt x="288310" y="28388"/>
                      <a:pt x="288310" y="18288"/>
                    </a:cubicBezTo>
                    <a:cubicBezTo>
                      <a:pt x="288310" y="8188"/>
                      <a:pt x="296498" y="0"/>
                      <a:pt x="306598" y="0"/>
                    </a:cubicBezTo>
                    <a:close/>
                    <a:moveTo>
                      <a:pt x="248936" y="0"/>
                    </a:moveTo>
                    <a:cubicBezTo>
                      <a:pt x="259036" y="0"/>
                      <a:pt x="267224" y="8188"/>
                      <a:pt x="267224" y="18288"/>
                    </a:cubicBezTo>
                    <a:cubicBezTo>
                      <a:pt x="267224" y="28388"/>
                      <a:pt x="259036" y="36576"/>
                      <a:pt x="248936" y="36576"/>
                    </a:cubicBezTo>
                    <a:cubicBezTo>
                      <a:pt x="238836" y="36576"/>
                      <a:pt x="230648" y="28388"/>
                      <a:pt x="230648" y="18288"/>
                    </a:cubicBezTo>
                    <a:cubicBezTo>
                      <a:pt x="230648" y="8188"/>
                      <a:pt x="238836" y="0"/>
                      <a:pt x="248936" y="0"/>
                    </a:cubicBezTo>
                    <a:close/>
                    <a:moveTo>
                      <a:pt x="191274" y="0"/>
                    </a:moveTo>
                    <a:cubicBezTo>
                      <a:pt x="201374" y="0"/>
                      <a:pt x="209562" y="8188"/>
                      <a:pt x="209562" y="18288"/>
                    </a:cubicBezTo>
                    <a:cubicBezTo>
                      <a:pt x="209562" y="28388"/>
                      <a:pt x="201374" y="36576"/>
                      <a:pt x="191274" y="36576"/>
                    </a:cubicBezTo>
                    <a:cubicBezTo>
                      <a:pt x="181174" y="36576"/>
                      <a:pt x="172986" y="28388"/>
                      <a:pt x="172986" y="18288"/>
                    </a:cubicBezTo>
                    <a:cubicBezTo>
                      <a:pt x="172986" y="8188"/>
                      <a:pt x="181174" y="0"/>
                      <a:pt x="191274" y="0"/>
                    </a:cubicBezTo>
                    <a:close/>
                    <a:moveTo>
                      <a:pt x="133612" y="0"/>
                    </a:moveTo>
                    <a:cubicBezTo>
                      <a:pt x="143712" y="0"/>
                      <a:pt x="151900" y="8188"/>
                      <a:pt x="151900" y="18288"/>
                    </a:cubicBezTo>
                    <a:cubicBezTo>
                      <a:pt x="151900" y="28388"/>
                      <a:pt x="143712" y="36576"/>
                      <a:pt x="133612" y="36576"/>
                    </a:cubicBezTo>
                    <a:cubicBezTo>
                      <a:pt x="123512" y="36576"/>
                      <a:pt x="115324" y="28388"/>
                      <a:pt x="115324" y="18288"/>
                    </a:cubicBezTo>
                    <a:cubicBezTo>
                      <a:pt x="115324" y="8188"/>
                      <a:pt x="123512" y="0"/>
                      <a:pt x="133612" y="0"/>
                    </a:cubicBezTo>
                    <a:close/>
                    <a:moveTo>
                      <a:pt x="75950" y="0"/>
                    </a:moveTo>
                    <a:cubicBezTo>
                      <a:pt x="86050" y="0"/>
                      <a:pt x="94238" y="8188"/>
                      <a:pt x="94238" y="18288"/>
                    </a:cubicBezTo>
                    <a:cubicBezTo>
                      <a:pt x="94238" y="28388"/>
                      <a:pt x="86050" y="36576"/>
                      <a:pt x="75950" y="36576"/>
                    </a:cubicBezTo>
                    <a:cubicBezTo>
                      <a:pt x="65850" y="36576"/>
                      <a:pt x="57662" y="28388"/>
                      <a:pt x="57662" y="18288"/>
                    </a:cubicBezTo>
                    <a:cubicBezTo>
                      <a:pt x="57662" y="8188"/>
                      <a:pt x="65850" y="0"/>
                      <a:pt x="75950" y="0"/>
                    </a:cubicBezTo>
                    <a:close/>
                    <a:moveTo>
                      <a:pt x="18288" y="0"/>
                    </a:moveTo>
                    <a:cubicBezTo>
                      <a:pt x="28388" y="0"/>
                      <a:pt x="36576" y="8188"/>
                      <a:pt x="36576" y="18288"/>
                    </a:cubicBezTo>
                    <a:cubicBezTo>
                      <a:pt x="36576" y="28388"/>
                      <a:pt x="28388" y="36576"/>
                      <a:pt x="18288" y="36576"/>
                    </a:cubicBezTo>
                    <a:cubicBezTo>
                      <a:pt x="8188" y="36576"/>
                      <a:pt x="0" y="28388"/>
                      <a:pt x="0" y="18288"/>
                    </a:cubicBezTo>
                    <a:cubicBezTo>
                      <a:pt x="0" y="8188"/>
                      <a:pt x="8188" y="0"/>
                      <a:pt x="18288" y="0"/>
                    </a:cubicBezTo>
                    <a:close/>
                  </a:path>
                </a:pathLst>
              </a:custGeom>
              <a:solidFill>
                <a:srgbClr val="3A7A64"/>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2000"/>
                  <a:buFont typeface="Arial"/>
                  <a:buNone/>
                </a:pPr>
                <a:endParaRPr sz="2000" b="0" i="0" u="none" strike="noStrike" cap="none">
                  <a:solidFill>
                    <a:schemeClr val="lt1"/>
                  </a:solidFill>
                  <a:latin typeface="Calibri"/>
                  <a:ea typeface="Calibri"/>
                  <a:cs typeface="Calibri"/>
                  <a:sym typeface="Calibri"/>
                </a:endParaRPr>
              </a:p>
            </p:txBody>
          </p:sp>
        </p:grpSp>
        <p:pic>
          <p:nvPicPr>
            <p:cNvPr id="116" name="Google Shape;116;p2"/>
            <p:cNvPicPr preferRelativeResize="0"/>
            <p:nvPr/>
          </p:nvPicPr>
          <p:blipFill rotWithShape="1">
            <a:blip r:embed="rId3">
              <a:alphaModFix/>
            </a:blip>
            <a:srcRect/>
            <a:stretch/>
          </p:blipFill>
          <p:spPr>
            <a:xfrm>
              <a:off x="3701848" y="777116"/>
              <a:ext cx="262278" cy="862069"/>
            </a:xfrm>
            <a:prstGeom prst="rect">
              <a:avLst/>
            </a:prstGeom>
            <a:noFill/>
            <a:ln>
              <a:noFill/>
            </a:ln>
          </p:spPr>
        </p:pic>
        <p:cxnSp>
          <p:nvCxnSpPr>
            <p:cNvPr id="117" name="Google Shape;117;p2"/>
            <p:cNvCxnSpPr/>
            <p:nvPr/>
          </p:nvCxnSpPr>
          <p:spPr>
            <a:xfrm>
              <a:off x="4231795" y="1234939"/>
              <a:ext cx="510894" cy="0"/>
            </a:xfrm>
            <a:prstGeom prst="straightConnector1">
              <a:avLst/>
            </a:prstGeom>
            <a:noFill/>
            <a:ln w="25400" cap="flat" cmpd="sng">
              <a:solidFill>
                <a:schemeClr val="dk1"/>
              </a:solidFill>
              <a:prstDash val="solid"/>
              <a:miter lim="800000"/>
              <a:headEnd type="none" w="sm" len="sm"/>
              <a:tailEnd type="none" w="sm" len="sm"/>
            </a:ln>
          </p:spPr>
        </p:cxnSp>
        <p:sp>
          <p:nvSpPr>
            <p:cNvPr id="118" name="Google Shape;118;p2"/>
            <p:cNvSpPr txBox="1"/>
            <p:nvPr/>
          </p:nvSpPr>
          <p:spPr>
            <a:xfrm>
              <a:off x="4190150" y="1247501"/>
              <a:ext cx="596638"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Aliquot</a:t>
              </a:r>
              <a:endParaRPr sz="1400" b="0" i="0" u="none" strike="noStrike" cap="none">
                <a:solidFill>
                  <a:srgbClr val="000000"/>
                </a:solidFill>
                <a:latin typeface="Arial"/>
                <a:ea typeface="Arial"/>
                <a:cs typeface="Arial"/>
                <a:sym typeface="Arial"/>
              </a:endParaRPr>
            </a:p>
          </p:txBody>
        </p:sp>
        <p:sp>
          <p:nvSpPr>
            <p:cNvPr id="119" name="Google Shape;119;p2"/>
            <p:cNvSpPr txBox="1"/>
            <p:nvPr/>
          </p:nvSpPr>
          <p:spPr>
            <a:xfrm>
              <a:off x="1187752" y="1764211"/>
              <a:ext cx="1211126" cy="246221"/>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The CLiP mutants</a:t>
              </a:r>
              <a:endParaRPr sz="1400" b="0" i="0" u="none" strike="noStrike" cap="none">
                <a:solidFill>
                  <a:srgbClr val="000000"/>
                </a:solidFill>
                <a:latin typeface="Arial"/>
                <a:ea typeface="Arial"/>
                <a:cs typeface="Arial"/>
                <a:sym typeface="Arial"/>
              </a:endParaRPr>
            </a:p>
          </p:txBody>
        </p:sp>
        <p:sp>
          <p:nvSpPr>
            <p:cNvPr id="120" name="Google Shape;120;p2"/>
            <p:cNvSpPr/>
            <p:nvPr/>
          </p:nvSpPr>
          <p:spPr>
            <a:xfrm>
              <a:off x="1155449" y="3992187"/>
              <a:ext cx="1645920" cy="663346"/>
            </a:xfrm>
            <a:prstGeom prst="roundRect">
              <a:avLst>
                <a:gd name="adj" fmla="val 16667"/>
              </a:avLst>
            </a:prstGeom>
            <a:gradFill>
              <a:gsLst>
                <a:gs pos="0">
                  <a:srgbClr val="FF0000"/>
                </a:gs>
                <a:gs pos="74000">
                  <a:srgbClr val="FF0000">
                    <a:alpha val="85098"/>
                  </a:srgbClr>
                </a:gs>
                <a:gs pos="89000">
                  <a:srgbClr val="FF0000">
                    <a:alpha val="60000"/>
                  </a:srgbClr>
                </a:gs>
                <a:gs pos="94500">
                  <a:srgbClr val="FF8080">
                    <a:alpha val="40000"/>
                  </a:srgbClr>
                </a:gs>
                <a:gs pos="100000">
                  <a:srgbClr val="FFFFFF">
                    <a:alpha val="2000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sp>
          <p:nvSpPr>
            <p:cNvPr id="121" name="Google Shape;121;p2"/>
            <p:cNvSpPr/>
            <p:nvPr/>
          </p:nvSpPr>
          <p:spPr>
            <a:xfrm>
              <a:off x="1155449" y="2988982"/>
              <a:ext cx="1645920" cy="719488"/>
            </a:xfrm>
            <a:prstGeom prst="roundRect">
              <a:avLst>
                <a:gd name="adj" fmla="val 16667"/>
              </a:avLst>
            </a:prstGeom>
            <a:gradFill>
              <a:gsLst>
                <a:gs pos="0">
                  <a:srgbClr val="FBE6D6"/>
                </a:gs>
                <a:gs pos="85000">
                  <a:srgbClr val="FBE6D6"/>
                </a:gs>
                <a:gs pos="92000">
                  <a:srgbClr val="FBE6D6">
                    <a:alpha val="49411"/>
                  </a:srgbClr>
                </a:gs>
                <a:gs pos="100000">
                  <a:srgbClr val="FFFFFF">
                    <a:alpha val="20000"/>
                  </a:srgbClr>
                </a:gs>
              </a:gsLst>
              <a:path path="circle">
                <a:fillToRect l="50000" t="50000" r="50000" b="50000"/>
              </a:path>
              <a:tileRect/>
            </a:gra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grpSp>
          <p:nvGrpSpPr>
            <p:cNvPr id="122" name="Google Shape;122;p2"/>
            <p:cNvGrpSpPr/>
            <p:nvPr/>
          </p:nvGrpSpPr>
          <p:grpSpPr>
            <a:xfrm>
              <a:off x="1460113" y="3001159"/>
              <a:ext cx="305250" cy="641525"/>
              <a:chOff x="3945967" y="2628996"/>
              <a:chExt cx="305250" cy="641525"/>
            </a:xfrm>
          </p:grpSpPr>
          <p:sp>
            <p:nvSpPr>
              <p:cNvPr id="123" name="Google Shape;123;p2"/>
              <p:cNvSpPr/>
              <p:nvPr/>
            </p:nvSpPr>
            <p:spPr>
              <a:xfrm>
                <a:off x="3965371" y="3177815"/>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24" name="Google Shape;124;p2"/>
              <p:cNvSpPr/>
              <p:nvPr/>
            </p:nvSpPr>
            <p:spPr>
              <a:xfrm>
                <a:off x="3951460" y="2929034"/>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25" name="Google Shape;125;p2"/>
              <p:cNvSpPr/>
              <p:nvPr/>
            </p:nvSpPr>
            <p:spPr>
              <a:xfrm>
                <a:off x="3965371" y="2866199"/>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26" name="Google Shape;126;p2"/>
              <p:cNvSpPr/>
              <p:nvPr/>
            </p:nvSpPr>
            <p:spPr>
              <a:xfrm>
                <a:off x="4020115" y="2822850"/>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127" name="Google Shape;127;p2"/>
              <p:cNvSpPr/>
              <p:nvPr/>
            </p:nvSpPr>
            <p:spPr>
              <a:xfrm>
                <a:off x="3945967" y="2760773"/>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28" name="Google Shape;128;p2"/>
              <p:cNvSpPr/>
              <p:nvPr/>
            </p:nvSpPr>
            <p:spPr>
              <a:xfrm>
                <a:off x="4025223" y="2745083"/>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29" name="Google Shape;129;p2"/>
              <p:cNvSpPr/>
              <p:nvPr/>
            </p:nvSpPr>
            <p:spPr>
              <a:xfrm>
                <a:off x="4025858" y="2721881"/>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30" name="Google Shape;130;p2"/>
              <p:cNvSpPr/>
              <p:nvPr/>
            </p:nvSpPr>
            <p:spPr>
              <a:xfrm rot="4804356">
                <a:off x="4086508" y="3125170"/>
                <a:ext cx="24258" cy="125311"/>
              </a:xfrm>
              <a:prstGeom prst="roundRect">
                <a:avLst>
                  <a:gd name="adj" fmla="val 16667"/>
                </a:avLst>
              </a:prstGeom>
              <a:solidFill>
                <a:srgbClr val="7F7F7F"/>
              </a:solidFill>
              <a:ln w="1270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grpSp>
            <p:nvGrpSpPr>
              <p:cNvPr id="131" name="Google Shape;131;p2"/>
              <p:cNvGrpSpPr/>
              <p:nvPr/>
            </p:nvGrpSpPr>
            <p:grpSpPr>
              <a:xfrm>
                <a:off x="4102466" y="2980478"/>
                <a:ext cx="113321" cy="219881"/>
                <a:chOff x="4940806" y="3570065"/>
                <a:chExt cx="281753" cy="608662"/>
              </a:xfrm>
            </p:grpSpPr>
            <p:sp>
              <p:nvSpPr>
                <p:cNvPr id="132" name="Google Shape;132;p2"/>
                <p:cNvSpPr/>
                <p:nvPr/>
              </p:nvSpPr>
              <p:spPr>
                <a:xfrm>
                  <a:off x="4940806" y="4095941"/>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33" name="Google Shape;133;p2"/>
                <p:cNvSpPr/>
                <p:nvPr/>
              </p:nvSpPr>
              <p:spPr>
                <a:xfrm>
                  <a:off x="4978936" y="3990103"/>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34" name="Google Shape;134;p2"/>
                <p:cNvSpPr/>
                <p:nvPr/>
              </p:nvSpPr>
              <p:spPr>
                <a:xfrm>
                  <a:off x="5062637" y="4044814"/>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35" name="Google Shape;135;p2"/>
                <p:cNvSpPr/>
                <p:nvPr/>
              </p:nvSpPr>
              <p:spPr>
                <a:xfrm>
                  <a:off x="5050776" y="3872146"/>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36" name="Google Shape;136;p2"/>
                <p:cNvSpPr/>
                <p:nvPr/>
              </p:nvSpPr>
              <p:spPr>
                <a:xfrm>
                  <a:off x="4972600" y="3789846"/>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37" name="Google Shape;137;p2"/>
                <p:cNvSpPr/>
                <p:nvPr/>
              </p:nvSpPr>
              <p:spPr>
                <a:xfrm>
                  <a:off x="5106004" y="3755353"/>
                  <a:ext cx="67089" cy="105418"/>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38" name="Google Shape;138;p2"/>
                <p:cNvSpPr/>
                <p:nvPr/>
              </p:nvSpPr>
              <p:spPr>
                <a:xfrm>
                  <a:off x="5008179" y="3626649"/>
                  <a:ext cx="67089" cy="105418"/>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39" name="Google Shape;139;p2"/>
                <p:cNvSpPr/>
                <p:nvPr/>
              </p:nvSpPr>
              <p:spPr>
                <a:xfrm>
                  <a:off x="5130512" y="3570065"/>
                  <a:ext cx="92047" cy="129852"/>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140" name="Google Shape;140;p2"/>
              <p:cNvGrpSpPr/>
              <p:nvPr/>
            </p:nvGrpSpPr>
            <p:grpSpPr>
              <a:xfrm>
                <a:off x="4090650" y="2628996"/>
                <a:ext cx="31183" cy="548640"/>
                <a:chOff x="4090650" y="2495646"/>
                <a:chExt cx="31183" cy="640080"/>
              </a:xfrm>
            </p:grpSpPr>
            <p:cxnSp>
              <p:nvCxnSpPr>
                <p:cNvPr id="141" name="Google Shape;141;p2"/>
                <p:cNvCxnSpPr/>
                <p:nvPr/>
              </p:nvCxnSpPr>
              <p:spPr>
                <a:xfrm>
                  <a:off x="4090650" y="2495646"/>
                  <a:ext cx="608" cy="640080"/>
                </a:xfrm>
                <a:prstGeom prst="straightConnector1">
                  <a:avLst/>
                </a:prstGeom>
                <a:noFill/>
                <a:ln w="9525" cap="flat" cmpd="sng">
                  <a:solidFill>
                    <a:schemeClr val="dk1"/>
                  </a:solidFill>
                  <a:prstDash val="solid"/>
                  <a:miter lim="800000"/>
                  <a:headEnd type="none" w="sm" len="sm"/>
                  <a:tailEnd type="none" w="sm" len="sm"/>
                </a:ln>
              </p:spPr>
            </p:cxnSp>
            <p:cxnSp>
              <p:nvCxnSpPr>
                <p:cNvPr id="142" name="Google Shape;142;p2"/>
                <p:cNvCxnSpPr/>
                <p:nvPr/>
              </p:nvCxnSpPr>
              <p:spPr>
                <a:xfrm>
                  <a:off x="4121833" y="2495646"/>
                  <a:ext cx="0" cy="640080"/>
                </a:xfrm>
                <a:prstGeom prst="straightConnector1">
                  <a:avLst/>
                </a:prstGeom>
                <a:noFill/>
                <a:ln w="9525" cap="flat" cmpd="sng">
                  <a:solidFill>
                    <a:schemeClr val="dk1"/>
                  </a:solidFill>
                  <a:prstDash val="solid"/>
                  <a:miter lim="800000"/>
                  <a:headEnd type="none" w="sm" len="sm"/>
                  <a:tailEnd type="none" w="sm" len="sm"/>
                </a:ln>
              </p:spPr>
            </p:cxnSp>
          </p:grpSp>
        </p:grpSp>
        <p:sp>
          <p:nvSpPr>
            <p:cNvPr id="143" name="Google Shape;143;p2"/>
            <p:cNvSpPr/>
            <p:nvPr/>
          </p:nvSpPr>
          <p:spPr>
            <a:xfrm>
              <a:off x="1301152" y="2637228"/>
              <a:ext cx="642373" cy="365760"/>
            </a:xfrm>
            <a:prstGeom prst="rect">
              <a:avLst/>
            </a:prstGeom>
            <a:solidFill>
              <a:srgbClr val="FFFDDA"/>
            </a:solid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Hypoxic</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Hy)</a:t>
              </a:r>
              <a:endParaRPr sz="1400" b="0" i="0" u="none" strike="noStrike" cap="none">
                <a:solidFill>
                  <a:srgbClr val="000000"/>
                </a:solidFill>
                <a:latin typeface="Arial"/>
                <a:ea typeface="Arial"/>
                <a:cs typeface="Arial"/>
                <a:sym typeface="Arial"/>
              </a:endParaRPr>
            </a:p>
          </p:txBody>
        </p:sp>
        <p:sp>
          <p:nvSpPr>
            <p:cNvPr id="144" name="Google Shape;144;p2"/>
            <p:cNvSpPr/>
            <p:nvPr/>
          </p:nvSpPr>
          <p:spPr>
            <a:xfrm>
              <a:off x="2031745" y="2631438"/>
              <a:ext cx="642373" cy="365760"/>
            </a:xfrm>
            <a:prstGeom prst="rect">
              <a:avLst/>
            </a:prstGeom>
            <a:solidFill>
              <a:schemeClr val="accent5"/>
            </a:solidFill>
            <a:ln w="12700"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Oxic</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Ox)</a:t>
              </a:r>
              <a:endParaRPr sz="1400" b="0" i="0" u="none" strike="noStrike" cap="none">
                <a:solidFill>
                  <a:srgbClr val="000000"/>
                </a:solidFill>
                <a:latin typeface="Arial"/>
                <a:ea typeface="Arial"/>
                <a:cs typeface="Arial"/>
                <a:sym typeface="Arial"/>
              </a:endParaRPr>
            </a:p>
          </p:txBody>
        </p:sp>
        <p:grpSp>
          <p:nvGrpSpPr>
            <p:cNvPr id="145" name="Google Shape;145;p2"/>
            <p:cNvGrpSpPr/>
            <p:nvPr/>
          </p:nvGrpSpPr>
          <p:grpSpPr>
            <a:xfrm>
              <a:off x="2202157" y="3001159"/>
              <a:ext cx="305250" cy="641525"/>
              <a:chOff x="3945967" y="2628996"/>
              <a:chExt cx="305250" cy="641525"/>
            </a:xfrm>
          </p:grpSpPr>
          <p:sp>
            <p:nvSpPr>
              <p:cNvPr id="146" name="Google Shape;146;p2"/>
              <p:cNvSpPr/>
              <p:nvPr/>
            </p:nvSpPr>
            <p:spPr>
              <a:xfrm>
                <a:off x="3965371" y="3177815"/>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47" name="Google Shape;147;p2"/>
              <p:cNvSpPr/>
              <p:nvPr/>
            </p:nvSpPr>
            <p:spPr>
              <a:xfrm>
                <a:off x="3951460" y="2929034"/>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48" name="Google Shape;148;p2"/>
              <p:cNvSpPr/>
              <p:nvPr/>
            </p:nvSpPr>
            <p:spPr>
              <a:xfrm>
                <a:off x="3965371" y="2866199"/>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49" name="Google Shape;149;p2"/>
              <p:cNvSpPr/>
              <p:nvPr/>
            </p:nvSpPr>
            <p:spPr>
              <a:xfrm>
                <a:off x="4020115" y="2822850"/>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150" name="Google Shape;150;p2"/>
              <p:cNvSpPr/>
              <p:nvPr/>
            </p:nvSpPr>
            <p:spPr>
              <a:xfrm>
                <a:off x="3945967" y="2760773"/>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51" name="Google Shape;151;p2"/>
              <p:cNvSpPr/>
              <p:nvPr/>
            </p:nvSpPr>
            <p:spPr>
              <a:xfrm>
                <a:off x="4025223" y="2745083"/>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52" name="Google Shape;152;p2"/>
              <p:cNvSpPr/>
              <p:nvPr/>
            </p:nvSpPr>
            <p:spPr>
              <a:xfrm>
                <a:off x="4025858" y="2721881"/>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53" name="Google Shape;153;p2"/>
              <p:cNvSpPr/>
              <p:nvPr/>
            </p:nvSpPr>
            <p:spPr>
              <a:xfrm rot="4804356">
                <a:off x="4086508" y="3125170"/>
                <a:ext cx="24258" cy="125311"/>
              </a:xfrm>
              <a:prstGeom prst="roundRect">
                <a:avLst>
                  <a:gd name="adj" fmla="val 16667"/>
                </a:avLst>
              </a:prstGeom>
              <a:solidFill>
                <a:srgbClr val="7F7F7F"/>
              </a:solidFill>
              <a:ln w="1270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grpSp>
            <p:nvGrpSpPr>
              <p:cNvPr id="154" name="Google Shape;154;p2"/>
              <p:cNvGrpSpPr/>
              <p:nvPr/>
            </p:nvGrpSpPr>
            <p:grpSpPr>
              <a:xfrm>
                <a:off x="4102466" y="2980478"/>
                <a:ext cx="113321" cy="219881"/>
                <a:chOff x="4940806" y="3570065"/>
                <a:chExt cx="281753" cy="608662"/>
              </a:xfrm>
            </p:grpSpPr>
            <p:sp>
              <p:nvSpPr>
                <p:cNvPr id="155" name="Google Shape;155;p2"/>
                <p:cNvSpPr/>
                <p:nvPr/>
              </p:nvSpPr>
              <p:spPr>
                <a:xfrm>
                  <a:off x="4940806" y="4095941"/>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56" name="Google Shape;156;p2"/>
                <p:cNvSpPr/>
                <p:nvPr/>
              </p:nvSpPr>
              <p:spPr>
                <a:xfrm>
                  <a:off x="4978936" y="3990103"/>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57" name="Google Shape;157;p2"/>
                <p:cNvSpPr/>
                <p:nvPr/>
              </p:nvSpPr>
              <p:spPr>
                <a:xfrm>
                  <a:off x="5062637" y="4044814"/>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58" name="Google Shape;158;p2"/>
                <p:cNvSpPr/>
                <p:nvPr/>
              </p:nvSpPr>
              <p:spPr>
                <a:xfrm>
                  <a:off x="5050776" y="3872146"/>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59" name="Google Shape;159;p2"/>
                <p:cNvSpPr/>
                <p:nvPr/>
              </p:nvSpPr>
              <p:spPr>
                <a:xfrm>
                  <a:off x="4972600" y="3789846"/>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60" name="Google Shape;160;p2"/>
                <p:cNvSpPr/>
                <p:nvPr/>
              </p:nvSpPr>
              <p:spPr>
                <a:xfrm>
                  <a:off x="5106004" y="3755353"/>
                  <a:ext cx="67089" cy="105418"/>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61" name="Google Shape;161;p2"/>
                <p:cNvSpPr/>
                <p:nvPr/>
              </p:nvSpPr>
              <p:spPr>
                <a:xfrm>
                  <a:off x="5008179" y="3626649"/>
                  <a:ext cx="67089" cy="105418"/>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62" name="Google Shape;162;p2"/>
                <p:cNvSpPr/>
                <p:nvPr/>
              </p:nvSpPr>
              <p:spPr>
                <a:xfrm>
                  <a:off x="5130512" y="3570065"/>
                  <a:ext cx="92047" cy="129852"/>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163" name="Google Shape;163;p2"/>
              <p:cNvGrpSpPr/>
              <p:nvPr/>
            </p:nvGrpSpPr>
            <p:grpSpPr>
              <a:xfrm>
                <a:off x="4090650" y="2628996"/>
                <a:ext cx="31183" cy="548640"/>
                <a:chOff x="4090650" y="2495646"/>
                <a:chExt cx="31183" cy="640080"/>
              </a:xfrm>
            </p:grpSpPr>
            <p:cxnSp>
              <p:nvCxnSpPr>
                <p:cNvPr id="164" name="Google Shape;164;p2"/>
                <p:cNvCxnSpPr/>
                <p:nvPr/>
              </p:nvCxnSpPr>
              <p:spPr>
                <a:xfrm>
                  <a:off x="4090650" y="2495646"/>
                  <a:ext cx="608" cy="640080"/>
                </a:xfrm>
                <a:prstGeom prst="straightConnector1">
                  <a:avLst/>
                </a:prstGeom>
                <a:noFill/>
                <a:ln w="9525" cap="flat" cmpd="sng">
                  <a:solidFill>
                    <a:schemeClr val="dk1"/>
                  </a:solidFill>
                  <a:prstDash val="solid"/>
                  <a:miter lim="800000"/>
                  <a:headEnd type="none" w="sm" len="sm"/>
                  <a:tailEnd type="none" w="sm" len="sm"/>
                </a:ln>
              </p:spPr>
            </p:cxnSp>
            <p:cxnSp>
              <p:nvCxnSpPr>
                <p:cNvPr id="165" name="Google Shape;165;p2"/>
                <p:cNvCxnSpPr/>
                <p:nvPr/>
              </p:nvCxnSpPr>
              <p:spPr>
                <a:xfrm>
                  <a:off x="4121833" y="2495646"/>
                  <a:ext cx="0" cy="640080"/>
                </a:xfrm>
                <a:prstGeom prst="straightConnector1">
                  <a:avLst/>
                </a:prstGeom>
                <a:noFill/>
                <a:ln w="9525" cap="flat" cmpd="sng">
                  <a:solidFill>
                    <a:schemeClr val="dk1"/>
                  </a:solidFill>
                  <a:prstDash val="solid"/>
                  <a:miter lim="800000"/>
                  <a:headEnd type="none" w="sm" len="sm"/>
                  <a:tailEnd type="none" w="sm" len="sm"/>
                </a:ln>
              </p:spPr>
            </p:cxnSp>
          </p:grpSp>
        </p:grpSp>
        <p:grpSp>
          <p:nvGrpSpPr>
            <p:cNvPr id="166" name="Google Shape;166;p2"/>
            <p:cNvGrpSpPr/>
            <p:nvPr/>
          </p:nvGrpSpPr>
          <p:grpSpPr>
            <a:xfrm>
              <a:off x="1463987" y="2997198"/>
              <a:ext cx="459186" cy="1603209"/>
              <a:chOff x="1910552" y="3252088"/>
              <a:chExt cx="459186" cy="1603209"/>
            </a:xfrm>
          </p:grpSpPr>
          <p:grpSp>
            <p:nvGrpSpPr>
              <p:cNvPr id="167" name="Google Shape;167;p2"/>
              <p:cNvGrpSpPr/>
              <p:nvPr/>
            </p:nvGrpSpPr>
            <p:grpSpPr>
              <a:xfrm>
                <a:off x="1910552" y="4183064"/>
                <a:ext cx="305250" cy="672233"/>
                <a:chOff x="3945967" y="2598288"/>
                <a:chExt cx="305250" cy="672233"/>
              </a:xfrm>
            </p:grpSpPr>
            <p:sp>
              <p:nvSpPr>
                <p:cNvPr id="168" name="Google Shape;168;p2"/>
                <p:cNvSpPr/>
                <p:nvPr/>
              </p:nvSpPr>
              <p:spPr>
                <a:xfrm>
                  <a:off x="3965371" y="3177815"/>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69" name="Google Shape;169;p2"/>
                <p:cNvSpPr/>
                <p:nvPr/>
              </p:nvSpPr>
              <p:spPr>
                <a:xfrm>
                  <a:off x="3951460" y="2929034"/>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70" name="Google Shape;170;p2"/>
                <p:cNvSpPr/>
                <p:nvPr/>
              </p:nvSpPr>
              <p:spPr>
                <a:xfrm>
                  <a:off x="3965371" y="2866199"/>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71" name="Google Shape;171;p2"/>
                <p:cNvSpPr/>
                <p:nvPr/>
              </p:nvSpPr>
              <p:spPr>
                <a:xfrm>
                  <a:off x="4020115" y="2822850"/>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172" name="Google Shape;172;p2"/>
                <p:cNvSpPr/>
                <p:nvPr/>
              </p:nvSpPr>
              <p:spPr>
                <a:xfrm>
                  <a:off x="3945967" y="2760773"/>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73" name="Google Shape;173;p2"/>
                <p:cNvSpPr/>
                <p:nvPr/>
              </p:nvSpPr>
              <p:spPr>
                <a:xfrm>
                  <a:off x="4025223" y="2745083"/>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74" name="Google Shape;174;p2"/>
                <p:cNvSpPr/>
                <p:nvPr/>
              </p:nvSpPr>
              <p:spPr>
                <a:xfrm>
                  <a:off x="4025858" y="2721881"/>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75" name="Google Shape;175;p2"/>
                <p:cNvSpPr/>
                <p:nvPr/>
              </p:nvSpPr>
              <p:spPr>
                <a:xfrm rot="4804356">
                  <a:off x="4086508" y="3125170"/>
                  <a:ext cx="24258" cy="125311"/>
                </a:xfrm>
                <a:prstGeom prst="roundRect">
                  <a:avLst>
                    <a:gd name="adj" fmla="val 16667"/>
                  </a:avLst>
                </a:prstGeom>
                <a:solidFill>
                  <a:srgbClr val="7F7F7F"/>
                </a:solidFill>
                <a:ln w="1270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grpSp>
              <p:nvGrpSpPr>
                <p:cNvPr id="176" name="Google Shape;176;p2"/>
                <p:cNvGrpSpPr/>
                <p:nvPr/>
              </p:nvGrpSpPr>
              <p:grpSpPr>
                <a:xfrm>
                  <a:off x="4102466" y="2980478"/>
                  <a:ext cx="113321" cy="219881"/>
                  <a:chOff x="4940806" y="3570065"/>
                  <a:chExt cx="281753" cy="608662"/>
                </a:xfrm>
              </p:grpSpPr>
              <p:sp>
                <p:nvSpPr>
                  <p:cNvPr id="177" name="Google Shape;177;p2"/>
                  <p:cNvSpPr/>
                  <p:nvPr/>
                </p:nvSpPr>
                <p:spPr>
                  <a:xfrm>
                    <a:off x="4940806" y="4095941"/>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78" name="Google Shape;178;p2"/>
                  <p:cNvSpPr/>
                  <p:nvPr/>
                </p:nvSpPr>
                <p:spPr>
                  <a:xfrm>
                    <a:off x="4978936" y="3990103"/>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79" name="Google Shape;179;p2"/>
                  <p:cNvSpPr/>
                  <p:nvPr/>
                </p:nvSpPr>
                <p:spPr>
                  <a:xfrm>
                    <a:off x="5062637" y="4044814"/>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80" name="Google Shape;180;p2"/>
                  <p:cNvSpPr/>
                  <p:nvPr/>
                </p:nvSpPr>
                <p:spPr>
                  <a:xfrm>
                    <a:off x="5050776" y="3872146"/>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81" name="Google Shape;181;p2"/>
                  <p:cNvSpPr/>
                  <p:nvPr/>
                </p:nvSpPr>
                <p:spPr>
                  <a:xfrm>
                    <a:off x="4972600" y="3789846"/>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82" name="Google Shape;182;p2"/>
                  <p:cNvSpPr/>
                  <p:nvPr/>
                </p:nvSpPr>
                <p:spPr>
                  <a:xfrm>
                    <a:off x="5106004" y="3755353"/>
                    <a:ext cx="67089" cy="105418"/>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83" name="Google Shape;183;p2"/>
                  <p:cNvSpPr/>
                  <p:nvPr/>
                </p:nvSpPr>
                <p:spPr>
                  <a:xfrm>
                    <a:off x="5008179" y="3626649"/>
                    <a:ext cx="67089" cy="105418"/>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84" name="Google Shape;184;p2"/>
                  <p:cNvSpPr/>
                  <p:nvPr/>
                </p:nvSpPr>
                <p:spPr>
                  <a:xfrm>
                    <a:off x="5130512" y="3570065"/>
                    <a:ext cx="92047" cy="129852"/>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185" name="Google Shape;185;p2"/>
                <p:cNvGrpSpPr/>
                <p:nvPr/>
              </p:nvGrpSpPr>
              <p:grpSpPr>
                <a:xfrm>
                  <a:off x="4091258" y="2598288"/>
                  <a:ext cx="23375" cy="579347"/>
                  <a:chOff x="4091258" y="2459821"/>
                  <a:chExt cx="23375" cy="675905"/>
                </a:xfrm>
              </p:grpSpPr>
              <p:cxnSp>
                <p:nvCxnSpPr>
                  <p:cNvPr id="186" name="Google Shape;186;p2"/>
                  <p:cNvCxnSpPr/>
                  <p:nvPr/>
                </p:nvCxnSpPr>
                <p:spPr>
                  <a:xfrm>
                    <a:off x="4091258" y="2459821"/>
                    <a:ext cx="0" cy="675905"/>
                  </a:xfrm>
                  <a:prstGeom prst="straightConnector1">
                    <a:avLst/>
                  </a:prstGeom>
                  <a:noFill/>
                  <a:ln w="9525" cap="flat" cmpd="sng">
                    <a:solidFill>
                      <a:schemeClr val="dk1"/>
                    </a:solidFill>
                    <a:prstDash val="solid"/>
                    <a:miter lim="800000"/>
                    <a:headEnd type="none" w="sm" len="sm"/>
                    <a:tailEnd type="none" w="sm" len="sm"/>
                  </a:ln>
                </p:spPr>
              </p:cxnSp>
              <p:cxnSp>
                <p:nvCxnSpPr>
                  <p:cNvPr id="187" name="Google Shape;187;p2"/>
                  <p:cNvCxnSpPr/>
                  <p:nvPr/>
                </p:nvCxnSpPr>
                <p:spPr>
                  <a:xfrm>
                    <a:off x="4114633" y="2495646"/>
                    <a:ext cx="0" cy="640080"/>
                  </a:xfrm>
                  <a:prstGeom prst="straightConnector1">
                    <a:avLst/>
                  </a:prstGeom>
                  <a:noFill/>
                  <a:ln w="9525" cap="flat" cmpd="sng">
                    <a:solidFill>
                      <a:schemeClr val="dk1"/>
                    </a:solidFill>
                    <a:prstDash val="solid"/>
                    <a:miter lim="800000"/>
                    <a:headEnd type="none" w="sm" len="sm"/>
                    <a:tailEnd type="none" w="sm" len="sm"/>
                  </a:ln>
                </p:spPr>
              </p:cxnSp>
            </p:grpSp>
          </p:grpSp>
          <p:grpSp>
            <p:nvGrpSpPr>
              <p:cNvPr id="188" name="Google Shape;188;p2"/>
              <p:cNvGrpSpPr/>
              <p:nvPr/>
            </p:nvGrpSpPr>
            <p:grpSpPr>
              <a:xfrm>
                <a:off x="2339031" y="3252088"/>
                <a:ext cx="30707" cy="963373"/>
                <a:chOff x="4146830" y="2258604"/>
                <a:chExt cx="30707" cy="963373"/>
              </a:xfrm>
            </p:grpSpPr>
            <p:cxnSp>
              <p:nvCxnSpPr>
                <p:cNvPr id="189" name="Google Shape;189;p2"/>
                <p:cNvCxnSpPr/>
                <p:nvPr/>
              </p:nvCxnSpPr>
              <p:spPr>
                <a:xfrm>
                  <a:off x="4146830" y="2258604"/>
                  <a:ext cx="0" cy="938997"/>
                </a:xfrm>
                <a:prstGeom prst="straightConnector1">
                  <a:avLst/>
                </a:prstGeom>
                <a:noFill/>
                <a:ln w="9525" cap="flat" cmpd="sng">
                  <a:solidFill>
                    <a:schemeClr val="dk1"/>
                  </a:solidFill>
                  <a:prstDash val="solid"/>
                  <a:miter lim="800000"/>
                  <a:headEnd type="none" w="sm" len="sm"/>
                  <a:tailEnd type="none" w="sm" len="sm"/>
                </a:ln>
              </p:spPr>
            </p:cxnSp>
            <p:cxnSp>
              <p:nvCxnSpPr>
                <p:cNvPr id="190" name="Google Shape;190;p2"/>
                <p:cNvCxnSpPr/>
                <p:nvPr/>
              </p:nvCxnSpPr>
              <p:spPr>
                <a:xfrm>
                  <a:off x="4177537" y="2258604"/>
                  <a:ext cx="0" cy="963373"/>
                </a:xfrm>
                <a:prstGeom prst="straightConnector1">
                  <a:avLst/>
                </a:prstGeom>
                <a:noFill/>
                <a:ln w="9525" cap="flat" cmpd="sng">
                  <a:solidFill>
                    <a:schemeClr val="dk1"/>
                  </a:solidFill>
                  <a:prstDash val="solid"/>
                  <a:miter lim="800000"/>
                  <a:headEnd type="none" w="sm" len="sm"/>
                  <a:tailEnd type="none" w="sm" len="sm"/>
                </a:ln>
              </p:spPr>
            </p:cxnSp>
          </p:grpSp>
          <p:cxnSp>
            <p:nvCxnSpPr>
              <p:cNvPr id="191" name="Google Shape;191;p2"/>
              <p:cNvCxnSpPr/>
              <p:nvPr/>
            </p:nvCxnSpPr>
            <p:spPr>
              <a:xfrm rot="10800000">
                <a:off x="2059305" y="4185126"/>
                <a:ext cx="284108" cy="0"/>
              </a:xfrm>
              <a:prstGeom prst="straightConnector1">
                <a:avLst/>
              </a:prstGeom>
              <a:noFill/>
              <a:ln w="9525" cap="flat" cmpd="sng">
                <a:solidFill>
                  <a:schemeClr val="dk1"/>
                </a:solidFill>
                <a:prstDash val="solid"/>
                <a:miter lim="800000"/>
                <a:headEnd type="none" w="sm" len="sm"/>
                <a:tailEnd type="none" w="sm" len="sm"/>
              </a:ln>
            </p:spPr>
          </p:cxnSp>
          <p:cxnSp>
            <p:nvCxnSpPr>
              <p:cNvPr id="192" name="Google Shape;192;p2"/>
              <p:cNvCxnSpPr/>
              <p:nvPr/>
            </p:nvCxnSpPr>
            <p:spPr>
              <a:xfrm rot="10800000">
                <a:off x="2077442" y="4212286"/>
                <a:ext cx="289998" cy="0"/>
              </a:xfrm>
              <a:prstGeom prst="straightConnector1">
                <a:avLst/>
              </a:prstGeom>
              <a:noFill/>
              <a:ln w="9525" cap="flat" cmpd="sng">
                <a:solidFill>
                  <a:schemeClr val="dk1"/>
                </a:solidFill>
                <a:prstDash val="solid"/>
                <a:miter lim="800000"/>
                <a:headEnd type="none" w="sm" len="sm"/>
                <a:tailEnd type="none" w="sm" len="sm"/>
              </a:ln>
            </p:spPr>
          </p:cxnSp>
        </p:grpSp>
        <p:grpSp>
          <p:nvGrpSpPr>
            <p:cNvPr id="193" name="Google Shape;193;p2"/>
            <p:cNvGrpSpPr/>
            <p:nvPr/>
          </p:nvGrpSpPr>
          <p:grpSpPr>
            <a:xfrm>
              <a:off x="2200926" y="2997198"/>
              <a:ext cx="442174" cy="1603209"/>
              <a:chOff x="1910552" y="3252088"/>
              <a:chExt cx="442174" cy="1603209"/>
            </a:xfrm>
          </p:grpSpPr>
          <p:grpSp>
            <p:nvGrpSpPr>
              <p:cNvPr id="194" name="Google Shape;194;p2"/>
              <p:cNvGrpSpPr/>
              <p:nvPr/>
            </p:nvGrpSpPr>
            <p:grpSpPr>
              <a:xfrm>
                <a:off x="1910552" y="4183064"/>
                <a:ext cx="305250" cy="672233"/>
                <a:chOff x="3945967" y="2598288"/>
                <a:chExt cx="305250" cy="672233"/>
              </a:xfrm>
            </p:grpSpPr>
            <p:sp>
              <p:nvSpPr>
                <p:cNvPr id="195" name="Google Shape;195;p2"/>
                <p:cNvSpPr/>
                <p:nvPr/>
              </p:nvSpPr>
              <p:spPr>
                <a:xfrm>
                  <a:off x="3965371" y="3177815"/>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96" name="Google Shape;196;p2"/>
                <p:cNvSpPr/>
                <p:nvPr/>
              </p:nvSpPr>
              <p:spPr>
                <a:xfrm>
                  <a:off x="3951460" y="2929034"/>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97" name="Google Shape;197;p2"/>
                <p:cNvSpPr/>
                <p:nvPr/>
              </p:nvSpPr>
              <p:spPr>
                <a:xfrm>
                  <a:off x="3965371" y="2866199"/>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198" name="Google Shape;198;p2"/>
                <p:cNvSpPr/>
                <p:nvPr/>
              </p:nvSpPr>
              <p:spPr>
                <a:xfrm>
                  <a:off x="4020115" y="2822850"/>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199" name="Google Shape;199;p2"/>
                <p:cNvSpPr/>
                <p:nvPr/>
              </p:nvSpPr>
              <p:spPr>
                <a:xfrm>
                  <a:off x="3945967" y="2760773"/>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00" name="Google Shape;200;p2"/>
                <p:cNvSpPr/>
                <p:nvPr/>
              </p:nvSpPr>
              <p:spPr>
                <a:xfrm>
                  <a:off x="4025223" y="2745083"/>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01" name="Google Shape;201;p2"/>
                <p:cNvSpPr/>
                <p:nvPr/>
              </p:nvSpPr>
              <p:spPr>
                <a:xfrm>
                  <a:off x="4025858" y="2721881"/>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02" name="Google Shape;202;p2"/>
                <p:cNvSpPr/>
                <p:nvPr/>
              </p:nvSpPr>
              <p:spPr>
                <a:xfrm rot="4804356">
                  <a:off x="4086508" y="3125170"/>
                  <a:ext cx="24258" cy="125311"/>
                </a:xfrm>
                <a:prstGeom prst="roundRect">
                  <a:avLst>
                    <a:gd name="adj" fmla="val 16667"/>
                  </a:avLst>
                </a:prstGeom>
                <a:solidFill>
                  <a:srgbClr val="7F7F7F"/>
                </a:solidFill>
                <a:ln w="1270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grpSp>
              <p:nvGrpSpPr>
                <p:cNvPr id="203" name="Google Shape;203;p2"/>
                <p:cNvGrpSpPr/>
                <p:nvPr/>
              </p:nvGrpSpPr>
              <p:grpSpPr>
                <a:xfrm>
                  <a:off x="4102466" y="2980478"/>
                  <a:ext cx="113321" cy="219881"/>
                  <a:chOff x="4940806" y="3570065"/>
                  <a:chExt cx="281753" cy="608662"/>
                </a:xfrm>
              </p:grpSpPr>
              <p:sp>
                <p:nvSpPr>
                  <p:cNvPr id="204" name="Google Shape;204;p2"/>
                  <p:cNvSpPr/>
                  <p:nvPr/>
                </p:nvSpPr>
                <p:spPr>
                  <a:xfrm>
                    <a:off x="4940806" y="4095941"/>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05" name="Google Shape;205;p2"/>
                  <p:cNvSpPr/>
                  <p:nvPr/>
                </p:nvSpPr>
                <p:spPr>
                  <a:xfrm>
                    <a:off x="4978936" y="3990103"/>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06" name="Google Shape;206;p2"/>
                  <p:cNvSpPr/>
                  <p:nvPr/>
                </p:nvSpPr>
                <p:spPr>
                  <a:xfrm>
                    <a:off x="5062637" y="4044814"/>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07" name="Google Shape;207;p2"/>
                  <p:cNvSpPr/>
                  <p:nvPr/>
                </p:nvSpPr>
                <p:spPr>
                  <a:xfrm>
                    <a:off x="5050776" y="3872146"/>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08" name="Google Shape;208;p2"/>
                  <p:cNvSpPr/>
                  <p:nvPr/>
                </p:nvSpPr>
                <p:spPr>
                  <a:xfrm>
                    <a:off x="4972600" y="3789846"/>
                    <a:ext cx="55228" cy="82786"/>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09" name="Google Shape;209;p2"/>
                  <p:cNvSpPr/>
                  <p:nvPr/>
                </p:nvSpPr>
                <p:spPr>
                  <a:xfrm>
                    <a:off x="5106004" y="3755353"/>
                    <a:ext cx="67089" cy="105418"/>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10" name="Google Shape;210;p2"/>
                  <p:cNvSpPr/>
                  <p:nvPr/>
                </p:nvSpPr>
                <p:spPr>
                  <a:xfrm>
                    <a:off x="5008179" y="3626649"/>
                    <a:ext cx="67089" cy="105418"/>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11" name="Google Shape;211;p2"/>
                  <p:cNvSpPr/>
                  <p:nvPr/>
                </p:nvSpPr>
                <p:spPr>
                  <a:xfrm>
                    <a:off x="5130512" y="3570065"/>
                    <a:ext cx="92047" cy="129852"/>
                  </a:xfrm>
                  <a:prstGeom prst="ellipse">
                    <a:avLst/>
                  </a:prstGeom>
                  <a:noFill/>
                  <a:ln w="9525" cap="flat" cmpd="sng">
                    <a:solidFill>
                      <a:srgbClr val="385623"/>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212" name="Google Shape;212;p2"/>
                <p:cNvGrpSpPr/>
                <p:nvPr/>
              </p:nvGrpSpPr>
              <p:grpSpPr>
                <a:xfrm>
                  <a:off x="4091258" y="2598288"/>
                  <a:ext cx="23375" cy="579347"/>
                  <a:chOff x="4091258" y="2459821"/>
                  <a:chExt cx="23375" cy="675905"/>
                </a:xfrm>
              </p:grpSpPr>
              <p:cxnSp>
                <p:nvCxnSpPr>
                  <p:cNvPr id="213" name="Google Shape;213;p2"/>
                  <p:cNvCxnSpPr/>
                  <p:nvPr/>
                </p:nvCxnSpPr>
                <p:spPr>
                  <a:xfrm>
                    <a:off x="4091258" y="2459821"/>
                    <a:ext cx="0" cy="675905"/>
                  </a:xfrm>
                  <a:prstGeom prst="straightConnector1">
                    <a:avLst/>
                  </a:prstGeom>
                  <a:noFill/>
                  <a:ln w="9525" cap="flat" cmpd="sng">
                    <a:solidFill>
                      <a:schemeClr val="dk1"/>
                    </a:solidFill>
                    <a:prstDash val="solid"/>
                    <a:miter lim="800000"/>
                    <a:headEnd type="none" w="sm" len="sm"/>
                    <a:tailEnd type="none" w="sm" len="sm"/>
                  </a:ln>
                </p:spPr>
              </p:cxnSp>
              <p:cxnSp>
                <p:nvCxnSpPr>
                  <p:cNvPr id="214" name="Google Shape;214;p2"/>
                  <p:cNvCxnSpPr/>
                  <p:nvPr/>
                </p:nvCxnSpPr>
                <p:spPr>
                  <a:xfrm>
                    <a:off x="4114633" y="2495646"/>
                    <a:ext cx="0" cy="640080"/>
                  </a:xfrm>
                  <a:prstGeom prst="straightConnector1">
                    <a:avLst/>
                  </a:prstGeom>
                  <a:noFill/>
                  <a:ln w="9525" cap="flat" cmpd="sng">
                    <a:solidFill>
                      <a:schemeClr val="dk1"/>
                    </a:solidFill>
                    <a:prstDash val="solid"/>
                    <a:miter lim="800000"/>
                    <a:headEnd type="none" w="sm" len="sm"/>
                    <a:tailEnd type="none" w="sm" len="sm"/>
                  </a:ln>
                </p:spPr>
              </p:cxnSp>
            </p:grpSp>
          </p:grpSp>
          <p:grpSp>
            <p:nvGrpSpPr>
              <p:cNvPr id="215" name="Google Shape;215;p2"/>
              <p:cNvGrpSpPr/>
              <p:nvPr/>
            </p:nvGrpSpPr>
            <p:grpSpPr>
              <a:xfrm>
                <a:off x="2322019" y="3252088"/>
                <a:ext cx="30707" cy="963373"/>
                <a:chOff x="4129818" y="2258604"/>
                <a:chExt cx="30707" cy="963373"/>
              </a:xfrm>
            </p:grpSpPr>
            <p:cxnSp>
              <p:nvCxnSpPr>
                <p:cNvPr id="216" name="Google Shape;216;p2"/>
                <p:cNvCxnSpPr/>
                <p:nvPr/>
              </p:nvCxnSpPr>
              <p:spPr>
                <a:xfrm>
                  <a:off x="4129818" y="2258604"/>
                  <a:ext cx="0" cy="938997"/>
                </a:xfrm>
                <a:prstGeom prst="straightConnector1">
                  <a:avLst/>
                </a:prstGeom>
                <a:noFill/>
                <a:ln w="9525" cap="flat" cmpd="sng">
                  <a:solidFill>
                    <a:schemeClr val="dk1"/>
                  </a:solidFill>
                  <a:prstDash val="solid"/>
                  <a:miter lim="800000"/>
                  <a:headEnd type="none" w="sm" len="sm"/>
                  <a:tailEnd type="none" w="sm" len="sm"/>
                </a:ln>
              </p:spPr>
            </p:cxnSp>
            <p:cxnSp>
              <p:nvCxnSpPr>
                <p:cNvPr id="217" name="Google Shape;217;p2"/>
                <p:cNvCxnSpPr/>
                <p:nvPr/>
              </p:nvCxnSpPr>
              <p:spPr>
                <a:xfrm>
                  <a:off x="4160525" y="2258604"/>
                  <a:ext cx="0" cy="963373"/>
                </a:xfrm>
                <a:prstGeom prst="straightConnector1">
                  <a:avLst/>
                </a:prstGeom>
                <a:noFill/>
                <a:ln w="9525" cap="flat" cmpd="sng">
                  <a:solidFill>
                    <a:schemeClr val="dk1"/>
                  </a:solidFill>
                  <a:prstDash val="solid"/>
                  <a:miter lim="800000"/>
                  <a:headEnd type="none" w="sm" len="sm"/>
                  <a:tailEnd type="none" w="sm" len="sm"/>
                </a:ln>
              </p:spPr>
            </p:cxnSp>
          </p:grpSp>
          <p:cxnSp>
            <p:nvCxnSpPr>
              <p:cNvPr id="218" name="Google Shape;218;p2"/>
              <p:cNvCxnSpPr/>
              <p:nvPr/>
            </p:nvCxnSpPr>
            <p:spPr>
              <a:xfrm rot="10800000">
                <a:off x="2056130" y="4185126"/>
                <a:ext cx="265176" cy="0"/>
              </a:xfrm>
              <a:prstGeom prst="straightConnector1">
                <a:avLst/>
              </a:prstGeom>
              <a:noFill/>
              <a:ln w="9525" cap="flat" cmpd="sng">
                <a:solidFill>
                  <a:schemeClr val="dk1"/>
                </a:solidFill>
                <a:prstDash val="solid"/>
                <a:miter lim="800000"/>
                <a:headEnd type="none" w="sm" len="sm"/>
                <a:tailEnd type="none" w="sm" len="sm"/>
              </a:ln>
            </p:spPr>
          </p:cxnSp>
          <p:cxnSp>
            <p:nvCxnSpPr>
              <p:cNvPr id="219" name="Google Shape;219;p2"/>
              <p:cNvCxnSpPr/>
              <p:nvPr/>
            </p:nvCxnSpPr>
            <p:spPr>
              <a:xfrm rot="10800000">
                <a:off x="2077444" y="4212286"/>
                <a:ext cx="274320" cy="0"/>
              </a:xfrm>
              <a:prstGeom prst="straightConnector1">
                <a:avLst/>
              </a:prstGeom>
              <a:noFill/>
              <a:ln w="9525" cap="flat" cmpd="sng">
                <a:solidFill>
                  <a:schemeClr val="dk1"/>
                </a:solidFill>
                <a:prstDash val="solid"/>
                <a:miter lim="800000"/>
                <a:headEnd type="none" w="sm" len="sm"/>
                <a:tailEnd type="none" w="sm" len="sm"/>
              </a:ln>
            </p:spPr>
          </p:cxnSp>
        </p:grpSp>
        <p:grpSp>
          <p:nvGrpSpPr>
            <p:cNvPr id="220" name="Google Shape;220;p2"/>
            <p:cNvGrpSpPr/>
            <p:nvPr/>
          </p:nvGrpSpPr>
          <p:grpSpPr>
            <a:xfrm>
              <a:off x="5056513" y="1471691"/>
              <a:ext cx="305250" cy="548640"/>
              <a:chOff x="5210279" y="1092017"/>
              <a:chExt cx="305250" cy="548640"/>
            </a:xfrm>
          </p:grpSpPr>
          <p:sp>
            <p:nvSpPr>
              <p:cNvPr id="221" name="Google Shape;221;p2"/>
              <p:cNvSpPr/>
              <p:nvPr/>
            </p:nvSpPr>
            <p:spPr>
              <a:xfrm>
                <a:off x="5229683" y="1547951"/>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22" name="Google Shape;222;p2"/>
              <p:cNvSpPr/>
              <p:nvPr/>
            </p:nvSpPr>
            <p:spPr>
              <a:xfrm>
                <a:off x="5215772" y="1299170"/>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23" name="Google Shape;223;p2"/>
              <p:cNvSpPr/>
              <p:nvPr/>
            </p:nvSpPr>
            <p:spPr>
              <a:xfrm>
                <a:off x="5229683" y="1236335"/>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24" name="Google Shape;224;p2"/>
              <p:cNvSpPr/>
              <p:nvPr/>
            </p:nvSpPr>
            <p:spPr>
              <a:xfrm>
                <a:off x="5284427" y="1192986"/>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225" name="Google Shape;225;p2"/>
              <p:cNvSpPr/>
              <p:nvPr/>
            </p:nvSpPr>
            <p:spPr>
              <a:xfrm>
                <a:off x="5210279" y="1130909"/>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26" name="Google Shape;226;p2"/>
              <p:cNvSpPr/>
              <p:nvPr/>
            </p:nvSpPr>
            <p:spPr>
              <a:xfrm>
                <a:off x="5289535" y="1115219"/>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27" name="Google Shape;227;p2"/>
              <p:cNvSpPr/>
              <p:nvPr/>
            </p:nvSpPr>
            <p:spPr>
              <a:xfrm>
                <a:off x="5290170" y="1092017"/>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228" name="Google Shape;228;p2"/>
            <p:cNvGrpSpPr/>
            <p:nvPr/>
          </p:nvGrpSpPr>
          <p:grpSpPr>
            <a:xfrm>
              <a:off x="5489547" y="1471691"/>
              <a:ext cx="305250" cy="548640"/>
              <a:chOff x="5210279" y="1092017"/>
              <a:chExt cx="305250" cy="548640"/>
            </a:xfrm>
          </p:grpSpPr>
          <p:sp>
            <p:nvSpPr>
              <p:cNvPr id="229" name="Google Shape;229;p2"/>
              <p:cNvSpPr/>
              <p:nvPr/>
            </p:nvSpPr>
            <p:spPr>
              <a:xfrm>
                <a:off x="5229683" y="1547951"/>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30" name="Google Shape;230;p2"/>
              <p:cNvSpPr/>
              <p:nvPr/>
            </p:nvSpPr>
            <p:spPr>
              <a:xfrm>
                <a:off x="5215772" y="1299170"/>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31" name="Google Shape;231;p2"/>
              <p:cNvSpPr/>
              <p:nvPr/>
            </p:nvSpPr>
            <p:spPr>
              <a:xfrm>
                <a:off x="5229683" y="1236335"/>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32" name="Google Shape;232;p2"/>
              <p:cNvSpPr/>
              <p:nvPr/>
            </p:nvSpPr>
            <p:spPr>
              <a:xfrm>
                <a:off x="5284427" y="1192986"/>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233" name="Google Shape;233;p2"/>
              <p:cNvSpPr/>
              <p:nvPr/>
            </p:nvSpPr>
            <p:spPr>
              <a:xfrm>
                <a:off x="5210279" y="1130909"/>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34" name="Google Shape;234;p2"/>
              <p:cNvSpPr/>
              <p:nvPr/>
            </p:nvSpPr>
            <p:spPr>
              <a:xfrm>
                <a:off x="5289535" y="1115219"/>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35" name="Google Shape;235;p2"/>
              <p:cNvSpPr/>
              <p:nvPr/>
            </p:nvSpPr>
            <p:spPr>
              <a:xfrm>
                <a:off x="5290170" y="1092017"/>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236" name="Google Shape;236;p2"/>
            <p:cNvGrpSpPr/>
            <p:nvPr/>
          </p:nvGrpSpPr>
          <p:grpSpPr>
            <a:xfrm>
              <a:off x="5922581" y="1471691"/>
              <a:ext cx="305250" cy="548640"/>
              <a:chOff x="5210279" y="1092017"/>
              <a:chExt cx="305250" cy="548640"/>
            </a:xfrm>
          </p:grpSpPr>
          <p:sp>
            <p:nvSpPr>
              <p:cNvPr id="237" name="Google Shape;237;p2"/>
              <p:cNvSpPr/>
              <p:nvPr/>
            </p:nvSpPr>
            <p:spPr>
              <a:xfrm>
                <a:off x="5229683" y="1547951"/>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38" name="Google Shape;238;p2"/>
              <p:cNvSpPr/>
              <p:nvPr/>
            </p:nvSpPr>
            <p:spPr>
              <a:xfrm>
                <a:off x="5215772" y="1299170"/>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39" name="Google Shape;239;p2"/>
              <p:cNvSpPr/>
              <p:nvPr/>
            </p:nvSpPr>
            <p:spPr>
              <a:xfrm>
                <a:off x="5229683" y="1236335"/>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40" name="Google Shape;240;p2"/>
              <p:cNvSpPr/>
              <p:nvPr/>
            </p:nvSpPr>
            <p:spPr>
              <a:xfrm>
                <a:off x="5284427" y="1192986"/>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241" name="Google Shape;241;p2"/>
              <p:cNvSpPr/>
              <p:nvPr/>
            </p:nvSpPr>
            <p:spPr>
              <a:xfrm>
                <a:off x="5210279" y="1130909"/>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42" name="Google Shape;242;p2"/>
              <p:cNvSpPr/>
              <p:nvPr/>
            </p:nvSpPr>
            <p:spPr>
              <a:xfrm>
                <a:off x="5289535" y="1115219"/>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43" name="Google Shape;243;p2"/>
              <p:cNvSpPr/>
              <p:nvPr/>
            </p:nvSpPr>
            <p:spPr>
              <a:xfrm>
                <a:off x="5290170" y="1092017"/>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244" name="Google Shape;244;p2"/>
            <p:cNvGrpSpPr/>
            <p:nvPr/>
          </p:nvGrpSpPr>
          <p:grpSpPr>
            <a:xfrm>
              <a:off x="6355614" y="1471691"/>
              <a:ext cx="305250" cy="548640"/>
              <a:chOff x="5210279" y="1092017"/>
              <a:chExt cx="305250" cy="548640"/>
            </a:xfrm>
          </p:grpSpPr>
          <p:sp>
            <p:nvSpPr>
              <p:cNvPr id="245" name="Google Shape;245;p2"/>
              <p:cNvSpPr/>
              <p:nvPr/>
            </p:nvSpPr>
            <p:spPr>
              <a:xfrm>
                <a:off x="5229683" y="1547951"/>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46" name="Google Shape;246;p2"/>
              <p:cNvSpPr/>
              <p:nvPr/>
            </p:nvSpPr>
            <p:spPr>
              <a:xfrm>
                <a:off x="5215772" y="1299170"/>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47" name="Google Shape;247;p2"/>
              <p:cNvSpPr/>
              <p:nvPr/>
            </p:nvSpPr>
            <p:spPr>
              <a:xfrm>
                <a:off x="5229683" y="1236335"/>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48" name="Google Shape;248;p2"/>
              <p:cNvSpPr/>
              <p:nvPr/>
            </p:nvSpPr>
            <p:spPr>
              <a:xfrm>
                <a:off x="5284427" y="1192986"/>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249" name="Google Shape;249;p2"/>
              <p:cNvSpPr/>
              <p:nvPr/>
            </p:nvSpPr>
            <p:spPr>
              <a:xfrm>
                <a:off x="5210279" y="1130909"/>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50" name="Google Shape;250;p2"/>
              <p:cNvSpPr/>
              <p:nvPr/>
            </p:nvSpPr>
            <p:spPr>
              <a:xfrm>
                <a:off x="5289535" y="1115219"/>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51" name="Google Shape;251;p2"/>
              <p:cNvSpPr/>
              <p:nvPr/>
            </p:nvSpPr>
            <p:spPr>
              <a:xfrm>
                <a:off x="5290170" y="1092017"/>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cxnSp>
          <p:nvCxnSpPr>
            <p:cNvPr id="252" name="Google Shape;252;p2"/>
            <p:cNvCxnSpPr/>
            <p:nvPr/>
          </p:nvCxnSpPr>
          <p:spPr>
            <a:xfrm rot="10800000">
              <a:off x="4736339" y="932696"/>
              <a:ext cx="0" cy="300734"/>
            </a:xfrm>
            <a:prstGeom prst="straightConnector1">
              <a:avLst/>
            </a:prstGeom>
            <a:noFill/>
            <a:ln w="25400" cap="flat" cmpd="sng">
              <a:solidFill>
                <a:schemeClr val="dk1"/>
              </a:solidFill>
              <a:prstDash val="solid"/>
              <a:miter lim="800000"/>
              <a:headEnd type="none" w="sm" len="sm"/>
              <a:tailEnd type="none" w="sm" len="sm"/>
            </a:ln>
          </p:spPr>
        </p:cxnSp>
        <p:cxnSp>
          <p:nvCxnSpPr>
            <p:cNvPr id="253" name="Google Shape;253;p2"/>
            <p:cNvCxnSpPr/>
            <p:nvPr/>
          </p:nvCxnSpPr>
          <p:spPr>
            <a:xfrm>
              <a:off x="4724568" y="940040"/>
              <a:ext cx="1798025" cy="2483"/>
            </a:xfrm>
            <a:prstGeom prst="straightConnector1">
              <a:avLst/>
            </a:prstGeom>
            <a:noFill/>
            <a:ln w="25400" cap="flat" cmpd="sng">
              <a:solidFill>
                <a:schemeClr val="dk1"/>
              </a:solidFill>
              <a:prstDash val="solid"/>
              <a:miter lim="800000"/>
              <a:headEnd type="none" w="sm" len="sm"/>
              <a:tailEnd type="none" w="sm" len="sm"/>
            </a:ln>
          </p:spPr>
        </p:cxnSp>
        <p:grpSp>
          <p:nvGrpSpPr>
            <p:cNvPr id="254" name="Google Shape;254;p2"/>
            <p:cNvGrpSpPr/>
            <p:nvPr/>
          </p:nvGrpSpPr>
          <p:grpSpPr>
            <a:xfrm>
              <a:off x="5211867" y="932497"/>
              <a:ext cx="289512" cy="491023"/>
              <a:chOff x="5211867" y="741112"/>
              <a:chExt cx="289512" cy="491023"/>
            </a:xfrm>
          </p:grpSpPr>
          <p:pic>
            <p:nvPicPr>
              <p:cNvPr id="255" name="Google Shape;255;p2"/>
              <p:cNvPicPr preferRelativeResize="0"/>
              <p:nvPr/>
            </p:nvPicPr>
            <p:blipFill rotWithShape="1">
              <a:blip r:embed="rId4">
                <a:alphaModFix/>
              </a:blip>
              <a:srcRect l="5108" r="73711" b="61513"/>
              <a:stretch/>
            </p:blipFill>
            <p:spPr>
              <a:xfrm>
                <a:off x="5239432" y="805936"/>
                <a:ext cx="261947" cy="341750"/>
              </a:xfrm>
              <a:prstGeom prst="rect">
                <a:avLst/>
              </a:prstGeom>
              <a:noFill/>
              <a:ln>
                <a:noFill/>
              </a:ln>
            </p:spPr>
          </p:pic>
          <p:cxnSp>
            <p:nvCxnSpPr>
              <p:cNvPr id="256" name="Google Shape;256;p2"/>
              <p:cNvCxnSpPr/>
              <p:nvPr/>
            </p:nvCxnSpPr>
            <p:spPr>
              <a:xfrm rot="10800000">
                <a:off x="5211867" y="741112"/>
                <a:ext cx="0" cy="491023"/>
              </a:xfrm>
              <a:prstGeom prst="straightConnector1">
                <a:avLst/>
              </a:prstGeom>
              <a:noFill/>
              <a:ln w="25400" cap="flat" cmpd="sng">
                <a:solidFill>
                  <a:schemeClr val="dk1"/>
                </a:solidFill>
                <a:prstDash val="solid"/>
                <a:miter lim="800000"/>
                <a:headEnd type="stealth" w="med" len="med"/>
                <a:tailEnd type="none" w="sm" len="sm"/>
              </a:ln>
            </p:spPr>
          </p:cxnSp>
        </p:grpSp>
        <p:grpSp>
          <p:nvGrpSpPr>
            <p:cNvPr id="257" name="Google Shape;257;p2"/>
            <p:cNvGrpSpPr/>
            <p:nvPr/>
          </p:nvGrpSpPr>
          <p:grpSpPr>
            <a:xfrm>
              <a:off x="5646614" y="932497"/>
              <a:ext cx="289512" cy="491023"/>
              <a:chOff x="5211867" y="741112"/>
              <a:chExt cx="289512" cy="491023"/>
            </a:xfrm>
          </p:grpSpPr>
          <p:pic>
            <p:nvPicPr>
              <p:cNvPr id="258" name="Google Shape;258;p2"/>
              <p:cNvPicPr preferRelativeResize="0"/>
              <p:nvPr/>
            </p:nvPicPr>
            <p:blipFill rotWithShape="1">
              <a:blip r:embed="rId4">
                <a:alphaModFix/>
              </a:blip>
              <a:srcRect l="5108" r="73711" b="61513"/>
              <a:stretch/>
            </p:blipFill>
            <p:spPr>
              <a:xfrm>
                <a:off x="5239432" y="805936"/>
                <a:ext cx="261947" cy="341750"/>
              </a:xfrm>
              <a:prstGeom prst="rect">
                <a:avLst/>
              </a:prstGeom>
              <a:noFill/>
              <a:ln>
                <a:noFill/>
              </a:ln>
            </p:spPr>
          </p:pic>
          <p:cxnSp>
            <p:nvCxnSpPr>
              <p:cNvPr id="259" name="Google Shape;259;p2"/>
              <p:cNvCxnSpPr/>
              <p:nvPr/>
            </p:nvCxnSpPr>
            <p:spPr>
              <a:xfrm rot="10800000">
                <a:off x="5211867" y="741112"/>
                <a:ext cx="0" cy="491023"/>
              </a:xfrm>
              <a:prstGeom prst="straightConnector1">
                <a:avLst/>
              </a:prstGeom>
              <a:noFill/>
              <a:ln w="25400" cap="flat" cmpd="sng">
                <a:solidFill>
                  <a:schemeClr val="dk1"/>
                </a:solidFill>
                <a:prstDash val="solid"/>
                <a:miter lim="800000"/>
                <a:headEnd type="stealth" w="med" len="med"/>
                <a:tailEnd type="none" w="sm" len="sm"/>
              </a:ln>
            </p:spPr>
          </p:cxnSp>
        </p:grpSp>
        <p:grpSp>
          <p:nvGrpSpPr>
            <p:cNvPr id="260" name="Google Shape;260;p2"/>
            <p:cNvGrpSpPr/>
            <p:nvPr/>
          </p:nvGrpSpPr>
          <p:grpSpPr>
            <a:xfrm>
              <a:off x="6081361" y="932497"/>
              <a:ext cx="289512" cy="491023"/>
              <a:chOff x="5211867" y="741112"/>
              <a:chExt cx="289512" cy="491023"/>
            </a:xfrm>
          </p:grpSpPr>
          <p:pic>
            <p:nvPicPr>
              <p:cNvPr id="261" name="Google Shape;261;p2"/>
              <p:cNvPicPr preferRelativeResize="0"/>
              <p:nvPr/>
            </p:nvPicPr>
            <p:blipFill rotWithShape="1">
              <a:blip r:embed="rId4">
                <a:alphaModFix/>
              </a:blip>
              <a:srcRect l="5108" r="73711" b="61513"/>
              <a:stretch/>
            </p:blipFill>
            <p:spPr>
              <a:xfrm>
                <a:off x="5239432" y="805936"/>
                <a:ext cx="261947" cy="341750"/>
              </a:xfrm>
              <a:prstGeom prst="rect">
                <a:avLst/>
              </a:prstGeom>
              <a:noFill/>
              <a:ln>
                <a:noFill/>
              </a:ln>
            </p:spPr>
          </p:pic>
          <p:cxnSp>
            <p:nvCxnSpPr>
              <p:cNvPr id="262" name="Google Shape;262;p2"/>
              <p:cNvCxnSpPr/>
              <p:nvPr/>
            </p:nvCxnSpPr>
            <p:spPr>
              <a:xfrm rot="10800000">
                <a:off x="5211867" y="741112"/>
                <a:ext cx="0" cy="491023"/>
              </a:xfrm>
              <a:prstGeom prst="straightConnector1">
                <a:avLst/>
              </a:prstGeom>
              <a:noFill/>
              <a:ln w="25400" cap="flat" cmpd="sng">
                <a:solidFill>
                  <a:schemeClr val="dk1"/>
                </a:solidFill>
                <a:prstDash val="solid"/>
                <a:miter lim="800000"/>
                <a:headEnd type="stealth" w="med" len="med"/>
                <a:tailEnd type="none" w="sm" len="sm"/>
              </a:ln>
            </p:spPr>
          </p:cxnSp>
        </p:grpSp>
        <p:grpSp>
          <p:nvGrpSpPr>
            <p:cNvPr id="263" name="Google Shape;263;p2"/>
            <p:cNvGrpSpPr/>
            <p:nvPr/>
          </p:nvGrpSpPr>
          <p:grpSpPr>
            <a:xfrm>
              <a:off x="6516108" y="932497"/>
              <a:ext cx="289512" cy="491023"/>
              <a:chOff x="5211867" y="741112"/>
              <a:chExt cx="289512" cy="491023"/>
            </a:xfrm>
          </p:grpSpPr>
          <p:pic>
            <p:nvPicPr>
              <p:cNvPr id="264" name="Google Shape;264;p2"/>
              <p:cNvPicPr preferRelativeResize="0"/>
              <p:nvPr/>
            </p:nvPicPr>
            <p:blipFill rotWithShape="1">
              <a:blip r:embed="rId4">
                <a:alphaModFix/>
              </a:blip>
              <a:srcRect l="5108" r="73711" b="61513"/>
              <a:stretch/>
            </p:blipFill>
            <p:spPr>
              <a:xfrm>
                <a:off x="5239432" y="805936"/>
                <a:ext cx="261947" cy="341750"/>
              </a:xfrm>
              <a:prstGeom prst="rect">
                <a:avLst/>
              </a:prstGeom>
              <a:noFill/>
              <a:ln>
                <a:noFill/>
              </a:ln>
            </p:spPr>
          </p:pic>
          <p:cxnSp>
            <p:nvCxnSpPr>
              <p:cNvPr id="265" name="Google Shape;265;p2"/>
              <p:cNvCxnSpPr/>
              <p:nvPr/>
            </p:nvCxnSpPr>
            <p:spPr>
              <a:xfrm rot="10800000">
                <a:off x="5211867" y="741112"/>
                <a:ext cx="0" cy="491023"/>
              </a:xfrm>
              <a:prstGeom prst="straightConnector1">
                <a:avLst/>
              </a:prstGeom>
              <a:noFill/>
              <a:ln w="25400" cap="flat" cmpd="sng">
                <a:solidFill>
                  <a:schemeClr val="dk1"/>
                </a:solidFill>
                <a:prstDash val="solid"/>
                <a:miter lim="800000"/>
                <a:headEnd type="stealth" w="med" len="med"/>
                <a:tailEnd type="none" w="sm" len="sm"/>
              </a:ln>
            </p:spPr>
          </p:cxnSp>
        </p:grpSp>
        <p:grpSp>
          <p:nvGrpSpPr>
            <p:cNvPr id="266" name="Google Shape;266;p2"/>
            <p:cNvGrpSpPr/>
            <p:nvPr/>
          </p:nvGrpSpPr>
          <p:grpSpPr>
            <a:xfrm>
              <a:off x="1973403" y="2144426"/>
              <a:ext cx="3868973" cy="414004"/>
              <a:chOff x="1994668" y="2101896"/>
              <a:chExt cx="3868973" cy="414004"/>
            </a:xfrm>
          </p:grpSpPr>
          <p:cxnSp>
            <p:nvCxnSpPr>
              <p:cNvPr id="267" name="Google Shape;267;p2"/>
              <p:cNvCxnSpPr/>
              <p:nvPr/>
            </p:nvCxnSpPr>
            <p:spPr>
              <a:xfrm rot="10800000">
                <a:off x="2007102" y="2287300"/>
                <a:ext cx="0" cy="228600"/>
              </a:xfrm>
              <a:prstGeom prst="straightConnector1">
                <a:avLst/>
              </a:prstGeom>
              <a:noFill/>
              <a:ln w="25400" cap="flat" cmpd="sng">
                <a:solidFill>
                  <a:schemeClr val="dk1"/>
                </a:solidFill>
                <a:prstDash val="solid"/>
                <a:miter lim="800000"/>
                <a:headEnd type="stealth" w="med" len="med"/>
                <a:tailEnd type="none" w="sm" len="sm"/>
              </a:ln>
            </p:spPr>
          </p:cxnSp>
          <p:cxnSp>
            <p:nvCxnSpPr>
              <p:cNvPr id="268" name="Google Shape;268;p2"/>
              <p:cNvCxnSpPr/>
              <p:nvPr/>
            </p:nvCxnSpPr>
            <p:spPr>
              <a:xfrm>
                <a:off x="1994668" y="2287300"/>
                <a:ext cx="3868973" cy="0"/>
              </a:xfrm>
              <a:prstGeom prst="straightConnector1">
                <a:avLst/>
              </a:prstGeom>
              <a:noFill/>
              <a:ln w="25400" cap="flat" cmpd="sng">
                <a:solidFill>
                  <a:schemeClr val="dk1"/>
                </a:solidFill>
                <a:prstDash val="solid"/>
                <a:miter lim="800000"/>
                <a:headEnd type="none" w="sm" len="sm"/>
                <a:tailEnd type="none" w="sm" len="sm"/>
              </a:ln>
            </p:spPr>
          </p:cxnSp>
          <p:cxnSp>
            <p:nvCxnSpPr>
              <p:cNvPr id="269" name="Google Shape;269;p2"/>
              <p:cNvCxnSpPr/>
              <p:nvPr/>
            </p:nvCxnSpPr>
            <p:spPr>
              <a:xfrm rot="10800000">
                <a:off x="5849211" y="2101896"/>
                <a:ext cx="0" cy="182880"/>
              </a:xfrm>
              <a:prstGeom prst="straightConnector1">
                <a:avLst/>
              </a:prstGeom>
              <a:noFill/>
              <a:ln w="25400" cap="flat" cmpd="sng">
                <a:solidFill>
                  <a:schemeClr val="dk1"/>
                </a:solidFill>
                <a:prstDash val="solid"/>
                <a:miter lim="800000"/>
                <a:headEnd type="none" w="sm" len="sm"/>
                <a:tailEnd type="none" w="sm" len="sm"/>
              </a:ln>
            </p:spPr>
          </p:cxnSp>
        </p:grpSp>
        <p:grpSp>
          <p:nvGrpSpPr>
            <p:cNvPr id="270" name="Google Shape;270;p2"/>
            <p:cNvGrpSpPr/>
            <p:nvPr/>
          </p:nvGrpSpPr>
          <p:grpSpPr>
            <a:xfrm>
              <a:off x="4840355" y="2964720"/>
              <a:ext cx="305250" cy="548640"/>
              <a:chOff x="5103139" y="3195110"/>
              <a:chExt cx="305250" cy="548640"/>
            </a:xfrm>
          </p:grpSpPr>
          <p:sp>
            <p:nvSpPr>
              <p:cNvPr id="271" name="Google Shape;271;p2"/>
              <p:cNvSpPr/>
              <p:nvPr/>
            </p:nvSpPr>
            <p:spPr>
              <a:xfrm>
                <a:off x="5122543" y="3651044"/>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72" name="Google Shape;272;p2"/>
              <p:cNvSpPr/>
              <p:nvPr/>
            </p:nvSpPr>
            <p:spPr>
              <a:xfrm>
                <a:off x="5108632" y="3402263"/>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73" name="Google Shape;273;p2"/>
              <p:cNvSpPr/>
              <p:nvPr/>
            </p:nvSpPr>
            <p:spPr>
              <a:xfrm>
                <a:off x="5122543" y="3339428"/>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74" name="Google Shape;274;p2"/>
              <p:cNvSpPr/>
              <p:nvPr/>
            </p:nvSpPr>
            <p:spPr>
              <a:xfrm>
                <a:off x="5177287" y="3296079"/>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275" name="Google Shape;275;p2"/>
              <p:cNvSpPr/>
              <p:nvPr/>
            </p:nvSpPr>
            <p:spPr>
              <a:xfrm>
                <a:off x="5103139" y="3234002"/>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76" name="Google Shape;276;p2"/>
              <p:cNvSpPr/>
              <p:nvPr/>
            </p:nvSpPr>
            <p:spPr>
              <a:xfrm>
                <a:off x="5182395" y="3218312"/>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77" name="Google Shape;277;p2"/>
              <p:cNvSpPr/>
              <p:nvPr/>
            </p:nvSpPr>
            <p:spPr>
              <a:xfrm>
                <a:off x="5183030" y="3195110"/>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78" name="Google Shape;278;p2"/>
              <p:cNvSpPr/>
              <p:nvPr/>
            </p:nvSpPr>
            <p:spPr>
              <a:xfrm rot="4804356">
                <a:off x="5243680" y="3598399"/>
                <a:ext cx="24258" cy="125311"/>
              </a:xfrm>
              <a:prstGeom prst="roundRect">
                <a:avLst>
                  <a:gd name="adj" fmla="val 16667"/>
                </a:avLst>
              </a:prstGeom>
              <a:solidFill>
                <a:srgbClr val="7F7F7F"/>
              </a:solidFill>
              <a:ln w="1270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grpSp>
        <p:grpSp>
          <p:nvGrpSpPr>
            <p:cNvPr id="279" name="Google Shape;279;p2"/>
            <p:cNvGrpSpPr/>
            <p:nvPr/>
          </p:nvGrpSpPr>
          <p:grpSpPr>
            <a:xfrm>
              <a:off x="6319238" y="2964720"/>
              <a:ext cx="305250" cy="548640"/>
              <a:chOff x="5103139" y="3195110"/>
              <a:chExt cx="305250" cy="548640"/>
            </a:xfrm>
          </p:grpSpPr>
          <p:sp>
            <p:nvSpPr>
              <p:cNvPr id="280" name="Google Shape;280;p2"/>
              <p:cNvSpPr/>
              <p:nvPr/>
            </p:nvSpPr>
            <p:spPr>
              <a:xfrm>
                <a:off x="5122543" y="3651044"/>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81" name="Google Shape;281;p2"/>
              <p:cNvSpPr/>
              <p:nvPr/>
            </p:nvSpPr>
            <p:spPr>
              <a:xfrm>
                <a:off x="5108632" y="3402263"/>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82" name="Google Shape;282;p2"/>
              <p:cNvSpPr/>
              <p:nvPr/>
            </p:nvSpPr>
            <p:spPr>
              <a:xfrm>
                <a:off x="5122543" y="3339428"/>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83" name="Google Shape;283;p2"/>
              <p:cNvSpPr/>
              <p:nvPr/>
            </p:nvSpPr>
            <p:spPr>
              <a:xfrm>
                <a:off x="5177287" y="3296079"/>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284" name="Google Shape;284;p2"/>
              <p:cNvSpPr/>
              <p:nvPr/>
            </p:nvSpPr>
            <p:spPr>
              <a:xfrm>
                <a:off x="5103139" y="3234002"/>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85" name="Google Shape;285;p2"/>
              <p:cNvSpPr/>
              <p:nvPr/>
            </p:nvSpPr>
            <p:spPr>
              <a:xfrm>
                <a:off x="5182395" y="3218312"/>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86" name="Google Shape;286;p2"/>
              <p:cNvSpPr/>
              <p:nvPr/>
            </p:nvSpPr>
            <p:spPr>
              <a:xfrm>
                <a:off x="5183030" y="3195110"/>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87" name="Google Shape;287;p2"/>
              <p:cNvSpPr/>
              <p:nvPr/>
            </p:nvSpPr>
            <p:spPr>
              <a:xfrm rot="4804356">
                <a:off x="5243680" y="3598399"/>
                <a:ext cx="24258" cy="125311"/>
              </a:xfrm>
              <a:prstGeom prst="roundRect">
                <a:avLst>
                  <a:gd name="adj" fmla="val 16667"/>
                </a:avLst>
              </a:prstGeom>
              <a:solidFill>
                <a:srgbClr val="7F7F7F"/>
              </a:solidFill>
              <a:ln w="1270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grpSp>
        <p:grpSp>
          <p:nvGrpSpPr>
            <p:cNvPr id="288" name="Google Shape;288;p2"/>
            <p:cNvGrpSpPr/>
            <p:nvPr/>
          </p:nvGrpSpPr>
          <p:grpSpPr>
            <a:xfrm>
              <a:off x="5302189" y="2964720"/>
              <a:ext cx="305250" cy="548640"/>
              <a:chOff x="5103139" y="3195110"/>
              <a:chExt cx="305250" cy="548640"/>
            </a:xfrm>
          </p:grpSpPr>
          <p:sp>
            <p:nvSpPr>
              <p:cNvPr id="289" name="Google Shape;289;p2"/>
              <p:cNvSpPr/>
              <p:nvPr/>
            </p:nvSpPr>
            <p:spPr>
              <a:xfrm>
                <a:off x="5122543" y="3651044"/>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90" name="Google Shape;290;p2"/>
              <p:cNvSpPr/>
              <p:nvPr/>
            </p:nvSpPr>
            <p:spPr>
              <a:xfrm>
                <a:off x="5108632" y="3402263"/>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91" name="Google Shape;291;p2"/>
              <p:cNvSpPr/>
              <p:nvPr/>
            </p:nvSpPr>
            <p:spPr>
              <a:xfrm>
                <a:off x="5122543" y="3339428"/>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92" name="Google Shape;292;p2"/>
              <p:cNvSpPr/>
              <p:nvPr/>
            </p:nvSpPr>
            <p:spPr>
              <a:xfrm>
                <a:off x="5177287" y="3296079"/>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293" name="Google Shape;293;p2"/>
              <p:cNvSpPr/>
              <p:nvPr/>
            </p:nvSpPr>
            <p:spPr>
              <a:xfrm>
                <a:off x="5103139" y="3234002"/>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94" name="Google Shape;294;p2"/>
              <p:cNvSpPr/>
              <p:nvPr/>
            </p:nvSpPr>
            <p:spPr>
              <a:xfrm>
                <a:off x="5182395" y="3218312"/>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95" name="Google Shape;295;p2"/>
              <p:cNvSpPr/>
              <p:nvPr/>
            </p:nvSpPr>
            <p:spPr>
              <a:xfrm>
                <a:off x="5183030" y="3195110"/>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96" name="Google Shape;296;p2"/>
              <p:cNvSpPr/>
              <p:nvPr/>
            </p:nvSpPr>
            <p:spPr>
              <a:xfrm rot="4804356">
                <a:off x="5243680" y="3598399"/>
                <a:ext cx="24258" cy="125311"/>
              </a:xfrm>
              <a:prstGeom prst="roundRect">
                <a:avLst>
                  <a:gd name="adj" fmla="val 16667"/>
                </a:avLst>
              </a:prstGeom>
              <a:solidFill>
                <a:srgbClr val="7F7F7F"/>
              </a:solidFill>
              <a:ln w="1270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grpSp>
        <p:grpSp>
          <p:nvGrpSpPr>
            <p:cNvPr id="297" name="Google Shape;297;p2"/>
            <p:cNvGrpSpPr/>
            <p:nvPr/>
          </p:nvGrpSpPr>
          <p:grpSpPr>
            <a:xfrm>
              <a:off x="5857405" y="2964720"/>
              <a:ext cx="305250" cy="548640"/>
              <a:chOff x="5103139" y="3195110"/>
              <a:chExt cx="305250" cy="548640"/>
            </a:xfrm>
          </p:grpSpPr>
          <p:sp>
            <p:nvSpPr>
              <p:cNvPr id="298" name="Google Shape;298;p2"/>
              <p:cNvSpPr/>
              <p:nvPr/>
            </p:nvSpPr>
            <p:spPr>
              <a:xfrm>
                <a:off x="5122543" y="3651044"/>
                <a:ext cx="270692" cy="79131"/>
              </a:xfrm>
              <a:prstGeom prst="roundRect">
                <a:avLst>
                  <a:gd name="adj" fmla="val 50000"/>
                </a:avLst>
              </a:prstGeom>
              <a:solidFill>
                <a:schemeClr val="accent6">
                  <a:alpha val="33333"/>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299" name="Google Shape;299;p2"/>
              <p:cNvSpPr/>
              <p:nvPr/>
            </p:nvSpPr>
            <p:spPr>
              <a:xfrm>
                <a:off x="5108632" y="3402263"/>
                <a:ext cx="296049" cy="334215"/>
              </a:xfrm>
              <a:prstGeom prst="roundRect">
                <a:avLst>
                  <a:gd name="adj" fmla="val 23077"/>
                </a:avLst>
              </a:prstGeom>
              <a:solidFill>
                <a:srgbClr val="00B050">
                  <a:alpha val="45098"/>
                </a:srgb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00" name="Google Shape;300;p2"/>
              <p:cNvSpPr/>
              <p:nvPr/>
            </p:nvSpPr>
            <p:spPr>
              <a:xfrm>
                <a:off x="5122543" y="3339428"/>
                <a:ext cx="266841" cy="134565"/>
              </a:xfrm>
              <a:prstGeom prst="roundRect">
                <a:avLst>
                  <a:gd name="adj" fmla="val 37450"/>
                </a:avLst>
              </a:prstGeom>
              <a:solidFill>
                <a:schemeClr val="lt1">
                  <a:alpha val="45098"/>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01" name="Google Shape;301;p2"/>
              <p:cNvSpPr/>
              <p:nvPr/>
            </p:nvSpPr>
            <p:spPr>
              <a:xfrm>
                <a:off x="5177287" y="3296079"/>
                <a:ext cx="162649" cy="61075"/>
              </a:xfrm>
              <a:prstGeom prst="arc">
                <a:avLst>
                  <a:gd name="adj1" fmla="val 21502752"/>
                  <a:gd name="adj2" fmla="val 10964922"/>
                </a:avLst>
              </a:pr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dk1"/>
                  </a:solidFill>
                  <a:latin typeface="Times New Roman"/>
                  <a:ea typeface="Times New Roman"/>
                  <a:cs typeface="Times New Roman"/>
                  <a:sym typeface="Times New Roman"/>
                </a:endParaRPr>
              </a:p>
            </p:txBody>
          </p:sp>
          <p:sp>
            <p:nvSpPr>
              <p:cNvPr id="302" name="Google Shape;302;p2"/>
              <p:cNvSpPr/>
              <p:nvPr/>
            </p:nvSpPr>
            <p:spPr>
              <a:xfrm>
                <a:off x="5103139" y="3234002"/>
                <a:ext cx="305250" cy="509748"/>
              </a:xfrm>
              <a:custGeom>
                <a:avLst/>
                <a:gdLst/>
                <a:ahLst/>
                <a:cxnLst/>
                <a:rect l="l" t="t" r="r" b="b"/>
                <a:pathLst>
                  <a:path w="791027" h="1411053" extrusionOk="0">
                    <a:moveTo>
                      <a:pt x="205541" y="0"/>
                    </a:moveTo>
                    <a:lnTo>
                      <a:pt x="585486" y="0"/>
                    </a:lnTo>
                    <a:lnTo>
                      <a:pt x="585486" y="255206"/>
                    </a:lnTo>
                    <a:lnTo>
                      <a:pt x="660135" y="270277"/>
                    </a:lnTo>
                    <a:cubicBezTo>
                      <a:pt x="737055" y="302811"/>
                      <a:pt x="791027" y="378977"/>
                      <a:pt x="791027" y="467748"/>
                    </a:cubicBezTo>
                    <a:lnTo>
                      <a:pt x="791027" y="1196740"/>
                    </a:lnTo>
                    <a:cubicBezTo>
                      <a:pt x="791027" y="1315102"/>
                      <a:pt x="695076" y="1411053"/>
                      <a:pt x="576714" y="1411053"/>
                    </a:cubicBezTo>
                    <a:lnTo>
                      <a:pt x="214313" y="1411053"/>
                    </a:lnTo>
                    <a:cubicBezTo>
                      <a:pt x="95951" y="1411053"/>
                      <a:pt x="0" y="1315102"/>
                      <a:pt x="0" y="1196740"/>
                    </a:cubicBezTo>
                    <a:lnTo>
                      <a:pt x="0" y="467748"/>
                    </a:lnTo>
                    <a:cubicBezTo>
                      <a:pt x="0" y="378977"/>
                      <a:pt x="53972" y="302811"/>
                      <a:pt x="130892" y="270277"/>
                    </a:cubicBezTo>
                    <a:lnTo>
                      <a:pt x="205541" y="255206"/>
                    </a:lnTo>
                    <a:close/>
                  </a:path>
                </a:pathLst>
              </a:custGeom>
              <a:no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03" name="Google Shape;303;p2"/>
              <p:cNvSpPr/>
              <p:nvPr/>
            </p:nvSpPr>
            <p:spPr>
              <a:xfrm>
                <a:off x="5182395" y="3218312"/>
                <a:ext cx="146932" cy="75572"/>
              </a:xfrm>
              <a:prstGeom prst="ellipse">
                <a:avLst/>
              </a:prstGeom>
              <a:solidFill>
                <a:schemeClr val="accent2"/>
              </a:soli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04" name="Google Shape;304;p2"/>
              <p:cNvSpPr/>
              <p:nvPr/>
            </p:nvSpPr>
            <p:spPr>
              <a:xfrm>
                <a:off x="5183030" y="3195110"/>
                <a:ext cx="146297" cy="58635"/>
              </a:xfrm>
              <a:prstGeom prst="ellipse">
                <a:avLst/>
              </a:prstGeom>
              <a:gradFill>
                <a:gsLst>
                  <a:gs pos="0">
                    <a:srgbClr val="FFC000"/>
                  </a:gs>
                  <a:gs pos="100000">
                    <a:schemeClr val="accent2"/>
                  </a:gs>
                </a:gsLst>
                <a:path path="circle">
                  <a:fillToRect l="50000" t="50000" r="50000" b="50000"/>
                </a:path>
                <a:tileRect/>
              </a:gradFill>
              <a:ln w="2857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05" name="Google Shape;305;p2"/>
              <p:cNvSpPr/>
              <p:nvPr/>
            </p:nvSpPr>
            <p:spPr>
              <a:xfrm rot="4804356">
                <a:off x="5243680" y="3598399"/>
                <a:ext cx="24258" cy="125311"/>
              </a:xfrm>
              <a:prstGeom prst="roundRect">
                <a:avLst>
                  <a:gd name="adj" fmla="val 16667"/>
                </a:avLst>
              </a:prstGeom>
              <a:solidFill>
                <a:srgbClr val="7F7F7F"/>
              </a:solidFill>
              <a:ln w="12700"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endParaRPr sz="1000" b="0" i="0" u="none" strike="noStrike" cap="none">
                  <a:solidFill>
                    <a:schemeClr val="lt1"/>
                  </a:solidFill>
                  <a:latin typeface="Times New Roman"/>
                  <a:ea typeface="Times New Roman"/>
                  <a:cs typeface="Times New Roman"/>
                  <a:sym typeface="Times New Roman"/>
                </a:endParaRPr>
              </a:p>
            </p:txBody>
          </p:sp>
        </p:grpSp>
        <p:sp>
          <p:nvSpPr>
            <p:cNvPr id="306" name="Google Shape;306;p2"/>
            <p:cNvSpPr txBox="1"/>
            <p:nvPr/>
          </p:nvSpPr>
          <p:spPr>
            <a:xfrm>
              <a:off x="1343181" y="3640148"/>
              <a:ext cx="558800"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LL-Hy</a:t>
              </a:r>
              <a:endParaRPr sz="1000" b="1" i="0" u="none" strike="noStrike" cap="none">
                <a:solidFill>
                  <a:schemeClr val="dk1"/>
                </a:solidFill>
                <a:latin typeface="Times New Roman"/>
                <a:ea typeface="Times New Roman"/>
                <a:cs typeface="Times New Roman"/>
                <a:sym typeface="Times New Roman"/>
              </a:endParaRPr>
            </a:p>
          </p:txBody>
        </p:sp>
        <p:sp>
          <p:nvSpPr>
            <p:cNvPr id="307" name="Google Shape;307;p2"/>
            <p:cNvSpPr txBox="1"/>
            <p:nvPr/>
          </p:nvSpPr>
          <p:spPr>
            <a:xfrm>
              <a:off x="2083502" y="3640148"/>
              <a:ext cx="558800"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LL-Ox</a:t>
              </a:r>
              <a:endParaRPr sz="1400" b="0" i="0" u="none" strike="noStrike" cap="none">
                <a:solidFill>
                  <a:srgbClr val="000000"/>
                </a:solidFill>
                <a:latin typeface="Arial"/>
                <a:ea typeface="Arial"/>
                <a:cs typeface="Arial"/>
                <a:sym typeface="Arial"/>
              </a:endParaRPr>
            </a:p>
          </p:txBody>
        </p:sp>
        <p:pic>
          <p:nvPicPr>
            <p:cNvPr id="308" name="Google Shape;308;p2"/>
            <p:cNvPicPr preferRelativeResize="0"/>
            <p:nvPr/>
          </p:nvPicPr>
          <p:blipFill rotWithShape="1">
            <a:blip r:embed="rId4">
              <a:alphaModFix/>
            </a:blip>
            <a:srcRect l="5108" r="73711" b="61513"/>
            <a:stretch/>
          </p:blipFill>
          <p:spPr>
            <a:xfrm>
              <a:off x="4896196" y="4158434"/>
              <a:ext cx="261947" cy="341750"/>
            </a:xfrm>
            <a:prstGeom prst="rect">
              <a:avLst/>
            </a:prstGeom>
            <a:noFill/>
            <a:ln>
              <a:noFill/>
            </a:ln>
          </p:spPr>
        </p:pic>
        <p:cxnSp>
          <p:nvCxnSpPr>
            <p:cNvPr id="309" name="Google Shape;309;p2"/>
            <p:cNvCxnSpPr/>
            <p:nvPr/>
          </p:nvCxnSpPr>
          <p:spPr>
            <a:xfrm rot="10800000">
              <a:off x="4992001" y="3846870"/>
              <a:ext cx="0" cy="274320"/>
            </a:xfrm>
            <a:prstGeom prst="straightConnector1">
              <a:avLst/>
            </a:prstGeom>
            <a:noFill/>
            <a:ln w="25400" cap="flat" cmpd="sng">
              <a:solidFill>
                <a:schemeClr val="dk1"/>
              </a:solidFill>
              <a:prstDash val="solid"/>
              <a:miter lim="800000"/>
              <a:headEnd type="stealth" w="med" len="med"/>
              <a:tailEnd type="none" w="sm" len="sm"/>
            </a:ln>
          </p:spPr>
        </p:cxnSp>
        <p:pic>
          <p:nvPicPr>
            <p:cNvPr id="310" name="Google Shape;310;p2"/>
            <p:cNvPicPr preferRelativeResize="0"/>
            <p:nvPr/>
          </p:nvPicPr>
          <p:blipFill rotWithShape="1">
            <a:blip r:embed="rId4">
              <a:alphaModFix/>
            </a:blip>
            <a:srcRect l="5108" r="73711" b="61513"/>
            <a:stretch/>
          </p:blipFill>
          <p:spPr>
            <a:xfrm>
              <a:off x="5388543" y="4158434"/>
              <a:ext cx="261947" cy="341750"/>
            </a:xfrm>
            <a:prstGeom prst="rect">
              <a:avLst/>
            </a:prstGeom>
            <a:noFill/>
            <a:ln>
              <a:noFill/>
            </a:ln>
          </p:spPr>
        </p:pic>
        <p:cxnSp>
          <p:nvCxnSpPr>
            <p:cNvPr id="311" name="Google Shape;311;p2"/>
            <p:cNvCxnSpPr/>
            <p:nvPr/>
          </p:nvCxnSpPr>
          <p:spPr>
            <a:xfrm rot="10800000">
              <a:off x="5488206" y="3846870"/>
              <a:ext cx="0" cy="274320"/>
            </a:xfrm>
            <a:prstGeom prst="straightConnector1">
              <a:avLst/>
            </a:prstGeom>
            <a:noFill/>
            <a:ln w="25400" cap="flat" cmpd="sng">
              <a:solidFill>
                <a:schemeClr val="dk1"/>
              </a:solidFill>
              <a:prstDash val="solid"/>
              <a:miter lim="800000"/>
              <a:headEnd type="stealth" w="med" len="med"/>
              <a:tailEnd type="none" w="sm" len="sm"/>
            </a:ln>
          </p:spPr>
        </p:cxnSp>
        <p:pic>
          <p:nvPicPr>
            <p:cNvPr id="312" name="Google Shape;312;p2"/>
            <p:cNvPicPr preferRelativeResize="0"/>
            <p:nvPr/>
          </p:nvPicPr>
          <p:blipFill rotWithShape="1">
            <a:blip r:embed="rId4">
              <a:alphaModFix/>
            </a:blip>
            <a:srcRect l="5108" r="73711" b="61513"/>
            <a:stretch/>
          </p:blipFill>
          <p:spPr>
            <a:xfrm>
              <a:off x="5916672" y="4158434"/>
              <a:ext cx="261947" cy="341750"/>
            </a:xfrm>
            <a:prstGeom prst="rect">
              <a:avLst/>
            </a:prstGeom>
            <a:noFill/>
            <a:ln>
              <a:noFill/>
            </a:ln>
          </p:spPr>
        </p:pic>
        <p:cxnSp>
          <p:nvCxnSpPr>
            <p:cNvPr id="313" name="Google Shape;313;p2"/>
            <p:cNvCxnSpPr/>
            <p:nvPr/>
          </p:nvCxnSpPr>
          <p:spPr>
            <a:xfrm rot="10800000">
              <a:off x="6012477" y="3846870"/>
              <a:ext cx="0" cy="274320"/>
            </a:xfrm>
            <a:prstGeom prst="straightConnector1">
              <a:avLst/>
            </a:prstGeom>
            <a:noFill/>
            <a:ln w="25400" cap="flat" cmpd="sng">
              <a:solidFill>
                <a:schemeClr val="dk1"/>
              </a:solidFill>
              <a:prstDash val="solid"/>
              <a:miter lim="800000"/>
              <a:headEnd type="stealth" w="med" len="med"/>
              <a:tailEnd type="none" w="sm" len="sm"/>
            </a:ln>
          </p:spPr>
        </p:cxnSp>
        <p:pic>
          <p:nvPicPr>
            <p:cNvPr id="314" name="Google Shape;314;p2"/>
            <p:cNvPicPr preferRelativeResize="0"/>
            <p:nvPr/>
          </p:nvPicPr>
          <p:blipFill rotWithShape="1">
            <a:blip r:embed="rId4">
              <a:alphaModFix/>
            </a:blip>
            <a:srcRect l="5108" r="73711" b="61513"/>
            <a:stretch/>
          </p:blipFill>
          <p:spPr>
            <a:xfrm>
              <a:off x="6380219" y="4158434"/>
              <a:ext cx="261947" cy="341750"/>
            </a:xfrm>
            <a:prstGeom prst="rect">
              <a:avLst/>
            </a:prstGeom>
            <a:noFill/>
            <a:ln>
              <a:noFill/>
            </a:ln>
          </p:spPr>
        </p:pic>
        <p:cxnSp>
          <p:nvCxnSpPr>
            <p:cNvPr id="315" name="Google Shape;315;p2"/>
            <p:cNvCxnSpPr/>
            <p:nvPr/>
          </p:nvCxnSpPr>
          <p:spPr>
            <a:xfrm rot="10800000">
              <a:off x="6476024" y="3846870"/>
              <a:ext cx="0" cy="274320"/>
            </a:xfrm>
            <a:prstGeom prst="straightConnector1">
              <a:avLst/>
            </a:prstGeom>
            <a:noFill/>
            <a:ln w="25400" cap="flat" cmpd="sng">
              <a:solidFill>
                <a:schemeClr val="dk1"/>
              </a:solidFill>
              <a:prstDash val="solid"/>
              <a:miter lim="800000"/>
              <a:headEnd type="stealth" w="med" len="med"/>
              <a:tailEnd type="none" w="sm" len="sm"/>
            </a:ln>
          </p:spPr>
        </p:cxnSp>
        <p:cxnSp>
          <p:nvCxnSpPr>
            <p:cNvPr id="316" name="Google Shape;316;p2"/>
            <p:cNvCxnSpPr/>
            <p:nvPr/>
          </p:nvCxnSpPr>
          <p:spPr>
            <a:xfrm>
              <a:off x="3734498" y="3674785"/>
              <a:ext cx="457200" cy="0"/>
            </a:xfrm>
            <a:prstGeom prst="straightConnector1">
              <a:avLst/>
            </a:prstGeom>
            <a:noFill/>
            <a:ln w="25400" cap="flat" cmpd="sng">
              <a:solidFill>
                <a:schemeClr val="dk1"/>
              </a:solidFill>
              <a:prstDash val="solid"/>
              <a:miter lim="800000"/>
              <a:headEnd type="none" w="sm" len="sm"/>
              <a:tailEnd type="stealth" w="med" len="med"/>
            </a:ln>
          </p:spPr>
        </p:cxnSp>
        <p:sp>
          <p:nvSpPr>
            <p:cNvPr id="317" name="Google Shape;317;p2"/>
            <p:cNvSpPr txBox="1"/>
            <p:nvPr/>
          </p:nvSpPr>
          <p:spPr>
            <a:xfrm>
              <a:off x="3080763" y="2347024"/>
              <a:ext cx="1655576"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Growth under 4 conditions</a:t>
              </a:r>
              <a:endParaRPr sz="1400" b="0" i="0" u="none" strike="noStrike" cap="none">
                <a:solidFill>
                  <a:srgbClr val="000000"/>
                </a:solidFill>
                <a:latin typeface="Arial"/>
                <a:ea typeface="Arial"/>
                <a:cs typeface="Arial"/>
                <a:sym typeface="Arial"/>
              </a:endParaRPr>
            </a:p>
          </p:txBody>
        </p:sp>
        <p:sp>
          <p:nvSpPr>
            <p:cNvPr id="318" name="Google Shape;318;p2"/>
            <p:cNvSpPr txBox="1"/>
            <p:nvPr/>
          </p:nvSpPr>
          <p:spPr>
            <a:xfrm>
              <a:off x="4850568" y="4581059"/>
              <a:ext cx="1791598"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Extraction of genomic DNAs</a:t>
              </a:r>
              <a:endParaRPr sz="1400" b="0" i="0" u="none" strike="noStrike" cap="none">
                <a:solidFill>
                  <a:srgbClr val="000000"/>
                </a:solidFill>
                <a:latin typeface="Arial"/>
                <a:ea typeface="Arial"/>
                <a:cs typeface="Arial"/>
                <a:sym typeface="Arial"/>
              </a:endParaRPr>
            </a:p>
          </p:txBody>
        </p:sp>
        <p:pic>
          <p:nvPicPr>
            <p:cNvPr id="319" name="Google Shape;319;p2"/>
            <p:cNvPicPr preferRelativeResize="0"/>
            <p:nvPr/>
          </p:nvPicPr>
          <p:blipFill rotWithShape="1">
            <a:blip r:embed="rId5">
              <a:alphaModFix/>
            </a:blip>
            <a:srcRect l="1812" t="70983" r="78939" b="6682"/>
            <a:stretch/>
          </p:blipFill>
          <p:spPr>
            <a:xfrm>
              <a:off x="1286237" y="5388936"/>
              <a:ext cx="1126100" cy="1299447"/>
            </a:xfrm>
            <a:prstGeom prst="rect">
              <a:avLst/>
            </a:prstGeom>
            <a:noFill/>
            <a:ln>
              <a:noFill/>
            </a:ln>
          </p:spPr>
        </p:pic>
        <p:grpSp>
          <p:nvGrpSpPr>
            <p:cNvPr id="320" name="Google Shape;320;p2"/>
            <p:cNvGrpSpPr/>
            <p:nvPr/>
          </p:nvGrpSpPr>
          <p:grpSpPr>
            <a:xfrm>
              <a:off x="1842118" y="4863863"/>
              <a:ext cx="4023360" cy="414004"/>
              <a:chOff x="2033503" y="2101896"/>
              <a:chExt cx="4023360" cy="414004"/>
            </a:xfrm>
          </p:grpSpPr>
          <p:cxnSp>
            <p:nvCxnSpPr>
              <p:cNvPr id="321" name="Google Shape;321;p2"/>
              <p:cNvCxnSpPr/>
              <p:nvPr/>
            </p:nvCxnSpPr>
            <p:spPr>
              <a:xfrm rot="10800000">
                <a:off x="2045379" y="2287300"/>
                <a:ext cx="0" cy="228600"/>
              </a:xfrm>
              <a:prstGeom prst="straightConnector1">
                <a:avLst/>
              </a:prstGeom>
              <a:noFill/>
              <a:ln w="25400" cap="flat" cmpd="sng">
                <a:solidFill>
                  <a:schemeClr val="dk1"/>
                </a:solidFill>
                <a:prstDash val="solid"/>
                <a:miter lim="800000"/>
                <a:headEnd type="stealth" w="med" len="med"/>
                <a:tailEnd type="none" w="sm" len="sm"/>
              </a:ln>
            </p:spPr>
          </p:cxnSp>
          <p:cxnSp>
            <p:nvCxnSpPr>
              <p:cNvPr id="322" name="Google Shape;322;p2"/>
              <p:cNvCxnSpPr/>
              <p:nvPr/>
            </p:nvCxnSpPr>
            <p:spPr>
              <a:xfrm>
                <a:off x="2033503" y="2287300"/>
                <a:ext cx="4023360" cy="0"/>
              </a:xfrm>
              <a:prstGeom prst="straightConnector1">
                <a:avLst/>
              </a:prstGeom>
              <a:noFill/>
              <a:ln w="25400" cap="flat" cmpd="sng">
                <a:solidFill>
                  <a:schemeClr val="dk1"/>
                </a:solidFill>
                <a:prstDash val="solid"/>
                <a:miter lim="800000"/>
                <a:headEnd type="none" w="sm" len="sm"/>
                <a:tailEnd type="none" w="sm" len="sm"/>
              </a:ln>
            </p:spPr>
          </p:cxnSp>
          <p:cxnSp>
            <p:nvCxnSpPr>
              <p:cNvPr id="323" name="Google Shape;323;p2"/>
              <p:cNvCxnSpPr/>
              <p:nvPr/>
            </p:nvCxnSpPr>
            <p:spPr>
              <a:xfrm rot="10800000">
                <a:off x="6041556" y="2101896"/>
                <a:ext cx="0" cy="182880"/>
              </a:xfrm>
              <a:prstGeom prst="straightConnector1">
                <a:avLst/>
              </a:prstGeom>
              <a:noFill/>
              <a:ln w="25400" cap="flat" cmpd="sng">
                <a:solidFill>
                  <a:schemeClr val="dk1"/>
                </a:solidFill>
                <a:prstDash val="solid"/>
                <a:miter lim="800000"/>
                <a:headEnd type="none" w="sm" len="sm"/>
                <a:tailEnd type="none" w="sm" len="sm"/>
              </a:ln>
            </p:spPr>
          </p:cxnSp>
        </p:grpSp>
        <p:sp>
          <p:nvSpPr>
            <p:cNvPr id="324" name="Google Shape;324;p2"/>
            <p:cNvSpPr txBox="1"/>
            <p:nvPr/>
          </p:nvSpPr>
          <p:spPr>
            <a:xfrm>
              <a:off x="1206914" y="6683398"/>
              <a:ext cx="1309422"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Gel electrophoresis</a:t>
              </a:r>
              <a:endParaRPr sz="1400" b="0" i="0" u="none" strike="noStrike" cap="none">
                <a:solidFill>
                  <a:srgbClr val="000000"/>
                </a:solidFill>
                <a:latin typeface="Arial"/>
                <a:ea typeface="Arial"/>
                <a:cs typeface="Arial"/>
                <a:sym typeface="Arial"/>
              </a:endParaRPr>
            </a:p>
          </p:txBody>
        </p:sp>
        <p:grpSp>
          <p:nvGrpSpPr>
            <p:cNvPr id="325" name="Google Shape;325;p2"/>
            <p:cNvGrpSpPr/>
            <p:nvPr/>
          </p:nvGrpSpPr>
          <p:grpSpPr>
            <a:xfrm>
              <a:off x="3421051" y="5644113"/>
              <a:ext cx="1024884" cy="949857"/>
              <a:chOff x="3674963" y="5267130"/>
              <a:chExt cx="1024884" cy="1324921"/>
            </a:xfrm>
          </p:grpSpPr>
          <p:sp>
            <p:nvSpPr>
              <p:cNvPr id="326" name="Google Shape;326;p2"/>
              <p:cNvSpPr/>
              <p:nvPr/>
            </p:nvSpPr>
            <p:spPr>
              <a:xfrm>
                <a:off x="3674963" y="5267130"/>
                <a:ext cx="1024884" cy="1324921"/>
              </a:xfrm>
              <a:prstGeom prst="roundRect">
                <a:avLst>
                  <a:gd name="adj" fmla="val 12690"/>
                </a:avLst>
              </a:prstGeom>
              <a:gradFill>
                <a:gsLst>
                  <a:gs pos="0">
                    <a:srgbClr val="FBE4D4">
                      <a:alpha val="0"/>
                    </a:srgbClr>
                  </a:gs>
                  <a:gs pos="85000">
                    <a:srgbClr val="FBE4D4"/>
                  </a:gs>
                  <a:gs pos="92500">
                    <a:srgbClr val="FDF2EB"/>
                  </a:gs>
                  <a:gs pos="96250">
                    <a:srgbClr val="FEF9F5"/>
                  </a:gs>
                  <a:gs pos="100000">
                    <a:schemeClr val="lt1"/>
                  </a:gs>
                </a:gsLst>
                <a:path path="circle">
                  <a:fillToRect l="50000" t="50000" r="50000" b="50000"/>
                </a:path>
                <a:tileRect/>
              </a:gradFill>
              <a:ln w="25400" cap="flat" cmpd="sng">
                <a:solidFill>
                  <a:srgbClr val="FF0000">
                    <a:alpha val="43137"/>
                  </a:srgbClr>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nvGrpSpPr>
              <p:cNvPr id="327" name="Google Shape;327;p2"/>
              <p:cNvGrpSpPr/>
              <p:nvPr/>
            </p:nvGrpSpPr>
            <p:grpSpPr>
              <a:xfrm>
                <a:off x="3825826" y="5549622"/>
                <a:ext cx="731520" cy="27432"/>
                <a:chOff x="1388619" y="2967171"/>
                <a:chExt cx="1461659" cy="56186"/>
              </a:xfrm>
            </p:grpSpPr>
            <p:sp>
              <p:nvSpPr>
                <p:cNvPr id="328" name="Google Shape;328;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29" name="Google Shape;329;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30" name="Google Shape;330;p2"/>
                <p:cNvSpPr/>
                <p:nvPr/>
              </p:nvSpPr>
              <p:spPr>
                <a:xfrm>
                  <a:off x="1660707" y="2967171"/>
                  <a:ext cx="914400" cy="56186"/>
                </a:xfrm>
                <a:prstGeom prst="rect">
                  <a:avLst/>
                </a:prstGeom>
                <a:solidFill>
                  <a:srgbClr val="C55A11">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31" name="Google Shape;331;p2"/>
              <p:cNvGrpSpPr/>
              <p:nvPr/>
            </p:nvGrpSpPr>
            <p:grpSpPr>
              <a:xfrm>
                <a:off x="3825826" y="5648372"/>
                <a:ext cx="731520" cy="27432"/>
                <a:chOff x="1388619" y="2967171"/>
                <a:chExt cx="1461659" cy="56186"/>
              </a:xfrm>
            </p:grpSpPr>
            <p:sp>
              <p:nvSpPr>
                <p:cNvPr id="332" name="Google Shape;332;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33" name="Google Shape;333;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34" name="Google Shape;334;p2"/>
                <p:cNvSpPr/>
                <p:nvPr/>
              </p:nvSpPr>
              <p:spPr>
                <a:xfrm>
                  <a:off x="1660707" y="2967171"/>
                  <a:ext cx="914400" cy="56186"/>
                </a:xfrm>
                <a:prstGeom prst="rect">
                  <a:avLst/>
                </a:prstGeom>
                <a:solidFill>
                  <a:srgbClr val="1F3864">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35" name="Google Shape;335;p2"/>
              <p:cNvGrpSpPr/>
              <p:nvPr/>
            </p:nvGrpSpPr>
            <p:grpSpPr>
              <a:xfrm>
                <a:off x="3825826" y="5796497"/>
                <a:ext cx="731520" cy="27432"/>
                <a:chOff x="1388619" y="2967171"/>
                <a:chExt cx="1461659" cy="56186"/>
              </a:xfrm>
            </p:grpSpPr>
            <p:sp>
              <p:nvSpPr>
                <p:cNvPr id="336" name="Google Shape;336;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37" name="Google Shape;337;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38" name="Google Shape;338;p2"/>
                <p:cNvSpPr/>
                <p:nvPr/>
              </p:nvSpPr>
              <p:spPr>
                <a:xfrm>
                  <a:off x="1660707" y="2967171"/>
                  <a:ext cx="914400" cy="56186"/>
                </a:xfrm>
                <a:prstGeom prst="rect">
                  <a:avLst/>
                </a:prstGeom>
                <a:solidFill>
                  <a:srgbClr val="C00000">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39" name="Google Shape;339;p2"/>
              <p:cNvGrpSpPr/>
              <p:nvPr/>
            </p:nvGrpSpPr>
            <p:grpSpPr>
              <a:xfrm>
                <a:off x="3825826" y="5895247"/>
                <a:ext cx="731520" cy="27432"/>
                <a:chOff x="1388619" y="2967171"/>
                <a:chExt cx="1461659" cy="56186"/>
              </a:xfrm>
            </p:grpSpPr>
            <p:sp>
              <p:nvSpPr>
                <p:cNvPr id="340" name="Google Shape;340;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41" name="Google Shape;341;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42" name="Google Shape;342;p2"/>
                <p:cNvSpPr/>
                <p:nvPr/>
              </p:nvSpPr>
              <p:spPr>
                <a:xfrm>
                  <a:off x="1660707" y="2967171"/>
                  <a:ext cx="914400" cy="56186"/>
                </a:xfrm>
                <a:prstGeom prst="rect">
                  <a:avLst/>
                </a:prstGeom>
                <a:solidFill>
                  <a:srgbClr val="0070C0">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43" name="Google Shape;343;p2"/>
              <p:cNvGrpSpPr/>
              <p:nvPr/>
            </p:nvGrpSpPr>
            <p:grpSpPr>
              <a:xfrm>
                <a:off x="3825826" y="6142122"/>
                <a:ext cx="731520" cy="27432"/>
                <a:chOff x="1388619" y="2967171"/>
                <a:chExt cx="1461659" cy="56186"/>
              </a:xfrm>
            </p:grpSpPr>
            <p:sp>
              <p:nvSpPr>
                <p:cNvPr id="344" name="Google Shape;344;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45" name="Google Shape;345;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46" name="Google Shape;346;p2"/>
                <p:cNvSpPr/>
                <p:nvPr/>
              </p:nvSpPr>
              <p:spPr>
                <a:xfrm>
                  <a:off x="1660707" y="2967171"/>
                  <a:ext cx="914400" cy="56186"/>
                </a:xfrm>
                <a:prstGeom prst="rect">
                  <a:avLst/>
                </a:prstGeom>
                <a:solidFill>
                  <a:srgbClr val="1E4E79">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47" name="Google Shape;347;p2"/>
              <p:cNvGrpSpPr/>
              <p:nvPr/>
            </p:nvGrpSpPr>
            <p:grpSpPr>
              <a:xfrm>
                <a:off x="3825826" y="6043372"/>
                <a:ext cx="731520" cy="27432"/>
                <a:chOff x="1388619" y="2967171"/>
                <a:chExt cx="1461659" cy="56186"/>
              </a:xfrm>
            </p:grpSpPr>
            <p:sp>
              <p:nvSpPr>
                <p:cNvPr id="348" name="Google Shape;348;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49" name="Google Shape;349;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50" name="Google Shape;350;p2"/>
                <p:cNvSpPr/>
                <p:nvPr/>
              </p:nvSpPr>
              <p:spPr>
                <a:xfrm>
                  <a:off x="1660707" y="2967171"/>
                  <a:ext cx="914400" cy="56186"/>
                </a:xfrm>
                <a:prstGeom prst="rect">
                  <a:avLst/>
                </a:prstGeom>
                <a:solidFill>
                  <a:srgbClr val="E24240">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51" name="Google Shape;351;p2"/>
              <p:cNvGrpSpPr/>
              <p:nvPr/>
            </p:nvGrpSpPr>
            <p:grpSpPr>
              <a:xfrm>
                <a:off x="3825826" y="6240872"/>
                <a:ext cx="731520" cy="27432"/>
                <a:chOff x="1388619" y="2967171"/>
                <a:chExt cx="1461659" cy="56186"/>
              </a:xfrm>
            </p:grpSpPr>
            <p:sp>
              <p:nvSpPr>
                <p:cNvPr id="352" name="Google Shape;352;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53" name="Google Shape;353;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54" name="Google Shape;354;p2"/>
                <p:cNvSpPr/>
                <p:nvPr/>
              </p:nvSpPr>
              <p:spPr>
                <a:xfrm>
                  <a:off x="1660707" y="2967171"/>
                  <a:ext cx="914400" cy="56186"/>
                </a:xfrm>
                <a:prstGeom prst="rect">
                  <a:avLst/>
                </a:prstGeom>
                <a:solidFill>
                  <a:srgbClr val="E24240">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55" name="Google Shape;355;p2"/>
              <p:cNvGrpSpPr/>
              <p:nvPr/>
            </p:nvGrpSpPr>
            <p:grpSpPr>
              <a:xfrm>
                <a:off x="3825826" y="5944622"/>
                <a:ext cx="731520" cy="27432"/>
                <a:chOff x="1388619" y="2967171"/>
                <a:chExt cx="1461659" cy="56186"/>
              </a:xfrm>
            </p:grpSpPr>
            <p:sp>
              <p:nvSpPr>
                <p:cNvPr id="356" name="Google Shape;356;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57" name="Google Shape;357;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58" name="Google Shape;358;p2"/>
                <p:cNvSpPr/>
                <p:nvPr/>
              </p:nvSpPr>
              <p:spPr>
                <a:xfrm>
                  <a:off x="1660707" y="2967171"/>
                  <a:ext cx="914400" cy="56186"/>
                </a:xfrm>
                <a:prstGeom prst="rect">
                  <a:avLst/>
                </a:prstGeom>
                <a:solidFill>
                  <a:srgbClr val="002060">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59" name="Google Shape;359;p2"/>
              <p:cNvGrpSpPr/>
              <p:nvPr/>
            </p:nvGrpSpPr>
            <p:grpSpPr>
              <a:xfrm>
                <a:off x="3825826" y="5598997"/>
                <a:ext cx="731520" cy="27432"/>
                <a:chOff x="1388619" y="2967171"/>
                <a:chExt cx="1461659" cy="56186"/>
              </a:xfrm>
            </p:grpSpPr>
            <p:sp>
              <p:nvSpPr>
                <p:cNvPr id="360" name="Google Shape;360;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61" name="Google Shape;361;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62" name="Google Shape;362;p2"/>
                <p:cNvSpPr/>
                <p:nvPr/>
              </p:nvSpPr>
              <p:spPr>
                <a:xfrm>
                  <a:off x="1660707" y="2967171"/>
                  <a:ext cx="914400" cy="56186"/>
                </a:xfrm>
                <a:prstGeom prst="rect">
                  <a:avLst/>
                </a:prstGeom>
                <a:solidFill>
                  <a:schemeClr val="accent6">
                    <a:alpha val="53333"/>
                  </a:scheme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63" name="Google Shape;363;p2"/>
              <p:cNvGrpSpPr/>
              <p:nvPr/>
            </p:nvGrpSpPr>
            <p:grpSpPr>
              <a:xfrm>
                <a:off x="3825826" y="5747122"/>
                <a:ext cx="731520" cy="27432"/>
                <a:chOff x="1388619" y="2967171"/>
                <a:chExt cx="1461659" cy="56186"/>
              </a:xfrm>
            </p:grpSpPr>
            <p:sp>
              <p:nvSpPr>
                <p:cNvPr id="364" name="Google Shape;364;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65" name="Google Shape;365;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66" name="Google Shape;366;p2"/>
                <p:cNvSpPr/>
                <p:nvPr/>
              </p:nvSpPr>
              <p:spPr>
                <a:xfrm>
                  <a:off x="1660707" y="2967171"/>
                  <a:ext cx="914400" cy="56186"/>
                </a:xfrm>
                <a:prstGeom prst="rect">
                  <a:avLst/>
                </a:prstGeom>
                <a:solidFill>
                  <a:srgbClr val="BF9000">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67" name="Google Shape;367;p2"/>
              <p:cNvGrpSpPr/>
              <p:nvPr/>
            </p:nvGrpSpPr>
            <p:grpSpPr>
              <a:xfrm>
                <a:off x="3825826" y="5845872"/>
                <a:ext cx="731520" cy="27432"/>
                <a:chOff x="1388619" y="2967171"/>
                <a:chExt cx="1461659" cy="56186"/>
              </a:xfrm>
            </p:grpSpPr>
            <p:sp>
              <p:nvSpPr>
                <p:cNvPr id="368" name="Google Shape;368;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69" name="Google Shape;369;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70" name="Google Shape;370;p2"/>
                <p:cNvSpPr/>
                <p:nvPr/>
              </p:nvSpPr>
              <p:spPr>
                <a:xfrm>
                  <a:off x="1660707" y="2967171"/>
                  <a:ext cx="914400" cy="56186"/>
                </a:xfrm>
                <a:prstGeom prst="rect">
                  <a:avLst/>
                </a:prstGeom>
                <a:solidFill>
                  <a:srgbClr val="7030A0">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71" name="Google Shape;371;p2"/>
              <p:cNvGrpSpPr/>
              <p:nvPr/>
            </p:nvGrpSpPr>
            <p:grpSpPr>
              <a:xfrm>
                <a:off x="3825826" y="6092747"/>
                <a:ext cx="731520" cy="27432"/>
                <a:chOff x="1388619" y="2967171"/>
                <a:chExt cx="1461659" cy="56186"/>
              </a:xfrm>
            </p:grpSpPr>
            <p:sp>
              <p:nvSpPr>
                <p:cNvPr id="372" name="Google Shape;372;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73" name="Google Shape;373;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74" name="Google Shape;374;p2"/>
                <p:cNvSpPr/>
                <p:nvPr/>
              </p:nvSpPr>
              <p:spPr>
                <a:xfrm>
                  <a:off x="1660707" y="2967171"/>
                  <a:ext cx="914400" cy="56186"/>
                </a:xfrm>
                <a:prstGeom prst="rect">
                  <a:avLst/>
                </a:prstGeom>
                <a:solidFill>
                  <a:srgbClr val="C55A11">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75" name="Google Shape;375;p2"/>
              <p:cNvGrpSpPr/>
              <p:nvPr/>
            </p:nvGrpSpPr>
            <p:grpSpPr>
              <a:xfrm>
                <a:off x="3825826" y="5993997"/>
                <a:ext cx="731520" cy="27432"/>
                <a:chOff x="1388619" y="2967171"/>
                <a:chExt cx="1461659" cy="56186"/>
              </a:xfrm>
            </p:grpSpPr>
            <p:sp>
              <p:nvSpPr>
                <p:cNvPr id="376" name="Google Shape;376;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77" name="Google Shape;377;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78" name="Google Shape;378;p2"/>
                <p:cNvSpPr/>
                <p:nvPr/>
              </p:nvSpPr>
              <p:spPr>
                <a:xfrm>
                  <a:off x="1660707" y="2967171"/>
                  <a:ext cx="914400" cy="56186"/>
                </a:xfrm>
                <a:prstGeom prst="rect">
                  <a:avLst/>
                </a:prstGeom>
                <a:solidFill>
                  <a:srgbClr val="00B0F0">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79" name="Google Shape;379;p2"/>
              <p:cNvGrpSpPr/>
              <p:nvPr/>
            </p:nvGrpSpPr>
            <p:grpSpPr>
              <a:xfrm>
                <a:off x="3825826" y="6191497"/>
                <a:ext cx="731520" cy="27432"/>
                <a:chOff x="1388619" y="2967171"/>
                <a:chExt cx="1461659" cy="56186"/>
              </a:xfrm>
            </p:grpSpPr>
            <p:sp>
              <p:nvSpPr>
                <p:cNvPr id="380" name="Google Shape;380;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81" name="Google Shape;381;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82" name="Google Shape;382;p2"/>
                <p:cNvSpPr/>
                <p:nvPr/>
              </p:nvSpPr>
              <p:spPr>
                <a:xfrm>
                  <a:off x="1660707" y="2967171"/>
                  <a:ext cx="914400" cy="56186"/>
                </a:xfrm>
                <a:prstGeom prst="rect">
                  <a:avLst/>
                </a:prstGeom>
                <a:solidFill>
                  <a:srgbClr val="4FAE1C">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83" name="Google Shape;383;p2"/>
              <p:cNvGrpSpPr/>
              <p:nvPr/>
            </p:nvGrpSpPr>
            <p:grpSpPr>
              <a:xfrm>
                <a:off x="3825826" y="6290252"/>
                <a:ext cx="731520" cy="27432"/>
                <a:chOff x="1388619" y="2967171"/>
                <a:chExt cx="1461659" cy="56186"/>
              </a:xfrm>
            </p:grpSpPr>
            <p:sp>
              <p:nvSpPr>
                <p:cNvPr id="384" name="Google Shape;384;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85" name="Google Shape;385;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86" name="Google Shape;386;p2"/>
                <p:cNvSpPr/>
                <p:nvPr/>
              </p:nvSpPr>
              <p:spPr>
                <a:xfrm>
                  <a:off x="1660707" y="2967171"/>
                  <a:ext cx="914400" cy="56186"/>
                </a:xfrm>
                <a:prstGeom prst="rect">
                  <a:avLst/>
                </a:prstGeom>
                <a:solidFill>
                  <a:schemeClr val="accent6">
                    <a:alpha val="53333"/>
                  </a:scheme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grpSp>
            <p:nvGrpSpPr>
              <p:cNvPr id="387" name="Google Shape;387;p2"/>
              <p:cNvGrpSpPr/>
              <p:nvPr/>
            </p:nvGrpSpPr>
            <p:grpSpPr>
              <a:xfrm>
                <a:off x="3825826" y="5697747"/>
                <a:ext cx="731520" cy="27432"/>
                <a:chOff x="1388619" y="2967171"/>
                <a:chExt cx="1461659" cy="56186"/>
              </a:xfrm>
            </p:grpSpPr>
            <p:sp>
              <p:nvSpPr>
                <p:cNvPr id="388" name="Google Shape;388;p2"/>
                <p:cNvSpPr/>
                <p:nvPr/>
              </p:nvSpPr>
              <p:spPr>
                <a:xfrm>
                  <a:off x="2575958"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89" name="Google Shape;389;p2"/>
                <p:cNvSpPr/>
                <p:nvPr/>
              </p:nvSpPr>
              <p:spPr>
                <a:xfrm>
                  <a:off x="1388619" y="2967171"/>
                  <a:ext cx="274320" cy="56186"/>
                </a:xfrm>
                <a:prstGeom prst="rect">
                  <a:avLst/>
                </a:prstGeom>
                <a:solidFill>
                  <a:schemeClr val="lt1"/>
                </a:solidFill>
                <a:ln w="9525" cap="flat" cmpd="sng">
                  <a:solidFill>
                    <a:schemeClr val="dk1"/>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390" name="Google Shape;390;p2"/>
                <p:cNvSpPr/>
                <p:nvPr/>
              </p:nvSpPr>
              <p:spPr>
                <a:xfrm>
                  <a:off x="1660707" y="2967171"/>
                  <a:ext cx="914400" cy="56186"/>
                </a:xfrm>
                <a:prstGeom prst="rect">
                  <a:avLst/>
                </a:prstGeom>
                <a:solidFill>
                  <a:srgbClr val="757070">
                    <a:alpha val="53333"/>
                  </a:srgbClr>
                </a:solidFill>
                <a:ln w="9525" cap="flat" cmpd="sng">
                  <a:solidFill>
                    <a:srgbClr val="FF0000"/>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grpSp>
          <p:cxnSp>
            <p:nvCxnSpPr>
              <p:cNvPr id="391" name="Google Shape;391;p2"/>
              <p:cNvCxnSpPr/>
              <p:nvPr/>
            </p:nvCxnSpPr>
            <p:spPr>
              <a:xfrm rot="10800000">
                <a:off x="4191586" y="5311128"/>
                <a:ext cx="0" cy="182880"/>
              </a:xfrm>
              <a:prstGeom prst="straightConnector1">
                <a:avLst/>
              </a:prstGeom>
              <a:noFill/>
              <a:ln w="25400" cap="flat" cmpd="sng">
                <a:solidFill>
                  <a:schemeClr val="dk1"/>
                </a:solidFill>
                <a:prstDash val="dot"/>
                <a:miter lim="800000"/>
                <a:headEnd type="none" w="sm" len="sm"/>
                <a:tailEnd type="none" w="sm" len="sm"/>
              </a:ln>
            </p:spPr>
          </p:cxnSp>
          <p:cxnSp>
            <p:nvCxnSpPr>
              <p:cNvPr id="392" name="Google Shape;392;p2"/>
              <p:cNvCxnSpPr/>
              <p:nvPr/>
            </p:nvCxnSpPr>
            <p:spPr>
              <a:xfrm rot="10800000">
                <a:off x="4191586" y="6361081"/>
                <a:ext cx="0" cy="182880"/>
              </a:xfrm>
              <a:prstGeom prst="straightConnector1">
                <a:avLst/>
              </a:prstGeom>
              <a:noFill/>
              <a:ln w="25400" cap="flat" cmpd="sng">
                <a:solidFill>
                  <a:schemeClr val="dk1"/>
                </a:solidFill>
                <a:prstDash val="dot"/>
                <a:miter lim="800000"/>
                <a:headEnd type="none" w="sm" len="sm"/>
                <a:tailEnd type="none" w="sm" len="sm"/>
              </a:ln>
            </p:spPr>
          </p:cxnSp>
        </p:grpSp>
        <p:cxnSp>
          <p:nvCxnSpPr>
            <p:cNvPr id="393" name="Google Shape;393;p2"/>
            <p:cNvCxnSpPr/>
            <p:nvPr/>
          </p:nvCxnSpPr>
          <p:spPr>
            <a:xfrm>
              <a:off x="2629683" y="5949441"/>
              <a:ext cx="457200" cy="0"/>
            </a:xfrm>
            <a:prstGeom prst="straightConnector1">
              <a:avLst/>
            </a:prstGeom>
            <a:noFill/>
            <a:ln w="25400" cap="flat" cmpd="sng">
              <a:solidFill>
                <a:schemeClr val="dk1"/>
              </a:solidFill>
              <a:prstDash val="solid"/>
              <a:miter lim="800000"/>
              <a:headEnd type="none" w="sm" len="sm"/>
              <a:tailEnd type="stealth" w="med" len="med"/>
            </a:ln>
          </p:spPr>
        </p:cxnSp>
        <p:sp>
          <p:nvSpPr>
            <p:cNvPr id="394" name="Google Shape;394;p2"/>
            <p:cNvSpPr txBox="1"/>
            <p:nvPr/>
          </p:nvSpPr>
          <p:spPr>
            <a:xfrm>
              <a:off x="2455490" y="6067568"/>
              <a:ext cx="878722" cy="553998"/>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Purification of barcode DNAs</a:t>
              </a:r>
              <a:endParaRPr sz="1400" b="0" i="0" u="none" strike="noStrike" cap="none">
                <a:solidFill>
                  <a:srgbClr val="000000"/>
                </a:solidFill>
                <a:latin typeface="Arial"/>
                <a:ea typeface="Arial"/>
                <a:cs typeface="Arial"/>
                <a:sym typeface="Arial"/>
              </a:endParaRPr>
            </a:p>
          </p:txBody>
        </p:sp>
        <p:sp>
          <p:nvSpPr>
            <p:cNvPr id="395" name="Google Shape;395;p2"/>
            <p:cNvSpPr txBox="1"/>
            <p:nvPr/>
          </p:nvSpPr>
          <p:spPr>
            <a:xfrm>
              <a:off x="3164175" y="6683398"/>
              <a:ext cx="1591605"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Amplified barcode DNAs</a:t>
              </a:r>
              <a:endParaRPr sz="1400" b="0" i="0" u="none" strike="noStrike" cap="none">
                <a:solidFill>
                  <a:srgbClr val="000000"/>
                </a:solidFill>
                <a:latin typeface="Arial"/>
                <a:ea typeface="Arial"/>
                <a:cs typeface="Arial"/>
                <a:sym typeface="Arial"/>
              </a:endParaRPr>
            </a:p>
          </p:txBody>
        </p:sp>
        <p:pic>
          <p:nvPicPr>
            <p:cNvPr id="396" name="Google Shape;396;p2"/>
            <p:cNvPicPr preferRelativeResize="0"/>
            <p:nvPr/>
          </p:nvPicPr>
          <p:blipFill rotWithShape="1">
            <a:blip r:embed="rId5">
              <a:alphaModFix/>
            </a:blip>
            <a:srcRect l="73541" t="70813" r="1125" b="6604"/>
            <a:stretch/>
          </p:blipFill>
          <p:spPr>
            <a:xfrm>
              <a:off x="5282780" y="5327708"/>
              <a:ext cx="1227719" cy="1313870"/>
            </a:xfrm>
            <a:prstGeom prst="rect">
              <a:avLst/>
            </a:prstGeom>
            <a:noFill/>
            <a:ln>
              <a:noFill/>
            </a:ln>
          </p:spPr>
        </p:pic>
        <p:sp>
          <p:nvSpPr>
            <p:cNvPr id="397" name="Google Shape;397;p2"/>
            <p:cNvSpPr txBox="1"/>
            <p:nvPr/>
          </p:nvSpPr>
          <p:spPr>
            <a:xfrm>
              <a:off x="5056513" y="6683397"/>
              <a:ext cx="1714616"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Barcode sequences of the reads</a:t>
              </a:r>
              <a:endParaRPr sz="1400" b="0" i="0" u="none" strike="noStrike" cap="none">
                <a:solidFill>
                  <a:srgbClr val="000000"/>
                </a:solidFill>
                <a:latin typeface="Arial"/>
                <a:ea typeface="Arial"/>
                <a:cs typeface="Arial"/>
                <a:sym typeface="Arial"/>
              </a:endParaRPr>
            </a:p>
          </p:txBody>
        </p:sp>
        <p:cxnSp>
          <p:nvCxnSpPr>
            <p:cNvPr id="398" name="Google Shape;398;p2"/>
            <p:cNvCxnSpPr/>
            <p:nvPr/>
          </p:nvCxnSpPr>
          <p:spPr>
            <a:xfrm>
              <a:off x="4656730" y="5949441"/>
              <a:ext cx="457200" cy="0"/>
            </a:xfrm>
            <a:prstGeom prst="straightConnector1">
              <a:avLst/>
            </a:prstGeom>
            <a:noFill/>
            <a:ln w="25400" cap="flat" cmpd="sng">
              <a:solidFill>
                <a:schemeClr val="dk1"/>
              </a:solidFill>
              <a:prstDash val="solid"/>
              <a:miter lim="800000"/>
              <a:headEnd type="none" w="sm" len="sm"/>
              <a:tailEnd type="stealth" w="med" len="med"/>
            </a:ln>
          </p:spPr>
        </p:cxnSp>
        <p:sp>
          <p:nvSpPr>
            <p:cNvPr id="399" name="Google Shape;399;p2"/>
            <p:cNvSpPr txBox="1"/>
            <p:nvPr/>
          </p:nvSpPr>
          <p:spPr>
            <a:xfrm>
              <a:off x="4482537" y="6067568"/>
              <a:ext cx="829399"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Sequencing</a:t>
              </a:r>
              <a:endParaRPr sz="1400" b="0" i="0" u="none" strike="noStrike" cap="none">
                <a:solidFill>
                  <a:srgbClr val="000000"/>
                </a:solidFill>
                <a:latin typeface="Arial"/>
                <a:ea typeface="Arial"/>
                <a:cs typeface="Arial"/>
                <a:sym typeface="Arial"/>
              </a:endParaRPr>
            </a:p>
          </p:txBody>
        </p:sp>
        <p:sp>
          <p:nvSpPr>
            <p:cNvPr id="400" name="Google Shape;400;p2"/>
            <p:cNvSpPr txBox="1"/>
            <p:nvPr/>
          </p:nvSpPr>
          <p:spPr>
            <a:xfrm>
              <a:off x="3476516" y="3718846"/>
              <a:ext cx="1002259" cy="40011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Harvest after ~7 doublings</a:t>
              </a:r>
              <a:endParaRPr sz="1400" b="0" i="0" u="none" strike="noStrike" cap="none">
                <a:solidFill>
                  <a:srgbClr val="000000"/>
                </a:solidFill>
                <a:latin typeface="Arial"/>
                <a:ea typeface="Arial"/>
                <a:cs typeface="Arial"/>
                <a:sym typeface="Arial"/>
              </a:endParaRPr>
            </a:p>
          </p:txBody>
        </p:sp>
        <p:sp>
          <p:nvSpPr>
            <p:cNvPr id="401" name="Google Shape;401;p2"/>
            <p:cNvSpPr txBox="1"/>
            <p:nvPr/>
          </p:nvSpPr>
          <p:spPr>
            <a:xfrm>
              <a:off x="4702928" y="3595735"/>
              <a:ext cx="558800"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LL-Hy</a:t>
              </a:r>
              <a:endParaRPr sz="1000" b="1" i="0" u="none" strike="noStrike" cap="none">
                <a:solidFill>
                  <a:schemeClr val="dk1"/>
                </a:solidFill>
                <a:latin typeface="Times New Roman"/>
                <a:ea typeface="Times New Roman"/>
                <a:cs typeface="Times New Roman"/>
                <a:sym typeface="Times New Roman"/>
              </a:endParaRPr>
            </a:p>
          </p:txBody>
        </p:sp>
        <p:sp>
          <p:nvSpPr>
            <p:cNvPr id="402" name="Google Shape;402;p2"/>
            <p:cNvSpPr txBox="1"/>
            <p:nvPr/>
          </p:nvSpPr>
          <p:spPr>
            <a:xfrm>
              <a:off x="5161909" y="3595735"/>
              <a:ext cx="558800"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LL-Ox</a:t>
              </a:r>
              <a:endParaRPr sz="1400" b="0" i="0" u="none" strike="noStrike" cap="none">
                <a:solidFill>
                  <a:srgbClr val="000000"/>
                </a:solidFill>
                <a:latin typeface="Arial"/>
                <a:ea typeface="Arial"/>
                <a:cs typeface="Arial"/>
                <a:sym typeface="Arial"/>
              </a:endParaRPr>
            </a:p>
          </p:txBody>
        </p:sp>
        <p:sp>
          <p:nvSpPr>
            <p:cNvPr id="403" name="Google Shape;403;p2"/>
            <p:cNvSpPr txBox="1"/>
            <p:nvPr/>
          </p:nvSpPr>
          <p:spPr>
            <a:xfrm>
              <a:off x="5712254" y="3595735"/>
              <a:ext cx="592955"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HL-Hy</a:t>
              </a:r>
              <a:endParaRPr sz="1000" b="1" i="0" u="none" strike="noStrike" cap="none">
                <a:solidFill>
                  <a:schemeClr val="dk1"/>
                </a:solidFill>
                <a:latin typeface="Times New Roman"/>
                <a:ea typeface="Times New Roman"/>
                <a:cs typeface="Times New Roman"/>
                <a:sym typeface="Times New Roman"/>
              </a:endParaRPr>
            </a:p>
          </p:txBody>
        </p:sp>
        <p:sp>
          <p:nvSpPr>
            <p:cNvPr id="404" name="Google Shape;404;p2"/>
            <p:cNvSpPr txBox="1"/>
            <p:nvPr/>
          </p:nvSpPr>
          <p:spPr>
            <a:xfrm>
              <a:off x="6170467" y="3595735"/>
              <a:ext cx="579209"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HL-Ox</a:t>
              </a:r>
              <a:endParaRPr sz="1400" b="0" i="0" u="none" strike="noStrike" cap="none">
                <a:solidFill>
                  <a:srgbClr val="000000"/>
                </a:solidFill>
                <a:latin typeface="Arial"/>
                <a:ea typeface="Arial"/>
                <a:cs typeface="Arial"/>
                <a:sym typeface="Arial"/>
              </a:endParaRPr>
            </a:p>
          </p:txBody>
        </p:sp>
        <p:sp>
          <p:nvSpPr>
            <p:cNvPr id="405" name="Google Shape;405;p2"/>
            <p:cNvSpPr txBox="1"/>
            <p:nvPr/>
          </p:nvSpPr>
          <p:spPr>
            <a:xfrm>
              <a:off x="1307015" y="4605726"/>
              <a:ext cx="605660"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HL-Hy</a:t>
              </a:r>
              <a:endParaRPr sz="1000" b="1" i="0" u="none" strike="noStrike" cap="none">
                <a:solidFill>
                  <a:schemeClr val="dk1"/>
                </a:solidFill>
                <a:latin typeface="Times New Roman"/>
                <a:ea typeface="Times New Roman"/>
                <a:cs typeface="Times New Roman"/>
                <a:sym typeface="Times New Roman"/>
              </a:endParaRPr>
            </a:p>
          </p:txBody>
        </p:sp>
        <p:sp>
          <p:nvSpPr>
            <p:cNvPr id="406" name="Google Shape;406;p2"/>
            <p:cNvSpPr txBox="1"/>
            <p:nvPr/>
          </p:nvSpPr>
          <p:spPr>
            <a:xfrm>
              <a:off x="2053547" y="4605726"/>
              <a:ext cx="599449"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HL-Ox</a:t>
              </a:r>
              <a:endParaRPr sz="1400" b="0" i="0" u="none" strike="noStrike" cap="none">
                <a:solidFill>
                  <a:srgbClr val="000000"/>
                </a:solidFill>
                <a:latin typeface="Arial"/>
                <a:ea typeface="Arial"/>
                <a:cs typeface="Arial"/>
                <a:sym typeface="Arial"/>
              </a:endParaRPr>
            </a:p>
          </p:txBody>
        </p:sp>
        <p:sp>
          <p:nvSpPr>
            <p:cNvPr id="407" name="Google Shape;407;p2"/>
            <p:cNvSpPr/>
            <p:nvPr/>
          </p:nvSpPr>
          <p:spPr>
            <a:xfrm>
              <a:off x="1387992" y="3685479"/>
              <a:ext cx="455337" cy="166088"/>
            </a:xfrm>
            <a:prstGeom prst="roundRect">
              <a:avLst>
                <a:gd name="adj" fmla="val 32765"/>
              </a:avLst>
            </a:prstGeom>
            <a:noFill/>
            <a:ln w="9525"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408" name="Google Shape;408;p2"/>
            <p:cNvSpPr/>
            <p:nvPr/>
          </p:nvSpPr>
          <p:spPr>
            <a:xfrm>
              <a:off x="2122671" y="3685479"/>
              <a:ext cx="455337" cy="166088"/>
            </a:xfrm>
            <a:prstGeom prst="roundRect">
              <a:avLst>
                <a:gd name="adj" fmla="val 32765"/>
              </a:avLst>
            </a:prstGeom>
            <a:noFill/>
            <a:ln w="9525"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409" name="Google Shape;409;p2"/>
            <p:cNvSpPr/>
            <p:nvPr/>
          </p:nvSpPr>
          <p:spPr>
            <a:xfrm>
              <a:off x="1387992" y="4650185"/>
              <a:ext cx="455337" cy="166088"/>
            </a:xfrm>
            <a:prstGeom prst="roundRect">
              <a:avLst>
                <a:gd name="adj" fmla="val 32765"/>
              </a:avLst>
            </a:prstGeom>
            <a:noFill/>
            <a:ln w="9525"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410" name="Google Shape;410;p2"/>
            <p:cNvSpPr/>
            <p:nvPr/>
          </p:nvSpPr>
          <p:spPr>
            <a:xfrm>
              <a:off x="2122671" y="4650185"/>
              <a:ext cx="455337" cy="166088"/>
            </a:xfrm>
            <a:prstGeom prst="roundRect">
              <a:avLst>
                <a:gd name="adj" fmla="val 32765"/>
              </a:avLst>
            </a:prstGeom>
            <a:noFill/>
            <a:ln w="9525" cap="flat" cmpd="sng">
              <a:solidFill>
                <a:srgbClr val="7F7F7F"/>
              </a:solidFill>
              <a:prstDash val="solid"/>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Times New Roman"/>
                <a:ea typeface="Times New Roman"/>
                <a:cs typeface="Times New Roman"/>
                <a:sym typeface="Times New Roman"/>
              </a:endParaRPr>
            </a:p>
          </p:txBody>
        </p:sp>
        <p:sp>
          <p:nvSpPr>
            <p:cNvPr id="411" name="Google Shape;411;p2"/>
            <p:cNvSpPr txBox="1"/>
            <p:nvPr/>
          </p:nvSpPr>
          <p:spPr>
            <a:xfrm>
              <a:off x="2777069" y="5041675"/>
              <a:ext cx="2449988" cy="246221"/>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Amplification of barcode DNAs by PCR</a:t>
              </a:r>
              <a:endParaRPr sz="1400" b="0" i="0" u="none" strike="noStrike" cap="none">
                <a:solidFill>
                  <a:srgbClr val="000000"/>
                </a:solidFill>
                <a:latin typeface="Arial"/>
                <a:ea typeface="Arial"/>
                <a:cs typeface="Arial"/>
                <a:sym typeface="Arial"/>
              </a:endParaRPr>
            </a:p>
          </p:txBody>
        </p:sp>
        <p:sp>
          <p:nvSpPr>
            <p:cNvPr id="412" name="Google Shape;412;p2"/>
            <p:cNvSpPr/>
            <p:nvPr/>
          </p:nvSpPr>
          <p:spPr>
            <a:xfrm>
              <a:off x="2788857" y="3062980"/>
              <a:ext cx="521208" cy="518657"/>
            </a:xfrm>
            <a:prstGeom prst="roundRect">
              <a:avLst>
                <a:gd name="adj" fmla="val 10138"/>
              </a:avLst>
            </a:prstGeom>
            <a:gradFill>
              <a:gsLst>
                <a:gs pos="0">
                  <a:srgbClr val="FBE6D6"/>
                </a:gs>
                <a:gs pos="85000">
                  <a:srgbClr val="FBE6D6"/>
                </a:gs>
                <a:gs pos="92000">
                  <a:srgbClr val="FBE6D6">
                    <a:alpha val="49411"/>
                  </a:srgbClr>
                </a:gs>
                <a:gs pos="100000">
                  <a:srgbClr val="FFFFFF">
                    <a:alpha val="20000"/>
                  </a:srgbClr>
                </a:gs>
              </a:gsLst>
              <a:path path="circle">
                <a:fillToRect l="50000" t="50000" r="50000" b="50000"/>
              </a:path>
              <a:tileRect/>
            </a:gradFill>
            <a:ln w="12700" cap="flat" cmpd="sng">
              <a:solidFill>
                <a:srgbClr val="D0CECE"/>
              </a:solidFill>
              <a:prstDash val="dash"/>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Low Light</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LL)</a:t>
              </a:r>
              <a:endParaRPr sz="1400" b="0" i="0" u="none" strike="noStrike" cap="none">
                <a:solidFill>
                  <a:srgbClr val="000000"/>
                </a:solidFill>
                <a:latin typeface="Arial"/>
                <a:ea typeface="Arial"/>
                <a:cs typeface="Arial"/>
                <a:sym typeface="Arial"/>
              </a:endParaRPr>
            </a:p>
          </p:txBody>
        </p:sp>
        <p:sp>
          <p:nvSpPr>
            <p:cNvPr id="413" name="Google Shape;413;p2"/>
            <p:cNvSpPr/>
            <p:nvPr/>
          </p:nvSpPr>
          <p:spPr>
            <a:xfrm>
              <a:off x="2793253" y="4054829"/>
              <a:ext cx="521208" cy="518657"/>
            </a:xfrm>
            <a:prstGeom prst="roundRect">
              <a:avLst>
                <a:gd name="adj" fmla="val 10138"/>
              </a:avLst>
            </a:prstGeom>
            <a:gradFill>
              <a:gsLst>
                <a:gs pos="0">
                  <a:srgbClr val="FF0000"/>
                </a:gs>
                <a:gs pos="74000">
                  <a:srgbClr val="FF0000">
                    <a:alpha val="85098"/>
                  </a:srgbClr>
                </a:gs>
                <a:gs pos="89000">
                  <a:srgbClr val="FF0000">
                    <a:alpha val="60000"/>
                  </a:srgbClr>
                </a:gs>
                <a:gs pos="94500">
                  <a:srgbClr val="FF8080">
                    <a:alpha val="40000"/>
                  </a:srgbClr>
                </a:gs>
                <a:gs pos="100000">
                  <a:srgbClr val="FFFFFF">
                    <a:alpha val="20000"/>
                  </a:srgbClr>
                </a:gs>
              </a:gsLst>
              <a:path path="circle">
                <a:fillToRect l="50000" t="50000" r="50000" b="50000"/>
              </a:path>
              <a:tileRect/>
            </a:gradFill>
            <a:ln w="12700" cap="flat" cmpd="sng">
              <a:solidFill>
                <a:srgbClr val="D0CECE"/>
              </a:solidFill>
              <a:prstDash val="dash"/>
              <a:miter lim="800000"/>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High Light</a:t>
              </a:r>
              <a:endParaRPr sz="1400" b="0" i="0" u="none" strike="noStrike" cap="none">
                <a:solidFill>
                  <a:srgbClr val="000000"/>
                </a:solidFill>
                <a:latin typeface="Arial"/>
                <a:ea typeface="Arial"/>
                <a:cs typeface="Arial"/>
                <a:sym typeface="Arial"/>
              </a:endParaRPr>
            </a:p>
            <a:p>
              <a:pPr marL="0" marR="0" lvl="0" indent="0" algn="ctr" rtl="0">
                <a:lnSpc>
                  <a:spcPct val="100000"/>
                </a:lnSpc>
                <a:spcBef>
                  <a:spcPts val="0"/>
                </a:spcBef>
                <a:spcAft>
                  <a:spcPts val="0"/>
                </a:spcAft>
                <a:buClr>
                  <a:srgbClr val="000000"/>
                </a:buClr>
                <a:buSzPts val="1000"/>
                <a:buFont typeface="Arial"/>
                <a:buNone/>
              </a:pPr>
              <a:r>
                <a:rPr lang="en-US" sz="1000" b="1" i="0" u="none" strike="noStrike" cap="none">
                  <a:solidFill>
                    <a:schemeClr val="dk1"/>
                  </a:solidFill>
                  <a:latin typeface="Times New Roman"/>
                  <a:ea typeface="Times New Roman"/>
                  <a:cs typeface="Times New Roman"/>
                  <a:sym typeface="Times New Roman"/>
                </a:rPr>
                <a:t>(HL)</a:t>
              </a:r>
              <a:endParaRPr sz="1400" b="0" i="0" u="none" strike="noStrike" cap="none">
                <a:solidFill>
                  <a:srgbClr val="000000"/>
                </a:solidFill>
                <a:latin typeface="Arial"/>
                <a:ea typeface="Arial"/>
                <a:cs typeface="Arial"/>
                <a:sym typeface="Arial"/>
              </a:endParaRPr>
            </a:p>
          </p:txBody>
        </p:sp>
      </p:gr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419"/>
        <p:cNvGrpSpPr/>
        <p:nvPr/>
      </p:nvGrpSpPr>
      <p:grpSpPr>
        <a:xfrm>
          <a:off x="0" y="0"/>
          <a:ext cx="0" cy="0"/>
          <a:chOff x="0" y="0"/>
          <a:chExt cx="0" cy="0"/>
        </a:xfrm>
      </p:grpSpPr>
      <p:sp>
        <p:nvSpPr>
          <p:cNvPr id="420" name="Google Shape;420;p3"/>
          <p:cNvSpPr txBox="1"/>
          <p:nvPr/>
        </p:nvSpPr>
        <p:spPr>
          <a:xfrm>
            <a:off x="111347" y="151182"/>
            <a:ext cx="1088760"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Times New Roman"/>
                <a:ea typeface="Times New Roman"/>
                <a:cs typeface="Times New Roman"/>
                <a:sym typeface="Times New Roman"/>
              </a:rPr>
              <a:t>Figure S2</a:t>
            </a:r>
            <a:endParaRPr sz="1400" b="0" i="0" u="none" strike="noStrike" cap="none">
              <a:solidFill>
                <a:srgbClr val="000000"/>
              </a:solidFill>
              <a:latin typeface="Arial"/>
              <a:ea typeface="Arial"/>
              <a:cs typeface="Arial"/>
              <a:sym typeface="Arial"/>
            </a:endParaRPr>
          </a:p>
        </p:txBody>
      </p:sp>
      <p:sp>
        <p:nvSpPr>
          <p:cNvPr id="421" name="Google Shape;421;p3"/>
          <p:cNvSpPr txBox="1"/>
          <p:nvPr/>
        </p:nvSpPr>
        <p:spPr>
          <a:xfrm>
            <a:off x="778545" y="5130134"/>
            <a:ext cx="6121200" cy="1015622"/>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000000"/>
              </a:buClr>
              <a:buSzPts val="1200"/>
              <a:buFont typeface="Arial"/>
              <a:buNone/>
            </a:pPr>
            <a:r>
              <a:rPr lang="en-US" sz="1200" b="1" i="0" u="none" strike="noStrike" cap="none">
                <a:solidFill>
                  <a:schemeClr val="dk1"/>
                </a:solidFill>
                <a:latin typeface="Calibri"/>
                <a:ea typeface="Calibri"/>
                <a:cs typeface="Calibri"/>
                <a:sym typeface="Calibri"/>
              </a:rPr>
              <a:t>Figure S2. Growth of WT and </a:t>
            </a:r>
            <a:r>
              <a:rPr lang="en-US" sz="1200" b="1" i="1" u="none" strike="noStrike" cap="none">
                <a:solidFill>
                  <a:schemeClr val="dk1"/>
                </a:solidFill>
                <a:latin typeface="Calibri"/>
                <a:ea typeface="Calibri"/>
                <a:cs typeface="Calibri"/>
                <a:sym typeface="Calibri"/>
              </a:rPr>
              <a:t>rmt2</a:t>
            </a:r>
            <a:r>
              <a:rPr lang="en-US" sz="1200" b="1" i="0" u="none" strike="noStrike" cap="none">
                <a:solidFill>
                  <a:schemeClr val="dk1"/>
                </a:solidFill>
                <a:latin typeface="Calibri"/>
                <a:ea typeface="Calibri"/>
                <a:cs typeface="Calibri"/>
                <a:sym typeface="Calibri"/>
              </a:rPr>
              <a:t> at various light intensities. </a:t>
            </a:r>
            <a:r>
              <a:rPr lang="en-US" sz="1200" b="0" i="0" u="none" strike="noStrike" cap="none">
                <a:solidFill>
                  <a:schemeClr val="dk1"/>
                </a:solidFill>
                <a:latin typeface="Calibri"/>
                <a:ea typeface="Calibri"/>
                <a:cs typeface="Calibri"/>
                <a:sym typeface="Calibri"/>
              </a:rPr>
              <a:t>WT and the </a:t>
            </a:r>
            <a:r>
              <a:rPr lang="en-US" sz="1200" b="0" i="1" u="none" strike="noStrike" cap="none">
                <a:solidFill>
                  <a:schemeClr val="dk1"/>
                </a:solidFill>
                <a:latin typeface="Calibri"/>
                <a:ea typeface="Calibri"/>
                <a:cs typeface="Calibri"/>
                <a:sym typeface="Calibri"/>
              </a:rPr>
              <a:t>rmt2 </a:t>
            </a:r>
            <a:r>
              <a:rPr lang="en-US" sz="1200" b="0" i="0" u="none" strike="noStrike" cap="none">
                <a:solidFill>
                  <a:schemeClr val="dk1"/>
                </a:solidFill>
                <a:latin typeface="Calibri"/>
                <a:ea typeface="Calibri"/>
                <a:cs typeface="Calibri"/>
                <a:sym typeface="Calibri"/>
              </a:rPr>
              <a:t>mutant (LMJ.RY0402.237082, designated </a:t>
            </a:r>
            <a:r>
              <a:rPr lang="en-US" sz="1200" b="0" i="1" u="none" strike="noStrike" cap="none">
                <a:solidFill>
                  <a:schemeClr val="dk1"/>
                </a:solidFill>
                <a:latin typeface="Calibri"/>
                <a:ea typeface="Calibri"/>
                <a:cs typeface="Calibri"/>
                <a:sym typeface="Calibri"/>
              </a:rPr>
              <a:t>rmt2-1</a:t>
            </a:r>
            <a:r>
              <a:rPr lang="en-US" sz="1200" b="0" i="0" u="none" strike="noStrike" cap="none">
                <a:solidFill>
                  <a:schemeClr val="dk1"/>
                </a:solidFill>
                <a:latin typeface="Calibri"/>
                <a:ea typeface="Calibri"/>
                <a:cs typeface="Calibri"/>
                <a:sym typeface="Calibri"/>
              </a:rPr>
              <a:t>) cells were inoculated at a chl concentration of 1 μg mL</a:t>
            </a:r>
            <a:r>
              <a:rPr lang="en-US" sz="1200" b="0" i="0" u="none" strike="noStrike" cap="none" baseline="30000">
                <a:solidFill>
                  <a:schemeClr val="dk1"/>
                </a:solidFill>
                <a:latin typeface="Calibri"/>
                <a:ea typeface="Calibri"/>
                <a:cs typeface="Calibri"/>
                <a:sym typeface="Calibri"/>
              </a:rPr>
              <a:t>-1</a:t>
            </a:r>
            <a:r>
              <a:rPr lang="en-US" sz="1200" b="0" i="0" u="none" strike="noStrike" cap="none">
                <a:solidFill>
                  <a:schemeClr val="dk1"/>
                </a:solidFill>
                <a:latin typeface="Calibri"/>
                <a:ea typeface="Calibri"/>
                <a:cs typeface="Calibri"/>
                <a:sym typeface="Calibri"/>
              </a:rPr>
              <a:t> and grown for 5 days at 20, 50, 100, 200, and 500 μE. (</a:t>
            </a:r>
            <a:r>
              <a:rPr lang="en-US" sz="1200" b="1" i="0" u="none" strike="noStrike" cap="none">
                <a:solidFill>
                  <a:schemeClr val="dk1"/>
                </a:solidFill>
                <a:latin typeface="Calibri"/>
                <a:ea typeface="Calibri"/>
                <a:cs typeface="Calibri"/>
                <a:sym typeface="Calibri"/>
              </a:rPr>
              <a:t>A</a:t>
            </a:r>
            <a:r>
              <a:rPr lang="en-US" sz="1200" b="0" i="0" u="none" strike="noStrike" cap="none">
                <a:solidFill>
                  <a:schemeClr val="dk1"/>
                </a:solidFill>
                <a:latin typeface="Calibri"/>
                <a:ea typeface="Calibri"/>
                <a:cs typeface="Calibri"/>
                <a:sym typeface="Calibri"/>
              </a:rPr>
              <a:t>) Appearance of cells grown in TAP liquid medium for 5 days under the indicated conditions. (</a:t>
            </a:r>
            <a:r>
              <a:rPr lang="en-US" sz="1200" b="1" i="0" u="none" strike="noStrike" cap="none">
                <a:solidFill>
                  <a:schemeClr val="dk1"/>
                </a:solidFill>
                <a:latin typeface="Calibri"/>
                <a:ea typeface="Calibri"/>
                <a:cs typeface="Calibri"/>
                <a:sym typeface="Calibri"/>
              </a:rPr>
              <a:t>B</a:t>
            </a:r>
            <a:r>
              <a:rPr lang="en-US" sz="1200" b="0" i="0" u="none" strike="noStrike" cap="none">
                <a:solidFill>
                  <a:schemeClr val="dk1"/>
                </a:solidFill>
                <a:latin typeface="Calibri"/>
                <a:ea typeface="Calibri"/>
                <a:cs typeface="Calibri"/>
                <a:sym typeface="Calibri"/>
              </a:rPr>
              <a:t>) Chl concentrations of cultures from (</a:t>
            </a:r>
            <a:r>
              <a:rPr lang="en-US" sz="1200" b="1" i="0" u="none" strike="noStrike" cap="none">
                <a:solidFill>
                  <a:schemeClr val="dk1"/>
                </a:solidFill>
                <a:latin typeface="Calibri"/>
                <a:ea typeface="Calibri"/>
                <a:cs typeface="Calibri"/>
                <a:sym typeface="Calibri"/>
              </a:rPr>
              <a:t>A</a:t>
            </a:r>
            <a:r>
              <a:rPr lang="en-US" sz="1200" b="0" i="0" u="none" strike="noStrike" cap="none">
                <a:solidFill>
                  <a:schemeClr val="dk1"/>
                </a:solidFill>
                <a:latin typeface="Calibri"/>
                <a:ea typeface="Calibri"/>
                <a:cs typeface="Calibri"/>
                <a:sym typeface="Calibri"/>
              </a:rPr>
              <a:t>). Values are averages of two technical replicates. (µE: µ mol photons m</a:t>
            </a:r>
            <a:r>
              <a:rPr lang="en-US" sz="1200" b="0" i="0" u="none" strike="noStrike" cap="none" baseline="30000">
                <a:solidFill>
                  <a:schemeClr val="dk1"/>
                </a:solidFill>
                <a:latin typeface="Calibri"/>
                <a:ea typeface="Calibri"/>
                <a:cs typeface="Calibri"/>
                <a:sym typeface="Calibri"/>
              </a:rPr>
              <a:t>-2</a:t>
            </a:r>
            <a:r>
              <a:rPr lang="en-US" sz="1200" b="0" i="0" u="none" strike="noStrike" cap="none">
                <a:solidFill>
                  <a:schemeClr val="dk1"/>
                </a:solidFill>
                <a:latin typeface="Calibri"/>
                <a:ea typeface="Calibri"/>
                <a:cs typeface="Calibri"/>
                <a:sym typeface="Calibri"/>
              </a:rPr>
              <a:t> s</a:t>
            </a:r>
            <a:r>
              <a:rPr lang="en-US" sz="1200" b="0" i="0" u="none" strike="noStrike" cap="none" baseline="30000">
                <a:solidFill>
                  <a:schemeClr val="dk1"/>
                </a:solidFill>
                <a:latin typeface="Calibri"/>
                <a:ea typeface="Calibri"/>
                <a:cs typeface="Calibri"/>
                <a:sym typeface="Calibri"/>
              </a:rPr>
              <a:t>-1</a:t>
            </a:r>
            <a:r>
              <a:rPr lang="en-US" sz="1200" b="0" i="0" u="none" strike="noStrike" cap="none">
                <a:solidFill>
                  <a:schemeClr val="dk1"/>
                </a:solidFill>
                <a:latin typeface="Calibri"/>
                <a:ea typeface="Calibri"/>
                <a:cs typeface="Calibri"/>
                <a:sym typeface="Calibri"/>
              </a:rPr>
              <a:t>)</a:t>
            </a:r>
            <a:endParaRPr sz="1400" b="0" i="0" u="none" strike="noStrike" cap="none">
              <a:solidFill>
                <a:srgbClr val="000000"/>
              </a:solidFill>
              <a:latin typeface="Arial"/>
              <a:ea typeface="Arial"/>
              <a:cs typeface="Arial"/>
              <a:sym typeface="Arial"/>
            </a:endParaRPr>
          </a:p>
        </p:txBody>
      </p:sp>
      <p:grpSp>
        <p:nvGrpSpPr>
          <p:cNvPr id="422" name="Google Shape;422;p3"/>
          <p:cNvGrpSpPr/>
          <p:nvPr/>
        </p:nvGrpSpPr>
        <p:grpSpPr>
          <a:xfrm>
            <a:off x="935959" y="1340793"/>
            <a:ext cx="2079254" cy="3379766"/>
            <a:chOff x="790848" y="1021997"/>
            <a:chExt cx="1865829" cy="3259989"/>
          </a:xfrm>
        </p:grpSpPr>
        <p:sp>
          <p:nvSpPr>
            <p:cNvPr id="423" name="Google Shape;423;p3"/>
            <p:cNvSpPr txBox="1"/>
            <p:nvPr/>
          </p:nvSpPr>
          <p:spPr>
            <a:xfrm>
              <a:off x="1997573" y="1610421"/>
              <a:ext cx="569919" cy="31616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530"/>
                <a:buFont typeface="Arial"/>
                <a:buNone/>
              </a:pPr>
              <a:r>
                <a:rPr lang="en-US" sz="1530" b="1" i="0" u="none" strike="noStrike" cap="none">
                  <a:solidFill>
                    <a:schemeClr val="dk1"/>
                  </a:solidFill>
                  <a:latin typeface="Calibri"/>
                  <a:ea typeface="Calibri"/>
                  <a:cs typeface="Calibri"/>
                  <a:sym typeface="Calibri"/>
                </a:rPr>
                <a:t>20 μE</a:t>
              </a:r>
              <a:endParaRPr sz="1400" b="0" i="0" u="none" strike="noStrike" cap="none">
                <a:solidFill>
                  <a:srgbClr val="000000"/>
                </a:solidFill>
                <a:latin typeface="Arial"/>
                <a:ea typeface="Arial"/>
                <a:cs typeface="Arial"/>
                <a:sym typeface="Arial"/>
              </a:endParaRPr>
            </a:p>
          </p:txBody>
        </p:sp>
        <p:sp>
          <p:nvSpPr>
            <p:cNvPr id="424" name="Google Shape;424;p3"/>
            <p:cNvSpPr txBox="1"/>
            <p:nvPr/>
          </p:nvSpPr>
          <p:spPr>
            <a:xfrm>
              <a:off x="1997573" y="2313302"/>
              <a:ext cx="569919" cy="31616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530"/>
                <a:buFont typeface="Arial"/>
                <a:buNone/>
              </a:pPr>
              <a:r>
                <a:rPr lang="en-US" sz="1530" b="1" i="0" u="none" strike="noStrike" cap="none">
                  <a:solidFill>
                    <a:schemeClr val="dk1"/>
                  </a:solidFill>
                  <a:latin typeface="Calibri"/>
                  <a:ea typeface="Calibri"/>
                  <a:cs typeface="Calibri"/>
                  <a:sym typeface="Calibri"/>
                </a:rPr>
                <a:t>50 μE</a:t>
              </a:r>
              <a:endParaRPr sz="1400" b="0" i="0" u="none" strike="noStrike" cap="none">
                <a:solidFill>
                  <a:srgbClr val="000000"/>
                </a:solidFill>
                <a:latin typeface="Arial"/>
                <a:ea typeface="Arial"/>
                <a:cs typeface="Arial"/>
                <a:sym typeface="Arial"/>
              </a:endParaRPr>
            </a:p>
          </p:txBody>
        </p:sp>
        <p:sp>
          <p:nvSpPr>
            <p:cNvPr id="425" name="Google Shape;425;p3"/>
            <p:cNvSpPr txBox="1"/>
            <p:nvPr/>
          </p:nvSpPr>
          <p:spPr>
            <a:xfrm>
              <a:off x="1997573" y="2789045"/>
              <a:ext cx="659104" cy="31616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530"/>
                <a:buFont typeface="Arial"/>
                <a:buNone/>
              </a:pPr>
              <a:r>
                <a:rPr lang="en-US" sz="1530" b="1" i="0" u="none" strike="noStrike" cap="none">
                  <a:solidFill>
                    <a:schemeClr val="dk1"/>
                  </a:solidFill>
                  <a:latin typeface="Calibri"/>
                  <a:ea typeface="Calibri"/>
                  <a:cs typeface="Calibri"/>
                  <a:sym typeface="Calibri"/>
                </a:rPr>
                <a:t>100 μE</a:t>
              </a:r>
              <a:endParaRPr sz="1400" b="0" i="0" u="none" strike="noStrike" cap="none">
                <a:solidFill>
                  <a:srgbClr val="000000"/>
                </a:solidFill>
                <a:latin typeface="Arial"/>
                <a:ea typeface="Arial"/>
                <a:cs typeface="Arial"/>
                <a:sym typeface="Arial"/>
              </a:endParaRPr>
            </a:p>
          </p:txBody>
        </p:sp>
        <p:sp>
          <p:nvSpPr>
            <p:cNvPr id="426" name="Google Shape;426;p3"/>
            <p:cNvSpPr txBox="1"/>
            <p:nvPr/>
          </p:nvSpPr>
          <p:spPr>
            <a:xfrm>
              <a:off x="1997573" y="3261876"/>
              <a:ext cx="659104" cy="31616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530"/>
                <a:buFont typeface="Arial"/>
                <a:buNone/>
              </a:pPr>
              <a:r>
                <a:rPr lang="en-US" sz="1530" b="1" i="0" u="none" strike="noStrike" cap="none">
                  <a:solidFill>
                    <a:schemeClr val="dk1"/>
                  </a:solidFill>
                  <a:latin typeface="Calibri"/>
                  <a:ea typeface="Calibri"/>
                  <a:cs typeface="Calibri"/>
                  <a:sym typeface="Calibri"/>
                </a:rPr>
                <a:t>200 μE</a:t>
              </a:r>
              <a:endParaRPr sz="1400" b="0" i="0" u="none" strike="noStrike" cap="none">
                <a:solidFill>
                  <a:srgbClr val="000000"/>
                </a:solidFill>
                <a:latin typeface="Arial"/>
                <a:ea typeface="Arial"/>
                <a:cs typeface="Arial"/>
                <a:sym typeface="Arial"/>
              </a:endParaRPr>
            </a:p>
          </p:txBody>
        </p:sp>
        <p:sp>
          <p:nvSpPr>
            <p:cNvPr id="427" name="Google Shape;427;p3"/>
            <p:cNvSpPr txBox="1"/>
            <p:nvPr/>
          </p:nvSpPr>
          <p:spPr>
            <a:xfrm>
              <a:off x="1997573" y="3738716"/>
              <a:ext cx="659104" cy="54327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530"/>
                <a:buFont typeface="Arial"/>
                <a:buNone/>
              </a:pPr>
              <a:r>
                <a:rPr lang="en-US" sz="1530" b="1" i="0" u="none" strike="noStrike" cap="none">
                  <a:solidFill>
                    <a:schemeClr val="dk1"/>
                  </a:solidFill>
                  <a:latin typeface="Calibri"/>
                  <a:ea typeface="Calibri"/>
                  <a:cs typeface="Calibri"/>
                  <a:sym typeface="Calibri"/>
                </a:rPr>
                <a:t>500 μE</a:t>
              </a:r>
              <a:endParaRPr sz="1400" b="0" i="0" u="none" strike="noStrike" cap="none">
                <a:solidFill>
                  <a:srgbClr val="000000"/>
                </a:solidFill>
                <a:latin typeface="Arial"/>
                <a:ea typeface="Arial"/>
                <a:cs typeface="Arial"/>
                <a:sym typeface="Arial"/>
              </a:endParaRPr>
            </a:p>
            <a:p>
              <a:pPr marL="0" marR="0" lvl="0" indent="0" algn="l" rtl="0">
                <a:lnSpc>
                  <a:spcPct val="100000"/>
                </a:lnSpc>
                <a:spcBef>
                  <a:spcPts val="0"/>
                </a:spcBef>
                <a:spcAft>
                  <a:spcPts val="0"/>
                </a:spcAft>
                <a:buClr>
                  <a:srgbClr val="000000"/>
                </a:buClr>
                <a:buSzPts val="1530"/>
                <a:buFont typeface="Arial"/>
                <a:buNone/>
              </a:pPr>
              <a:endParaRPr sz="1530" b="1" i="0" u="none" strike="noStrike" cap="none">
                <a:solidFill>
                  <a:schemeClr val="dk1"/>
                </a:solidFill>
                <a:latin typeface="Calibri"/>
                <a:ea typeface="Calibri"/>
                <a:cs typeface="Calibri"/>
                <a:sym typeface="Calibri"/>
              </a:endParaRPr>
            </a:p>
          </p:txBody>
        </p:sp>
        <p:grpSp>
          <p:nvGrpSpPr>
            <p:cNvPr id="428" name="Google Shape;428;p3"/>
            <p:cNvGrpSpPr/>
            <p:nvPr/>
          </p:nvGrpSpPr>
          <p:grpSpPr>
            <a:xfrm>
              <a:off x="790848" y="1330430"/>
              <a:ext cx="1132972" cy="2714989"/>
              <a:chOff x="790848" y="1330430"/>
              <a:chExt cx="1132972" cy="2714989"/>
            </a:xfrm>
          </p:grpSpPr>
          <p:pic>
            <p:nvPicPr>
              <p:cNvPr id="429" name="Google Shape;429;p3"/>
              <p:cNvPicPr preferRelativeResize="0"/>
              <p:nvPr/>
            </p:nvPicPr>
            <p:blipFill rotWithShape="1">
              <a:blip r:embed="rId3">
                <a:alphaModFix/>
              </a:blip>
              <a:srcRect l="7221" t="10119"/>
              <a:stretch/>
            </p:blipFill>
            <p:spPr>
              <a:xfrm>
                <a:off x="793882" y="1330430"/>
                <a:ext cx="1128372" cy="819840"/>
              </a:xfrm>
              <a:prstGeom prst="rect">
                <a:avLst/>
              </a:prstGeom>
              <a:noFill/>
              <a:ln w="9525" cap="flat" cmpd="sng">
                <a:solidFill>
                  <a:schemeClr val="dk1"/>
                </a:solidFill>
                <a:prstDash val="solid"/>
                <a:round/>
                <a:headEnd type="none" w="sm" len="sm"/>
                <a:tailEnd type="none" w="sm" len="sm"/>
              </a:ln>
            </p:spPr>
          </p:pic>
          <p:pic>
            <p:nvPicPr>
              <p:cNvPr id="430" name="Google Shape;430;p3"/>
              <p:cNvPicPr preferRelativeResize="0"/>
              <p:nvPr/>
            </p:nvPicPr>
            <p:blipFill rotWithShape="1">
              <a:blip r:embed="rId4">
                <a:alphaModFix/>
              </a:blip>
              <a:srcRect l="4847" t="59982" r="7221"/>
              <a:stretch/>
            </p:blipFill>
            <p:spPr>
              <a:xfrm>
                <a:off x="793882" y="2261975"/>
                <a:ext cx="1129938" cy="385665"/>
              </a:xfrm>
              <a:prstGeom prst="rect">
                <a:avLst/>
              </a:prstGeom>
              <a:noFill/>
              <a:ln w="9525" cap="flat" cmpd="sng">
                <a:solidFill>
                  <a:schemeClr val="dk1"/>
                </a:solidFill>
                <a:prstDash val="solid"/>
                <a:round/>
                <a:headEnd type="none" w="sm" len="sm"/>
                <a:tailEnd type="none" w="sm" len="sm"/>
              </a:ln>
            </p:spPr>
          </p:pic>
          <p:pic>
            <p:nvPicPr>
              <p:cNvPr id="431" name="Google Shape;431;p3"/>
              <p:cNvPicPr preferRelativeResize="0"/>
              <p:nvPr/>
            </p:nvPicPr>
            <p:blipFill rotWithShape="1">
              <a:blip r:embed="rId5">
                <a:alphaModFix/>
              </a:blip>
              <a:srcRect l="7218" t="56415" r="3747" b="4936"/>
              <a:stretch/>
            </p:blipFill>
            <p:spPr>
              <a:xfrm>
                <a:off x="790848" y="2743204"/>
                <a:ext cx="1128372" cy="367371"/>
              </a:xfrm>
              <a:prstGeom prst="rect">
                <a:avLst/>
              </a:prstGeom>
              <a:noFill/>
              <a:ln w="9525" cap="flat" cmpd="sng">
                <a:solidFill>
                  <a:schemeClr val="dk1"/>
                </a:solidFill>
                <a:prstDash val="solid"/>
                <a:round/>
                <a:headEnd type="none" w="sm" len="sm"/>
                <a:tailEnd type="none" w="sm" len="sm"/>
              </a:ln>
            </p:spPr>
          </p:pic>
          <p:pic>
            <p:nvPicPr>
              <p:cNvPr id="432" name="Google Shape;432;p3"/>
              <p:cNvPicPr preferRelativeResize="0"/>
              <p:nvPr/>
            </p:nvPicPr>
            <p:blipFill rotWithShape="1">
              <a:blip r:embed="rId6">
                <a:alphaModFix/>
              </a:blip>
              <a:srcRect l="10782" t="57415" b="3877"/>
              <a:stretch/>
            </p:blipFill>
            <p:spPr>
              <a:xfrm>
                <a:off x="790848" y="3225248"/>
                <a:ext cx="1128372" cy="367136"/>
              </a:xfrm>
              <a:prstGeom prst="rect">
                <a:avLst/>
              </a:prstGeom>
              <a:noFill/>
              <a:ln w="9525" cap="flat" cmpd="sng">
                <a:solidFill>
                  <a:schemeClr val="dk1"/>
                </a:solidFill>
                <a:prstDash val="solid"/>
                <a:round/>
                <a:headEnd type="none" w="sm" len="sm"/>
                <a:tailEnd type="none" w="sm" len="sm"/>
              </a:ln>
            </p:spPr>
          </p:pic>
          <p:pic>
            <p:nvPicPr>
              <p:cNvPr id="433" name="Google Shape;433;p3"/>
              <p:cNvPicPr preferRelativeResize="0"/>
              <p:nvPr/>
            </p:nvPicPr>
            <p:blipFill rotWithShape="1">
              <a:blip r:embed="rId7">
                <a:alphaModFix/>
              </a:blip>
              <a:srcRect l="13155" t="58644" r="2561" b="7081"/>
              <a:stretch/>
            </p:blipFill>
            <p:spPr>
              <a:xfrm>
                <a:off x="790848" y="3701283"/>
                <a:ext cx="1128372" cy="344136"/>
              </a:xfrm>
              <a:prstGeom prst="rect">
                <a:avLst/>
              </a:prstGeom>
              <a:noFill/>
              <a:ln w="9525" cap="flat" cmpd="sng">
                <a:solidFill>
                  <a:schemeClr val="dk1"/>
                </a:solidFill>
                <a:prstDash val="solid"/>
                <a:round/>
                <a:headEnd type="none" w="sm" len="sm"/>
                <a:tailEnd type="none" w="sm" len="sm"/>
              </a:ln>
            </p:spPr>
          </p:pic>
        </p:grpSp>
        <p:sp>
          <p:nvSpPr>
            <p:cNvPr id="434" name="Google Shape;434;p3"/>
            <p:cNvSpPr txBox="1"/>
            <p:nvPr/>
          </p:nvSpPr>
          <p:spPr>
            <a:xfrm>
              <a:off x="830336" y="1021998"/>
              <a:ext cx="413126" cy="31616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530"/>
                <a:buFont typeface="Arial"/>
                <a:buNone/>
              </a:pPr>
              <a:r>
                <a:rPr lang="en-US" sz="1530" b="1" i="0" u="none" strike="noStrike" cap="none">
                  <a:solidFill>
                    <a:schemeClr val="dk1"/>
                  </a:solidFill>
                  <a:latin typeface="Calibri"/>
                  <a:ea typeface="Calibri"/>
                  <a:cs typeface="Calibri"/>
                  <a:sym typeface="Calibri"/>
                </a:rPr>
                <a:t>WT</a:t>
              </a:r>
              <a:endParaRPr sz="1400" b="0" i="0" u="none" strike="noStrike" cap="none">
                <a:solidFill>
                  <a:srgbClr val="000000"/>
                </a:solidFill>
                <a:latin typeface="Arial"/>
                <a:ea typeface="Arial"/>
                <a:cs typeface="Arial"/>
                <a:sym typeface="Arial"/>
              </a:endParaRPr>
            </a:p>
          </p:txBody>
        </p:sp>
        <p:sp>
          <p:nvSpPr>
            <p:cNvPr id="435" name="Google Shape;435;p3"/>
            <p:cNvSpPr txBox="1"/>
            <p:nvPr/>
          </p:nvSpPr>
          <p:spPr>
            <a:xfrm>
              <a:off x="1350485" y="1021997"/>
              <a:ext cx="516524" cy="316166"/>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530"/>
                <a:buFont typeface="Arial"/>
                <a:buNone/>
              </a:pPr>
              <a:r>
                <a:rPr lang="en-US" sz="1530" b="1" i="1" u="none" strike="noStrike" cap="none">
                  <a:solidFill>
                    <a:schemeClr val="dk1"/>
                  </a:solidFill>
                  <a:latin typeface="Calibri"/>
                  <a:ea typeface="Calibri"/>
                  <a:cs typeface="Calibri"/>
                  <a:sym typeface="Calibri"/>
                </a:rPr>
                <a:t>rmt2</a:t>
              </a:r>
              <a:endParaRPr sz="1530" b="1" i="1" u="none" strike="noStrike" cap="none">
                <a:solidFill>
                  <a:schemeClr val="dk1"/>
                </a:solidFill>
                <a:latin typeface="Calibri"/>
                <a:ea typeface="Calibri"/>
                <a:cs typeface="Calibri"/>
                <a:sym typeface="Calibri"/>
              </a:endParaRPr>
            </a:p>
          </p:txBody>
        </p:sp>
      </p:grpSp>
      <p:graphicFrame>
        <p:nvGraphicFramePr>
          <p:cNvPr id="436" name="Google Shape;436;p3"/>
          <p:cNvGraphicFramePr/>
          <p:nvPr/>
        </p:nvGraphicFramePr>
        <p:xfrm>
          <a:off x="3208854" y="1407786"/>
          <a:ext cx="3825478" cy="3199077"/>
        </p:xfrm>
        <a:graphic>
          <a:graphicData uri="http://schemas.openxmlformats.org/drawingml/2006/chart">
            <c:chart xmlns:c="http://schemas.openxmlformats.org/drawingml/2006/chart" xmlns:r="http://schemas.openxmlformats.org/officeDocument/2006/relationships" r:id="rId8"/>
          </a:graphicData>
        </a:graphic>
      </p:graphicFrame>
      <p:sp>
        <p:nvSpPr>
          <p:cNvPr id="437" name="Google Shape;437;p3"/>
          <p:cNvSpPr txBox="1"/>
          <p:nvPr/>
        </p:nvSpPr>
        <p:spPr>
          <a:xfrm>
            <a:off x="527538" y="1230923"/>
            <a:ext cx="351378"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i="0" u="none" strike="noStrike" cap="none">
                <a:solidFill>
                  <a:schemeClr val="dk1"/>
                </a:solidFill>
                <a:latin typeface="Times New Roman"/>
                <a:ea typeface="Times New Roman"/>
                <a:cs typeface="Times New Roman"/>
                <a:sym typeface="Times New Roman"/>
              </a:rPr>
              <a:t>A</a:t>
            </a:r>
            <a:endParaRPr sz="1400" b="0" i="0" u="none" strike="noStrike" cap="none">
              <a:solidFill>
                <a:srgbClr val="000000"/>
              </a:solidFill>
              <a:latin typeface="Arial"/>
              <a:ea typeface="Arial"/>
              <a:cs typeface="Arial"/>
              <a:sym typeface="Arial"/>
            </a:endParaRPr>
          </a:p>
        </p:txBody>
      </p:sp>
      <p:sp>
        <p:nvSpPr>
          <p:cNvPr id="438" name="Google Shape;438;p3"/>
          <p:cNvSpPr txBox="1"/>
          <p:nvPr/>
        </p:nvSpPr>
        <p:spPr>
          <a:xfrm>
            <a:off x="2963546" y="1230923"/>
            <a:ext cx="351378"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1" i="0" u="none" strike="noStrike" cap="none">
                <a:solidFill>
                  <a:schemeClr val="dk1"/>
                </a:solidFill>
                <a:latin typeface="Times New Roman"/>
                <a:ea typeface="Times New Roman"/>
                <a:cs typeface="Times New Roman"/>
                <a:sym typeface="Times New Roman"/>
              </a:rPr>
              <a:t>B</a:t>
            </a:r>
            <a:endParaRPr sz="1400" b="0" i="0" u="none" strike="noStrike" cap="none">
              <a:solidFill>
                <a:srgbClr val="000000"/>
              </a:solidFill>
              <a:latin typeface="Arial"/>
              <a:ea typeface="Arial"/>
              <a:cs typeface="Arial"/>
              <a:sym typeface="Arial"/>
            </a:endParaRPr>
          </a:p>
        </p:txBody>
      </p:sp>
    </p:spTree>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43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443"/>
        <p:cNvGrpSpPr/>
        <p:nvPr/>
      </p:nvGrpSpPr>
      <p:grpSpPr>
        <a:xfrm>
          <a:off x="0" y="0"/>
          <a:ext cx="0" cy="0"/>
          <a:chOff x="0" y="0"/>
          <a:chExt cx="0" cy="0"/>
        </a:xfrm>
      </p:grpSpPr>
      <p:sp>
        <p:nvSpPr>
          <p:cNvPr id="444" name="Google Shape;444;p4"/>
          <p:cNvSpPr txBox="1"/>
          <p:nvPr/>
        </p:nvSpPr>
        <p:spPr>
          <a:xfrm>
            <a:off x="111347" y="151182"/>
            <a:ext cx="1088760"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Times New Roman"/>
                <a:ea typeface="Times New Roman"/>
                <a:cs typeface="Times New Roman"/>
                <a:sym typeface="Times New Roman"/>
              </a:rPr>
              <a:t>Figure S3</a:t>
            </a:r>
            <a:endParaRPr sz="1400" b="0" i="0" u="none" strike="noStrike" cap="none">
              <a:solidFill>
                <a:srgbClr val="000000"/>
              </a:solidFill>
              <a:latin typeface="Arial"/>
              <a:ea typeface="Arial"/>
              <a:cs typeface="Arial"/>
              <a:sym typeface="Arial"/>
            </a:endParaRPr>
          </a:p>
        </p:txBody>
      </p:sp>
      <p:sp>
        <p:nvSpPr>
          <p:cNvPr id="445" name="Google Shape;445;p4"/>
          <p:cNvSpPr txBox="1"/>
          <p:nvPr/>
        </p:nvSpPr>
        <p:spPr>
          <a:xfrm>
            <a:off x="910035" y="5575648"/>
            <a:ext cx="6121270" cy="1015622"/>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000000"/>
              </a:buClr>
              <a:buSzPts val="1200"/>
              <a:buFont typeface="Arial"/>
              <a:buNone/>
            </a:pPr>
            <a:r>
              <a:rPr lang="en-US" sz="1200" b="1" i="0" u="none" strike="noStrike" cap="none">
                <a:solidFill>
                  <a:schemeClr val="dk1"/>
                </a:solidFill>
                <a:latin typeface="Calibri"/>
                <a:ea typeface="Calibri"/>
                <a:cs typeface="Calibri"/>
                <a:sym typeface="Calibri"/>
              </a:rPr>
              <a:t>Figure S3. Summary of peptide identification by LC-MS/MS. </a:t>
            </a:r>
            <a:r>
              <a:rPr lang="en-US" sz="1200" b="0" i="0" u="none" strike="noStrike" cap="none">
                <a:solidFill>
                  <a:schemeClr val="dk1"/>
                </a:solidFill>
                <a:latin typeface="Calibri"/>
                <a:ea typeface="Calibri"/>
                <a:cs typeface="Calibri"/>
                <a:sym typeface="Calibri"/>
              </a:rPr>
              <a:t>Samples were extracted and analyzed by LC-MS/MS using the same method as in </a:t>
            </a:r>
            <a:r>
              <a:rPr lang="en-US" sz="1200" b="1" i="0" u="none" strike="noStrike" cap="none">
                <a:solidFill>
                  <a:schemeClr val="dk1"/>
                </a:solidFill>
                <a:latin typeface="Calibri"/>
                <a:ea typeface="Calibri"/>
                <a:cs typeface="Calibri"/>
                <a:sym typeface="Calibri"/>
              </a:rPr>
              <a:t>Fig. 5</a:t>
            </a:r>
            <a:r>
              <a:rPr lang="en-US" sz="1200" b="0" i="0" u="none" strike="noStrike" cap="none">
                <a:solidFill>
                  <a:schemeClr val="dk1"/>
                </a:solidFill>
                <a:latin typeface="Calibri"/>
                <a:ea typeface="Calibri"/>
                <a:cs typeface="Calibri"/>
                <a:sym typeface="Calibri"/>
              </a:rPr>
              <a:t>. The value on the y-axis is the average of the relative quantities of the detected peptides of the subunits of the various photosynthetic complexes in </a:t>
            </a:r>
            <a:r>
              <a:rPr lang="en-US" sz="1200" b="0" i="1" u="none" strike="noStrike" cap="none">
                <a:solidFill>
                  <a:schemeClr val="dk1"/>
                </a:solidFill>
                <a:latin typeface="Calibri"/>
                <a:ea typeface="Calibri"/>
                <a:cs typeface="Calibri"/>
                <a:sym typeface="Calibri"/>
              </a:rPr>
              <a:t>rmt2</a:t>
            </a:r>
            <a:r>
              <a:rPr lang="en-US" sz="1200" b="0" i="0" u="none" strike="noStrike" cap="none">
                <a:solidFill>
                  <a:schemeClr val="dk1"/>
                </a:solidFill>
                <a:latin typeface="Calibri"/>
                <a:ea typeface="Calibri"/>
                <a:cs typeface="Calibri"/>
                <a:sym typeface="Calibri"/>
              </a:rPr>
              <a:t> cells (both </a:t>
            </a:r>
            <a:r>
              <a:rPr lang="en-US" sz="1200" b="0" i="1" u="none" strike="noStrike" cap="none">
                <a:solidFill>
                  <a:schemeClr val="dk1"/>
                </a:solidFill>
                <a:latin typeface="Calibri"/>
                <a:ea typeface="Calibri"/>
                <a:cs typeface="Calibri"/>
                <a:sym typeface="Calibri"/>
              </a:rPr>
              <a:t>rmt2-1</a:t>
            </a:r>
            <a:r>
              <a:rPr lang="en-US" sz="1200" b="0" i="0" u="none" strike="noStrike" cap="none">
                <a:solidFill>
                  <a:schemeClr val="dk1"/>
                </a:solidFill>
                <a:latin typeface="Calibri"/>
                <a:ea typeface="Calibri"/>
                <a:cs typeface="Calibri"/>
                <a:sym typeface="Calibri"/>
              </a:rPr>
              <a:t> and </a:t>
            </a:r>
            <a:r>
              <a:rPr lang="en-US" sz="1200" b="0" i="1" u="none" strike="noStrike" cap="none">
                <a:solidFill>
                  <a:schemeClr val="dk1"/>
                </a:solidFill>
                <a:latin typeface="Calibri"/>
                <a:ea typeface="Calibri"/>
                <a:cs typeface="Calibri"/>
                <a:sym typeface="Calibri"/>
              </a:rPr>
              <a:t>rmt2-2</a:t>
            </a:r>
            <a:r>
              <a:rPr lang="en-US" sz="1200" b="0" i="0" u="none" strike="noStrike" cap="none">
                <a:solidFill>
                  <a:schemeClr val="dk1"/>
                </a:solidFill>
                <a:latin typeface="Calibri"/>
                <a:ea typeface="Calibri"/>
                <a:cs typeface="Calibri"/>
                <a:sym typeface="Calibri"/>
              </a:rPr>
              <a:t>) compared to those of WT cells</a:t>
            </a:r>
            <a:r>
              <a:rPr lang="en-US" sz="1200" b="1" i="0" u="none" strike="noStrike" cap="none">
                <a:solidFill>
                  <a:schemeClr val="dk1"/>
                </a:solidFill>
                <a:latin typeface="Calibri"/>
                <a:ea typeface="Calibri"/>
                <a:cs typeface="Calibri"/>
                <a:sym typeface="Calibri"/>
              </a:rPr>
              <a:t>.</a:t>
            </a:r>
            <a:endParaRPr sz="1000" b="0" i="0" u="none" strike="noStrike" cap="none">
              <a:solidFill>
                <a:schemeClr val="dk1"/>
              </a:solidFill>
              <a:latin typeface="Calibri"/>
              <a:ea typeface="Calibri"/>
              <a:cs typeface="Calibri"/>
              <a:sym typeface="Calibri"/>
            </a:endParaRPr>
          </a:p>
        </p:txBody>
      </p:sp>
      <p:graphicFrame>
        <p:nvGraphicFramePr>
          <p:cNvPr id="446" name="Google Shape;446;p4"/>
          <p:cNvGraphicFramePr/>
          <p:nvPr/>
        </p:nvGraphicFramePr>
        <p:xfrm>
          <a:off x="1097295" y="1587500"/>
          <a:ext cx="5746750" cy="3606800"/>
        </p:xfrm>
        <a:graphic>
          <a:graphicData uri="http://schemas.openxmlformats.org/drawingml/2006/chart">
            <c:chart xmlns:c="http://schemas.openxmlformats.org/drawingml/2006/chart" xmlns:r="http://schemas.openxmlformats.org/officeDocument/2006/relationships" r:id="rId3"/>
          </a:graphicData>
        </a:graphic>
      </p:graphicFrame>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451"/>
        <p:cNvGrpSpPr/>
        <p:nvPr/>
      </p:nvGrpSpPr>
      <p:grpSpPr>
        <a:xfrm>
          <a:off x="0" y="0"/>
          <a:ext cx="0" cy="0"/>
          <a:chOff x="0" y="0"/>
          <a:chExt cx="0" cy="0"/>
        </a:xfrm>
      </p:grpSpPr>
      <p:sp>
        <p:nvSpPr>
          <p:cNvPr id="452" name="Google Shape;452;p5"/>
          <p:cNvSpPr txBox="1"/>
          <p:nvPr/>
        </p:nvSpPr>
        <p:spPr>
          <a:xfrm>
            <a:off x="111347" y="151182"/>
            <a:ext cx="1088760"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Times New Roman"/>
                <a:ea typeface="Times New Roman"/>
                <a:cs typeface="Times New Roman"/>
                <a:sym typeface="Times New Roman"/>
              </a:rPr>
              <a:t>Figure S4</a:t>
            </a:r>
            <a:endParaRPr sz="1800" b="0" i="0" u="none" strike="noStrike" cap="none">
              <a:solidFill>
                <a:schemeClr val="dk1"/>
              </a:solidFill>
              <a:latin typeface="Times New Roman"/>
              <a:ea typeface="Times New Roman"/>
              <a:cs typeface="Times New Roman"/>
              <a:sym typeface="Times New Roman"/>
            </a:endParaRPr>
          </a:p>
        </p:txBody>
      </p:sp>
      <p:sp>
        <p:nvSpPr>
          <p:cNvPr id="453" name="Google Shape;453;p5"/>
          <p:cNvSpPr txBox="1"/>
          <p:nvPr/>
        </p:nvSpPr>
        <p:spPr>
          <a:xfrm>
            <a:off x="704270" y="4367925"/>
            <a:ext cx="6121270" cy="1384954"/>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000000"/>
              </a:buClr>
              <a:buSzPts val="1200"/>
              <a:buFont typeface="Arial"/>
              <a:buNone/>
            </a:pPr>
            <a:r>
              <a:rPr lang="en-US" sz="1200" b="1" i="0" u="none" strike="noStrike" cap="none">
                <a:solidFill>
                  <a:srgbClr val="000000"/>
                </a:solidFill>
                <a:latin typeface="Calibri"/>
                <a:ea typeface="Calibri"/>
                <a:cs typeface="Calibri"/>
                <a:sym typeface="Calibri"/>
              </a:rPr>
              <a:t>Figure S4. Relative gene expression profiles of CCM associated genes in cells acclimating to LC. </a:t>
            </a:r>
            <a:r>
              <a:rPr lang="en-US" sz="1200" b="0" i="0" u="none" strike="noStrike" cap="none">
                <a:solidFill>
                  <a:srgbClr val="000000"/>
                </a:solidFill>
                <a:latin typeface="Calibri"/>
                <a:ea typeface="Calibri"/>
                <a:cs typeface="Calibri"/>
                <a:sym typeface="Calibri"/>
              </a:rPr>
              <a:t> Cells grown under HC (2% CO</a:t>
            </a:r>
            <a:r>
              <a:rPr lang="en-US" sz="1200" b="0" i="0" u="none" strike="noStrike" cap="none" baseline="-25000">
                <a:solidFill>
                  <a:srgbClr val="000000"/>
                </a:solidFill>
                <a:latin typeface="Calibri"/>
                <a:ea typeface="Calibri"/>
                <a:cs typeface="Calibri"/>
                <a:sym typeface="Calibri"/>
              </a:rPr>
              <a:t>2</a:t>
            </a:r>
            <a:r>
              <a:rPr lang="en-US" sz="1200" b="0" i="0" u="none" strike="noStrike" cap="none">
                <a:solidFill>
                  <a:srgbClr val="000000"/>
                </a:solidFill>
                <a:latin typeface="Calibri"/>
                <a:ea typeface="Calibri"/>
                <a:cs typeface="Calibri"/>
                <a:sym typeface="Calibri"/>
              </a:rPr>
              <a:t>) conditions were transitioned to low CO</a:t>
            </a:r>
            <a:r>
              <a:rPr lang="en-US" sz="1200" b="0" i="0" u="none" strike="noStrike" cap="none" baseline="-25000">
                <a:solidFill>
                  <a:srgbClr val="000000"/>
                </a:solidFill>
                <a:latin typeface="Calibri"/>
                <a:ea typeface="Calibri"/>
                <a:cs typeface="Calibri"/>
                <a:sym typeface="Calibri"/>
              </a:rPr>
              <a:t>2</a:t>
            </a:r>
            <a:r>
              <a:rPr lang="en-US" sz="1200" b="0" i="0" u="none" strike="noStrike" cap="none">
                <a:solidFill>
                  <a:srgbClr val="000000"/>
                </a:solidFill>
                <a:latin typeface="Calibri"/>
                <a:ea typeface="Calibri"/>
                <a:cs typeface="Calibri"/>
                <a:sym typeface="Calibri"/>
              </a:rPr>
              <a:t> (0.04%) (TP medium; 50 </a:t>
            </a:r>
            <a:r>
              <a:rPr lang="en-US" sz="1200" b="0" i="0" u="none" strike="noStrike" cap="none">
                <a:solidFill>
                  <a:schemeClr val="dk1"/>
                </a:solidFill>
                <a:latin typeface="Calibri"/>
                <a:ea typeface="Calibri"/>
                <a:cs typeface="Calibri"/>
                <a:sym typeface="Calibri"/>
              </a:rPr>
              <a:t>µmol photons m</a:t>
            </a:r>
            <a:r>
              <a:rPr lang="en-US" sz="1200" b="0" i="0" u="none" strike="noStrike" cap="none" baseline="30000">
                <a:solidFill>
                  <a:schemeClr val="dk1"/>
                </a:solidFill>
                <a:latin typeface="Calibri"/>
                <a:ea typeface="Calibri"/>
                <a:cs typeface="Calibri"/>
                <a:sym typeface="Calibri"/>
              </a:rPr>
              <a:t>-2</a:t>
            </a:r>
            <a:r>
              <a:rPr lang="en-US" sz="1200" b="0" i="0" u="none" strike="noStrike" cap="none">
                <a:solidFill>
                  <a:schemeClr val="dk1"/>
                </a:solidFill>
                <a:latin typeface="Calibri"/>
                <a:ea typeface="Calibri"/>
                <a:cs typeface="Calibri"/>
                <a:sym typeface="Calibri"/>
              </a:rPr>
              <a:t> s</a:t>
            </a:r>
            <a:r>
              <a:rPr lang="en-US" sz="1200" b="0" i="0" u="none" strike="noStrike" cap="none" baseline="30000">
                <a:solidFill>
                  <a:schemeClr val="dk1"/>
                </a:solidFill>
                <a:latin typeface="Calibri"/>
                <a:ea typeface="Calibri"/>
                <a:cs typeface="Calibri"/>
                <a:sym typeface="Calibri"/>
              </a:rPr>
              <a:t>-1</a:t>
            </a:r>
            <a:r>
              <a:rPr lang="en-US" sz="1200" b="0" i="0" u="none" strike="noStrike" cap="none">
                <a:solidFill>
                  <a:srgbClr val="000000"/>
                </a:solidFill>
                <a:latin typeface="Calibri"/>
                <a:ea typeface="Calibri"/>
                <a:cs typeface="Calibri"/>
                <a:sym typeface="Calibri"/>
              </a:rPr>
              <a:t>) at 0 h. The levels of mRNA from the CCM genes </a:t>
            </a:r>
            <a:r>
              <a:rPr lang="en-US" sz="1200" b="0" i="1" u="none" strike="noStrike" cap="none">
                <a:solidFill>
                  <a:srgbClr val="000000"/>
                </a:solidFill>
                <a:latin typeface="Calibri"/>
                <a:ea typeface="Calibri"/>
                <a:cs typeface="Calibri"/>
                <a:sym typeface="Calibri"/>
              </a:rPr>
              <a:t>CAH1</a:t>
            </a:r>
            <a:r>
              <a:rPr lang="en-US" sz="1200" b="0" i="0" u="none" strike="noStrike" cap="none">
                <a:solidFill>
                  <a:srgbClr val="000000"/>
                </a:solidFill>
                <a:latin typeface="Calibri"/>
                <a:ea typeface="Calibri"/>
                <a:cs typeface="Calibri"/>
                <a:sym typeface="Calibri"/>
              </a:rPr>
              <a:t>, </a:t>
            </a:r>
            <a:r>
              <a:rPr lang="en-US" sz="1200" b="0" i="1" u="none" strike="noStrike" cap="none">
                <a:solidFill>
                  <a:srgbClr val="000000"/>
                </a:solidFill>
                <a:latin typeface="Calibri"/>
                <a:ea typeface="Calibri"/>
                <a:cs typeface="Calibri"/>
                <a:sym typeface="Calibri"/>
              </a:rPr>
              <a:t>CCP1</a:t>
            </a:r>
            <a:r>
              <a:rPr lang="en-US" sz="1200" b="0" i="0" u="none" strike="noStrike" cap="none">
                <a:solidFill>
                  <a:srgbClr val="000000"/>
                </a:solidFill>
                <a:latin typeface="Calibri"/>
                <a:ea typeface="Calibri"/>
                <a:cs typeface="Calibri"/>
                <a:sym typeface="Calibri"/>
              </a:rPr>
              <a:t> and </a:t>
            </a:r>
            <a:r>
              <a:rPr lang="en-US" sz="1200" b="0" i="1" u="none" strike="noStrike" cap="none">
                <a:solidFill>
                  <a:srgbClr val="000000"/>
                </a:solidFill>
                <a:latin typeface="Calibri"/>
                <a:ea typeface="Calibri"/>
                <a:cs typeface="Calibri"/>
                <a:sym typeface="Calibri"/>
              </a:rPr>
              <a:t>LCI1</a:t>
            </a:r>
            <a:r>
              <a:rPr lang="en-US" sz="1200" b="0" i="0" u="none" strike="noStrike" cap="none">
                <a:solidFill>
                  <a:srgbClr val="000000"/>
                </a:solidFill>
                <a:latin typeface="Calibri"/>
                <a:ea typeface="Calibri"/>
                <a:cs typeface="Calibri"/>
                <a:sym typeface="Calibri"/>
              </a:rPr>
              <a:t> were determined from samples by qRT-PCR at various times (0, 3, 6 and 24 h) following the transfer. The values were normalized to </a:t>
            </a:r>
            <a:r>
              <a:rPr lang="en-US" sz="1200" b="0" i="1" u="none" strike="noStrike" cap="none">
                <a:solidFill>
                  <a:srgbClr val="000000"/>
                </a:solidFill>
                <a:latin typeface="Calibri"/>
                <a:ea typeface="Calibri"/>
                <a:cs typeface="Calibri"/>
                <a:sym typeface="Calibri"/>
              </a:rPr>
              <a:t>CBLP</a:t>
            </a:r>
            <a:r>
              <a:rPr lang="en-US" sz="1200" b="0" i="0" u="none" strike="noStrike" cap="none">
                <a:solidFill>
                  <a:srgbClr val="000000"/>
                </a:solidFill>
                <a:latin typeface="Calibri"/>
                <a:ea typeface="Calibri"/>
                <a:cs typeface="Calibri"/>
                <a:sym typeface="Calibri"/>
              </a:rPr>
              <a:t> (control gene) expression and to the mRNA levels of WT at 0 h. Values are the mean of two technical replicates, and error bars represent standard deviations.</a:t>
            </a:r>
            <a:endParaRPr sz="1200" b="0" i="0" u="none" strike="noStrike" cap="none">
              <a:solidFill>
                <a:schemeClr val="dk1"/>
              </a:solidFill>
              <a:latin typeface="Calibri"/>
              <a:ea typeface="Calibri"/>
              <a:cs typeface="Calibri"/>
              <a:sym typeface="Calibri"/>
            </a:endParaRPr>
          </a:p>
        </p:txBody>
      </p:sp>
      <p:grpSp>
        <p:nvGrpSpPr>
          <p:cNvPr id="454" name="Google Shape;454;p5"/>
          <p:cNvGrpSpPr/>
          <p:nvPr/>
        </p:nvGrpSpPr>
        <p:grpSpPr>
          <a:xfrm>
            <a:off x="550381" y="768013"/>
            <a:ext cx="6396760" cy="2979620"/>
            <a:chOff x="121349" y="2204927"/>
            <a:chExt cx="6396760" cy="2979620"/>
          </a:xfrm>
        </p:grpSpPr>
        <p:graphicFrame>
          <p:nvGraphicFramePr>
            <p:cNvPr id="455" name="Google Shape;455;p5"/>
            <p:cNvGraphicFramePr/>
            <p:nvPr/>
          </p:nvGraphicFramePr>
          <p:xfrm>
            <a:off x="379571" y="2577721"/>
            <a:ext cx="2011680" cy="2606825"/>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456" name="Google Shape;456;p5"/>
            <p:cNvGraphicFramePr/>
            <p:nvPr/>
          </p:nvGraphicFramePr>
          <p:xfrm>
            <a:off x="2552725" y="2577721"/>
            <a:ext cx="2011680" cy="2606825"/>
          </p:xfrm>
          <a:graphic>
            <a:graphicData uri="http://schemas.openxmlformats.org/drawingml/2006/chart">
              <c:chart xmlns:c="http://schemas.openxmlformats.org/drawingml/2006/chart" xmlns:r="http://schemas.openxmlformats.org/officeDocument/2006/relationships" r:id="rId4"/>
            </a:graphicData>
          </a:graphic>
        </p:graphicFrame>
        <p:graphicFrame>
          <p:nvGraphicFramePr>
            <p:cNvPr id="457" name="Google Shape;457;p5"/>
            <p:cNvGraphicFramePr/>
            <p:nvPr/>
          </p:nvGraphicFramePr>
          <p:xfrm>
            <a:off x="4506429" y="2575553"/>
            <a:ext cx="2011680" cy="2608994"/>
          </p:xfrm>
          <a:graphic>
            <a:graphicData uri="http://schemas.openxmlformats.org/drawingml/2006/chart">
              <c:chart xmlns:c="http://schemas.openxmlformats.org/drawingml/2006/chart" xmlns:r="http://schemas.openxmlformats.org/officeDocument/2006/relationships" r:id="rId5"/>
            </a:graphicData>
          </a:graphic>
        </p:graphicFrame>
        <p:sp>
          <p:nvSpPr>
            <p:cNvPr id="458" name="Google Shape;458;p5"/>
            <p:cNvSpPr txBox="1"/>
            <p:nvPr/>
          </p:nvSpPr>
          <p:spPr>
            <a:xfrm>
              <a:off x="1348875" y="2204927"/>
              <a:ext cx="673582"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1" i="0" u="none" strike="noStrike" cap="none">
                  <a:solidFill>
                    <a:schemeClr val="dk1"/>
                  </a:solidFill>
                  <a:latin typeface="Times New Roman"/>
                  <a:ea typeface="Times New Roman"/>
                  <a:cs typeface="Times New Roman"/>
                  <a:sym typeface="Times New Roman"/>
                </a:rPr>
                <a:t>CAH1</a:t>
              </a:r>
              <a:endParaRPr sz="1400" b="0" i="0" u="none" strike="noStrike" cap="none">
                <a:solidFill>
                  <a:srgbClr val="000000"/>
                </a:solidFill>
                <a:latin typeface="Arial"/>
                <a:ea typeface="Arial"/>
                <a:cs typeface="Arial"/>
                <a:sym typeface="Arial"/>
              </a:endParaRPr>
            </a:p>
          </p:txBody>
        </p:sp>
        <p:sp>
          <p:nvSpPr>
            <p:cNvPr id="459" name="Google Shape;459;p5"/>
            <p:cNvSpPr txBox="1"/>
            <p:nvPr/>
          </p:nvSpPr>
          <p:spPr>
            <a:xfrm>
              <a:off x="3543991" y="2204927"/>
              <a:ext cx="643125"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1" i="0" u="none" strike="noStrike" cap="none">
                  <a:solidFill>
                    <a:schemeClr val="dk1"/>
                  </a:solidFill>
                  <a:latin typeface="Times New Roman"/>
                  <a:ea typeface="Times New Roman"/>
                  <a:cs typeface="Times New Roman"/>
                  <a:sym typeface="Times New Roman"/>
                </a:rPr>
                <a:t>CCP1</a:t>
              </a:r>
              <a:endParaRPr sz="1400" b="0" i="0" u="none" strike="noStrike" cap="none">
                <a:solidFill>
                  <a:srgbClr val="000000"/>
                </a:solidFill>
                <a:latin typeface="Arial"/>
                <a:ea typeface="Arial"/>
                <a:cs typeface="Arial"/>
                <a:sym typeface="Arial"/>
              </a:endParaRPr>
            </a:p>
          </p:txBody>
        </p:sp>
        <p:sp>
          <p:nvSpPr>
            <p:cNvPr id="460" name="Google Shape;460;p5"/>
            <p:cNvSpPr txBox="1"/>
            <p:nvPr/>
          </p:nvSpPr>
          <p:spPr>
            <a:xfrm>
              <a:off x="5588081" y="2204927"/>
              <a:ext cx="595035" cy="307777"/>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400"/>
                <a:buFont typeface="Arial"/>
                <a:buNone/>
              </a:pPr>
              <a:r>
                <a:rPr lang="en-US" sz="1400" b="1" i="0" u="none" strike="noStrike" cap="none">
                  <a:solidFill>
                    <a:schemeClr val="dk1"/>
                  </a:solidFill>
                  <a:latin typeface="Times New Roman"/>
                  <a:ea typeface="Times New Roman"/>
                  <a:cs typeface="Times New Roman"/>
                  <a:sym typeface="Times New Roman"/>
                </a:rPr>
                <a:t>LCI1</a:t>
              </a:r>
              <a:endParaRPr sz="1400" b="0" i="0" u="none" strike="noStrike" cap="none">
                <a:solidFill>
                  <a:srgbClr val="000000"/>
                </a:solidFill>
                <a:latin typeface="Arial"/>
                <a:ea typeface="Arial"/>
                <a:cs typeface="Arial"/>
                <a:sym typeface="Arial"/>
              </a:endParaRPr>
            </a:p>
          </p:txBody>
        </p:sp>
        <p:sp>
          <p:nvSpPr>
            <p:cNvPr id="461" name="Google Shape;461;p5"/>
            <p:cNvSpPr/>
            <p:nvPr/>
          </p:nvSpPr>
          <p:spPr>
            <a:xfrm rot="-5400000">
              <a:off x="-843658" y="3511067"/>
              <a:ext cx="2237792" cy="307777"/>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400"/>
                <a:buFont typeface="Arial"/>
                <a:buNone/>
              </a:pPr>
              <a:r>
                <a:rPr lang="en-US" sz="1400" b="1" i="0" u="none" strike="noStrike" cap="none">
                  <a:solidFill>
                    <a:srgbClr val="000000"/>
                  </a:solidFill>
                  <a:latin typeface="Times New Roman"/>
                  <a:ea typeface="Times New Roman"/>
                  <a:cs typeface="Times New Roman"/>
                  <a:sym typeface="Times New Roman"/>
                </a:rPr>
                <a:t>Relative mRNA expression</a:t>
              </a:r>
              <a:endParaRPr sz="1400" b="0" i="0" u="none" strike="noStrike" cap="none">
                <a:solidFill>
                  <a:srgbClr val="000000"/>
                </a:solidFill>
                <a:latin typeface="Arial"/>
                <a:ea typeface="Arial"/>
                <a:cs typeface="Arial"/>
                <a:sym typeface="Arial"/>
              </a:endParaRPr>
            </a:p>
          </p:txBody>
        </p:sp>
      </p:gr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466"/>
        <p:cNvGrpSpPr/>
        <p:nvPr/>
      </p:nvGrpSpPr>
      <p:grpSpPr>
        <a:xfrm>
          <a:off x="0" y="0"/>
          <a:ext cx="0" cy="0"/>
          <a:chOff x="0" y="0"/>
          <a:chExt cx="0" cy="0"/>
        </a:xfrm>
      </p:grpSpPr>
      <p:sp>
        <p:nvSpPr>
          <p:cNvPr id="467" name="Google Shape;467;p6"/>
          <p:cNvSpPr txBox="1"/>
          <p:nvPr/>
        </p:nvSpPr>
        <p:spPr>
          <a:xfrm>
            <a:off x="111347" y="151182"/>
            <a:ext cx="1088760"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Times New Roman"/>
                <a:ea typeface="Times New Roman"/>
                <a:cs typeface="Times New Roman"/>
                <a:sym typeface="Times New Roman"/>
              </a:rPr>
              <a:t>Figure S5</a:t>
            </a:r>
            <a:endParaRPr sz="1400" b="0" i="0" u="none" strike="noStrike" cap="none">
              <a:solidFill>
                <a:srgbClr val="000000"/>
              </a:solidFill>
              <a:latin typeface="Arial"/>
              <a:ea typeface="Arial"/>
              <a:cs typeface="Arial"/>
              <a:sym typeface="Arial"/>
            </a:endParaRPr>
          </a:p>
        </p:txBody>
      </p:sp>
      <p:sp>
        <p:nvSpPr>
          <p:cNvPr id="468" name="Google Shape;468;p6"/>
          <p:cNvSpPr txBox="1"/>
          <p:nvPr/>
        </p:nvSpPr>
        <p:spPr>
          <a:xfrm>
            <a:off x="850600" y="4023152"/>
            <a:ext cx="6121270" cy="1384954"/>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000000"/>
              </a:buClr>
              <a:buSzPts val="1200"/>
              <a:buFont typeface="Arial"/>
              <a:buNone/>
            </a:pPr>
            <a:r>
              <a:rPr lang="en-US" sz="1200" b="1" i="0" u="none" strike="noStrike" cap="none">
                <a:solidFill>
                  <a:srgbClr val="000000"/>
                </a:solidFill>
                <a:latin typeface="Calibri"/>
                <a:ea typeface="Calibri"/>
                <a:cs typeface="Calibri"/>
                <a:sym typeface="Calibri"/>
              </a:rPr>
              <a:t>Figure S5. Relative expression profiles of PSI genes in cells grown under LL conditions.</a:t>
            </a:r>
            <a:r>
              <a:rPr lang="en-US" sz="1200" b="0" i="0" u="none" strike="noStrike" cap="none">
                <a:solidFill>
                  <a:srgbClr val="000000"/>
                </a:solidFill>
                <a:latin typeface="Calibri"/>
                <a:ea typeface="Calibri"/>
                <a:cs typeface="Calibri"/>
                <a:sym typeface="Calibri"/>
              </a:rPr>
              <a:t> WT, </a:t>
            </a:r>
            <a:r>
              <a:rPr lang="en-US" sz="1200" b="0" i="1" u="none" strike="noStrike" cap="none">
                <a:solidFill>
                  <a:srgbClr val="000000"/>
                </a:solidFill>
                <a:latin typeface="Calibri"/>
                <a:ea typeface="Calibri"/>
                <a:cs typeface="Calibri"/>
                <a:sym typeface="Calibri"/>
              </a:rPr>
              <a:t>rmt2-1</a:t>
            </a:r>
            <a:r>
              <a:rPr lang="en-US" sz="1200" b="0" i="0" u="none" strike="noStrike" cap="none">
                <a:solidFill>
                  <a:srgbClr val="000000"/>
                </a:solidFill>
                <a:latin typeface="Calibri"/>
                <a:ea typeface="Calibri"/>
                <a:cs typeface="Calibri"/>
                <a:sym typeface="Calibri"/>
              </a:rPr>
              <a:t>, </a:t>
            </a:r>
            <a:r>
              <a:rPr lang="en-US" sz="1200" b="0" i="1" u="none" strike="noStrike" cap="none">
                <a:solidFill>
                  <a:srgbClr val="000000"/>
                </a:solidFill>
                <a:latin typeface="Calibri"/>
                <a:ea typeface="Calibri"/>
                <a:cs typeface="Calibri"/>
                <a:sym typeface="Calibri"/>
              </a:rPr>
              <a:t>rmt2-2</a:t>
            </a:r>
            <a:r>
              <a:rPr lang="en-US" sz="1200" b="0" i="0" u="none" strike="noStrike" cap="none">
                <a:solidFill>
                  <a:srgbClr val="000000"/>
                </a:solidFill>
                <a:latin typeface="Calibri"/>
                <a:ea typeface="Calibri"/>
                <a:cs typeface="Calibri"/>
                <a:sym typeface="Calibri"/>
              </a:rPr>
              <a:t>, and </a:t>
            </a:r>
            <a:r>
              <a:rPr lang="en-US" sz="1200" b="0" i="1" u="none" strike="noStrike" cap="none">
                <a:solidFill>
                  <a:srgbClr val="000000"/>
                </a:solidFill>
                <a:latin typeface="Calibri"/>
                <a:ea typeface="Calibri"/>
                <a:cs typeface="Calibri"/>
                <a:sym typeface="Calibri"/>
              </a:rPr>
              <a:t>rmt2-2</a:t>
            </a:r>
            <a:r>
              <a:rPr lang="en-US" sz="1200" b="0" i="0" u="none" strike="noStrike" cap="none">
                <a:solidFill>
                  <a:srgbClr val="000000"/>
                </a:solidFill>
                <a:latin typeface="Calibri"/>
                <a:ea typeface="Calibri"/>
                <a:cs typeface="Calibri"/>
                <a:sym typeface="Calibri"/>
              </a:rPr>
              <a:t>(RMT2-VENUS) #35 cells were grown under LL and mixotrophic conditions (TAP medium; 30 </a:t>
            </a:r>
            <a:r>
              <a:rPr lang="en-US" sz="1200" b="0" i="0" u="none" strike="noStrike" cap="none">
                <a:solidFill>
                  <a:schemeClr val="dk1"/>
                </a:solidFill>
                <a:latin typeface="Calibri"/>
                <a:ea typeface="Calibri"/>
                <a:cs typeface="Calibri"/>
                <a:sym typeface="Calibri"/>
              </a:rPr>
              <a:t>µmol photons m</a:t>
            </a:r>
            <a:r>
              <a:rPr lang="en-US" sz="1200" b="0" i="0" u="none" strike="noStrike" cap="none" baseline="30000">
                <a:solidFill>
                  <a:schemeClr val="dk1"/>
                </a:solidFill>
                <a:latin typeface="Calibri"/>
                <a:ea typeface="Calibri"/>
                <a:cs typeface="Calibri"/>
                <a:sym typeface="Calibri"/>
              </a:rPr>
              <a:t>-2</a:t>
            </a:r>
            <a:r>
              <a:rPr lang="en-US" sz="1200" b="0" i="0" u="none" strike="noStrike" cap="none">
                <a:solidFill>
                  <a:schemeClr val="dk1"/>
                </a:solidFill>
                <a:latin typeface="Calibri"/>
                <a:ea typeface="Calibri"/>
                <a:cs typeface="Calibri"/>
                <a:sym typeface="Calibri"/>
              </a:rPr>
              <a:t> s</a:t>
            </a:r>
            <a:r>
              <a:rPr lang="en-US" sz="1200" b="0" i="0" u="none" strike="noStrike" cap="none" baseline="30000">
                <a:solidFill>
                  <a:schemeClr val="dk1"/>
                </a:solidFill>
                <a:latin typeface="Calibri"/>
                <a:ea typeface="Calibri"/>
                <a:cs typeface="Calibri"/>
                <a:sym typeface="Calibri"/>
              </a:rPr>
              <a:t>-1</a:t>
            </a:r>
            <a:r>
              <a:rPr lang="en-US" sz="1200" b="0" i="0" u="none" strike="noStrike" cap="none">
                <a:solidFill>
                  <a:srgbClr val="000000"/>
                </a:solidFill>
                <a:latin typeface="Calibri"/>
                <a:ea typeface="Calibri"/>
                <a:cs typeface="Calibri"/>
                <a:sym typeface="Calibri"/>
              </a:rPr>
              <a:t>). The mRNA levels of PSI subunits (</a:t>
            </a:r>
            <a:r>
              <a:rPr lang="en-US" sz="1200" b="0" i="1" u="none" strike="noStrike" cap="none">
                <a:solidFill>
                  <a:srgbClr val="000000"/>
                </a:solidFill>
                <a:latin typeface="Calibri"/>
                <a:ea typeface="Calibri"/>
                <a:cs typeface="Calibri"/>
                <a:sym typeface="Calibri"/>
              </a:rPr>
              <a:t>PsaA</a:t>
            </a:r>
            <a:r>
              <a:rPr lang="en-US" sz="1200" b="0" i="0" u="none" strike="noStrike" cap="none">
                <a:solidFill>
                  <a:srgbClr val="000000"/>
                </a:solidFill>
                <a:latin typeface="Calibri"/>
                <a:ea typeface="Calibri"/>
                <a:cs typeface="Calibri"/>
                <a:sym typeface="Calibri"/>
              </a:rPr>
              <a:t>, </a:t>
            </a:r>
            <a:r>
              <a:rPr lang="en-US" sz="1200" b="0" i="1" u="none" strike="noStrike" cap="none">
                <a:solidFill>
                  <a:srgbClr val="000000"/>
                </a:solidFill>
                <a:latin typeface="Calibri"/>
                <a:ea typeface="Calibri"/>
                <a:cs typeface="Calibri"/>
                <a:sym typeface="Calibri"/>
              </a:rPr>
              <a:t>PsaB</a:t>
            </a:r>
            <a:r>
              <a:rPr lang="en-US" sz="1200" b="0" i="0" u="none" strike="noStrike" cap="none">
                <a:solidFill>
                  <a:srgbClr val="000000"/>
                </a:solidFill>
                <a:latin typeface="Calibri"/>
                <a:ea typeface="Calibri"/>
                <a:cs typeface="Calibri"/>
                <a:sym typeface="Calibri"/>
              </a:rPr>
              <a:t>, </a:t>
            </a:r>
            <a:r>
              <a:rPr lang="en-US" sz="1200" b="0" i="1" u="none" strike="noStrike" cap="none">
                <a:solidFill>
                  <a:srgbClr val="000000"/>
                </a:solidFill>
                <a:latin typeface="Calibri"/>
                <a:ea typeface="Calibri"/>
                <a:cs typeface="Calibri"/>
                <a:sym typeface="Calibri"/>
              </a:rPr>
              <a:t>PSAD</a:t>
            </a:r>
            <a:r>
              <a:rPr lang="en-US" sz="1200" b="0" i="0" u="none" strike="noStrike" cap="none">
                <a:solidFill>
                  <a:srgbClr val="000000"/>
                </a:solidFill>
                <a:latin typeface="Calibri"/>
                <a:ea typeface="Calibri"/>
                <a:cs typeface="Calibri"/>
                <a:sym typeface="Calibri"/>
              </a:rPr>
              <a:t> and </a:t>
            </a:r>
            <a:r>
              <a:rPr lang="en-US" sz="1200" b="0" i="1" u="none" strike="noStrike" cap="none">
                <a:solidFill>
                  <a:srgbClr val="000000"/>
                </a:solidFill>
                <a:latin typeface="Calibri"/>
                <a:ea typeface="Calibri"/>
                <a:cs typeface="Calibri"/>
                <a:sym typeface="Calibri"/>
              </a:rPr>
              <a:t>PSAE</a:t>
            </a:r>
            <a:r>
              <a:rPr lang="en-US" sz="1200" b="0" i="0" u="none" strike="noStrike" cap="none">
                <a:solidFill>
                  <a:srgbClr val="000000"/>
                </a:solidFill>
                <a:latin typeface="Calibri"/>
                <a:ea typeface="Calibri"/>
                <a:cs typeface="Calibri"/>
                <a:sym typeface="Calibri"/>
              </a:rPr>
              <a:t>) and </a:t>
            </a:r>
            <a:r>
              <a:rPr lang="en-US" sz="1200" b="0" i="1" u="none" strike="noStrike" cap="none">
                <a:solidFill>
                  <a:srgbClr val="000000"/>
                </a:solidFill>
                <a:latin typeface="Calibri"/>
                <a:ea typeface="Calibri"/>
                <a:cs typeface="Calibri"/>
                <a:sym typeface="Calibri"/>
              </a:rPr>
              <a:t>RMT2</a:t>
            </a:r>
            <a:r>
              <a:rPr lang="en-US" sz="1200" b="0" i="0" u="none" strike="noStrike" cap="none">
                <a:solidFill>
                  <a:srgbClr val="000000"/>
                </a:solidFill>
                <a:latin typeface="Calibri"/>
                <a:ea typeface="Calibri"/>
                <a:cs typeface="Calibri"/>
                <a:sym typeface="Calibri"/>
              </a:rPr>
              <a:t> were determined using qRT-PCR from samples extracted at the mid-exponential growth phase. The values were normalized to CBLP (control gene) expression and to the mRNA levels of WT. Values are a mean of three biological replicates, and error bars represent standard deviations.</a:t>
            </a:r>
            <a:endParaRPr sz="1200" b="0" i="0" u="none" strike="noStrike" cap="none">
              <a:solidFill>
                <a:schemeClr val="dk1"/>
              </a:solidFill>
              <a:latin typeface="Calibri"/>
              <a:ea typeface="Calibri"/>
              <a:cs typeface="Calibri"/>
              <a:sym typeface="Calibri"/>
            </a:endParaRPr>
          </a:p>
        </p:txBody>
      </p:sp>
      <p:graphicFrame>
        <p:nvGraphicFramePr>
          <p:cNvPr id="469" name="Google Shape;469;p6"/>
          <p:cNvGraphicFramePr/>
          <p:nvPr/>
        </p:nvGraphicFramePr>
        <p:xfrm>
          <a:off x="1200107" y="1017438"/>
          <a:ext cx="5592775" cy="2779486"/>
        </p:xfrm>
        <a:graphic>
          <a:graphicData uri="http://schemas.openxmlformats.org/drawingml/2006/chart">
            <c:chart xmlns:c="http://schemas.openxmlformats.org/drawingml/2006/chart" xmlns:r="http://schemas.openxmlformats.org/officeDocument/2006/relationships" r:id="rId3"/>
          </a:graphicData>
        </a:graphic>
      </p:graphicFrame>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474"/>
        <p:cNvGrpSpPr/>
        <p:nvPr/>
      </p:nvGrpSpPr>
      <p:grpSpPr>
        <a:xfrm>
          <a:off x="0" y="0"/>
          <a:ext cx="0" cy="0"/>
          <a:chOff x="0" y="0"/>
          <a:chExt cx="0" cy="0"/>
        </a:xfrm>
      </p:grpSpPr>
      <p:sp>
        <p:nvSpPr>
          <p:cNvPr id="475" name="Google Shape;475;p7"/>
          <p:cNvSpPr txBox="1"/>
          <p:nvPr/>
        </p:nvSpPr>
        <p:spPr>
          <a:xfrm>
            <a:off x="111347" y="151182"/>
            <a:ext cx="1088760"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Times New Roman"/>
                <a:ea typeface="Times New Roman"/>
                <a:cs typeface="Times New Roman"/>
                <a:sym typeface="Times New Roman"/>
              </a:rPr>
              <a:t>Figure S6</a:t>
            </a:r>
            <a:endParaRPr sz="1400" b="0" i="0" u="none" strike="noStrike" cap="none">
              <a:solidFill>
                <a:srgbClr val="000000"/>
              </a:solidFill>
              <a:latin typeface="Arial"/>
              <a:ea typeface="Arial"/>
              <a:cs typeface="Arial"/>
              <a:sym typeface="Arial"/>
            </a:endParaRPr>
          </a:p>
        </p:txBody>
      </p:sp>
      <p:sp>
        <p:nvSpPr>
          <p:cNvPr id="476" name="Google Shape;476;p7"/>
          <p:cNvSpPr txBox="1"/>
          <p:nvPr/>
        </p:nvSpPr>
        <p:spPr>
          <a:xfrm>
            <a:off x="242738" y="8579005"/>
            <a:ext cx="7291200" cy="830956"/>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000000"/>
              </a:buClr>
              <a:buSzPts val="1600"/>
              <a:buFont typeface="Arial"/>
              <a:buNone/>
            </a:pPr>
            <a:r>
              <a:rPr lang="en-US" sz="1200" b="1" i="0" u="none" strike="noStrike" cap="none">
                <a:solidFill>
                  <a:schemeClr val="dk1"/>
                </a:solidFill>
                <a:latin typeface="Calibri"/>
                <a:ea typeface="Calibri"/>
                <a:cs typeface="Calibri"/>
                <a:sym typeface="Calibri"/>
              </a:rPr>
              <a:t>Figure S6. PSI turnover under LL conditions in presence of translation inhibitors. </a:t>
            </a:r>
            <a:r>
              <a:rPr lang="en-US" sz="1200" b="0" i="0" u="none" strike="noStrike" cap="none">
                <a:solidFill>
                  <a:schemeClr val="dk1"/>
                </a:solidFill>
                <a:latin typeface="Calibri"/>
                <a:ea typeface="Calibri"/>
                <a:cs typeface="Calibri"/>
                <a:sym typeface="Calibri"/>
              </a:rPr>
              <a:t>Cells were diluted to 5 µg of chlorophyll per mL and incubated in presence of chloramphenicol (CAP, 250 µg mL</a:t>
            </a:r>
            <a:r>
              <a:rPr lang="en-US" sz="1200" b="0" i="0" u="none" strike="noStrike" cap="none" baseline="30000">
                <a:solidFill>
                  <a:schemeClr val="dk1"/>
                </a:solidFill>
                <a:latin typeface="Calibri"/>
                <a:ea typeface="Calibri"/>
                <a:cs typeface="Calibri"/>
                <a:sym typeface="Calibri"/>
              </a:rPr>
              <a:t>-1</a:t>
            </a:r>
            <a:r>
              <a:rPr lang="en-US" sz="1200" b="0" i="0" u="none" strike="noStrike" cap="none">
                <a:solidFill>
                  <a:schemeClr val="dk1"/>
                </a:solidFill>
                <a:latin typeface="Calibri"/>
                <a:ea typeface="Calibri"/>
                <a:cs typeface="Calibri"/>
                <a:sym typeface="Calibri"/>
              </a:rPr>
              <a:t>) and cycloheximide (CHX, 10 µg mL</a:t>
            </a:r>
            <a:r>
              <a:rPr lang="en-US" sz="1200" b="0" i="0" u="none" strike="noStrike" cap="none" baseline="30000">
                <a:solidFill>
                  <a:schemeClr val="dk1"/>
                </a:solidFill>
                <a:latin typeface="Calibri"/>
                <a:ea typeface="Calibri"/>
                <a:cs typeface="Calibri"/>
                <a:sym typeface="Calibri"/>
              </a:rPr>
              <a:t>-1</a:t>
            </a:r>
            <a:r>
              <a:rPr lang="en-US" sz="1200" b="0" i="0" u="none" strike="noStrike" cap="none">
                <a:solidFill>
                  <a:schemeClr val="dk1"/>
                </a:solidFill>
                <a:latin typeface="Calibri"/>
                <a:ea typeface="Calibri"/>
                <a:cs typeface="Calibri"/>
                <a:sym typeface="Calibri"/>
              </a:rPr>
              <a:t>). Proteins were resolved by SDS/PAGE and detected by immunoblot analyses using antibodies raised against PsaA, PsbA and Tubulin. </a:t>
            </a:r>
            <a:endParaRPr sz="1200" b="0" i="0" u="none" strike="noStrike" cap="none">
              <a:solidFill>
                <a:srgbClr val="000000"/>
              </a:solidFill>
              <a:latin typeface="Calibri"/>
              <a:ea typeface="Calibri"/>
              <a:cs typeface="Calibri"/>
              <a:sym typeface="Calibri"/>
            </a:endParaRPr>
          </a:p>
        </p:txBody>
      </p:sp>
      <p:grpSp>
        <p:nvGrpSpPr>
          <p:cNvPr id="477" name="Google Shape;477;p7"/>
          <p:cNvGrpSpPr/>
          <p:nvPr/>
        </p:nvGrpSpPr>
        <p:grpSpPr>
          <a:xfrm>
            <a:off x="459860" y="1968910"/>
            <a:ext cx="7016619" cy="4792958"/>
            <a:chOff x="459860" y="1865430"/>
            <a:chExt cx="7164222" cy="4896438"/>
          </a:xfrm>
        </p:grpSpPr>
        <p:cxnSp>
          <p:nvCxnSpPr>
            <p:cNvPr id="478" name="Google Shape;478;p7"/>
            <p:cNvCxnSpPr/>
            <p:nvPr/>
          </p:nvCxnSpPr>
          <p:spPr>
            <a:xfrm>
              <a:off x="576053" y="2499111"/>
              <a:ext cx="1368000" cy="0"/>
            </a:xfrm>
            <a:prstGeom prst="straightConnector1">
              <a:avLst/>
            </a:prstGeom>
            <a:noFill/>
            <a:ln w="28575" cap="flat" cmpd="sng">
              <a:solidFill>
                <a:schemeClr val="dk1"/>
              </a:solidFill>
              <a:prstDash val="solid"/>
              <a:miter lim="800000"/>
              <a:headEnd type="none" w="sm" len="sm"/>
              <a:tailEnd type="none" w="sm" len="sm"/>
            </a:ln>
          </p:spPr>
        </p:cxnSp>
        <p:sp>
          <p:nvSpPr>
            <p:cNvPr id="479" name="Google Shape;479;p7"/>
            <p:cNvSpPr txBox="1"/>
            <p:nvPr/>
          </p:nvSpPr>
          <p:spPr>
            <a:xfrm>
              <a:off x="615688" y="2465244"/>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0</a:t>
              </a:r>
              <a:endParaRPr sz="1400" b="0" i="0" u="none" strike="noStrike" cap="none">
                <a:solidFill>
                  <a:srgbClr val="000000"/>
                </a:solidFill>
                <a:latin typeface="Calibri"/>
                <a:ea typeface="Calibri"/>
                <a:cs typeface="Calibri"/>
                <a:sym typeface="Calibri"/>
              </a:endParaRPr>
            </a:p>
          </p:txBody>
        </p:sp>
        <p:sp>
          <p:nvSpPr>
            <p:cNvPr id="480" name="Google Shape;480;p7"/>
            <p:cNvSpPr txBox="1"/>
            <p:nvPr/>
          </p:nvSpPr>
          <p:spPr>
            <a:xfrm>
              <a:off x="1109210" y="2465244"/>
              <a:ext cx="30168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Times New Roman"/>
                  <a:ea typeface="Times New Roman"/>
                  <a:cs typeface="Times New Roman"/>
                  <a:sym typeface="Times New Roman"/>
                </a:rPr>
                <a:t>6</a:t>
              </a:r>
              <a:endParaRPr sz="1400" b="0" i="0" u="none" strike="noStrike" cap="none">
                <a:solidFill>
                  <a:srgbClr val="000000"/>
                </a:solidFill>
                <a:latin typeface="Arial"/>
                <a:ea typeface="Arial"/>
                <a:cs typeface="Arial"/>
                <a:sym typeface="Arial"/>
              </a:endParaRPr>
            </a:p>
          </p:txBody>
        </p:sp>
        <p:sp>
          <p:nvSpPr>
            <p:cNvPr id="481" name="Google Shape;481;p7"/>
            <p:cNvSpPr txBox="1"/>
            <p:nvPr/>
          </p:nvSpPr>
          <p:spPr>
            <a:xfrm>
              <a:off x="1546150" y="2465238"/>
              <a:ext cx="5037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24</a:t>
              </a:r>
              <a:endParaRPr sz="1400" b="0" i="0" u="none" strike="noStrike" cap="none">
                <a:solidFill>
                  <a:srgbClr val="000000"/>
                </a:solidFill>
                <a:latin typeface="Calibri"/>
                <a:ea typeface="Calibri"/>
                <a:cs typeface="Calibri"/>
                <a:sym typeface="Calibri"/>
              </a:endParaRPr>
            </a:p>
          </p:txBody>
        </p:sp>
        <p:cxnSp>
          <p:nvCxnSpPr>
            <p:cNvPr id="482" name="Google Shape;482;p7"/>
            <p:cNvCxnSpPr/>
            <p:nvPr/>
          </p:nvCxnSpPr>
          <p:spPr>
            <a:xfrm>
              <a:off x="459863" y="2163511"/>
              <a:ext cx="3060000" cy="0"/>
            </a:xfrm>
            <a:prstGeom prst="straightConnector1">
              <a:avLst/>
            </a:prstGeom>
            <a:noFill/>
            <a:ln w="28575" cap="flat" cmpd="sng">
              <a:solidFill>
                <a:schemeClr val="dk1"/>
              </a:solidFill>
              <a:prstDash val="solid"/>
              <a:miter lim="800000"/>
              <a:headEnd type="none" w="sm" len="sm"/>
              <a:tailEnd type="none" w="sm" len="sm"/>
            </a:ln>
          </p:spPr>
        </p:cxnSp>
        <p:pic>
          <p:nvPicPr>
            <p:cNvPr id="483" name="Google Shape;483;p7" descr="A black and white image of a rectangular object&#10;&#10;Description automatically generated with medium confidence"/>
            <p:cNvPicPr preferRelativeResize="0"/>
            <p:nvPr/>
          </p:nvPicPr>
          <p:blipFill rotWithShape="1">
            <a:blip r:embed="rId3">
              <a:alphaModFix/>
            </a:blip>
            <a:srcRect l="21197" t="38463" r="45816" b="56446"/>
            <a:stretch/>
          </p:blipFill>
          <p:spPr>
            <a:xfrm flipH="1">
              <a:off x="3769846" y="2799652"/>
              <a:ext cx="3032126" cy="382772"/>
            </a:xfrm>
            <a:prstGeom prst="rect">
              <a:avLst/>
            </a:prstGeom>
            <a:noFill/>
            <a:ln w="28575" cap="flat" cmpd="sng">
              <a:solidFill>
                <a:schemeClr val="dk1"/>
              </a:solidFill>
              <a:prstDash val="solid"/>
              <a:round/>
              <a:headEnd type="none" w="sm" len="sm"/>
              <a:tailEnd type="none" w="sm" len="sm"/>
            </a:ln>
          </p:spPr>
        </p:pic>
        <p:pic>
          <p:nvPicPr>
            <p:cNvPr id="484" name="Google Shape;484;p7" descr="A close-up of a test&#10;&#10;Description automatically generated"/>
            <p:cNvPicPr preferRelativeResize="0"/>
            <p:nvPr/>
          </p:nvPicPr>
          <p:blipFill rotWithShape="1">
            <a:blip r:embed="rId4">
              <a:alphaModFix/>
            </a:blip>
            <a:srcRect l="17630" t="79179" r="47763" b="15483"/>
            <a:stretch/>
          </p:blipFill>
          <p:spPr>
            <a:xfrm flipH="1">
              <a:off x="2095355" y="5297302"/>
              <a:ext cx="3032126" cy="382772"/>
            </a:xfrm>
            <a:prstGeom prst="rect">
              <a:avLst/>
            </a:prstGeom>
            <a:noFill/>
            <a:ln w="28575" cap="flat" cmpd="sng">
              <a:solidFill>
                <a:schemeClr val="dk1"/>
              </a:solidFill>
              <a:prstDash val="solid"/>
              <a:round/>
              <a:headEnd type="none" w="sm" len="sm"/>
              <a:tailEnd type="none" w="sm" len="sm"/>
            </a:ln>
          </p:spPr>
        </p:pic>
        <p:pic>
          <p:nvPicPr>
            <p:cNvPr id="485" name="Google Shape;485;p7" descr="A close-up of a test&#10;&#10;Description automatically generated"/>
            <p:cNvPicPr preferRelativeResize="0"/>
            <p:nvPr/>
          </p:nvPicPr>
          <p:blipFill rotWithShape="1">
            <a:blip r:embed="rId5">
              <a:alphaModFix/>
            </a:blip>
            <a:srcRect l="18198" t="47656" r="47515" b="47051"/>
            <a:stretch/>
          </p:blipFill>
          <p:spPr>
            <a:xfrm flipH="1">
              <a:off x="459860" y="2799652"/>
              <a:ext cx="3032125" cy="382772"/>
            </a:xfrm>
            <a:prstGeom prst="rect">
              <a:avLst/>
            </a:prstGeom>
            <a:noFill/>
            <a:ln w="28575" cap="flat" cmpd="sng">
              <a:solidFill>
                <a:schemeClr val="dk1"/>
              </a:solidFill>
              <a:prstDash val="solid"/>
              <a:round/>
              <a:headEnd type="none" w="sm" len="sm"/>
              <a:tailEnd type="none" w="sm" len="sm"/>
            </a:ln>
          </p:spPr>
        </p:pic>
        <p:sp>
          <p:nvSpPr>
            <p:cNvPr id="486" name="Google Shape;486;p7"/>
            <p:cNvSpPr txBox="1"/>
            <p:nvPr/>
          </p:nvSpPr>
          <p:spPr>
            <a:xfrm>
              <a:off x="2088990" y="2465244"/>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0</a:t>
              </a:r>
              <a:endParaRPr sz="1400" b="0" i="0" u="none" strike="noStrike" cap="none">
                <a:solidFill>
                  <a:srgbClr val="000000"/>
                </a:solidFill>
                <a:latin typeface="Calibri"/>
                <a:ea typeface="Calibri"/>
                <a:cs typeface="Calibri"/>
                <a:sym typeface="Calibri"/>
              </a:endParaRPr>
            </a:p>
          </p:txBody>
        </p:sp>
        <p:sp>
          <p:nvSpPr>
            <p:cNvPr id="487" name="Google Shape;487;p7"/>
            <p:cNvSpPr txBox="1"/>
            <p:nvPr/>
          </p:nvSpPr>
          <p:spPr>
            <a:xfrm>
              <a:off x="2582512" y="2465244"/>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6</a:t>
              </a:r>
              <a:endParaRPr sz="1400" b="0" i="0" u="none" strike="noStrike" cap="none">
                <a:solidFill>
                  <a:srgbClr val="000000"/>
                </a:solidFill>
                <a:latin typeface="Calibri"/>
                <a:ea typeface="Calibri"/>
                <a:cs typeface="Calibri"/>
                <a:sym typeface="Calibri"/>
              </a:endParaRPr>
            </a:p>
          </p:txBody>
        </p:sp>
        <p:sp>
          <p:nvSpPr>
            <p:cNvPr id="488" name="Google Shape;488;p7"/>
            <p:cNvSpPr txBox="1"/>
            <p:nvPr/>
          </p:nvSpPr>
          <p:spPr>
            <a:xfrm>
              <a:off x="3019450" y="2465238"/>
              <a:ext cx="5037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24</a:t>
              </a:r>
              <a:endParaRPr sz="1400" b="0" i="0" u="none" strike="noStrike" cap="none">
                <a:solidFill>
                  <a:srgbClr val="000000"/>
                </a:solidFill>
                <a:latin typeface="Calibri"/>
                <a:ea typeface="Calibri"/>
                <a:cs typeface="Calibri"/>
                <a:sym typeface="Calibri"/>
              </a:endParaRPr>
            </a:p>
          </p:txBody>
        </p:sp>
        <p:cxnSp>
          <p:nvCxnSpPr>
            <p:cNvPr id="489" name="Google Shape;489;p7"/>
            <p:cNvCxnSpPr/>
            <p:nvPr/>
          </p:nvCxnSpPr>
          <p:spPr>
            <a:xfrm>
              <a:off x="2082866" y="2499111"/>
              <a:ext cx="1368000" cy="0"/>
            </a:xfrm>
            <a:prstGeom prst="straightConnector1">
              <a:avLst/>
            </a:prstGeom>
            <a:noFill/>
            <a:ln w="28575" cap="flat" cmpd="sng">
              <a:solidFill>
                <a:schemeClr val="dk1"/>
              </a:solidFill>
              <a:prstDash val="solid"/>
              <a:miter lim="800000"/>
              <a:headEnd type="none" w="sm" len="sm"/>
              <a:tailEnd type="none" w="sm" len="sm"/>
            </a:ln>
          </p:spPr>
        </p:cxnSp>
        <p:sp>
          <p:nvSpPr>
            <p:cNvPr id="490" name="Google Shape;490;p7"/>
            <p:cNvSpPr txBox="1"/>
            <p:nvPr/>
          </p:nvSpPr>
          <p:spPr>
            <a:xfrm>
              <a:off x="853531" y="2188194"/>
              <a:ext cx="870274" cy="345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0" i="0" u="none" strike="noStrike" cap="none">
                  <a:solidFill>
                    <a:schemeClr val="dk1"/>
                  </a:solidFill>
                  <a:latin typeface="Calibri"/>
                  <a:ea typeface="Calibri"/>
                  <a:cs typeface="Calibri"/>
                  <a:sym typeface="Calibri"/>
                </a:rPr>
                <a:t>Control</a:t>
              </a:r>
              <a:endParaRPr sz="1400" b="0" i="0" u="none" strike="noStrike" cap="none">
                <a:solidFill>
                  <a:srgbClr val="000000"/>
                </a:solidFill>
                <a:latin typeface="Calibri"/>
                <a:ea typeface="Calibri"/>
                <a:cs typeface="Calibri"/>
                <a:sym typeface="Calibri"/>
              </a:endParaRPr>
            </a:p>
          </p:txBody>
        </p:sp>
        <p:sp>
          <p:nvSpPr>
            <p:cNvPr id="491" name="Google Shape;491;p7"/>
            <p:cNvSpPr txBox="1"/>
            <p:nvPr/>
          </p:nvSpPr>
          <p:spPr>
            <a:xfrm>
              <a:off x="2122907" y="2188194"/>
              <a:ext cx="1287900" cy="345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0" i="0" u="none" strike="noStrike" cap="none">
                  <a:solidFill>
                    <a:schemeClr val="dk1"/>
                  </a:solidFill>
                  <a:latin typeface="Calibri"/>
                  <a:ea typeface="Calibri"/>
                  <a:cs typeface="Calibri"/>
                  <a:sym typeface="Calibri"/>
                </a:rPr>
                <a:t>+CAP +CHX</a:t>
              </a:r>
              <a:endParaRPr sz="1400" b="0" i="0" u="none" strike="noStrike" cap="none">
                <a:solidFill>
                  <a:srgbClr val="000000"/>
                </a:solidFill>
                <a:latin typeface="Calibri"/>
                <a:ea typeface="Calibri"/>
                <a:cs typeface="Calibri"/>
                <a:sym typeface="Calibri"/>
              </a:endParaRPr>
            </a:p>
          </p:txBody>
        </p:sp>
        <p:cxnSp>
          <p:nvCxnSpPr>
            <p:cNvPr id="492" name="Google Shape;492;p7"/>
            <p:cNvCxnSpPr/>
            <p:nvPr/>
          </p:nvCxnSpPr>
          <p:spPr>
            <a:xfrm>
              <a:off x="2171034" y="4999813"/>
              <a:ext cx="1368000" cy="0"/>
            </a:xfrm>
            <a:prstGeom prst="straightConnector1">
              <a:avLst/>
            </a:prstGeom>
            <a:noFill/>
            <a:ln w="28575" cap="flat" cmpd="sng">
              <a:solidFill>
                <a:schemeClr val="dk1"/>
              </a:solidFill>
              <a:prstDash val="solid"/>
              <a:miter lim="800000"/>
              <a:headEnd type="none" w="sm" len="sm"/>
              <a:tailEnd type="none" w="sm" len="sm"/>
            </a:ln>
          </p:spPr>
        </p:cxnSp>
        <p:sp>
          <p:nvSpPr>
            <p:cNvPr id="493" name="Google Shape;493;p7"/>
            <p:cNvSpPr txBox="1"/>
            <p:nvPr/>
          </p:nvSpPr>
          <p:spPr>
            <a:xfrm>
              <a:off x="2210669" y="4965946"/>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0</a:t>
              </a:r>
              <a:endParaRPr sz="1400" b="0" i="0" u="none" strike="noStrike" cap="none">
                <a:solidFill>
                  <a:srgbClr val="000000"/>
                </a:solidFill>
                <a:latin typeface="Calibri"/>
                <a:ea typeface="Calibri"/>
                <a:cs typeface="Calibri"/>
                <a:sym typeface="Calibri"/>
              </a:endParaRPr>
            </a:p>
          </p:txBody>
        </p:sp>
        <p:sp>
          <p:nvSpPr>
            <p:cNvPr id="494" name="Google Shape;494;p7"/>
            <p:cNvSpPr txBox="1"/>
            <p:nvPr/>
          </p:nvSpPr>
          <p:spPr>
            <a:xfrm>
              <a:off x="2704191" y="4965946"/>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6</a:t>
              </a:r>
              <a:endParaRPr sz="1400" b="0" i="0" u="none" strike="noStrike" cap="none">
                <a:solidFill>
                  <a:srgbClr val="000000"/>
                </a:solidFill>
                <a:latin typeface="Calibri"/>
                <a:ea typeface="Calibri"/>
                <a:cs typeface="Calibri"/>
                <a:sym typeface="Calibri"/>
              </a:endParaRPr>
            </a:p>
          </p:txBody>
        </p:sp>
        <p:sp>
          <p:nvSpPr>
            <p:cNvPr id="495" name="Google Shape;495;p7"/>
            <p:cNvSpPr txBox="1"/>
            <p:nvPr/>
          </p:nvSpPr>
          <p:spPr>
            <a:xfrm>
              <a:off x="3141132" y="4965953"/>
              <a:ext cx="5484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24</a:t>
              </a:r>
              <a:endParaRPr sz="1400" b="0" i="0" u="none" strike="noStrike" cap="none">
                <a:solidFill>
                  <a:srgbClr val="000000"/>
                </a:solidFill>
                <a:latin typeface="Calibri"/>
                <a:ea typeface="Calibri"/>
                <a:cs typeface="Calibri"/>
                <a:sym typeface="Calibri"/>
              </a:endParaRPr>
            </a:p>
          </p:txBody>
        </p:sp>
        <p:sp>
          <p:nvSpPr>
            <p:cNvPr id="496" name="Google Shape;496;p7"/>
            <p:cNvSpPr txBox="1"/>
            <p:nvPr/>
          </p:nvSpPr>
          <p:spPr>
            <a:xfrm>
              <a:off x="3683971" y="4965946"/>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0</a:t>
              </a:r>
              <a:endParaRPr sz="1400" b="0" i="0" u="none" strike="noStrike" cap="none">
                <a:solidFill>
                  <a:srgbClr val="000000"/>
                </a:solidFill>
                <a:latin typeface="Calibri"/>
                <a:ea typeface="Calibri"/>
                <a:cs typeface="Calibri"/>
                <a:sym typeface="Calibri"/>
              </a:endParaRPr>
            </a:p>
          </p:txBody>
        </p:sp>
        <p:sp>
          <p:nvSpPr>
            <p:cNvPr id="497" name="Google Shape;497;p7"/>
            <p:cNvSpPr txBox="1"/>
            <p:nvPr/>
          </p:nvSpPr>
          <p:spPr>
            <a:xfrm>
              <a:off x="4177493" y="4965946"/>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6</a:t>
              </a:r>
              <a:endParaRPr sz="1400" b="0" i="0" u="none" strike="noStrike" cap="none">
                <a:solidFill>
                  <a:srgbClr val="000000"/>
                </a:solidFill>
                <a:latin typeface="Calibri"/>
                <a:ea typeface="Calibri"/>
                <a:cs typeface="Calibri"/>
                <a:sym typeface="Calibri"/>
              </a:endParaRPr>
            </a:p>
          </p:txBody>
        </p:sp>
        <p:sp>
          <p:nvSpPr>
            <p:cNvPr id="498" name="Google Shape;498;p7"/>
            <p:cNvSpPr txBox="1"/>
            <p:nvPr/>
          </p:nvSpPr>
          <p:spPr>
            <a:xfrm>
              <a:off x="4614431" y="4965953"/>
              <a:ext cx="5037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24</a:t>
              </a:r>
              <a:endParaRPr sz="1400" b="0" i="0" u="none" strike="noStrike" cap="none">
                <a:solidFill>
                  <a:srgbClr val="000000"/>
                </a:solidFill>
                <a:latin typeface="Calibri"/>
                <a:ea typeface="Calibri"/>
                <a:cs typeface="Calibri"/>
                <a:sym typeface="Calibri"/>
              </a:endParaRPr>
            </a:p>
          </p:txBody>
        </p:sp>
        <p:cxnSp>
          <p:nvCxnSpPr>
            <p:cNvPr id="499" name="Google Shape;499;p7"/>
            <p:cNvCxnSpPr/>
            <p:nvPr/>
          </p:nvCxnSpPr>
          <p:spPr>
            <a:xfrm>
              <a:off x="3677847" y="4999813"/>
              <a:ext cx="1368000" cy="0"/>
            </a:xfrm>
            <a:prstGeom prst="straightConnector1">
              <a:avLst/>
            </a:prstGeom>
            <a:noFill/>
            <a:ln w="28575" cap="flat" cmpd="sng">
              <a:solidFill>
                <a:schemeClr val="dk1"/>
              </a:solidFill>
              <a:prstDash val="solid"/>
              <a:miter lim="800000"/>
              <a:headEnd type="none" w="sm" len="sm"/>
              <a:tailEnd type="none" w="sm" len="sm"/>
            </a:ln>
          </p:spPr>
        </p:cxnSp>
        <p:sp>
          <p:nvSpPr>
            <p:cNvPr id="500" name="Google Shape;500;p7"/>
            <p:cNvSpPr txBox="1"/>
            <p:nvPr/>
          </p:nvSpPr>
          <p:spPr>
            <a:xfrm>
              <a:off x="2448512" y="4688896"/>
              <a:ext cx="962296" cy="345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0" i="0" u="none" strike="noStrike" cap="none">
                  <a:solidFill>
                    <a:schemeClr val="dk1"/>
                  </a:solidFill>
                  <a:latin typeface="Calibri"/>
                  <a:ea typeface="Calibri"/>
                  <a:cs typeface="Calibri"/>
                  <a:sym typeface="Calibri"/>
                </a:rPr>
                <a:t>Control</a:t>
              </a:r>
              <a:endParaRPr sz="1400" b="0" i="0" u="none" strike="noStrike" cap="none">
                <a:solidFill>
                  <a:srgbClr val="000000"/>
                </a:solidFill>
                <a:latin typeface="Calibri"/>
                <a:ea typeface="Calibri"/>
                <a:cs typeface="Calibri"/>
                <a:sym typeface="Calibri"/>
              </a:endParaRPr>
            </a:p>
          </p:txBody>
        </p:sp>
        <p:sp>
          <p:nvSpPr>
            <p:cNvPr id="501" name="Google Shape;501;p7"/>
            <p:cNvSpPr txBox="1"/>
            <p:nvPr/>
          </p:nvSpPr>
          <p:spPr>
            <a:xfrm>
              <a:off x="3717888" y="4688896"/>
              <a:ext cx="1287900" cy="345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0" i="0" u="none" strike="noStrike" cap="none">
                  <a:solidFill>
                    <a:schemeClr val="dk1"/>
                  </a:solidFill>
                  <a:latin typeface="Calibri"/>
                  <a:ea typeface="Calibri"/>
                  <a:cs typeface="Calibri"/>
                  <a:sym typeface="Calibri"/>
                </a:rPr>
                <a:t>+CAP +CHX</a:t>
              </a:r>
              <a:endParaRPr sz="1400" b="0" i="0" u="none" strike="noStrike" cap="none">
                <a:solidFill>
                  <a:srgbClr val="000000"/>
                </a:solidFill>
                <a:latin typeface="Calibri"/>
                <a:ea typeface="Calibri"/>
                <a:cs typeface="Calibri"/>
                <a:sym typeface="Calibri"/>
              </a:endParaRPr>
            </a:p>
          </p:txBody>
        </p:sp>
        <p:cxnSp>
          <p:nvCxnSpPr>
            <p:cNvPr id="502" name="Google Shape;502;p7"/>
            <p:cNvCxnSpPr/>
            <p:nvPr/>
          </p:nvCxnSpPr>
          <p:spPr>
            <a:xfrm>
              <a:off x="3848699" y="2503173"/>
              <a:ext cx="1368000" cy="0"/>
            </a:xfrm>
            <a:prstGeom prst="straightConnector1">
              <a:avLst/>
            </a:prstGeom>
            <a:noFill/>
            <a:ln w="28575" cap="flat" cmpd="sng">
              <a:solidFill>
                <a:schemeClr val="dk1"/>
              </a:solidFill>
              <a:prstDash val="solid"/>
              <a:miter lim="800000"/>
              <a:headEnd type="none" w="sm" len="sm"/>
              <a:tailEnd type="none" w="sm" len="sm"/>
            </a:ln>
          </p:spPr>
        </p:cxnSp>
        <p:sp>
          <p:nvSpPr>
            <p:cNvPr id="503" name="Google Shape;503;p7"/>
            <p:cNvSpPr txBox="1"/>
            <p:nvPr/>
          </p:nvSpPr>
          <p:spPr>
            <a:xfrm>
              <a:off x="3888334" y="2469306"/>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0</a:t>
              </a:r>
              <a:endParaRPr sz="1400" b="0" i="0" u="none" strike="noStrike" cap="none">
                <a:solidFill>
                  <a:srgbClr val="000000"/>
                </a:solidFill>
                <a:latin typeface="Calibri"/>
                <a:ea typeface="Calibri"/>
                <a:cs typeface="Calibri"/>
                <a:sym typeface="Calibri"/>
              </a:endParaRPr>
            </a:p>
          </p:txBody>
        </p:sp>
        <p:sp>
          <p:nvSpPr>
            <p:cNvPr id="504" name="Google Shape;504;p7"/>
            <p:cNvSpPr txBox="1"/>
            <p:nvPr/>
          </p:nvSpPr>
          <p:spPr>
            <a:xfrm>
              <a:off x="4381856" y="2469306"/>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6</a:t>
              </a:r>
              <a:endParaRPr sz="1400" b="0" i="0" u="none" strike="noStrike" cap="none">
                <a:solidFill>
                  <a:srgbClr val="000000"/>
                </a:solidFill>
                <a:latin typeface="Calibri"/>
                <a:ea typeface="Calibri"/>
                <a:cs typeface="Calibri"/>
                <a:sym typeface="Calibri"/>
              </a:endParaRPr>
            </a:p>
          </p:txBody>
        </p:sp>
        <p:sp>
          <p:nvSpPr>
            <p:cNvPr id="505" name="Google Shape;505;p7"/>
            <p:cNvSpPr txBox="1"/>
            <p:nvPr/>
          </p:nvSpPr>
          <p:spPr>
            <a:xfrm>
              <a:off x="4818791" y="2469299"/>
              <a:ext cx="5037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24</a:t>
              </a:r>
              <a:endParaRPr sz="1400" b="0" i="0" u="none" strike="noStrike" cap="none">
                <a:solidFill>
                  <a:srgbClr val="000000"/>
                </a:solidFill>
                <a:latin typeface="Calibri"/>
                <a:ea typeface="Calibri"/>
                <a:cs typeface="Calibri"/>
                <a:sym typeface="Calibri"/>
              </a:endParaRPr>
            </a:p>
          </p:txBody>
        </p:sp>
        <p:sp>
          <p:nvSpPr>
            <p:cNvPr id="506" name="Google Shape;506;p7"/>
            <p:cNvSpPr txBox="1"/>
            <p:nvPr/>
          </p:nvSpPr>
          <p:spPr>
            <a:xfrm>
              <a:off x="5361636" y="2469306"/>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0</a:t>
              </a:r>
              <a:endParaRPr sz="1400" b="0" i="0" u="none" strike="noStrike" cap="none">
                <a:solidFill>
                  <a:srgbClr val="000000"/>
                </a:solidFill>
                <a:latin typeface="Calibri"/>
                <a:ea typeface="Calibri"/>
                <a:cs typeface="Calibri"/>
                <a:sym typeface="Calibri"/>
              </a:endParaRPr>
            </a:p>
          </p:txBody>
        </p:sp>
        <p:sp>
          <p:nvSpPr>
            <p:cNvPr id="507" name="Google Shape;507;p7"/>
            <p:cNvSpPr txBox="1"/>
            <p:nvPr/>
          </p:nvSpPr>
          <p:spPr>
            <a:xfrm>
              <a:off x="5855158" y="2469306"/>
              <a:ext cx="3018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6</a:t>
              </a:r>
              <a:endParaRPr sz="1400" b="0" i="0" u="none" strike="noStrike" cap="none">
                <a:solidFill>
                  <a:srgbClr val="000000"/>
                </a:solidFill>
                <a:latin typeface="Calibri"/>
                <a:ea typeface="Calibri"/>
                <a:cs typeface="Calibri"/>
                <a:sym typeface="Calibri"/>
              </a:endParaRPr>
            </a:p>
          </p:txBody>
        </p:sp>
        <p:sp>
          <p:nvSpPr>
            <p:cNvPr id="508" name="Google Shape;508;p7"/>
            <p:cNvSpPr txBox="1"/>
            <p:nvPr/>
          </p:nvSpPr>
          <p:spPr>
            <a:xfrm>
              <a:off x="6292088" y="2469299"/>
              <a:ext cx="5484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24</a:t>
              </a:r>
              <a:endParaRPr sz="1400" b="0" i="0" u="none" strike="noStrike" cap="none">
                <a:solidFill>
                  <a:srgbClr val="000000"/>
                </a:solidFill>
                <a:latin typeface="Calibri"/>
                <a:ea typeface="Calibri"/>
                <a:cs typeface="Calibri"/>
                <a:sym typeface="Calibri"/>
              </a:endParaRPr>
            </a:p>
          </p:txBody>
        </p:sp>
        <p:cxnSp>
          <p:nvCxnSpPr>
            <p:cNvPr id="509" name="Google Shape;509;p7"/>
            <p:cNvCxnSpPr/>
            <p:nvPr/>
          </p:nvCxnSpPr>
          <p:spPr>
            <a:xfrm>
              <a:off x="5355512" y="2503173"/>
              <a:ext cx="1368000" cy="0"/>
            </a:xfrm>
            <a:prstGeom prst="straightConnector1">
              <a:avLst/>
            </a:prstGeom>
            <a:noFill/>
            <a:ln w="28575" cap="flat" cmpd="sng">
              <a:solidFill>
                <a:schemeClr val="dk1"/>
              </a:solidFill>
              <a:prstDash val="solid"/>
              <a:miter lim="800000"/>
              <a:headEnd type="none" w="sm" len="sm"/>
              <a:tailEnd type="none" w="sm" len="sm"/>
            </a:ln>
          </p:spPr>
        </p:cxnSp>
        <p:sp>
          <p:nvSpPr>
            <p:cNvPr id="510" name="Google Shape;510;p7"/>
            <p:cNvSpPr txBox="1"/>
            <p:nvPr/>
          </p:nvSpPr>
          <p:spPr>
            <a:xfrm>
              <a:off x="4126176" y="2192256"/>
              <a:ext cx="919669" cy="345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0" i="0" u="none" strike="noStrike" cap="none">
                  <a:solidFill>
                    <a:schemeClr val="dk1"/>
                  </a:solidFill>
                  <a:latin typeface="Calibri"/>
                  <a:ea typeface="Calibri"/>
                  <a:cs typeface="Calibri"/>
                  <a:sym typeface="Calibri"/>
                </a:rPr>
                <a:t>Control</a:t>
              </a:r>
              <a:endParaRPr sz="1400" b="0" i="0" u="none" strike="noStrike" cap="none">
                <a:solidFill>
                  <a:srgbClr val="000000"/>
                </a:solidFill>
                <a:latin typeface="Calibri"/>
                <a:ea typeface="Calibri"/>
                <a:cs typeface="Calibri"/>
                <a:sym typeface="Calibri"/>
              </a:endParaRPr>
            </a:p>
          </p:txBody>
        </p:sp>
        <p:sp>
          <p:nvSpPr>
            <p:cNvPr id="511" name="Google Shape;511;p7"/>
            <p:cNvSpPr txBox="1"/>
            <p:nvPr/>
          </p:nvSpPr>
          <p:spPr>
            <a:xfrm>
              <a:off x="5395553" y="2192256"/>
              <a:ext cx="1287900" cy="345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0" i="0" u="none" strike="noStrike" cap="none">
                  <a:solidFill>
                    <a:schemeClr val="dk1"/>
                  </a:solidFill>
                  <a:latin typeface="Calibri"/>
                  <a:ea typeface="Calibri"/>
                  <a:cs typeface="Calibri"/>
                  <a:sym typeface="Calibri"/>
                </a:rPr>
                <a:t>+CAP +CHX</a:t>
              </a:r>
              <a:endParaRPr sz="1400" b="0" i="0" u="none" strike="noStrike" cap="none">
                <a:solidFill>
                  <a:srgbClr val="000000"/>
                </a:solidFill>
                <a:latin typeface="Calibri"/>
                <a:ea typeface="Calibri"/>
                <a:cs typeface="Calibri"/>
                <a:sym typeface="Calibri"/>
              </a:endParaRPr>
            </a:p>
          </p:txBody>
        </p:sp>
        <p:sp>
          <p:nvSpPr>
            <p:cNvPr id="512" name="Google Shape;512;p7"/>
            <p:cNvSpPr txBox="1"/>
            <p:nvPr/>
          </p:nvSpPr>
          <p:spPr>
            <a:xfrm>
              <a:off x="1711227" y="1865430"/>
              <a:ext cx="503700" cy="3459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600"/>
                <a:buFont typeface="Arial"/>
                <a:buNone/>
              </a:pPr>
              <a:r>
                <a:rPr lang="en-US" sz="1600" b="0" i="0" u="none" strike="noStrike" cap="none">
                  <a:solidFill>
                    <a:schemeClr val="dk1"/>
                  </a:solidFill>
                  <a:latin typeface="Calibri"/>
                  <a:ea typeface="Calibri"/>
                  <a:cs typeface="Calibri"/>
                  <a:sym typeface="Calibri"/>
                </a:rPr>
                <a:t>WT</a:t>
              </a:r>
              <a:endParaRPr sz="1400" b="0" i="0" u="none" strike="noStrike" cap="none">
                <a:solidFill>
                  <a:srgbClr val="000000"/>
                </a:solidFill>
                <a:latin typeface="Calibri"/>
                <a:ea typeface="Calibri"/>
                <a:cs typeface="Calibri"/>
                <a:sym typeface="Calibri"/>
              </a:endParaRPr>
            </a:p>
          </p:txBody>
        </p:sp>
        <p:cxnSp>
          <p:nvCxnSpPr>
            <p:cNvPr id="513" name="Google Shape;513;p7"/>
            <p:cNvCxnSpPr/>
            <p:nvPr/>
          </p:nvCxnSpPr>
          <p:spPr>
            <a:xfrm>
              <a:off x="2083215" y="4666611"/>
              <a:ext cx="3060000" cy="0"/>
            </a:xfrm>
            <a:prstGeom prst="straightConnector1">
              <a:avLst/>
            </a:prstGeom>
            <a:noFill/>
            <a:ln w="28575" cap="flat" cmpd="sng">
              <a:solidFill>
                <a:schemeClr val="dk1"/>
              </a:solidFill>
              <a:prstDash val="solid"/>
              <a:miter lim="800000"/>
              <a:headEnd type="none" w="sm" len="sm"/>
              <a:tailEnd type="none" w="sm" len="sm"/>
            </a:ln>
          </p:spPr>
        </p:cxnSp>
        <p:sp>
          <p:nvSpPr>
            <p:cNvPr id="514" name="Google Shape;514;p7"/>
            <p:cNvSpPr txBox="1"/>
            <p:nvPr/>
          </p:nvSpPr>
          <p:spPr>
            <a:xfrm>
              <a:off x="2595598" y="4368530"/>
              <a:ext cx="1981500" cy="3459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600"/>
                <a:buFont typeface="Arial"/>
                <a:buNone/>
              </a:pPr>
              <a:r>
                <a:rPr lang="en-US" sz="1600" b="0" i="1" u="none" strike="noStrike" cap="none">
                  <a:solidFill>
                    <a:schemeClr val="dk1"/>
                  </a:solidFill>
                  <a:latin typeface="Calibri"/>
                  <a:ea typeface="Calibri"/>
                  <a:cs typeface="Calibri"/>
                  <a:sym typeface="Calibri"/>
                </a:rPr>
                <a:t>rmt2-2</a:t>
              </a:r>
              <a:r>
                <a:rPr lang="en-US" sz="1600" b="0" i="0" u="none" strike="noStrike" cap="none">
                  <a:solidFill>
                    <a:schemeClr val="dk1"/>
                  </a:solidFill>
                  <a:latin typeface="Calibri"/>
                  <a:ea typeface="Calibri"/>
                  <a:cs typeface="Calibri"/>
                  <a:sym typeface="Calibri"/>
                </a:rPr>
                <a:t> +RMT2-mNG</a:t>
              </a:r>
              <a:endParaRPr sz="1400" b="0" i="0" u="none" strike="noStrike" cap="none">
                <a:solidFill>
                  <a:srgbClr val="000000"/>
                </a:solidFill>
                <a:latin typeface="Calibri"/>
                <a:ea typeface="Calibri"/>
                <a:cs typeface="Calibri"/>
                <a:sym typeface="Calibri"/>
              </a:endParaRPr>
            </a:p>
          </p:txBody>
        </p:sp>
        <p:cxnSp>
          <p:nvCxnSpPr>
            <p:cNvPr id="515" name="Google Shape;515;p7"/>
            <p:cNvCxnSpPr/>
            <p:nvPr/>
          </p:nvCxnSpPr>
          <p:spPr>
            <a:xfrm>
              <a:off x="3757311" y="2167967"/>
              <a:ext cx="3060000" cy="0"/>
            </a:xfrm>
            <a:prstGeom prst="straightConnector1">
              <a:avLst/>
            </a:prstGeom>
            <a:noFill/>
            <a:ln w="28575" cap="flat" cmpd="sng">
              <a:solidFill>
                <a:schemeClr val="dk1"/>
              </a:solidFill>
              <a:prstDash val="solid"/>
              <a:miter lim="800000"/>
              <a:headEnd type="none" w="sm" len="sm"/>
              <a:tailEnd type="none" w="sm" len="sm"/>
            </a:ln>
          </p:spPr>
        </p:cxnSp>
        <p:sp>
          <p:nvSpPr>
            <p:cNvPr id="516" name="Google Shape;516;p7"/>
            <p:cNvSpPr txBox="1"/>
            <p:nvPr/>
          </p:nvSpPr>
          <p:spPr>
            <a:xfrm>
              <a:off x="4887664" y="1869876"/>
              <a:ext cx="876900" cy="345900"/>
            </a:xfrm>
            <a:prstGeom prst="rect">
              <a:avLst/>
            </a:prstGeom>
            <a:noFill/>
            <a:ln>
              <a:noFill/>
            </a:ln>
          </p:spPr>
          <p:txBody>
            <a:bodyPr spcFirstLastPara="1" wrap="square" lIns="91425" tIns="45700" rIns="91425" bIns="45700" anchor="t" anchorCtr="0">
              <a:spAutoFit/>
            </a:bodyPr>
            <a:lstStyle/>
            <a:p>
              <a:pPr marL="0" marR="0" lvl="0" indent="0" algn="ctr" rtl="0">
                <a:lnSpc>
                  <a:spcPct val="100000"/>
                </a:lnSpc>
                <a:spcBef>
                  <a:spcPts val="0"/>
                </a:spcBef>
                <a:spcAft>
                  <a:spcPts val="0"/>
                </a:spcAft>
                <a:buClr>
                  <a:srgbClr val="000000"/>
                </a:buClr>
                <a:buSzPts val="1600"/>
                <a:buFont typeface="Arial"/>
                <a:buNone/>
              </a:pPr>
              <a:r>
                <a:rPr lang="en-US" sz="1600" b="0" i="1" u="none" strike="noStrike" cap="none">
                  <a:solidFill>
                    <a:schemeClr val="dk1"/>
                  </a:solidFill>
                  <a:latin typeface="Calibri"/>
                  <a:ea typeface="Calibri"/>
                  <a:cs typeface="Calibri"/>
                  <a:sym typeface="Calibri"/>
                </a:rPr>
                <a:t>rmt2-2</a:t>
              </a:r>
              <a:endParaRPr sz="1400" b="0" i="0" u="none" strike="noStrike" cap="none">
                <a:solidFill>
                  <a:srgbClr val="000000"/>
                </a:solidFill>
                <a:latin typeface="Calibri"/>
                <a:ea typeface="Calibri"/>
                <a:cs typeface="Calibri"/>
                <a:sym typeface="Calibri"/>
              </a:endParaRPr>
            </a:p>
          </p:txBody>
        </p:sp>
        <p:sp>
          <p:nvSpPr>
            <p:cNvPr id="517" name="Google Shape;517;p7"/>
            <p:cNvSpPr txBox="1"/>
            <p:nvPr/>
          </p:nvSpPr>
          <p:spPr>
            <a:xfrm>
              <a:off x="5127263" y="5297302"/>
              <a:ext cx="672000" cy="37740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PsaA</a:t>
              </a:r>
              <a:endParaRPr sz="1800" b="0" i="0" u="none" strike="noStrike" cap="none">
                <a:solidFill>
                  <a:schemeClr val="dk1"/>
                </a:solidFill>
                <a:latin typeface="Calibri"/>
                <a:ea typeface="Calibri"/>
                <a:cs typeface="Calibri"/>
                <a:sym typeface="Calibri"/>
              </a:endParaRPr>
            </a:p>
          </p:txBody>
        </p:sp>
        <p:sp>
          <p:nvSpPr>
            <p:cNvPr id="518" name="Google Shape;518;p7"/>
            <p:cNvSpPr txBox="1"/>
            <p:nvPr/>
          </p:nvSpPr>
          <p:spPr>
            <a:xfrm>
              <a:off x="5127262" y="5838199"/>
              <a:ext cx="684900" cy="37740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PsbA</a:t>
              </a:r>
              <a:endParaRPr sz="1800" b="0" i="0" u="none" strike="noStrike" cap="none">
                <a:solidFill>
                  <a:schemeClr val="dk1"/>
                </a:solidFill>
                <a:latin typeface="Calibri"/>
                <a:ea typeface="Calibri"/>
                <a:cs typeface="Calibri"/>
                <a:sym typeface="Calibri"/>
              </a:endParaRPr>
            </a:p>
          </p:txBody>
        </p:sp>
        <p:sp>
          <p:nvSpPr>
            <p:cNvPr id="519" name="Google Shape;519;p7"/>
            <p:cNvSpPr txBox="1"/>
            <p:nvPr/>
          </p:nvSpPr>
          <p:spPr>
            <a:xfrm>
              <a:off x="5127262" y="6379096"/>
              <a:ext cx="548400" cy="37740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Tub</a:t>
              </a:r>
              <a:endParaRPr sz="1400" b="0" i="0" u="none" strike="noStrike" cap="none">
                <a:solidFill>
                  <a:srgbClr val="000000"/>
                </a:solidFill>
                <a:latin typeface="Calibri"/>
                <a:ea typeface="Calibri"/>
                <a:cs typeface="Calibri"/>
                <a:sym typeface="Calibri"/>
              </a:endParaRPr>
            </a:p>
          </p:txBody>
        </p:sp>
        <p:pic>
          <p:nvPicPr>
            <p:cNvPr id="520" name="Google Shape;520;p7" descr="A blurry image of a test&#10;&#10;Description automatically generated with medium confidence"/>
            <p:cNvPicPr preferRelativeResize="0"/>
            <p:nvPr/>
          </p:nvPicPr>
          <p:blipFill rotWithShape="1">
            <a:blip r:embed="rId6">
              <a:alphaModFix/>
            </a:blip>
            <a:srcRect l="15204" t="72443" r="51816" b="22484"/>
            <a:stretch/>
          </p:blipFill>
          <p:spPr>
            <a:xfrm flipH="1">
              <a:off x="3769846" y="3340549"/>
              <a:ext cx="3032124" cy="381600"/>
            </a:xfrm>
            <a:prstGeom prst="rect">
              <a:avLst/>
            </a:prstGeom>
            <a:noFill/>
            <a:ln w="28575" cap="flat" cmpd="sng">
              <a:solidFill>
                <a:schemeClr val="dk1"/>
              </a:solidFill>
              <a:prstDash val="solid"/>
              <a:round/>
              <a:headEnd type="none" w="sm" len="sm"/>
              <a:tailEnd type="none" w="sm" len="sm"/>
            </a:ln>
          </p:spPr>
        </p:pic>
        <p:pic>
          <p:nvPicPr>
            <p:cNvPr id="521" name="Google Shape;521;p7" descr="A blurry image of a dna test&#10;&#10;Description automatically generated"/>
            <p:cNvPicPr preferRelativeResize="0"/>
            <p:nvPr/>
          </p:nvPicPr>
          <p:blipFill rotWithShape="1">
            <a:blip r:embed="rId7">
              <a:alphaModFix/>
            </a:blip>
            <a:srcRect l="15000" t="33583" r="52458" b="61395"/>
            <a:stretch/>
          </p:blipFill>
          <p:spPr>
            <a:xfrm flipH="1">
              <a:off x="459860" y="3340549"/>
              <a:ext cx="3032125" cy="382770"/>
            </a:xfrm>
            <a:prstGeom prst="rect">
              <a:avLst/>
            </a:prstGeom>
            <a:noFill/>
            <a:ln w="28575" cap="flat" cmpd="sng">
              <a:solidFill>
                <a:schemeClr val="dk1"/>
              </a:solidFill>
              <a:prstDash val="solid"/>
              <a:round/>
              <a:headEnd type="none" w="sm" len="sm"/>
              <a:tailEnd type="none" w="sm" len="sm"/>
            </a:ln>
          </p:spPr>
        </p:pic>
        <p:pic>
          <p:nvPicPr>
            <p:cNvPr id="522" name="Google Shape;522;p7" descr="A blurry image of a dna test&#10;&#10;Description automatically generated"/>
            <p:cNvPicPr preferRelativeResize="0"/>
            <p:nvPr/>
          </p:nvPicPr>
          <p:blipFill rotWithShape="1">
            <a:blip r:embed="rId8">
              <a:alphaModFix/>
            </a:blip>
            <a:srcRect l="18762" t="51638" r="46807" b="43062"/>
            <a:stretch/>
          </p:blipFill>
          <p:spPr>
            <a:xfrm>
              <a:off x="2095355" y="5838199"/>
              <a:ext cx="3032126" cy="381600"/>
            </a:xfrm>
            <a:prstGeom prst="rect">
              <a:avLst/>
            </a:prstGeom>
            <a:noFill/>
            <a:ln w="28575" cap="flat" cmpd="sng">
              <a:solidFill>
                <a:schemeClr val="dk1"/>
              </a:solidFill>
              <a:prstDash val="solid"/>
              <a:round/>
              <a:headEnd type="none" w="sm" len="sm"/>
              <a:tailEnd type="none" w="sm" len="sm"/>
            </a:ln>
          </p:spPr>
        </p:pic>
        <p:pic>
          <p:nvPicPr>
            <p:cNvPr id="523" name="Google Shape;523;p7" descr="A black lines on a white background&#10;&#10;Description automatically generated"/>
            <p:cNvPicPr preferRelativeResize="0"/>
            <p:nvPr/>
          </p:nvPicPr>
          <p:blipFill rotWithShape="1">
            <a:blip r:embed="rId9">
              <a:alphaModFix/>
            </a:blip>
            <a:srcRect l="8315" t="29828" r="59045" b="65135"/>
            <a:stretch/>
          </p:blipFill>
          <p:spPr>
            <a:xfrm flipH="1">
              <a:off x="459860" y="3881446"/>
              <a:ext cx="3032125" cy="382770"/>
            </a:xfrm>
            <a:prstGeom prst="rect">
              <a:avLst/>
            </a:prstGeom>
            <a:noFill/>
            <a:ln w="28575" cap="flat" cmpd="sng">
              <a:solidFill>
                <a:schemeClr val="dk1"/>
              </a:solidFill>
              <a:prstDash val="solid"/>
              <a:round/>
              <a:headEnd type="none" w="sm" len="sm"/>
              <a:tailEnd type="none" w="sm" len="sm"/>
            </a:ln>
          </p:spPr>
        </p:pic>
        <p:pic>
          <p:nvPicPr>
            <p:cNvPr id="524" name="Google Shape;524;p7" descr="A black lines on a white background&#10;&#10;Description automatically generated"/>
            <p:cNvPicPr preferRelativeResize="0"/>
            <p:nvPr/>
          </p:nvPicPr>
          <p:blipFill rotWithShape="1">
            <a:blip r:embed="rId10">
              <a:alphaModFix/>
            </a:blip>
            <a:srcRect l="7240" t="67717" r="58633" b="27014"/>
            <a:stretch/>
          </p:blipFill>
          <p:spPr>
            <a:xfrm flipH="1">
              <a:off x="3769846" y="3881446"/>
              <a:ext cx="3032125" cy="382772"/>
            </a:xfrm>
            <a:prstGeom prst="rect">
              <a:avLst/>
            </a:prstGeom>
            <a:noFill/>
            <a:ln w="28575" cap="flat" cmpd="sng">
              <a:solidFill>
                <a:schemeClr val="dk1"/>
              </a:solidFill>
              <a:prstDash val="solid"/>
              <a:round/>
              <a:headEnd type="none" w="sm" len="sm"/>
              <a:tailEnd type="none" w="sm" len="sm"/>
            </a:ln>
          </p:spPr>
        </p:pic>
        <p:pic>
          <p:nvPicPr>
            <p:cNvPr id="525" name="Google Shape;525;p7" descr="A close-up of a white sheet&#10;&#10;Description automatically generated"/>
            <p:cNvPicPr preferRelativeResize="0"/>
            <p:nvPr/>
          </p:nvPicPr>
          <p:blipFill rotWithShape="1">
            <a:blip r:embed="rId11">
              <a:alphaModFix/>
            </a:blip>
            <a:srcRect l="12714" t="44342" r="54345" b="50575"/>
            <a:stretch/>
          </p:blipFill>
          <p:spPr>
            <a:xfrm>
              <a:off x="2095355" y="6379096"/>
              <a:ext cx="3032126" cy="382772"/>
            </a:xfrm>
            <a:prstGeom prst="rect">
              <a:avLst/>
            </a:prstGeom>
            <a:noFill/>
            <a:ln w="28575" cap="flat" cmpd="sng">
              <a:solidFill>
                <a:schemeClr val="dk1"/>
              </a:solidFill>
              <a:prstDash val="solid"/>
              <a:round/>
              <a:headEnd type="none" w="sm" len="sm"/>
              <a:tailEnd type="none" w="sm" len="sm"/>
            </a:ln>
          </p:spPr>
        </p:pic>
        <p:sp>
          <p:nvSpPr>
            <p:cNvPr id="526" name="Google Shape;526;p7"/>
            <p:cNvSpPr txBox="1"/>
            <p:nvPr/>
          </p:nvSpPr>
          <p:spPr>
            <a:xfrm>
              <a:off x="5123293" y="4962888"/>
              <a:ext cx="8769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hours</a:t>
              </a:r>
              <a:endParaRPr sz="1400" b="0" i="0" u="none" strike="noStrike" cap="none">
                <a:solidFill>
                  <a:srgbClr val="000000"/>
                </a:solidFill>
                <a:latin typeface="Calibri"/>
                <a:ea typeface="Calibri"/>
                <a:cs typeface="Calibri"/>
                <a:sym typeface="Calibri"/>
              </a:endParaRPr>
            </a:p>
          </p:txBody>
        </p:sp>
        <p:sp>
          <p:nvSpPr>
            <p:cNvPr id="527" name="Google Shape;527;p7"/>
            <p:cNvSpPr txBox="1"/>
            <p:nvPr/>
          </p:nvSpPr>
          <p:spPr>
            <a:xfrm>
              <a:off x="6815075" y="2768656"/>
              <a:ext cx="672000" cy="37740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PsaA</a:t>
              </a:r>
              <a:endParaRPr sz="1800" b="0" i="0" u="none" strike="noStrike" cap="none">
                <a:solidFill>
                  <a:schemeClr val="dk1"/>
                </a:solidFill>
                <a:latin typeface="Calibri"/>
                <a:ea typeface="Calibri"/>
                <a:cs typeface="Calibri"/>
                <a:sym typeface="Calibri"/>
              </a:endParaRPr>
            </a:p>
          </p:txBody>
        </p:sp>
        <p:sp>
          <p:nvSpPr>
            <p:cNvPr id="528" name="Google Shape;528;p7"/>
            <p:cNvSpPr txBox="1"/>
            <p:nvPr/>
          </p:nvSpPr>
          <p:spPr>
            <a:xfrm>
              <a:off x="6815074" y="3309553"/>
              <a:ext cx="684900" cy="37740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PsbA</a:t>
              </a:r>
              <a:endParaRPr sz="1800" b="0" i="0" u="none" strike="noStrike" cap="none">
                <a:solidFill>
                  <a:schemeClr val="dk1"/>
                </a:solidFill>
                <a:latin typeface="Calibri"/>
                <a:ea typeface="Calibri"/>
                <a:cs typeface="Calibri"/>
                <a:sym typeface="Calibri"/>
              </a:endParaRPr>
            </a:p>
          </p:txBody>
        </p:sp>
        <p:sp>
          <p:nvSpPr>
            <p:cNvPr id="529" name="Google Shape;529;p7"/>
            <p:cNvSpPr txBox="1"/>
            <p:nvPr/>
          </p:nvSpPr>
          <p:spPr>
            <a:xfrm>
              <a:off x="6815074" y="3850450"/>
              <a:ext cx="548400" cy="377400"/>
            </a:xfrm>
            <a:prstGeom prst="rect">
              <a:avLst/>
            </a:prstGeom>
            <a:noFill/>
            <a:ln>
              <a:noFill/>
            </a:ln>
          </p:spPr>
          <p:txBody>
            <a:bodyPr spcFirstLastPara="1" wrap="square" lIns="91425" tIns="45700" rIns="91425" bIns="45700" anchor="ctr"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Tub</a:t>
              </a:r>
              <a:endParaRPr sz="1400" b="0" i="0" u="none" strike="noStrike" cap="none">
                <a:solidFill>
                  <a:srgbClr val="000000"/>
                </a:solidFill>
                <a:latin typeface="Calibri"/>
                <a:ea typeface="Calibri"/>
                <a:cs typeface="Calibri"/>
                <a:sym typeface="Calibri"/>
              </a:endParaRPr>
            </a:p>
          </p:txBody>
        </p:sp>
        <p:sp>
          <p:nvSpPr>
            <p:cNvPr id="530" name="Google Shape;530;p7"/>
            <p:cNvSpPr txBox="1"/>
            <p:nvPr/>
          </p:nvSpPr>
          <p:spPr>
            <a:xfrm>
              <a:off x="6811082" y="2434259"/>
              <a:ext cx="813000" cy="377400"/>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Calibri"/>
                  <a:ea typeface="Calibri"/>
                  <a:cs typeface="Calibri"/>
                  <a:sym typeface="Calibri"/>
                </a:rPr>
                <a:t>hours</a:t>
              </a:r>
              <a:endParaRPr sz="1400" b="0" i="0" u="none" strike="noStrike" cap="none">
                <a:solidFill>
                  <a:srgbClr val="000000"/>
                </a:solidFill>
                <a:latin typeface="Calibri"/>
                <a:ea typeface="Calibri"/>
                <a:cs typeface="Calibri"/>
                <a:sym typeface="Calibri"/>
              </a:endParaRPr>
            </a:p>
          </p:txBody>
        </p:sp>
      </p:gr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534"/>
        <p:cNvGrpSpPr/>
        <p:nvPr/>
      </p:nvGrpSpPr>
      <p:grpSpPr>
        <a:xfrm>
          <a:off x="0" y="0"/>
          <a:ext cx="0" cy="0"/>
          <a:chOff x="0" y="0"/>
          <a:chExt cx="0" cy="0"/>
        </a:xfrm>
      </p:grpSpPr>
      <p:sp>
        <p:nvSpPr>
          <p:cNvPr id="535" name="Google Shape;535;p8"/>
          <p:cNvSpPr txBox="1"/>
          <p:nvPr/>
        </p:nvSpPr>
        <p:spPr>
          <a:xfrm>
            <a:off x="142644" y="107414"/>
            <a:ext cx="1152756"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Times New Roman"/>
                <a:ea typeface="Times New Roman"/>
                <a:cs typeface="Times New Roman"/>
                <a:sym typeface="Times New Roman"/>
              </a:rPr>
              <a:t>Figure S7</a:t>
            </a:r>
            <a:endParaRPr sz="1400" b="0" i="0" u="none" strike="noStrike" cap="none">
              <a:solidFill>
                <a:srgbClr val="000000"/>
              </a:solidFill>
              <a:latin typeface="Arial"/>
              <a:ea typeface="Arial"/>
              <a:cs typeface="Arial"/>
              <a:sym typeface="Arial"/>
            </a:endParaRPr>
          </a:p>
        </p:txBody>
      </p:sp>
      <p:sp>
        <p:nvSpPr>
          <p:cNvPr id="536" name="Google Shape;536;p8"/>
          <p:cNvSpPr txBox="1"/>
          <p:nvPr/>
        </p:nvSpPr>
        <p:spPr>
          <a:xfrm>
            <a:off x="419100" y="3206319"/>
            <a:ext cx="7137300" cy="646290"/>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000000"/>
              </a:buClr>
              <a:buSzPts val="1600"/>
              <a:buFont typeface="Arial"/>
              <a:buNone/>
            </a:pPr>
            <a:r>
              <a:rPr lang="en-US" sz="1200" b="1" i="0" u="none" strike="noStrike" cap="none">
                <a:solidFill>
                  <a:schemeClr val="dk1"/>
                </a:solidFill>
                <a:latin typeface="Calibri"/>
                <a:ea typeface="Calibri"/>
                <a:cs typeface="Calibri"/>
                <a:sym typeface="Calibri"/>
              </a:rPr>
              <a:t>Figure S7</a:t>
            </a:r>
            <a:r>
              <a:rPr lang="en-US" sz="1200" b="0" i="0" u="none" strike="noStrike" cap="none">
                <a:solidFill>
                  <a:schemeClr val="dk1"/>
                </a:solidFill>
                <a:latin typeface="Calibri"/>
                <a:ea typeface="Calibri"/>
                <a:cs typeface="Calibri"/>
                <a:sym typeface="Calibri"/>
              </a:rPr>
              <a:t>. Localization of RMT2-mNG after 4 h in VLC (&lt;0.02 % CO</a:t>
            </a:r>
            <a:r>
              <a:rPr lang="en-US" sz="1200" b="0" i="0" u="none" strike="noStrike" cap="none" baseline="-25000">
                <a:solidFill>
                  <a:schemeClr val="dk1"/>
                </a:solidFill>
                <a:latin typeface="Calibri"/>
                <a:ea typeface="Calibri"/>
                <a:cs typeface="Calibri"/>
                <a:sym typeface="Calibri"/>
              </a:rPr>
              <a:t>2</a:t>
            </a:r>
            <a:r>
              <a:rPr lang="en-US" sz="1200" b="0" i="0" u="none" strike="noStrike" cap="none">
                <a:solidFill>
                  <a:schemeClr val="dk1"/>
                </a:solidFill>
                <a:latin typeface="Calibri"/>
                <a:ea typeface="Calibri"/>
                <a:cs typeface="Calibri"/>
                <a:sym typeface="Calibri"/>
              </a:rPr>
              <a:t>) conditions. Shown are brightfield (BF), RMT2-mNG (mNeon Green) localization, chl autofluorescence, merge of Neon green and chl fluorescence (Merge). Scale bar: 10 µm.</a:t>
            </a:r>
            <a:endParaRPr sz="1200" b="0" i="0" u="none" strike="noStrike" cap="none">
              <a:solidFill>
                <a:schemeClr val="dk1"/>
              </a:solidFill>
              <a:latin typeface="Calibri"/>
              <a:ea typeface="Calibri"/>
              <a:cs typeface="Calibri"/>
              <a:sym typeface="Calibri"/>
            </a:endParaRPr>
          </a:p>
        </p:txBody>
      </p:sp>
      <p:grpSp>
        <p:nvGrpSpPr>
          <p:cNvPr id="537" name="Google Shape;537;p8"/>
          <p:cNvGrpSpPr/>
          <p:nvPr/>
        </p:nvGrpSpPr>
        <p:grpSpPr>
          <a:xfrm>
            <a:off x="84320" y="895932"/>
            <a:ext cx="7197359" cy="1955646"/>
            <a:chOff x="3541" y="1248188"/>
            <a:chExt cx="7197359" cy="1955646"/>
          </a:xfrm>
        </p:grpSpPr>
        <p:pic>
          <p:nvPicPr>
            <p:cNvPr id="538" name="Google Shape;538;p8"/>
            <p:cNvPicPr preferRelativeResize="0"/>
            <p:nvPr/>
          </p:nvPicPr>
          <p:blipFill rotWithShape="1">
            <a:blip r:embed="rId3">
              <a:alphaModFix/>
            </a:blip>
            <a:srcRect b="88061"/>
            <a:stretch/>
          </p:blipFill>
          <p:spPr>
            <a:xfrm>
              <a:off x="3541" y="1248188"/>
              <a:ext cx="7044959" cy="509870"/>
            </a:xfrm>
            <a:prstGeom prst="rect">
              <a:avLst/>
            </a:prstGeom>
            <a:noFill/>
            <a:ln>
              <a:noFill/>
            </a:ln>
          </p:spPr>
        </p:pic>
        <p:pic>
          <p:nvPicPr>
            <p:cNvPr id="539" name="Google Shape;539;p8"/>
            <p:cNvPicPr preferRelativeResize="0"/>
            <p:nvPr/>
          </p:nvPicPr>
          <p:blipFill rotWithShape="1">
            <a:blip r:embed="rId3">
              <a:alphaModFix/>
            </a:blip>
            <a:srcRect l="898" t="56294" r="-897" b="2836"/>
            <a:stretch/>
          </p:blipFill>
          <p:spPr>
            <a:xfrm>
              <a:off x="61865" y="1717229"/>
              <a:ext cx="7139035" cy="1486605"/>
            </a:xfrm>
            <a:prstGeom prst="rect">
              <a:avLst/>
            </a:prstGeom>
            <a:noFill/>
            <a:ln>
              <a:noFill/>
            </a:ln>
          </p:spPr>
        </p:pic>
      </p:gr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544"/>
        <p:cNvGrpSpPr/>
        <p:nvPr/>
      </p:nvGrpSpPr>
      <p:grpSpPr>
        <a:xfrm>
          <a:off x="0" y="0"/>
          <a:ext cx="0" cy="0"/>
          <a:chOff x="0" y="0"/>
          <a:chExt cx="0" cy="0"/>
        </a:xfrm>
      </p:grpSpPr>
      <p:sp>
        <p:nvSpPr>
          <p:cNvPr id="545" name="Google Shape;545;p13"/>
          <p:cNvSpPr txBox="1"/>
          <p:nvPr/>
        </p:nvSpPr>
        <p:spPr>
          <a:xfrm>
            <a:off x="434799" y="6289863"/>
            <a:ext cx="6884400" cy="1384954"/>
          </a:xfrm>
          <a:prstGeom prst="rect">
            <a:avLst/>
          </a:prstGeom>
          <a:noFill/>
          <a:ln>
            <a:noFill/>
          </a:ln>
        </p:spPr>
        <p:txBody>
          <a:bodyPr spcFirstLastPara="1" wrap="square" lIns="91425" tIns="45700" rIns="91425" bIns="45700" anchor="t" anchorCtr="0">
            <a:spAutoFit/>
          </a:bodyPr>
          <a:lstStyle/>
          <a:p>
            <a:pPr marL="0" marR="0" lvl="0" indent="0" algn="just" rtl="0">
              <a:lnSpc>
                <a:spcPct val="100000"/>
              </a:lnSpc>
              <a:spcBef>
                <a:spcPts val="0"/>
              </a:spcBef>
              <a:spcAft>
                <a:spcPts val="0"/>
              </a:spcAft>
              <a:buClr>
                <a:srgbClr val="000000"/>
              </a:buClr>
              <a:buSzPts val="1400"/>
              <a:buFont typeface="Arial"/>
              <a:buNone/>
            </a:pPr>
            <a:r>
              <a:rPr lang="en-US" sz="1400" b="1" i="0" u="none" strike="noStrike" cap="none">
                <a:solidFill>
                  <a:schemeClr val="dk1"/>
                </a:solidFill>
                <a:latin typeface="Calibri"/>
                <a:ea typeface="Calibri"/>
                <a:cs typeface="Calibri"/>
                <a:sym typeface="Calibri"/>
              </a:rPr>
              <a:t>Figure S9. PSI activity of WT, </a:t>
            </a:r>
            <a:r>
              <a:rPr lang="en-US" sz="1400" b="1" i="1" u="none" strike="noStrike" cap="none">
                <a:solidFill>
                  <a:schemeClr val="dk1"/>
                </a:solidFill>
                <a:latin typeface="Calibri"/>
                <a:ea typeface="Calibri"/>
                <a:cs typeface="Calibri"/>
                <a:sym typeface="Calibri"/>
              </a:rPr>
              <a:t>rmt2-1 </a:t>
            </a:r>
            <a:r>
              <a:rPr lang="en-US" sz="1400" b="1" i="0" u="none" strike="noStrike" cap="none">
                <a:solidFill>
                  <a:schemeClr val="dk1"/>
                </a:solidFill>
                <a:latin typeface="Calibri"/>
                <a:ea typeface="Calibri"/>
                <a:cs typeface="Calibri"/>
                <a:sym typeface="Calibri"/>
              </a:rPr>
              <a:t>and</a:t>
            </a:r>
            <a:r>
              <a:rPr lang="en-US" sz="1400" b="1" i="1" u="none" strike="noStrike" cap="none">
                <a:solidFill>
                  <a:schemeClr val="dk1"/>
                </a:solidFill>
                <a:latin typeface="Calibri"/>
                <a:ea typeface="Calibri"/>
                <a:cs typeface="Calibri"/>
                <a:sym typeface="Calibri"/>
              </a:rPr>
              <a:t> rmt2-2</a:t>
            </a:r>
            <a:r>
              <a:rPr lang="en-US" sz="1400" b="1" i="0" u="none" strike="noStrike" cap="none">
                <a:solidFill>
                  <a:schemeClr val="dk1"/>
                </a:solidFill>
                <a:latin typeface="Calibri"/>
                <a:ea typeface="Calibri"/>
                <a:cs typeface="Calibri"/>
                <a:sym typeface="Calibri"/>
              </a:rPr>
              <a:t> under LL-Ox and HL-Hy.</a:t>
            </a:r>
            <a:r>
              <a:rPr lang="en-US" sz="1400" b="0" i="0" u="none" strike="noStrike" cap="none">
                <a:solidFill>
                  <a:schemeClr val="dk1"/>
                </a:solidFill>
                <a:latin typeface="Calibri"/>
                <a:ea typeface="Calibri"/>
                <a:cs typeface="Calibri"/>
                <a:sym typeface="Calibri"/>
              </a:rPr>
              <a:t> WT, </a:t>
            </a:r>
            <a:r>
              <a:rPr lang="en-US" sz="1400" b="0" i="1" u="none" strike="noStrike" cap="none">
                <a:solidFill>
                  <a:schemeClr val="dk1"/>
                </a:solidFill>
                <a:latin typeface="Calibri"/>
                <a:ea typeface="Calibri"/>
                <a:cs typeface="Calibri"/>
                <a:sym typeface="Calibri"/>
              </a:rPr>
              <a:t>rmt2-1,</a:t>
            </a:r>
            <a:r>
              <a:rPr lang="en-US" sz="1400" b="0" i="0" u="none" strike="noStrike" cap="none">
                <a:solidFill>
                  <a:schemeClr val="dk1"/>
                </a:solidFill>
                <a:latin typeface="Calibri"/>
                <a:ea typeface="Calibri"/>
                <a:cs typeface="Calibri"/>
                <a:sym typeface="Calibri"/>
              </a:rPr>
              <a:t> and</a:t>
            </a:r>
            <a:r>
              <a:rPr lang="en-US" sz="1400" b="0" i="1" u="none" strike="noStrike" cap="none">
                <a:solidFill>
                  <a:schemeClr val="dk1"/>
                </a:solidFill>
                <a:latin typeface="Calibri"/>
                <a:ea typeface="Calibri"/>
                <a:cs typeface="Calibri"/>
                <a:sym typeface="Calibri"/>
              </a:rPr>
              <a:t> rmt2-2</a:t>
            </a:r>
            <a:r>
              <a:rPr lang="en-US" sz="1400" b="0" i="0" u="none" strike="noStrike" cap="none">
                <a:solidFill>
                  <a:schemeClr val="dk1"/>
                </a:solidFill>
                <a:latin typeface="Calibri"/>
                <a:ea typeface="Calibri"/>
                <a:cs typeface="Calibri"/>
                <a:sym typeface="Calibri"/>
              </a:rPr>
              <a:t> cells were grown in TAP medium under Dark-Ox, LL-Ox (20 µmol photons m</a:t>
            </a:r>
            <a:r>
              <a:rPr lang="en-US" sz="1400" b="0" i="0" u="none" strike="noStrike" cap="none" baseline="30000">
                <a:solidFill>
                  <a:schemeClr val="dk1"/>
                </a:solidFill>
                <a:latin typeface="Calibri"/>
                <a:ea typeface="Calibri"/>
                <a:cs typeface="Calibri"/>
                <a:sym typeface="Calibri"/>
              </a:rPr>
              <a:t>-2</a:t>
            </a:r>
            <a:r>
              <a:rPr lang="en-US" sz="1400" b="0" i="0" u="none" strike="noStrike" cap="none">
                <a:solidFill>
                  <a:schemeClr val="dk1"/>
                </a:solidFill>
                <a:latin typeface="Calibri"/>
                <a:ea typeface="Calibri"/>
                <a:cs typeface="Calibri"/>
                <a:sym typeface="Calibri"/>
              </a:rPr>
              <a:t> s</a:t>
            </a:r>
            <a:r>
              <a:rPr lang="en-US" sz="1400" b="0" i="0" u="none" strike="noStrike" cap="none" baseline="30000">
                <a:solidFill>
                  <a:schemeClr val="dk1"/>
                </a:solidFill>
                <a:latin typeface="Calibri"/>
                <a:ea typeface="Calibri"/>
                <a:cs typeface="Calibri"/>
                <a:sym typeface="Calibri"/>
              </a:rPr>
              <a:t>-1</a:t>
            </a:r>
            <a:r>
              <a:rPr lang="en-US" sz="1400" b="0" i="0" u="none" strike="noStrike" cap="none">
                <a:solidFill>
                  <a:schemeClr val="dk1"/>
                </a:solidFill>
                <a:latin typeface="Calibri"/>
                <a:ea typeface="Calibri"/>
                <a:cs typeface="Calibri"/>
                <a:sym typeface="Calibri"/>
              </a:rPr>
              <a:t>) and HL-Hy (750 µmol photons m</a:t>
            </a:r>
            <a:r>
              <a:rPr lang="en-US" sz="1400" b="0" i="0" u="none" strike="noStrike" cap="none" baseline="30000">
                <a:solidFill>
                  <a:schemeClr val="dk1"/>
                </a:solidFill>
                <a:latin typeface="Calibri"/>
                <a:ea typeface="Calibri"/>
                <a:cs typeface="Calibri"/>
                <a:sym typeface="Calibri"/>
              </a:rPr>
              <a:t>-2</a:t>
            </a:r>
            <a:r>
              <a:rPr lang="en-US" sz="1400" b="0" i="0" u="none" strike="noStrike" cap="none">
                <a:solidFill>
                  <a:schemeClr val="dk1"/>
                </a:solidFill>
                <a:latin typeface="Calibri"/>
                <a:ea typeface="Calibri"/>
                <a:cs typeface="Calibri"/>
                <a:sym typeface="Calibri"/>
              </a:rPr>
              <a:t> s</a:t>
            </a:r>
            <a:r>
              <a:rPr lang="en-US" sz="1400" b="0" i="0" u="none" strike="noStrike" cap="none" baseline="30000">
                <a:solidFill>
                  <a:schemeClr val="dk1"/>
                </a:solidFill>
                <a:latin typeface="Calibri"/>
                <a:ea typeface="Calibri"/>
                <a:cs typeface="Calibri"/>
                <a:sym typeface="Calibri"/>
              </a:rPr>
              <a:t>-1</a:t>
            </a:r>
            <a:r>
              <a:rPr lang="en-US" sz="1400" b="0" i="0" u="none" strike="noStrike" cap="none">
                <a:solidFill>
                  <a:schemeClr val="dk1"/>
                </a:solidFill>
                <a:latin typeface="Calibri"/>
                <a:ea typeface="Calibri"/>
                <a:cs typeface="Calibri"/>
                <a:sym typeface="Calibri"/>
              </a:rPr>
              <a:t>) conditions. P700 kinetics were measured as described in </a:t>
            </a:r>
            <a:r>
              <a:rPr lang="en-US" sz="1400" b="1" i="0" u="none" strike="noStrike" cap="none">
                <a:solidFill>
                  <a:schemeClr val="dk1"/>
                </a:solidFill>
                <a:latin typeface="Calibri"/>
                <a:ea typeface="Calibri"/>
                <a:cs typeface="Calibri"/>
                <a:sym typeface="Calibri"/>
              </a:rPr>
              <a:t>Figure 3</a:t>
            </a:r>
            <a:r>
              <a:rPr lang="en-US" sz="1400" b="0" i="0" u="none" strike="noStrike" cap="none">
                <a:solidFill>
                  <a:schemeClr val="dk1"/>
                </a:solidFill>
                <a:latin typeface="Calibri"/>
                <a:ea typeface="Calibri"/>
                <a:cs typeface="Calibri"/>
                <a:sym typeface="Calibri"/>
              </a:rPr>
              <a:t>. The maximum P700 oxidation was taken at the saturating pulse (2250 µmol photons m</a:t>
            </a:r>
            <a:r>
              <a:rPr lang="en-US" sz="1400" b="0" i="0" u="none" strike="noStrike" cap="none" baseline="30000">
                <a:solidFill>
                  <a:schemeClr val="dk1"/>
                </a:solidFill>
                <a:latin typeface="Calibri"/>
                <a:ea typeface="Calibri"/>
                <a:cs typeface="Calibri"/>
                <a:sym typeface="Calibri"/>
              </a:rPr>
              <a:t>-2</a:t>
            </a:r>
            <a:r>
              <a:rPr lang="en-US" sz="1400" b="0" i="0" u="none" strike="noStrike" cap="none">
                <a:solidFill>
                  <a:schemeClr val="dk1"/>
                </a:solidFill>
                <a:latin typeface="Calibri"/>
                <a:ea typeface="Calibri"/>
                <a:cs typeface="Calibri"/>
                <a:sym typeface="Calibri"/>
              </a:rPr>
              <a:t> s</a:t>
            </a:r>
            <a:r>
              <a:rPr lang="en-US" sz="1400" b="0" i="0" u="none" strike="noStrike" cap="none" baseline="30000">
                <a:solidFill>
                  <a:schemeClr val="dk1"/>
                </a:solidFill>
                <a:latin typeface="Calibri"/>
                <a:ea typeface="Calibri"/>
                <a:cs typeface="Calibri"/>
                <a:sym typeface="Calibri"/>
              </a:rPr>
              <a:t>-1</a:t>
            </a:r>
            <a:r>
              <a:rPr lang="en-US" sz="1400" b="0" i="0" u="none" strike="noStrike" cap="none">
                <a:solidFill>
                  <a:schemeClr val="dk1"/>
                </a:solidFill>
                <a:latin typeface="Calibri"/>
                <a:ea typeface="Calibri"/>
                <a:cs typeface="Calibri"/>
                <a:sym typeface="Calibri"/>
              </a:rPr>
              <a:t>). The data was normalized to the activity of WT grown under LL-Ox. Values are the mean of two biological replicates. Error bars represent the standard deviations.</a:t>
            </a:r>
            <a:endParaRPr sz="1400" b="0" i="0" u="none" strike="noStrike" cap="none">
              <a:solidFill>
                <a:srgbClr val="000000"/>
              </a:solidFill>
              <a:latin typeface="Arial"/>
              <a:ea typeface="Arial"/>
              <a:cs typeface="Arial"/>
              <a:sym typeface="Arial"/>
            </a:endParaRPr>
          </a:p>
        </p:txBody>
      </p:sp>
      <p:sp>
        <p:nvSpPr>
          <p:cNvPr id="546" name="Google Shape;546;p13"/>
          <p:cNvSpPr txBox="1"/>
          <p:nvPr/>
        </p:nvSpPr>
        <p:spPr>
          <a:xfrm>
            <a:off x="111347" y="151182"/>
            <a:ext cx="1195584" cy="369332"/>
          </a:xfrm>
          <a:prstGeom prst="rect">
            <a:avLst/>
          </a:prstGeom>
          <a:noFill/>
          <a:ln>
            <a:noFill/>
          </a:ln>
        </p:spPr>
        <p:txBody>
          <a:bodyPr spcFirstLastPara="1" wrap="square" lIns="91425" tIns="45700" rIns="91425" bIns="45700" anchor="t" anchorCtr="0">
            <a:spAutoFit/>
          </a:bodyPr>
          <a:lstStyle/>
          <a:p>
            <a:pPr marL="0" marR="0" lvl="0" indent="0" algn="l" rtl="0">
              <a:lnSpc>
                <a:spcPct val="100000"/>
              </a:lnSpc>
              <a:spcBef>
                <a:spcPts val="0"/>
              </a:spcBef>
              <a:spcAft>
                <a:spcPts val="0"/>
              </a:spcAft>
              <a:buClr>
                <a:srgbClr val="000000"/>
              </a:buClr>
              <a:buSzPts val="1800"/>
              <a:buFont typeface="Arial"/>
              <a:buNone/>
            </a:pPr>
            <a:r>
              <a:rPr lang="en-US" sz="1800" b="0" i="0" u="none" strike="noStrike" cap="none">
                <a:solidFill>
                  <a:schemeClr val="dk1"/>
                </a:solidFill>
                <a:latin typeface="Times New Roman"/>
                <a:ea typeface="Times New Roman"/>
                <a:cs typeface="Times New Roman"/>
                <a:sym typeface="Times New Roman"/>
              </a:rPr>
              <a:t>Figure S</a:t>
            </a:r>
            <a:r>
              <a:rPr lang="en-US" sz="1800">
                <a:solidFill>
                  <a:schemeClr val="dk1"/>
                </a:solidFill>
                <a:latin typeface="Times New Roman"/>
                <a:ea typeface="Times New Roman"/>
                <a:cs typeface="Times New Roman"/>
                <a:sym typeface="Times New Roman"/>
              </a:rPr>
              <a:t>8</a:t>
            </a:r>
            <a:endParaRPr sz="1400" b="0" i="0" u="none" strike="noStrike" cap="none">
              <a:solidFill>
                <a:srgbClr val="000000"/>
              </a:solidFill>
              <a:latin typeface="Arial"/>
              <a:ea typeface="Arial"/>
              <a:cs typeface="Arial"/>
              <a:sym typeface="Arial"/>
            </a:endParaRPr>
          </a:p>
        </p:txBody>
      </p:sp>
      <p:graphicFrame>
        <p:nvGraphicFramePr>
          <p:cNvPr id="547" name="Google Shape;547;p13"/>
          <p:cNvGraphicFramePr/>
          <p:nvPr/>
        </p:nvGraphicFramePr>
        <p:xfrm>
          <a:off x="655726" y="964615"/>
          <a:ext cx="6402799" cy="4970963"/>
        </p:xfrm>
        <a:graphic>
          <a:graphicData uri="http://schemas.openxmlformats.org/drawingml/2006/chart">
            <c:chart xmlns:c="http://schemas.openxmlformats.org/drawingml/2006/chart" xmlns:r="http://schemas.openxmlformats.org/officeDocument/2006/relationships" r:id="rId3"/>
          </a:graphicData>
        </a:graphic>
      </p:graphicFrame>
    </p:spTree>
  </p:cSld>
  <p:clrMapOvr>
    <a:masterClrMapping/>
  </p:clrMapOvr>
</p:sld>
</file>

<file path=ppt/theme/theme1.xml><?xml version="1.0" encoding="utf-8"?>
<a:theme xmlns:a="http://schemas.openxmlformats.org/drawingml/2006/main" name="Office Theme">
  <a:themeElements>
    <a:clrScheme name="Office Theme">
      <a:dk1>
        <a:srgbClr val="000000"/>
      </a:dk1>
      <a:lt1>
        <a:srgbClr val="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Override1.xml><?xml version="1.0" encoding="utf-8"?>
<a:themeOverride xmlns:a="http://schemas.openxmlformats.org/drawingml/2006/main">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Times New Roman">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Times New Roman" panose="02020603050405020304"/>
      <a:ea typeface=""/>
      <a:cs typeface=""/>
      <a:font script="Jpan" typeface="ＭＳ Ｐ明朝"/>
      <a:font script="Hang" typeface="바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ppt/theme/themeOverride2.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3.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ppt/theme/themeOverride4.xml><?xml version="1.0" encoding="utf-8"?>
<a:themeOverride xmlns:a="http://schemas.openxmlformats.org/drawingml/2006/main">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mbria"/>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Override>
</file>

<file path=docProps/app.xml><?xml version="1.0" encoding="utf-8"?>
<Properties xmlns="http://schemas.openxmlformats.org/officeDocument/2006/extended-properties" xmlns:vt="http://schemas.openxmlformats.org/officeDocument/2006/docPropsVTypes">
  <TotalTime>60</TotalTime>
  <Words>1763</Words>
  <Application>Microsoft Office PowerPoint</Application>
  <PresentationFormat>Custom</PresentationFormat>
  <Paragraphs>440</Paragraphs>
  <Slides>12</Slides>
  <Notes>1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2</vt:i4>
      </vt:variant>
    </vt:vector>
  </HeadingPairs>
  <TitlesOfParts>
    <vt:vector size="16" baseType="lpstr">
      <vt:lpstr>Arial</vt:lpstr>
      <vt:lpstr>Calibri</vt:lpstr>
      <vt:lpstr>Times New Roman</vt:lpstr>
      <vt:lpstr>Office Theme</vt:lpstr>
      <vt:lpstr>RMT2 Supplemental Figures</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RMT2 Supplemental Figures</dc:title>
  <dc:creator>Rick Kim</dc:creator>
  <cp:lastModifiedBy>Justin Findinier</cp:lastModifiedBy>
  <cp:revision>4</cp:revision>
  <dcterms:created xsi:type="dcterms:W3CDTF">2018-01-30T19:04:14Z</dcterms:created>
  <dcterms:modified xsi:type="dcterms:W3CDTF">2024-04-05T17:06:20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F4EE1AE0CC83A4BB4B43BC3C2DACF0B</vt:lpwstr>
  </property>
</Properties>
</file>